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1090" r:id="rId2"/>
  </p:sldIdLst>
  <p:sldSz cx="12192000" cy="6858000"/>
  <p:notesSz cx="6735763" cy="986631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70C0"/>
    <a:srgbClr val="CC0099"/>
    <a:srgbClr val="FFF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4BEBAD3-CDC6-4E60-BDDD-D9A6E533E4C1}" v="1548" dt="2021-04-26T06:05:30.629"/>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614" autoAdjust="0"/>
    <p:restoredTop sz="94710" autoAdjust="0"/>
  </p:normalViewPr>
  <p:slideViewPr>
    <p:cSldViewPr snapToGrid="0" snapToObjects="1">
      <p:cViewPr varScale="1">
        <p:scale>
          <a:sx n="76" d="100"/>
          <a:sy n="76" d="100"/>
        </p:scale>
        <p:origin x="869" y="67"/>
      </p:cViewPr>
      <p:guideLst/>
    </p:cSldViewPr>
  </p:slideViewPr>
  <p:notesTextViewPr>
    <p:cViewPr>
      <p:scale>
        <a:sx n="1" d="1"/>
        <a:sy n="1" d="1"/>
      </p:scale>
      <p:origin x="0" y="0"/>
    </p:cViewPr>
  </p:notesTextViewPr>
  <p:sorterViewPr>
    <p:cViewPr varScale="1">
      <p:scale>
        <a:sx n="100" d="100"/>
        <a:sy n="100" d="100"/>
      </p:scale>
      <p:origin x="0" y="-18480"/>
    </p:cViewPr>
  </p:sorter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sujimoto,Mitsuhiro 辻本光宏(関東北甲信越統括支店O領域専門室)" userId="7251bc67-91ee-45c9-97e7-9c240c9b485c" providerId="ADAL" clId="{F45C6952-A25A-49D5-BDB5-91BE0D468A00}"/>
    <pc:docChg chg="addSld delSld modSld delMainMaster">
      <pc:chgData name="Tsujimoto,Mitsuhiro 辻本光宏(関東北甲信越統括支店O領域専門室)" userId="7251bc67-91ee-45c9-97e7-9c240c9b485c" providerId="ADAL" clId="{F45C6952-A25A-49D5-BDB5-91BE0D468A00}" dt="2021-04-21T10:12:16.769" v="17" actId="2696"/>
      <pc:docMkLst>
        <pc:docMk/>
      </pc:docMkLst>
      <pc:sldChg chg="add del">
        <pc:chgData name="Tsujimoto,Mitsuhiro 辻本光宏(関東北甲信越統括支店O領域専門室)" userId="7251bc67-91ee-45c9-97e7-9c240c9b485c" providerId="ADAL" clId="{F45C6952-A25A-49D5-BDB5-91BE0D468A00}" dt="2021-04-21T10:12:16.753" v="3" actId="2696"/>
        <pc:sldMkLst>
          <pc:docMk/>
          <pc:sldMk cId="1844831332" sldId="336"/>
        </pc:sldMkLst>
      </pc:sldChg>
      <pc:sldMasterChg chg="del delSldLayout">
        <pc:chgData name="Tsujimoto,Mitsuhiro 辻本光宏(関東北甲信越統括支店O領域専門室)" userId="7251bc67-91ee-45c9-97e7-9c240c9b485c" providerId="ADAL" clId="{F45C6952-A25A-49D5-BDB5-91BE0D468A00}" dt="2021-04-21T10:12:16.769" v="17" actId="2696"/>
        <pc:sldMasterMkLst>
          <pc:docMk/>
          <pc:sldMasterMk cId="2228098739" sldId="2147483660"/>
        </pc:sldMasterMkLst>
        <pc:sldLayoutChg chg="del">
          <pc:chgData name="Tsujimoto,Mitsuhiro 辻本光宏(関東北甲信越統括支店O領域専門室)" userId="7251bc67-91ee-45c9-97e7-9c240c9b485c" providerId="ADAL" clId="{F45C6952-A25A-49D5-BDB5-91BE0D468A00}" dt="2021-04-21T10:12:16.769" v="4" actId="2696"/>
          <pc:sldLayoutMkLst>
            <pc:docMk/>
            <pc:sldMasterMk cId="2228098739" sldId="2147483660"/>
            <pc:sldLayoutMk cId="3720571287" sldId="2147483661"/>
          </pc:sldLayoutMkLst>
        </pc:sldLayoutChg>
        <pc:sldLayoutChg chg="del">
          <pc:chgData name="Tsujimoto,Mitsuhiro 辻本光宏(関東北甲信越統括支店O領域専門室)" userId="7251bc67-91ee-45c9-97e7-9c240c9b485c" providerId="ADAL" clId="{F45C6952-A25A-49D5-BDB5-91BE0D468A00}" dt="2021-04-21T10:12:16.769" v="5" actId="2696"/>
          <pc:sldLayoutMkLst>
            <pc:docMk/>
            <pc:sldMasterMk cId="2228098739" sldId="2147483660"/>
            <pc:sldLayoutMk cId="2223222688" sldId="2147483662"/>
          </pc:sldLayoutMkLst>
        </pc:sldLayoutChg>
        <pc:sldLayoutChg chg="del">
          <pc:chgData name="Tsujimoto,Mitsuhiro 辻本光宏(関東北甲信越統括支店O領域専門室)" userId="7251bc67-91ee-45c9-97e7-9c240c9b485c" providerId="ADAL" clId="{F45C6952-A25A-49D5-BDB5-91BE0D468A00}" dt="2021-04-21T10:12:16.769" v="6" actId="2696"/>
          <pc:sldLayoutMkLst>
            <pc:docMk/>
            <pc:sldMasterMk cId="2228098739" sldId="2147483660"/>
            <pc:sldLayoutMk cId="866729709" sldId="2147483663"/>
          </pc:sldLayoutMkLst>
        </pc:sldLayoutChg>
        <pc:sldLayoutChg chg="del">
          <pc:chgData name="Tsujimoto,Mitsuhiro 辻本光宏(関東北甲信越統括支店O領域専門室)" userId="7251bc67-91ee-45c9-97e7-9c240c9b485c" providerId="ADAL" clId="{F45C6952-A25A-49D5-BDB5-91BE0D468A00}" dt="2021-04-21T10:12:16.769" v="7" actId="2696"/>
          <pc:sldLayoutMkLst>
            <pc:docMk/>
            <pc:sldMasterMk cId="2228098739" sldId="2147483660"/>
            <pc:sldLayoutMk cId="23820841" sldId="2147483664"/>
          </pc:sldLayoutMkLst>
        </pc:sldLayoutChg>
        <pc:sldLayoutChg chg="del">
          <pc:chgData name="Tsujimoto,Mitsuhiro 辻本光宏(関東北甲信越統括支店O領域専門室)" userId="7251bc67-91ee-45c9-97e7-9c240c9b485c" providerId="ADAL" clId="{F45C6952-A25A-49D5-BDB5-91BE0D468A00}" dt="2021-04-21T10:12:16.769" v="8" actId="2696"/>
          <pc:sldLayoutMkLst>
            <pc:docMk/>
            <pc:sldMasterMk cId="2228098739" sldId="2147483660"/>
            <pc:sldLayoutMk cId="860219612" sldId="2147483665"/>
          </pc:sldLayoutMkLst>
        </pc:sldLayoutChg>
        <pc:sldLayoutChg chg="del">
          <pc:chgData name="Tsujimoto,Mitsuhiro 辻本光宏(関東北甲信越統括支店O領域専門室)" userId="7251bc67-91ee-45c9-97e7-9c240c9b485c" providerId="ADAL" clId="{F45C6952-A25A-49D5-BDB5-91BE0D468A00}" dt="2021-04-21T10:12:16.769" v="9" actId="2696"/>
          <pc:sldLayoutMkLst>
            <pc:docMk/>
            <pc:sldMasterMk cId="2228098739" sldId="2147483660"/>
            <pc:sldLayoutMk cId="2107707247" sldId="2147483666"/>
          </pc:sldLayoutMkLst>
        </pc:sldLayoutChg>
        <pc:sldLayoutChg chg="del">
          <pc:chgData name="Tsujimoto,Mitsuhiro 辻本光宏(関東北甲信越統括支店O領域専門室)" userId="7251bc67-91ee-45c9-97e7-9c240c9b485c" providerId="ADAL" clId="{F45C6952-A25A-49D5-BDB5-91BE0D468A00}" dt="2021-04-21T10:12:16.769" v="10" actId="2696"/>
          <pc:sldLayoutMkLst>
            <pc:docMk/>
            <pc:sldMasterMk cId="2228098739" sldId="2147483660"/>
            <pc:sldLayoutMk cId="344278912" sldId="2147483667"/>
          </pc:sldLayoutMkLst>
        </pc:sldLayoutChg>
        <pc:sldLayoutChg chg="del">
          <pc:chgData name="Tsujimoto,Mitsuhiro 辻本光宏(関東北甲信越統括支店O領域専門室)" userId="7251bc67-91ee-45c9-97e7-9c240c9b485c" providerId="ADAL" clId="{F45C6952-A25A-49D5-BDB5-91BE0D468A00}" dt="2021-04-21T10:12:16.769" v="11" actId="2696"/>
          <pc:sldLayoutMkLst>
            <pc:docMk/>
            <pc:sldMasterMk cId="2228098739" sldId="2147483660"/>
            <pc:sldLayoutMk cId="2000294377" sldId="2147483668"/>
          </pc:sldLayoutMkLst>
        </pc:sldLayoutChg>
        <pc:sldLayoutChg chg="del">
          <pc:chgData name="Tsujimoto,Mitsuhiro 辻本光宏(関東北甲信越統括支店O領域専門室)" userId="7251bc67-91ee-45c9-97e7-9c240c9b485c" providerId="ADAL" clId="{F45C6952-A25A-49D5-BDB5-91BE0D468A00}" dt="2021-04-21T10:12:16.769" v="12" actId="2696"/>
          <pc:sldLayoutMkLst>
            <pc:docMk/>
            <pc:sldMasterMk cId="2228098739" sldId="2147483660"/>
            <pc:sldLayoutMk cId="1280826430" sldId="2147483669"/>
          </pc:sldLayoutMkLst>
        </pc:sldLayoutChg>
        <pc:sldLayoutChg chg="del">
          <pc:chgData name="Tsujimoto,Mitsuhiro 辻本光宏(関東北甲信越統括支店O領域専門室)" userId="7251bc67-91ee-45c9-97e7-9c240c9b485c" providerId="ADAL" clId="{F45C6952-A25A-49D5-BDB5-91BE0D468A00}" dt="2021-04-21T10:12:16.769" v="13" actId="2696"/>
          <pc:sldLayoutMkLst>
            <pc:docMk/>
            <pc:sldMasterMk cId="2228098739" sldId="2147483660"/>
            <pc:sldLayoutMk cId="653635555" sldId="2147483670"/>
          </pc:sldLayoutMkLst>
        </pc:sldLayoutChg>
        <pc:sldLayoutChg chg="del">
          <pc:chgData name="Tsujimoto,Mitsuhiro 辻本光宏(関東北甲信越統括支店O領域専門室)" userId="7251bc67-91ee-45c9-97e7-9c240c9b485c" providerId="ADAL" clId="{F45C6952-A25A-49D5-BDB5-91BE0D468A00}" dt="2021-04-21T10:12:16.769" v="14" actId="2696"/>
          <pc:sldLayoutMkLst>
            <pc:docMk/>
            <pc:sldMasterMk cId="2228098739" sldId="2147483660"/>
            <pc:sldLayoutMk cId="2491929892" sldId="2147483671"/>
          </pc:sldLayoutMkLst>
        </pc:sldLayoutChg>
        <pc:sldLayoutChg chg="del">
          <pc:chgData name="Tsujimoto,Mitsuhiro 辻本光宏(関東北甲信越統括支店O領域専門室)" userId="7251bc67-91ee-45c9-97e7-9c240c9b485c" providerId="ADAL" clId="{F45C6952-A25A-49D5-BDB5-91BE0D468A00}" dt="2021-04-21T10:12:16.769" v="15" actId="2696"/>
          <pc:sldLayoutMkLst>
            <pc:docMk/>
            <pc:sldMasterMk cId="2228098739" sldId="2147483660"/>
            <pc:sldLayoutMk cId="2272665183" sldId="2147483672"/>
          </pc:sldLayoutMkLst>
        </pc:sldLayoutChg>
        <pc:sldLayoutChg chg="del">
          <pc:chgData name="Tsujimoto,Mitsuhiro 辻本光宏(関東北甲信越統括支店O領域専門室)" userId="7251bc67-91ee-45c9-97e7-9c240c9b485c" providerId="ADAL" clId="{F45C6952-A25A-49D5-BDB5-91BE0D468A00}" dt="2021-04-21T10:12:16.769" v="16" actId="2696"/>
          <pc:sldLayoutMkLst>
            <pc:docMk/>
            <pc:sldMasterMk cId="2228098739" sldId="2147483660"/>
            <pc:sldLayoutMk cId="1422465597" sldId="2147483673"/>
          </pc:sldLayoutMkLst>
        </pc:sldLayoutChg>
      </pc:sldMasterChg>
    </pc:docChg>
  </pc:docChgLst>
  <pc:docChgLst>
    <pc:chgData name="Tsujimoto,Mitsuhiro 辻本光宏(関東北甲信越統括支店O領域専門室)" userId="7251bc67-91ee-45c9-97e7-9c240c9b485c" providerId="ADAL" clId="{51945A91-CB03-4A52-98BE-5B2D563FE265}"/>
    <pc:docChg chg="undo redo custSel mod addSld delSld modSld sldOrd modMainMaster">
      <pc:chgData name="Tsujimoto,Mitsuhiro 辻本光宏(関東北甲信越統括支店O領域専門室)" userId="7251bc67-91ee-45c9-97e7-9c240c9b485c" providerId="ADAL" clId="{51945A91-CB03-4A52-98BE-5B2D563FE265}" dt="2021-04-23T05:27:14.737" v="13683" actId="1582"/>
      <pc:docMkLst>
        <pc:docMk/>
      </pc:docMkLst>
      <pc:sldChg chg="addSp delSp">
        <pc:chgData name="Tsujimoto,Mitsuhiro 辻本光宏(関東北甲信越統括支店O領域専門室)" userId="7251bc67-91ee-45c9-97e7-9c240c9b485c" providerId="ADAL" clId="{51945A91-CB03-4A52-98BE-5B2D563FE265}" dt="2021-04-21T10:25:09.874" v="331"/>
        <pc:sldMkLst>
          <pc:docMk/>
          <pc:sldMk cId="122688492" sldId="256"/>
        </pc:sldMkLst>
        <pc:spChg chg="add del">
          <ac:chgData name="Tsujimoto,Mitsuhiro 辻本光宏(関東北甲信越統括支店O領域専門室)" userId="7251bc67-91ee-45c9-97e7-9c240c9b485c" providerId="ADAL" clId="{51945A91-CB03-4A52-98BE-5B2D563FE265}" dt="2021-04-21T10:25:09.874" v="331"/>
          <ac:spMkLst>
            <pc:docMk/>
            <pc:sldMk cId="122688492" sldId="256"/>
            <ac:spMk id="5" creationId="{8B89FEB9-1625-4577-965D-E92FDA6BE48B}"/>
          </ac:spMkLst>
        </pc:spChg>
      </pc:sldChg>
      <pc:sldChg chg="add del">
        <pc:chgData name="Tsujimoto,Mitsuhiro 辻本光宏(関東北甲信越統括支店O領域専門室)" userId="7251bc67-91ee-45c9-97e7-9c240c9b485c" providerId="ADAL" clId="{51945A91-CB03-4A52-98BE-5B2D563FE265}" dt="2021-04-22T07:38:14.891" v="4490"/>
        <pc:sldMkLst>
          <pc:docMk/>
          <pc:sldMk cId="0" sldId="257"/>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58"/>
        </pc:sldMkLst>
      </pc:sldChg>
      <pc:sldChg chg="modSp">
        <pc:chgData name="Tsujimoto,Mitsuhiro 辻本光宏(関東北甲信越統括支店O領域専門室)" userId="7251bc67-91ee-45c9-97e7-9c240c9b485c" providerId="ADAL" clId="{51945A91-CB03-4A52-98BE-5B2D563FE265}" dt="2021-04-21T10:39:09.436" v="1063" actId="1076"/>
        <pc:sldMkLst>
          <pc:docMk/>
          <pc:sldMk cId="1305757310" sldId="262"/>
        </pc:sldMkLst>
        <pc:picChg chg="mod">
          <ac:chgData name="Tsujimoto,Mitsuhiro 辻本光宏(関東北甲信越統括支店O領域専門室)" userId="7251bc67-91ee-45c9-97e7-9c240c9b485c" providerId="ADAL" clId="{51945A91-CB03-4A52-98BE-5B2D563FE265}" dt="2021-04-21T10:39:01.151" v="1061" actId="1076"/>
          <ac:picMkLst>
            <pc:docMk/>
            <pc:sldMk cId="1305757310" sldId="262"/>
            <ac:picMk id="3" creationId="{49A5211B-AF58-4C0D-A5F6-ACD2FCB3817B}"/>
          </ac:picMkLst>
        </pc:picChg>
        <pc:picChg chg="mod">
          <ac:chgData name="Tsujimoto,Mitsuhiro 辻本光宏(関東北甲信越統括支店O領域専門室)" userId="7251bc67-91ee-45c9-97e7-9c240c9b485c" providerId="ADAL" clId="{51945A91-CB03-4A52-98BE-5B2D563FE265}" dt="2021-04-21T10:39:09.436" v="1063" actId="1076"/>
          <ac:picMkLst>
            <pc:docMk/>
            <pc:sldMk cId="1305757310" sldId="262"/>
            <ac:picMk id="4" creationId="{375555C9-E33A-4A2F-9884-5498C1803508}"/>
          </ac:picMkLst>
        </pc:picChg>
      </pc:sldChg>
      <pc:sldChg chg="add del">
        <pc:chgData name="Tsujimoto,Mitsuhiro 辻本光宏(関東北甲信越統括支店O領域専門室)" userId="7251bc67-91ee-45c9-97e7-9c240c9b485c" providerId="ADAL" clId="{51945A91-CB03-4A52-98BE-5B2D563FE265}" dt="2021-04-22T07:38:14.891" v="4490"/>
        <pc:sldMkLst>
          <pc:docMk/>
          <pc:sldMk cId="0" sldId="263"/>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64"/>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65"/>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66"/>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67"/>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68"/>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69"/>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70"/>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71"/>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72"/>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73"/>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74"/>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75"/>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0" sldId="276"/>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0" sldId="277"/>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0" sldId="278"/>
        </pc:sldMkLst>
      </pc:sldChg>
      <pc:sldChg chg="modSp add del ord">
        <pc:chgData name="Tsujimoto,Mitsuhiro 辻本光宏(関東北甲信越統括支店O領域専門室)" userId="7251bc67-91ee-45c9-97e7-9c240c9b485c" providerId="ADAL" clId="{51945A91-CB03-4A52-98BE-5B2D563FE265}" dt="2021-04-21T10:28:50.714" v="519" actId="2696"/>
        <pc:sldMkLst>
          <pc:docMk/>
          <pc:sldMk cId="1844831332" sldId="336"/>
        </pc:sldMkLst>
        <pc:spChg chg="mod">
          <ac:chgData name="Tsujimoto,Mitsuhiro 辻本光宏(関東北甲信越統括支店O領域専門室)" userId="7251bc67-91ee-45c9-97e7-9c240c9b485c" providerId="ADAL" clId="{51945A91-CB03-4A52-98BE-5B2D563FE265}" dt="2021-04-21T10:18:02.400" v="249" actId="2711"/>
          <ac:spMkLst>
            <pc:docMk/>
            <pc:sldMk cId="1844831332" sldId="336"/>
            <ac:spMk id="12" creationId="{1B6593AA-0776-8D4A-8849-70E1D8B8B914}"/>
          </ac:spMkLst>
        </pc:spChg>
      </pc:sldChg>
      <pc:sldChg chg="add del">
        <pc:chgData name="Tsujimoto,Mitsuhiro 辻本光宏(関東北甲信越統括支店O領域専門室)" userId="7251bc67-91ee-45c9-97e7-9c240c9b485c" providerId="ADAL" clId="{51945A91-CB03-4A52-98BE-5B2D563FE265}" dt="2021-04-22T07:20:34.120" v="4405" actId="2696"/>
        <pc:sldMkLst>
          <pc:docMk/>
          <pc:sldMk cId="2163238923" sldId="338"/>
        </pc:sldMkLst>
      </pc:sldChg>
      <pc:sldChg chg="add del">
        <pc:chgData name="Tsujimoto,Mitsuhiro 辻本光宏(関東北甲信越統括支店O領域専門室)" userId="7251bc67-91ee-45c9-97e7-9c240c9b485c" providerId="ADAL" clId="{51945A91-CB03-4A52-98BE-5B2D563FE265}" dt="2021-04-22T07:20:34.167" v="4406" actId="2696"/>
        <pc:sldMkLst>
          <pc:docMk/>
          <pc:sldMk cId="1533906966" sldId="339"/>
        </pc:sldMkLst>
      </pc:sldChg>
      <pc:sldChg chg="add del">
        <pc:chgData name="Tsujimoto,Mitsuhiro 辻本光宏(関東北甲信越統括支店O領域専門室)" userId="7251bc67-91ee-45c9-97e7-9c240c9b485c" providerId="ADAL" clId="{51945A91-CB03-4A52-98BE-5B2D563FE265}" dt="2021-04-22T07:20:34.385" v="4411" actId="2696"/>
        <pc:sldMkLst>
          <pc:docMk/>
          <pc:sldMk cId="4164889676" sldId="340"/>
        </pc:sldMkLst>
      </pc:sldChg>
      <pc:sldChg chg="add del">
        <pc:chgData name="Tsujimoto,Mitsuhiro 辻本光宏(関東北甲信越統括支店O領域専門室)" userId="7251bc67-91ee-45c9-97e7-9c240c9b485c" providerId="ADAL" clId="{51945A91-CB03-4A52-98BE-5B2D563FE265}" dt="2021-04-22T07:20:34.421" v="4412" actId="2696"/>
        <pc:sldMkLst>
          <pc:docMk/>
          <pc:sldMk cId="3450013105" sldId="341"/>
        </pc:sldMkLst>
      </pc:sldChg>
      <pc:sldChg chg="add del">
        <pc:chgData name="Tsujimoto,Mitsuhiro 辻本光宏(関東北甲信越統括支店O領域専門室)" userId="7251bc67-91ee-45c9-97e7-9c240c9b485c" providerId="ADAL" clId="{51945A91-CB03-4A52-98BE-5B2D563FE265}" dt="2021-04-22T07:20:35.027" v="4434" actId="2696"/>
        <pc:sldMkLst>
          <pc:docMk/>
          <pc:sldMk cId="2584608338" sldId="355"/>
        </pc:sldMkLst>
      </pc:sldChg>
      <pc:sldChg chg="add del">
        <pc:chgData name="Tsujimoto,Mitsuhiro 辻本光宏(関東北甲信越統括支店O領域専門室)" userId="7251bc67-91ee-45c9-97e7-9c240c9b485c" providerId="ADAL" clId="{51945A91-CB03-4A52-98BE-5B2D563FE265}" dt="2021-04-22T07:20:35.845" v="4460" actId="2696"/>
        <pc:sldMkLst>
          <pc:docMk/>
          <pc:sldMk cId="305464407" sldId="378"/>
        </pc:sldMkLst>
      </pc:sldChg>
      <pc:sldChg chg="add del">
        <pc:chgData name="Tsujimoto,Mitsuhiro 辻本光宏(関東北甲信越統括支店O領域専門室)" userId="7251bc67-91ee-45c9-97e7-9c240c9b485c" providerId="ADAL" clId="{51945A91-CB03-4A52-98BE-5B2D563FE265}" dt="2021-04-22T07:20:35.729" v="4455" actId="2696"/>
        <pc:sldMkLst>
          <pc:docMk/>
          <pc:sldMk cId="896371184" sldId="379"/>
        </pc:sldMkLst>
      </pc:sldChg>
      <pc:sldChg chg="add del">
        <pc:chgData name="Tsujimoto,Mitsuhiro 辻本光宏(関東北甲信越統括支店O領域専門室)" userId="7251bc67-91ee-45c9-97e7-9c240c9b485c" providerId="ADAL" clId="{51945A91-CB03-4A52-98BE-5B2D563FE265}" dt="2021-04-22T07:20:36.023" v="4466" actId="2696"/>
        <pc:sldMkLst>
          <pc:docMk/>
          <pc:sldMk cId="3524088718" sldId="386"/>
        </pc:sldMkLst>
      </pc:sldChg>
      <pc:sldChg chg="add del">
        <pc:chgData name="Tsujimoto,Mitsuhiro 辻本光宏(関東北甲信越統括支店O領域専門室)" userId="7251bc67-91ee-45c9-97e7-9c240c9b485c" providerId="ADAL" clId="{51945A91-CB03-4A52-98BE-5B2D563FE265}" dt="2021-04-22T07:20:36.062" v="4468" actId="2696"/>
        <pc:sldMkLst>
          <pc:docMk/>
          <pc:sldMk cId="3851813881" sldId="387"/>
        </pc:sldMkLst>
      </pc:sldChg>
      <pc:sldChg chg="add del">
        <pc:chgData name="Tsujimoto,Mitsuhiro 辻本光宏(関東北甲信越統括支店O領域専門室)" userId="7251bc67-91ee-45c9-97e7-9c240c9b485c" providerId="ADAL" clId="{51945A91-CB03-4A52-98BE-5B2D563FE265}" dt="2021-04-22T07:20:36.078" v="4469" actId="2696"/>
        <pc:sldMkLst>
          <pc:docMk/>
          <pc:sldMk cId="3061762019" sldId="389"/>
        </pc:sldMkLst>
      </pc:sldChg>
      <pc:sldChg chg="add del">
        <pc:chgData name="Tsujimoto,Mitsuhiro 辻本光宏(関東北甲信越統括支店O領域専門室)" userId="7251bc67-91ee-45c9-97e7-9c240c9b485c" providerId="ADAL" clId="{51945A91-CB03-4A52-98BE-5B2D563FE265}" dt="2021-04-22T07:20:36.078" v="4470" actId="2696"/>
        <pc:sldMkLst>
          <pc:docMk/>
          <pc:sldMk cId="3300931365" sldId="390"/>
        </pc:sldMkLst>
      </pc:sldChg>
      <pc:sldChg chg="add del">
        <pc:chgData name="Tsujimoto,Mitsuhiro 辻本光宏(関東北甲信越統括支店O領域専門室)" userId="7251bc67-91ee-45c9-97e7-9c240c9b485c" providerId="ADAL" clId="{51945A91-CB03-4A52-98BE-5B2D563FE265}" dt="2021-04-22T07:20:36.109" v="4471" actId="2696"/>
        <pc:sldMkLst>
          <pc:docMk/>
          <pc:sldMk cId="3708645521" sldId="394"/>
        </pc:sldMkLst>
      </pc:sldChg>
      <pc:sldChg chg="add del">
        <pc:chgData name="Tsujimoto,Mitsuhiro 辻本光宏(関東北甲信越統括支店O領域専門室)" userId="7251bc67-91ee-45c9-97e7-9c240c9b485c" providerId="ADAL" clId="{51945A91-CB03-4A52-98BE-5B2D563FE265}" dt="2021-04-22T07:20:36.297" v="4477" actId="2696"/>
        <pc:sldMkLst>
          <pc:docMk/>
          <pc:sldMk cId="2051249854" sldId="402"/>
        </pc:sldMkLst>
      </pc:sldChg>
      <pc:sldChg chg="add del">
        <pc:chgData name="Tsujimoto,Mitsuhiro 辻本光宏(関東北甲信越統括支店O領域専門室)" userId="7251bc67-91ee-45c9-97e7-9c240c9b485c" providerId="ADAL" clId="{51945A91-CB03-4A52-98BE-5B2D563FE265}" dt="2021-04-22T07:20:34.336" v="4409" actId="2696"/>
        <pc:sldMkLst>
          <pc:docMk/>
          <pc:sldMk cId="2874809384" sldId="409"/>
        </pc:sldMkLst>
      </pc:sldChg>
      <pc:sldChg chg="add del">
        <pc:chgData name="Tsujimoto,Mitsuhiro 辻本光宏(関東北甲信越統括支店O領域専門室)" userId="7251bc67-91ee-45c9-97e7-9c240c9b485c" providerId="ADAL" clId="{51945A91-CB03-4A52-98BE-5B2D563FE265}" dt="2021-04-22T07:20:34.368" v="4410" actId="2696"/>
        <pc:sldMkLst>
          <pc:docMk/>
          <pc:sldMk cId="1370496211" sldId="442"/>
        </pc:sldMkLst>
      </pc:sldChg>
      <pc:sldChg chg="add del">
        <pc:chgData name="Tsujimoto,Mitsuhiro 辻本光宏(関東北甲信越統括支店O領域専門室)" userId="7251bc67-91ee-45c9-97e7-9c240c9b485c" providerId="ADAL" clId="{51945A91-CB03-4A52-98BE-5B2D563FE265}" dt="2021-04-22T07:20:34.557" v="4418" actId="2696"/>
        <pc:sldMkLst>
          <pc:docMk/>
          <pc:sldMk cId="4119583974" sldId="444"/>
        </pc:sldMkLst>
      </pc:sldChg>
      <pc:sldChg chg="add del">
        <pc:chgData name="Tsujimoto,Mitsuhiro 辻本光宏(関東北甲信越統括支店O領域専門室)" userId="7251bc67-91ee-45c9-97e7-9c240c9b485c" providerId="ADAL" clId="{51945A91-CB03-4A52-98BE-5B2D563FE265}" dt="2021-04-22T07:20:34.572" v="4419" actId="2696"/>
        <pc:sldMkLst>
          <pc:docMk/>
          <pc:sldMk cId="2486299017" sldId="446"/>
        </pc:sldMkLst>
      </pc:sldChg>
      <pc:sldChg chg="add del">
        <pc:chgData name="Tsujimoto,Mitsuhiro 辻本光宏(関東北甲信越統括支店O領域専門室)" userId="7251bc67-91ee-45c9-97e7-9c240c9b485c" providerId="ADAL" clId="{51945A91-CB03-4A52-98BE-5B2D563FE265}" dt="2021-04-22T07:20:34.621" v="4421" actId="2696"/>
        <pc:sldMkLst>
          <pc:docMk/>
          <pc:sldMk cId="3983218799" sldId="447"/>
        </pc:sldMkLst>
      </pc:sldChg>
      <pc:sldChg chg="add del">
        <pc:chgData name="Tsujimoto,Mitsuhiro 辻本光宏(関東北甲信越統括支店O領域専門室)" userId="7251bc67-91ee-45c9-97e7-9c240c9b485c" providerId="ADAL" clId="{51945A91-CB03-4A52-98BE-5B2D563FE265}" dt="2021-04-22T07:20:34.588" v="4420" actId="2696"/>
        <pc:sldMkLst>
          <pc:docMk/>
          <pc:sldMk cId="2647448088" sldId="448"/>
        </pc:sldMkLst>
      </pc:sldChg>
      <pc:sldChg chg="add del">
        <pc:chgData name="Tsujimoto,Mitsuhiro 辻本光宏(関東北甲信越統括支店O領域専門室)" userId="7251bc67-91ee-45c9-97e7-9c240c9b485c" providerId="ADAL" clId="{51945A91-CB03-4A52-98BE-5B2D563FE265}" dt="2021-04-22T07:20:34.737" v="4424" actId="2696"/>
        <pc:sldMkLst>
          <pc:docMk/>
          <pc:sldMk cId="2130570687" sldId="450"/>
        </pc:sldMkLst>
      </pc:sldChg>
      <pc:sldChg chg="add del">
        <pc:chgData name="Tsujimoto,Mitsuhiro 辻本光宏(関東北甲信越統括支店O領域専門室)" userId="7251bc67-91ee-45c9-97e7-9c240c9b485c" providerId="ADAL" clId="{51945A91-CB03-4A52-98BE-5B2D563FE265}" dt="2021-04-22T07:20:36.313" v="4478" actId="2696"/>
        <pc:sldMkLst>
          <pc:docMk/>
          <pc:sldMk cId="2190153718" sldId="459"/>
        </pc:sldMkLst>
      </pc:sldChg>
      <pc:sldChg chg="add del">
        <pc:chgData name="Tsujimoto,Mitsuhiro 辻本光宏(関東北甲信越統括支店O領域専門室)" userId="7251bc67-91ee-45c9-97e7-9c240c9b485c" providerId="ADAL" clId="{51945A91-CB03-4A52-98BE-5B2D563FE265}" dt="2021-04-22T07:20:34.484" v="4415" actId="2696"/>
        <pc:sldMkLst>
          <pc:docMk/>
          <pc:sldMk cId="4051583725" sldId="467"/>
        </pc:sldMkLst>
      </pc:sldChg>
      <pc:sldChg chg="add del">
        <pc:chgData name="Tsujimoto,Mitsuhiro 辻本光宏(関東北甲信越統括支店O領域専門室)" userId="7251bc67-91ee-45c9-97e7-9c240c9b485c" providerId="ADAL" clId="{51945A91-CB03-4A52-98BE-5B2D563FE265}" dt="2021-04-22T07:20:34.505" v="4416" actId="2696"/>
        <pc:sldMkLst>
          <pc:docMk/>
          <pc:sldMk cId="34498157" sldId="469"/>
        </pc:sldMkLst>
      </pc:sldChg>
      <pc:sldChg chg="add del">
        <pc:chgData name="Tsujimoto,Mitsuhiro 辻本光宏(関東北甲信越統括支店O領域専門室)" userId="7251bc67-91ee-45c9-97e7-9c240c9b485c" providerId="ADAL" clId="{51945A91-CB03-4A52-98BE-5B2D563FE265}" dt="2021-04-22T07:20:34.421" v="4413" actId="2696"/>
        <pc:sldMkLst>
          <pc:docMk/>
          <pc:sldMk cId="4089775984" sldId="471"/>
        </pc:sldMkLst>
      </pc:sldChg>
      <pc:sldChg chg="add del">
        <pc:chgData name="Tsujimoto,Mitsuhiro 辻本光宏(関東北甲信越統括支店O領域専門室)" userId="7251bc67-91ee-45c9-97e7-9c240c9b485c" providerId="ADAL" clId="{51945A91-CB03-4A52-98BE-5B2D563FE265}" dt="2021-04-22T07:20:35.676" v="4454" actId="2696"/>
        <pc:sldMkLst>
          <pc:docMk/>
          <pc:sldMk cId="1608019227" sldId="472"/>
        </pc:sldMkLst>
      </pc:sldChg>
      <pc:sldChg chg="add del">
        <pc:chgData name="Tsujimoto,Mitsuhiro 辻本光宏(関東北甲信越統括支店O領域専門室)" userId="7251bc67-91ee-45c9-97e7-9c240c9b485c" providerId="ADAL" clId="{51945A91-CB03-4A52-98BE-5B2D563FE265}" dt="2021-04-22T07:20:34.922" v="4432" actId="2696"/>
        <pc:sldMkLst>
          <pc:docMk/>
          <pc:sldMk cId="537895152" sldId="474"/>
        </pc:sldMkLst>
      </pc:sldChg>
      <pc:sldChg chg="add del">
        <pc:chgData name="Tsujimoto,Mitsuhiro 辻本光宏(関東北甲信越統括支店O領域専門室)" userId="7251bc67-91ee-45c9-97e7-9c240c9b485c" providerId="ADAL" clId="{51945A91-CB03-4A52-98BE-5B2D563FE265}" dt="2021-04-22T07:20:35.765" v="4456" actId="2696"/>
        <pc:sldMkLst>
          <pc:docMk/>
          <pc:sldMk cId="3126329999" sldId="475"/>
        </pc:sldMkLst>
      </pc:sldChg>
      <pc:sldChg chg="add del">
        <pc:chgData name="Tsujimoto,Mitsuhiro 辻本光宏(関東北甲信越統括支店O領域専門室)" userId="7251bc67-91ee-45c9-97e7-9c240c9b485c" providerId="ADAL" clId="{51945A91-CB03-4A52-98BE-5B2D563FE265}" dt="2021-04-22T07:20:35.796" v="4457" actId="2696"/>
        <pc:sldMkLst>
          <pc:docMk/>
          <pc:sldMk cId="2278515837" sldId="476"/>
        </pc:sldMkLst>
      </pc:sldChg>
      <pc:sldChg chg="add del">
        <pc:chgData name="Tsujimoto,Mitsuhiro 辻本光宏(関東北甲信越統括支店O領域専門室)" userId="7251bc67-91ee-45c9-97e7-9c240c9b485c" providerId="ADAL" clId="{51945A91-CB03-4A52-98BE-5B2D563FE265}" dt="2021-04-22T07:20:35.829" v="4459" actId="2696"/>
        <pc:sldMkLst>
          <pc:docMk/>
          <pc:sldMk cId="2301179219" sldId="478"/>
        </pc:sldMkLst>
      </pc:sldChg>
      <pc:sldChg chg="add del">
        <pc:chgData name="Tsujimoto,Mitsuhiro 辻本光宏(関東北甲信越統括支店O領域専門室)" userId="7251bc67-91ee-45c9-97e7-9c240c9b485c" providerId="ADAL" clId="{51945A91-CB03-4A52-98BE-5B2D563FE265}" dt="2021-04-22T07:20:35.892" v="4464" actId="2696"/>
        <pc:sldMkLst>
          <pc:docMk/>
          <pc:sldMk cId="1323201524" sldId="481"/>
        </pc:sldMkLst>
      </pc:sldChg>
      <pc:sldChg chg="add del">
        <pc:chgData name="Tsujimoto,Mitsuhiro 辻本光宏(関東北甲信越統括支店O領域専門室)" userId="7251bc67-91ee-45c9-97e7-9c240c9b485c" providerId="ADAL" clId="{51945A91-CB03-4A52-98BE-5B2D563FE265}" dt="2021-04-22T07:20:36.130" v="4472" actId="2696"/>
        <pc:sldMkLst>
          <pc:docMk/>
          <pc:sldMk cId="4031157540" sldId="490"/>
        </pc:sldMkLst>
      </pc:sldChg>
      <pc:sldChg chg="add del">
        <pc:chgData name="Tsujimoto,Mitsuhiro 辻本光宏(関東北甲信越統括支店O領域専門室)" userId="7251bc67-91ee-45c9-97e7-9c240c9b485c" providerId="ADAL" clId="{51945A91-CB03-4A52-98BE-5B2D563FE265}" dt="2021-04-22T07:20:36.161" v="4473" actId="2696"/>
        <pc:sldMkLst>
          <pc:docMk/>
          <pc:sldMk cId="2328769261" sldId="491"/>
        </pc:sldMkLst>
      </pc:sldChg>
      <pc:sldChg chg="add del">
        <pc:chgData name="Tsujimoto,Mitsuhiro 辻本光宏(関東北甲信越統括支店O領域専門室)" userId="7251bc67-91ee-45c9-97e7-9c240c9b485c" providerId="ADAL" clId="{51945A91-CB03-4A52-98BE-5B2D563FE265}" dt="2021-04-22T07:20:36.045" v="4467" actId="2696"/>
        <pc:sldMkLst>
          <pc:docMk/>
          <pc:sldMk cId="2034532869" sldId="495"/>
        </pc:sldMkLst>
      </pc:sldChg>
      <pc:sldChg chg="add del">
        <pc:chgData name="Tsujimoto,Mitsuhiro 辻本光宏(関東北甲信越統括支店O領域専門室)" userId="7251bc67-91ee-45c9-97e7-9c240c9b485c" providerId="ADAL" clId="{51945A91-CB03-4A52-98BE-5B2D563FE265}" dt="2021-04-22T07:20:34.305" v="4408" actId="2696"/>
        <pc:sldMkLst>
          <pc:docMk/>
          <pc:sldMk cId="4224184431" sldId="497"/>
        </pc:sldMkLst>
      </pc:sldChg>
      <pc:sldChg chg="add del">
        <pc:chgData name="Tsujimoto,Mitsuhiro 辻本光宏(関東北甲信越統括支店O領域専門室)" userId="7251bc67-91ee-45c9-97e7-9c240c9b485c" providerId="ADAL" clId="{51945A91-CB03-4A52-98BE-5B2D563FE265}" dt="2021-04-22T07:20:34.067" v="4404" actId="2696"/>
        <pc:sldMkLst>
          <pc:docMk/>
          <pc:sldMk cId="1826043330" sldId="498"/>
        </pc:sldMkLst>
      </pc:sldChg>
      <pc:sldChg chg="add del">
        <pc:chgData name="Tsujimoto,Mitsuhiro 辻本光宏(関東北甲信越統括支店O領域専門室)" userId="7251bc67-91ee-45c9-97e7-9c240c9b485c" providerId="ADAL" clId="{51945A91-CB03-4A52-98BE-5B2D563FE265}" dt="2021-04-22T07:20:34.541" v="4417" actId="2696"/>
        <pc:sldMkLst>
          <pc:docMk/>
          <pc:sldMk cId="310865632" sldId="501"/>
        </pc:sldMkLst>
      </pc:sldChg>
      <pc:sldChg chg="add del">
        <pc:chgData name="Tsujimoto,Mitsuhiro 辻本光宏(関東北甲信越統括支店O領域専門室)" userId="7251bc67-91ee-45c9-97e7-9c240c9b485c" providerId="ADAL" clId="{51945A91-CB03-4A52-98BE-5B2D563FE265}" dt="2021-04-22T07:20:34.652" v="4422" actId="2696"/>
        <pc:sldMkLst>
          <pc:docMk/>
          <pc:sldMk cId="1173185512" sldId="503"/>
        </pc:sldMkLst>
      </pc:sldChg>
      <pc:sldChg chg="add del">
        <pc:chgData name="Tsujimoto,Mitsuhiro 辻本光宏(関東北甲信越統括支店O領域専門室)" userId="7251bc67-91ee-45c9-97e7-9c240c9b485c" providerId="ADAL" clId="{51945A91-CB03-4A52-98BE-5B2D563FE265}" dt="2021-04-22T07:20:35.475" v="4449" actId="2696"/>
        <pc:sldMkLst>
          <pc:docMk/>
          <pc:sldMk cId="1353782911" sldId="504"/>
        </pc:sldMkLst>
      </pc:sldChg>
      <pc:sldChg chg="add del">
        <pc:chgData name="Tsujimoto,Mitsuhiro 辻本光宏(関東北甲信越統括支店O領域専門室)" userId="7251bc67-91ee-45c9-97e7-9c240c9b485c" providerId="ADAL" clId="{51945A91-CB03-4A52-98BE-5B2D563FE265}" dt="2021-04-22T07:20:35.508" v="4450" actId="2696"/>
        <pc:sldMkLst>
          <pc:docMk/>
          <pc:sldMk cId="3143410321" sldId="505"/>
        </pc:sldMkLst>
      </pc:sldChg>
      <pc:sldChg chg="add del">
        <pc:chgData name="Tsujimoto,Mitsuhiro 辻本光宏(関東北甲信越統括支店O領域専門室)" userId="7251bc67-91ee-45c9-97e7-9c240c9b485c" providerId="ADAL" clId="{51945A91-CB03-4A52-98BE-5B2D563FE265}" dt="2021-04-22T07:20:35.591" v="4453" actId="2696"/>
        <pc:sldMkLst>
          <pc:docMk/>
          <pc:sldMk cId="1032688277" sldId="507"/>
        </pc:sldMkLst>
      </pc:sldChg>
      <pc:sldChg chg="add del">
        <pc:chgData name="Tsujimoto,Mitsuhiro 辻本光宏(関東北甲信越統括支店O領域専門室)" userId="7251bc67-91ee-45c9-97e7-9c240c9b485c" providerId="ADAL" clId="{51945A91-CB03-4A52-98BE-5B2D563FE265}" dt="2021-04-22T07:20:35.275" v="4443" actId="2696"/>
        <pc:sldMkLst>
          <pc:docMk/>
          <pc:sldMk cId="2288056100" sldId="509"/>
        </pc:sldMkLst>
      </pc:sldChg>
      <pc:sldChg chg="add del">
        <pc:chgData name="Tsujimoto,Mitsuhiro 辻本光宏(関東北甲信越統括支店O領域専門室)" userId="7251bc67-91ee-45c9-97e7-9c240c9b485c" providerId="ADAL" clId="{51945A91-CB03-4A52-98BE-5B2D563FE265}" dt="2021-04-22T07:20:35.328" v="4445" actId="2696"/>
        <pc:sldMkLst>
          <pc:docMk/>
          <pc:sldMk cId="2517352159" sldId="510"/>
        </pc:sldMkLst>
      </pc:sldChg>
      <pc:sldChg chg="add del">
        <pc:chgData name="Tsujimoto,Mitsuhiro 辻本光宏(関東北甲信越統括支店O領域専門室)" userId="7251bc67-91ee-45c9-97e7-9c240c9b485c" providerId="ADAL" clId="{51945A91-CB03-4A52-98BE-5B2D563FE265}" dt="2021-04-22T07:20:35.059" v="4435" actId="2696"/>
        <pc:sldMkLst>
          <pc:docMk/>
          <pc:sldMk cId="254271608" sldId="511"/>
        </pc:sldMkLst>
      </pc:sldChg>
      <pc:sldChg chg="add del">
        <pc:chgData name="Tsujimoto,Mitsuhiro 辻本光宏(関東北甲信越統括支店O領域専門室)" userId="7251bc67-91ee-45c9-97e7-9c240c9b485c" providerId="ADAL" clId="{51945A91-CB03-4A52-98BE-5B2D563FE265}" dt="2021-04-22T07:20:35.074" v="4436" actId="2696"/>
        <pc:sldMkLst>
          <pc:docMk/>
          <pc:sldMk cId="131277132" sldId="512"/>
        </pc:sldMkLst>
      </pc:sldChg>
      <pc:sldChg chg="add del">
        <pc:chgData name="Tsujimoto,Mitsuhiro 辻本光宏(関東北甲信越統括支店O領域専門室)" userId="7251bc67-91ee-45c9-97e7-9c240c9b485c" providerId="ADAL" clId="{51945A91-CB03-4A52-98BE-5B2D563FE265}" dt="2021-04-22T07:20:34.753" v="4425" actId="2696"/>
        <pc:sldMkLst>
          <pc:docMk/>
          <pc:sldMk cId="3835529095" sldId="513"/>
        </pc:sldMkLst>
      </pc:sldChg>
      <pc:sldChg chg="add del">
        <pc:chgData name="Tsujimoto,Mitsuhiro 辻本光宏(関東北甲信越統括支店O領域専門室)" userId="7251bc67-91ee-45c9-97e7-9c240c9b485c" providerId="ADAL" clId="{51945A91-CB03-4A52-98BE-5B2D563FE265}" dt="2021-04-22T07:20:34.768" v="4426" actId="2696"/>
        <pc:sldMkLst>
          <pc:docMk/>
          <pc:sldMk cId="1957665408" sldId="514"/>
        </pc:sldMkLst>
      </pc:sldChg>
      <pc:sldChg chg="add del">
        <pc:chgData name="Tsujimoto,Mitsuhiro 辻本光宏(関東北甲信越統括支店O領域専門室)" userId="7251bc67-91ee-45c9-97e7-9c240c9b485c" providerId="ADAL" clId="{51945A91-CB03-4A52-98BE-5B2D563FE265}" dt="2021-04-22T07:20:34.806" v="4428" actId="2696"/>
        <pc:sldMkLst>
          <pc:docMk/>
          <pc:sldMk cId="2496764882" sldId="516"/>
        </pc:sldMkLst>
      </pc:sldChg>
      <pc:sldChg chg="add del">
        <pc:chgData name="Tsujimoto,Mitsuhiro 辻本光宏(関東北甲信越統括支店O領域専門室)" userId="7251bc67-91ee-45c9-97e7-9c240c9b485c" providerId="ADAL" clId="{51945A91-CB03-4A52-98BE-5B2D563FE265}" dt="2021-04-22T07:20:34.721" v="4423" actId="2696"/>
        <pc:sldMkLst>
          <pc:docMk/>
          <pc:sldMk cId="674223372" sldId="520"/>
        </pc:sldMkLst>
      </pc:sldChg>
      <pc:sldChg chg="add del">
        <pc:chgData name="Tsujimoto,Mitsuhiro 辻本光宏(関東北甲信越統括支店O領域専門室)" userId="7251bc67-91ee-45c9-97e7-9c240c9b485c" providerId="ADAL" clId="{51945A91-CB03-4A52-98BE-5B2D563FE265}" dt="2021-04-22T07:20:34.907" v="4431" actId="2696"/>
        <pc:sldMkLst>
          <pc:docMk/>
          <pc:sldMk cId="958801513" sldId="521"/>
        </pc:sldMkLst>
      </pc:sldChg>
      <pc:sldChg chg="add del">
        <pc:chgData name="Tsujimoto,Mitsuhiro 辻本光宏(関東北甲信越統括支店O領域専門室)" userId="7251bc67-91ee-45c9-97e7-9c240c9b485c" providerId="ADAL" clId="{51945A91-CB03-4A52-98BE-5B2D563FE265}" dt="2021-04-22T07:20:34.853" v="4430" actId="2696"/>
        <pc:sldMkLst>
          <pc:docMk/>
          <pc:sldMk cId="1214367737" sldId="522"/>
        </pc:sldMkLst>
      </pc:sldChg>
      <pc:sldChg chg="add del">
        <pc:chgData name="Tsujimoto,Mitsuhiro 辻本光宏(関東北甲信越統括支店O領域専門室)" userId="7251bc67-91ee-45c9-97e7-9c240c9b485c" providerId="ADAL" clId="{51945A91-CB03-4A52-98BE-5B2D563FE265}" dt="2021-04-22T07:20:35.105" v="4437" actId="2696"/>
        <pc:sldMkLst>
          <pc:docMk/>
          <pc:sldMk cId="1336473746" sldId="523"/>
        </pc:sldMkLst>
      </pc:sldChg>
      <pc:sldChg chg="add del">
        <pc:chgData name="Tsujimoto,Mitsuhiro 辻本光宏(関東北甲信越統括支店O領域専門室)" userId="7251bc67-91ee-45c9-97e7-9c240c9b485c" providerId="ADAL" clId="{51945A91-CB03-4A52-98BE-5B2D563FE265}" dt="2021-04-22T07:20:35" v="4433" actId="2696"/>
        <pc:sldMkLst>
          <pc:docMk/>
          <pc:sldMk cId="3631059986" sldId="524"/>
        </pc:sldMkLst>
      </pc:sldChg>
      <pc:sldChg chg="add del">
        <pc:chgData name="Tsujimoto,Mitsuhiro 辻本光宏(関東北甲信越統括支店O領域専門室)" userId="7251bc67-91ee-45c9-97e7-9c240c9b485c" providerId="ADAL" clId="{51945A91-CB03-4A52-98BE-5B2D563FE265}" dt="2021-04-22T07:20:35.128" v="4439" actId="2696"/>
        <pc:sldMkLst>
          <pc:docMk/>
          <pc:sldMk cId="2050514055" sldId="525"/>
        </pc:sldMkLst>
      </pc:sldChg>
      <pc:sldChg chg="modSp add del">
        <pc:chgData name="Tsujimoto,Mitsuhiro 辻本光宏(関東北甲信越統括支店O領域専門室)" userId="7251bc67-91ee-45c9-97e7-9c240c9b485c" providerId="ADAL" clId="{51945A91-CB03-4A52-98BE-5B2D563FE265}" dt="2021-04-22T07:20:35.143" v="4440" actId="2696"/>
        <pc:sldMkLst>
          <pc:docMk/>
          <pc:sldMk cId="2966321085" sldId="526"/>
        </pc:sldMkLst>
        <pc:spChg chg="mod">
          <ac:chgData name="Tsujimoto,Mitsuhiro 辻本光宏(関東北甲信越統括支店O領域専門室)" userId="7251bc67-91ee-45c9-97e7-9c240c9b485c" providerId="ADAL" clId="{51945A91-CB03-4A52-98BE-5B2D563FE265}" dt="2021-04-21T10:24:30.507" v="326" actId="1076"/>
          <ac:spMkLst>
            <pc:docMk/>
            <pc:sldMk cId="2966321085" sldId="526"/>
            <ac:spMk id="11" creationId="{29EF434E-4080-C14A-AA02-587010710176}"/>
          </ac:spMkLst>
        </pc:spChg>
      </pc:sldChg>
      <pc:sldChg chg="add del">
        <pc:chgData name="Tsujimoto,Mitsuhiro 辻本光宏(関東北甲信越統括支店O領域専門室)" userId="7251bc67-91ee-45c9-97e7-9c240c9b485c" providerId="ADAL" clId="{51945A91-CB03-4A52-98BE-5B2D563FE265}" dt="2021-04-22T07:20:35.228" v="4442" actId="2696"/>
        <pc:sldMkLst>
          <pc:docMk/>
          <pc:sldMk cId="587919086" sldId="527"/>
        </pc:sldMkLst>
      </pc:sldChg>
      <pc:sldChg chg="add del">
        <pc:chgData name="Tsujimoto,Mitsuhiro 辻本光宏(関東北甲信越統括支店O領域専門室)" userId="7251bc67-91ee-45c9-97e7-9c240c9b485c" providerId="ADAL" clId="{51945A91-CB03-4A52-98BE-5B2D563FE265}" dt="2021-04-22T07:20:35.174" v="4441" actId="2696"/>
        <pc:sldMkLst>
          <pc:docMk/>
          <pc:sldMk cId="2047390886" sldId="528"/>
        </pc:sldMkLst>
      </pc:sldChg>
      <pc:sldChg chg="add del">
        <pc:chgData name="Tsujimoto,Mitsuhiro 辻本光宏(関東北甲信越統括支店O領域専門室)" userId="7251bc67-91ee-45c9-97e7-9c240c9b485c" providerId="ADAL" clId="{51945A91-CB03-4A52-98BE-5B2D563FE265}" dt="2021-04-22T07:20:35.121" v="4438" actId="2696"/>
        <pc:sldMkLst>
          <pc:docMk/>
          <pc:sldMk cId="818296420" sldId="529"/>
        </pc:sldMkLst>
      </pc:sldChg>
      <pc:sldChg chg="add del">
        <pc:chgData name="Tsujimoto,Mitsuhiro 辻本光宏(関東北甲信越統括支店O領域専門室)" userId="7251bc67-91ee-45c9-97e7-9c240c9b485c" providerId="ADAL" clId="{51945A91-CB03-4A52-98BE-5B2D563FE265}" dt="2021-04-22T07:20:35.429" v="4448" actId="2696"/>
        <pc:sldMkLst>
          <pc:docMk/>
          <pc:sldMk cId="3178920021" sldId="530"/>
        </pc:sldMkLst>
      </pc:sldChg>
      <pc:sldChg chg="add del">
        <pc:chgData name="Tsujimoto,Mitsuhiro 辻本光宏(関東北甲信越統括支店O領域専門室)" userId="7251bc67-91ee-45c9-97e7-9c240c9b485c" providerId="ADAL" clId="{51945A91-CB03-4A52-98BE-5B2D563FE265}" dt="2021-04-22T07:20:35.375" v="4446" actId="2696"/>
        <pc:sldMkLst>
          <pc:docMk/>
          <pc:sldMk cId="1787300794" sldId="531"/>
        </pc:sldMkLst>
      </pc:sldChg>
      <pc:sldChg chg="add del">
        <pc:chgData name="Tsujimoto,Mitsuhiro 辻本光宏(関東北甲信越統括支店O領域専門室)" userId="7251bc67-91ee-45c9-97e7-9c240c9b485c" providerId="ADAL" clId="{51945A91-CB03-4A52-98BE-5B2D563FE265}" dt="2021-04-22T07:20:35.290" v="4444" actId="2696"/>
        <pc:sldMkLst>
          <pc:docMk/>
          <pc:sldMk cId="550659472" sldId="532"/>
        </pc:sldMkLst>
      </pc:sldChg>
      <pc:sldChg chg="add del">
        <pc:chgData name="Tsujimoto,Mitsuhiro 辻本光宏(関東北甲信越統括支店O領域専門室)" userId="7251bc67-91ee-45c9-97e7-9c240c9b485c" providerId="ADAL" clId="{51945A91-CB03-4A52-98BE-5B2D563FE265}" dt="2021-04-22T07:20:35.391" v="4447" actId="2696"/>
        <pc:sldMkLst>
          <pc:docMk/>
          <pc:sldMk cId="1120969691" sldId="533"/>
        </pc:sldMkLst>
      </pc:sldChg>
      <pc:sldChg chg="add del">
        <pc:chgData name="Tsujimoto,Mitsuhiro 辻本光宏(関東北甲信越統括支店O領域専門室)" userId="7251bc67-91ee-45c9-97e7-9c240c9b485c" providerId="ADAL" clId="{51945A91-CB03-4A52-98BE-5B2D563FE265}" dt="2021-04-22T07:20:36.208" v="4475" actId="2696"/>
        <pc:sldMkLst>
          <pc:docMk/>
          <pc:sldMk cId="726751282" sldId="534"/>
        </pc:sldMkLst>
      </pc:sldChg>
      <pc:sldChg chg="add del">
        <pc:chgData name="Tsujimoto,Mitsuhiro 辻本光宏(関東北甲信越統括支店O領域専門室)" userId="7251bc67-91ee-45c9-97e7-9c240c9b485c" providerId="ADAL" clId="{51945A91-CB03-4A52-98BE-5B2D563FE265}" dt="2021-04-22T07:20:34.452" v="4414" actId="2696"/>
        <pc:sldMkLst>
          <pc:docMk/>
          <pc:sldMk cId="1758766697" sldId="536"/>
        </pc:sldMkLst>
      </pc:sldChg>
      <pc:sldChg chg="add del">
        <pc:chgData name="Tsujimoto,Mitsuhiro 辻本光宏(関東北甲信越統括支店O領域専門室)" userId="7251bc67-91ee-45c9-97e7-9c240c9b485c" providerId="ADAL" clId="{51945A91-CB03-4A52-98BE-5B2D563FE265}" dt="2021-04-22T07:20:35.829" v="4458" actId="2696"/>
        <pc:sldMkLst>
          <pc:docMk/>
          <pc:sldMk cId="2151767713" sldId="537"/>
        </pc:sldMkLst>
      </pc:sldChg>
      <pc:sldChg chg="add del">
        <pc:chgData name="Tsujimoto,Mitsuhiro 辻本光宏(関東北甲信越統括支店O領域専門室)" userId="7251bc67-91ee-45c9-97e7-9c240c9b485c" providerId="ADAL" clId="{51945A91-CB03-4A52-98BE-5B2D563FE265}" dt="2021-04-22T07:20:35.861" v="4461" actId="2696"/>
        <pc:sldMkLst>
          <pc:docMk/>
          <pc:sldMk cId="2038561326" sldId="538"/>
        </pc:sldMkLst>
      </pc:sldChg>
      <pc:sldChg chg="add del">
        <pc:chgData name="Tsujimoto,Mitsuhiro 辻本光宏(関東北甲信越統括支店O領域専門室)" userId="7251bc67-91ee-45c9-97e7-9c240c9b485c" providerId="ADAL" clId="{51945A91-CB03-4A52-98BE-5B2D563FE265}" dt="2021-04-22T07:20:35.876" v="4462" actId="2696"/>
        <pc:sldMkLst>
          <pc:docMk/>
          <pc:sldMk cId="2018899798" sldId="539"/>
        </pc:sldMkLst>
      </pc:sldChg>
      <pc:sldChg chg="add del">
        <pc:chgData name="Tsujimoto,Mitsuhiro 辻本光宏(関東北甲信越統括支店O領域専門室)" userId="7251bc67-91ee-45c9-97e7-9c240c9b485c" providerId="ADAL" clId="{51945A91-CB03-4A52-98BE-5B2D563FE265}" dt="2021-04-22T07:20:35.892" v="4463" actId="2696"/>
        <pc:sldMkLst>
          <pc:docMk/>
          <pc:sldMk cId="2569405934" sldId="540"/>
        </pc:sldMkLst>
      </pc:sldChg>
      <pc:sldChg chg="addSp delSp modSp">
        <pc:chgData name="Tsujimoto,Mitsuhiro 辻本光宏(関東北甲信越統括支店O領域専門室)" userId="7251bc67-91ee-45c9-97e7-9c240c9b485c" providerId="ADAL" clId="{51945A91-CB03-4A52-98BE-5B2D563FE265}" dt="2021-04-21T11:23:48.650" v="2263" actId="478"/>
        <pc:sldMkLst>
          <pc:docMk/>
          <pc:sldMk cId="1300297693" sldId="706"/>
        </pc:sldMkLst>
        <pc:spChg chg="add del">
          <ac:chgData name="Tsujimoto,Mitsuhiro 辻本光宏(関東北甲信越統括支店O領域専門室)" userId="7251bc67-91ee-45c9-97e7-9c240c9b485c" providerId="ADAL" clId="{51945A91-CB03-4A52-98BE-5B2D563FE265}" dt="2021-04-21T10:15:17.760" v="137"/>
          <ac:spMkLst>
            <pc:docMk/>
            <pc:sldMk cId="1300297693" sldId="706"/>
            <ac:spMk id="58" creationId="{9FAEF2C1-E858-4029-8106-ACE419629356}"/>
          </ac:spMkLst>
        </pc:spChg>
        <pc:picChg chg="mod">
          <ac:chgData name="Tsujimoto,Mitsuhiro 辻本光宏(関東北甲信越統括支店O領域専門室)" userId="7251bc67-91ee-45c9-97e7-9c240c9b485c" providerId="ADAL" clId="{51945A91-CB03-4A52-98BE-5B2D563FE265}" dt="2021-04-21T11:22:55.160" v="2255" actId="1076"/>
          <ac:picMkLst>
            <pc:docMk/>
            <pc:sldMk cId="1300297693" sldId="706"/>
            <ac:picMk id="115" creationId="{00000000-0000-0000-0000-000000000000}"/>
          </ac:picMkLst>
        </pc:picChg>
        <pc:cxnChg chg="add del mod">
          <ac:chgData name="Tsujimoto,Mitsuhiro 辻本光宏(関東北甲信越統括支店O領域専門室)" userId="7251bc67-91ee-45c9-97e7-9c240c9b485c" providerId="ADAL" clId="{51945A91-CB03-4A52-98BE-5B2D563FE265}" dt="2021-04-21T11:23:48.650" v="2263" actId="478"/>
          <ac:cxnSpMkLst>
            <pc:docMk/>
            <pc:sldMk cId="1300297693" sldId="706"/>
            <ac:cxnSpMk id="9" creationId="{954CCBA0-957C-450A-AA6F-EEE28B1AD585}"/>
          </ac:cxnSpMkLst>
        </pc:cxnChg>
      </pc:sldChg>
      <pc:sldChg chg="modSp">
        <pc:chgData name="Tsujimoto,Mitsuhiro 辻本光宏(関東北甲信越統括支店O領域専門室)" userId="7251bc67-91ee-45c9-97e7-9c240c9b485c" providerId="ADAL" clId="{51945A91-CB03-4A52-98BE-5B2D563FE265}" dt="2021-04-21T10:18:02.250" v="248" actId="2711"/>
        <pc:sldMkLst>
          <pc:docMk/>
          <pc:sldMk cId="2819914708" sldId="721"/>
        </pc:sldMkLst>
        <pc:spChg chg="mod">
          <ac:chgData name="Tsujimoto,Mitsuhiro 辻本光宏(関東北甲信越統括支店O領域専門室)" userId="7251bc67-91ee-45c9-97e7-9c240c9b485c" providerId="ADAL" clId="{51945A91-CB03-4A52-98BE-5B2D563FE265}" dt="2021-04-21T10:18:02.250" v="248" actId="2711"/>
          <ac:spMkLst>
            <pc:docMk/>
            <pc:sldMk cId="2819914708" sldId="721"/>
            <ac:spMk id="7" creationId="{0A646D46-81FB-4482-A207-AF872E985EBB}"/>
          </ac:spMkLst>
        </pc:spChg>
        <pc:spChg chg="mod">
          <ac:chgData name="Tsujimoto,Mitsuhiro 辻本光宏(関東北甲信越統括支店O領域専門室)" userId="7251bc67-91ee-45c9-97e7-9c240c9b485c" providerId="ADAL" clId="{51945A91-CB03-4A52-98BE-5B2D563FE265}" dt="2021-04-21T10:18:02.250" v="248" actId="2711"/>
          <ac:spMkLst>
            <pc:docMk/>
            <pc:sldMk cId="2819914708" sldId="721"/>
            <ac:spMk id="11" creationId="{727D4F42-1518-4C18-8845-EBC98814A89B}"/>
          </ac:spMkLst>
        </pc:spChg>
      </pc:sldChg>
      <pc:sldChg chg="ord">
        <pc:chgData name="Tsujimoto,Mitsuhiro 辻本光宏(関東北甲信越統括支店O領域専門室)" userId="7251bc67-91ee-45c9-97e7-9c240c9b485c" providerId="ADAL" clId="{51945A91-CB03-4A52-98BE-5B2D563FE265}" dt="2021-04-21T10:20:19.547" v="309"/>
        <pc:sldMkLst>
          <pc:docMk/>
          <pc:sldMk cId="749637405" sldId="722"/>
        </pc:sldMkLst>
      </pc:sldChg>
      <pc:sldChg chg="modSp">
        <pc:chgData name="Tsujimoto,Mitsuhiro 辻本光宏(関東北甲信越統括支店O領域専門室)" userId="7251bc67-91ee-45c9-97e7-9c240c9b485c" providerId="ADAL" clId="{51945A91-CB03-4A52-98BE-5B2D563FE265}" dt="2021-04-21T10:22:26.995" v="315" actId="1076"/>
        <pc:sldMkLst>
          <pc:docMk/>
          <pc:sldMk cId="1018968927" sldId="723"/>
        </pc:sldMkLst>
        <pc:spChg chg="mod">
          <ac:chgData name="Tsujimoto,Mitsuhiro 辻本光宏(関東北甲信越統括支店O領域専門室)" userId="7251bc67-91ee-45c9-97e7-9c240c9b485c" providerId="ADAL" clId="{51945A91-CB03-4A52-98BE-5B2D563FE265}" dt="2021-04-21T10:22:26.995" v="315" actId="1076"/>
          <ac:spMkLst>
            <pc:docMk/>
            <pc:sldMk cId="1018968927" sldId="723"/>
            <ac:spMk id="2" creationId="{A68F92E2-AC7A-4059-8FC5-3A5CE4E67461}"/>
          </ac:spMkLst>
        </pc:spChg>
      </pc:sldChg>
      <pc:sldChg chg="ord">
        <pc:chgData name="Tsujimoto,Mitsuhiro 辻本光宏(関東北甲信越統括支店O領域専門室)" userId="7251bc67-91ee-45c9-97e7-9c240c9b485c" providerId="ADAL" clId="{51945A91-CB03-4A52-98BE-5B2D563FE265}" dt="2021-04-21T10:28:28.706" v="517"/>
        <pc:sldMkLst>
          <pc:docMk/>
          <pc:sldMk cId="3302547705" sldId="725"/>
        </pc:sldMkLst>
      </pc:sldChg>
      <pc:sldChg chg="ord">
        <pc:chgData name="Tsujimoto,Mitsuhiro 辻本光宏(関東北甲信越統括支店O領域専門室)" userId="7251bc67-91ee-45c9-97e7-9c240c9b485c" providerId="ADAL" clId="{51945A91-CB03-4A52-98BE-5B2D563FE265}" dt="2021-04-22T01:44:42.102" v="2800"/>
        <pc:sldMkLst>
          <pc:docMk/>
          <pc:sldMk cId="2656621879" sldId="727"/>
        </pc:sldMkLst>
      </pc:sldChg>
      <pc:sldChg chg="ord">
        <pc:chgData name="Tsujimoto,Mitsuhiro 辻本光宏(関東北甲信越統括支店O領域専門室)" userId="7251bc67-91ee-45c9-97e7-9c240c9b485c" providerId="ADAL" clId="{51945A91-CB03-4A52-98BE-5B2D563FE265}" dt="2021-04-22T02:15:51.163" v="4375"/>
        <pc:sldMkLst>
          <pc:docMk/>
          <pc:sldMk cId="198448236" sldId="728"/>
        </pc:sldMkLst>
      </pc:sldChg>
      <pc:sldChg chg="ord">
        <pc:chgData name="Tsujimoto,Mitsuhiro 辻本光宏(関東北甲信越統括支店O領域専門室)" userId="7251bc67-91ee-45c9-97e7-9c240c9b485c" providerId="ADAL" clId="{51945A91-CB03-4A52-98BE-5B2D563FE265}" dt="2021-04-22T11:10:10.947" v="8430"/>
        <pc:sldMkLst>
          <pc:docMk/>
          <pc:sldMk cId="2465407958" sldId="742"/>
        </pc:sldMkLst>
      </pc:sldChg>
      <pc:sldChg chg="ord">
        <pc:chgData name="Tsujimoto,Mitsuhiro 辻本光宏(関東北甲信越統括支店O領域専門室)" userId="7251bc67-91ee-45c9-97e7-9c240c9b485c" providerId="ADAL" clId="{51945A91-CB03-4A52-98BE-5B2D563FE265}" dt="2021-04-23T05:20:36.331" v="13620"/>
        <pc:sldMkLst>
          <pc:docMk/>
          <pc:sldMk cId="618097399" sldId="751"/>
        </pc:sldMkLst>
      </pc:sldChg>
      <pc:sldChg chg="addSp delSp modSp ord">
        <pc:chgData name="Tsujimoto,Mitsuhiro 辻本光宏(関東北甲信越統括支店O領域専門室)" userId="7251bc67-91ee-45c9-97e7-9c240c9b485c" providerId="ADAL" clId="{51945A91-CB03-4A52-98BE-5B2D563FE265}" dt="2021-04-23T01:33:32.168" v="9686"/>
        <pc:sldMkLst>
          <pc:docMk/>
          <pc:sldMk cId="1046730939" sldId="768"/>
        </pc:sldMkLst>
        <pc:picChg chg="add del mod">
          <ac:chgData name="Tsujimoto,Mitsuhiro 辻本光宏(関東北甲信越統括支店O領域専門室)" userId="7251bc67-91ee-45c9-97e7-9c240c9b485c" providerId="ADAL" clId="{51945A91-CB03-4A52-98BE-5B2D563FE265}" dt="2021-04-23T01:21:55.684" v="8975" actId="478"/>
          <ac:picMkLst>
            <pc:docMk/>
            <pc:sldMk cId="1046730939" sldId="768"/>
            <ac:picMk id="7" creationId="{9AA6340C-B998-494B-89A8-B44739CA5CF1}"/>
          </ac:picMkLst>
        </pc:picChg>
      </pc:sldChg>
      <pc:sldChg chg="ord">
        <pc:chgData name="Tsujimoto,Mitsuhiro 辻本光宏(関東北甲信越統括支店O領域専門室)" userId="7251bc67-91ee-45c9-97e7-9c240c9b485c" providerId="ADAL" clId="{51945A91-CB03-4A52-98BE-5B2D563FE265}" dt="2021-04-23T01:33:32.168" v="9686"/>
        <pc:sldMkLst>
          <pc:docMk/>
          <pc:sldMk cId="542936682" sldId="769"/>
        </pc:sldMkLst>
      </pc:sldChg>
      <pc:sldChg chg="ord">
        <pc:chgData name="Tsujimoto,Mitsuhiro 辻本光宏(関東北甲信越統括支店O領域専門室)" userId="7251bc67-91ee-45c9-97e7-9c240c9b485c" providerId="ADAL" clId="{51945A91-CB03-4A52-98BE-5B2D563FE265}" dt="2021-04-23T04:48:40.897" v="11466"/>
        <pc:sldMkLst>
          <pc:docMk/>
          <pc:sldMk cId="2724684597" sldId="771"/>
        </pc:sldMkLst>
      </pc:sldChg>
      <pc:sldChg chg="ord">
        <pc:chgData name="Tsujimoto,Mitsuhiro 辻本光宏(関東北甲信越統括支店O領域専門室)" userId="7251bc67-91ee-45c9-97e7-9c240c9b485c" providerId="ADAL" clId="{51945A91-CB03-4A52-98BE-5B2D563FE265}" dt="2021-04-23T04:58:48.216" v="11810"/>
        <pc:sldMkLst>
          <pc:docMk/>
          <pc:sldMk cId="3523293569" sldId="772"/>
        </pc:sldMkLst>
      </pc:sldChg>
      <pc:sldChg chg="ord">
        <pc:chgData name="Tsujimoto,Mitsuhiro 辻本光宏(関東北甲信越統括支店O領域専門室)" userId="7251bc67-91ee-45c9-97e7-9c240c9b485c" providerId="ADAL" clId="{51945A91-CB03-4A52-98BE-5B2D563FE265}" dt="2021-04-23T05:03:08.807" v="12656"/>
        <pc:sldMkLst>
          <pc:docMk/>
          <pc:sldMk cId="2984594396" sldId="773"/>
        </pc:sldMkLst>
      </pc:sldChg>
      <pc:sldChg chg="ord">
        <pc:chgData name="Tsujimoto,Mitsuhiro 辻本光宏(関東北甲信越統括支店O領域専門室)" userId="7251bc67-91ee-45c9-97e7-9c240c9b485c" providerId="ADAL" clId="{51945A91-CB03-4A52-98BE-5B2D563FE265}" dt="2021-04-23T02:53:03.804" v="11058"/>
        <pc:sldMkLst>
          <pc:docMk/>
          <pc:sldMk cId="736248774" sldId="774"/>
        </pc:sldMkLst>
      </pc:sldChg>
      <pc:sldChg chg="ord">
        <pc:chgData name="Tsujimoto,Mitsuhiro 辻本光宏(関東北甲信越統括支店O領域専門室)" userId="7251bc67-91ee-45c9-97e7-9c240c9b485c" providerId="ADAL" clId="{51945A91-CB03-4A52-98BE-5B2D563FE265}" dt="2021-04-23T04:45:46.201" v="11107"/>
        <pc:sldMkLst>
          <pc:docMk/>
          <pc:sldMk cId="3521530438" sldId="775"/>
        </pc:sldMkLst>
      </pc:sldChg>
      <pc:sldChg chg="ord">
        <pc:chgData name="Tsujimoto,Mitsuhiro 辻本光宏(関東北甲信越統括支店O領域専門室)" userId="7251bc67-91ee-45c9-97e7-9c240c9b485c" providerId="ADAL" clId="{51945A91-CB03-4A52-98BE-5B2D563FE265}" dt="2021-04-23T05:10:09.513" v="13463"/>
        <pc:sldMkLst>
          <pc:docMk/>
          <pc:sldMk cId="3153821987" sldId="776"/>
        </pc:sldMkLst>
      </pc:sldChg>
      <pc:sldChg chg="ord">
        <pc:chgData name="Tsujimoto,Mitsuhiro 辻本光宏(関東北甲信越統括支店O領域専門室)" userId="7251bc67-91ee-45c9-97e7-9c240c9b485c" providerId="ADAL" clId="{51945A91-CB03-4A52-98BE-5B2D563FE265}" dt="2021-04-23T01:37:29.442" v="9873"/>
        <pc:sldMkLst>
          <pc:docMk/>
          <pc:sldMk cId="518700404" sldId="784"/>
        </pc:sldMkLst>
      </pc:sldChg>
      <pc:sldChg chg="ord">
        <pc:chgData name="Tsujimoto,Mitsuhiro 辻本光宏(関東北甲信越統括支店O領域専門室)" userId="7251bc67-91ee-45c9-97e7-9c240c9b485c" providerId="ADAL" clId="{51945A91-CB03-4A52-98BE-5B2D563FE265}" dt="2021-04-23T01:37:31.866" v="9874"/>
        <pc:sldMkLst>
          <pc:docMk/>
          <pc:sldMk cId="350877147" sldId="785"/>
        </pc:sldMkLst>
      </pc:sldChg>
      <pc:sldChg chg="ord">
        <pc:chgData name="Tsujimoto,Mitsuhiro 辻本光宏(関東北甲信越統括支店O領域専門室)" userId="7251bc67-91ee-45c9-97e7-9c240c9b485c" providerId="ADAL" clId="{51945A91-CB03-4A52-98BE-5B2D563FE265}" dt="2021-04-23T01:37:31.866" v="9874"/>
        <pc:sldMkLst>
          <pc:docMk/>
          <pc:sldMk cId="3715807874" sldId="786"/>
        </pc:sldMkLst>
      </pc:sldChg>
      <pc:sldChg chg="ord">
        <pc:chgData name="Tsujimoto,Mitsuhiro 辻本光宏(関東北甲信越統括支店O領域専門室)" userId="7251bc67-91ee-45c9-97e7-9c240c9b485c" providerId="ADAL" clId="{51945A91-CB03-4A52-98BE-5B2D563FE265}" dt="2021-04-23T04:58:48.216" v="11810"/>
        <pc:sldMkLst>
          <pc:docMk/>
          <pc:sldMk cId="1885713338" sldId="787"/>
        </pc:sldMkLst>
      </pc:sldChg>
      <pc:sldChg chg="add del">
        <pc:chgData name="Tsujimoto,Mitsuhiro 辻本光宏(関東北甲信越統括支店O領域専門室)" userId="7251bc67-91ee-45c9-97e7-9c240c9b485c" providerId="ADAL" clId="{51945A91-CB03-4A52-98BE-5B2D563FE265}" dt="2021-04-22T07:20:34.283" v="4407" actId="2696"/>
        <pc:sldMkLst>
          <pc:docMk/>
          <pc:sldMk cId="1822352895" sldId="788"/>
        </pc:sldMkLst>
      </pc:sldChg>
      <pc:sldChg chg="add del">
        <pc:chgData name="Tsujimoto,Mitsuhiro 辻本光宏(関東北甲信越統括支店O領域専門室)" userId="7251bc67-91ee-45c9-97e7-9c240c9b485c" providerId="ADAL" clId="{51945A91-CB03-4A52-98BE-5B2D563FE265}" dt="2021-04-22T07:20:34.784" v="4427" actId="2696"/>
        <pc:sldMkLst>
          <pc:docMk/>
          <pc:sldMk cId="2669715003" sldId="789"/>
        </pc:sldMkLst>
      </pc:sldChg>
      <pc:sldChg chg="add del">
        <pc:chgData name="Tsujimoto,Mitsuhiro 辻本光宏(関東北甲信越統括支店O領域専門室)" userId="7251bc67-91ee-45c9-97e7-9c240c9b485c" providerId="ADAL" clId="{51945A91-CB03-4A52-98BE-5B2D563FE265}" dt="2021-04-22T07:20:34.822" v="4429" actId="2696"/>
        <pc:sldMkLst>
          <pc:docMk/>
          <pc:sldMk cId="4204655298" sldId="790"/>
        </pc:sldMkLst>
      </pc:sldChg>
      <pc:sldChg chg="add del">
        <pc:chgData name="Tsujimoto,Mitsuhiro 辻本光宏(関東北甲信越統括支店O領域専門室)" userId="7251bc67-91ee-45c9-97e7-9c240c9b485c" providerId="ADAL" clId="{51945A91-CB03-4A52-98BE-5B2D563FE265}" dt="2021-04-22T07:20:35.529" v="4451" actId="2696"/>
        <pc:sldMkLst>
          <pc:docMk/>
          <pc:sldMk cId="2905391778" sldId="791"/>
        </pc:sldMkLst>
      </pc:sldChg>
      <pc:sldChg chg="add del">
        <pc:chgData name="Tsujimoto,Mitsuhiro 辻本光宏(関東北甲信越統括支店O領域専門室)" userId="7251bc67-91ee-45c9-97e7-9c240c9b485c" providerId="ADAL" clId="{51945A91-CB03-4A52-98BE-5B2D563FE265}" dt="2021-04-22T07:20:35.560" v="4452" actId="2696"/>
        <pc:sldMkLst>
          <pc:docMk/>
          <pc:sldMk cId="3367058087" sldId="792"/>
        </pc:sldMkLst>
      </pc:sldChg>
      <pc:sldChg chg="add del">
        <pc:chgData name="Tsujimoto,Mitsuhiro 辻本光宏(関東北甲信越統括支店O領域専門室)" userId="7251bc67-91ee-45c9-97e7-9c240c9b485c" providerId="ADAL" clId="{51945A91-CB03-4A52-98BE-5B2D563FE265}" dt="2021-04-22T07:20:35.945" v="4465" actId="2696"/>
        <pc:sldMkLst>
          <pc:docMk/>
          <pc:sldMk cId="2957481215" sldId="793"/>
        </pc:sldMkLst>
      </pc:sldChg>
      <pc:sldChg chg="add del">
        <pc:chgData name="Tsujimoto,Mitsuhiro 辻本光宏(関東北甲信越統括支店O領域専門室)" userId="7251bc67-91ee-45c9-97e7-9c240c9b485c" providerId="ADAL" clId="{51945A91-CB03-4A52-98BE-5B2D563FE265}" dt="2021-04-22T07:20:36.177" v="4474" actId="2696"/>
        <pc:sldMkLst>
          <pc:docMk/>
          <pc:sldMk cId="2470664504" sldId="794"/>
        </pc:sldMkLst>
      </pc:sldChg>
      <pc:sldChg chg="add del">
        <pc:chgData name="Tsujimoto,Mitsuhiro 辻本光宏(関東北甲信越統括支店O領域専門室)" userId="7251bc67-91ee-45c9-97e7-9c240c9b485c" providerId="ADAL" clId="{51945A91-CB03-4A52-98BE-5B2D563FE265}" dt="2021-04-22T07:20:36.246" v="4476" actId="2696"/>
        <pc:sldMkLst>
          <pc:docMk/>
          <pc:sldMk cId="2341054668" sldId="795"/>
        </pc:sldMkLst>
      </pc:sldChg>
      <pc:sldChg chg="addSp delSp modSp add">
        <pc:chgData name="Tsujimoto,Mitsuhiro 辻本光宏(関東北甲信越統括支店O領域専門室)" userId="7251bc67-91ee-45c9-97e7-9c240c9b485c" providerId="ADAL" clId="{51945A91-CB03-4A52-98BE-5B2D563FE265}" dt="2021-04-21T11:29:05.977" v="2388" actId="207"/>
        <pc:sldMkLst>
          <pc:docMk/>
          <pc:sldMk cId="2725878237" sldId="796"/>
        </pc:sldMkLst>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2" creationId="{1A61A88F-B414-41A7-9EC3-2424AF4EF68C}"/>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3" creationId="{2B63F807-0956-4786-ADCF-D27FFA38A925}"/>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 creationId="{2C8C493D-B4CC-401D-993D-6712A2A4CA95}"/>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 creationId="{2A2F6339-817D-4516-B55C-CFE0B7C9EB9D}"/>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13" creationId="{BEC4BB8A-CC16-4380-BA92-BCD34A6735F8}"/>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14" creationId="{AF9B33DC-04CC-4321-AC76-273D80BAA936}"/>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15" creationId="{C005510C-801C-4730-BFF8-667F1011E2A4}"/>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16" creationId="{BFC5AEE8-1F76-420E-B193-F0DED7FD9B65}"/>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17" creationId="{FDF6CBA3-B9C4-4D73-AAA3-1EF2740A38AA}"/>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1" creationId="{DE38A975-D620-498C-968C-2FBB5AE81B17}"/>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2" creationId="{9215FEDF-245D-4E30-AF8B-6223A8647DA0}"/>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3" creationId="{BD386486-88BC-42AC-8917-BC10452BDB08}"/>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6" creationId="{79725E05-5753-452E-BF83-764922A459E2}"/>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7" creationId="{344F46BA-1238-4265-853D-85095B6597BD}"/>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8" creationId="{1B196F1E-59A2-4F71-941F-702EF2DFAFD0}"/>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49" creationId="{E2E37EE0-C5F6-4B64-BCC5-7692BA1489B3}"/>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2" creationId="{F4C8F3F6-2E26-41A7-8731-DAE912139052}"/>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3" creationId="{D6998981-46B8-462F-A324-46339251EDD7}"/>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4" creationId="{C30782FD-9341-45D5-BDD9-F09592CA3CA7}"/>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5" creationId="{4A8D2D0B-5694-46C9-975A-A0EB57629F7F}"/>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6" creationId="{0637FB9E-7814-41FB-970F-24A52A482471}"/>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7" creationId="{9C6E3879-0480-4749-AED2-12FFEC94244D}"/>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8" creationId="{4645A88D-DEA0-410D-8270-A2D6F00D23C6}"/>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59" creationId="{A962BBB7-E95A-4F6B-A074-5ECB00FBDFDD}"/>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0" creationId="{430C31AE-37AB-409D-AF81-9A1B8991C79A}"/>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1" creationId="{FDF60489-2C96-4FA3-8FA5-36F57708339D}"/>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2" creationId="{9F7C5605-D9D6-4A33-A0DB-8C7409502538}"/>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3" creationId="{59D8AABE-C40D-41BA-9607-4A2CD510A0CE}"/>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4" creationId="{B702B8FC-B0F8-4D86-B054-E8D13A681A51}"/>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5" creationId="{5FEE3FCB-7DC4-4503-8677-2A6ECECCDA50}"/>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6" creationId="{F872DB57-21BE-4660-B6D0-0EE9E7437050}"/>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7" creationId="{1D2948D7-828D-45F7-951A-8524301DE8FE}"/>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8" creationId="{614CCB04-05F6-4862-98A3-2710177E78B9}"/>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69" creationId="{524F3D67-51F7-4EFB-94C3-BA70776F1D94}"/>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70" creationId="{95D2C611-980F-45FB-B5B9-6CD1646858F0}"/>
          </ac:spMkLst>
        </pc:spChg>
        <pc:spChg chg="add del">
          <ac:chgData name="Tsujimoto,Mitsuhiro 辻本光宏(関東北甲信越統括支店O領域専門室)" userId="7251bc67-91ee-45c9-97e7-9c240c9b485c" providerId="ADAL" clId="{51945A91-CB03-4A52-98BE-5B2D563FE265}" dt="2021-04-21T10:13:55.552" v="8"/>
          <ac:spMkLst>
            <pc:docMk/>
            <pc:sldMk cId="2725878237" sldId="796"/>
            <ac:spMk id="71" creationId="{1591FA36-900E-4986-B314-6E4D05267AFA}"/>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73" creationId="{70B1CC68-CE07-4E7D-89D5-93F45339BEFE}"/>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74" creationId="{02B90DFC-DFE5-46F5-B45F-CE22A1E390BB}"/>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75" creationId="{2BA985C0-4E60-48D5-A934-C37E55789EC3}"/>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76" creationId="{E3EEBFB4-A965-42D4-B4CC-D7F096284696}"/>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84" creationId="{26405D5D-46C5-4C14-9BA0-A599EE60EEEB}"/>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85" creationId="{6B89B4EE-1E16-42D3-B1F1-F78EEC1D40EA}"/>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86" creationId="{67049869-83B6-443E-88EC-B4A96E637D1B}"/>
          </ac:spMkLst>
        </pc:spChg>
        <pc:spChg chg="add mod">
          <ac:chgData name="Tsujimoto,Mitsuhiro 辻本光宏(関東北甲信越統括支店O領域専門室)" userId="7251bc67-91ee-45c9-97e7-9c240c9b485c" providerId="ADAL" clId="{51945A91-CB03-4A52-98BE-5B2D563FE265}" dt="2021-04-21T10:14:04.903" v="10" actId="1076"/>
          <ac:spMkLst>
            <pc:docMk/>
            <pc:sldMk cId="2725878237" sldId="796"/>
            <ac:spMk id="87" creationId="{5CAAF54B-82DE-4EB8-AE83-15B4502CC953}"/>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88" creationId="{523CF6EE-C22F-499F-9F43-9DEDF4B617C3}"/>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12" creationId="{A5F8BB9C-8AC9-48E2-AEB6-C3C81965F98E}"/>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13" creationId="{61F802B2-1390-4718-821A-BF0EE5C5F25D}"/>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14" creationId="{EF82A13E-2428-4FE6-A43B-62CC396D10FC}"/>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17" creationId="{4BD0A505-7866-4A6A-A9DA-7EB57A45B64A}"/>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18" creationId="{1B0295D9-CD91-4EF8-90D0-F550BB0CB480}"/>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19" creationId="{C8A77106-D8C9-4908-A049-85E8C92CA53E}"/>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0" creationId="{4A33A1CE-B3C1-4A80-99E0-2DD5A1473394}"/>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3" creationId="{676487AB-7F6A-4134-9010-A0D017E33837}"/>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4" creationId="{2CCFA619-B74F-44E4-AE27-7719D863DE7F}"/>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5" creationId="{6B6BB6E8-5075-468B-9BE0-3AE0B8C27B8E}"/>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6" creationId="{351E124A-8B0D-44F4-9A12-C906E0D69389}"/>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7" creationId="{84F62BBE-D9A5-4EE2-A976-E05DF624EE24}"/>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8" creationId="{40869825-753D-41B4-9595-AAA4715F9BAD}"/>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29" creationId="{D9772FDA-4B45-4828-8F83-7967D915ED56}"/>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0" creationId="{CC87D7D0-5E88-4DC1-B61F-6C5B693B3DFB}"/>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1" creationId="{1C613188-1839-424E-8CB8-8403C866C296}"/>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2" creationId="{F4C956C9-CDC0-4889-8B5F-3BA2B2AF3A2D}"/>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3" creationId="{939A8785-A109-4762-B2C8-D582069A5B35}"/>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4" creationId="{8D111D3A-AB34-41D9-BBFD-47AB8621F065}"/>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5" creationId="{DE567394-6511-476F-B52F-A26EC32AFF9B}"/>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6" creationId="{F069B273-F81E-4BB0-8059-390893C5D11F}"/>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7" creationId="{A2293F27-B5BE-4E77-B381-BBE5DC2A2407}"/>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8" creationId="{820C1EDB-CC99-49CB-B3C4-838B82CBFF0E}"/>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39" creationId="{31974CCA-2203-4CBE-9735-632B979C1BF7}"/>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40" creationId="{8B498A17-573D-4EC3-B679-28A12FCCD6D0}"/>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41" creationId="{43B25EDE-29CA-4455-ABBD-939DAAD36E49}"/>
          </ac:spMkLst>
        </pc:spChg>
        <pc:spChg chg="add">
          <ac:chgData name="Tsujimoto,Mitsuhiro 辻本光宏(関東北甲信越統括支店O領域専門室)" userId="7251bc67-91ee-45c9-97e7-9c240c9b485c" providerId="ADAL" clId="{51945A91-CB03-4A52-98BE-5B2D563FE265}" dt="2021-04-21T10:13:55.583" v="9"/>
          <ac:spMkLst>
            <pc:docMk/>
            <pc:sldMk cId="2725878237" sldId="796"/>
            <ac:spMk id="142" creationId="{6EC7FE27-E0A4-424B-84D7-020EB3F9E4CB}"/>
          </ac:spMkLst>
        </pc:spChg>
        <pc:spChg chg="add mod">
          <ac:chgData name="Tsujimoto,Mitsuhiro 辻本光宏(関東北甲信越統括支店O領域専門室)" userId="7251bc67-91ee-45c9-97e7-9c240c9b485c" providerId="ADAL" clId="{51945A91-CB03-4A52-98BE-5B2D563FE265}" dt="2021-04-21T11:29:05.977" v="2388" actId="207"/>
          <ac:spMkLst>
            <pc:docMk/>
            <pc:sldMk cId="2725878237" sldId="796"/>
            <ac:spMk id="144" creationId="{CAF3DDEA-B41B-4DC4-9090-3A76A6265505}"/>
          </ac:spMkLst>
        </pc:spChg>
        <pc:spChg chg="add del mod">
          <ac:chgData name="Tsujimoto,Mitsuhiro 辻本光宏(関東北甲信越統括支店O領域専門室)" userId="7251bc67-91ee-45c9-97e7-9c240c9b485c" providerId="ADAL" clId="{51945A91-CB03-4A52-98BE-5B2D563FE265}" dt="2021-04-21T10:14:57.714" v="132" actId="478"/>
          <ac:spMkLst>
            <pc:docMk/>
            <pc:sldMk cId="2725878237" sldId="796"/>
            <ac:spMk id="145" creationId="{B944435E-CC81-4D1B-B224-3523D9BACAD2}"/>
          </ac:spMkLst>
        </pc:spChg>
        <pc:grpChg chg="add del">
          <ac:chgData name="Tsujimoto,Mitsuhiro 辻本光宏(関東北甲信越統括支店O領域専門室)" userId="7251bc67-91ee-45c9-97e7-9c240c9b485c" providerId="ADAL" clId="{51945A91-CB03-4A52-98BE-5B2D563FE265}" dt="2021-04-21T10:13:55.552" v="8"/>
          <ac:grpSpMkLst>
            <pc:docMk/>
            <pc:sldMk cId="2725878237" sldId="796"/>
            <ac:grpSpMk id="6" creationId="{0CA552C4-DB5F-479A-A89E-9EC2F8DBA433}"/>
          </ac:grpSpMkLst>
        </pc:grpChg>
        <pc:grpChg chg="add del">
          <ac:chgData name="Tsujimoto,Mitsuhiro 辻本光宏(関東北甲信越統括支店O領域専門室)" userId="7251bc67-91ee-45c9-97e7-9c240c9b485c" providerId="ADAL" clId="{51945A91-CB03-4A52-98BE-5B2D563FE265}" dt="2021-04-21T10:13:55.552" v="8"/>
          <ac:grpSpMkLst>
            <pc:docMk/>
            <pc:sldMk cId="2725878237" sldId="796"/>
            <ac:grpSpMk id="10" creationId="{461D80C1-08F6-4E2A-BE97-97A87530114E}"/>
          </ac:grpSpMkLst>
        </pc:grpChg>
        <pc:grpChg chg="add del">
          <ac:chgData name="Tsujimoto,Mitsuhiro 辻本光宏(関東北甲信越統括支店O領域専門室)" userId="7251bc67-91ee-45c9-97e7-9c240c9b485c" providerId="ADAL" clId="{51945A91-CB03-4A52-98BE-5B2D563FE265}" dt="2021-04-21T10:13:55.552" v="8"/>
          <ac:grpSpMkLst>
            <pc:docMk/>
            <pc:sldMk cId="2725878237" sldId="796"/>
            <ac:grpSpMk id="18" creationId="{3293083E-6F73-417C-8702-D99330966F52}"/>
          </ac:grpSpMkLst>
        </pc:grpChg>
        <pc:grpChg chg="add del">
          <ac:chgData name="Tsujimoto,Mitsuhiro 辻本光宏(関東北甲信越統括支店O領域専門室)" userId="7251bc67-91ee-45c9-97e7-9c240c9b485c" providerId="ADAL" clId="{51945A91-CB03-4A52-98BE-5B2D563FE265}" dt="2021-04-21T10:13:55.552" v="8"/>
          <ac:grpSpMkLst>
            <pc:docMk/>
            <pc:sldMk cId="2725878237" sldId="796"/>
            <ac:grpSpMk id="23" creationId="{052F5A08-2936-48D3-B6BE-DF93B43C3695}"/>
          </ac:grpSpMkLst>
        </pc:grpChg>
        <pc:grpChg chg="add del">
          <ac:chgData name="Tsujimoto,Mitsuhiro 辻本光宏(関東北甲信越統括支店O領域専門室)" userId="7251bc67-91ee-45c9-97e7-9c240c9b485c" providerId="ADAL" clId="{51945A91-CB03-4A52-98BE-5B2D563FE265}" dt="2021-04-21T10:13:55.552" v="8"/>
          <ac:grpSpMkLst>
            <pc:docMk/>
            <pc:sldMk cId="2725878237" sldId="796"/>
            <ac:grpSpMk id="30" creationId="{6C08F613-E75D-4C1D-A09F-2932205B31F8}"/>
          </ac:grpSpMkLst>
        </pc:grpChg>
        <pc:grpChg chg="add del">
          <ac:chgData name="Tsujimoto,Mitsuhiro 辻本光宏(関東北甲信越統括支店O領域専門室)" userId="7251bc67-91ee-45c9-97e7-9c240c9b485c" providerId="ADAL" clId="{51945A91-CB03-4A52-98BE-5B2D563FE265}" dt="2021-04-21T10:13:55.552" v="8"/>
          <ac:grpSpMkLst>
            <pc:docMk/>
            <pc:sldMk cId="2725878237" sldId="796"/>
            <ac:grpSpMk id="36" creationId="{7D0A05D2-D533-41CE-8AF5-4ED0DF8D5375}"/>
          </ac:grpSpMkLst>
        </pc:grpChg>
        <pc:grpChg chg="add">
          <ac:chgData name="Tsujimoto,Mitsuhiro 辻本光宏(関東北甲信越統括支店O領域専門室)" userId="7251bc67-91ee-45c9-97e7-9c240c9b485c" providerId="ADAL" clId="{51945A91-CB03-4A52-98BE-5B2D563FE265}" dt="2021-04-21T10:13:55.583" v="9"/>
          <ac:grpSpMkLst>
            <pc:docMk/>
            <pc:sldMk cId="2725878237" sldId="796"/>
            <ac:grpSpMk id="77" creationId="{C38B05D3-EF23-4195-92F2-D7F55DC1F4BA}"/>
          </ac:grpSpMkLst>
        </pc:grpChg>
        <pc:grpChg chg="add">
          <ac:chgData name="Tsujimoto,Mitsuhiro 辻本光宏(関東北甲信越統括支店O領域専門室)" userId="7251bc67-91ee-45c9-97e7-9c240c9b485c" providerId="ADAL" clId="{51945A91-CB03-4A52-98BE-5B2D563FE265}" dt="2021-04-21T10:13:55.583" v="9"/>
          <ac:grpSpMkLst>
            <pc:docMk/>
            <pc:sldMk cId="2725878237" sldId="796"/>
            <ac:grpSpMk id="81" creationId="{986EB27E-C932-484C-9420-3FC69986177E}"/>
          </ac:grpSpMkLst>
        </pc:grpChg>
        <pc:grpChg chg="add">
          <ac:chgData name="Tsujimoto,Mitsuhiro 辻本光宏(関東北甲信越統括支店O領域専門室)" userId="7251bc67-91ee-45c9-97e7-9c240c9b485c" providerId="ADAL" clId="{51945A91-CB03-4A52-98BE-5B2D563FE265}" dt="2021-04-21T10:13:55.583" v="9"/>
          <ac:grpSpMkLst>
            <pc:docMk/>
            <pc:sldMk cId="2725878237" sldId="796"/>
            <ac:grpSpMk id="89" creationId="{8C313CEE-ABB9-4979-8B60-2D2ABF37D6F3}"/>
          </ac:grpSpMkLst>
        </pc:grpChg>
        <pc:grpChg chg="add">
          <ac:chgData name="Tsujimoto,Mitsuhiro 辻本光宏(関東北甲信越統括支店O領域専門室)" userId="7251bc67-91ee-45c9-97e7-9c240c9b485c" providerId="ADAL" clId="{51945A91-CB03-4A52-98BE-5B2D563FE265}" dt="2021-04-21T10:13:55.583" v="9"/>
          <ac:grpSpMkLst>
            <pc:docMk/>
            <pc:sldMk cId="2725878237" sldId="796"/>
            <ac:grpSpMk id="94" creationId="{10E70256-8920-443D-B863-00B2EEA779D9}"/>
          </ac:grpSpMkLst>
        </pc:grpChg>
        <pc:grpChg chg="add">
          <ac:chgData name="Tsujimoto,Mitsuhiro 辻本光宏(関東北甲信越統括支店O領域専門室)" userId="7251bc67-91ee-45c9-97e7-9c240c9b485c" providerId="ADAL" clId="{51945A91-CB03-4A52-98BE-5B2D563FE265}" dt="2021-04-21T10:13:55.583" v="9"/>
          <ac:grpSpMkLst>
            <pc:docMk/>
            <pc:sldMk cId="2725878237" sldId="796"/>
            <ac:grpSpMk id="101" creationId="{FC44D9E0-E4E5-4A17-8E83-4E2F8BC60409}"/>
          </ac:grpSpMkLst>
        </pc:grpChg>
        <pc:grpChg chg="add">
          <ac:chgData name="Tsujimoto,Mitsuhiro 辻本光宏(関東北甲信越統括支店O領域専門室)" userId="7251bc67-91ee-45c9-97e7-9c240c9b485c" providerId="ADAL" clId="{51945A91-CB03-4A52-98BE-5B2D563FE265}" dt="2021-04-21T10:13:55.583" v="9"/>
          <ac:grpSpMkLst>
            <pc:docMk/>
            <pc:sldMk cId="2725878237" sldId="796"/>
            <ac:grpSpMk id="107" creationId="{BC99C4F2-8CC4-4643-9A52-05127B73CD41}"/>
          </ac:grpSpMkLst>
        </pc:grpChg>
        <pc:cxnChg chg="add del">
          <ac:chgData name="Tsujimoto,Mitsuhiro 辻本光宏(関東北甲信越統括支店O領域専門室)" userId="7251bc67-91ee-45c9-97e7-9c240c9b485c" providerId="ADAL" clId="{51945A91-CB03-4A52-98BE-5B2D563FE265}" dt="2021-04-21T10:13:55.552" v="8"/>
          <ac:cxnSpMkLst>
            <pc:docMk/>
            <pc:sldMk cId="2725878237" sldId="796"/>
            <ac:cxnSpMk id="44" creationId="{479988BD-6F0E-459B-9ABE-C0FFF5BDB17A}"/>
          </ac:cxnSpMkLst>
        </pc:cxnChg>
        <pc:cxnChg chg="add del">
          <ac:chgData name="Tsujimoto,Mitsuhiro 辻本光宏(関東北甲信越統括支店O領域専門室)" userId="7251bc67-91ee-45c9-97e7-9c240c9b485c" providerId="ADAL" clId="{51945A91-CB03-4A52-98BE-5B2D563FE265}" dt="2021-04-21T10:13:55.552" v="8"/>
          <ac:cxnSpMkLst>
            <pc:docMk/>
            <pc:sldMk cId="2725878237" sldId="796"/>
            <ac:cxnSpMk id="45" creationId="{816647B4-7793-4281-AFC2-2BE0CBE416E4}"/>
          </ac:cxnSpMkLst>
        </pc:cxnChg>
        <pc:cxnChg chg="add del">
          <ac:chgData name="Tsujimoto,Mitsuhiro 辻本光宏(関東北甲信越統括支店O領域専門室)" userId="7251bc67-91ee-45c9-97e7-9c240c9b485c" providerId="ADAL" clId="{51945A91-CB03-4A52-98BE-5B2D563FE265}" dt="2021-04-21T10:13:55.552" v="8"/>
          <ac:cxnSpMkLst>
            <pc:docMk/>
            <pc:sldMk cId="2725878237" sldId="796"/>
            <ac:cxnSpMk id="50" creationId="{C7180D8A-0F24-4BF8-9BF6-B1C3F31B933B}"/>
          </ac:cxnSpMkLst>
        </pc:cxnChg>
        <pc:cxnChg chg="add del">
          <ac:chgData name="Tsujimoto,Mitsuhiro 辻本光宏(関東北甲信越統括支店O領域専門室)" userId="7251bc67-91ee-45c9-97e7-9c240c9b485c" providerId="ADAL" clId="{51945A91-CB03-4A52-98BE-5B2D563FE265}" dt="2021-04-21T10:13:55.552" v="8"/>
          <ac:cxnSpMkLst>
            <pc:docMk/>
            <pc:sldMk cId="2725878237" sldId="796"/>
            <ac:cxnSpMk id="51" creationId="{6044E055-7402-4FD7-80CC-D04F76C3C597}"/>
          </ac:cxnSpMkLst>
        </pc:cxnChg>
        <pc:cxnChg chg="add del">
          <ac:chgData name="Tsujimoto,Mitsuhiro 辻本光宏(関東北甲信越統括支店O領域専門室)" userId="7251bc67-91ee-45c9-97e7-9c240c9b485c" providerId="ADAL" clId="{51945A91-CB03-4A52-98BE-5B2D563FE265}" dt="2021-04-21T10:13:55.552" v="8"/>
          <ac:cxnSpMkLst>
            <pc:docMk/>
            <pc:sldMk cId="2725878237" sldId="796"/>
            <ac:cxnSpMk id="72" creationId="{CF6430E3-03A9-4E83-B905-AC060803EE90}"/>
          </ac:cxnSpMkLst>
        </pc:cxnChg>
        <pc:cxnChg chg="add">
          <ac:chgData name="Tsujimoto,Mitsuhiro 辻本光宏(関東北甲信越統括支店O領域専門室)" userId="7251bc67-91ee-45c9-97e7-9c240c9b485c" providerId="ADAL" clId="{51945A91-CB03-4A52-98BE-5B2D563FE265}" dt="2021-04-21T10:13:55.583" v="9"/>
          <ac:cxnSpMkLst>
            <pc:docMk/>
            <pc:sldMk cId="2725878237" sldId="796"/>
            <ac:cxnSpMk id="115" creationId="{40121342-948D-4C20-9AE8-1E4A29351847}"/>
          </ac:cxnSpMkLst>
        </pc:cxnChg>
        <pc:cxnChg chg="add">
          <ac:chgData name="Tsujimoto,Mitsuhiro 辻本光宏(関東北甲信越統括支店O領域専門室)" userId="7251bc67-91ee-45c9-97e7-9c240c9b485c" providerId="ADAL" clId="{51945A91-CB03-4A52-98BE-5B2D563FE265}" dt="2021-04-21T10:13:55.583" v="9"/>
          <ac:cxnSpMkLst>
            <pc:docMk/>
            <pc:sldMk cId="2725878237" sldId="796"/>
            <ac:cxnSpMk id="116" creationId="{FC7DD19A-D111-4761-8E2B-E68F219DF25A}"/>
          </ac:cxnSpMkLst>
        </pc:cxnChg>
        <pc:cxnChg chg="add">
          <ac:chgData name="Tsujimoto,Mitsuhiro 辻本光宏(関東北甲信越統括支店O領域専門室)" userId="7251bc67-91ee-45c9-97e7-9c240c9b485c" providerId="ADAL" clId="{51945A91-CB03-4A52-98BE-5B2D563FE265}" dt="2021-04-21T10:13:55.583" v="9"/>
          <ac:cxnSpMkLst>
            <pc:docMk/>
            <pc:sldMk cId="2725878237" sldId="796"/>
            <ac:cxnSpMk id="121" creationId="{9F3CA624-E278-4F0D-9A89-2DCA6C8CCE12}"/>
          </ac:cxnSpMkLst>
        </pc:cxnChg>
        <pc:cxnChg chg="add">
          <ac:chgData name="Tsujimoto,Mitsuhiro 辻本光宏(関東北甲信越統括支店O領域専門室)" userId="7251bc67-91ee-45c9-97e7-9c240c9b485c" providerId="ADAL" clId="{51945A91-CB03-4A52-98BE-5B2D563FE265}" dt="2021-04-21T10:13:55.583" v="9"/>
          <ac:cxnSpMkLst>
            <pc:docMk/>
            <pc:sldMk cId="2725878237" sldId="796"/>
            <ac:cxnSpMk id="122" creationId="{F258B407-2575-4114-8FD9-948CD692780D}"/>
          </ac:cxnSpMkLst>
        </pc:cxnChg>
        <pc:cxnChg chg="add del">
          <ac:chgData name="Tsujimoto,Mitsuhiro 辻本光宏(関東北甲信越統括支店O領域専門室)" userId="7251bc67-91ee-45c9-97e7-9c240c9b485c" providerId="ADAL" clId="{51945A91-CB03-4A52-98BE-5B2D563FE265}" dt="2021-04-21T10:14:08.711" v="11" actId="478"/>
          <ac:cxnSpMkLst>
            <pc:docMk/>
            <pc:sldMk cId="2725878237" sldId="796"/>
            <ac:cxnSpMk id="143" creationId="{53DECB00-EA42-4C6F-89A6-2EF5835459CB}"/>
          </ac:cxnSpMkLst>
        </pc:cxnChg>
      </pc:sldChg>
      <pc:sldChg chg="addSp delSp modSp add ord">
        <pc:chgData name="Tsujimoto,Mitsuhiro 辻本光宏(関東北甲信越統括支店O領域専門室)" userId="7251bc67-91ee-45c9-97e7-9c240c9b485c" providerId="ADAL" clId="{51945A91-CB03-4A52-98BE-5B2D563FE265}" dt="2021-04-21T11:29:00.996" v="2387" actId="207"/>
        <pc:sldMkLst>
          <pc:docMk/>
          <pc:sldMk cId="3037864581" sldId="797"/>
        </pc:sldMkLst>
        <pc:spChg chg="add mod">
          <ac:chgData name="Tsujimoto,Mitsuhiro 辻本光宏(関東北甲信越統括支店O領域専門室)" userId="7251bc67-91ee-45c9-97e7-9c240c9b485c" providerId="ADAL" clId="{51945A91-CB03-4A52-98BE-5B2D563FE265}" dt="2021-04-21T11:29:00.996" v="2387" actId="207"/>
          <ac:spMkLst>
            <pc:docMk/>
            <pc:sldMk cId="3037864581" sldId="797"/>
            <ac:spMk id="2" creationId="{FB1200E0-B5A2-4255-A16B-754D5D96F99F}"/>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0" creationId="{88856E9A-24BB-4D68-80E9-A475257352E9}"/>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1" creationId="{EFF247EC-57B4-4151-8DE7-5839263955EC}"/>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2" creationId="{D6174A68-8913-469D-8E41-DD8142705758}"/>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3" creationId="{CC8466A2-848F-4063-B1CB-29633AED8D4C}"/>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4" creationId="{1F4F3CA9-0DD8-4E74-98DC-ABF48D1F8644}"/>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5" creationId="{E401A38E-97D2-4E58-BFC9-1891976FDAE7}"/>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6" creationId="{C1B3CEE3-D608-4769-B3E3-5B29C8098999}"/>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7" creationId="{65FAFB38-8822-4F76-8F80-50CC6632D025}"/>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8" creationId="{656458CC-CE44-4781-B589-6CC7638510CB}"/>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29" creationId="{7C83ECC7-9B10-4878-AB45-5B0695F0B7EB}"/>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30" creationId="{ED081CEA-64B6-4368-AE2D-6202FCA3CE29}"/>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31" creationId="{F66296E4-1C4B-48A3-8742-0A86DA598C4C}"/>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33" creationId="{1ED9A583-9E24-44C8-98A2-EAEC5EA55FF4}"/>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35" creationId="{3CA64032-4F6B-42AD-84F5-4CE20AA57593}"/>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37" creationId="{8FAEE000-8BC2-4A9C-A7AA-3D4F22382640}"/>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39" creationId="{2DFB8D38-7C99-4DCA-9226-9A7009D33605}"/>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41" creationId="{FE4822DF-7C22-4360-B666-4074DB6A0BBB}"/>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43" creationId="{33E3BCC0-D562-47F9-ADF7-8591D19BE0D2}"/>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46" creationId="{6432B6E8-EF92-4E3A-AFE0-E32468012795}"/>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47" creationId="{225D5065-7FB7-408A-AAC9-80C7318B4501}"/>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50" creationId="{B8CF4BA8-5B6B-4E0D-945B-C3E9D0B5552E}"/>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51" creationId="{1D68DAE1-CE37-453B-9165-AF8409CB56CC}"/>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52" creationId="{366FB203-D68B-4E20-A1F7-20BEA663B1A8}"/>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53" creationId="{C469B729-52BE-4E8A-97A3-422B0325C6F2}"/>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54" creationId="{9B780543-B4CB-4E17-AA85-6039883B9F70}"/>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55" creationId="{76F93AE7-C670-43C9-B7DA-B02F059D9B8C}"/>
          </ac:spMkLst>
        </pc:spChg>
        <pc:spChg chg="add del">
          <ac:chgData name="Tsujimoto,Mitsuhiro 辻本光宏(関東北甲信越統括支店O領域専門室)" userId="7251bc67-91ee-45c9-97e7-9c240c9b485c" providerId="ADAL" clId="{51945A91-CB03-4A52-98BE-5B2D563FE265}" dt="2021-04-21T10:15:35.299" v="177"/>
          <ac:spMkLst>
            <pc:docMk/>
            <pc:sldMk cId="3037864581" sldId="797"/>
            <ac:spMk id="56" creationId="{3AC5405A-8284-4141-AD7C-5B00131C93A7}"/>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74" creationId="{9CA65BC9-3EAA-4D79-95EF-23E5375F243B}"/>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75" creationId="{617CC609-2BA0-4C34-8F0D-75ECCF49F6CB}"/>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76" creationId="{B5274A37-7CD8-416A-9E24-FD51C9B66263}"/>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77" creationId="{5411F574-A9D8-40F5-A5DB-CED35D0DE96C}"/>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78" creationId="{59B50107-C5A7-418B-8029-603EFC7C0651}"/>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79" creationId="{9700FE59-547A-4ACF-9EA0-7896FFA20E7B}"/>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0" creationId="{67CA65A3-B1D0-416A-80BE-1B9158567D25}"/>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1" creationId="{6F34F360-7C9E-4313-89F5-207F2EBCBBE9}"/>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2" creationId="{CA768770-1B97-4186-A1CE-F7D3114164F0}"/>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3" creationId="{40BB44A5-0A07-4190-AA50-152DEEB11107}"/>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4" creationId="{8936716E-6258-4BAA-8C1B-5886BF6033F9}"/>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5" creationId="{69F2F1F2-A86F-4763-8DCE-19F22AF38E5D}"/>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7" creationId="{3A133534-90FA-4770-A67B-B64F0EBEAF2D}"/>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89" creationId="{2302319E-7F2F-4C24-9BE2-300F176179AC}"/>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91" creationId="{9692C3BC-B222-447D-81EE-4B424DC577E7}"/>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93" creationId="{7B789943-7633-4192-8602-B24BDA21ECEE}"/>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95" creationId="{C9FF6ACC-A094-4B1D-A5F4-10B623702626}"/>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97" creationId="{A0EA4355-C7D4-4C2E-8B8B-E6E151642AF2}"/>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0" creationId="{179F9876-985F-4F86-AD01-CE8E2F62BD96}"/>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1" creationId="{CB5CC653-CE33-4FE9-9891-A833D72B4C7E}"/>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4" creationId="{85A9B30D-5551-49E7-A0FA-15BCB6155FA9}"/>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5" creationId="{2C880CF6-6D8F-4B12-9A64-C4855B00BAF6}"/>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6" creationId="{80BABA15-A17B-40C8-B684-70B05EDF3B63}"/>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7" creationId="{CCD90ED2-377B-4FB3-8931-7EA7E4E6AB44}"/>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8" creationId="{0F3DD22F-0AA3-4E7F-A9AB-EEEE366F6F25}"/>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09" creationId="{FF0435EF-F49E-4842-A866-8B4964DABBDA}"/>
          </ac:spMkLst>
        </pc:spChg>
        <pc:spChg chg="add del">
          <ac:chgData name="Tsujimoto,Mitsuhiro 辻本光宏(関東北甲信越統括支店O領域専門室)" userId="7251bc67-91ee-45c9-97e7-9c240c9b485c" providerId="ADAL" clId="{51945A91-CB03-4A52-98BE-5B2D563FE265}" dt="2021-04-21T10:15:38.242" v="179"/>
          <ac:spMkLst>
            <pc:docMk/>
            <pc:sldMk cId="3037864581" sldId="797"/>
            <ac:spMk id="110" creationId="{E35329FD-8896-494A-BDC7-98FA76C460B4}"/>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28" creationId="{9164C81A-6F6D-405F-86EA-1F128110EB1F}"/>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29" creationId="{D67547DD-D348-4D84-BE58-D4ECA41C5EDA}"/>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0" creationId="{9AE5AA71-9BD6-432D-94FB-E0B105733E11}"/>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1" creationId="{9EEFBB2C-511C-4E42-B4F6-E4AF8B3C1BA3}"/>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2" creationId="{9142BFCC-DC6E-45EF-AD92-192C72277B85}"/>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3" creationId="{8CFCC005-D323-4DB4-91B1-140371EDDEAA}"/>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4" creationId="{D8988630-B7FC-4659-AA04-BA4DD9EE7452}"/>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5" creationId="{6F6E5B0A-47D6-44C3-AFC7-66BDE530E28C}"/>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6" creationId="{A0DAB589-CF7A-4C0D-ABD3-B72066B36904}"/>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7" creationId="{4B78597D-D647-4DDF-A469-86E55F284C24}"/>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38" creationId="{AAA64A30-EAD7-4C9D-82DF-5AFD81CCFB3F}"/>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39" creationId="{A11409EC-958C-4CD3-9059-F1FF1624517D}"/>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41" creationId="{F7067E63-4684-4ED2-B7EB-0338291162C8}"/>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43" creationId="{4841FA55-7368-4B1A-8350-628FBE7770D1}"/>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45" creationId="{8E751451-2AE5-45FB-ADEF-4BE7EEBDD9B3}"/>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47" creationId="{CDA0C8F4-057F-4ACA-A1DF-D6B40FC4A641}"/>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49" creationId="{5409E6F4-7ECE-4ADA-A782-FA7FE58937D7}"/>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51" creationId="{55A7E9A1-80DF-4355-B157-CB76F85D2A02}"/>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54" creationId="{60AD0F5D-8A56-4C77-9143-4BE7A4CC3D41}"/>
          </ac:spMkLst>
        </pc:spChg>
        <pc:spChg chg="add mod">
          <ac:chgData name="Tsujimoto,Mitsuhiro 辻本光宏(関東北甲信越統括支店O領域専門室)" userId="7251bc67-91ee-45c9-97e7-9c240c9b485c" providerId="ADAL" clId="{51945A91-CB03-4A52-98BE-5B2D563FE265}" dt="2021-04-21T10:16:18.336" v="204" actId="1035"/>
          <ac:spMkLst>
            <pc:docMk/>
            <pc:sldMk cId="3037864581" sldId="797"/>
            <ac:spMk id="155" creationId="{D430B7A8-A9B1-4136-9884-B67B614C07A3}"/>
          </ac:spMkLst>
        </pc:spChg>
        <pc:spChg chg="add mod">
          <ac:chgData name="Tsujimoto,Mitsuhiro 辻本光宏(関東北甲信越統括支店O領域専門室)" userId="7251bc67-91ee-45c9-97e7-9c240c9b485c" providerId="ADAL" clId="{51945A91-CB03-4A52-98BE-5B2D563FE265}" dt="2021-04-21T11:29:00.996" v="2387" actId="207"/>
          <ac:spMkLst>
            <pc:docMk/>
            <pc:sldMk cId="3037864581" sldId="797"/>
            <ac:spMk id="158" creationId="{82B28A68-C9F9-4EB8-B839-B47377E10F04}"/>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59" creationId="{8F995159-1182-4C19-A0D6-41253472D31E}"/>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60" creationId="{989B1C92-29F2-43D1-B5B4-7BE8DCDBCFF2}"/>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61" creationId="{9D8E92E0-7F32-4E27-BCE8-3A1AD0CE1307}"/>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62" creationId="{5A69B9FF-54CC-4F15-A34C-F43CFAF909F3}"/>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63" creationId="{7500FB9A-D104-467B-8D77-1FE082062D04}"/>
          </ac:spMkLst>
        </pc:spChg>
        <pc:spChg chg="add mod">
          <ac:chgData name="Tsujimoto,Mitsuhiro 辻本光宏(関東北甲信越統括支店O領域専門室)" userId="7251bc67-91ee-45c9-97e7-9c240c9b485c" providerId="ADAL" clId="{51945A91-CB03-4A52-98BE-5B2D563FE265}" dt="2021-04-21T10:18:48.294" v="253" actId="2711"/>
          <ac:spMkLst>
            <pc:docMk/>
            <pc:sldMk cId="3037864581" sldId="797"/>
            <ac:spMk id="164" creationId="{72A46B9B-D836-4645-A039-8C9CA9AA57DD}"/>
          </ac:spMkLst>
        </pc:spChg>
        <pc:grpChg chg="add del">
          <ac:chgData name="Tsujimoto,Mitsuhiro 辻本光宏(関東北甲信越統括支店O領域専門室)" userId="7251bc67-91ee-45c9-97e7-9c240c9b485c" providerId="ADAL" clId="{51945A91-CB03-4A52-98BE-5B2D563FE265}" dt="2021-04-21T10:15:35.299" v="177"/>
          <ac:grpSpMkLst>
            <pc:docMk/>
            <pc:sldMk cId="3037864581" sldId="797"/>
            <ac:grpSpMk id="4" creationId="{9E9F346C-BA91-43FD-8282-289DF74913AE}"/>
          </ac:grpSpMkLst>
        </pc:grpChg>
        <pc:grpChg chg="add del">
          <ac:chgData name="Tsujimoto,Mitsuhiro 辻本光宏(関東北甲信越統括支店O領域専門室)" userId="7251bc67-91ee-45c9-97e7-9c240c9b485c" providerId="ADAL" clId="{51945A91-CB03-4A52-98BE-5B2D563FE265}" dt="2021-04-21T10:15:38.242" v="179"/>
          <ac:grpSpMkLst>
            <pc:docMk/>
            <pc:sldMk cId="3037864581" sldId="797"/>
            <ac:grpSpMk id="58" creationId="{7CD0CE4A-2849-43A8-B28A-B9B12EECAFDF}"/>
          </ac:grpSpMkLst>
        </pc:grpChg>
        <pc:grpChg chg="add mod">
          <ac:chgData name="Tsujimoto,Mitsuhiro 辻本光宏(関東北甲信越統括支店O領域専門室)" userId="7251bc67-91ee-45c9-97e7-9c240c9b485c" providerId="ADAL" clId="{51945A91-CB03-4A52-98BE-5B2D563FE265}" dt="2021-04-21T10:16:18.336" v="204" actId="1035"/>
          <ac:grpSpMkLst>
            <pc:docMk/>
            <pc:sldMk cId="3037864581" sldId="797"/>
            <ac:grpSpMk id="112" creationId="{689DE914-C941-4B74-AB81-C223EBC6A0D0}"/>
          </ac:grpSpMkLst>
        </pc:grpChg>
        <pc:picChg chg="add del">
          <ac:chgData name="Tsujimoto,Mitsuhiro 辻本光宏(関東北甲信越統括支店O領域専門室)" userId="7251bc67-91ee-45c9-97e7-9c240c9b485c" providerId="ADAL" clId="{51945A91-CB03-4A52-98BE-5B2D563FE265}" dt="2021-04-21T10:15:35.299" v="177"/>
          <ac:picMkLst>
            <pc:docMk/>
            <pc:sldMk cId="3037864581" sldId="797"/>
            <ac:picMk id="3" creationId="{5D2ADFB2-723C-46A3-9251-2844C8F152FE}"/>
          </ac:picMkLst>
        </pc:picChg>
        <pc:picChg chg="add del">
          <ac:chgData name="Tsujimoto,Mitsuhiro 辻本光宏(関東北甲信越統括支店O領域専門室)" userId="7251bc67-91ee-45c9-97e7-9c240c9b485c" providerId="ADAL" clId="{51945A91-CB03-4A52-98BE-5B2D563FE265}" dt="2021-04-21T10:15:35.299" v="177"/>
          <ac:picMkLst>
            <pc:docMk/>
            <pc:sldMk cId="3037864581" sldId="797"/>
            <ac:picMk id="19" creationId="{3C298786-C14F-4753-B206-160FFF070DFF}"/>
          </ac:picMkLst>
        </pc:picChg>
        <pc:picChg chg="add del">
          <ac:chgData name="Tsujimoto,Mitsuhiro 辻本光宏(関東北甲信越統括支店O領域専門室)" userId="7251bc67-91ee-45c9-97e7-9c240c9b485c" providerId="ADAL" clId="{51945A91-CB03-4A52-98BE-5B2D563FE265}" dt="2021-04-21T10:15:38.242" v="179"/>
          <ac:picMkLst>
            <pc:docMk/>
            <pc:sldMk cId="3037864581" sldId="797"/>
            <ac:picMk id="57" creationId="{9BE145E2-09C4-4EAB-A06D-01699F939B06}"/>
          </ac:picMkLst>
        </pc:picChg>
        <pc:picChg chg="add del">
          <ac:chgData name="Tsujimoto,Mitsuhiro 辻本光宏(関東北甲信越統括支店O領域専門室)" userId="7251bc67-91ee-45c9-97e7-9c240c9b485c" providerId="ADAL" clId="{51945A91-CB03-4A52-98BE-5B2D563FE265}" dt="2021-04-21T10:15:38.242" v="179"/>
          <ac:picMkLst>
            <pc:docMk/>
            <pc:sldMk cId="3037864581" sldId="797"/>
            <ac:picMk id="73" creationId="{A7604A91-B1EE-47A2-92E7-DC8469F30CED}"/>
          </ac:picMkLst>
        </pc:picChg>
        <pc:picChg chg="add mod">
          <ac:chgData name="Tsujimoto,Mitsuhiro 辻本光宏(関東北甲信越統括支店O領域専門室)" userId="7251bc67-91ee-45c9-97e7-9c240c9b485c" providerId="ADAL" clId="{51945A91-CB03-4A52-98BE-5B2D563FE265}" dt="2021-04-21T10:16:18.336" v="204" actId="1035"/>
          <ac:picMkLst>
            <pc:docMk/>
            <pc:sldMk cId="3037864581" sldId="797"/>
            <ac:picMk id="111" creationId="{B0C829A9-41BC-4599-8DE8-AE45242EA92D}"/>
          </ac:picMkLst>
        </pc:picChg>
        <pc:picChg chg="add mod">
          <ac:chgData name="Tsujimoto,Mitsuhiro 辻本光宏(関東北甲信越統括支店O領域専門室)" userId="7251bc67-91ee-45c9-97e7-9c240c9b485c" providerId="ADAL" clId="{51945A91-CB03-4A52-98BE-5B2D563FE265}" dt="2021-04-21T10:16:18.336" v="204" actId="1035"/>
          <ac:picMkLst>
            <pc:docMk/>
            <pc:sldMk cId="3037864581" sldId="797"/>
            <ac:picMk id="127" creationId="{26312A44-0D6A-428D-B6AD-66AC9890B82A}"/>
          </ac:picMkLst>
        </pc:pic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32" creationId="{D3E1052E-4AAC-4AD4-A2BB-A2EFA653E0BC}"/>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34" creationId="{885BE7BB-8C72-4A9F-96F3-0470BB3D6221}"/>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36" creationId="{A452BA88-8A02-459E-982B-A21E8D072049}"/>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38" creationId="{E1924A85-F515-4B6E-95E2-294741C80651}"/>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40" creationId="{5B0EF60D-4B42-42BD-9CEA-9F1061FD5C22}"/>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42" creationId="{54AEC1C1-BA97-4C8F-B45E-00D730F9CC29}"/>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44" creationId="{0DF966FD-F737-4D34-89FD-B672C9B91CCF}"/>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45" creationId="{362A6517-1667-4735-8112-4F2ED3A71550}"/>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48" creationId="{C0CC42C1-BA6A-4E9D-BB4A-C9604BB34282}"/>
          </ac:cxnSpMkLst>
        </pc:cxnChg>
        <pc:cxnChg chg="add del">
          <ac:chgData name="Tsujimoto,Mitsuhiro 辻本光宏(関東北甲信越統括支店O領域専門室)" userId="7251bc67-91ee-45c9-97e7-9c240c9b485c" providerId="ADAL" clId="{51945A91-CB03-4A52-98BE-5B2D563FE265}" dt="2021-04-21T10:15:35.299" v="177"/>
          <ac:cxnSpMkLst>
            <pc:docMk/>
            <pc:sldMk cId="3037864581" sldId="797"/>
            <ac:cxnSpMk id="49" creationId="{64F69817-7080-4742-855A-0DD8F9CE065A}"/>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86" creationId="{D725A73A-A66F-4D62-87F8-D15F91285F9A}"/>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88" creationId="{3D08E938-D382-4930-A65B-6B172C07E8AC}"/>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90" creationId="{C6C81566-0172-4E54-A978-75D179BB74E0}"/>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92" creationId="{181B27A3-689C-41C4-904A-16D9194821B3}"/>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94" creationId="{2B152AC2-A5C4-48F0-8BB5-2B01E22D4CE2}"/>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96" creationId="{6E212D8D-59DE-4427-BF10-A3BFE67D974F}"/>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98" creationId="{D4FB4203-E4B3-46C9-9AA8-520E21693F1F}"/>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99" creationId="{66C68D71-1D7F-4650-9380-6B725B2E444B}"/>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102" creationId="{7C2F63B4-E58F-4A20-B1EE-65B4C1EE6D7E}"/>
          </ac:cxnSpMkLst>
        </pc:cxnChg>
        <pc:cxnChg chg="add del">
          <ac:chgData name="Tsujimoto,Mitsuhiro 辻本光宏(関東北甲信越統括支店O領域専門室)" userId="7251bc67-91ee-45c9-97e7-9c240c9b485c" providerId="ADAL" clId="{51945A91-CB03-4A52-98BE-5B2D563FE265}" dt="2021-04-21T10:15:38.242" v="179"/>
          <ac:cxnSpMkLst>
            <pc:docMk/>
            <pc:sldMk cId="3037864581" sldId="797"/>
            <ac:cxnSpMk id="103" creationId="{1265F135-8D70-4686-8DB9-93BE1370F5C8}"/>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40" creationId="{F50F95EE-6AB0-43EB-91B7-0FF04F3BCA47}"/>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42" creationId="{EEF8D2AB-CE3E-4EC6-A74F-F88924F74356}"/>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44" creationId="{4703C66C-CA44-4DC2-B952-4CCCD17A74EF}"/>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46" creationId="{67C4E6E8-8BB3-457B-9BFD-8BDE4F305CAE}"/>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48" creationId="{0B015497-7B9B-45BA-8622-D82E525F1C03}"/>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50" creationId="{427C66ED-9C2A-4100-896D-84D7386B8155}"/>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52" creationId="{C36EA75E-2260-4197-8E93-E09E16B5798C}"/>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53" creationId="{A833A4EF-E726-47DB-8C21-A4A499DB5D66}"/>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56" creationId="{644F8FF0-AEAD-46FE-B7BE-1AF2A042B4CC}"/>
          </ac:cxnSpMkLst>
        </pc:cxnChg>
        <pc:cxnChg chg="add mod">
          <ac:chgData name="Tsujimoto,Mitsuhiro 辻本光宏(関東北甲信越統括支店O領域専門室)" userId="7251bc67-91ee-45c9-97e7-9c240c9b485c" providerId="ADAL" clId="{51945A91-CB03-4A52-98BE-5B2D563FE265}" dt="2021-04-21T10:16:18.336" v="204" actId="1035"/>
          <ac:cxnSpMkLst>
            <pc:docMk/>
            <pc:sldMk cId="3037864581" sldId="797"/>
            <ac:cxnSpMk id="157" creationId="{69E37D42-932B-4B7A-B6C6-F2402397C8F6}"/>
          </ac:cxnSpMkLst>
        </pc:cxnChg>
      </pc:sldChg>
      <pc:sldChg chg="addSp modSp add ord">
        <pc:chgData name="Tsujimoto,Mitsuhiro 辻本光宏(関東北甲信越統括支店O領域専門室)" userId="7251bc67-91ee-45c9-97e7-9c240c9b485c" providerId="ADAL" clId="{51945A91-CB03-4A52-98BE-5B2D563FE265}" dt="2021-04-23T00:49:12.522" v="8431" actId="2711"/>
        <pc:sldMkLst>
          <pc:docMk/>
          <pc:sldMk cId="3543729363" sldId="798"/>
        </pc:sldMkLst>
        <pc:spChg chg="add mod">
          <ac:chgData name="Tsujimoto,Mitsuhiro 辻本光宏(関東北甲信越統括支店O領域専門室)" userId="7251bc67-91ee-45c9-97e7-9c240c9b485c" providerId="ADAL" clId="{51945A91-CB03-4A52-98BE-5B2D563FE265}" dt="2021-04-21T11:28:56.806" v="2386" actId="207"/>
          <ac:spMkLst>
            <pc:docMk/>
            <pc:sldMk cId="3543729363" sldId="798"/>
            <ac:spMk id="2" creationId="{34267DC7-B5EC-4F47-BF29-4926F1557DE8}"/>
          </ac:spMkLst>
        </pc:spChg>
        <pc:spChg chg="add mod">
          <ac:chgData name="Tsujimoto,Mitsuhiro 辻本光宏(関東北甲信越統括支店O領域専門室)" userId="7251bc67-91ee-45c9-97e7-9c240c9b485c" providerId="ADAL" clId="{51945A91-CB03-4A52-98BE-5B2D563FE265}" dt="2021-04-21T10:18:09.346" v="250" actId="2711"/>
          <ac:spMkLst>
            <pc:docMk/>
            <pc:sldMk cId="3543729363" sldId="798"/>
            <ac:spMk id="4" creationId="{4FF55E1C-5D85-4145-B780-5661927CD5A7}"/>
          </ac:spMkLst>
        </pc:spChg>
        <pc:spChg chg="add mod">
          <ac:chgData name="Tsujimoto,Mitsuhiro 辻本光宏(関東北甲信越統括支店O領域専門室)" userId="7251bc67-91ee-45c9-97e7-9c240c9b485c" providerId="ADAL" clId="{51945A91-CB03-4A52-98BE-5B2D563FE265}" dt="2021-04-23T00:49:12.522" v="8431" actId="2711"/>
          <ac:spMkLst>
            <pc:docMk/>
            <pc:sldMk cId="3543729363" sldId="798"/>
            <ac:spMk id="5" creationId="{B953424C-428D-4344-9E54-6C9D9B53F569}"/>
          </ac:spMkLst>
        </pc:spChg>
        <pc:spChg chg="add mod">
          <ac:chgData name="Tsujimoto,Mitsuhiro 辻本光宏(関東北甲信越統括支店O領域専門室)" userId="7251bc67-91ee-45c9-97e7-9c240c9b485c" providerId="ADAL" clId="{51945A91-CB03-4A52-98BE-5B2D563FE265}" dt="2021-04-21T10:17:30.414" v="245" actId="1076"/>
          <ac:spMkLst>
            <pc:docMk/>
            <pc:sldMk cId="3543729363" sldId="798"/>
            <ac:spMk id="6" creationId="{B90E32E4-08C0-4CC4-9891-0BA720A1E278}"/>
          </ac:spMkLst>
        </pc:spChg>
        <pc:spChg chg="add mod">
          <ac:chgData name="Tsujimoto,Mitsuhiro 辻本光宏(関東北甲信越統括支店O領域専門室)" userId="7251bc67-91ee-45c9-97e7-9c240c9b485c" providerId="ADAL" clId="{51945A91-CB03-4A52-98BE-5B2D563FE265}" dt="2021-04-21T10:17:30.414" v="245" actId="1076"/>
          <ac:spMkLst>
            <pc:docMk/>
            <pc:sldMk cId="3543729363" sldId="798"/>
            <ac:spMk id="7" creationId="{D264C8FD-35D7-467D-B494-633712B2780A}"/>
          </ac:spMkLst>
        </pc:spChg>
        <pc:spChg chg="add mod">
          <ac:chgData name="Tsujimoto,Mitsuhiro 辻本光宏(関東北甲信越統括支店O領域専門室)" userId="7251bc67-91ee-45c9-97e7-9c240c9b485c" providerId="ADAL" clId="{51945A91-CB03-4A52-98BE-5B2D563FE265}" dt="2021-04-21T10:18:09.346" v="250" actId="2711"/>
          <ac:spMkLst>
            <pc:docMk/>
            <pc:sldMk cId="3543729363" sldId="798"/>
            <ac:spMk id="8" creationId="{7C74C544-8702-40C3-92D6-8C14C6CDE2C7}"/>
          </ac:spMkLst>
        </pc:spChg>
        <pc:spChg chg="add mod">
          <ac:chgData name="Tsujimoto,Mitsuhiro 辻本光宏(関東北甲信越統括支店O領域専門室)" userId="7251bc67-91ee-45c9-97e7-9c240c9b485c" providerId="ADAL" clId="{51945A91-CB03-4A52-98BE-5B2D563FE265}" dt="2021-04-21T11:28:56.806" v="2386" actId="207"/>
          <ac:spMkLst>
            <pc:docMk/>
            <pc:sldMk cId="3543729363" sldId="798"/>
            <ac:spMk id="9" creationId="{E93DD248-411B-4978-9317-AFE1748212FC}"/>
          </ac:spMkLst>
        </pc:spChg>
        <pc:picChg chg="add mod">
          <ac:chgData name="Tsujimoto,Mitsuhiro 辻本光宏(関東北甲信越統括支店O領域専門室)" userId="7251bc67-91ee-45c9-97e7-9c240c9b485c" providerId="ADAL" clId="{51945A91-CB03-4A52-98BE-5B2D563FE265}" dt="2021-04-21T10:17:30.414" v="245" actId="1076"/>
          <ac:picMkLst>
            <pc:docMk/>
            <pc:sldMk cId="3543729363" sldId="798"/>
            <ac:picMk id="3" creationId="{A343F129-F5BC-4B55-A8A8-EC8EEA636037}"/>
          </ac:picMkLst>
        </pc:picChg>
      </pc:sldChg>
      <pc:sldChg chg="addSp modSp add">
        <pc:chgData name="Tsujimoto,Mitsuhiro 辻本光宏(関東北甲信越統括支店O領域専門室)" userId="7251bc67-91ee-45c9-97e7-9c240c9b485c" providerId="ADAL" clId="{51945A91-CB03-4A52-98BE-5B2D563FE265}" dt="2021-04-21T11:28:52.383" v="2385" actId="207"/>
        <pc:sldMkLst>
          <pc:docMk/>
          <pc:sldMk cId="2362836689" sldId="799"/>
        </pc:sldMkLst>
        <pc:spChg chg="add mod">
          <ac:chgData name="Tsujimoto,Mitsuhiro 辻本光宏(関東北甲信越統括支店O領域専門室)" userId="7251bc67-91ee-45c9-97e7-9c240c9b485c" providerId="ADAL" clId="{51945A91-CB03-4A52-98BE-5B2D563FE265}" dt="2021-04-21T11:28:52.383" v="2385" actId="207"/>
          <ac:spMkLst>
            <pc:docMk/>
            <pc:sldMk cId="2362836689" sldId="799"/>
            <ac:spMk id="2" creationId="{A35B15B8-F359-47A2-AFB4-754AC8901A2B}"/>
          </ac:spMkLst>
        </pc:spChg>
        <pc:spChg chg="add mod">
          <ac:chgData name="Tsujimoto,Mitsuhiro 辻本光宏(関東北甲信越統括支店O領域専門室)" userId="7251bc67-91ee-45c9-97e7-9c240c9b485c" providerId="ADAL" clId="{51945A91-CB03-4A52-98BE-5B2D563FE265}" dt="2021-04-21T10:20:06.672" v="305" actId="1076"/>
          <ac:spMkLst>
            <pc:docMk/>
            <pc:sldMk cId="2362836689" sldId="799"/>
            <ac:spMk id="4" creationId="{A68DEC66-5A72-4D75-99C7-6EB21564D277}"/>
          </ac:spMkLst>
        </pc:spChg>
        <pc:spChg chg="add mod">
          <ac:chgData name="Tsujimoto,Mitsuhiro 辻本光宏(関東北甲信越統括支店O領域専門室)" userId="7251bc67-91ee-45c9-97e7-9c240c9b485c" providerId="ADAL" clId="{51945A91-CB03-4A52-98BE-5B2D563FE265}" dt="2021-04-21T10:20:06.672" v="305" actId="1076"/>
          <ac:spMkLst>
            <pc:docMk/>
            <pc:sldMk cId="2362836689" sldId="799"/>
            <ac:spMk id="5" creationId="{9F7968E0-2A5E-418B-B266-38D61BB2AC17}"/>
          </ac:spMkLst>
        </pc:spChg>
        <pc:spChg chg="add mod">
          <ac:chgData name="Tsujimoto,Mitsuhiro 辻本光宏(関東北甲信越統括支店O領域専門室)" userId="7251bc67-91ee-45c9-97e7-9c240c9b485c" providerId="ADAL" clId="{51945A91-CB03-4A52-98BE-5B2D563FE265}" dt="2021-04-21T10:20:06.672" v="305" actId="1076"/>
          <ac:spMkLst>
            <pc:docMk/>
            <pc:sldMk cId="2362836689" sldId="799"/>
            <ac:spMk id="6" creationId="{BBE697F5-51CC-49F7-9307-EFD054642D13}"/>
          </ac:spMkLst>
        </pc:spChg>
        <pc:spChg chg="add mod">
          <ac:chgData name="Tsujimoto,Mitsuhiro 辻本光宏(関東北甲信越統括支店O領域専門室)" userId="7251bc67-91ee-45c9-97e7-9c240c9b485c" providerId="ADAL" clId="{51945A91-CB03-4A52-98BE-5B2D563FE265}" dt="2021-04-21T10:20:06.672" v="305" actId="1076"/>
          <ac:spMkLst>
            <pc:docMk/>
            <pc:sldMk cId="2362836689" sldId="799"/>
            <ac:spMk id="7" creationId="{5C47920A-04FC-4E8A-A77D-7EA2B4BAE52C}"/>
          </ac:spMkLst>
        </pc:spChg>
        <pc:spChg chg="add mod">
          <ac:chgData name="Tsujimoto,Mitsuhiro 辻本光宏(関東北甲信越統括支店O領域専門室)" userId="7251bc67-91ee-45c9-97e7-9c240c9b485c" providerId="ADAL" clId="{51945A91-CB03-4A52-98BE-5B2D563FE265}" dt="2021-04-21T10:20:06.672" v="305" actId="1076"/>
          <ac:spMkLst>
            <pc:docMk/>
            <pc:sldMk cId="2362836689" sldId="799"/>
            <ac:spMk id="8" creationId="{A9604B3A-31CA-4617-81F9-32055DEBD135}"/>
          </ac:spMkLst>
        </pc:spChg>
        <pc:spChg chg="add mod">
          <ac:chgData name="Tsujimoto,Mitsuhiro 辻本光宏(関東北甲信越統括支店O領域専門室)" userId="7251bc67-91ee-45c9-97e7-9c240c9b485c" providerId="ADAL" clId="{51945A91-CB03-4A52-98BE-5B2D563FE265}" dt="2021-04-21T11:28:50.253" v="2384" actId="207"/>
          <ac:spMkLst>
            <pc:docMk/>
            <pc:sldMk cId="2362836689" sldId="799"/>
            <ac:spMk id="9" creationId="{15516029-4F7E-42D0-A2F2-12EABF1EFEF0}"/>
          </ac:spMkLst>
        </pc:spChg>
        <pc:picChg chg="add mod">
          <ac:chgData name="Tsujimoto,Mitsuhiro 辻本光宏(関東北甲信越統括支店O領域専門室)" userId="7251bc67-91ee-45c9-97e7-9c240c9b485c" providerId="ADAL" clId="{51945A91-CB03-4A52-98BE-5B2D563FE265}" dt="2021-04-21T10:20:06.672" v="305" actId="1076"/>
          <ac:picMkLst>
            <pc:docMk/>
            <pc:sldMk cId="2362836689" sldId="799"/>
            <ac:picMk id="3" creationId="{4FC4F309-AE71-49B4-A51E-972C389EA4DA}"/>
          </ac:picMkLst>
        </pc:picChg>
      </pc:sldChg>
      <pc:sldChg chg="addSp delSp add del">
        <pc:chgData name="Tsujimoto,Mitsuhiro 辻本光宏(関東北甲信越統括支店O領域専門室)" userId="7251bc67-91ee-45c9-97e7-9c240c9b485c" providerId="ADAL" clId="{51945A91-CB03-4A52-98BE-5B2D563FE265}" dt="2021-04-21T10:28:47.262" v="518" actId="2696"/>
        <pc:sldMkLst>
          <pc:docMk/>
          <pc:sldMk cId="3761735026" sldId="800"/>
        </pc:sldMkLst>
        <pc:spChg chg="add del">
          <ac:chgData name="Tsujimoto,Mitsuhiro 辻本光宏(関東北甲信越統括支店O領域専門室)" userId="7251bc67-91ee-45c9-97e7-9c240c9b485c" providerId="ADAL" clId="{51945A91-CB03-4A52-98BE-5B2D563FE265}" dt="2021-04-21T10:23:21.642" v="318"/>
          <ac:spMkLst>
            <pc:docMk/>
            <pc:sldMk cId="3761735026" sldId="800"/>
            <ac:spMk id="15" creationId="{3C203220-DC4D-4934-98AA-DCD4690D3010}"/>
          </ac:spMkLst>
        </pc:spChg>
        <pc:spChg chg="add del">
          <ac:chgData name="Tsujimoto,Mitsuhiro 辻本光宏(関東北甲信越統括支店O領域専門室)" userId="7251bc67-91ee-45c9-97e7-9c240c9b485c" providerId="ADAL" clId="{51945A91-CB03-4A52-98BE-5B2D563FE265}" dt="2021-04-21T10:23:21.642" v="318"/>
          <ac:spMkLst>
            <pc:docMk/>
            <pc:sldMk cId="3761735026" sldId="800"/>
            <ac:spMk id="16" creationId="{66FC664E-B47D-49B3-AB1E-467E77DCEB33}"/>
          </ac:spMkLst>
        </pc:spChg>
      </pc:sldChg>
      <pc:sldChg chg="addSp delSp modSp add ord">
        <pc:chgData name="Tsujimoto,Mitsuhiro 辻本光宏(関東北甲信越統括支店O領域専門室)" userId="7251bc67-91ee-45c9-97e7-9c240c9b485c" providerId="ADAL" clId="{51945A91-CB03-4A52-98BE-5B2D563FE265}" dt="2021-04-23T05:26:07.227" v="13666"/>
        <pc:sldMkLst>
          <pc:docMk/>
          <pc:sldMk cId="1851872886" sldId="801"/>
        </pc:sldMkLst>
        <pc:spChg chg="add mod">
          <ac:chgData name="Tsujimoto,Mitsuhiro 辻本光宏(関東北甲信越統括支店O領域専門室)" userId="7251bc67-91ee-45c9-97e7-9c240c9b485c" providerId="ADAL" clId="{51945A91-CB03-4A52-98BE-5B2D563FE265}" dt="2021-04-23T05:26:07.227" v="13666"/>
          <ac:spMkLst>
            <pc:docMk/>
            <pc:sldMk cId="1851872886" sldId="801"/>
            <ac:spMk id="2" creationId="{971AAE09-26CE-451A-B8FA-11FCC5711729}"/>
          </ac:spMkLst>
        </pc:spChg>
        <pc:spChg chg="add del mod">
          <ac:chgData name="Tsujimoto,Mitsuhiro 辻本光宏(関東北甲信越統括支店O領域専門室)" userId="7251bc67-91ee-45c9-97e7-9c240c9b485c" providerId="ADAL" clId="{51945A91-CB03-4A52-98BE-5B2D563FE265}" dt="2021-04-21T11:15:16.450" v="2082" actId="478"/>
          <ac:spMkLst>
            <pc:docMk/>
            <pc:sldMk cId="1851872886" sldId="801"/>
            <ac:spMk id="3" creationId="{E7E35B6C-025B-485E-A129-2A18D9A26CBB}"/>
          </ac:spMkLst>
        </pc:spChg>
        <pc:spChg chg="add del mod">
          <ac:chgData name="Tsujimoto,Mitsuhiro 辻本光宏(関東北甲信越統括支店O領域専門室)" userId="7251bc67-91ee-45c9-97e7-9c240c9b485c" providerId="ADAL" clId="{51945A91-CB03-4A52-98BE-5B2D563FE265}" dt="2021-04-21T11:15:18.847" v="2083" actId="478"/>
          <ac:spMkLst>
            <pc:docMk/>
            <pc:sldMk cId="1851872886" sldId="801"/>
            <ac:spMk id="4" creationId="{C7E90043-AB0C-4BD5-BB95-DFEA4B2C7165}"/>
          </ac:spMkLst>
        </pc:spChg>
        <pc:spChg chg="add mod">
          <ac:chgData name="Tsujimoto,Mitsuhiro 辻本光宏(関東北甲信越統括支店O領域専門室)" userId="7251bc67-91ee-45c9-97e7-9c240c9b485c" providerId="ADAL" clId="{51945A91-CB03-4A52-98BE-5B2D563FE265}" dt="2021-04-23T00:49:32.861" v="8433" actId="12"/>
          <ac:spMkLst>
            <pc:docMk/>
            <pc:sldMk cId="1851872886" sldId="801"/>
            <ac:spMk id="7" creationId="{8963A078-2263-46DD-8B59-4EAE3370160A}"/>
          </ac:spMkLst>
        </pc:spChg>
        <pc:spChg chg="add del mod">
          <ac:chgData name="Tsujimoto,Mitsuhiro 辻本光宏(関東北甲信越統括支店O領域専門室)" userId="7251bc67-91ee-45c9-97e7-9c240c9b485c" providerId="ADAL" clId="{51945A91-CB03-4A52-98BE-5B2D563FE265}" dt="2021-04-21T10:26:32.056" v="500" actId="478"/>
          <ac:spMkLst>
            <pc:docMk/>
            <pc:sldMk cId="1851872886" sldId="801"/>
            <ac:spMk id="8" creationId="{FFA70C55-8A84-4602-94B3-1331F4B22755}"/>
          </ac:spMkLst>
        </pc:spChg>
        <pc:spChg chg="add mod">
          <ac:chgData name="Tsujimoto,Mitsuhiro 辻本光宏(関東北甲信越統括支店O領域専門室)" userId="7251bc67-91ee-45c9-97e7-9c240c9b485c" providerId="ADAL" clId="{51945A91-CB03-4A52-98BE-5B2D563FE265}" dt="2021-04-21T11:25:32.300" v="2320" actId="207"/>
          <ac:spMkLst>
            <pc:docMk/>
            <pc:sldMk cId="1851872886" sldId="801"/>
            <ac:spMk id="9" creationId="{3B54BCA3-9B58-4797-B184-665FA835E61F}"/>
          </ac:spMkLst>
        </pc:spChg>
        <pc:spChg chg="add mod">
          <ac:chgData name="Tsujimoto,Mitsuhiro 辻本光宏(関東北甲信越統括支店O領域専門室)" userId="7251bc67-91ee-45c9-97e7-9c240c9b485c" providerId="ADAL" clId="{51945A91-CB03-4A52-98BE-5B2D563FE265}" dt="2021-04-23T05:25:16.430" v="13627" actId="20577"/>
          <ac:spMkLst>
            <pc:docMk/>
            <pc:sldMk cId="1851872886" sldId="801"/>
            <ac:spMk id="10" creationId="{228AD992-2426-4E95-954D-6E80FEC72589}"/>
          </ac:spMkLst>
        </pc:spChg>
        <pc:spChg chg="add mod">
          <ac:chgData name="Tsujimoto,Mitsuhiro 辻本光宏(関東北甲信越統括支店O領域専門室)" userId="7251bc67-91ee-45c9-97e7-9c240c9b485c" providerId="ADAL" clId="{51945A91-CB03-4A52-98BE-5B2D563FE265}" dt="2021-04-23T05:25:19.186" v="13629" actId="20577"/>
          <ac:spMkLst>
            <pc:docMk/>
            <pc:sldMk cId="1851872886" sldId="801"/>
            <ac:spMk id="11" creationId="{D3462EFE-8008-4FB7-B7C1-B528D0094240}"/>
          </ac:spMkLst>
        </pc:spChg>
        <pc:picChg chg="add mod">
          <ac:chgData name="Tsujimoto,Mitsuhiro 辻本光宏(関東北甲信越統括支店O領域専門室)" userId="7251bc67-91ee-45c9-97e7-9c240c9b485c" providerId="ADAL" clId="{51945A91-CB03-4A52-98BE-5B2D563FE265}" dt="2021-04-21T11:19:11.982" v="2160" actId="1035"/>
          <ac:picMkLst>
            <pc:docMk/>
            <pc:sldMk cId="1851872886" sldId="801"/>
            <ac:picMk id="5" creationId="{DD4ADFB3-B67E-4E13-8235-C4479548E28D}"/>
          </ac:picMkLst>
        </pc:picChg>
        <pc:picChg chg="add mod">
          <ac:chgData name="Tsujimoto,Mitsuhiro 辻本光宏(関東北甲信越統括支店O領域専門室)" userId="7251bc67-91ee-45c9-97e7-9c240c9b485c" providerId="ADAL" clId="{51945A91-CB03-4A52-98BE-5B2D563FE265}" dt="2021-04-21T11:19:11.982" v="2160" actId="1035"/>
          <ac:picMkLst>
            <pc:docMk/>
            <pc:sldMk cId="1851872886" sldId="801"/>
            <ac:picMk id="6" creationId="{A7A100A5-066A-4499-8294-76D62E41ABBC}"/>
          </ac:picMkLst>
        </pc:picChg>
      </pc:sldChg>
      <pc:sldChg chg="addSp delSp modSp add">
        <pc:chgData name="Tsujimoto,Mitsuhiro 辻本光宏(関東北甲信越統括支店O領域専門室)" userId="7251bc67-91ee-45c9-97e7-9c240c9b485c" providerId="ADAL" clId="{51945A91-CB03-4A52-98BE-5B2D563FE265}" dt="2021-04-23T05:26:34.091" v="13682"/>
        <pc:sldMkLst>
          <pc:docMk/>
          <pc:sldMk cId="3540568972" sldId="802"/>
        </pc:sldMkLst>
        <pc:spChg chg="mod">
          <ac:chgData name="Tsujimoto,Mitsuhiro 辻本光宏(関東北甲信越統括支店O領域専門室)" userId="7251bc67-91ee-45c9-97e7-9c240c9b485c" providerId="ADAL" clId="{51945A91-CB03-4A52-98BE-5B2D563FE265}" dt="2021-04-23T05:26:34.091" v="13682"/>
          <ac:spMkLst>
            <pc:docMk/>
            <pc:sldMk cId="3540568972" sldId="802"/>
            <ac:spMk id="2" creationId="{971AAE09-26CE-451A-B8FA-11FCC5711729}"/>
          </ac:spMkLst>
        </pc:spChg>
        <pc:spChg chg="mod">
          <ac:chgData name="Tsujimoto,Mitsuhiro 辻本光宏(関東北甲信越統括支店O領域専門室)" userId="7251bc67-91ee-45c9-97e7-9c240c9b485c" providerId="ADAL" clId="{51945A91-CB03-4A52-98BE-5B2D563FE265}" dt="2021-04-23T00:49:49.572" v="8435" actId="2711"/>
          <ac:spMkLst>
            <pc:docMk/>
            <pc:sldMk cId="3540568972" sldId="802"/>
            <ac:spMk id="3" creationId="{E7E35B6C-025B-485E-A129-2A18D9A26CBB}"/>
          </ac:spMkLst>
        </pc:spChg>
        <pc:spChg chg="mod">
          <ac:chgData name="Tsujimoto,Mitsuhiro 辻本光宏(関東北甲信越統括支店O領域専門室)" userId="7251bc67-91ee-45c9-97e7-9c240c9b485c" providerId="ADAL" clId="{51945A91-CB03-4A52-98BE-5B2D563FE265}" dt="2021-04-23T00:49:49.572" v="8435" actId="2711"/>
          <ac:spMkLst>
            <pc:docMk/>
            <pc:sldMk cId="3540568972" sldId="802"/>
            <ac:spMk id="4" creationId="{C7E90043-AB0C-4BD5-BB95-DFEA4B2C7165}"/>
          </ac:spMkLst>
        </pc:spChg>
        <pc:spChg chg="mod">
          <ac:chgData name="Tsujimoto,Mitsuhiro 辻本光宏(関東北甲信越統括支店O領域専門室)" userId="7251bc67-91ee-45c9-97e7-9c240c9b485c" providerId="ADAL" clId="{51945A91-CB03-4A52-98BE-5B2D563FE265}" dt="2021-04-23T00:49:53.842" v="8436" actId="12"/>
          <ac:spMkLst>
            <pc:docMk/>
            <pc:sldMk cId="3540568972" sldId="802"/>
            <ac:spMk id="7" creationId="{8963A078-2263-46DD-8B59-4EAE3370160A}"/>
          </ac:spMkLst>
        </pc:spChg>
        <pc:spChg chg="del">
          <ac:chgData name="Tsujimoto,Mitsuhiro 辻本光宏(関東北甲信越統括支店O領域専門室)" userId="7251bc67-91ee-45c9-97e7-9c240c9b485c" providerId="ADAL" clId="{51945A91-CB03-4A52-98BE-5B2D563FE265}" dt="2021-04-21T10:35:10.893" v="940" actId="478"/>
          <ac:spMkLst>
            <pc:docMk/>
            <pc:sldMk cId="3540568972" sldId="802"/>
            <ac:spMk id="9" creationId="{3B54BCA3-9B58-4797-B184-665FA835E61F}"/>
          </ac:spMkLst>
        </pc:spChg>
        <pc:spChg chg="add mod">
          <ac:chgData name="Tsujimoto,Mitsuhiro 辻本光宏(関東北甲信越統括支店O領域専門室)" userId="7251bc67-91ee-45c9-97e7-9c240c9b485c" providerId="ADAL" clId="{51945A91-CB03-4A52-98BE-5B2D563FE265}" dt="2021-04-21T10:33:32.469" v="737" actId="1035"/>
          <ac:spMkLst>
            <pc:docMk/>
            <pc:sldMk cId="3540568972" sldId="802"/>
            <ac:spMk id="12" creationId="{DA2F2A32-84F8-4CC9-99D1-FCEBBEFF6333}"/>
          </ac:spMkLst>
        </pc:spChg>
        <pc:spChg chg="add mod">
          <ac:chgData name="Tsujimoto,Mitsuhiro 辻本光宏(関東北甲信越統括支店O領域専門室)" userId="7251bc67-91ee-45c9-97e7-9c240c9b485c" providerId="ADAL" clId="{51945A91-CB03-4A52-98BE-5B2D563FE265}" dt="2021-04-21T10:33:32.469" v="737" actId="1035"/>
          <ac:spMkLst>
            <pc:docMk/>
            <pc:sldMk cId="3540568972" sldId="802"/>
            <ac:spMk id="13" creationId="{39AF6F76-D7B6-4E50-BE8A-ACC5D56DFD05}"/>
          </ac:spMkLst>
        </pc:spChg>
        <pc:spChg chg="add del mod">
          <ac:chgData name="Tsujimoto,Mitsuhiro 辻本光宏(関東北甲信越統括支店O領域専門室)" userId="7251bc67-91ee-45c9-97e7-9c240c9b485c" providerId="ADAL" clId="{51945A91-CB03-4A52-98BE-5B2D563FE265}" dt="2021-04-21T10:33:35.648" v="738" actId="478"/>
          <ac:spMkLst>
            <pc:docMk/>
            <pc:sldMk cId="3540568972" sldId="802"/>
            <ac:spMk id="14" creationId="{F1AF3209-5354-4953-BB80-E49DC13CC670}"/>
          </ac:spMkLst>
        </pc:spChg>
        <pc:spChg chg="add del mod">
          <ac:chgData name="Tsujimoto,Mitsuhiro 辻本光宏(関東北甲信越統括支店O領域専門室)" userId="7251bc67-91ee-45c9-97e7-9c240c9b485c" providerId="ADAL" clId="{51945A91-CB03-4A52-98BE-5B2D563FE265}" dt="2021-04-21T10:33:35.648" v="738" actId="478"/>
          <ac:spMkLst>
            <pc:docMk/>
            <pc:sldMk cId="3540568972" sldId="802"/>
            <ac:spMk id="15" creationId="{BAB266AE-483C-4D9F-A7CA-FD3090AD13C8}"/>
          </ac:spMkLst>
        </pc:spChg>
        <pc:spChg chg="add del mod">
          <ac:chgData name="Tsujimoto,Mitsuhiro 辻本光宏(関東北甲信越統括支店O領域専門室)" userId="7251bc67-91ee-45c9-97e7-9c240c9b485c" providerId="ADAL" clId="{51945A91-CB03-4A52-98BE-5B2D563FE265}" dt="2021-04-21T10:34:50.170" v="939" actId="478"/>
          <ac:spMkLst>
            <pc:docMk/>
            <pc:sldMk cId="3540568972" sldId="802"/>
            <ac:spMk id="16" creationId="{C471556A-5E5F-411F-B1BB-EC040DCEE717}"/>
          </ac:spMkLst>
        </pc:spChg>
        <pc:spChg chg="add mod">
          <ac:chgData name="Tsujimoto,Mitsuhiro 辻本光宏(関東北甲信越統括支店O領域専門室)" userId="7251bc67-91ee-45c9-97e7-9c240c9b485c" providerId="ADAL" clId="{51945A91-CB03-4A52-98BE-5B2D563FE265}" dt="2021-04-21T11:24:59.747" v="2317" actId="207"/>
          <ac:spMkLst>
            <pc:docMk/>
            <pc:sldMk cId="3540568972" sldId="802"/>
            <ac:spMk id="17" creationId="{B499970C-DCE4-4419-8165-1CE23CE43190}"/>
          </ac:spMkLst>
        </pc:spChg>
        <pc:picChg chg="del">
          <ac:chgData name="Tsujimoto,Mitsuhiro 辻本光宏(関東北甲信越統括支店O領域専門室)" userId="7251bc67-91ee-45c9-97e7-9c240c9b485c" providerId="ADAL" clId="{51945A91-CB03-4A52-98BE-5B2D563FE265}" dt="2021-04-21T10:31:31.277" v="600" actId="478"/>
          <ac:picMkLst>
            <pc:docMk/>
            <pc:sldMk cId="3540568972" sldId="802"/>
            <ac:picMk id="5" creationId="{DD4ADFB3-B67E-4E13-8235-C4479548E28D}"/>
          </ac:picMkLst>
        </pc:picChg>
        <pc:picChg chg="del">
          <ac:chgData name="Tsujimoto,Mitsuhiro 辻本光宏(関東北甲信越統括支店O領域専門室)" userId="7251bc67-91ee-45c9-97e7-9c240c9b485c" providerId="ADAL" clId="{51945A91-CB03-4A52-98BE-5B2D563FE265}" dt="2021-04-21T10:31:31.277" v="600" actId="478"/>
          <ac:picMkLst>
            <pc:docMk/>
            <pc:sldMk cId="3540568972" sldId="802"/>
            <ac:picMk id="6" creationId="{A7A100A5-066A-4499-8294-76D62E41ABBC}"/>
          </ac:picMkLst>
        </pc:picChg>
        <pc:picChg chg="add mod">
          <ac:chgData name="Tsujimoto,Mitsuhiro 辻本光宏(関東北甲信越統括支店O領域専門室)" userId="7251bc67-91ee-45c9-97e7-9c240c9b485c" providerId="ADAL" clId="{51945A91-CB03-4A52-98BE-5B2D563FE265}" dt="2021-04-21T10:33:32.469" v="737" actId="1035"/>
          <ac:picMkLst>
            <pc:docMk/>
            <pc:sldMk cId="3540568972" sldId="802"/>
            <ac:picMk id="10" creationId="{E08382DD-D3EE-4291-8D5F-DD664B3A8418}"/>
          </ac:picMkLst>
        </pc:picChg>
        <pc:picChg chg="add mod">
          <ac:chgData name="Tsujimoto,Mitsuhiro 辻本光宏(関東北甲信越統括支店O領域専門室)" userId="7251bc67-91ee-45c9-97e7-9c240c9b485c" providerId="ADAL" clId="{51945A91-CB03-4A52-98BE-5B2D563FE265}" dt="2021-04-21T10:33:32.469" v="737" actId="1035"/>
          <ac:picMkLst>
            <pc:docMk/>
            <pc:sldMk cId="3540568972" sldId="802"/>
            <ac:picMk id="11" creationId="{1F2AC229-3455-4496-930E-9F4F7AD99ADA}"/>
          </ac:picMkLst>
        </pc:picChg>
      </pc:sldChg>
      <pc:sldChg chg="addSp modSp add ord">
        <pc:chgData name="Tsujimoto,Mitsuhiro 辻本光宏(関東北甲信越統括支店O領域専門室)" userId="7251bc67-91ee-45c9-97e7-9c240c9b485c" providerId="ADAL" clId="{51945A91-CB03-4A52-98BE-5B2D563FE265}" dt="2021-04-23T00:50:03.944" v="8437" actId="2711"/>
        <pc:sldMkLst>
          <pc:docMk/>
          <pc:sldMk cId="2644131426" sldId="803"/>
        </pc:sldMkLst>
        <pc:spChg chg="add mod">
          <ac:chgData name="Tsujimoto,Mitsuhiro 辻本光宏(関東北甲信越統括支店O領域専門室)" userId="7251bc67-91ee-45c9-97e7-9c240c9b485c" providerId="ADAL" clId="{51945A91-CB03-4A52-98BE-5B2D563FE265}" dt="2021-04-21T11:25:41.526" v="2321" actId="207"/>
          <ac:spMkLst>
            <pc:docMk/>
            <pc:sldMk cId="2644131426" sldId="803"/>
            <ac:spMk id="2" creationId="{5D4EADA5-3D3A-4E04-A9A6-E8C928F7CCA1}"/>
          </ac:spMkLst>
        </pc:spChg>
        <pc:spChg chg="add mod">
          <ac:chgData name="Tsujimoto,Mitsuhiro 辻本光宏(関東北甲信越統括支店O領域専門室)" userId="7251bc67-91ee-45c9-97e7-9c240c9b485c" providerId="ADAL" clId="{51945A91-CB03-4A52-98BE-5B2D563FE265}" dt="2021-04-21T10:36:21.800" v="1009" actId="2711"/>
          <ac:spMkLst>
            <pc:docMk/>
            <pc:sldMk cId="2644131426" sldId="803"/>
            <ac:spMk id="6" creationId="{49D4FBE5-D169-4B1E-A758-6929B08F43B8}"/>
          </ac:spMkLst>
        </pc:spChg>
        <pc:spChg chg="add mod">
          <ac:chgData name="Tsujimoto,Mitsuhiro 辻本光宏(関東北甲信越統括支店O領域専門室)" userId="7251bc67-91ee-45c9-97e7-9c240c9b485c" providerId="ADAL" clId="{51945A91-CB03-4A52-98BE-5B2D563FE265}" dt="2021-04-23T00:50:03.944" v="8437" actId="2711"/>
          <ac:spMkLst>
            <pc:docMk/>
            <pc:sldMk cId="2644131426" sldId="803"/>
            <ac:spMk id="7" creationId="{C8B47421-2D5D-474A-93E6-E3E4F82B58F0}"/>
          </ac:spMkLst>
        </pc:spChg>
        <pc:spChg chg="add mod">
          <ac:chgData name="Tsujimoto,Mitsuhiro 辻本光宏(関東北甲信越統括支店O領域専門室)" userId="7251bc67-91ee-45c9-97e7-9c240c9b485c" providerId="ADAL" clId="{51945A91-CB03-4A52-98BE-5B2D563FE265}" dt="2021-04-23T00:50:03.944" v="8437" actId="2711"/>
          <ac:spMkLst>
            <pc:docMk/>
            <pc:sldMk cId="2644131426" sldId="803"/>
            <ac:spMk id="8" creationId="{FBFAE5A7-EC31-4C7D-AA57-D09112B05AB7}"/>
          </ac:spMkLst>
        </pc:spChg>
        <pc:spChg chg="add mod">
          <ac:chgData name="Tsujimoto,Mitsuhiro 辻本光宏(関東北甲信越統括支店O領域専門室)" userId="7251bc67-91ee-45c9-97e7-9c240c9b485c" providerId="ADAL" clId="{51945A91-CB03-4A52-98BE-5B2D563FE265}" dt="2021-04-23T00:50:03.944" v="8437" actId="2711"/>
          <ac:spMkLst>
            <pc:docMk/>
            <pc:sldMk cId="2644131426" sldId="803"/>
            <ac:spMk id="9" creationId="{497BD80D-7235-4741-8DB3-670E136E8DC2}"/>
          </ac:spMkLst>
        </pc:spChg>
        <pc:spChg chg="add mod">
          <ac:chgData name="Tsujimoto,Mitsuhiro 辻本光宏(関東北甲信越統括支店O領域専門室)" userId="7251bc67-91ee-45c9-97e7-9c240c9b485c" providerId="ADAL" clId="{51945A91-CB03-4A52-98BE-5B2D563FE265}" dt="2021-04-23T00:50:03.944" v="8437" actId="2711"/>
          <ac:spMkLst>
            <pc:docMk/>
            <pc:sldMk cId="2644131426" sldId="803"/>
            <ac:spMk id="13" creationId="{F80E1D89-266E-4FA4-BC72-AF502DC5A323}"/>
          </ac:spMkLst>
        </pc:spChg>
        <pc:spChg chg="add mod">
          <ac:chgData name="Tsujimoto,Mitsuhiro 辻本光宏(関東北甲信越統括支店O領域専門室)" userId="7251bc67-91ee-45c9-97e7-9c240c9b485c" providerId="ADAL" clId="{51945A91-CB03-4A52-98BE-5B2D563FE265}" dt="2021-04-23T00:50:03.944" v="8437" actId="2711"/>
          <ac:spMkLst>
            <pc:docMk/>
            <pc:sldMk cId="2644131426" sldId="803"/>
            <ac:spMk id="14" creationId="{8E660C79-2FB5-4149-8703-0518312E4939}"/>
          </ac:spMkLst>
        </pc:spChg>
        <pc:spChg chg="add mod">
          <ac:chgData name="Tsujimoto,Mitsuhiro 辻本光宏(関東北甲信越統括支店O領域専門室)" userId="7251bc67-91ee-45c9-97e7-9c240c9b485c" providerId="ADAL" clId="{51945A91-CB03-4A52-98BE-5B2D563FE265}" dt="2021-04-21T10:36:21.800" v="1009" actId="2711"/>
          <ac:spMkLst>
            <pc:docMk/>
            <pc:sldMk cId="2644131426" sldId="803"/>
            <ac:spMk id="15" creationId="{15F254BE-64E8-476E-8E09-BA74F1571E84}"/>
          </ac:spMkLst>
        </pc:spChg>
        <pc:spChg chg="add mod">
          <ac:chgData name="Tsujimoto,Mitsuhiro 辻本光宏(関東北甲信越統括支店O領域専門室)" userId="7251bc67-91ee-45c9-97e7-9c240c9b485c" providerId="ADAL" clId="{51945A91-CB03-4A52-98BE-5B2D563FE265}" dt="2021-04-21T10:36:21.800" v="1009" actId="2711"/>
          <ac:spMkLst>
            <pc:docMk/>
            <pc:sldMk cId="2644131426" sldId="803"/>
            <ac:spMk id="16" creationId="{F3A505F2-B800-4450-8AD0-FFA9262AAD8E}"/>
          </ac:spMkLst>
        </pc:spChg>
        <pc:cxnChg chg="add mod">
          <ac:chgData name="Tsujimoto,Mitsuhiro 辻本光宏(関東北甲信越統括支店O領域専門室)" userId="7251bc67-91ee-45c9-97e7-9c240c9b485c" providerId="ADAL" clId="{51945A91-CB03-4A52-98BE-5B2D563FE265}" dt="2021-04-21T10:36:17.877" v="1008" actId="1076"/>
          <ac:cxnSpMkLst>
            <pc:docMk/>
            <pc:sldMk cId="2644131426" sldId="803"/>
            <ac:cxnSpMk id="3" creationId="{C560A736-5579-4C58-AE61-F9532EDD0E3C}"/>
          </ac:cxnSpMkLst>
        </pc:cxnChg>
        <pc:cxnChg chg="add mod">
          <ac:chgData name="Tsujimoto,Mitsuhiro 辻本光宏(関東北甲信越統括支店O領域専門室)" userId="7251bc67-91ee-45c9-97e7-9c240c9b485c" providerId="ADAL" clId="{51945A91-CB03-4A52-98BE-5B2D563FE265}" dt="2021-04-21T10:36:17.877" v="1008" actId="1076"/>
          <ac:cxnSpMkLst>
            <pc:docMk/>
            <pc:sldMk cId="2644131426" sldId="803"/>
            <ac:cxnSpMk id="4" creationId="{1E6F0F3E-F991-44D4-80AB-09E74C44F499}"/>
          </ac:cxnSpMkLst>
        </pc:cxnChg>
        <pc:cxnChg chg="add mod">
          <ac:chgData name="Tsujimoto,Mitsuhiro 辻本光宏(関東北甲信越統括支店O領域専門室)" userId="7251bc67-91ee-45c9-97e7-9c240c9b485c" providerId="ADAL" clId="{51945A91-CB03-4A52-98BE-5B2D563FE265}" dt="2021-04-21T10:36:17.877" v="1008" actId="1076"/>
          <ac:cxnSpMkLst>
            <pc:docMk/>
            <pc:sldMk cId="2644131426" sldId="803"/>
            <ac:cxnSpMk id="5" creationId="{4F21B232-4E5A-45B5-A2D6-1BC90BC3B920}"/>
          </ac:cxnSpMkLst>
        </pc:cxnChg>
        <pc:cxnChg chg="add mod">
          <ac:chgData name="Tsujimoto,Mitsuhiro 辻本光宏(関東北甲信越統括支店O領域専門室)" userId="7251bc67-91ee-45c9-97e7-9c240c9b485c" providerId="ADAL" clId="{51945A91-CB03-4A52-98BE-5B2D563FE265}" dt="2021-04-21T10:36:17.877" v="1008" actId="1076"/>
          <ac:cxnSpMkLst>
            <pc:docMk/>
            <pc:sldMk cId="2644131426" sldId="803"/>
            <ac:cxnSpMk id="10" creationId="{E9CCEAE6-5D79-43C7-BC0D-B08B07CC2078}"/>
          </ac:cxnSpMkLst>
        </pc:cxnChg>
        <pc:cxnChg chg="add mod">
          <ac:chgData name="Tsujimoto,Mitsuhiro 辻本光宏(関東北甲信越統括支店O領域専門室)" userId="7251bc67-91ee-45c9-97e7-9c240c9b485c" providerId="ADAL" clId="{51945A91-CB03-4A52-98BE-5B2D563FE265}" dt="2021-04-21T10:36:17.877" v="1008" actId="1076"/>
          <ac:cxnSpMkLst>
            <pc:docMk/>
            <pc:sldMk cId="2644131426" sldId="803"/>
            <ac:cxnSpMk id="11" creationId="{5AA06D87-68C0-4CFA-8D14-CD0CB4CE2EDE}"/>
          </ac:cxnSpMkLst>
        </pc:cxnChg>
        <pc:cxnChg chg="add mod">
          <ac:chgData name="Tsujimoto,Mitsuhiro 辻本光宏(関東北甲信越統括支店O領域専門室)" userId="7251bc67-91ee-45c9-97e7-9c240c9b485c" providerId="ADAL" clId="{51945A91-CB03-4A52-98BE-5B2D563FE265}" dt="2021-04-21T10:36:17.877" v="1008" actId="1076"/>
          <ac:cxnSpMkLst>
            <pc:docMk/>
            <pc:sldMk cId="2644131426" sldId="803"/>
            <ac:cxnSpMk id="12" creationId="{908A204A-A890-4002-95F6-F7AE62B652EF}"/>
          </ac:cxnSpMkLst>
        </pc:cxnChg>
      </pc:sldChg>
      <pc:sldChg chg="addSp delSp modSp add mod ord setBg">
        <pc:chgData name="Tsujimoto,Mitsuhiro 辻本光宏(関東北甲信越統括支店O領域専門室)" userId="7251bc67-91ee-45c9-97e7-9c240c9b485c" providerId="ADAL" clId="{51945A91-CB03-4A52-98BE-5B2D563FE265}" dt="2021-04-21T11:25:47.719" v="2322" actId="207"/>
        <pc:sldMkLst>
          <pc:docMk/>
          <pc:sldMk cId="754859798" sldId="804"/>
        </pc:sldMkLst>
        <pc:spChg chg="add mod">
          <ac:chgData name="Tsujimoto,Mitsuhiro 辻本光宏(関東北甲信越統括支店O領域専門室)" userId="7251bc67-91ee-45c9-97e7-9c240c9b485c" providerId="ADAL" clId="{51945A91-CB03-4A52-98BE-5B2D563FE265}" dt="2021-04-21T11:25:47.719" v="2322" actId="207"/>
          <ac:spMkLst>
            <pc:docMk/>
            <pc:sldMk cId="754859798" sldId="804"/>
            <ac:spMk id="2" creationId="{3EF23D2C-7AF5-4EE8-BC15-E195632EF31C}"/>
          </ac:spMkLst>
        </pc:spChg>
        <pc:spChg chg="add del mod">
          <ac:chgData name="Tsujimoto,Mitsuhiro 辻本光宏(関東北甲信越統括支店O領域専門室)" userId="7251bc67-91ee-45c9-97e7-9c240c9b485c" providerId="ADAL" clId="{51945A91-CB03-4A52-98BE-5B2D563FE265}" dt="2021-04-21T10:42:09.140" v="1207" actId="478"/>
          <ac:spMkLst>
            <pc:docMk/>
            <pc:sldMk cId="754859798" sldId="804"/>
            <ac:spMk id="5" creationId="{427DFFBA-C816-4F7F-B0A6-C6076C266627}"/>
          </ac:spMkLst>
        </pc:spChg>
        <pc:spChg chg="add del">
          <ac:chgData name="Tsujimoto,Mitsuhiro 辻本光宏(関東北甲信越統括支店O領域専門室)" userId="7251bc67-91ee-45c9-97e7-9c240c9b485c" providerId="ADAL" clId="{51945A91-CB03-4A52-98BE-5B2D563FE265}" dt="2021-04-21T10:39:44.111" v="1066" actId="26606"/>
          <ac:spMkLst>
            <pc:docMk/>
            <pc:sldMk cId="754859798" sldId="804"/>
            <ac:spMk id="9" creationId="{88263A24-0C1F-4677-B43C-4AE14E276B27}"/>
          </ac:spMkLst>
        </pc:spChg>
        <pc:spChg chg="add del">
          <ac:chgData name="Tsujimoto,Mitsuhiro 辻本光宏(関東北甲信越統括支店O領域専門室)" userId="7251bc67-91ee-45c9-97e7-9c240c9b485c" providerId="ADAL" clId="{51945A91-CB03-4A52-98BE-5B2D563FE265}" dt="2021-04-21T10:39:44.111" v="1066" actId="26606"/>
          <ac:spMkLst>
            <pc:docMk/>
            <pc:sldMk cId="754859798" sldId="804"/>
            <ac:spMk id="11" creationId="{0ADDB668-2CA4-4D2B-9C34-3487CA330BA8}"/>
          </ac:spMkLst>
        </pc:spChg>
        <pc:spChg chg="add del">
          <ac:chgData name="Tsujimoto,Mitsuhiro 辻本光宏(関東北甲信越統括支店O領域専門室)" userId="7251bc67-91ee-45c9-97e7-9c240c9b485c" providerId="ADAL" clId="{51945A91-CB03-4A52-98BE-5B2D563FE265}" dt="2021-04-21T10:39:44.111" v="1066" actId="26606"/>
          <ac:spMkLst>
            <pc:docMk/>
            <pc:sldMk cId="754859798" sldId="804"/>
            <ac:spMk id="13" creationId="{2568BC19-F052-4108-93E1-6A3D1DEC072F}"/>
          </ac:spMkLst>
        </pc:spChg>
        <pc:spChg chg="add del">
          <ac:chgData name="Tsujimoto,Mitsuhiro 辻本光宏(関東北甲信越統括支店O領域専門室)" userId="7251bc67-91ee-45c9-97e7-9c240c9b485c" providerId="ADAL" clId="{51945A91-CB03-4A52-98BE-5B2D563FE265}" dt="2021-04-21T10:39:44.111" v="1066" actId="26606"/>
          <ac:spMkLst>
            <pc:docMk/>
            <pc:sldMk cId="754859798" sldId="804"/>
            <ac:spMk id="15" creationId="{D5FD337D-4D6B-4C8B-B6F5-121097E09881}"/>
          </ac:spMkLst>
        </pc:spChg>
        <pc:spChg chg="add del">
          <ac:chgData name="Tsujimoto,Mitsuhiro 辻本光宏(関東北甲信越統括支店O領域専門室)" userId="7251bc67-91ee-45c9-97e7-9c240c9b485c" providerId="ADAL" clId="{51945A91-CB03-4A52-98BE-5B2D563FE265}" dt="2021-04-21T10:39:45.735" v="1068" actId="26606"/>
          <ac:spMkLst>
            <pc:docMk/>
            <pc:sldMk cId="754859798" sldId="804"/>
            <ac:spMk id="17" creationId="{99ED5833-B85B-4103-8A3B-CAB0308E6C15}"/>
          </ac:spMkLst>
        </pc:spChg>
        <pc:spChg chg="add del">
          <ac:chgData name="Tsujimoto,Mitsuhiro 辻本光宏(関東北甲信越統括支店O領域専門室)" userId="7251bc67-91ee-45c9-97e7-9c240c9b485c" providerId="ADAL" clId="{51945A91-CB03-4A52-98BE-5B2D563FE265}" dt="2021-04-21T10:39:46.747" v="1070" actId="26606"/>
          <ac:spMkLst>
            <pc:docMk/>
            <pc:sldMk cId="754859798" sldId="804"/>
            <ac:spMk id="19" creationId="{88263A24-0C1F-4677-B43C-4AE14E276B27}"/>
          </ac:spMkLst>
        </pc:spChg>
        <pc:spChg chg="add del">
          <ac:chgData name="Tsujimoto,Mitsuhiro 辻本光宏(関東北甲信越統括支店O領域専門室)" userId="7251bc67-91ee-45c9-97e7-9c240c9b485c" providerId="ADAL" clId="{51945A91-CB03-4A52-98BE-5B2D563FE265}" dt="2021-04-21T10:39:46.747" v="1070" actId="26606"/>
          <ac:spMkLst>
            <pc:docMk/>
            <pc:sldMk cId="754859798" sldId="804"/>
            <ac:spMk id="20" creationId="{0ADDB668-2CA4-4D2B-9C34-3487CA330BA8}"/>
          </ac:spMkLst>
        </pc:spChg>
        <pc:spChg chg="add del">
          <ac:chgData name="Tsujimoto,Mitsuhiro 辻本光宏(関東北甲信越統括支店O領域専門室)" userId="7251bc67-91ee-45c9-97e7-9c240c9b485c" providerId="ADAL" clId="{51945A91-CB03-4A52-98BE-5B2D563FE265}" dt="2021-04-21T10:39:46.747" v="1070" actId="26606"/>
          <ac:spMkLst>
            <pc:docMk/>
            <pc:sldMk cId="754859798" sldId="804"/>
            <ac:spMk id="21" creationId="{2568BC19-F052-4108-93E1-6A3D1DEC072F}"/>
          </ac:spMkLst>
        </pc:spChg>
        <pc:spChg chg="add del">
          <ac:chgData name="Tsujimoto,Mitsuhiro 辻本光宏(関東北甲信越統括支店O領域専門室)" userId="7251bc67-91ee-45c9-97e7-9c240c9b485c" providerId="ADAL" clId="{51945A91-CB03-4A52-98BE-5B2D563FE265}" dt="2021-04-21T10:39:46.747" v="1070" actId="26606"/>
          <ac:spMkLst>
            <pc:docMk/>
            <pc:sldMk cId="754859798" sldId="804"/>
            <ac:spMk id="22" creationId="{D5FD337D-4D6B-4C8B-B6F5-121097E09881}"/>
          </ac:spMkLst>
        </pc:spChg>
        <pc:spChg chg="add del">
          <ac:chgData name="Tsujimoto,Mitsuhiro 辻本光宏(関東北甲信越統括支店O領域専門室)" userId="7251bc67-91ee-45c9-97e7-9c240c9b485c" providerId="ADAL" clId="{51945A91-CB03-4A52-98BE-5B2D563FE265}" dt="2021-04-21T10:39:48.044" v="1072" actId="26606"/>
          <ac:spMkLst>
            <pc:docMk/>
            <pc:sldMk cId="754859798" sldId="804"/>
            <ac:spMk id="24" creationId="{C4879EFC-8E62-4E00-973C-C45EE9EC676D}"/>
          </ac:spMkLst>
        </pc:spChg>
        <pc:spChg chg="add del">
          <ac:chgData name="Tsujimoto,Mitsuhiro 辻本光宏(関東北甲信越統括支店O領域専門室)" userId="7251bc67-91ee-45c9-97e7-9c240c9b485c" providerId="ADAL" clId="{51945A91-CB03-4A52-98BE-5B2D563FE265}" dt="2021-04-21T10:39:48.044" v="1072" actId="26606"/>
          <ac:spMkLst>
            <pc:docMk/>
            <pc:sldMk cId="754859798" sldId="804"/>
            <ac:spMk id="25" creationId="{D6A9C53F-5F90-40A5-8C85-5412D39C8C68}"/>
          </ac:spMkLst>
        </pc:spChg>
        <pc:spChg chg="add del">
          <ac:chgData name="Tsujimoto,Mitsuhiro 辻本光宏(関東北甲信越統括支店O領域専門室)" userId="7251bc67-91ee-45c9-97e7-9c240c9b485c" providerId="ADAL" clId="{51945A91-CB03-4A52-98BE-5B2D563FE265}" dt="2021-04-21T10:39:48.533" v="1074" actId="26606"/>
          <ac:spMkLst>
            <pc:docMk/>
            <pc:sldMk cId="754859798" sldId="804"/>
            <ac:spMk id="27" creationId="{70BDD0CE-06A4-404B-8A13-580229C1C923}"/>
          </ac:spMkLst>
        </pc:spChg>
        <pc:spChg chg="add del">
          <ac:chgData name="Tsujimoto,Mitsuhiro 辻本光宏(関東北甲信越統括支店O領域専門室)" userId="7251bc67-91ee-45c9-97e7-9c240c9b485c" providerId="ADAL" clId="{51945A91-CB03-4A52-98BE-5B2D563FE265}" dt="2021-04-21T10:39:48.533" v="1074" actId="26606"/>
          <ac:spMkLst>
            <pc:docMk/>
            <pc:sldMk cId="754859798" sldId="804"/>
            <ac:spMk id="28" creationId="{EE9899FA-8881-472C-AA59-D08A89CA8AEF}"/>
          </ac:spMkLst>
        </pc:spChg>
        <pc:spChg chg="add del">
          <ac:chgData name="Tsujimoto,Mitsuhiro 辻本光宏(関東北甲信越統括支店O領域専門室)" userId="7251bc67-91ee-45c9-97e7-9c240c9b485c" providerId="ADAL" clId="{51945A91-CB03-4A52-98BE-5B2D563FE265}" dt="2021-04-21T10:39:48.533" v="1074" actId="26606"/>
          <ac:spMkLst>
            <pc:docMk/>
            <pc:sldMk cId="754859798" sldId="804"/>
            <ac:spMk id="29" creationId="{080B7D90-3DF1-4514-B26D-616BE35553C9}"/>
          </ac:spMkLst>
        </pc:spChg>
        <pc:spChg chg="add del">
          <ac:chgData name="Tsujimoto,Mitsuhiro 辻本光宏(関東北甲信越統括支店O領域専門室)" userId="7251bc67-91ee-45c9-97e7-9c240c9b485c" providerId="ADAL" clId="{51945A91-CB03-4A52-98BE-5B2D563FE265}" dt="2021-04-21T10:39:51.490" v="1078" actId="26606"/>
          <ac:spMkLst>
            <pc:docMk/>
            <pc:sldMk cId="754859798" sldId="804"/>
            <ac:spMk id="34" creationId="{7316481C-0A49-4796-812B-0D64F063B720}"/>
          </ac:spMkLst>
        </pc:spChg>
        <pc:spChg chg="add del">
          <ac:chgData name="Tsujimoto,Mitsuhiro 辻本光宏(関東北甲信越統括支店O領域専門室)" userId="7251bc67-91ee-45c9-97e7-9c240c9b485c" providerId="ADAL" clId="{51945A91-CB03-4A52-98BE-5B2D563FE265}" dt="2021-04-21T10:39:51.490" v="1078" actId="26606"/>
          <ac:spMkLst>
            <pc:docMk/>
            <pc:sldMk cId="754859798" sldId="804"/>
            <ac:spMk id="35" creationId="{D9F5512A-48E1-4C07-B75E-3CCC517B6804}"/>
          </ac:spMkLst>
        </pc:spChg>
        <pc:spChg chg="add del">
          <ac:chgData name="Tsujimoto,Mitsuhiro 辻本光宏(関東北甲信越統括支店O領域専門室)" userId="7251bc67-91ee-45c9-97e7-9c240c9b485c" providerId="ADAL" clId="{51945A91-CB03-4A52-98BE-5B2D563FE265}" dt="2021-04-21T10:39:51.490" v="1078" actId="26606"/>
          <ac:spMkLst>
            <pc:docMk/>
            <pc:sldMk cId="754859798" sldId="804"/>
            <ac:spMk id="36" creationId="{A5271697-90F1-4A23-8EF2-0179F2EAFACB}"/>
          </ac:spMkLst>
        </pc:spChg>
        <pc:spChg chg="add mod">
          <ac:chgData name="Tsujimoto,Mitsuhiro 辻本光宏(関東北甲信越統括支店O領域専門室)" userId="7251bc67-91ee-45c9-97e7-9c240c9b485c" providerId="ADAL" clId="{51945A91-CB03-4A52-98BE-5B2D563FE265}" dt="2021-04-21T10:40:27.372" v="1087" actId="207"/>
          <ac:spMkLst>
            <pc:docMk/>
            <pc:sldMk cId="754859798" sldId="804"/>
            <ac:spMk id="49" creationId="{0BE9775B-F971-4FA3-BC8B-52CADE09D276}"/>
          </ac:spMkLst>
        </pc:spChg>
        <pc:grpChg chg="add del">
          <ac:chgData name="Tsujimoto,Mitsuhiro 辻本光宏(関東北甲信越統括支店O領域専門室)" userId="7251bc67-91ee-45c9-97e7-9c240c9b485c" providerId="ADAL" clId="{51945A91-CB03-4A52-98BE-5B2D563FE265}" dt="2021-04-21T10:39:51.490" v="1078" actId="26606"/>
          <ac:grpSpMkLst>
            <pc:docMk/>
            <pc:sldMk cId="754859798" sldId="804"/>
            <ac:grpSpMk id="37" creationId="{0924561D-756D-410B-973A-E68C2552C20C}"/>
          </ac:grpSpMkLst>
        </pc:grpChg>
        <pc:picChg chg="add mod ord">
          <ac:chgData name="Tsujimoto,Mitsuhiro 辻本光宏(関東北甲信越統括支店O領域専門室)" userId="7251bc67-91ee-45c9-97e7-9c240c9b485c" providerId="ADAL" clId="{51945A91-CB03-4A52-98BE-5B2D563FE265}" dt="2021-04-21T10:40:09.457" v="1083" actId="1076"/>
          <ac:picMkLst>
            <pc:docMk/>
            <pc:sldMk cId="754859798" sldId="804"/>
            <ac:picMk id="3" creationId="{07A40473-F19E-4E99-98DE-5BF798D520B9}"/>
          </ac:picMkLst>
        </pc:picChg>
        <pc:picChg chg="add mod">
          <ac:chgData name="Tsujimoto,Mitsuhiro 辻本光宏(関東北甲信越統括支店O領域専門室)" userId="7251bc67-91ee-45c9-97e7-9c240c9b485c" providerId="ADAL" clId="{51945A91-CB03-4A52-98BE-5B2D563FE265}" dt="2021-04-21T10:40:11.914" v="1084" actId="1076"/>
          <ac:picMkLst>
            <pc:docMk/>
            <pc:sldMk cId="754859798" sldId="804"/>
            <ac:picMk id="4" creationId="{F1ADD3B7-4D2A-4F17-8DAD-3D79F112E949}"/>
          </ac:picMkLst>
        </pc:picChg>
      </pc:sldChg>
      <pc:sldChg chg="add del ord">
        <pc:chgData name="Tsujimoto,Mitsuhiro 辻本光宏(関東北甲信越統括支店O領域専門室)" userId="7251bc67-91ee-45c9-97e7-9c240c9b485c" providerId="ADAL" clId="{51945A91-CB03-4A52-98BE-5B2D563FE265}" dt="2021-04-21T10:43:10.605" v="1211" actId="2696"/>
        <pc:sldMkLst>
          <pc:docMk/>
          <pc:sldMk cId="3365467611" sldId="805"/>
        </pc:sldMkLst>
      </pc:sldChg>
      <pc:sldChg chg="addSp delSp modSp add del">
        <pc:chgData name="Tsujimoto,Mitsuhiro 辻本光宏(関東北甲信越統括支店O領域専門室)" userId="7251bc67-91ee-45c9-97e7-9c240c9b485c" providerId="ADAL" clId="{51945A91-CB03-4A52-98BE-5B2D563FE265}" dt="2021-04-21T11:13:08.128" v="2023" actId="2696"/>
        <pc:sldMkLst>
          <pc:docMk/>
          <pc:sldMk cId="2564785880" sldId="806"/>
        </pc:sldMkLst>
        <pc:spChg chg="del">
          <ac:chgData name="Tsujimoto,Mitsuhiro 辻本光宏(関東北甲信越統括支店O領域専門室)" userId="7251bc67-91ee-45c9-97e7-9c240c9b485c" providerId="ADAL" clId="{51945A91-CB03-4A52-98BE-5B2D563FE265}" dt="2021-04-21T10:46:28.731" v="1300" actId="478"/>
          <ac:spMkLst>
            <pc:docMk/>
            <pc:sldMk cId="2564785880" sldId="806"/>
            <ac:spMk id="3" creationId="{0FFDB965-D10D-054E-B222-ECC4B0832174}"/>
          </ac:spMkLst>
        </pc:spChg>
        <pc:spChg chg="del">
          <ac:chgData name="Tsujimoto,Mitsuhiro 辻本光宏(関東北甲信越統括支店O領域専門室)" userId="7251bc67-91ee-45c9-97e7-9c240c9b485c" providerId="ADAL" clId="{51945A91-CB03-4A52-98BE-5B2D563FE265}" dt="2021-04-21T10:45:15.925" v="1297" actId="478"/>
          <ac:spMkLst>
            <pc:docMk/>
            <pc:sldMk cId="2564785880" sldId="806"/>
            <ac:spMk id="5" creationId="{1732FB2B-EC94-384D-8D3F-4AFB469B4368}"/>
          </ac:spMkLst>
        </pc:spChg>
        <pc:spChg chg="mod">
          <ac:chgData name="Tsujimoto,Mitsuhiro 辻本光宏(関東北甲信越統括支店O領域専門室)" userId="7251bc67-91ee-45c9-97e7-9c240c9b485c" providerId="ADAL" clId="{51945A91-CB03-4A52-98BE-5B2D563FE265}" dt="2021-04-21T10:44:05.163" v="1296"/>
          <ac:spMkLst>
            <pc:docMk/>
            <pc:sldMk cId="2564785880" sldId="806"/>
            <ac:spMk id="19" creationId="{586C9E94-5797-A445-AAB4-474A75B6BEF9}"/>
          </ac:spMkLst>
        </pc:spChg>
        <pc:spChg chg="mod">
          <ac:chgData name="Tsujimoto,Mitsuhiro 辻本光宏(関東北甲信越統括支店O領域専門室)" userId="7251bc67-91ee-45c9-97e7-9c240c9b485c" providerId="ADAL" clId="{51945A91-CB03-4A52-98BE-5B2D563FE265}" dt="2021-04-21T10:47:18.663" v="1308"/>
          <ac:spMkLst>
            <pc:docMk/>
            <pc:sldMk cId="2564785880" sldId="806"/>
            <ac:spMk id="21" creationId="{68652415-89B3-264F-ABFE-2505F946F76E}"/>
          </ac:spMkLst>
        </pc:spChg>
        <pc:spChg chg="del">
          <ac:chgData name="Tsujimoto,Mitsuhiro 辻本光宏(関東北甲信越統括支店O領域専門室)" userId="7251bc67-91ee-45c9-97e7-9c240c9b485c" providerId="ADAL" clId="{51945A91-CB03-4A52-98BE-5B2D563FE265}" dt="2021-04-21T10:46:18.894" v="1298" actId="478"/>
          <ac:spMkLst>
            <pc:docMk/>
            <pc:sldMk cId="2564785880" sldId="806"/>
            <ac:spMk id="22" creationId="{FFB4E4D8-A512-DA47-A149-931ABED48DB9}"/>
          </ac:spMkLst>
        </pc:spChg>
        <pc:spChg chg="add mod">
          <ac:chgData name="Tsujimoto,Mitsuhiro 辻本光宏(関東北甲信越統括支店O領域専門室)" userId="7251bc67-91ee-45c9-97e7-9c240c9b485c" providerId="ADAL" clId="{51945A91-CB03-4A52-98BE-5B2D563FE265}" dt="2021-04-21T10:47:36.900" v="1311" actId="20577"/>
          <ac:spMkLst>
            <pc:docMk/>
            <pc:sldMk cId="2564785880" sldId="806"/>
            <ac:spMk id="30" creationId="{DFBD2038-73C2-4952-82C9-AF01669CA2AF}"/>
          </ac:spMkLst>
        </pc:spChg>
        <pc:spChg chg="del">
          <ac:chgData name="Tsujimoto,Mitsuhiro 辻本光宏(関東北甲信越統括支店O領域専門室)" userId="7251bc67-91ee-45c9-97e7-9c240c9b485c" providerId="ADAL" clId="{51945A91-CB03-4A52-98BE-5B2D563FE265}" dt="2021-04-21T10:46:24.129" v="1299" actId="478"/>
          <ac:spMkLst>
            <pc:docMk/>
            <pc:sldMk cId="2564785880" sldId="806"/>
            <ac:spMk id="34" creationId="{7E871A6B-A79D-454D-8153-3DFC5AEFDFEB}"/>
          </ac:spMkLst>
        </pc:spChg>
        <pc:picChg chg="mod">
          <ac:chgData name="Tsujimoto,Mitsuhiro 辻本光宏(関東北甲信越統括支店O領域専門室)" userId="7251bc67-91ee-45c9-97e7-9c240c9b485c" providerId="ADAL" clId="{51945A91-CB03-4A52-98BE-5B2D563FE265}" dt="2021-04-21T10:47:15.683" v="1304" actId="1076"/>
          <ac:picMkLst>
            <pc:docMk/>
            <pc:sldMk cId="2564785880" sldId="806"/>
            <ac:picMk id="29" creationId="{DEAB5E75-3159-694C-9A02-2FD031A504AD}"/>
          </ac:picMkLst>
        </pc:picChg>
        <pc:picChg chg="del">
          <ac:chgData name="Tsujimoto,Mitsuhiro 辻本光宏(関東北甲信越統括支店O領域専門室)" userId="7251bc67-91ee-45c9-97e7-9c240c9b485c" providerId="ADAL" clId="{51945A91-CB03-4A52-98BE-5B2D563FE265}" dt="2021-04-21T10:46:18.894" v="1298" actId="478"/>
          <ac:picMkLst>
            <pc:docMk/>
            <pc:sldMk cId="2564785880" sldId="806"/>
            <ac:picMk id="35" creationId="{F3295D2F-9D9A-C84C-9AFB-9878E51D7B09}"/>
          </ac:picMkLst>
        </pc:picChg>
        <pc:picChg chg="del">
          <ac:chgData name="Tsujimoto,Mitsuhiro 辻本光宏(関東北甲信越統括支店O領域専門室)" userId="7251bc67-91ee-45c9-97e7-9c240c9b485c" providerId="ADAL" clId="{51945A91-CB03-4A52-98BE-5B2D563FE265}" dt="2021-04-21T10:46:18.894" v="1298" actId="478"/>
          <ac:picMkLst>
            <pc:docMk/>
            <pc:sldMk cId="2564785880" sldId="806"/>
            <ac:picMk id="36" creationId="{D464B0E8-6038-A94B-A740-465C22FE2FB4}"/>
          </ac:picMkLst>
        </pc:picChg>
        <pc:picChg chg="del">
          <ac:chgData name="Tsujimoto,Mitsuhiro 辻本光宏(関東北甲信越統括支店O領域専門室)" userId="7251bc67-91ee-45c9-97e7-9c240c9b485c" providerId="ADAL" clId="{51945A91-CB03-4A52-98BE-5B2D563FE265}" dt="2021-04-21T10:46:24.129" v="1299" actId="478"/>
          <ac:picMkLst>
            <pc:docMk/>
            <pc:sldMk cId="2564785880" sldId="806"/>
            <ac:picMk id="38" creationId="{30CBFF71-D9CB-3C48-B680-AC826E6E01FB}"/>
          </ac:picMkLst>
        </pc:picChg>
      </pc:sldChg>
      <pc:sldChg chg="addSp delSp modSp add">
        <pc:chgData name="Tsujimoto,Mitsuhiro 辻本光宏(関東北甲信越統括支店O領域専門室)" userId="7251bc67-91ee-45c9-97e7-9c240c9b485c" providerId="ADAL" clId="{51945A91-CB03-4A52-98BE-5B2D563FE265}" dt="2021-04-23T05:27:14.737" v="13683" actId="1582"/>
        <pc:sldMkLst>
          <pc:docMk/>
          <pc:sldMk cId="4145765581" sldId="807"/>
        </pc:sldMkLst>
        <pc:spChg chg="del">
          <ac:chgData name="Tsujimoto,Mitsuhiro 辻本光宏(関東北甲信越統括支店O領域専門室)" userId="7251bc67-91ee-45c9-97e7-9c240c9b485c" providerId="ADAL" clId="{51945A91-CB03-4A52-98BE-5B2D563FE265}" dt="2021-04-21T10:48:19.415" v="1314" actId="478"/>
          <ac:spMkLst>
            <pc:docMk/>
            <pc:sldMk cId="4145765581" sldId="807"/>
            <ac:spMk id="2" creationId="{0E348BB1-97A9-F744-BAB3-EEC389A4CF70}"/>
          </ac:spMkLst>
        </pc:spChg>
        <pc:spChg chg="add del mod">
          <ac:chgData name="Tsujimoto,Mitsuhiro 辻本光宏(関東北甲信越統括支店O領域専門室)" userId="7251bc67-91ee-45c9-97e7-9c240c9b485c" providerId="ADAL" clId="{51945A91-CB03-4A52-98BE-5B2D563FE265}" dt="2021-04-21T10:50:28.472" v="1347" actId="478"/>
          <ac:spMkLst>
            <pc:docMk/>
            <pc:sldMk cId="4145765581" sldId="807"/>
            <ac:spMk id="3" creationId="{FE1FB816-632A-46FC-8BFD-824E326E229B}"/>
          </ac:spMkLst>
        </pc:spChg>
        <pc:spChg chg="add mod">
          <ac:chgData name="Tsujimoto,Mitsuhiro 辻本光宏(関東北甲信越統括支店O領域専門室)" userId="7251bc67-91ee-45c9-97e7-9c240c9b485c" providerId="ADAL" clId="{51945A91-CB03-4A52-98BE-5B2D563FE265}" dt="2021-04-23T00:50:40.469" v="8440" actId="2711"/>
          <ac:spMkLst>
            <pc:docMk/>
            <pc:sldMk cId="4145765581" sldId="807"/>
            <ac:spMk id="5" creationId="{2CC2D2C1-8C50-4799-BD18-9E7065EFF618}"/>
          </ac:spMkLst>
        </pc:spChg>
        <pc:spChg chg="mod">
          <ac:chgData name="Tsujimoto,Mitsuhiro 辻本光宏(関東北甲信越統括支店O領域専門室)" userId="7251bc67-91ee-45c9-97e7-9c240c9b485c" providerId="ADAL" clId="{51945A91-CB03-4A52-98BE-5B2D563FE265}" dt="2021-04-23T05:27:14.737" v="13683" actId="1582"/>
          <ac:spMkLst>
            <pc:docMk/>
            <pc:sldMk cId="4145765581" sldId="807"/>
            <ac:spMk id="8" creationId="{FDE014BE-09AA-5F45-B7DF-AE8106588CE9}"/>
          </ac:spMkLst>
        </pc:spChg>
        <pc:spChg chg="mod">
          <ac:chgData name="Tsujimoto,Mitsuhiro 辻本光宏(関東北甲信越統括支店O領域専門室)" userId="7251bc67-91ee-45c9-97e7-9c240c9b485c" providerId="ADAL" clId="{51945A91-CB03-4A52-98BE-5B2D563FE265}" dt="2021-04-21T11:25:51.540" v="2323" actId="207"/>
          <ac:spMkLst>
            <pc:docMk/>
            <pc:sldMk cId="4145765581" sldId="807"/>
            <ac:spMk id="19" creationId="{586C9E94-5797-A445-AAB4-474A75B6BEF9}"/>
          </ac:spMkLst>
        </pc:spChg>
        <pc:spChg chg="del">
          <ac:chgData name="Tsujimoto,Mitsuhiro 辻本光宏(関東北甲信越統括支店O領域専門室)" userId="7251bc67-91ee-45c9-97e7-9c240c9b485c" providerId="ADAL" clId="{51945A91-CB03-4A52-98BE-5B2D563FE265}" dt="2021-04-21T10:48:18.595" v="1313" actId="478"/>
          <ac:spMkLst>
            <pc:docMk/>
            <pc:sldMk cId="4145765581" sldId="807"/>
            <ac:spMk id="20" creationId="{72BF7D92-AD67-8F4F-85C7-FB65D34A4020}"/>
          </ac:spMkLst>
        </pc:spChg>
        <pc:spChg chg="mod">
          <ac:chgData name="Tsujimoto,Mitsuhiro 辻本光宏(関東北甲信越統括支店O領域専門室)" userId="7251bc67-91ee-45c9-97e7-9c240c9b485c" providerId="ADAL" clId="{51945A91-CB03-4A52-98BE-5B2D563FE265}" dt="2021-04-23T05:27:14.737" v="13683" actId="1582"/>
          <ac:spMkLst>
            <pc:docMk/>
            <pc:sldMk cId="4145765581" sldId="807"/>
            <ac:spMk id="21" creationId="{68652415-89B3-264F-ABFE-2505F946F76E}"/>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22" creationId="{4F8FD102-CBEB-40A3-8679-10EB0E8C8272}"/>
          </ac:spMkLst>
        </pc:spChg>
        <pc:spChg chg="del">
          <ac:chgData name="Tsujimoto,Mitsuhiro 辻本光宏(関東北甲信越統括支店O領域専門室)" userId="7251bc67-91ee-45c9-97e7-9c240c9b485c" providerId="ADAL" clId="{51945A91-CB03-4A52-98BE-5B2D563FE265}" dt="2021-04-21T10:48:19.949" v="1315" actId="478"/>
          <ac:spMkLst>
            <pc:docMk/>
            <pc:sldMk cId="4145765581" sldId="807"/>
            <ac:spMk id="23" creationId="{74753931-748B-AC49-8FA9-77F65B8D4A26}"/>
          </ac:spMkLst>
        </pc:spChg>
        <pc:spChg chg="del">
          <ac:chgData name="Tsujimoto,Mitsuhiro 辻本光宏(関東北甲信越統括支店O領域専門室)" userId="7251bc67-91ee-45c9-97e7-9c240c9b485c" providerId="ADAL" clId="{51945A91-CB03-4A52-98BE-5B2D563FE265}" dt="2021-04-21T10:48:21.022" v="1316" actId="478"/>
          <ac:spMkLst>
            <pc:docMk/>
            <pc:sldMk cId="4145765581" sldId="807"/>
            <ac:spMk id="24" creationId="{B16C1683-A929-7744-94D4-0F5C50428E6B}"/>
          </ac:spMkLst>
        </pc:spChg>
        <pc:spChg chg="mod">
          <ac:chgData name="Tsujimoto,Mitsuhiro 辻本光宏(関東北甲信越統括支店O領域専門室)" userId="7251bc67-91ee-45c9-97e7-9c240c9b485c" providerId="ADAL" clId="{51945A91-CB03-4A52-98BE-5B2D563FE265}" dt="2021-04-23T05:27:14.737" v="13683" actId="1582"/>
          <ac:spMkLst>
            <pc:docMk/>
            <pc:sldMk cId="4145765581" sldId="807"/>
            <ac:spMk id="30" creationId="{DFBD2038-73C2-4952-82C9-AF01669CA2AF}"/>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34" creationId="{15FC5245-67C5-4CDB-9227-99C551C77E06}"/>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35" creationId="{7C650640-8152-487A-B452-14E9754E7433}"/>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36" creationId="{F4935562-E5B0-416C-AC38-9088FA0117EC}"/>
          </ac:spMkLst>
        </pc:spChg>
        <pc:spChg chg="add mod ord">
          <ac:chgData name="Tsujimoto,Mitsuhiro 辻本光宏(関東北甲信越統括支店O領域専門室)" userId="7251bc67-91ee-45c9-97e7-9c240c9b485c" providerId="ADAL" clId="{51945A91-CB03-4A52-98BE-5B2D563FE265}" dt="2021-04-21T11:31:49.307" v="2429" actId="1035"/>
          <ac:spMkLst>
            <pc:docMk/>
            <pc:sldMk cId="4145765581" sldId="807"/>
            <ac:spMk id="37" creationId="{74189C18-88B4-46EE-BBAE-951F2B626B8B}"/>
          </ac:spMkLst>
        </pc:spChg>
        <pc:spChg chg="add mod ord">
          <ac:chgData name="Tsujimoto,Mitsuhiro 辻本光宏(関東北甲信越統括支店O領域専門室)" userId="7251bc67-91ee-45c9-97e7-9c240c9b485c" providerId="ADAL" clId="{51945A91-CB03-4A52-98BE-5B2D563FE265}" dt="2021-04-21T11:31:49.307" v="2429" actId="1035"/>
          <ac:spMkLst>
            <pc:docMk/>
            <pc:sldMk cId="4145765581" sldId="807"/>
            <ac:spMk id="38" creationId="{AC2B22A5-AAF7-404E-BCB1-45FA114CFD95}"/>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39" creationId="{92C5781D-2E2D-4275-960F-363548B1E9C4}"/>
          </ac:spMkLst>
        </pc:spChg>
        <pc:spChg chg="add mod ord">
          <ac:chgData name="Tsujimoto,Mitsuhiro 辻本光宏(関東北甲信越統括支店O領域専門室)" userId="7251bc67-91ee-45c9-97e7-9c240c9b485c" providerId="ADAL" clId="{51945A91-CB03-4A52-98BE-5B2D563FE265}" dt="2021-04-21T11:31:49.307" v="2429" actId="1035"/>
          <ac:spMkLst>
            <pc:docMk/>
            <pc:sldMk cId="4145765581" sldId="807"/>
            <ac:spMk id="40" creationId="{465F4497-0354-4762-94B4-B4EDBFFF1FDA}"/>
          </ac:spMkLst>
        </pc:spChg>
        <pc:spChg chg="add mod">
          <ac:chgData name="Tsujimoto,Mitsuhiro 辻本光宏(関東北甲信越統括支店O領域専門室)" userId="7251bc67-91ee-45c9-97e7-9c240c9b485c" providerId="ADAL" clId="{51945A91-CB03-4A52-98BE-5B2D563FE265}" dt="2021-04-23T00:50:40.469" v="8440" actId="2711"/>
          <ac:spMkLst>
            <pc:docMk/>
            <pc:sldMk cId="4145765581" sldId="807"/>
            <ac:spMk id="41" creationId="{F97E967E-8A32-42C3-9DA2-9599FAEE3329}"/>
          </ac:spMkLst>
        </pc:spChg>
        <pc:spChg chg="add mod ord">
          <ac:chgData name="Tsujimoto,Mitsuhiro 辻本光宏(関東北甲信越統括支店O領域専門室)" userId="7251bc67-91ee-45c9-97e7-9c240c9b485c" providerId="ADAL" clId="{51945A91-CB03-4A52-98BE-5B2D563FE265}" dt="2021-04-23T00:50:40.469" v="8440" actId="2711"/>
          <ac:spMkLst>
            <pc:docMk/>
            <pc:sldMk cId="4145765581" sldId="807"/>
            <ac:spMk id="42" creationId="{51BF03D5-C93E-4BC4-B3BB-69C9D7F3BFA5}"/>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43" creationId="{F9351855-8253-4B0F-999B-DDCE0A79F59C}"/>
          </ac:spMkLst>
        </pc:spChg>
        <pc:spChg chg="add mod ord">
          <ac:chgData name="Tsujimoto,Mitsuhiro 辻本光宏(関東北甲信越統括支店O領域専門室)" userId="7251bc67-91ee-45c9-97e7-9c240c9b485c" providerId="ADAL" clId="{51945A91-CB03-4A52-98BE-5B2D563FE265}" dt="2021-04-21T11:31:49.307" v="2429" actId="1035"/>
          <ac:spMkLst>
            <pc:docMk/>
            <pc:sldMk cId="4145765581" sldId="807"/>
            <ac:spMk id="44" creationId="{DAF73590-ED12-4044-8DDB-888E3FF019CC}"/>
          </ac:spMkLst>
        </pc:spChg>
        <pc:spChg chg="add mod ord">
          <ac:chgData name="Tsujimoto,Mitsuhiro 辻本光宏(関東北甲信越統括支店O領域専門室)" userId="7251bc67-91ee-45c9-97e7-9c240c9b485c" providerId="ADAL" clId="{51945A91-CB03-4A52-98BE-5B2D563FE265}" dt="2021-04-21T11:31:49.307" v="2429" actId="1035"/>
          <ac:spMkLst>
            <pc:docMk/>
            <pc:sldMk cId="4145765581" sldId="807"/>
            <ac:spMk id="45" creationId="{48BEB54C-D760-4516-B9EA-A97EAFD353FF}"/>
          </ac:spMkLst>
        </pc:spChg>
        <pc:spChg chg="add mod ord">
          <ac:chgData name="Tsujimoto,Mitsuhiro 辻本光宏(関東北甲信越統括支店O領域専門室)" userId="7251bc67-91ee-45c9-97e7-9c240c9b485c" providerId="ADAL" clId="{51945A91-CB03-4A52-98BE-5B2D563FE265}" dt="2021-04-21T11:31:49.307" v="2429" actId="1035"/>
          <ac:spMkLst>
            <pc:docMk/>
            <pc:sldMk cId="4145765581" sldId="807"/>
            <ac:spMk id="46" creationId="{394419AE-5C7D-46C0-85A7-E8D5C15F48E8}"/>
          </ac:spMkLst>
        </pc:spChg>
        <pc:spChg chg="add mod ord">
          <ac:chgData name="Tsujimoto,Mitsuhiro 辻本光宏(関東北甲信越統括支店O領域専門室)" userId="7251bc67-91ee-45c9-97e7-9c240c9b485c" providerId="ADAL" clId="{51945A91-CB03-4A52-98BE-5B2D563FE265}" dt="2021-04-23T00:50:40.469" v="8440" actId="2711"/>
          <ac:spMkLst>
            <pc:docMk/>
            <pc:sldMk cId="4145765581" sldId="807"/>
            <ac:spMk id="47" creationId="{9FC97ACB-6F27-4F99-AC45-AB504C91B62B}"/>
          </ac:spMkLst>
        </pc:spChg>
        <pc:spChg chg="add mod ord">
          <ac:chgData name="Tsujimoto,Mitsuhiro 辻本光宏(関東北甲信越統括支店O領域専門室)" userId="7251bc67-91ee-45c9-97e7-9c240c9b485c" providerId="ADAL" clId="{51945A91-CB03-4A52-98BE-5B2D563FE265}" dt="2021-04-23T00:50:40.469" v="8440" actId="2711"/>
          <ac:spMkLst>
            <pc:docMk/>
            <pc:sldMk cId="4145765581" sldId="807"/>
            <ac:spMk id="48" creationId="{A53B9A91-B602-42A0-8F8C-26A66D664EF7}"/>
          </ac:spMkLst>
        </pc:spChg>
        <pc:spChg chg="add mod">
          <ac:chgData name="Tsujimoto,Mitsuhiro 辻本光宏(関東北甲信越統括支店O領域専門室)" userId="7251bc67-91ee-45c9-97e7-9c240c9b485c" providerId="ADAL" clId="{51945A91-CB03-4A52-98BE-5B2D563FE265}" dt="2021-04-23T00:50:40.469" v="8440" actId="2711"/>
          <ac:spMkLst>
            <pc:docMk/>
            <pc:sldMk cId="4145765581" sldId="807"/>
            <ac:spMk id="49" creationId="{94BB53C5-F7BF-41FD-9AFF-8D19BF32E0CD}"/>
          </ac:spMkLst>
        </pc:spChg>
        <pc:spChg chg="add del mod">
          <ac:chgData name="Tsujimoto,Mitsuhiro 辻本光宏(関東北甲信越統括支店O領域専門室)" userId="7251bc67-91ee-45c9-97e7-9c240c9b485c" providerId="ADAL" clId="{51945A91-CB03-4A52-98BE-5B2D563FE265}" dt="2021-04-21T11:11:14.452" v="1983" actId="478"/>
          <ac:spMkLst>
            <pc:docMk/>
            <pc:sldMk cId="4145765581" sldId="807"/>
            <ac:spMk id="50" creationId="{BB67D3F5-E298-4F1D-9A6C-4BB0F59C09E0}"/>
          </ac:spMkLst>
        </pc:spChg>
        <pc:spChg chg="add del mod">
          <ac:chgData name="Tsujimoto,Mitsuhiro 辻本光宏(関東北甲信越統括支店O領域専門室)" userId="7251bc67-91ee-45c9-97e7-9c240c9b485c" providerId="ADAL" clId="{51945A91-CB03-4A52-98BE-5B2D563FE265}" dt="2021-04-21T11:11:14.452" v="1983" actId="478"/>
          <ac:spMkLst>
            <pc:docMk/>
            <pc:sldMk cId="4145765581" sldId="807"/>
            <ac:spMk id="51" creationId="{EF8ED764-89BA-48B8-BF14-7912107E7475}"/>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52" creationId="{80F871E2-7D28-47BA-B3F6-D670E4B44E00}"/>
          </ac:spMkLst>
        </pc:spChg>
        <pc:spChg chg="add mod">
          <ac:chgData name="Tsujimoto,Mitsuhiro 辻本光宏(関東北甲信越統括支店O領域専門室)" userId="7251bc67-91ee-45c9-97e7-9c240c9b485c" providerId="ADAL" clId="{51945A91-CB03-4A52-98BE-5B2D563FE265}" dt="2021-04-23T00:51:02.582" v="8441" actId="2711"/>
          <ac:spMkLst>
            <pc:docMk/>
            <pc:sldMk cId="4145765581" sldId="807"/>
            <ac:spMk id="53" creationId="{D238160D-DD87-4A34-864E-7901FFEC987C}"/>
          </ac:spMkLst>
        </pc:spChg>
        <pc:spChg chg="add mod">
          <ac:chgData name="Tsujimoto,Mitsuhiro 辻本光宏(関東北甲信越統括支店O領域専門室)" userId="7251bc67-91ee-45c9-97e7-9c240c9b485c" providerId="ADAL" clId="{51945A91-CB03-4A52-98BE-5B2D563FE265}" dt="2021-04-23T00:50:19.390" v="8439" actId="12"/>
          <ac:spMkLst>
            <pc:docMk/>
            <pc:sldMk cId="4145765581" sldId="807"/>
            <ac:spMk id="54" creationId="{39469172-F535-49AC-83AA-04298BF088E0}"/>
          </ac:spMkLst>
        </pc:spChg>
        <pc:grpChg chg="del mod">
          <ac:chgData name="Tsujimoto,Mitsuhiro 辻本光宏(関東北甲信越統括支店O領域専門室)" userId="7251bc67-91ee-45c9-97e7-9c240c9b485c" providerId="ADAL" clId="{51945A91-CB03-4A52-98BE-5B2D563FE265}" dt="2021-04-21T11:11:16.277" v="1984" actId="478"/>
          <ac:grpSpMkLst>
            <pc:docMk/>
            <pc:sldMk cId="4145765581" sldId="807"/>
            <ac:grpSpMk id="4" creationId="{AE7B87B8-06E6-9B4D-B05B-D8A1E2D9DADC}"/>
          </ac:grpSpMkLst>
        </pc:grpChg>
        <pc:picChg chg="del">
          <ac:chgData name="Tsujimoto,Mitsuhiro 辻本光宏(関東北甲信越統括支店O領域専門室)" userId="7251bc67-91ee-45c9-97e7-9c240c9b485c" providerId="ADAL" clId="{51945A91-CB03-4A52-98BE-5B2D563FE265}" dt="2021-04-21T10:56:47.994" v="1576" actId="478"/>
          <ac:picMkLst>
            <pc:docMk/>
            <pc:sldMk cId="4145765581" sldId="807"/>
            <ac:picMk id="27" creationId="{67230B02-5FC1-894A-B685-ACD436DABD1A}"/>
          </ac:picMkLst>
        </pc:picChg>
        <pc:picChg chg="del">
          <ac:chgData name="Tsujimoto,Mitsuhiro 辻本光宏(関東北甲信越統括支店O領域専門室)" userId="7251bc67-91ee-45c9-97e7-9c240c9b485c" providerId="ADAL" clId="{51945A91-CB03-4A52-98BE-5B2D563FE265}" dt="2021-04-21T11:05:57.622" v="1811" actId="478"/>
          <ac:picMkLst>
            <pc:docMk/>
            <pc:sldMk cId="4145765581" sldId="807"/>
            <ac:picMk id="28" creationId="{BC38BFB8-CC7E-204E-B819-3F17B215536B}"/>
          </ac:picMkLst>
        </pc:picChg>
        <pc:picChg chg="del mod">
          <ac:chgData name="Tsujimoto,Mitsuhiro 辻本光宏(関東北甲信越統括支店O領域専門室)" userId="7251bc67-91ee-45c9-97e7-9c240c9b485c" providerId="ADAL" clId="{51945A91-CB03-4A52-98BE-5B2D563FE265}" dt="2021-04-21T11:05:59.367" v="1812" actId="478"/>
          <ac:picMkLst>
            <pc:docMk/>
            <pc:sldMk cId="4145765581" sldId="807"/>
            <ac:picMk id="29" creationId="{DEAB5E75-3159-694C-9A02-2FD031A504AD}"/>
          </ac:picMkLst>
        </pc:picChg>
        <pc:picChg chg="del">
          <ac:chgData name="Tsujimoto,Mitsuhiro 辻本光宏(関東北甲信越統括支店O領域専門室)" userId="7251bc67-91ee-45c9-97e7-9c240c9b485c" providerId="ADAL" clId="{51945A91-CB03-4A52-98BE-5B2D563FE265}" dt="2021-04-21T10:56:47.994" v="1576" actId="478"/>
          <ac:picMkLst>
            <pc:docMk/>
            <pc:sldMk cId="4145765581" sldId="807"/>
            <ac:picMk id="31" creationId="{64787B15-8B47-3B47-9E3B-3CFBB035B05F}"/>
          </ac:picMkLst>
        </pc:picChg>
        <pc:picChg chg="del">
          <ac:chgData name="Tsujimoto,Mitsuhiro 辻本光宏(関東北甲信越統括支店O領域専門室)" userId="7251bc67-91ee-45c9-97e7-9c240c9b485c" providerId="ADAL" clId="{51945A91-CB03-4A52-98BE-5B2D563FE265}" dt="2021-04-21T10:56:47.994" v="1576" actId="478"/>
          <ac:picMkLst>
            <pc:docMk/>
            <pc:sldMk cId="4145765581" sldId="807"/>
            <ac:picMk id="32" creationId="{4D6C2D23-0778-674A-AC53-618214C68C09}"/>
          </ac:picMkLst>
        </pc:picChg>
        <pc:picChg chg="del">
          <ac:chgData name="Tsujimoto,Mitsuhiro 辻本光宏(関東北甲信越統括支店O領域専門室)" userId="7251bc67-91ee-45c9-97e7-9c240c9b485c" providerId="ADAL" clId="{51945A91-CB03-4A52-98BE-5B2D563FE265}" dt="2021-04-21T10:56:47.994" v="1576" actId="478"/>
          <ac:picMkLst>
            <pc:docMk/>
            <pc:sldMk cId="4145765581" sldId="807"/>
            <ac:picMk id="33" creationId="{9B1CD3F3-8EAF-D845-A22B-69ADDB7E22E8}"/>
          </ac:picMkLst>
        </pc:picChg>
      </pc:sldChg>
      <pc:sldChg chg="add del">
        <pc:chgData name="Tsujimoto,Mitsuhiro 辻本光宏(関東北甲信越統括支店O領域専門室)" userId="7251bc67-91ee-45c9-97e7-9c240c9b485c" providerId="ADAL" clId="{51945A91-CB03-4A52-98BE-5B2D563FE265}" dt="2021-04-21T11:27:08.380" v="2357"/>
        <pc:sldMkLst>
          <pc:docMk/>
          <pc:sldMk cId="1230001186" sldId="808"/>
        </pc:sldMkLst>
      </pc:sldChg>
      <pc:sldChg chg="add del">
        <pc:chgData name="Tsujimoto,Mitsuhiro 辻本光宏(関東北甲信越統括支店O領域専門室)" userId="7251bc67-91ee-45c9-97e7-9c240c9b485c" providerId="ADAL" clId="{51945A91-CB03-4A52-98BE-5B2D563FE265}" dt="2021-04-21T11:27:04.224" v="2355"/>
        <pc:sldMkLst>
          <pc:docMk/>
          <pc:sldMk cId="1615625858" sldId="808"/>
        </pc:sldMkLst>
      </pc:sldChg>
      <pc:sldChg chg="add del">
        <pc:chgData name="Tsujimoto,Mitsuhiro 辻本光宏(関東北甲信越統括支店O領域専門室)" userId="7251bc67-91ee-45c9-97e7-9c240c9b485c" providerId="ADAL" clId="{51945A91-CB03-4A52-98BE-5B2D563FE265}" dt="2021-04-21T11:29:54.656" v="2395"/>
        <pc:sldMkLst>
          <pc:docMk/>
          <pc:sldMk cId="3032310633" sldId="808"/>
        </pc:sldMkLst>
      </pc:sldChg>
      <pc:sldChg chg="addSp modSp add ord">
        <pc:chgData name="Tsujimoto,Mitsuhiro 辻本光宏(関東北甲信越統括支店O領域専門室)" userId="7251bc67-91ee-45c9-97e7-9c240c9b485c" providerId="ADAL" clId="{51945A91-CB03-4A52-98BE-5B2D563FE265}" dt="2021-04-23T05:14:35.002" v="13615" actId="2711"/>
        <pc:sldMkLst>
          <pc:docMk/>
          <pc:sldMk cId="3286819254" sldId="808"/>
        </pc:sldMkLst>
        <pc:spChg chg="add mod">
          <ac:chgData name="Tsujimoto,Mitsuhiro 辻本光宏(関東北甲信越統括支店O領域専門室)" userId="7251bc67-91ee-45c9-97e7-9c240c9b485c" providerId="ADAL" clId="{51945A91-CB03-4A52-98BE-5B2D563FE265}" dt="2021-04-22T01:25:44.457" v="2499"/>
          <ac:spMkLst>
            <pc:docMk/>
            <pc:sldMk cId="3286819254" sldId="808"/>
            <ac:spMk id="2" creationId="{07C935AC-66CE-4B5E-B09D-5FAB3CDFADD4}"/>
          </ac:spMkLst>
        </pc:spChg>
        <pc:spChg chg="add mod">
          <ac:chgData name="Tsujimoto,Mitsuhiro 辻本光宏(関東北甲信越統括支店O領域専門室)" userId="7251bc67-91ee-45c9-97e7-9c240c9b485c" providerId="ADAL" clId="{51945A91-CB03-4A52-98BE-5B2D563FE265}" dt="2021-04-23T05:14:35.002" v="13615" actId="2711"/>
          <ac:spMkLst>
            <pc:docMk/>
            <pc:sldMk cId="3286819254" sldId="808"/>
            <ac:spMk id="3" creationId="{F40FF731-017A-4AE1-9261-D60D79D216C2}"/>
          </ac:spMkLst>
        </pc:spChg>
      </pc:sldChg>
      <pc:sldChg chg="add del">
        <pc:chgData name="Tsujimoto,Mitsuhiro 辻本光宏(関東北甲信越統括支店O領域専門室)" userId="7251bc67-91ee-45c9-97e7-9c240c9b485c" providerId="ADAL" clId="{51945A91-CB03-4A52-98BE-5B2D563FE265}" dt="2021-04-21T11:20:36.221" v="2172" actId="2696"/>
        <pc:sldMkLst>
          <pc:docMk/>
          <pc:sldMk cId="3464021814" sldId="808"/>
        </pc:sldMkLst>
      </pc:sldChg>
      <pc:sldChg chg="add del">
        <pc:chgData name="Tsujimoto,Mitsuhiro 辻本光宏(関東北甲信越統括支店O領域専門室)" userId="7251bc67-91ee-45c9-97e7-9c240c9b485c" providerId="ADAL" clId="{51945A91-CB03-4A52-98BE-5B2D563FE265}" dt="2021-04-21T11:20:36.082" v="2171" actId="2696"/>
        <pc:sldMkLst>
          <pc:docMk/>
          <pc:sldMk cId="1332007987" sldId="809"/>
        </pc:sldMkLst>
      </pc:sldChg>
      <pc:sldChg chg="modSp add del">
        <pc:chgData name="Tsujimoto,Mitsuhiro 辻本光宏(関東北甲信越統括支店O領域専門室)" userId="7251bc67-91ee-45c9-97e7-9c240c9b485c" providerId="ADAL" clId="{51945A91-CB03-4A52-98BE-5B2D563FE265}" dt="2021-04-23T05:14:55.867" v="13619" actId="2696"/>
        <pc:sldMkLst>
          <pc:docMk/>
          <pc:sldMk cId="2089715913" sldId="809"/>
        </pc:sldMkLst>
        <pc:spChg chg="mod">
          <ac:chgData name="Tsujimoto,Mitsuhiro 辻本光宏(関東北甲信越統括支店O領域専門室)" userId="7251bc67-91ee-45c9-97e7-9c240c9b485c" providerId="ADAL" clId="{51945A91-CB03-4A52-98BE-5B2D563FE265}" dt="2021-04-22T01:26:51.073" v="2508" actId="207"/>
          <ac:spMkLst>
            <pc:docMk/>
            <pc:sldMk cId="2089715913" sldId="809"/>
            <ac:spMk id="3" creationId="{F40FF731-017A-4AE1-9261-D60D79D216C2}"/>
          </ac:spMkLst>
        </pc:spChg>
      </pc:sldChg>
      <pc:sldChg chg="add del">
        <pc:chgData name="Tsujimoto,Mitsuhiro 辻本光宏(関東北甲信越統括支店O領域専門室)" userId="7251bc67-91ee-45c9-97e7-9c240c9b485c" providerId="ADAL" clId="{51945A91-CB03-4A52-98BE-5B2D563FE265}" dt="2021-04-21T11:20:26.392" v="2169"/>
        <pc:sldMkLst>
          <pc:docMk/>
          <pc:sldMk cId="4055567938" sldId="809"/>
        </pc:sldMkLst>
      </pc:sldChg>
      <pc:sldChg chg="addSp delSp modSp add mod ord setBg">
        <pc:chgData name="Tsujimoto,Mitsuhiro 辻本光宏(関東北甲信越統括支店O領域専門室)" userId="7251bc67-91ee-45c9-97e7-9c240c9b485c" providerId="ADAL" clId="{51945A91-CB03-4A52-98BE-5B2D563FE265}" dt="2021-04-23T05:05:04.686" v="12670" actId="20577"/>
        <pc:sldMkLst>
          <pc:docMk/>
          <pc:sldMk cId="3607764144" sldId="810"/>
        </pc:sldMkLst>
        <pc:spChg chg="add mod">
          <ac:chgData name="Tsujimoto,Mitsuhiro 辻本光宏(関東北甲信越統括支店O領域専門室)" userId="7251bc67-91ee-45c9-97e7-9c240c9b485c" providerId="ADAL" clId="{51945A91-CB03-4A52-98BE-5B2D563FE265}" dt="2021-04-23T05:05:04.686" v="12670" actId="20577"/>
          <ac:spMkLst>
            <pc:docMk/>
            <pc:sldMk cId="3607764144" sldId="810"/>
            <ac:spMk id="2" creationId="{E9C84B9A-0A5E-4501-A736-97E7536FAD85}"/>
          </ac:spMkLst>
        </pc:spChg>
        <pc:spChg chg="add mod">
          <ac:chgData name="Tsujimoto,Mitsuhiro 辻本光宏(関東北甲信越統括支店O領域専門室)" userId="7251bc67-91ee-45c9-97e7-9c240c9b485c" providerId="ADAL" clId="{51945A91-CB03-4A52-98BE-5B2D563FE265}" dt="2021-04-22T01:40:55.922" v="2591" actId="1076"/>
          <ac:spMkLst>
            <pc:docMk/>
            <pc:sldMk cId="3607764144" sldId="810"/>
            <ac:spMk id="5" creationId="{66CDE537-D3FB-4F28-96C0-7B8AE05E5957}"/>
          </ac:spMkLst>
        </pc:spChg>
        <pc:spChg chg="add del mod">
          <ac:chgData name="Tsujimoto,Mitsuhiro 辻本光宏(関東北甲信越統括支店O領域専門室)" userId="7251bc67-91ee-45c9-97e7-9c240c9b485c" providerId="ADAL" clId="{51945A91-CB03-4A52-98BE-5B2D563FE265}" dt="2021-04-22T01:43:58.268" v="2790" actId="478"/>
          <ac:spMkLst>
            <pc:docMk/>
            <pc:sldMk cId="3607764144" sldId="810"/>
            <ac:spMk id="7" creationId="{04FA03F1-4527-4B00-BA5B-03C7BAF90C73}"/>
          </ac:spMkLst>
        </pc:spChg>
        <pc:spChg chg="add del">
          <ac:chgData name="Tsujimoto,Mitsuhiro 辻本光宏(関東北甲信越統括支店O領域専門室)" userId="7251bc67-91ee-45c9-97e7-9c240c9b485c" providerId="ADAL" clId="{51945A91-CB03-4A52-98BE-5B2D563FE265}" dt="2021-04-22T01:40:43.512" v="2589" actId="26606"/>
          <ac:spMkLst>
            <pc:docMk/>
            <pc:sldMk cId="3607764144" sldId="810"/>
            <ac:spMk id="8" creationId="{D4771268-CB57-404A-9271-370EB28F6090}"/>
          </ac:spMkLst>
        </pc:spChg>
        <pc:spChg chg="add mod">
          <ac:chgData name="Tsujimoto,Mitsuhiro 辻本光宏(関東北甲信越統括支店O領域専門室)" userId="7251bc67-91ee-45c9-97e7-9c240c9b485c" providerId="ADAL" clId="{51945A91-CB03-4A52-98BE-5B2D563FE265}" dt="2021-04-23T00:51:31.910" v="8447" actId="20577"/>
          <ac:spMkLst>
            <pc:docMk/>
            <pc:sldMk cId="3607764144" sldId="810"/>
            <ac:spMk id="9" creationId="{961A8DDC-52FD-43C8-8EB1-F361125483B3}"/>
          </ac:spMkLst>
        </pc:spChg>
        <pc:picChg chg="add mod">
          <ac:chgData name="Tsujimoto,Mitsuhiro 辻本光宏(関東北甲信越統括支店O領域専門室)" userId="7251bc67-91ee-45c9-97e7-9c240c9b485c" providerId="ADAL" clId="{51945A91-CB03-4A52-98BE-5B2D563FE265}" dt="2021-04-22T01:44:16.342" v="2795" actId="1076"/>
          <ac:picMkLst>
            <pc:docMk/>
            <pc:sldMk cId="3607764144" sldId="810"/>
            <ac:picMk id="3" creationId="{0324A52F-F015-43B5-8175-D577D5A88CCE}"/>
          </ac:picMkLst>
        </pc:picChg>
        <pc:picChg chg="add del mod">
          <ac:chgData name="Tsujimoto,Mitsuhiro 辻本光宏(関東北甲信越統括支店O領域専門室)" userId="7251bc67-91ee-45c9-97e7-9c240c9b485c" providerId="ADAL" clId="{51945A91-CB03-4A52-98BE-5B2D563FE265}" dt="2021-04-22T01:43:24.294" v="2728" actId="478"/>
          <ac:picMkLst>
            <pc:docMk/>
            <pc:sldMk cId="3607764144" sldId="810"/>
            <ac:picMk id="6" creationId="{6EFBFB6F-06C0-48C4-8A9F-9E001E869EFF}"/>
          </ac:picMkLst>
        </pc:picChg>
      </pc:sldChg>
      <pc:sldChg chg="addSp delSp modSp add">
        <pc:chgData name="Tsujimoto,Mitsuhiro 辻本光宏(関東北甲信越統括支店O領域専門室)" userId="7251bc67-91ee-45c9-97e7-9c240c9b485c" providerId="ADAL" clId="{51945A91-CB03-4A52-98BE-5B2D563FE265}" dt="2021-04-23T00:51:58.415" v="8450" actId="2711"/>
        <pc:sldMkLst>
          <pc:docMk/>
          <pc:sldMk cId="1506810546" sldId="811"/>
        </pc:sldMkLst>
        <pc:spChg chg="mod">
          <ac:chgData name="Tsujimoto,Mitsuhiro 辻本光宏(関東北甲信越統括支店O領域専門室)" userId="7251bc67-91ee-45c9-97e7-9c240c9b485c" providerId="ADAL" clId="{51945A91-CB03-4A52-98BE-5B2D563FE265}" dt="2021-04-22T01:46:24.277" v="2886" actId="20577"/>
          <ac:spMkLst>
            <pc:docMk/>
            <pc:sldMk cId="1506810546" sldId="811"/>
            <ac:spMk id="2" creationId="{E9C84B9A-0A5E-4501-A736-97E7536FAD85}"/>
          </ac:spMkLst>
        </pc:spChg>
        <pc:spChg chg="add mod">
          <ac:chgData name="Tsujimoto,Mitsuhiro 辻本光宏(関東北甲信越統括支店O領域専門室)" userId="7251bc67-91ee-45c9-97e7-9c240c9b485c" providerId="ADAL" clId="{51945A91-CB03-4A52-98BE-5B2D563FE265}" dt="2021-04-23T00:51:58.415" v="8450" actId="2711"/>
          <ac:spMkLst>
            <pc:docMk/>
            <pc:sldMk cId="1506810546" sldId="811"/>
            <ac:spMk id="6" creationId="{0B68DE6B-E955-419F-8245-97EFCF5E794C}"/>
          </ac:spMkLst>
        </pc:spChg>
        <pc:spChg chg="add mod">
          <ac:chgData name="Tsujimoto,Mitsuhiro 辻本光宏(関東北甲信越統括支店O領域専門室)" userId="7251bc67-91ee-45c9-97e7-9c240c9b485c" providerId="ADAL" clId="{51945A91-CB03-4A52-98BE-5B2D563FE265}" dt="2021-04-23T00:51:58.415" v="8450" actId="2711"/>
          <ac:spMkLst>
            <pc:docMk/>
            <pc:sldMk cId="1506810546" sldId="811"/>
            <ac:spMk id="7" creationId="{B09C1FE5-DDAB-4F19-9343-BC72A755A813}"/>
          </ac:spMkLst>
        </pc:spChg>
        <pc:spChg chg="add del mod">
          <ac:chgData name="Tsujimoto,Mitsuhiro 辻本光宏(関東北甲信越統括支店O領域専門室)" userId="7251bc67-91ee-45c9-97e7-9c240c9b485c" providerId="ADAL" clId="{51945A91-CB03-4A52-98BE-5B2D563FE265}" dt="2021-04-22T02:00:38.803" v="3297" actId="478"/>
          <ac:spMkLst>
            <pc:docMk/>
            <pc:sldMk cId="1506810546" sldId="811"/>
            <ac:spMk id="8" creationId="{60D7BE04-21B2-4D1B-AC5B-37E8FFA7A6F5}"/>
          </ac:spMkLst>
        </pc:spChg>
        <pc:spChg chg="add mod">
          <ac:chgData name="Tsujimoto,Mitsuhiro 辻本光宏(関東北甲信越統括支店O領域専門室)" userId="7251bc67-91ee-45c9-97e7-9c240c9b485c" providerId="ADAL" clId="{51945A91-CB03-4A52-98BE-5B2D563FE265}" dt="2021-04-23T00:51:47.775" v="8449" actId="2711"/>
          <ac:spMkLst>
            <pc:docMk/>
            <pc:sldMk cId="1506810546" sldId="811"/>
            <ac:spMk id="9" creationId="{762CF155-EB4E-4C98-B600-6186088405D3}"/>
          </ac:spMkLst>
        </pc:spChg>
        <pc:spChg chg="add del mod">
          <ac:chgData name="Tsujimoto,Mitsuhiro 辻本光宏(関東北甲信越統括支店O領域専門室)" userId="7251bc67-91ee-45c9-97e7-9c240c9b485c" providerId="ADAL" clId="{51945A91-CB03-4A52-98BE-5B2D563FE265}" dt="2021-04-22T02:00:38.803" v="3297" actId="478"/>
          <ac:spMkLst>
            <pc:docMk/>
            <pc:sldMk cId="1506810546" sldId="811"/>
            <ac:spMk id="10" creationId="{A6D081C5-4D4E-4BF8-A225-FF8864B6D32F}"/>
          </ac:spMkLst>
        </pc:spChg>
        <pc:spChg chg="add">
          <ac:chgData name="Tsujimoto,Mitsuhiro 辻本光宏(関東北甲信越統括支店O領域専門室)" userId="7251bc67-91ee-45c9-97e7-9c240c9b485c" providerId="ADAL" clId="{51945A91-CB03-4A52-98BE-5B2D563FE265}" dt="2021-04-22T02:16:37.116" v="4377"/>
          <ac:spMkLst>
            <pc:docMk/>
            <pc:sldMk cId="1506810546" sldId="811"/>
            <ac:spMk id="11" creationId="{EE2F06D4-38EF-422C-AE8A-55586C65FB11}"/>
          </ac:spMkLst>
        </pc:spChg>
        <pc:picChg chg="add del mod">
          <ac:chgData name="Tsujimoto,Mitsuhiro 辻本光宏(関東北甲信越統括支店O領域専門室)" userId="7251bc67-91ee-45c9-97e7-9c240c9b485c" providerId="ADAL" clId="{51945A91-CB03-4A52-98BE-5B2D563FE265}" dt="2021-04-22T01:49:04.302" v="2898" actId="478"/>
          <ac:picMkLst>
            <pc:docMk/>
            <pc:sldMk cId="1506810546" sldId="811"/>
            <ac:picMk id="3" creationId="{1EA1A2A9-9142-40E3-AAE6-82D2C18B58A1}"/>
          </ac:picMkLst>
        </pc:picChg>
        <pc:picChg chg="add mod">
          <ac:chgData name="Tsujimoto,Mitsuhiro 辻本光宏(関東北甲信越統括支店O領域専門室)" userId="7251bc67-91ee-45c9-97e7-9c240c9b485c" providerId="ADAL" clId="{51945A91-CB03-4A52-98BE-5B2D563FE265}" dt="2021-04-22T02:00:50.399" v="3332" actId="1035"/>
          <ac:picMkLst>
            <pc:docMk/>
            <pc:sldMk cId="1506810546" sldId="811"/>
            <ac:picMk id="4" creationId="{C22D6773-B427-4C61-BD07-8572F22B376A}"/>
          </ac:picMkLst>
        </pc:picChg>
        <pc:picChg chg="add mod">
          <ac:chgData name="Tsujimoto,Mitsuhiro 辻本光宏(関東北甲信越統括支店O領域専門室)" userId="7251bc67-91ee-45c9-97e7-9c240c9b485c" providerId="ADAL" clId="{51945A91-CB03-4A52-98BE-5B2D563FE265}" dt="2021-04-22T02:00:50.399" v="3332" actId="1035"/>
          <ac:picMkLst>
            <pc:docMk/>
            <pc:sldMk cId="1506810546" sldId="811"/>
            <ac:picMk id="5" creationId="{D42D850E-8750-4FAD-847E-E7966D672532}"/>
          </ac:picMkLst>
        </pc:picChg>
      </pc:sldChg>
      <pc:sldChg chg="addSp delSp modSp add">
        <pc:chgData name="Tsujimoto,Mitsuhiro 辻本光宏(関東北甲信越統括支店O領域専門室)" userId="7251bc67-91ee-45c9-97e7-9c240c9b485c" providerId="ADAL" clId="{51945A91-CB03-4A52-98BE-5B2D563FE265}" dt="2021-04-23T00:52:29.954" v="8455" actId="1076"/>
        <pc:sldMkLst>
          <pc:docMk/>
          <pc:sldMk cId="1562766757" sldId="812"/>
        </pc:sldMkLst>
        <pc:spChg chg="mod">
          <ac:chgData name="Tsujimoto,Mitsuhiro 辻本光宏(関東北甲信越統括支店O領域専門室)" userId="7251bc67-91ee-45c9-97e7-9c240c9b485c" providerId="ADAL" clId="{51945A91-CB03-4A52-98BE-5B2D563FE265}" dt="2021-04-22T01:53:22.827" v="2965" actId="20577"/>
          <ac:spMkLst>
            <pc:docMk/>
            <pc:sldMk cId="1562766757" sldId="812"/>
            <ac:spMk id="2" creationId="{E9C84B9A-0A5E-4501-A736-97E7536FAD85}"/>
          </ac:spMkLst>
        </pc:spChg>
        <pc:spChg chg="add mod">
          <ac:chgData name="Tsujimoto,Mitsuhiro 辻本光宏(関東北甲信越統括支店O領域専門室)" userId="7251bc67-91ee-45c9-97e7-9c240c9b485c" providerId="ADAL" clId="{51945A91-CB03-4A52-98BE-5B2D563FE265}" dt="2021-04-23T00:52:19.611" v="8453" actId="2711"/>
          <ac:spMkLst>
            <pc:docMk/>
            <pc:sldMk cId="1562766757" sldId="812"/>
            <ac:spMk id="6" creationId="{C8BD4B9B-AD02-4CA3-929B-D783269DFE6C}"/>
          </ac:spMkLst>
        </pc:spChg>
        <pc:spChg chg="add mod">
          <ac:chgData name="Tsujimoto,Mitsuhiro 辻本光宏(関東北甲信越統括支店O領域専門室)" userId="7251bc67-91ee-45c9-97e7-9c240c9b485c" providerId="ADAL" clId="{51945A91-CB03-4A52-98BE-5B2D563FE265}" dt="2021-04-23T00:52:29.954" v="8455" actId="1076"/>
          <ac:spMkLst>
            <pc:docMk/>
            <pc:sldMk cId="1562766757" sldId="812"/>
            <ac:spMk id="7" creationId="{2C9CC779-C35F-4D60-94BB-94616DE64975}"/>
          </ac:spMkLst>
        </pc:spChg>
        <pc:spChg chg="add mod">
          <ac:chgData name="Tsujimoto,Mitsuhiro 辻本光宏(関東北甲信越統括支店O領域専門室)" userId="7251bc67-91ee-45c9-97e7-9c240c9b485c" providerId="ADAL" clId="{51945A91-CB03-4A52-98BE-5B2D563FE265}" dt="2021-04-23T00:52:19.611" v="8453" actId="2711"/>
          <ac:spMkLst>
            <pc:docMk/>
            <pc:sldMk cId="1562766757" sldId="812"/>
            <ac:spMk id="8" creationId="{A5FB70D3-651D-42DA-9293-39C12F552FB4}"/>
          </ac:spMkLst>
        </pc:spChg>
        <pc:spChg chg="add mod">
          <ac:chgData name="Tsujimoto,Mitsuhiro 辻本光宏(関東北甲信越統括支店O領域専門室)" userId="7251bc67-91ee-45c9-97e7-9c240c9b485c" providerId="ADAL" clId="{51945A91-CB03-4A52-98BE-5B2D563FE265}" dt="2021-04-23T00:52:11.096" v="8452" actId="2711"/>
          <ac:spMkLst>
            <pc:docMk/>
            <pc:sldMk cId="1562766757" sldId="812"/>
            <ac:spMk id="9" creationId="{542BFC70-CD2B-4D3B-B7BE-3404BC9A63B4}"/>
          </ac:spMkLst>
        </pc:spChg>
        <pc:spChg chg="add del mod">
          <ac:chgData name="Tsujimoto,Mitsuhiro 辻本光宏(関東北甲信越統括支店O領域専門室)" userId="7251bc67-91ee-45c9-97e7-9c240c9b485c" providerId="ADAL" clId="{51945A91-CB03-4A52-98BE-5B2D563FE265}" dt="2021-04-22T02:06:38.877" v="3742" actId="478"/>
          <ac:spMkLst>
            <pc:docMk/>
            <pc:sldMk cId="1562766757" sldId="812"/>
            <ac:spMk id="10" creationId="{9521AB0C-FFA0-4945-AA97-EAF1714399A2}"/>
          </ac:spMkLst>
        </pc:spChg>
        <pc:spChg chg="add del mod">
          <ac:chgData name="Tsujimoto,Mitsuhiro 辻本光宏(関東北甲信越統括支店O領域専門室)" userId="7251bc67-91ee-45c9-97e7-9c240c9b485c" providerId="ADAL" clId="{51945A91-CB03-4A52-98BE-5B2D563FE265}" dt="2021-04-22T02:06:38.877" v="3742" actId="478"/>
          <ac:spMkLst>
            <pc:docMk/>
            <pc:sldMk cId="1562766757" sldId="812"/>
            <ac:spMk id="11" creationId="{0BF8374D-B367-4919-AE9B-53C8AB42D6D9}"/>
          </ac:spMkLst>
        </pc:spChg>
        <pc:spChg chg="add del mod">
          <ac:chgData name="Tsujimoto,Mitsuhiro 辻本光宏(関東北甲信越統括支店O領域専門室)" userId="7251bc67-91ee-45c9-97e7-9c240c9b485c" providerId="ADAL" clId="{51945A91-CB03-4A52-98BE-5B2D563FE265}" dt="2021-04-22T02:06:38.877" v="3742" actId="478"/>
          <ac:spMkLst>
            <pc:docMk/>
            <pc:sldMk cId="1562766757" sldId="812"/>
            <ac:spMk id="12" creationId="{83CE5817-0DDC-40C7-9DC2-8627F1CFAC9E}"/>
          </ac:spMkLst>
        </pc:spChg>
        <pc:spChg chg="add del mod">
          <ac:chgData name="Tsujimoto,Mitsuhiro 辻本光宏(関東北甲信越統括支店O領域専門室)" userId="7251bc67-91ee-45c9-97e7-9c240c9b485c" providerId="ADAL" clId="{51945A91-CB03-4A52-98BE-5B2D563FE265}" dt="2021-04-22T02:09:43.558" v="4235" actId="478"/>
          <ac:spMkLst>
            <pc:docMk/>
            <pc:sldMk cId="1562766757" sldId="812"/>
            <ac:spMk id="13" creationId="{8B3FA2C3-B268-4247-8A7D-EAC25BEF271B}"/>
          </ac:spMkLst>
        </pc:spChg>
        <pc:spChg chg="add">
          <ac:chgData name="Tsujimoto,Mitsuhiro 辻本光宏(関東北甲信越統括支店O領域専門室)" userId="7251bc67-91ee-45c9-97e7-9c240c9b485c" providerId="ADAL" clId="{51945A91-CB03-4A52-98BE-5B2D563FE265}" dt="2021-04-22T02:16:37.871" v="4378"/>
          <ac:spMkLst>
            <pc:docMk/>
            <pc:sldMk cId="1562766757" sldId="812"/>
            <ac:spMk id="14" creationId="{9139604D-EC8B-4931-9D36-28585ADA31AA}"/>
          </ac:spMkLst>
        </pc:spChg>
        <pc:picChg chg="add mod">
          <ac:chgData name="Tsujimoto,Mitsuhiro 辻本光宏(関東北甲信越統括支店O領域専門室)" userId="7251bc67-91ee-45c9-97e7-9c240c9b485c" providerId="ADAL" clId="{51945A91-CB03-4A52-98BE-5B2D563FE265}" dt="2021-04-22T02:09:54.619" v="4262" actId="1036"/>
          <ac:picMkLst>
            <pc:docMk/>
            <pc:sldMk cId="1562766757" sldId="812"/>
            <ac:picMk id="3" creationId="{7B5033F6-2C5A-4D4D-AA4A-D022ADD1CD35}"/>
          </ac:picMkLst>
        </pc:picChg>
        <pc:picChg chg="add mod">
          <ac:chgData name="Tsujimoto,Mitsuhiro 辻本光宏(関東北甲信越統括支店O領域専門室)" userId="7251bc67-91ee-45c9-97e7-9c240c9b485c" providerId="ADAL" clId="{51945A91-CB03-4A52-98BE-5B2D563FE265}" dt="2021-04-22T02:09:54.619" v="4262" actId="1036"/>
          <ac:picMkLst>
            <pc:docMk/>
            <pc:sldMk cId="1562766757" sldId="812"/>
            <ac:picMk id="4" creationId="{F3A3D9B8-19F8-4245-A0DB-291A4FA9A168}"/>
          </ac:picMkLst>
        </pc:picChg>
        <pc:picChg chg="add mod">
          <ac:chgData name="Tsujimoto,Mitsuhiro 辻本光宏(関東北甲信越統括支店O領域専門室)" userId="7251bc67-91ee-45c9-97e7-9c240c9b485c" providerId="ADAL" clId="{51945A91-CB03-4A52-98BE-5B2D563FE265}" dt="2021-04-22T02:09:54.619" v="4262" actId="1036"/>
          <ac:picMkLst>
            <pc:docMk/>
            <pc:sldMk cId="1562766757" sldId="812"/>
            <ac:picMk id="5" creationId="{E7F816C4-BD42-4215-B655-930706830600}"/>
          </ac:picMkLst>
        </pc:picChg>
      </pc:sldChg>
      <pc:sldChg chg="addSp delSp modSp add">
        <pc:chgData name="Tsujimoto,Mitsuhiro 辻本光宏(関東北甲信越統括支店O領域専門室)" userId="7251bc67-91ee-45c9-97e7-9c240c9b485c" providerId="ADAL" clId="{51945A91-CB03-4A52-98BE-5B2D563FE265}" dt="2021-04-23T00:53:10.492" v="8460" actId="1076"/>
        <pc:sldMkLst>
          <pc:docMk/>
          <pc:sldMk cId="1300342973" sldId="813"/>
        </pc:sldMkLst>
        <pc:spChg chg="mod">
          <ac:chgData name="Tsujimoto,Mitsuhiro 辻本光宏(関東北甲信越統括支店O領域専門室)" userId="7251bc67-91ee-45c9-97e7-9c240c9b485c" providerId="ADAL" clId="{51945A91-CB03-4A52-98BE-5B2D563FE265}" dt="2021-04-22T02:10:33.253" v="4273"/>
          <ac:spMkLst>
            <pc:docMk/>
            <pc:sldMk cId="1300342973" sldId="813"/>
            <ac:spMk id="2" creationId="{E9C84B9A-0A5E-4501-A736-97E7536FAD85}"/>
          </ac:spMkLst>
        </pc:spChg>
        <pc:spChg chg="mod">
          <ac:chgData name="Tsujimoto,Mitsuhiro 辻本光宏(関東北甲信越統括支店O領域専門室)" userId="7251bc67-91ee-45c9-97e7-9c240c9b485c" providerId="ADAL" clId="{51945A91-CB03-4A52-98BE-5B2D563FE265}" dt="2021-04-23T00:52:53.367" v="8458" actId="2711"/>
          <ac:spMkLst>
            <pc:docMk/>
            <pc:sldMk cId="1300342973" sldId="813"/>
            <ac:spMk id="6" creationId="{C8BD4B9B-AD02-4CA3-929B-D783269DFE6C}"/>
          </ac:spMkLst>
        </pc:spChg>
        <pc:spChg chg="mod">
          <ac:chgData name="Tsujimoto,Mitsuhiro 辻本光宏(関東北甲信越統括支店O領域専門室)" userId="7251bc67-91ee-45c9-97e7-9c240c9b485c" providerId="ADAL" clId="{51945A91-CB03-4A52-98BE-5B2D563FE265}" dt="2021-04-23T00:52:53.367" v="8458" actId="2711"/>
          <ac:spMkLst>
            <pc:docMk/>
            <pc:sldMk cId="1300342973" sldId="813"/>
            <ac:spMk id="7" creationId="{2C9CC779-C35F-4D60-94BB-94616DE64975}"/>
          </ac:spMkLst>
        </pc:spChg>
        <pc:spChg chg="mod">
          <ac:chgData name="Tsujimoto,Mitsuhiro 辻本光宏(関東北甲信越統括支店O領域専門室)" userId="7251bc67-91ee-45c9-97e7-9c240c9b485c" providerId="ADAL" clId="{51945A91-CB03-4A52-98BE-5B2D563FE265}" dt="2021-04-23T00:53:10.492" v="8460" actId="1076"/>
          <ac:spMkLst>
            <pc:docMk/>
            <pc:sldMk cId="1300342973" sldId="813"/>
            <ac:spMk id="8" creationId="{A5FB70D3-651D-42DA-9293-39C12F552FB4}"/>
          </ac:spMkLst>
        </pc:spChg>
        <pc:spChg chg="mod">
          <ac:chgData name="Tsujimoto,Mitsuhiro 辻本光宏(関東北甲信越統括支店O領域専門室)" userId="7251bc67-91ee-45c9-97e7-9c240c9b485c" providerId="ADAL" clId="{51945A91-CB03-4A52-98BE-5B2D563FE265}" dt="2021-04-23T00:52:46.291" v="8457" actId="2711"/>
          <ac:spMkLst>
            <pc:docMk/>
            <pc:sldMk cId="1300342973" sldId="813"/>
            <ac:spMk id="9" creationId="{542BFC70-CD2B-4D3B-B7BE-3404BC9A63B4}"/>
          </ac:spMkLst>
        </pc:spChg>
        <pc:spChg chg="add del mod">
          <ac:chgData name="Tsujimoto,Mitsuhiro 辻本光宏(関東北甲信越統括支店O領域専門室)" userId="7251bc67-91ee-45c9-97e7-9c240c9b485c" providerId="ADAL" clId="{51945A91-CB03-4A52-98BE-5B2D563FE265}" dt="2021-04-22T02:15:03.560" v="4334" actId="478"/>
          <ac:spMkLst>
            <pc:docMk/>
            <pc:sldMk cId="1300342973" sldId="813"/>
            <ac:spMk id="13" creationId="{FE256608-32B7-40EC-939C-25557B5C5CBC}"/>
          </ac:spMkLst>
        </pc:spChg>
        <pc:spChg chg="add del mod">
          <ac:chgData name="Tsujimoto,Mitsuhiro 辻本光宏(関東北甲信越統括支店O領域専門室)" userId="7251bc67-91ee-45c9-97e7-9c240c9b485c" providerId="ADAL" clId="{51945A91-CB03-4A52-98BE-5B2D563FE265}" dt="2021-04-22T02:15:35.910" v="4374" actId="478"/>
          <ac:spMkLst>
            <pc:docMk/>
            <pc:sldMk cId="1300342973" sldId="813"/>
            <ac:spMk id="14" creationId="{CC3E8735-D502-4103-BA97-DB1985C8D62A}"/>
          </ac:spMkLst>
        </pc:spChg>
        <pc:spChg chg="add del mod">
          <ac:chgData name="Tsujimoto,Mitsuhiro 辻本光宏(関東北甲信越統括支店O領域専門室)" userId="7251bc67-91ee-45c9-97e7-9c240c9b485c" providerId="ADAL" clId="{51945A91-CB03-4A52-98BE-5B2D563FE265}" dt="2021-04-22T02:15:35.910" v="4374" actId="478"/>
          <ac:spMkLst>
            <pc:docMk/>
            <pc:sldMk cId="1300342973" sldId="813"/>
            <ac:spMk id="15" creationId="{11706B45-1464-492F-90A0-E1A6F2095BE4}"/>
          </ac:spMkLst>
        </pc:spChg>
        <pc:spChg chg="add">
          <ac:chgData name="Tsujimoto,Mitsuhiro 辻本光宏(関東北甲信越統括支店O領域専門室)" userId="7251bc67-91ee-45c9-97e7-9c240c9b485c" providerId="ADAL" clId="{51945A91-CB03-4A52-98BE-5B2D563FE265}" dt="2021-04-22T02:16:38.727" v="4379"/>
          <ac:spMkLst>
            <pc:docMk/>
            <pc:sldMk cId="1300342973" sldId="813"/>
            <ac:spMk id="16" creationId="{BA1AA1C6-5A36-4667-9135-873C8B72E961}"/>
          </ac:spMkLst>
        </pc:spChg>
        <pc:picChg chg="del">
          <ac:chgData name="Tsujimoto,Mitsuhiro 辻本光宏(関東北甲信越統括支店O領域専門室)" userId="7251bc67-91ee-45c9-97e7-9c240c9b485c" providerId="ADAL" clId="{51945A91-CB03-4A52-98BE-5B2D563FE265}" dt="2021-04-22T02:12:44.243" v="4288" actId="478"/>
          <ac:picMkLst>
            <pc:docMk/>
            <pc:sldMk cId="1300342973" sldId="813"/>
            <ac:picMk id="3" creationId="{7B5033F6-2C5A-4D4D-AA4A-D022ADD1CD35}"/>
          </ac:picMkLst>
        </pc:picChg>
        <pc:picChg chg="del">
          <ac:chgData name="Tsujimoto,Mitsuhiro 辻本光宏(関東北甲信越統括支店O領域専門室)" userId="7251bc67-91ee-45c9-97e7-9c240c9b485c" providerId="ADAL" clId="{51945A91-CB03-4A52-98BE-5B2D563FE265}" dt="2021-04-22T02:13:18.012" v="4293" actId="478"/>
          <ac:picMkLst>
            <pc:docMk/>
            <pc:sldMk cId="1300342973" sldId="813"/>
            <ac:picMk id="4" creationId="{F3A3D9B8-19F8-4245-A0DB-291A4FA9A168}"/>
          </ac:picMkLst>
        </pc:picChg>
        <pc:picChg chg="del">
          <ac:chgData name="Tsujimoto,Mitsuhiro 辻本光宏(関東北甲信越統括支店O領域専門室)" userId="7251bc67-91ee-45c9-97e7-9c240c9b485c" providerId="ADAL" clId="{51945A91-CB03-4A52-98BE-5B2D563FE265}" dt="2021-04-22T02:13:52.291" v="4299" actId="478"/>
          <ac:picMkLst>
            <pc:docMk/>
            <pc:sldMk cId="1300342973" sldId="813"/>
            <ac:picMk id="5" creationId="{E7F816C4-BD42-4215-B655-930706830600}"/>
          </ac:picMkLst>
        </pc:picChg>
        <pc:picChg chg="add mod">
          <ac:chgData name="Tsujimoto,Mitsuhiro 辻本光宏(関東北甲信越統括支店O領域専門室)" userId="7251bc67-91ee-45c9-97e7-9c240c9b485c" providerId="ADAL" clId="{51945A91-CB03-4A52-98BE-5B2D563FE265}" dt="2021-04-22T02:12:50.959" v="4289" actId="1076"/>
          <ac:picMkLst>
            <pc:docMk/>
            <pc:sldMk cId="1300342973" sldId="813"/>
            <ac:picMk id="10" creationId="{6A621265-8AED-4F52-B7F7-3B9966CB5A4A}"/>
          </ac:picMkLst>
        </pc:picChg>
        <pc:picChg chg="add mod">
          <ac:chgData name="Tsujimoto,Mitsuhiro 辻本光宏(関東北甲信越統括支店O領域専門室)" userId="7251bc67-91ee-45c9-97e7-9c240c9b485c" providerId="ADAL" clId="{51945A91-CB03-4A52-98BE-5B2D563FE265}" dt="2021-04-22T02:14:19.351" v="4304" actId="1076"/>
          <ac:picMkLst>
            <pc:docMk/>
            <pc:sldMk cId="1300342973" sldId="813"/>
            <ac:picMk id="11" creationId="{B5E86132-AF0E-4500-A22A-C2DB476725F1}"/>
          </ac:picMkLst>
        </pc:picChg>
        <pc:picChg chg="add mod">
          <ac:chgData name="Tsujimoto,Mitsuhiro 辻本光宏(関東北甲信越統括支店O領域専門室)" userId="7251bc67-91ee-45c9-97e7-9c240c9b485c" providerId="ADAL" clId="{51945A91-CB03-4A52-98BE-5B2D563FE265}" dt="2021-04-22T02:14:28.067" v="4305" actId="1076"/>
          <ac:picMkLst>
            <pc:docMk/>
            <pc:sldMk cId="1300342973" sldId="813"/>
            <ac:picMk id="12" creationId="{317EDB52-4293-488E-AD79-BF4E364CEB40}"/>
          </ac:picMkLst>
        </pc:picChg>
      </pc:sldChg>
      <pc:sldChg chg="add del">
        <pc:chgData name="Tsujimoto,Mitsuhiro 辻本光宏(関東北甲信越統括支店O領域専門室)" userId="7251bc67-91ee-45c9-97e7-9c240c9b485c" providerId="ADAL" clId="{51945A91-CB03-4A52-98BE-5B2D563FE265}" dt="2021-04-22T07:38:14.891" v="4490"/>
        <pc:sldMkLst>
          <pc:docMk/>
          <pc:sldMk cId="2564999324" sldId="814"/>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3604182268" sldId="815"/>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657269597" sldId="816"/>
        </pc:sldMkLst>
      </pc:sldChg>
      <pc:sldChg chg="add del">
        <pc:chgData name="Tsujimoto,Mitsuhiro 辻本光宏(関東北甲信越統括支店O領域専門室)" userId="7251bc67-91ee-45c9-97e7-9c240c9b485c" providerId="ADAL" clId="{51945A91-CB03-4A52-98BE-5B2D563FE265}" dt="2021-04-22T07:38:14.891" v="4490"/>
        <pc:sldMkLst>
          <pc:docMk/>
          <pc:sldMk cId="1172932861" sldId="817"/>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4128798923" sldId="818"/>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2101180717" sldId="819"/>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1866573599" sldId="820"/>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3684780289" sldId="821"/>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2034992123" sldId="822"/>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4271470290" sldId="823"/>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181187519" sldId="824"/>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2588628830" sldId="825"/>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1624020984" sldId="826"/>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1808461951" sldId="827"/>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2709625172" sldId="828"/>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2083894819" sldId="829"/>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1516807206" sldId="830"/>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3571752565" sldId="831"/>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2912000340" sldId="832"/>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2528286872" sldId="833"/>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0" sldId="834"/>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0" sldId="835"/>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0" sldId="836"/>
        </pc:sldMkLst>
      </pc:sldChg>
      <pc:sldChg chg="add del">
        <pc:chgData name="Tsujimoto,Mitsuhiro 辻本光宏(関東北甲信越統括支店O領域専門室)" userId="7251bc67-91ee-45c9-97e7-9c240c9b485c" providerId="ADAL" clId="{51945A91-CB03-4A52-98BE-5B2D563FE265}" dt="2021-04-22T07:39:10.877" v="4493"/>
        <pc:sldMkLst>
          <pc:docMk/>
          <pc:sldMk cId="0" sldId="837"/>
        </pc:sldMkLst>
      </pc:sldChg>
      <pc:sldChg chg="addSp delSp modSp add ord">
        <pc:chgData name="Tsujimoto,Mitsuhiro 辻本光宏(関東北甲信越統括支店O領域専門室)" userId="7251bc67-91ee-45c9-97e7-9c240c9b485c" providerId="ADAL" clId="{51945A91-CB03-4A52-98BE-5B2D563FE265}" dt="2021-04-23T05:04:27.423" v="12660" actId="20577"/>
        <pc:sldMkLst>
          <pc:docMk/>
          <pc:sldMk cId="2024961420" sldId="838"/>
        </pc:sldMkLst>
        <pc:spChg chg="mod">
          <ac:chgData name="Tsujimoto,Mitsuhiro 辻本光宏(関東北甲信越統括支店O領域専門室)" userId="7251bc67-91ee-45c9-97e7-9c240c9b485c" providerId="ADAL" clId="{51945A91-CB03-4A52-98BE-5B2D563FE265}" dt="2021-04-23T05:04:27.423" v="12660" actId="20577"/>
          <ac:spMkLst>
            <pc:docMk/>
            <pc:sldMk cId="2024961420" sldId="838"/>
            <ac:spMk id="2" creationId="{E9C84B9A-0A5E-4501-A736-97E7536FAD85}"/>
          </ac:spMkLst>
        </pc:spChg>
        <pc:spChg chg="del">
          <ac:chgData name="Tsujimoto,Mitsuhiro 辻本光宏(関東北甲信越統括支店O領域専門室)" userId="7251bc67-91ee-45c9-97e7-9c240c9b485c" providerId="ADAL" clId="{51945A91-CB03-4A52-98BE-5B2D563FE265}" dt="2021-04-22T08:01:24.313" v="4545" actId="478"/>
          <ac:spMkLst>
            <pc:docMk/>
            <pc:sldMk cId="2024961420" sldId="838"/>
            <ac:spMk id="5" creationId="{66CDE537-D3FB-4F28-96C0-7B8AE05E5957}"/>
          </ac:spMkLst>
        </pc:spChg>
        <pc:spChg chg="add mod">
          <ac:chgData name="Tsujimoto,Mitsuhiro 辻本光宏(関東北甲信越統括支店O領域専門室)" userId="7251bc67-91ee-45c9-97e7-9c240c9b485c" providerId="ADAL" clId="{51945A91-CB03-4A52-98BE-5B2D563FE265}" dt="2021-04-22T08:01:32.783" v="4547" actId="1076"/>
          <ac:spMkLst>
            <pc:docMk/>
            <pc:sldMk cId="2024961420" sldId="838"/>
            <ac:spMk id="6" creationId="{DB762508-B2DE-4DF4-BA8E-E427FABE18CF}"/>
          </ac:spMkLst>
        </pc:spChg>
        <pc:spChg chg="mod">
          <ac:chgData name="Tsujimoto,Mitsuhiro 辻本光宏(関東北甲信越統括支店O領域専門室)" userId="7251bc67-91ee-45c9-97e7-9c240c9b485c" providerId="ADAL" clId="{51945A91-CB03-4A52-98BE-5B2D563FE265}" dt="2021-04-23T00:53:54.128" v="8463" actId="20577"/>
          <ac:spMkLst>
            <pc:docMk/>
            <pc:sldMk cId="2024961420" sldId="838"/>
            <ac:spMk id="9" creationId="{961A8DDC-52FD-43C8-8EB1-F361125483B3}"/>
          </ac:spMkLst>
        </pc:spChg>
        <pc:spChg chg="add del">
          <ac:chgData name="Tsujimoto,Mitsuhiro 辻本光宏(関東北甲信越統括支店O領域専門室)" userId="7251bc67-91ee-45c9-97e7-9c240c9b485c" providerId="ADAL" clId="{51945A91-CB03-4A52-98BE-5B2D563FE265}" dt="2021-04-22T08:03:55.589" v="4640" actId="478"/>
          <ac:spMkLst>
            <pc:docMk/>
            <pc:sldMk cId="2024961420" sldId="838"/>
            <ac:spMk id="36" creationId="{AE567735-1CB5-4392-9A5E-792C825F0698}"/>
          </ac:spMkLst>
        </pc:spChg>
        <pc:grpChg chg="add mod">
          <ac:chgData name="Tsujimoto,Mitsuhiro 辻本光宏(関東北甲信越統括支店O領域専門室)" userId="7251bc67-91ee-45c9-97e7-9c240c9b485c" providerId="ADAL" clId="{51945A91-CB03-4A52-98BE-5B2D563FE265}" dt="2021-04-22T08:02:44.476" v="4561" actId="1036"/>
          <ac:grpSpMkLst>
            <pc:docMk/>
            <pc:sldMk cId="2024961420" sldId="838"/>
            <ac:grpSpMk id="7" creationId="{7FE6651F-1136-4D61-B65B-2E615A516C40}"/>
          </ac:grpSpMkLst>
        </pc:grpChg>
        <pc:picChg chg="del">
          <ac:chgData name="Tsujimoto,Mitsuhiro 辻本光宏(関東北甲信越統括支店O領域専門室)" userId="7251bc67-91ee-45c9-97e7-9c240c9b485c" providerId="ADAL" clId="{51945A91-CB03-4A52-98BE-5B2D563FE265}" dt="2021-04-22T08:02:21.570" v="4548" actId="478"/>
          <ac:picMkLst>
            <pc:docMk/>
            <pc:sldMk cId="2024961420" sldId="838"/>
            <ac:picMk id="3" creationId="{0324A52F-F015-43B5-8175-D577D5A88CCE}"/>
          </ac:picMkLst>
        </pc:picChg>
        <pc:picChg chg="add del">
          <ac:chgData name="Tsujimoto,Mitsuhiro 辻本光宏(関東北甲信越統括支店O領域専門室)" userId="7251bc67-91ee-45c9-97e7-9c240c9b485c" providerId="ADAL" clId="{51945A91-CB03-4A52-98BE-5B2D563FE265}" dt="2021-04-22T08:03:55.589" v="4640" actId="478"/>
          <ac:picMkLst>
            <pc:docMk/>
            <pc:sldMk cId="2024961420" sldId="838"/>
            <ac:picMk id="37" creationId="{E291640B-1876-4B4F-BA0D-B549E1DEE62A}"/>
          </ac:picMkLst>
        </pc:picChg>
      </pc:sldChg>
      <pc:sldChg chg="addSp delSp modSp add ord">
        <pc:chgData name="Tsujimoto,Mitsuhiro 辻本光宏(関東北甲信越統括支店O領域専門室)" userId="7251bc67-91ee-45c9-97e7-9c240c9b485c" providerId="ADAL" clId="{51945A91-CB03-4A52-98BE-5B2D563FE265}" dt="2021-04-23T03:16:12.617" v="11059"/>
        <pc:sldMkLst>
          <pc:docMk/>
          <pc:sldMk cId="3330569479" sldId="839"/>
        </pc:sldMkLst>
        <pc:spChg chg="add mod">
          <ac:chgData name="Tsujimoto,Mitsuhiro 辻本光宏(関東北甲信越統括支店O領域専門室)" userId="7251bc67-91ee-45c9-97e7-9c240c9b485c" providerId="ADAL" clId="{51945A91-CB03-4A52-98BE-5B2D563FE265}" dt="2021-04-22T08:12:32.974" v="4710" actId="20577"/>
          <ac:spMkLst>
            <pc:docMk/>
            <pc:sldMk cId="3330569479" sldId="839"/>
            <ac:spMk id="2" creationId="{B67DD072-EE98-408E-A750-34564FBD2D7D}"/>
          </ac:spMkLst>
        </pc:spChg>
        <pc:spChg chg="add">
          <ac:chgData name="Tsujimoto,Mitsuhiro 辻本光宏(関東北甲信越統括支店O領域専門室)" userId="7251bc67-91ee-45c9-97e7-9c240c9b485c" providerId="ADAL" clId="{51945A91-CB03-4A52-98BE-5B2D563FE265}" dt="2021-04-22T08:10:07.485" v="4659"/>
          <ac:spMkLst>
            <pc:docMk/>
            <pc:sldMk cId="3330569479" sldId="839"/>
            <ac:spMk id="3" creationId="{B866AC4F-D945-467C-8512-F40A13B04C48}"/>
          </ac:spMkLst>
        </pc:spChg>
        <pc:spChg chg="add del mod">
          <ac:chgData name="Tsujimoto,Mitsuhiro 辻本光宏(関東北甲信越統括支店O領域専門室)" userId="7251bc67-91ee-45c9-97e7-9c240c9b485c" providerId="ADAL" clId="{51945A91-CB03-4A52-98BE-5B2D563FE265}" dt="2021-04-22T08:12:35.687" v="4711" actId="478"/>
          <ac:spMkLst>
            <pc:docMk/>
            <pc:sldMk cId="3330569479" sldId="839"/>
            <ac:spMk id="4" creationId="{84CB2108-F489-46DF-B2C7-ABE67E35289B}"/>
          </ac:spMkLst>
        </pc:spChg>
        <pc:spChg chg="add mod">
          <ac:chgData name="Tsujimoto,Mitsuhiro 辻本光宏(関東北甲信越統括支店O領域専門室)" userId="7251bc67-91ee-45c9-97e7-9c240c9b485c" providerId="ADAL" clId="{51945A91-CB03-4A52-98BE-5B2D563FE265}" dt="2021-04-22T08:14:46.335" v="4772" actId="164"/>
          <ac:spMkLst>
            <pc:docMk/>
            <pc:sldMk cId="3330569479" sldId="839"/>
            <ac:spMk id="9" creationId="{4969E933-C953-4D20-B4E8-F7B3B6B55996}"/>
          </ac:spMkLst>
        </pc:spChg>
        <pc:spChg chg="add mod">
          <ac:chgData name="Tsujimoto,Mitsuhiro 辻本光宏(関東北甲信越統括支店O領域専門室)" userId="7251bc67-91ee-45c9-97e7-9c240c9b485c" providerId="ADAL" clId="{51945A91-CB03-4A52-98BE-5B2D563FE265}" dt="2021-04-22T08:14:46.335" v="4772" actId="164"/>
          <ac:spMkLst>
            <pc:docMk/>
            <pc:sldMk cId="3330569479" sldId="839"/>
            <ac:spMk id="10" creationId="{47CAFDB5-4E8E-43B2-ACDE-1E637B0C47AE}"/>
          </ac:spMkLst>
        </pc:spChg>
        <pc:spChg chg="add del mod">
          <ac:chgData name="Tsujimoto,Mitsuhiro 辻本光宏(関東北甲信越統括支店O領域専門室)" userId="7251bc67-91ee-45c9-97e7-9c240c9b485c" providerId="ADAL" clId="{51945A91-CB03-4A52-98BE-5B2D563FE265}" dt="2021-04-22T09:37:38.685" v="5216" actId="478"/>
          <ac:spMkLst>
            <pc:docMk/>
            <pc:sldMk cId="3330569479" sldId="839"/>
            <ac:spMk id="11" creationId="{ECFA8120-98FD-44F5-B967-B57789A604C7}"/>
          </ac:spMkLst>
        </pc:spChg>
        <pc:spChg chg="add del mod">
          <ac:chgData name="Tsujimoto,Mitsuhiro 辻本光宏(関東北甲信越統括支店O領域専門室)" userId="7251bc67-91ee-45c9-97e7-9c240c9b485c" providerId="ADAL" clId="{51945A91-CB03-4A52-98BE-5B2D563FE265}" dt="2021-04-22T09:37:43.965" v="5218" actId="478"/>
          <ac:spMkLst>
            <pc:docMk/>
            <pc:sldMk cId="3330569479" sldId="839"/>
            <ac:spMk id="13" creationId="{A7462489-2FB0-4E40-A15B-843A97F0B608}"/>
          </ac:spMkLst>
        </pc:spChg>
        <pc:spChg chg="add mod">
          <ac:chgData name="Tsujimoto,Mitsuhiro 辻本光宏(関東北甲信越統括支店O領域専門室)" userId="7251bc67-91ee-45c9-97e7-9c240c9b485c" providerId="ADAL" clId="{51945A91-CB03-4A52-98BE-5B2D563FE265}" dt="2021-04-23T00:54:05.849" v="8465" actId="2711"/>
          <ac:spMkLst>
            <pc:docMk/>
            <pc:sldMk cId="3330569479" sldId="839"/>
            <ac:spMk id="14" creationId="{BB326143-66C6-4594-A01D-3E4C08BB27EF}"/>
          </ac:spMkLst>
        </pc:spChg>
        <pc:spChg chg="add del mod">
          <ac:chgData name="Tsujimoto,Mitsuhiro 辻本光宏(関東北甲信越統括支店O領域専門室)" userId="7251bc67-91ee-45c9-97e7-9c240c9b485c" providerId="ADAL" clId="{51945A91-CB03-4A52-98BE-5B2D563FE265}" dt="2021-04-22T08:14:27.064" v="4769" actId="478"/>
          <ac:spMkLst>
            <pc:docMk/>
            <pc:sldMk cId="3330569479" sldId="839"/>
            <ac:spMk id="15" creationId="{EB2654FF-E317-4BE6-BE77-A5E4C6B748E3}"/>
          </ac:spMkLst>
        </pc:spChg>
        <pc:spChg chg="add del">
          <ac:chgData name="Tsujimoto,Mitsuhiro 辻本光宏(関東北甲信越統括支店O領域専門室)" userId="7251bc67-91ee-45c9-97e7-9c240c9b485c" providerId="ADAL" clId="{51945A91-CB03-4A52-98BE-5B2D563FE265}" dt="2021-04-22T09:37:29.374" v="5212"/>
          <ac:spMkLst>
            <pc:docMk/>
            <pc:sldMk cId="3330569479" sldId="839"/>
            <ac:spMk id="23" creationId="{1B2D91E5-77AD-4BD5-9F24-F588FA69C6E3}"/>
          </ac:spMkLst>
        </pc:spChg>
        <pc:spChg chg="add del">
          <ac:chgData name="Tsujimoto,Mitsuhiro 辻本光宏(関東北甲信越統括支店O領域専門室)" userId="7251bc67-91ee-45c9-97e7-9c240c9b485c" providerId="ADAL" clId="{51945A91-CB03-4A52-98BE-5B2D563FE265}" dt="2021-04-22T09:37:29.374" v="5212"/>
          <ac:spMkLst>
            <pc:docMk/>
            <pc:sldMk cId="3330569479" sldId="839"/>
            <ac:spMk id="24" creationId="{95E3A3F2-3C7A-44DF-BD53-7B1B81463279}"/>
          </ac:spMkLst>
        </pc:spChg>
        <pc:spChg chg="add del">
          <ac:chgData name="Tsujimoto,Mitsuhiro 辻本光宏(関東北甲信越統括支店O領域専門室)" userId="7251bc67-91ee-45c9-97e7-9c240c9b485c" providerId="ADAL" clId="{51945A91-CB03-4A52-98BE-5B2D563FE265}" dt="2021-04-22T09:37:29.374" v="5212"/>
          <ac:spMkLst>
            <pc:docMk/>
            <pc:sldMk cId="3330569479" sldId="839"/>
            <ac:spMk id="25" creationId="{67C0229F-50EE-45B0-AAB2-B4A31984A520}"/>
          </ac:spMkLst>
        </pc:spChg>
        <pc:spChg chg="add del">
          <ac:chgData name="Tsujimoto,Mitsuhiro 辻本光宏(関東北甲信越統括支店O領域専門室)" userId="7251bc67-91ee-45c9-97e7-9c240c9b485c" providerId="ADAL" clId="{51945A91-CB03-4A52-98BE-5B2D563FE265}" dt="2021-04-22T09:37:29.374" v="5212"/>
          <ac:spMkLst>
            <pc:docMk/>
            <pc:sldMk cId="3330569479" sldId="839"/>
            <ac:spMk id="27" creationId="{BBD714B1-B435-4B44-AB0B-799E7C5C14D6}"/>
          </ac:spMkLst>
        </pc:spChg>
        <pc:grpChg chg="add mod">
          <ac:chgData name="Tsujimoto,Mitsuhiro 辻本光宏(関東北甲信越統括支店O領域専門室)" userId="7251bc67-91ee-45c9-97e7-9c240c9b485c" providerId="ADAL" clId="{51945A91-CB03-4A52-98BE-5B2D563FE265}" dt="2021-04-22T08:15:10.929" v="4778" actId="1076"/>
          <ac:grpSpMkLst>
            <pc:docMk/>
            <pc:sldMk cId="3330569479" sldId="839"/>
            <ac:grpSpMk id="19" creationId="{B9F597EB-C79B-454F-995B-FE51EF6C9355}"/>
          </ac:grpSpMkLst>
        </pc:grpChg>
        <pc:picChg chg="add del mod">
          <ac:chgData name="Tsujimoto,Mitsuhiro 辻本光宏(関東北甲信越統括支店O領域専門室)" userId="7251bc67-91ee-45c9-97e7-9c240c9b485c" providerId="ADAL" clId="{51945A91-CB03-4A52-98BE-5B2D563FE265}" dt="2021-04-22T08:12:54.943" v="4715"/>
          <ac:picMkLst>
            <pc:docMk/>
            <pc:sldMk cId="3330569479" sldId="839"/>
            <ac:picMk id="5" creationId="{368EE2E3-D498-4ECF-9F14-BD72B1E0134C}"/>
          </ac:picMkLst>
        </pc:picChg>
        <pc:picChg chg="add del mod">
          <ac:chgData name="Tsujimoto,Mitsuhiro 辻本光宏(関東北甲信越統括支店O領域専門室)" userId="7251bc67-91ee-45c9-97e7-9c240c9b485c" providerId="ADAL" clId="{51945A91-CB03-4A52-98BE-5B2D563FE265}" dt="2021-04-22T09:37:45.543" v="5219" actId="478"/>
          <ac:picMkLst>
            <pc:docMk/>
            <pc:sldMk cId="3330569479" sldId="839"/>
            <ac:picMk id="6" creationId="{135DA63A-D801-41D7-91B6-A9E0A8111EC3}"/>
          </ac:picMkLst>
        </pc:picChg>
        <pc:picChg chg="add del">
          <ac:chgData name="Tsujimoto,Mitsuhiro 辻本光宏(関東北甲信越統括支店O領域専門室)" userId="7251bc67-91ee-45c9-97e7-9c240c9b485c" providerId="ADAL" clId="{51945A91-CB03-4A52-98BE-5B2D563FE265}" dt="2021-04-22T09:37:29.374" v="5212"/>
          <ac:picMkLst>
            <pc:docMk/>
            <pc:sldMk cId="3330569479" sldId="839"/>
            <ac:picMk id="20" creationId="{03107616-0697-448D-94A0-87AD296BB091}"/>
          </ac:picMkLst>
        </pc:picChg>
        <pc:picChg chg="add mod">
          <ac:chgData name="Tsujimoto,Mitsuhiro 辻本光宏(関東北甲信越統括支店O領域専門室)" userId="7251bc67-91ee-45c9-97e7-9c240c9b485c" providerId="ADAL" clId="{51945A91-CB03-4A52-98BE-5B2D563FE265}" dt="2021-04-22T09:37:50.832" v="5220" actId="1076"/>
          <ac:picMkLst>
            <pc:docMk/>
            <pc:sldMk cId="3330569479" sldId="839"/>
            <ac:picMk id="28" creationId="{8DAD9F69-8D4F-41B9-B6BF-42E776E1BE90}"/>
          </ac:picMkLst>
        </pc:picChg>
        <pc:cxnChg chg="add mod">
          <ac:chgData name="Tsujimoto,Mitsuhiro 辻本光宏(関東北甲信越統括支店O領域専門室)" userId="7251bc67-91ee-45c9-97e7-9c240c9b485c" providerId="ADAL" clId="{51945A91-CB03-4A52-98BE-5B2D563FE265}" dt="2021-04-22T08:14:46.335" v="4772" actId="164"/>
          <ac:cxnSpMkLst>
            <pc:docMk/>
            <pc:sldMk cId="3330569479" sldId="839"/>
            <ac:cxnSpMk id="7" creationId="{0EA1CFD6-948A-441D-8860-BB5FA41C4C93}"/>
          </ac:cxnSpMkLst>
        </pc:cxnChg>
        <pc:cxnChg chg="add mod">
          <ac:chgData name="Tsujimoto,Mitsuhiro 辻本光宏(関東北甲信越統括支店O領域専門室)" userId="7251bc67-91ee-45c9-97e7-9c240c9b485c" providerId="ADAL" clId="{51945A91-CB03-4A52-98BE-5B2D563FE265}" dt="2021-04-22T08:14:46.335" v="4772" actId="164"/>
          <ac:cxnSpMkLst>
            <pc:docMk/>
            <pc:sldMk cId="3330569479" sldId="839"/>
            <ac:cxnSpMk id="8" creationId="{F976ECE9-F850-472B-956C-F918834926D9}"/>
          </ac:cxnSpMkLst>
        </pc:cxnChg>
        <pc:cxnChg chg="add mod">
          <ac:chgData name="Tsujimoto,Mitsuhiro 辻本光宏(関東北甲信越統括支店O領域専門室)" userId="7251bc67-91ee-45c9-97e7-9c240c9b485c" providerId="ADAL" clId="{51945A91-CB03-4A52-98BE-5B2D563FE265}" dt="2021-04-22T08:14:46.335" v="4772" actId="164"/>
          <ac:cxnSpMkLst>
            <pc:docMk/>
            <pc:sldMk cId="3330569479" sldId="839"/>
            <ac:cxnSpMk id="12" creationId="{63720554-6D85-48F8-9D5D-D1092F4BF3B9}"/>
          </ac:cxnSpMkLst>
        </pc:cxnChg>
        <pc:cxnChg chg="add del">
          <ac:chgData name="Tsujimoto,Mitsuhiro 辻本光宏(関東北甲信越統括支店O領域専門室)" userId="7251bc67-91ee-45c9-97e7-9c240c9b485c" providerId="ADAL" clId="{51945A91-CB03-4A52-98BE-5B2D563FE265}" dt="2021-04-22T09:37:29.374" v="5212"/>
          <ac:cxnSpMkLst>
            <pc:docMk/>
            <pc:sldMk cId="3330569479" sldId="839"/>
            <ac:cxnSpMk id="21" creationId="{12C1E542-05AA-4318-8FEB-32EE74C633A8}"/>
          </ac:cxnSpMkLst>
        </pc:cxnChg>
        <pc:cxnChg chg="add del">
          <ac:chgData name="Tsujimoto,Mitsuhiro 辻本光宏(関東北甲信越統括支店O領域専門室)" userId="7251bc67-91ee-45c9-97e7-9c240c9b485c" providerId="ADAL" clId="{51945A91-CB03-4A52-98BE-5B2D563FE265}" dt="2021-04-22T09:37:29.374" v="5212"/>
          <ac:cxnSpMkLst>
            <pc:docMk/>
            <pc:sldMk cId="3330569479" sldId="839"/>
            <ac:cxnSpMk id="22" creationId="{0F5B0992-0020-4923-B41A-455CF568A6DA}"/>
          </ac:cxnSpMkLst>
        </pc:cxnChg>
        <pc:cxnChg chg="add del">
          <ac:chgData name="Tsujimoto,Mitsuhiro 辻本光宏(関東北甲信越統括支店O領域専門室)" userId="7251bc67-91ee-45c9-97e7-9c240c9b485c" providerId="ADAL" clId="{51945A91-CB03-4A52-98BE-5B2D563FE265}" dt="2021-04-22T09:37:29.374" v="5212"/>
          <ac:cxnSpMkLst>
            <pc:docMk/>
            <pc:sldMk cId="3330569479" sldId="839"/>
            <ac:cxnSpMk id="26" creationId="{A730B215-D343-4D70-91C8-C7CEE5722631}"/>
          </ac:cxnSpMkLst>
        </pc:cxnChg>
      </pc:sldChg>
      <pc:sldChg chg="addSp delSp modSp add del">
        <pc:chgData name="Tsujimoto,Mitsuhiro 辻本光宏(関東北甲信越統括支店O領域専門室)" userId="7251bc67-91ee-45c9-97e7-9c240c9b485c" providerId="ADAL" clId="{51945A91-CB03-4A52-98BE-5B2D563FE265}" dt="2021-04-22T10:07:32.764" v="5756" actId="2696"/>
        <pc:sldMkLst>
          <pc:docMk/>
          <pc:sldMk cId="124344159" sldId="840"/>
        </pc:sldMkLst>
        <pc:spChg chg="add del">
          <ac:chgData name="Tsujimoto,Mitsuhiro 辻本光宏(関東北甲信越統括支店O領域専門室)" userId="7251bc67-91ee-45c9-97e7-9c240c9b485c" providerId="ADAL" clId="{51945A91-CB03-4A52-98BE-5B2D563FE265}" dt="2021-04-22T08:17:03.221" v="4832"/>
          <ac:spMkLst>
            <pc:docMk/>
            <pc:sldMk cId="124344159" sldId="840"/>
            <ac:spMk id="2" creationId="{5BA65096-AF89-4261-80F5-D4F2E6D1851C}"/>
          </ac:spMkLst>
        </pc:spChg>
        <pc:spChg chg="add mod">
          <ac:chgData name="Tsujimoto,Mitsuhiro 辻本光宏(関東北甲信越統括支店O領域専門室)" userId="7251bc67-91ee-45c9-97e7-9c240c9b485c" providerId="ADAL" clId="{51945A91-CB03-4A52-98BE-5B2D563FE265}" dt="2021-04-22T08:17:24.641" v="4882" actId="20577"/>
          <ac:spMkLst>
            <pc:docMk/>
            <pc:sldMk cId="124344159" sldId="840"/>
            <ac:spMk id="3" creationId="{F9E7FBE1-6C88-48D9-9A0A-29577AFD96F8}"/>
          </ac:spMkLst>
        </pc:spChg>
        <pc:spChg chg="add del">
          <ac:chgData name="Tsujimoto,Mitsuhiro 辻本光宏(関東北甲信越統括支店O領域専門室)" userId="7251bc67-91ee-45c9-97e7-9c240c9b485c" providerId="ADAL" clId="{51945A91-CB03-4A52-98BE-5B2D563FE265}" dt="2021-04-22T08:17:58.245" v="4888"/>
          <ac:spMkLst>
            <pc:docMk/>
            <pc:sldMk cId="124344159" sldId="840"/>
            <ac:spMk id="6" creationId="{5BB29AD6-C89C-4092-9890-C86467FABB47}"/>
          </ac:spMkLst>
        </pc:spChg>
        <pc:spChg chg="add del">
          <ac:chgData name="Tsujimoto,Mitsuhiro 辻本光宏(関東北甲信越統括支店O領域専門室)" userId="7251bc67-91ee-45c9-97e7-9c240c9b485c" providerId="ADAL" clId="{51945A91-CB03-4A52-98BE-5B2D563FE265}" dt="2021-04-22T08:17:58.245" v="4888"/>
          <ac:spMkLst>
            <pc:docMk/>
            <pc:sldMk cId="124344159" sldId="840"/>
            <ac:spMk id="7" creationId="{A376B7A5-FE95-41D3-8983-7D1C98F265A4}"/>
          </ac:spMkLst>
        </pc:spChg>
        <pc:spChg chg="add del">
          <ac:chgData name="Tsujimoto,Mitsuhiro 辻本光宏(関東北甲信越統括支店O領域専門室)" userId="7251bc67-91ee-45c9-97e7-9c240c9b485c" providerId="ADAL" clId="{51945A91-CB03-4A52-98BE-5B2D563FE265}" dt="2021-04-22T08:17:58.245" v="4888"/>
          <ac:spMkLst>
            <pc:docMk/>
            <pc:sldMk cId="124344159" sldId="840"/>
            <ac:spMk id="8" creationId="{0B5C834E-603E-45E3-9EFB-8900045F0A9C}"/>
          </ac:spMkLst>
        </pc:spChg>
        <pc:spChg chg="add del">
          <ac:chgData name="Tsujimoto,Mitsuhiro 辻本光宏(関東北甲信越統括支店O領域専門室)" userId="7251bc67-91ee-45c9-97e7-9c240c9b485c" providerId="ADAL" clId="{51945A91-CB03-4A52-98BE-5B2D563FE265}" dt="2021-04-22T08:17:58.245" v="4888"/>
          <ac:spMkLst>
            <pc:docMk/>
            <pc:sldMk cId="124344159" sldId="840"/>
            <ac:spMk id="11" creationId="{7742C388-0C19-496A-8AF3-4B1E59A23899}"/>
          </ac:spMkLst>
        </pc:spChg>
        <pc:spChg chg="add mod">
          <ac:chgData name="Tsujimoto,Mitsuhiro 辻本光宏(関東北甲信越統括支店O領域専門室)" userId="7251bc67-91ee-45c9-97e7-9c240c9b485c" providerId="ADAL" clId="{51945A91-CB03-4A52-98BE-5B2D563FE265}" dt="2021-04-22T08:19:40.208" v="5181" actId="20577"/>
          <ac:spMkLst>
            <pc:docMk/>
            <pc:sldMk cId="124344159" sldId="840"/>
            <ac:spMk id="15" creationId="{DA6D73D3-19B1-42DA-AF40-FCA5F3AA1D30}"/>
          </ac:spMkLst>
        </pc:spChg>
        <pc:spChg chg="add">
          <ac:chgData name="Tsujimoto,Mitsuhiro 辻本光宏(関東北甲信越統括支店O領域専門室)" userId="7251bc67-91ee-45c9-97e7-9c240c9b485c" providerId="ADAL" clId="{51945A91-CB03-4A52-98BE-5B2D563FE265}" dt="2021-04-22T08:18:20.591" v="4896"/>
          <ac:spMkLst>
            <pc:docMk/>
            <pc:sldMk cId="124344159" sldId="840"/>
            <ac:spMk id="16" creationId="{89E2DFD2-5557-4156-8FC8-F1495AE70E47}"/>
          </ac:spMkLst>
        </pc:spChg>
        <pc:spChg chg="add del mod">
          <ac:chgData name="Tsujimoto,Mitsuhiro 辻本光宏(関東北甲信越統括支店O領域専門室)" userId="7251bc67-91ee-45c9-97e7-9c240c9b485c" providerId="ADAL" clId="{51945A91-CB03-4A52-98BE-5B2D563FE265}" dt="2021-04-22T08:19:33.573" v="5180" actId="478"/>
          <ac:spMkLst>
            <pc:docMk/>
            <pc:sldMk cId="124344159" sldId="840"/>
            <ac:spMk id="17" creationId="{CDFDE245-6386-4891-8544-E5F2E9CFA83A}"/>
          </ac:spMkLst>
        </pc:spChg>
        <pc:spChg chg="add del mod">
          <ac:chgData name="Tsujimoto,Mitsuhiro 辻本光宏(関東北甲信越統括支店O領域専門室)" userId="7251bc67-91ee-45c9-97e7-9c240c9b485c" providerId="ADAL" clId="{51945A91-CB03-4A52-98BE-5B2D563FE265}" dt="2021-04-22T08:19:53.202" v="5184" actId="478"/>
          <ac:spMkLst>
            <pc:docMk/>
            <pc:sldMk cId="124344159" sldId="840"/>
            <ac:spMk id="18" creationId="{52DDB7F4-4695-408F-A119-6304A73D6ED0}"/>
          </ac:spMkLst>
        </pc:spChg>
        <pc:spChg chg="add del mod">
          <ac:chgData name="Tsujimoto,Mitsuhiro 辻本光宏(関東北甲信越統括支店O領域専門室)" userId="7251bc67-91ee-45c9-97e7-9c240c9b485c" providerId="ADAL" clId="{51945A91-CB03-4A52-98BE-5B2D563FE265}" dt="2021-04-22T10:03:29.965" v="5720" actId="478"/>
          <ac:spMkLst>
            <pc:docMk/>
            <pc:sldMk cId="124344159" sldId="840"/>
            <ac:spMk id="19" creationId="{9480E125-A023-46FB-98B3-6F9FAE6FECFD}"/>
          </ac:spMkLst>
        </pc:spChg>
        <pc:graphicFrameChg chg="add del">
          <ac:chgData name="Tsujimoto,Mitsuhiro 辻本光宏(関東北甲信越統括支店O領域専門室)" userId="7251bc67-91ee-45c9-97e7-9c240c9b485c" providerId="ADAL" clId="{51945A91-CB03-4A52-98BE-5B2D563FE265}" dt="2021-04-22T08:17:58.245" v="4888"/>
          <ac:graphicFrameMkLst>
            <pc:docMk/>
            <pc:sldMk cId="124344159" sldId="840"/>
            <ac:graphicFrameMk id="4" creationId="{B5654898-819E-4E77-840F-1E7ED8CDDBFD}"/>
          </ac:graphicFrameMkLst>
        </pc:graphicFrameChg>
        <pc:graphicFrameChg chg="add del">
          <ac:chgData name="Tsujimoto,Mitsuhiro 辻本光宏(関東北甲信越統括支店O領域専門室)" userId="7251bc67-91ee-45c9-97e7-9c240c9b485c" providerId="ADAL" clId="{51945A91-CB03-4A52-98BE-5B2D563FE265}" dt="2021-04-22T08:17:58.245" v="4888"/>
          <ac:graphicFrameMkLst>
            <pc:docMk/>
            <pc:sldMk cId="124344159" sldId="840"/>
            <ac:graphicFrameMk id="5" creationId="{70BE5094-25CD-4E23-8C00-4DB27921EFDD}"/>
          </ac:graphicFrameMkLst>
        </pc:graphicFrameChg>
        <pc:graphicFrameChg chg="add del">
          <ac:chgData name="Tsujimoto,Mitsuhiro 辻本光宏(関東北甲信越統括支店O領域専門室)" userId="7251bc67-91ee-45c9-97e7-9c240c9b485c" providerId="ADAL" clId="{51945A91-CB03-4A52-98BE-5B2D563FE265}" dt="2021-04-22T08:17:58.245" v="4888"/>
          <ac:graphicFrameMkLst>
            <pc:docMk/>
            <pc:sldMk cId="124344159" sldId="840"/>
            <ac:graphicFrameMk id="13" creationId="{3F5ABB93-7463-4381-BA8C-8530F440D6E3}"/>
          </ac:graphicFrameMkLst>
        </pc:graphicFrameChg>
        <pc:picChg chg="add mod ord modCrop">
          <ac:chgData name="Tsujimoto,Mitsuhiro 辻本光宏(関東北甲信越統括支店O領域専門室)" userId="7251bc67-91ee-45c9-97e7-9c240c9b485c" providerId="ADAL" clId="{51945A91-CB03-4A52-98BE-5B2D563FE265}" dt="2021-04-22T10:03:38.089" v="5721" actId="732"/>
          <ac:picMkLst>
            <pc:docMk/>
            <pc:sldMk cId="124344159" sldId="840"/>
            <ac:picMk id="14" creationId="{4426DAF1-BACE-47F7-8E6B-51CA979D8383}"/>
          </ac:picMkLst>
        </pc:picChg>
        <pc:cxnChg chg="add del">
          <ac:chgData name="Tsujimoto,Mitsuhiro 辻本光宏(関東北甲信越統括支店O領域専門室)" userId="7251bc67-91ee-45c9-97e7-9c240c9b485c" providerId="ADAL" clId="{51945A91-CB03-4A52-98BE-5B2D563FE265}" dt="2021-04-22T08:17:58.245" v="4888"/>
          <ac:cxnSpMkLst>
            <pc:docMk/>
            <pc:sldMk cId="124344159" sldId="840"/>
            <ac:cxnSpMk id="9" creationId="{C3CD5D17-0F4C-4C0A-B903-64FC2CB5C0E1}"/>
          </ac:cxnSpMkLst>
        </pc:cxnChg>
        <pc:cxnChg chg="add del">
          <ac:chgData name="Tsujimoto,Mitsuhiro 辻本光宏(関東北甲信越統括支店O領域専門室)" userId="7251bc67-91ee-45c9-97e7-9c240c9b485c" providerId="ADAL" clId="{51945A91-CB03-4A52-98BE-5B2D563FE265}" dt="2021-04-22T08:17:58.245" v="4888"/>
          <ac:cxnSpMkLst>
            <pc:docMk/>
            <pc:sldMk cId="124344159" sldId="840"/>
            <ac:cxnSpMk id="10" creationId="{282FF742-FA32-4198-A750-A47C0F557F15}"/>
          </ac:cxnSpMkLst>
        </pc:cxnChg>
        <pc:cxnChg chg="add del">
          <ac:chgData name="Tsujimoto,Mitsuhiro 辻本光宏(関東北甲信越統括支店O領域専門室)" userId="7251bc67-91ee-45c9-97e7-9c240c9b485c" providerId="ADAL" clId="{51945A91-CB03-4A52-98BE-5B2D563FE265}" dt="2021-04-22T08:17:58.245" v="4888"/>
          <ac:cxnSpMkLst>
            <pc:docMk/>
            <pc:sldMk cId="124344159" sldId="840"/>
            <ac:cxnSpMk id="12" creationId="{CCA2CB4C-1C36-4919-BC71-5BFD3BECEFAB}"/>
          </ac:cxnSpMkLst>
        </pc:cxnChg>
      </pc:sldChg>
      <pc:sldChg chg="addSp delSp modSp add ord">
        <pc:chgData name="Tsujimoto,Mitsuhiro 辻本光宏(関東北甲信越統括支店O領域専門室)" userId="7251bc67-91ee-45c9-97e7-9c240c9b485c" providerId="ADAL" clId="{51945A91-CB03-4A52-98BE-5B2D563FE265}" dt="2021-04-23T03:16:12.617" v="11059"/>
        <pc:sldMkLst>
          <pc:docMk/>
          <pc:sldMk cId="2443364138" sldId="841"/>
        </pc:sldMkLst>
        <pc:spChg chg="mod">
          <ac:chgData name="Tsujimoto,Mitsuhiro 辻本光宏(関東北甲信越統括支店O領域専門室)" userId="7251bc67-91ee-45c9-97e7-9c240c9b485c" providerId="ADAL" clId="{51945A91-CB03-4A52-98BE-5B2D563FE265}" dt="2021-04-22T09:35:57.532" v="5200"/>
          <ac:spMkLst>
            <pc:docMk/>
            <pc:sldMk cId="2443364138" sldId="841"/>
            <ac:spMk id="2" creationId="{B67DD072-EE98-408E-A750-34564FBD2D7D}"/>
          </ac:spMkLst>
        </pc:spChg>
        <pc:spChg chg="del">
          <ac:chgData name="Tsujimoto,Mitsuhiro 辻本光宏(関東北甲信越統括支店O領域専門室)" userId="7251bc67-91ee-45c9-97e7-9c240c9b485c" providerId="ADAL" clId="{51945A91-CB03-4A52-98BE-5B2D563FE265}" dt="2021-04-22T09:36:51.373" v="5207" actId="478"/>
          <ac:spMkLst>
            <pc:docMk/>
            <pc:sldMk cId="2443364138" sldId="841"/>
            <ac:spMk id="11" creationId="{ECFA8120-98FD-44F5-B967-B57789A604C7}"/>
          </ac:spMkLst>
        </pc:spChg>
        <pc:spChg chg="del">
          <ac:chgData name="Tsujimoto,Mitsuhiro 辻本光宏(関東北甲信越統括支店O領域専門室)" userId="7251bc67-91ee-45c9-97e7-9c240c9b485c" providerId="ADAL" clId="{51945A91-CB03-4A52-98BE-5B2D563FE265}" dt="2021-04-22T09:36:55.007" v="5208" actId="478"/>
          <ac:spMkLst>
            <pc:docMk/>
            <pc:sldMk cId="2443364138" sldId="841"/>
            <ac:spMk id="13" creationId="{A7462489-2FB0-4E40-A15B-843A97F0B608}"/>
          </ac:spMkLst>
        </pc:spChg>
        <pc:spChg chg="mod">
          <ac:chgData name="Tsujimoto,Mitsuhiro 辻本光宏(関東北甲信越統括支店O領域専門室)" userId="7251bc67-91ee-45c9-97e7-9c240c9b485c" providerId="ADAL" clId="{51945A91-CB03-4A52-98BE-5B2D563FE265}" dt="2021-04-23T00:54:17.152" v="8467" actId="2711"/>
          <ac:spMkLst>
            <pc:docMk/>
            <pc:sldMk cId="2443364138" sldId="841"/>
            <ac:spMk id="14" creationId="{BB326143-66C6-4594-A01D-3E4C08BB27EF}"/>
          </ac:spMkLst>
        </pc:spChg>
        <pc:spChg chg="add del">
          <ac:chgData name="Tsujimoto,Mitsuhiro 辻本光宏(関東北甲信越統括支店O領域専門室)" userId="7251bc67-91ee-45c9-97e7-9c240c9b485c" providerId="ADAL" clId="{51945A91-CB03-4A52-98BE-5B2D563FE265}" dt="2021-04-22T09:36:31.181" v="5202"/>
          <ac:spMkLst>
            <pc:docMk/>
            <pc:sldMk cId="2443364138" sldId="841"/>
            <ac:spMk id="16" creationId="{614E9FBA-558C-4669-AB8E-E25F9C15B788}"/>
          </ac:spMkLst>
        </pc:spChg>
        <pc:spChg chg="add del">
          <ac:chgData name="Tsujimoto,Mitsuhiro 辻本光宏(関東北甲信越統括支店O領域専門室)" userId="7251bc67-91ee-45c9-97e7-9c240c9b485c" providerId="ADAL" clId="{51945A91-CB03-4A52-98BE-5B2D563FE265}" dt="2021-04-22T09:36:31.181" v="5202"/>
          <ac:spMkLst>
            <pc:docMk/>
            <pc:sldMk cId="2443364138" sldId="841"/>
            <ac:spMk id="21" creationId="{D921D54E-3A6B-43F0-9196-8ECC4CB91C03}"/>
          </ac:spMkLst>
        </pc:spChg>
        <pc:spChg chg="add del">
          <ac:chgData name="Tsujimoto,Mitsuhiro 辻本光宏(関東北甲信越統括支店O領域専門室)" userId="7251bc67-91ee-45c9-97e7-9c240c9b485c" providerId="ADAL" clId="{51945A91-CB03-4A52-98BE-5B2D563FE265}" dt="2021-04-22T09:36:31.181" v="5202"/>
          <ac:spMkLst>
            <pc:docMk/>
            <pc:sldMk cId="2443364138" sldId="841"/>
            <ac:spMk id="22" creationId="{BD8D2666-AADA-4A1C-BB11-AAEC921B5E24}"/>
          </ac:spMkLst>
        </pc:spChg>
        <pc:spChg chg="add del">
          <ac:chgData name="Tsujimoto,Mitsuhiro 辻本光宏(関東北甲信越統括支店O領域専門室)" userId="7251bc67-91ee-45c9-97e7-9c240c9b485c" providerId="ADAL" clId="{51945A91-CB03-4A52-98BE-5B2D563FE265}" dt="2021-04-22T09:36:31.181" v="5202"/>
          <ac:spMkLst>
            <pc:docMk/>
            <pc:sldMk cId="2443364138" sldId="841"/>
            <ac:spMk id="23" creationId="{E560F996-24C4-43A6-8919-D6284734322C}"/>
          </ac:spMkLst>
        </pc:spChg>
        <pc:spChg chg="add del mod">
          <ac:chgData name="Tsujimoto,Mitsuhiro 辻本光宏(関東北甲信越統括支店O領域専門室)" userId="7251bc67-91ee-45c9-97e7-9c240c9b485c" providerId="ADAL" clId="{51945A91-CB03-4A52-98BE-5B2D563FE265}" dt="2021-04-22T09:39:04.047" v="5309" actId="478"/>
          <ac:spMkLst>
            <pc:docMk/>
            <pc:sldMk cId="2443364138" sldId="841"/>
            <ac:spMk id="24" creationId="{2C3FADB1-F6A6-4FB6-BE02-9369AAF491B1}"/>
          </ac:spMkLst>
        </pc:spChg>
        <pc:picChg chg="add mod">
          <ac:chgData name="Tsujimoto,Mitsuhiro 辻本光宏(関東北甲信越統括支店O領域専門室)" userId="7251bc67-91ee-45c9-97e7-9c240c9b485c" providerId="ADAL" clId="{51945A91-CB03-4A52-98BE-5B2D563FE265}" dt="2021-04-22T09:37:01.947" v="5210" actId="1076"/>
          <ac:picMkLst>
            <pc:docMk/>
            <pc:sldMk cId="2443364138" sldId="841"/>
            <ac:picMk id="4" creationId="{E6077187-0171-4DC2-A9F8-BCD055D46BFC}"/>
          </ac:picMkLst>
        </pc:picChg>
        <pc:picChg chg="del">
          <ac:chgData name="Tsujimoto,Mitsuhiro 辻本光宏(関東北甲信越統括支店O領域専門室)" userId="7251bc67-91ee-45c9-97e7-9c240c9b485c" providerId="ADAL" clId="{51945A91-CB03-4A52-98BE-5B2D563FE265}" dt="2021-04-22T09:36:51.373" v="5207" actId="478"/>
          <ac:picMkLst>
            <pc:docMk/>
            <pc:sldMk cId="2443364138" sldId="841"/>
            <ac:picMk id="6" creationId="{135DA63A-D801-41D7-91B6-A9E0A8111EC3}"/>
          </ac:picMkLst>
        </pc:picChg>
        <pc:picChg chg="add del">
          <ac:chgData name="Tsujimoto,Mitsuhiro 辻本光宏(関東北甲信越統括支店O領域専門室)" userId="7251bc67-91ee-45c9-97e7-9c240c9b485c" providerId="ADAL" clId="{51945A91-CB03-4A52-98BE-5B2D563FE265}" dt="2021-04-22T09:36:31.181" v="5202"/>
          <ac:picMkLst>
            <pc:docMk/>
            <pc:sldMk cId="2443364138" sldId="841"/>
            <ac:picMk id="15" creationId="{907CAA17-D5F3-4BE1-ABEF-64F8529B84D1}"/>
          </ac:picMkLst>
        </pc:picChg>
        <pc:cxnChg chg="add del">
          <ac:chgData name="Tsujimoto,Mitsuhiro 辻本光宏(関東北甲信越統括支店O領域専門室)" userId="7251bc67-91ee-45c9-97e7-9c240c9b485c" providerId="ADAL" clId="{51945A91-CB03-4A52-98BE-5B2D563FE265}" dt="2021-04-22T09:36:31.181" v="5202"/>
          <ac:cxnSpMkLst>
            <pc:docMk/>
            <pc:sldMk cId="2443364138" sldId="841"/>
            <ac:cxnSpMk id="17" creationId="{BCBFDCD0-B28C-4A25-B83A-64FD531D66F2}"/>
          </ac:cxnSpMkLst>
        </pc:cxnChg>
        <pc:cxnChg chg="add del">
          <ac:chgData name="Tsujimoto,Mitsuhiro 辻本光宏(関東北甲信越統括支店O領域専門室)" userId="7251bc67-91ee-45c9-97e7-9c240c9b485c" providerId="ADAL" clId="{51945A91-CB03-4A52-98BE-5B2D563FE265}" dt="2021-04-22T09:36:31.181" v="5202"/>
          <ac:cxnSpMkLst>
            <pc:docMk/>
            <pc:sldMk cId="2443364138" sldId="841"/>
            <ac:cxnSpMk id="18" creationId="{D7EE4970-09E4-4702-B629-A8420B0F51C5}"/>
          </ac:cxnSpMkLst>
        </pc:cxnChg>
        <pc:cxnChg chg="add del">
          <ac:chgData name="Tsujimoto,Mitsuhiro 辻本光宏(関東北甲信越統括支店O領域専門室)" userId="7251bc67-91ee-45c9-97e7-9c240c9b485c" providerId="ADAL" clId="{51945A91-CB03-4A52-98BE-5B2D563FE265}" dt="2021-04-22T09:36:31.181" v="5202"/>
          <ac:cxnSpMkLst>
            <pc:docMk/>
            <pc:sldMk cId="2443364138" sldId="841"/>
            <ac:cxnSpMk id="20" creationId="{93B2CA35-644C-4FD1-AF05-ECD066C7BEAE}"/>
          </ac:cxnSpMkLst>
        </pc:cxnChg>
      </pc:sldChg>
      <pc:sldChg chg="addSp delSp modSp add ord">
        <pc:chgData name="Tsujimoto,Mitsuhiro 辻本光宏(関東北甲信越統括支店O領域専門室)" userId="7251bc67-91ee-45c9-97e7-9c240c9b485c" providerId="ADAL" clId="{51945A91-CB03-4A52-98BE-5B2D563FE265}" dt="2021-04-23T03:16:12.617" v="11059"/>
        <pc:sldMkLst>
          <pc:docMk/>
          <pc:sldMk cId="4242311681" sldId="842"/>
        </pc:sldMkLst>
        <pc:spChg chg="add mod">
          <ac:chgData name="Tsujimoto,Mitsuhiro 辻本光宏(関東北甲信越統括支店O領域専門室)" userId="7251bc67-91ee-45c9-97e7-9c240c9b485c" providerId="ADAL" clId="{51945A91-CB03-4A52-98BE-5B2D563FE265}" dt="2021-04-22T10:07:45.500" v="5799"/>
          <ac:spMkLst>
            <pc:docMk/>
            <pc:sldMk cId="4242311681" sldId="842"/>
            <ac:spMk id="2" creationId="{CC1162C8-AFF0-41DD-9FB3-4037F1043041}"/>
          </ac:spMkLst>
        </pc:spChg>
        <pc:spChg chg="add mod">
          <ac:chgData name="Tsujimoto,Mitsuhiro 辻本光宏(関東北甲信越統括支店O領域専門室)" userId="7251bc67-91ee-45c9-97e7-9c240c9b485c" providerId="ADAL" clId="{51945A91-CB03-4A52-98BE-5B2D563FE265}" dt="2021-04-22T09:41:57.620" v="5331" actId="1076"/>
          <ac:spMkLst>
            <pc:docMk/>
            <pc:sldMk cId="4242311681" sldId="842"/>
            <ac:spMk id="5" creationId="{8C77266B-814E-452D-A515-ADB5DDE32D3F}"/>
          </ac:spMkLst>
        </pc:spChg>
        <pc:spChg chg="add mod">
          <ac:chgData name="Tsujimoto,Mitsuhiro 辻本光宏(関東北甲信越統括支店O領域専門室)" userId="7251bc67-91ee-45c9-97e7-9c240c9b485c" providerId="ADAL" clId="{51945A91-CB03-4A52-98BE-5B2D563FE265}" dt="2021-04-23T00:54:27.801" v="8469" actId="2711"/>
          <ac:spMkLst>
            <pc:docMk/>
            <pc:sldMk cId="4242311681" sldId="842"/>
            <ac:spMk id="6" creationId="{67FEB859-2DF5-49B6-9E37-CD4C8F09B447}"/>
          </ac:spMkLst>
        </pc:spChg>
        <pc:spChg chg="add del mod">
          <ac:chgData name="Tsujimoto,Mitsuhiro 辻本光宏(関東北甲信越統括支店O領域専門室)" userId="7251bc67-91ee-45c9-97e7-9c240c9b485c" providerId="ADAL" clId="{51945A91-CB03-4A52-98BE-5B2D563FE265}" dt="2021-04-22T09:43:30.631" v="5529" actId="478"/>
          <ac:spMkLst>
            <pc:docMk/>
            <pc:sldMk cId="4242311681" sldId="842"/>
            <ac:spMk id="7" creationId="{01723B3B-0715-4751-A1C7-7975C28D1FE5}"/>
          </ac:spMkLst>
        </pc:spChg>
        <pc:picChg chg="add mod">
          <ac:chgData name="Tsujimoto,Mitsuhiro 辻本光宏(関東北甲信越統括支店O領域専門室)" userId="7251bc67-91ee-45c9-97e7-9c240c9b485c" providerId="ADAL" clId="{51945A91-CB03-4A52-98BE-5B2D563FE265}" dt="2021-04-22T09:42:33.474" v="5336" actId="1076"/>
          <ac:picMkLst>
            <pc:docMk/>
            <pc:sldMk cId="4242311681" sldId="842"/>
            <ac:picMk id="3" creationId="{C80BF1F5-0910-4A2E-911C-9A0B7A66C0A9}"/>
          </ac:picMkLst>
        </pc:picChg>
        <pc:picChg chg="add mod">
          <ac:chgData name="Tsujimoto,Mitsuhiro 辻本光宏(関東北甲信越統括支店O領域専門室)" userId="7251bc67-91ee-45c9-97e7-9c240c9b485c" providerId="ADAL" clId="{51945A91-CB03-4A52-98BE-5B2D563FE265}" dt="2021-04-22T09:42:33.474" v="5336" actId="1076"/>
          <ac:picMkLst>
            <pc:docMk/>
            <pc:sldMk cId="4242311681" sldId="842"/>
            <ac:picMk id="4" creationId="{5B897C6C-884D-4A08-A864-53A846D4E7ED}"/>
          </ac:picMkLst>
        </pc:picChg>
      </pc:sldChg>
      <pc:sldChg chg="addSp delSp modSp add mod ord setBg">
        <pc:chgData name="Tsujimoto,Mitsuhiro 辻本光宏(関東北甲信越統括支店O領域専門室)" userId="7251bc67-91ee-45c9-97e7-9c240c9b485c" providerId="ADAL" clId="{51945A91-CB03-4A52-98BE-5B2D563FE265}" dt="2021-04-23T03:16:12.617" v="11059"/>
        <pc:sldMkLst>
          <pc:docMk/>
          <pc:sldMk cId="3559440001" sldId="843"/>
        </pc:sldMkLst>
        <pc:spChg chg="add mod">
          <ac:chgData name="Tsujimoto,Mitsuhiro 辻本光宏(関東北甲信越統括支店O領域専門室)" userId="7251bc67-91ee-45c9-97e7-9c240c9b485c" providerId="ADAL" clId="{51945A91-CB03-4A52-98BE-5B2D563FE265}" dt="2021-04-22T09:45:48.091" v="5616" actId="26606"/>
          <ac:spMkLst>
            <pc:docMk/>
            <pc:sldMk cId="3559440001" sldId="843"/>
            <ac:spMk id="2" creationId="{6835F053-59ED-4005-9803-F6CE9FB30054}"/>
          </ac:spMkLst>
        </pc:spChg>
        <pc:spChg chg="add mod">
          <ac:chgData name="Tsujimoto,Mitsuhiro 辻本光宏(関東北甲信越統括支店O領域専門室)" userId="7251bc67-91ee-45c9-97e7-9c240c9b485c" providerId="ADAL" clId="{51945A91-CB03-4A52-98BE-5B2D563FE265}" dt="2021-04-23T00:55:13.809" v="8479" actId="1036"/>
          <ac:spMkLst>
            <pc:docMk/>
            <pc:sldMk cId="3559440001" sldId="843"/>
            <ac:spMk id="5" creationId="{EFDAC30D-A299-45D2-9D7A-85E18096C40D}"/>
          </ac:spMkLst>
        </pc:spChg>
        <pc:spChg chg="add mod">
          <ac:chgData name="Tsujimoto,Mitsuhiro 辻本光宏(関東北甲信越統括支店O領域専門室)" userId="7251bc67-91ee-45c9-97e7-9c240c9b485c" providerId="ADAL" clId="{51945A91-CB03-4A52-98BE-5B2D563FE265}" dt="2021-04-23T00:55:13.809" v="8479" actId="1036"/>
          <ac:spMkLst>
            <pc:docMk/>
            <pc:sldMk cId="3559440001" sldId="843"/>
            <ac:spMk id="6" creationId="{07B75FF7-9BFB-44F2-9869-87C68594B77C}"/>
          </ac:spMkLst>
        </pc:spChg>
        <pc:spChg chg="add mod">
          <ac:chgData name="Tsujimoto,Mitsuhiro 辻本光宏(関東北甲信越統括支店O領域専門室)" userId="7251bc67-91ee-45c9-97e7-9c240c9b485c" providerId="ADAL" clId="{51945A91-CB03-4A52-98BE-5B2D563FE265}" dt="2021-04-23T00:55:19.489" v="8482" actId="1035"/>
          <ac:spMkLst>
            <pc:docMk/>
            <pc:sldMk cId="3559440001" sldId="843"/>
            <ac:spMk id="7" creationId="{E28748BF-DDEE-4142-9DF4-0C207954F653}"/>
          </ac:spMkLst>
        </pc:spChg>
        <pc:spChg chg="add del mod">
          <ac:chgData name="Tsujimoto,Mitsuhiro 辻本光宏(関東北甲信越統括支店O領域専門室)" userId="7251bc67-91ee-45c9-97e7-9c240c9b485c" providerId="ADAL" clId="{51945A91-CB03-4A52-98BE-5B2D563FE265}" dt="2021-04-22T10:33:20.283" v="6767" actId="478"/>
          <ac:spMkLst>
            <pc:docMk/>
            <pc:sldMk cId="3559440001" sldId="843"/>
            <ac:spMk id="8" creationId="{7D8AB5CA-B300-48CA-8E41-B5881E27D613}"/>
          </ac:spMkLst>
        </pc:spChg>
        <pc:spChg chg="add del mod">
          <ac:chgData name="Tsujimoto,Mitsuhiro 辻本光宏(関東北甲信越統括支店O領域専門室)" userId="7251bc67-91ee-45c9-97e7-9c240c9b485c" providerId="ADAL" clId="{51945A91-CB03-4A52-98BE-5B2D563FE265}" dt="2021-04-22T10:35:22.879" v="6919" actId="478"/>
          <ac:spMkLst>
            <pc:docMk/>
            <pc:sldMk cId="3559440001" sldId="843"/>
            <ac:spMk id="9" creationId="{B70100EE-E652-4AB8-AA85-B542C120F1DC}"/>
          </ac:spMkLst>
        </pc:spChg>
        <pc:spChg chg="add del">
          <ac:chgData name="Tsujimoto,Mitsuhiro 辻本光宏(関東北甲信越統括支店O領域専門室)" userId="7251bc67-91ee-45c9-97e7-9c240c9b485c" providerId="ADAL" clId="{51945A91-CB03-4A52-98BE-5B2D563FE265}" dt="2021-04-22T09:45:48.091" v="5616" actId="26606"/>
          <ac:spMkLst>
            <pc:docMk/>
            <pc:sldMk cId="3559440001" sldId="843"/>
            <ac:spMk id="12" creationId="{5E52985E-2553-471E-82AA-5ED7A329890A}"/>
          </ac:spMkLst>
        </pc:spChg>
        <pc:spChg chg="add mod">
          <ac:chgData name="Tsujimoto,Mitsuhiro 辻本光宏(関東北甲信越統括支店O領域専門室)" userId="7251bc67-91ee-45c9-97e7-9c240c9b485c" providerId="ADAL" clId="{51945A91-CB03-4A52-98BE-5B2D563FE265}" dt="2021-04-22T10:10:51.450" v="5837" actId="20577"/>
          <ac:spMkLst>
            <pc:docMk/>
            <pc:sldMk cId="3559440001" sldId="843"/>
            <ac:spMk id="15" creationId="{A38271DA-E111-4682-BF81-BA94E83AB5B3}"/>
          </ac:spMkLst>
        </pc:spChg>
        <pc:picChg chg="add del mod ord">
          <ac:chgData name="Tsujimoto,Mitsuhiro 辻本光宏(関東北甲信越統括支店O領域専門室)" userId="7251bc67-91ee-45c9-97e7-9c240c9b485c" providerId="ADAL" clId="{51945A91-CB03-4A52-98BE-5B2D563FE265}" dt="2021-04-22T10:01:15.101" v="5619" actId="478"/>
          <ac:picMkLst>
            <pc:docMk/>
            <pc:sldMk cId="3559440001" sldId="843"/>
            <ac:picMk id="3" creationId="{8CA40320-58DD-4C9E-BE69-8CC5D02127B8}"/>
          </ac:picMkLst>
        </pc:picChg>
        <pc:picChg chg="add del mod ord">
          <ac:chgData name="Tsujimoto,Mitsuhiro 辻本光宏(関東北甲信越統括支店O領域専門室)" userId="7251bc67-91ee-45c9-97e7-9c240c9b485c" providerId="ADAL" clId="{51945A91-CB03-4A52-98BE-5B2D563FE265}" dt="2021-04-22T10:01:15.101" v="5619" actId="478"/>
          <ac:picMkLst>
            <pc:docMk/>
            <pc:sldMk cId="3559440001" sldId="843"/>
            <ac:picMk id="4" creationId="{28AC0C67-A8E8-4208-AFE3-79C75C1949CE}"/>
          </ac:picMkLst>
        </pc:picChg>
        <pc:picChg chg="add mod">
          <ac:chgData name="Tsujimoto,Mitsuhiro 辻本光宏(関東北甲信越統括支店O領域専門室)" userId="7251bc67-91ee-45c9-97e7-9c240c9b485c" providerId="ADAL" clId="{51945A91-CB03-4A52-98BE-5B2D563FE265}" dt="2021-04-23T00:55:13.809" v="8479" actId="1036"/>
          <ac:picMkLst>
            <pc:docMk/>
            <pc:sldMk cId="3559440001" sldId="843"/>
            <ac:picMk id="10" creationId="{F1401302-0E62-43CC-961A-DC224AC9D5E6}"/>
          </ac:picMkLst>
        </pc:picChg>
        <pc:picChg chg="add mod">
          <ac:chgData name="Tsujimoto,Mitsuhiro 辻本光宏(関東北甲信越統括支店O領域専門室)" userId="7251bc67-91ee-45c9-97e7-9c240c9b485c" providerId="ADAL" clId="{51945A91-CB03-4A52-98BE-5B2D563FE265}" dt="2021-04-23T00:55:13.809" v="8479" actId="1036"/>
          <ac:picMkLst>
            <pc:docMk/>
            <pc:sldMk cId="3559440001" sldId="843"/>
            <ac:picMk id="11" creationId="{717B7E4B-7B44-47F8-A30F-F27C454EC2C1}"/>
          </ac:picMkLst>
        </pc:picChg>
        <pc:picChg chg="add mod">
          <ac:chgData name="Tsujimoto,Mitsuhiro 辻本光宏(関東北甲信越統括支店O領域専門室)" userId="7251bc67-91ee-45c9-97e7-9c240c9b485c" providerId="ADAL" clId="{51945A91-CB03-4A52-98BE-5B2D563FE265}" dt="2021-04-23T00:55:13.809" v="8479" actId="1036"/>
          <ac:picMkLst>
            <pc:docMk/>
            <pc:sldMk cId="3559440001" sldId="843"/>
            <ac:picMk id="13" creationId="{F1120E6F-B11E-4A6B-B812-B1D0756C6A62}"/>
          </ac:picMkLst>
        </pc:picChg>
        <pc:cxnChg chg="add del">
          <ac:chgData name="Tsujimoto,Mitsuhiro 辻本光宏(関東北甲信越統括支店O領域専門室)" userId="7251bc67-91ee-45c9-97e7-9c240c9b485c" providerId="ADAL" clId="{51945A91-CB03-4A52-98BE-5B2D563FE265}" dt="2021-04-22T09:45:48.091" v="5616" actId="26606"/>
          <ac:cxnSpMkLst>
            <pc:docMk/>
            <pc:sldMk cId="3559440001" sldId="843"/>
            <ac:cxnSpMk id="14" creationId="{DAE3ABC6-4042-4293-A7DF-F01181363B7E}"/>
          </ac:cxnSpMkLst>
        </pc:cxnChg>
      </pc:sldChg>
      <pc:sldChg chg="addSp delSp modSp add del">
        <pc:chgData name="Tsujimoto,Mitsuhiro 辻本光宏(関東北甲信越統括支店O領域専門室)" userId="7251bc67-91ee-45c9-97e7-9c240c9b485c" providerId="ADAL" clId="{51945A91-CB03-4A52-98BE-5B2D563FE265}" dt="2021-04-22T10:33:53.136" v="6809" actId="2696"/>
        <pc:sldMkLst>
          <pc:docMk/>
          <pc:sldMk cId="1446007559" sldId="844"/>
        </pc:sldMkLst>
        <pc:spChg chg="mod">
          <ac:chgData name="Tsujimoto,Mitsuhiro 辻本光宏(関東北甲信越統括支店O領域専門室)" userId="7251bc67-91ee-45c9-97e7-9c240c9b485c" providerId="ADAL" clId="{51945A91-CB03-4A52-98BE-5B2D563FE265}" dt="2021-04-22T10:08:48.180" v="5821"/>
          <ac:spMkLst>
            <pc:docMk/>
            <pc:sldMk cId="1446007559" sldId="844"/>
            <ac:spMk id="2" creationId="{B67DD072-EE98-408E-A750-34564FBD2D7D}"/>
          </ac:spMkLst>
        </pc:spChg>
        <pc:spChg chg="del">
          <ac:chgData name="Tsujimoto,Mitsuhiro 辻本光宏(関東北甲信越統括支店O領域専門室)" userId="7251bc67-91ee-45c9-97e7-9c240c9b485c" providerId="ADAL" clId="{51945A91-CB03-4A52-98BE-5B2D563FE265}" dt="2021-04-22T10:11:05.181" v="5843" actId="478"/>
          <ac:spMkLst>
            <pc:docMk/>
            <pc:sldMk cId="1446007559" sldId="844"/>
            <ac:spMk id="3" creationId="{B866AC4F-D945-467C-8512-F40A13B04C48}"/>
          </ac:spMkLst>
        </pc:spChg>
        <pc:spChg chg="add del">
          <ac:chgData name="Tsujimoto,Mitsuhiro 辻本光宏(関東北甲信越統括支店O領域専門室)" userId="7251bc67-91ee-45c9-97e7-9c240c9b485c" providerId="ADAL" clId="{51945A91-CB03-4A52-98BE-5B2D563FE265}" dt="2021-04-22T10:10:51.709" v="5838"/>
          <ac:spMkLst>
            <pc:docMk/>
            <pc:sldMk cId="1446007559" sldId="844"/>
            <ac:spMk id="13" creationId="{1C430240-27E8-483C-82CE-CEC775CDCA57}"/>
          </ac:spMkLst>
        </pc:spChg>
        <pc:spChg chg="mod">
          <ac:chgData name="Tsujimoto,Mitsuhiro 辻本光宏(関東北甲信越統括支店O領域専門室)" userId="7251bc67-91ee-45c9-97e7-9c240c9b485c" providerId="ADAL" clId="{51945A91-CB03-4A52-98BE-5B2D563FE265}" dt="2021-04-22T10:13:28.961" v="6199"/>
          <ac:spMkLst>
            <pc:docMk/>
            <pc:sldMk cId="1446007559" sldId="844"/>
            <ac:spMk id="14" creationId="{BB326143-66C6-4594-A01D-3E4C08BB27EF}"/>
          </ac:spMkLst>
        </pc:spChg>
        <pc:spChg chg="add mod">
          <ac:chgData name="Tsujimoto,Mitsuhiro 辻本光宏(関東北甲信越統括支店O領域専門室)" userId="7251bc67-91ee-45c9-97e7-9c240c9b485c" providerId="ADAL" clId="{51945A91-CB03-4A52-98BE-5B2D563FE265}" dt="2021-04-22T10:11:55.818" v="5866" actId="20577"/>
          <ac:spMkLst>
            <pc:docMk/>
            <pc:sldMk cId="1446007559" sldId="844"/>
            <ac:spMk id="15" creationId="{162E1AFD-8712-48DA-9F11-CD12375B5FAB}"/>
          </ac:spMkLst>
        </pc:spChg>
        <pc:spChg chg="add del mod">
          <ac:chgData name="Tsujimoto,Mitsuhiro 辻本光宏(関東北甲信越統括支店O領域専門室)" userId="7251bc67-91ee-45c9-97e7-9c240c9b485c" providerId="ADAL" clId="{51945A91-CB03-4A52-98BE-5B2D563FE265}" dt="2021-04-22T10:13:32.478" v="6200" actId="478"/>
          <ac:spMkLst>
            <pc:docMk/>
            <pc:sldMk cId="1446007559" sldId="844"/>
            <ac:spMk id="16" creationId="{CD2EDF77-DBE4-4BFF-A7BC-07045C9C7628}"/>
          </ac:spMkLst>
        </pc:spChg>
        <pc:grpChg chg="del">
          <ac:chgData name="Tsujimoto,Mitsuhiro 辻本光宏(関東北甲信越統括支店O領域専門室)" userId="7251bc67-91ee-45c9-97e7-9c240c9b485c" providerId="ADAL" clId="{51945A91-CB03-4A52-98BE-5B2D563FE265}" dt="2021-04-22T10:09:55.854" v="5826" actId="478"/>
          <ac:grpSpMkLst>
            <pc:docMk/>
            <pc:sldMk cId="1446007559" sldId="844"/>
            <ac:grpSpMk id="19" creationId="{B9F597EB-C79B-454F-995B-FE51EF6C9355}"/>
          </ac:grpSpMkLst>
        </pc:grpChg>
        <pc:picChg chg="del">
          <ac:chgData name="Tsujimoto,Mitsuhiro 辻本光宏(関東北甲信越統括支店O領域専門室)" userId="7251bc67-91ee-45c9-97e7-9c240c9b485c" providerId="ADAL" clId="{51945A91-CB03-4A52-98BE-5B2D563FE265}" dt="2021-04-22T10:09:44.465" v="5823" actId="478"/>
          <ac:picMkLst>
            <pc:docMk/>
            <pc:sldMk cId="1446007559" sldId="844"/>
            <ac:picMk id="4" creationId="{E6077187-0171-4DC2-A9F8-BCD055D46BFC}"/>
          </ac:picMkLst>
        </pc:picChg>
        <pc:picChg chg="add mod">
          <ac:chgData name="Tsujimoto,Mitsuhiro 辻本光宏(関東北甲信越統括支店O領域専門室)" userId="7251bc67-91ee-45c9-97e7-9c240c9b485c" providerId="ADAL" clId="{51945A91-CB03-4A52-98BE-5B2D563FE265}" dt="2021-04-22T10:10:53.858" v="5842" actId="1076"/>
          <ac:picMkLst>
            <pc:docMk/>
            <pc:sldMk cId="1446007559" sldId="844"/>
            <ac:picMk id="5" creationId="{58B8EDA0-2EA8-400B-BA14-8FF102B0CC61}"/>
          </ac:picMkLst>
        </pc:picChg>
      </pc:sldChg>
      <pc:sldChg chg="add del">
        <pc:chgData name="Tsujimoto,Mitsuhiro 辻本光宏(関東北甲信越統括支店O領域専門室)" userId="7251bc67-91ee-45c9-97e7-9c240c9b485c" providerId="ADAL" clId="{51945A91-CB03-4A52-98BE-5B2D563FE265}" dt="2021-04-22T10:08:29.689" v="5801"/>
        <pc:sldMkLst>
          <pc:docMk/>
          <pc:sldMk cId="3719402767" sldId="844"/>
        </pc:sldMkLst>
      </pc:sldChg>
      <pc:sldChg chg="addSp delSp modSp add ord">
        <pc:chgData name="Tsujimoto,Mitsuhiro 辻本光宏(関東北甲信越統括支店O領域専門室)" userId="7251bc67-91ee-45c9-97e7-9c240c9b485c" providerId="ADAL" clId="{51945A91-CB03-4A52-98BE-5B2D563FE265}" dt="2021-04-23T03:16:12.617" v="11059"/>
        <pc:sldMkLst>
          <pc:docMk/>
          <pc:sldMk cId="4154227508" sldId="845"/>
        </pc:sldMkLst>
        <pc:spChg chg="add mod">
          <ac:chgData name="Tsujimoto,Mitsuhiro 辻本光宏(関東北甲信越統括支店O領域専門室)" userId="7251bc67-91ee-45c9-97e7-9c240c9b485c" providerId="ADAL" clId="{51945A91-CB03-4A52-98BE-5B2D563FE265}" dt="2021-04-22T10:22:56.413" v="6215"/>
          <ac:spMkLst>
            <pc:docMk/>
            <pc:sldMk cId="4154227508" sldId="845"/>
            <ac:spMk id="2" creationId="{E7FF515F-3C09-4FAE-98F6-52FFA668160A}"/>
          </ac:spMkLst>
        </pc:spChg>
        <pc:spChg chg="add mod">
          <ac:chgData name="Tsujimoto,Mitsuhiro 辻本光宏(関東北甲信越統括支店O領域専門室)" userId="7251bc67-91ee-45c9-97e7-9c240c9b485c" providerId="ADAL" clId="{51945A91-CB03-4A52-98BE-5B2D563FE265}" dt="2021-04-23T00:55:30.724" v="8484" actId="2711"/>
          <ac:spMkLst>
            <pc:docMk/>
            <pc:sldMk cId="4154227508" sldId="845"/>
            <ac:spMk id="3" creationId="{95280CD7-1251-486F-A0D6-E05809CC9D7E}"/>
          </ac:spMkLst>
        </pc:spChg>
        <pc:spChg chg="add del mod">
          <ac:chgData name="Tsujimoto,Mitsuhiro 辻本光宏(関東北甲信越統括支店O領域専門室)" userId="7251bc67-91ee-45c9-97e7-9c240c9b485c" providerId="ADAL" clId="{51945A91-CB03-4A52-98BE-5B2D563FE265}" dt="2021-04-22T10:24:36.828" v="6488" actId="478"/>
          <ac:spMkLst>
            <pc:docMk/>
            <pc:sldMk cId="4154227508" sldId="845"/>
            <ac:spMk id="4" creationId="{6480EE72-282E-49FF-A358-E2B8DF1DDA65}"/>
          </ac:spMkLst>
        </pc:spChg>
        <pc:spChg chg="add mod">
          <ac:chgData name="Tsujimoto,Mitsuhiro 辻本光宏(関東北甲信越統括支店O領域専門室)" userId="7251bc67-91ee-45c9-97e7-9c240c9b485c" providerId="ADAL" clId="{51945A91-CB03-4A52-98BE-5B2D563FE265}" dt="2021-04-22T10:30:45.207" v="6595" actId="14100"/>
          <ac:spMkLst>
            <pc:docMk/>
            <pc:sldMk cId="4154227508" sldId="845"/>
            <ac:spMk id="6" creationId="{78DC9ACC-311A-478D-B584-9AC26BF9E1C2}"/>
          </ac:spMkLst>
        </pc:spChg>
        <pc:spChg chg="add del">
          <ac:chgData name="Tsujimoto,Mitsuhiro 辻本光宏(関東北甲信越統括支店O領域専門室)" userId="7251bc67-91ee-45c9-97e7-9c240c9b485c" providerId="ADAL" clId="{51945A91-CB03-4A52-98BE-5B2D563FE265}" dt="2021-04-22T10:30:57.577" v="6598" actId="478"/>
          <ac:spMkLst>
            <pc:docMk/>
            <pc:sldMk cId="4154227508" sldId="845"/>
            <ac:spMk id="7" creationId="{92B4C699-A5B6-446D-85DD-FABE71CB09CB}"/>
          </ac:spMkLst>
        </pc:spChg>
        <pc:spChg chg="add del">
          <ac:chgData name="Tsujimoto,Mitsuhiro 辻本光宏(関東北甲信越統括支店O領域専門室)" userId="7251bc67-91ee-45c9-97e7-9c240c9b485c" providerId="ADAL" clId="{51945A91-CB03-4A52-98BE-5B2D563FE265}" dt="2021-04-22T10:30:54.127" v="6597" actId="478"/>
          <ac:spMkLst>
            <pc:docMk/>
            <pc:sldMk cId="4154227508" sldId="845"/>
            <ac:spMk id="8" creationId="{BA9CA8DE-48C5-4DAE-8A5D-EF7662ECB51B}"/>
          </ac:spMkLst>
        </pc:spChg>
        <pc:picChg chg="add mod">
          <ac:chgData name="Tsujimoto,Mitsuhiro 辻本光宏(関東北甲信越統括支店O領域専門室)" userId="7251bc67-91ee-45c9-97e7-9c240c9b485c" providerId="ADAL" clId="{51945A91-CB03-4A52-98BE-5B2D563FE265}" dt="2021-04-22T10:25:16.548" v="6492" actId="1076"/>
          <ac:picMkLst>
            <pc:docMk/>
            <pc:sldMk cId="4154227508" sldId="845"/>
            <ac:picMk id="5" creationId="{77449AE6-856F-4E8C-89DA-E44BA264DCC2}"/>
          </ac:picMkLst>
        </pc:picChg>
        <pc:picChg chg="add del mod">
          <ac:chgData name="Tsujimoto,Mitsuhiro 辻本光宏(関東北甲信越統括支店O領域専門室)" userId="7251bc67-91ee-45c9-97e7-9c240c9b485c" providerId="ADAL" clId="{51945A91-CB03-4A52-98BE-5B2D563FE265}" dt="2021-04-22T10:30:47.131" v="6596" actId="478"/>
          <ac:picMkLst>
            <pc:docMk/>
            <pc:sldMk cId="4154227508" sldId="845"/>
            <ac:picMk id="9" creationId="{DDE153F4-A329-4BA5-B532-A0F5FA857AB3}"/>
          </ac:picMkLst>
        </pc:picChg>
      </pc:sldChg>
      <pc:sldChg chg="addSp delSp modSp add ord delAnim modAnim">
        <pc:chgData name="Tsujimoto,Mitsuhiro 辻本光宏(関東北甲信越統括支店O領域専門室)" userId="7251bc67-91ee-45c9-97e7-9c240c9b485c" providerId="ADAL" clId="{51945A91-CB03-4A52-98BE-5B2D563FE265}" dt="2021-04-23T03:16:12.617" v="11059"/>
        <pc:sldMkLst>
          <pc:docMk/>
          <pc:sldMk cId="1438196563" sldId="846"/>
        </pc:sldMkLst>
        <pc:spChg chg="add mod">
          <ac:chgData name="Tsujimoto,Mitsuhiro 辻本光宏(関東北甲信越統括支店O領域専門室)" userId="7251bc67-91ee-45c9-97e7-9c240c9b485c" providerId="ADAL" clId="{51945A91-CB03-4A52-98BE-5B2D563FE265}" dt="2021-04-22T10:47:18.634" v="7314" actId="20577"/>
          <ac:spMkLst>
            <pc:docMk/>
            <pc:sldMk cId="1438196563" sldId="846"/>
            <ac:spMk id="2" creationId="{84EF22D3-4978-47AC-8C95-0E01BAE7E78B}"/>
          </ac:spMkLst>
        </pc:spChg>
        <pc:spChg chg="add del mod">
          <ac:chgData name="Tsujimoto,Mitsuhiro 辻本光宏(関東北甲信越統括支店O領域専門室)" userId="7251bc67-91ee-45c9-97e7-9c240c9b485c" providerId="ADAL" clId="{51945A91-CB03-4A52-98BE-5B2D563FE265}" dt="2021-04-22T10:49:27.555" v="7325" actId="478"/>
          <ac:spMkLst>
            <pc:docMk/>
            <pc:sldMk cId="1438196563" sldId="846"/>
            <ac:spMk id="3" creationId="{66FEDCCE-BE71-4549-BD72-CBF6E2B4A0DA}"/>
          </ac:spMkLst>
        </pc:spChg>
        <pc:spChg chg="add del mod">
          <ac:chgData name="Tsujimoto,Mitsuhiro 辻本光宏(関東北甲信越統括支店O領域専門室)" userId="7251bc67-91ee-45c9-97e7-9c240c9b485c" providerId="ADAL" clId="{51945A91-CB03-4A52-98BE-5B2D563FE265}" dt="2021-04-22T10:52:55.920" v="8109" actId="478"/>
          <ac:spMkLst>
            <pc:docMk/>
            <pc:sldMk cId="1438196563" sldId="846"/>
            <ac:spMk id="4" creationId="{FC94CAFE-6D48-4987-923B-0584AE2F4381}"/>
          </ac:spMkLst>
        </pc:spChg>
        <pc:spChg chg="add mod">
          <ac:chgData name="Tsujimoto,Mitsuhiro 辻本光宏(関東北甲信越統括支店O領域専門室)" userId="7251bc67-91ee-45c9-97e7-9c240c9b485c" providerId="ADAL" clId="{51945A91-CB03-4A52-98BE-5B2D563FE265}" dt="2021-04-23T00:56:48.980" v="8491" actId="2711"/>
          <ac:spMkLst>
            <pc:docMk/>
            <pc:sldMk cId="1438196563" sldId="846"/>
            <ac:spMk id="5" creationId="{52708625-118C-4AF9-A524-AFAD6E7A7550}"/>
          </ac:spMkLst>
        </pc:spChg>
        <pc:spChg chg="add del">
          <ac:chgData name="Tsujimoto,Mitsuhiro 辻本光宏(関東北甲信越統括支店O領域専門室)" userId="7251bc67-91ee-45c9-97e7-9c240c9b485c" providerId="ADAL" clId="{51945A91-CB03-4A52-98BE-5B2D563FE265}" dt="2021-04-22T10:52:49.574" v="8107" actId="478"/>
          <ac:spMkLst>
            <pc:docMk/>
            <pc:sldMk cId="1438196563" sldId="846"/>
            <ac:spMk id="6" creationId="{3FD1D781-F733-4A3F-9FE6-BEC37BECC674}"/>
          </ac:spMkLst>
        </pc:spChg>
        <pc:spChg chg="add del">
          <ac:chgData name="Tsujimoto,Mitsuhiro 辻本光宏(関東北甲信越統括支店O領域専門室)" userId="7251bc67-91ee-45c9-97e7-9c240c9b485c" providerId="ADAL" clId="{51945A91-CB03-4A52-98BE-5B2D563FE265}" dt="2021-04-22T10:52:49.574" v="8107" actId="478"/>
          <ac:spMkLst>
            <pc:docMk/>
            <pc:sldMk cId="1438196563" sldId="846"/>
            <ac:spMk id="7" creationId="{9F0AB78B-9151-4640-906A-D05CEAB6EFF5}"/>
          </ac:spMkLst>
        </pc:spChg>
        <pc:spChg chg="add del">
          <ac:chgData name="Tsujimoto,Mitsuhiro 辻本光宏(関東北甲信越統括支店O領域専門室)" userId="7251bc67-91ee-45c9-97e7-9c240c9b485c" providerId="ADAL" clId="{51945A91-CB03-4A52-98BE-5B2D563FE265}" dt="2021-04-22T10:52:53.431" v="8108" actId="478"/>
          <ac:spMkLst>
            <pc:docMk/>
            <pc:sldMk cId="1438196563" sldId="846"/>
            <ac:spMk id="8" creationId="{0AB25869-6CED-4898-A103-628EA41F852C}"/>
          </ac:spMkLst>
        </pc:spChg>
      </pc:sldChg>
      <pc:sldChg chg="addSp delSp modSp add ord">
        <pc:chgData name="Tsujimoto,Mitsuhiro 辻本光宏(関東北甲信越統括支店O領域専門室)" userId="7251bc67-91ee-45c9-97e7-9c240c9b485c" providerId="ADAL" clId="{51945A91-CB03-4A52-98BE-5B2D563FE265}" dt="2021-04-23T03:16:12.617" v="11059"/>
        <pc:sldMkLst>
          <pc:docMk/>
          <pc:sldMk cId="106793652" sldId="847"/>
        </pc:sldMkLst>
        <pc:spChg chg="mod">
          <ac:chgData name="Tsujimoto,Mitsuhiro 辻本光宏(関東北甲信越統括支店O領域専門室)" userId="7251bc67-91ee-45c9-97e7-9c240c9b485c" providerId="ADAL" clId="{51945A91-CB03-4A52-98BE-5B2D563FE265}" dt="2021-04-22T10:38:48.899" v="6990"/>
          <ac:spMkLst>
            <pc:docMk/>
            <pc:sldMk cId="106793652" sldId="847"/>
            <ac:spMk id="2" creationId="{6835F053-59ED-4005-9803-F6CE9FB30054}"/>
          </ac:spMkLst>
        </pc:spChg>
        <pc:spChg chg="mod">
          <ac:chgData name="Tsujimoto,Mitsuhiro 辻本光宏(関東北甲信越統括支店O領域専門室)" userId="7251bc67-91ee-45c9-97e7-9c240c9b485c" providerId="ADAL" clId="{51945A91-CB03-4A52-98BE-5B2D563FE265}" dt="2021-04-23T00:56:37.912" v="8489" actId="1076"/>
          <ac:spMkLst>
            <pc:docMk/>
            <pc:sldMk cId="106793652" sldId="847"/>
            <ac:spMk id="5" creationId="{EFDAC30D-A299-45D2-9D7A-85E18096C40D}"/>
          </ac:spMkLst>
        </pc:spChg>
        <pc:spChg chg="mod">
          <ac:chgData name="Tsujimoto,Mitsuhiro 辻本光宏(関東北甲信越統括支店O領域専門室)" userId="7251bc67-91ee-45c9-97e7-9c240c9b485c" providerId="ADAL" clId="{51945A91-CB03-4A52-98BE-5B2D563FE265}" dt="2021-04-23T00:56:37.912" v="8489" actId="1076"/>
          <ac:spMkLst>
            <pc:docMk/>
            <pc:sldMk cId="106793652" sldId="847"/>
            <ac:spMk id="6" creationId="{07B75FF7-9BFB-44F2-9869-87C68594B77C}"/>
          </ac:spMkLst>
        </pc:spChg>
        <pc:spChg chg="add del mod">
          <ac:chgData name="Tsujimoto,Mitsuhiro 辻本光宏(関東北甲信越統括支店O領域専門室)" userId="7251bc67-91ee-45c9-97e7-9c240c9b485c" providerId="ADAL" clId="{51945A91-CB03-4A52-98BE-5B2D563FE265}" dt="2021-04-23T00:56:21.252" v="8486" actId="2711"/>
          <ac:spMkLst>
            <pc:docMk/>
            <pc:sldMk cId="106793652" sldId="847"/>
            <ac:spMk id="7" creationId="{E28748BF-DDEE-4142-9DF4-0C207954F653}"/>
          </ac:spMkLst>
        </pc:spChg>
        <pc:spChg chg="del">
          <ac:chgData name="Tsujimoto,Mitsuhiro 辻本光宏(関東北甲信越統括支店O領域専門室)" userId="7251bc67-91ee-45c9-97e7-9c240c9b485c" providerId="ADAL" clId="{51945A91-CB03-4A52-98BE-5B2D563FE265}" dt="2021-04-22T10:43:22.688" v="7079" actId="478"/>
          <ac:spMkLst>
            <pc:docMk/>
            <pc:sldMk cId="106793652" sldId="847"/>
            <ac:spMk id="15" creationId="{A38271DA-E111-4682-BF81-BA94E83AB5B3}"/>
          </ac:spMkLst>
        </pc:spChg>
        <pc:spChg chg="add mod">
          <ac:chgData name="Tsujimoto,Mitsuhiro 辻本光宏(関東北甲信越統括支店O領域専門室)" userId="7251bc67-91ee-45c9-97e7-9c240c9b485c" providerId="ADAL" clId="{51945A91-CB03-4A52-98BE-5B2D563FE265}" dt="2021-04-22T10:43:27.124" v="7082" actId="1076"/>
          <ac:spMkLst>
            <pc:docMk/>
            <pc:sldMk cId="106793652" sldId="847"/>
            <ac:spMk id="23" creationId="{88CF7702-C018-4642-BDE8-A960109F0EEF}"/>
          </ac:spMkLst>
        </pc:spChg>
        <pc:spChg chg="add del">
          <ac:chgData name="Tsujimoto,Mitsuhiro 辻本光宏(関東北甲信越統括支店O領域専門室)" userId="7251bc67-91ee-45c9-97e7-9c240c9b485c" providerId="ADAL" clId="{51945A91-CB03-4A52-98BE-5B2D563FE265}" dt="2021-04-22T10:46:45.493" v="7306" actId="478"/>
          <ac:spMkLst>
            <pc:docMk/>
            <pc:sldMk cId="106793652" sldId="847"/>
            <ac:spMk id="24" creationId="{ED0D875A-5E11-4B39-8875-90ABEF5661B0}"/>
          </ac:spMkLst>
        </pc:spChg>
        <pc:grpChg chg="add del mod">
          <ac:chgData name="Tsujimoto,Mitsuhiro 辻本光宏(関東北甲信越統括支店O領域専門室)" userId="7251bc67-91ee-45c9-97e7-9c240c9b485c" providerId="ADAL" clId="{51945A91-CB03-4A52-98BE-5B2D563FE265}" dt="2021-04-22T10:38:18.516" v="6959"/>
          <ac:grpSpMkLst>
            <pc:docMk/>
            <pc:sldMk cId="106793652" sldId="847"/>
            <ac:grpSpMk id="12" creationId="{99984F43-D3CF-42E4-834B-6A9A4E486120}"/>
          </ac:grpSpMkLst>
        </pc:grpChg>
        <pc:graphicFrameChg chg="add del mod">
          <ac:chgData name="Tsujimoto,Mitsuhiro 辻本光宏(関東北甲信越統括支店O領域専門室)" userId="7251bc67-91ee-45c9-97e7-9c240c9b485c" providerId="ADAL" clId="{51945A91-CB03-4A52-98BE-5B2D563FE265}" dt="2021-04-22T10:41:33.769" v="7057" actId="478"/>
          <ac:graphicFrameMkLst>
            <pc:docMk/>
            <pc:sldMk cId="106793652" sldId="847"/>
            <ac:graphicFrameMk id="21" creationId="{8475B814-FB18-45EC-978E-BA742930B8C0}"/>
          </ac:graphicFrameMkLst>
        </pc:graphicFrameChg>
        <pc:graphicFrameChg chg="add del mod">
          <ac:chgData name="Tsujimoto,Mitsuhiro 辻本光宏(関東北甲信越統括支店O領域専門室)" userId="7251bc67-91ee-45c9-97e7-9c240c9b485c" providerId="ADAL" clId="{51945A91-CB03-4A52-98BE-5B2D563FE265}" dt="2021-04-22T10:42:09.237" v="7078" actId="478"/>
          <ac:graphicFrameMkLst>
            <pc:docMk/>
            <pc:sldMk cId="106793652" sldId="847"/>
            <ac:graphicFrameMk id="22" creationId="{CC156A8E-2EBE-47B2-8B07-CCA26247E603}"/>
          </ac:graphicFrameMkLst>
        </pc:graphicFrameChg>
        <pc:picChg chg="add del mod">
          <ac:chgData name="Tsujimoto,Mitsuhiro 辻本光宏(関東北甲信越統括支店O領域専門室)" userId="7251bc67-91ee-45c9-97e7-9c240c9b485c" providerId="ADAL" clId="{51945A91-CB03-4A52-98BE-5B2D563FE265}" dt="2021-04-22T10:37:39.293" v="6954" actId="478"/>
          <ac:picMkLst>
            <pc:docMk/>
            <pc:sldMk cId="106793652" sldId="847"/>
            <ac:picMk id="3" creationId="{C2D39033-B627-447E-9C6D-A14F9FA1919C}"/>
          </ac:picMkLst>
        </pc:picChg>
        <pc:picChg chg="add mod">
          <ac:chgData name="Tsujimoto,Mitsuhiro 辻本光宏(関東北甲信越統括支店O領域専門室)" userId="7251bc67-91ee-45c9-97e7-9c240c9b485c" providerId="ADAL" clId="{51945A91-CB03-4A52-98BE-5B2D563FE265}" dt="2021-04-22T10:43:46.301" v="7094" actId="1036"/>
          <ac:picMkLst>
            <pc:docMk/>
            <pc:sldMk cId="106793652" sldId="847"/>
            <ac:picMk id="4" creationId="{026F69DB-DCC1-46D2-9082-EFE8A68F5E1D}"/>
          </ac:picMkLst>
        </pc:picChg>
        <pc:picChg chg="add mod">
          <ac:chgData name="Tsujimoto,Mitsuhiro 辻本光宏(関東北甲信越統括支店O領域専門室)" userId="7251bc67-91ee-45c9-97e7-9c240c9b485c" providerId="ADAL" clId="{51945A91-CB03-4A52-98BE-5B2D563FE265}" dt="2021-04-22T10:43:46.301" v="7094" actId="1036"/>
          <ac:picMkLst>
            <pc:docMk/>
            <pc:sldMk cId="106793652" sldId="847"/>
            <ac:picMk id="8" creationId="{BBF52438-0461-4B07-9B1D-CF4A36139B1D}"/>
          </ac:picMkLst>
        </pc:picChg>
        <pc:picChg chg="del">
          <ac:chgData name="Tsujimoto,Mitsuhiro 辻本光宏(関東北甲信越統括支店O領域専門室)" userId="7251bc67-91ee-45c9-97e7-9c240c9b485c" providerId="ADAL" clId="{51945A91-CB03-4A52-98BE-5B2D563FE265}" dt="2021-04-22T10:39:06.901" v="6994" actId="478"/>
          <ac:picMkLst>
            <pc:docMk/>
            <pc:sldMk cId="106793652" sldId="847"/>
            <ac:picMk id="10" creationId="{F1401302-0E62-43CC-961A-DC224AC9D5E6}"/>
          </ac:picMkLst>
        </pc:picChg>
        <pc:picChg chg="del">
          <ac:chgData name="Tsujimoto,Mitsuhiro 辻本光宏(関東北甲信越統括支店O領域専門室)" userId="7251bc67-91ee-45c9-97e7-9c240c9b485c" providerId="ADAL" clId="{51945A91-CB03-4A52-98BE-5B2D563FE265}" dt="2021-04-22T10:39:59.039" v="7004" actId="478"/>
          <ac:picMkLst>
            <pc:docMk/>
            <pc:sldMk cId="106793652" sldId="847"/>
            <ac:picMk id="11" creationId="{717B7E4B-7B44-47F8-A30F-F27C454EC2C1}"/>
          </ac:picMkLst>
        </pc:picChg>
        <pc:picChg chg="del">
          <ac:chgData name="Tsujimoto,Mitsuhiro 辻本光宏(関東北甲信越統括支店O領域専門室)" userId="7251bc67-91ee-45c9-97e7-9c240c9b485c" providerId="ADAL" clId="{51945A91-CB03-4A52-98BE-5B2D563FE265}" dt="2021-04-22T10:36:53.375" v="6949" actId="478"/>
          <ac:picMkLst>
            <pc:docMk/>
            <pc:sldMk cId="106793652" sldId="847"/>
            <ac:picMk id="13" creationId="{F1120E6F-B11E-4A6B-B812-B1D0756C6A62}"/>
          </ac:picMkLst>
        </pc:picChg>
      </pc:sldChg>
      <pc:sldChg chg="addSp delSp modSp add ord">
        <pc:chgData name="Tsujimoto,Mitsuhiro 辻本光宏(関東北甲信越統括支店O領域専門室)" userId="7251bc67-91ee-45c9-97e7-9c240c9b485c" providerId="ADAL" clId="{51945A91-CB03-4A52-98BE-5B2D563FE265}" dt="2021-04-23T00:57:24.331" v="8492" actId="2711"/>
        <pc:sldMkLst>
          <pc:docMk/>
          <pc:sldMk cId="2334153184" sldId="848"/>
        </pc:sldMkLst>
        <pc:spChg chg="mod">
          <ac:chgData name="Tsujimoto,Mitsuhiro 辻本光宏(関東北甲信越統括支店O領域専門室)" userId="7251bc67-91ee-45c9-97e7-9c240c9b485c" providerId="ADAL" clId="{51945A91-CB03-4A52-98BE-5B2D563FE265}" dt="2021-04-22T10:57:06.874" v="8251"/>
          <ac:spMkLst>
            <pc:docMk/>
            <pc:sldMk cId="2334153184" sldId="848"/>
            <ac:spMk id="2" creationId="{CC1162C8-AFF0-41DD-9FB3-4037F1043041}"/>
          </ac:spMkLst>
        </pc:spChg>
        <pc:spChg chg="del">
          <ac:chgData name="Tsujimoto,Mitsuhiro 辻本光宏(関東北甲信越統括支店O領域専門室)" userId="7251bc67-91ee-45c9-97e7-9c240c9b485c" providerId="ADAL" clId="{51945A91-CB03-4A52-98BE-5B2D563FE265}" dt="2021-04-22T10:57:11.980" v="8253" actId="478"/>
          <ac:spMkLst>
            <pc:docMk/>
            <pc:sldMk cId="2334153184" sldId="848"/>
            <ac:spMk id="5" creationId="{8C77266B-814E-452D-A515-ADB5DDE32D3F}"/>
          </ac:spMkLst>
        </pc:spChg>
        <pc:spChg chg="del">
          <ac:chgData name="Tsujimoto,Mitsuhiro 辻本光宏(関東北甲信越統括支店O領域専門室)" userId="7251bc67-91ee-45c9-97e7-9c240c9b485c" providerId="ADAL" clId="{51945A91-CB03-4A52-98BE-5B2D563FE265}" dt="2021-04-22T10:57:10.099" v="8252" actId="478"/>
          <ac:spMkLst>
            <pc:docMk/>
            <pc:sldMk cId="2334153184" sldId="848"/>
            <ac:spMk id="6" creationId="{67FEB859-2DF5-49B6-9E37-CD4C8F09B447}"/>
          </ac:spMkLst>
        </pc:spChg>
        <pc:spChg chg="add mod">
          <ac:chgData name="Tsujimoto,Mitsuhiro 辻本光宏(関東北甲信越統括支店O領域専門室)" userId="7251bc67-91ee-45c9-97e7-9c240c9b485c" providerId="ADAL" clId="{51945A91-CB03-4A52-98BE-5B2D563FE265}" dt="2021-04-22T11:07:38.954" v="8426" actId="208"/>
          <ac:spMkLst>
            <pc:docMk/>
            <pc:sldMk cId="2334153184" sldId="848"/>
            <ac:spMk id="7" creationId="{57BD455B-195A-4309-AD4E-6BC6976160AA}"/>
          </ac:spMkLst>
        </pc:spChg>
        <pc:spChg chg="add mod">
          <ac:chgData name="Tsujimoto,Mitsuhiro 辻本光宏(関東北甲信越統括支店O領域専門室)" userId="7251bc67-91ee-45c9-97e7-9c240c9b485c" providerId="ADAL" clId="{51945A91-CB03-4A52-98BE-5B2D563FE265}" dt="2021-04-22T11:07:38.954" v="8426" actId="208"/>
          <ac:spMkLst>
            <pc:docMk/>
            <pc:sldMk cId="2334153184" sldId="848"/>
            <ac:spMk id="8" creationId="{1E911D6B-C921-4194-89ED-9733FB4A11FA}"/>
          </ac:spMkLst>
        </pc:spChg>
        <pc:spChg chg="add mod">
          <ac:chgData name="Tsujimoto,Mitsuhiro 辻本光宏(関東北甲信越統括支店O領域専門室)" userId="7251bc67-91ee-45c9-97e7-9c240c9b485c" providerId="ADAL" clId="{51945A91-CB03-4A52-98BE-5B2D563FE265}" dt="2021-04-22T11:07:38.954" v="8426" actId="208"/>
          <ac:spMkLst>
            <pc:docMk/>
            <pc:sldMk cId="2334153184" sldId="848"/>
            <ac:spMk id="9" creationId="{A7FFCC32-B8E9-4E35-A92F-6B38F883B0A8}"/>
          </ac:spMkLst>
        </pc:spChg>
        <pc:spChg chg="add mod">
          <ac:chgData name="Tsujimoto,Mitsuhiro 辻本光宏(関東北甲信越統括支店O領域専門室)" userId="7251bc67-91ee-45c9-97e7-9c240c9b485c" providerId="ADAL" clId="{51945A91-CB03-4A52-98BE-5B2D563FE265}" dt="2021-04-23T00:57:24.331" v="8492" actId="2711"/>
          <ac:spMkLst>
            <pc:docMk/>
            <pc:sldMk cId="2334153184" sldId="848"/>
            <ac:spMk id="14" creationId="{D2D9FE1F-7640-4E57-B47D-D39338E3DE3E}"/>
          </ac:spMkLst>
        </pc:spChg>
        <pc:spChg chg="add mod">
          <ac:chgData name="Tsujimoto,Mitsuhiro 辻本光宏(関東北甲信越統括支店O領域専門室)" userId="7251bc67-91ee-45c9-97e7-9c240c9b485c" providerId="ADAL" clId="{51945A91-CB03-4A52-98BE-5B2D563FE265}" dt="2021-04-23T00:57:24.331" v="8492" actId="2711"/>
          <ac:spMkLst>
            <pc:docMk/>
            <pc:sldMk cId="2334153184" sldId="848"/>
            <ac:spMk id="15" creationId="{09214FCE-F87C-4C4C-B8FD-0D764CD152B1}"/>
          </ac:spMkLst>
        </pc:spChg>
        <pc:spChg chg="add mod">
          <ac:chgData name="Tsujimoto,Mitsuhiro 辻本光宏(関東北甲信越統括支店O領域専門室)" userId="7251bc67-91ee-45c9-97e7-9c240c9b485c" providerId="ADAL" clId="{51945A91-CB03-4A52-98BE-5B2D563FE265}" dt="2021-04-23T00:57:24.331" v="8492" actId="2711"/>
          <ac:spMkLst>
            <pc:docMk/>
            <pc:sldMk cId="2334153184" sldId="848"/>
            <ac:spMk id="16" creationId="{CB8BD04B-5844-411A-8516-9CD9C79DE91B}"/>
          </ac:spMkLst>
        </pc:spChg>
        <pc:picChg chg="del">
          <ac:chgData name="Tsujimoto,Mitsuhiro 辻本光宏(関東北甲信越統括支店O領域専門室)" userId="7251bc67-91ee-45c9-97e7-9c240c9b485c" providerId="ADAL" clId="{51945A91-CB03-4A52-98BE-5B2D563FE265}" dt="2021-04-22T10:57:10.099" v="8252" actId="478"/>
          <ac:picMkLst>
            <pc:docMk/>
            <pc:sldMk cId="2334153184" sldId="848"/>
            <ac:picMk id="3" creationId="{C80BF1F5-0910-4A2E-911C-9A0B7A66C0A9}"/>
          </ac:picMkLst>
        </pc:picChg>
        <pc:picChg chg="del">
          <ac:chgData name="Tsujimoto,Mitsuhiro 辻本光宏(関東北甲信越統括支店O領域専門室)" userId="7251bc67-91ee-45c9-97e7-9c240c9b485c" providerId="ADAL" clId="{51945A91-CB03-4A52-98BE-5B2D563FE265}" dt="2021-04-22T10:57:10.099" v="8252" actId="478"/>
          <ac:picMkLst>
            <pc:docMk/>
            <pc:sldMk cId="2334153184" sldId="848"/>
            <ac:picMk id="4" creationId="{5B897C6C-884D-4A08-A864-53A846D4E7ED}"/>
          </ac:picMkLst>
        </pc:picChg>
        <pc:picChg chg="add mod">
          <ac:chgData name="Tsujimoto,Mitsuhiro 辻本光宏(関東北甲信越統括支店O領域専門室)" userId="7251bc67-91ee-45c9-97e7-9c240c9b485c" providerId="ADAL" clId="{51945A91-CB03-4A52-98BE-5B2D563FE265}" dt="2021-04-22T11:02:05.240" v="8358" actId="1076"/>
          <ac:picMkLst>
            <pc:docMk/>
            <pc:sldMk cId="2334153184" sldId="848"/>
            <ac:picMk id="2050" creationId="{EE37813D-C78B-458D-AD0A-E7289C7716F0}"/>
          </ac:picMkLst>
        </pc:picChg>
        <pc:picChg chg="add mod">
          <ac:chgData name="Tsujimoto,Mitsuhiro 辻本光宏(関東北甲信越統括支店O領域専門室)" userId="7251bc67-91ee-45c9-97e7-9c240c9b485c" providerId="ADAL" clId="{51945A91-CB03-4A52-98BE-5B2D563FE265}" dt="2021-04-22T11:02:05.240" v="8358" actId="1076"/>
          <ac:picMkLst>
            <pc:docMk/>
            <pc:sldMk cId="2334153184" sldId="848"/>
            <ac:picMk id="2052" creationId="{C07B4C9A-27F3-4544-A0DA-ABAC2C13FB22}"/>
          </ac:picMkLst>
        </pc:picChg>
        <pc:picChg chg="add del mod">
          <ac:chgData name="Tsujimoto,Mitsuhiro 辻本光宏(関東北甲信越統括支店O領域専門室)" userId="7251bc67-91ee-45c9-97e7-9c240c9b485c" providerId="ADAL" clId="{51945A91-CB03-4A52-98BE-5B2D563FE265}" dt="2021-04-22T10:59:43.799" v="8277" actId="478"/>
          <ac:picMkLst>
            <pc:docMk/>
            <pc:sldMk cId="2334153184" sldId="848"/>
            <ac:picMk id="2054" creationId="{D821A3B6-C2AC-41D3-B871-8115AF0F8649}"/>
          </ac:picMkLst>
        </pc:picChg>
        <pc:picChg chg="add mod">
          <ac:chgData name="Tsujimoto,Mitsuhiro 辻本光宏(関東北甲信越統括支店O領域専門室)" userId="7251bc67-91ee-45c9-97e7-9c240c9b485c" providerId="ADAL" clId="{51945A91-CB03-4A52-98BE-5B2D563FE265}" dt="2021-04-22T11:02:05.240" v="8358" actId="1076"/>
          <ac:picMkLst>
            <pc:docMk/>
            <pc:sldMk cId="2334153184" sldId="848"/>
            <ac:picMk id="2056" creationId="{C9518F7E-D0E0-4C0D-9549-E0EF4F6D4A19}"/>
          </ac:picMkLst>
        </pc:picChg>
      </pc:sldChg>
      <pc:sldChg chg="modSp add">
        <pc:chgData name="Tsujimoto,Mitsuhiro 辻本光宏(関東北甲信越統括支店O領域専門室)" userId="7251bc67-91ee-45c9-97e7-9c240c9b485c" providerId="ADAL" clId="{51945A91-CB03-4A52-98BE-5B2D563FE265}" dt="2021-04-23T00:57:38.190" v="8493" actId="2711"/>
        <pc:sldMkLst>
          <pc:docMk/>
          <pc:sldMk cId="3163130775" sldId="849"/>
        </pc:sldMkLst>
        <pc:spChg chg="mod">
          <ac:chgData name="Tsujimoto,Mitsuhiro 辻本光宏(関東北甲信越統括支店O領域専門室)" userId="7251bc67-91ee-45c9-97e7-9c240c9b485c" providerId="ADAL" clId="{51945A91-CB03-4A52-98BE-5B2D563FE265}" dt="2021-04-22T11:07:51.450" v="8428" actId="208"/>
          <ac:spMkLst>
            <pc:docMk/>
            <pc:sldMk cId="3163130775" sldId="849"/>
            <ac:spMk id="7" creationId="{57BD455B-195A-4309-AD4E-6BC6976160AA}"/>
          </ac:spMkLst>
        </pc:spChg>
        <pc:spChg chg="mod">
          <ac:chgData name="Tsujimoto,Mitsuhiro 辻本光宏(関東北甲信越統括支店O領域専門室)" userId="7251bc67-91ee-45c9-97e7-9c240c9b485c" providerId="ADAL" clId="{51945A91-CB03-4A52-98BE-5B2D563FE265}" dt="2021-04-22T11:07:51.450" v="8428" actId="208"/>
          <ac:spMkLst>
            <pc:docMk/>
            <pc:sldMk cId="3163130775" sldId="849"/>
            <ac:spMk id="8" creationId="{1E911D6B-C921-4194-89ED-9733FB4A11FA}"/>
          </ac:spMkLst>
        </pc:spChg>
        <pc:spChg chg="mod">
          <ac:chgData name="Tsujimoto,Mitsuhiro 辻本光宏(関東北甲信越統括支店O領域専門室)" userId="7251bc67-91ee-45c9-97e7-9c240c9b485c" providerId="ADAL" clId="{51945A91-CB03-4A52-98BE-5B2D563FE265}" dt="2021-04-22T11:07:51.450" v="8428" actId="208"/>
          <ac:spMkLst>
            <pc:docMk/>
            <pc:sldMk cId="3163130775" sldId="849"/>
            <ac:spMk id="9" creationId="{A7FFCC32-B8E9-4E35-A92F-6B38F883B0A8}"/>
          </ac:spMkLst>
        </pc:spChg>
        <pc:spChg chg="mod">
          <ac:chgData name="Tsujimoto,Mitsuhiro 辻本光宏(関東北甲信越統括支店O領域専門室)" userId="7251bc67-91ee-45c9-97e7-9c240c9b485c" providerId="ADAL" clId="{51945A91-CB03-4A52-98BE-5B2D563FE265}" dt="2021-04-23T00:57:38.190" v="8493" actId="2711"/>
          <ac:spMkLst>
            <pc:docMk/>
            <pc:sldMk cId="3163130775" sldId="849"/>
            <ac:spMk id="14" creationId="{D2D9FE1F-7640-4E57-B47D-D39338E3DE3E}"/>
          </ac:spMkLst>
        </pc:spChg>
        <pc:spChg chg="mod">
          <ac:chgData name="Tsujimoto,Mitsuhiro 辻本光宏(関東北甲信越統括支店O領域専門室)" userId="7251bc67-91ee-45c9-97e7-9c240c9b485c" providerId="ADAL" clId="{51945A91-CB03-4A52-98BE-5B2D563FE265}" dt="2021-04-23T00:57:38.190" v="8493" actId="2711"/>
          <ac:spMkLst>
            <pc:docMk/>
            <pc:sldMk cId="3163130775" sldId="849"/>
            <ac:spMk id="15" creationId="{09214FCE-F87C-4C4C-B8FD-0D764CD152B1}"/>
          </ac:spMkLst>
        </pc:spChg>
        <pc:spChg chg="mod">
          <ac:chgData name="Tsujimoto,Mitsuhiro 辻本光宏(関東北甲信越統括支店O領域専門室)" userId="7251bc67-91ee-45c9-97e7-9c240c9b485c" providerId="ADAL" clId="{51945A91-CB03-4A52-98BE-5B2D563FE265}" dt="2021-04-23T00:57:38.190" v="8493" actId="2711"/>
          <ac:spMkLst>
            <pc:docMk/>
            <pc:sldMk cId="3163130775" sldId="849"/>
            <ac:spMk id="16" creationId="{CB8BD04B-5844-411A-8516-9CD9C79DE91B}"/>
          </ac:spMkLst>
        </pc:spChg>
      </pc:sldChg>
      <pc:sldChg chg="addSp delSp modSp add">
        <pc:chgData name="Tsujimoto,Mitsuhiro 辻本光宏(関東北甲信越統括支店O領域専門室)" userId="7251bc67-91ee-45c9-97e7-9c240c9b485c" providerId="ADAL" clId="{51945A91-CB03-4A52-98BE-5B2D563FE265}" dt="2021-04-22T11:07:23.133" v="8425" actId="208"/>
        <pc:sldMkLst>
          <pc:docMk/>
          <pc:sldMk cId="2750986973" sldId="850"/>
        </pc:sldMkLst>
        <pc:spChg chg="mod topLvl">
          <ac:chgData name="Tsujimoto,Mitsuhiro 辻本光宏(関東北甲信越統括支店O領域専門室)" userId="7251bc67-91ee-45c9-97e7-9c240c9b485c" providerId="ADAL" clId="{51945A91-CB03-4A52-98BE-5B2D563FE265}" dt="2021-04-22T11:07:23.133" v="8425" actId="208"/>
          <ac:spMkLst>
            <pc:docMk/>
            <pc:sldMk cId="2750986973" sldId="850"/>
            <ac:spMk id="7" creationId="{57BD455B-195A-4309-AD4E-6BC6976160AA}"/>
          </ac:spMkLst>
        </pc:spChg>
        <pc:spChg chg="mod topLvl">
          <ac:chgData name="Tsujimoto,Mitsuhiro 辻本光宏(関東北甲信越統括支店O領域専門室)" userId="7251bc67-91ee-45c9-97e7-9c240c9b485c" providerId="ADAL" clId="{51945A91-CB03-4A52-98BE-5B2D563FE265}" dt="2021-04-22T11:07:23.133" v="8425" actId="208"/>
          <ac:spMkLst>
            <pc:docMk/>
            <pc:sldMk cId="2750986973" sldId="850"/>
            <ac:spMk id="8" creationId="{1E911D6B-C921-4194-89ED-9733FB4A11FA}"/>
          </ac:spMkLst>
        </pc:spChg>
        <pc:spChg chg="mod topLvl">
          <ac:chgData name="Tsujimoto,Mitsuhiro 辻本光宏(関東北甲信越統括支店O領域専門室)" userId="7251bc67-91ee-45c9-97e7-9c240c9b485c" providerId="ADAL" clId="{51945A91-CB03-4A52-98BE-5B2D563FE265}" dt="2021-04-22T11:07:23.133" v="8425" actId="208"/>
          <ac:spMkLst>
            <pc:docMk/>
            <pc:sldMk cId="2750986973" sldId="850"/>
            <ac:spMk id="9" creationId="{A7FFCC32-B8E9-4E35-A92F-6B38F883B0A8}"/>
          </ac:spMkLst>
        </pc:spChg>
        <pc:spChg chg="mod">
          <ac:chgData name="Tsujimoto,Mitsuhiro 辻本光宏(関東北甲信越統括支店O領域専門室)" userId="7251bc67-91ee-45c9-97e7-9c240c9b485c" providerId="ADAL" clId="{51945A91-CB03-4A52-98BE-5B2D563FE265}" dt="2021-04-22T11:06:49.282" v="8418" actId="1037"/>
          <ac:spMkLst>
            <pc:docMk/>
            <pc:sldMk cId="2750986973" sldId="850"/>
            <ac:spMk id="14" creationId="{D2D9FE1F-7640-4E57-B47D-D39338E3DE3E}"/>
          </ac:spMkLst>
        </pc:spChg>
        <pc:spChg chg="mod">
          <ac:chgData name="Tsujimoto,Mitsuhiro 辻本光宏(関東北甲信越統括支店O領域専門室)" userId="7251bc67-91ee-45c9-97e7-9c240c9b485c" providerId="ADAL" clId="{51945A91-CB03-4A52-98BE-5B2D563FE265}" dt="2021-04-22T11:05:48.375" v="8391" actId="1076"/>
          <ac:spMkLst>
            <pc:docMk/>
            <pc:sldMk cId="2750986973" sldId="850"/>
            <ac:spMk id="15" creationId="{09214FCE-F87C-4C4C-B8FD-0D764CD152B1}"/>
          </ac:spMkLst>
        </pc:spChg>
        <pc:spChg chg="mod">
          <ac:chgData name="Tsujimoto,Mitsuhiro 辻本光宏(関東北甲信越統括支店O領域専門室)" userId="7251bc67-91ee-45c9-97e7-9c240c9b485c" providerId="ADAL" clId="{51945A91-CB03-4A52-98BE-5B2D563FE265}" dt="2021-04-22T11:06:49.282" v="8418" actId="1037"/>
          <ac:spMkLst>
            <pc:docMk/>
            <pc:sldMk cId="2750986973" sldId="850"/>
            <ac:spMk id="16" creationId="{CB8BD04B-5844-411A-8516-9CD9C79DE91B}"/>
          </ac:spMkLst>
        </pc:spChg>
        <pc:spChg chg="add del mod">
          <ac:chgData name="Tsujimoto,Mitsuhiro 辻本光宏(関東北甲信越統括支店O領域専門室)" userId="7251bc67-91ee-45c9-97e7-9c240c9b485c" providerId="ADAL" clId="{51945A91-CB03-4A52-98BE-5B2D563FE265}" dt="2021-04-22T11:06:49.576" v="8420"/>
          <ac:spMkLst>
            <pc:docMk/>
            <pc:sldMk cId="2750986973" sldId="850"/>
            <ac:spMk id="17" creationId="{3A759CA8-04A6-484E-BAA6-3A64CE9696B9}"/>
          </ac:spMkLst>
        </pc:spChg>
        <pc:grpChg chg="add del mod">
          <ac:chgData name="Tsujimoto,Mitsuhiro 辻本光宏(関東北甲信越統括支店O領域専門室)" userId="7251bc67-91ee-45c9-97e7-9c240c9b485c" providerId="ADAL" clId="{51945A91-CB03-4A52-98BE-5B2D563FE265}" dt="2021-04-22T11:07:09.183" v="8422" actId="165"/>
          <ac:grpSpMkLst>
            <pc:docMk/>
            <pc:sldMk cId="2750986973" sldId="850"/>
            <ac:grpSpMk id="3" creationId="{04137F44-4407-41F5-A883-B1DDB3D8B428}"/>
          </ac:grpSpMkLst>
        </pc:grpChg>
        <pc:grpChg chg="add del mod">
          <ac:chgData name="Tsujimoto,Mitsuhiro 辻本光宏(関東北甲信越統括支店O領域専門室)" userId="7251bc67-91ee-45c9-97e7-9c240c9b485c" providerId="ADAL" clId="{51945A91-CB03-4A52-98BE-5B2D563FE265}" dt="2021-04-22T11:07:12.991" v="8423" actId="165"/>
          <ac:grpSpMkLst>
            <pc:docMk/>
            <pc:sldMk cId="2750986973" sldId="850"/>
            <ac:grpSpMk id="4" creationId="{022D3788-3721-48CA-914D-B3D1C10AD325}"/>
          </ac:grpSpMkLst>
        </pc:grpChg>
        <pc:grpChg chg="add del mod">
          <ac:chgData name="Tsujimoto,Mitsuhiro 辻本光宏(関東北甲信越統括支店O領域専門室)" userId="7251bc67-91ee-45c9-97e7-9c240c9b485c" providerId="ADAL" clId="{51945A91-CB03-4A52-98BE-5B2D563FE265}" dt="2021-04-22T11:07:16.077" v="8424" actId="165"/>
          <ac:grpSpMkLst>
            <pc:docMk/>
            <pc:sldMk cId="2750986973" sldId="850"/>
            <ac:grpSpMk id="5" creationId="{1166EA82-BF82-4A2D-9C71-E4984E462CA3}"/>
          </ac:grpSpMkLst>
        </pc:grpChg>
        <pc:picChg chg="mod topLvl">
          <ac:chgData name="Tsujimoto,Mitsuhiro 辻本光宏(関東北甲信越統括支店O領域専門室)" userId="7251bc67-91ee-45c9-97e7-9c240c9b485c" providerId="ADAL" clId="{51945A91-CB03-4A52-98BE-5B2D563FE265}" dt="2021-04-22T11:07:12.991" v="8423" actId="165"/>
          <ac:picMkLst>
            <pc:docMk/>
            <pc:sldMk cId="2750986973" sldId="850"/>
            <ac:picMk id="2050" creationId="{EE37813D-C78B-458D-AD0A-E7289C7716F0}"/>
          </ac:picMkLst>
        </pc:picChg>
        <pc:picChg chg="mod topLvl">
          <ac:chgData name="Tsujimoto,Mitsuhiro 辻本光宏(関東北甲信越統括支店O領域専門室)" userId="7251bc67-91ee-45c9-97e7-9c240c9b485c" providerId="ADAL" clId="{51945A91-CB03-4A52-98BE-5B2D563FE265}" dt="2021-04-22T11:07:16.077" v="8424" actId="165"/>
          <ac:picMkLst>
            <pc:docMk/>
            <pc:sldMk cId="2750986973" sldId="850"/>
            <ac:picMk id="2052" creationId="{C07B4C9A-27F3-4544-A0DA-ABAC2C13FB22}"/>
          </ac:picMkLst>
        </pc:picChg>
        <pc:picChg chg="mod topLvl">
          <ac:chgData name="Tsujimoto,Mitsuhiro 辻本光宏(関東北甲信越統括支店O領域専門室)" userId="7251bc67-91ee-45c9-97e7-9c240c9b485c" providerId="ADAL" clId="{51945A91-CB03-4A52-98BE-5B2D563FE265}" dt="2021-04-22T11:07:09.183" v="8422" actId="165"/>
          <ac:picMkLst>
            <pc:docMk/>
            <pc:sldMk cId="2750986973" sldId="850"/>
            <ac:picMk id="2056" creationId="{C9518F7E-D0E0-4C0D-9549-E0EF4F6D4A19}"/>
          </ac:picMkLst>
        </pc:picChg>
      </pc:sldChg>
      <pc:sldChg chg="addSp delSp modSp add">
        <pc:chgData name="Tsujimoto,Mitsuhiro 辻本光宏(関東北甲信越統括支店O領域専門室)" userId="7251bc67-91ee-45c9-97e7-9c240c9b485c" providerId="ADAL" clId="{51945A91-CB03-4A52-98BE-5B2D563FE265}" dt="2021-04-23T05:05:29.072" v="12671" actId="207"/>
        <pc:sldMkLst>
          <pc:docMk/>
          <pc:sldMk cId="3543397277" sldId="851"/>
        </pc:sldMkLst>
        <pc:spChg chg="mod">
          <ac:chgData name="Tsujimoto,Mitsuhiro 辻本光宏(関東北甲信越統括支店O領域専門室)" userId="7251bc67-91ee-45c9-97e7-9c240c9b485c" providerId="ADAL" clId="{51945A91-CB03-4A52-98BE-5B2D563FE265}" dt="2021-04-23T05:05:29.072" v="12671" actId="207"/>
          <ac:spMkLst>
            <pc:docMk/>
            <pc:sldMk cId="3543397277" sldId="851"/>
            <ac:spMk id="2" creationId="{E9C84B9A-0A5E-4501-A736-97E7536FAD85}"/>
          </ac:spMkLst>
        </pc:spChg>
        <pc:spChg chg="del">
          <ac:chgData name="Tsujimoto,Mitsuhiro 辻本光宏(関東北甲信越統括支店O領域専門室)" userId="7251bc67-91ee-45c9-97e7-9c240c9b485c" providerId="ADAL" clId="{51945A91-CB03-4A52-98BE-5B2D563FE265}" dt="2021-04-23T01:18:03.025" v="8952" actId="478"/>
          <ac:spMkLst>
            <pc:docMk/>
            <pc:sldMk cId="3543397277" sldId="851"/>
            <ac:spMk id="6" creationId="{DB762508-B2DE-4DF4-BA8E-E427FABE18CF}"/>
          </ac:spMkLst>
        </pc:spChg>
        <pc:spChg chg="mod">
          <ac:chgData name="Tsujimoto,Mitsuhiro 辻本光宏(関東北甲信越統括支店O領域専門室)" userId="7251bc67-91ee-45c9-97e7-9c240c9b485c" providerId="ADAL" clId="{51945A91-CB03-4A52-98BE-5B2D563FE265}" dt="2021-04-23T01:17:32.038" v="8943" actId="20577"/>
          <ac:spMkLst>
            <pc:docMk/>
            <pc:sldMk cId="3543397277" sldId="851"/>
            <ac:spMk id="9" creationId="{961A8DDC-52FD-43C8-8EB1-F361125483B3}"/>
          </ac:spMkLst>
        </pc:spChg>
        <pc:spChg chg="add del">
          <ac:chgData name="Tsujimoto,Mitsuhiro 辻本光宏(関東北甲信越統括支店O領域専門室)" userId="7251bc67-91ee-45c9-97e7-9c240c9b485c" providerId="ADAL" clId="{51945A91-CB03-4A52-98BE-5B2D563FE265}" dt="2021-04-23T01:17:35.217" v="8944" actId="478"/>
          <ac:spMkLst>
            <pc:docMk/>
            <pc:sldMk cId="3543397277" sldId="851"/>
            <ac:spMk id="38" creationId="{6EFAE8C2-1333-453B-A39B-936798CB7958}"/>
          </ac:spMkLst>
        </pc:spChg>
        <pc:spChg chg="add del">
          <ac:chgData name="Tsujimoto,Mitsuhiro 辻本光宏(関東北甲信越統括支店O領域専門室)" userId="7251bc67-91ee-45c9-97e7-9c240c9b485c" providerId="ADAL" clId="{51945A91-CB03-4A52-98BE-5B2D563FE265}" dt="2021-04-23T01:17:35.217" v="8944" actId="478"/>
          <ac:spMkLst>
            <pc:docMk/>
            <pc:sldMk cId="3543397277" sldId="851"/>
            <ac:spMk id="39" creationId="{854E51AE-0CCC-41D8-826E-D6D614FA266A}"/>
          </ac:spMkLst>
        </pc:spChg>
        <pc:spChg chg="add mod">
          <ac:chgData name="Tsujimoto,Mitsuhiro 辻本光宏(関東北甲信越統括支店O領域専門室)" userId="7251bc67-91ee-45c9-97e7-9c240c9b485c" providerId="ADAL" clId="{51945A91-CB03-4A52-98BE-5B2D563FE265}" dt="2021-04-23T01:18:10.012" v="8956" actId="1076"/>
          <ac:spMkLst>
            <pc:docMk/>
            <pc:sldMk cId="3543397277" sldId="851"/>
            <ac:spMk id="40" creationId="{698C932D-9DF5-48E7-8ABF-6183B13358D0}"/>
          </ac:spMkLst>
        </pc:spChg>
        <pc:grpChg chg="del">
          <ac:chgData name="Tsujimoto,Mitsuhiro 辻本光宏(関東北甲信越統括支店O領域専門室)" userId="7251bc67-91ee-45c9-97e7-9c240c9b485c" providerId="ADAL" clId="{51945A91-CB03-4A52-98BE-5B2D563FE265}" dt="2021-04-23T01:14:31.218" v="8546" actId="478"/>
          <ac:grpSpMkLst>
            <pc:docMk/>
            <pc:sldMk cId="3543397277" sldId="851"/>
            <ac:grpSpMk id="7" creationId="{7FE6651F-1136-4D61-B65B-2E615A516C40}"/>
          </ac:grpSpMkLst>
        </pc:grpChg>
        <pc:picChg chg="add mod">
          <ac:chgData name="Tsujimoto,Mitsuhiro 辻本光宏(関東北甲信越統括支店O領域専門室)" userId="7251bc67-91ee-45c9-97e7-9c240c9b485c" providerId="ADAL" clId="{51945A91-CB03-4A52-98BE-5B2D563FE265}" dt="2021-04-23T01:17:55.133" v="8951" actId="1076"/>
          <ac:picMkLst>
            <pc:docMk/>
            <pc:sldMk cId="3543397277" sldId="851"/>
            <ac:picMk id="36" creationId="{83943AB1-B09C-47C0-B40B-FA43755FC40D}"/>
          </ac:picMkLst>
        </pc:picChg>
        <pc:picChg chg="add del mod">
          <ac:chgData name="Tsujimoto,Mitsuhiro 辻本光宏(関東北甲信越統括支店O領域専門室)" userId="7251bc67-91ee-45c9-97e7-9c240c9b485c" providerId="ADAL" clId="{51945A91-CB03-4A52-98BE-5B2D563FE265}" dt="2021-04-23T01:16:47.166" v="8727" actId="478"/>
          <ac:picMkLst>
            <pc:docMk/>
            <pc:sldMk cId="3543397277" sldId="851"/>
            <ac:picMk id="37" creationId="{673263E4-6968-4178-B656-80D269F68F5E}"/>
          </ac:picMkLst>
        </pc:pic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12" creationId="{1900D124-F7FC-4DEB-A656-4AC80E94DD36}"/>
          </ac:cxnSpMkLst>
        </pc:cxn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14" creationId="{74C0921E-0212-4570-A077-CCAD25325550}"/>
          </ac:cxnSpMkLst>
        </pc:cxn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23" creationId="{2BBA75EE-84A3-45C9-96BB-AFA383C35D64}"/>
          </ac:cxnSpMkLst>
        </pc:cxn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27" creationId="{8EE7037D-996F-46B3-892C-29C4035031F0}"/>
          </ac:cxnSpMkLst>
        </pc:cxn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28" creationId="{7C579B56-4CA6-414B-BC91-F4BA197ABEC5}"/>
          </ac:cxnSpMkLst>
        </pc:cxn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31" creationId="{C85F07B8-2FF6-46EA-B056-EEB543CF1FF7}"/>
          </ac:cxnSpMkLst>
        </pc:cxn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32" creationId="{E364300B-84FE-4918-945B-FBDC02B76579}"/>
          </ac:cxnSpMkLst>
        </pc:cxnChg>
        <pc:cxnChg chg="mod">
          <ac:chgData name="Tsujimoto,Mitsuhiro 辻本光宏(関東北甲信越統括支店O領域専門室)" userId="7251bc67-91ee-45c9-97e7-9c240c9b485c" providerId="ADAL" clId="{51945A91-CB03-4A52-98BE-5B2D563FE265}" dt="2021-04-23T01:14:31.218" v="8546" actId="478"/>
          <ac:cxnSpMkLst>
            <pc:docMk/>
            <pc:sldMk cId="3543397277" sldId="851"/>
            <ac:cxnSpMk id="35" creationId="{928323BE-50F2-43A4-96B9-A7E7CD2F0DE7}"/>
          </ac:cxnSpMkLst>
        </pc:cxnChg>
      </pc:sldChg>
      <pc:sldChg chg="addSp delSp modSp add">
        <pc:chgData name="Tsujimoto,Mitsuhiro 辻本光宏(関東北甲信越統括支店O領域専門室)" userId="7251bc67-91ee-45c9-97e7-9c240c9b485c" providerId="ADAL" clId="{51945A91-CB03-4A52-98BE-5B2D563FE265}" dt="2021-04-23T04:33:46.166" v="11091"/>
        <pc:sldMkLst>
          <pc:docMk/>
          <pc:sldMk cId="1779646733" sldId="852"/>
        </pc:sldMkLst>
        <pc:spChg chg="add mod">
          <ac:chgData name="Tsujimoto,Mitsuhiro 辻本光宏(関東北甲信越統括支店O領域専門室)" userId="7251bc67-91ee-45c9-97e7-9c240c9b485c" providerId="ADAL" clId="{51945A91-CB03-4A52-98BE-5B2D563FE265}" dt="2021-04-23T01:20:58.324" v="8966"/>
          <ac:spMkLst>
            <pc:docMk/>
            <pc:sldMk cId="1779646733" sldId="852"/>
            <ac:spMk id="2" creationId="{97604AAA-8C29-4C04-8C9E-025D712EF78D}"/>
          </ac:spMkLst>
        </pc:spChg>
        <pc:spChg chg="add mod">
          <ac:chgData name="Tsujimoto,Mitsuhiro 辻本光宏(関東北甲信越統括支店O領域専門室)" userId="7251bc67-91ee-45c9-97e7-9c240c9b485c" providerId="ADAL" clId="{51945A91-CB03-4A52-98BE-5B2D563FE265}" dt="2021-04-23T04:33:46.166" v="11091"/>
          <ac:spMkLst>
            <pc:docMk/>
            <pc:sldMk cId="1779646733" sldId="852"/>
            <ac:spMk id="3" creationId="{4633F855-18B5-4A22-8D2D-BCEE2D3D6A12}"/>
          </ac:spMkLst>
        </pc:spChg>
        <pc:spChg chg="add mod">
          <ac:chgData name="Tsujimoto,Mitsuhiro 辻本光宏(関東北甲信越統括支店O領域専門室)" userId="7251bc67-91ee-45c9-97e7-9c240c9b485c" providerId="ADAL" clId="{51945A91-CB03-4A52-98BE-5B2D563FE265}" dt="2021-04-23T01:31:17.892" v="9575" actId="1036"/>
          <ac:spMkLst>
            <pc:docMk/>
            <pc:sldMk cId="1779646733" sldId="852"/>
            <ac:spMk id="6" creationId="{219B40BE-267B-4362-96C4-A668AC994D93}"/>
          </ac:spMkLst>
        </pc:spChg>
        <pc:spChg chg="add del">
          <ac:chgData name="Tsujimoto,Mitsuhiro 辻本光宏(関東北甲信越統括支店O領域専門室)" userId="7251bc67-91ee-45c9-97e7-9c240c9b485c" providerId="ADAL" clId="{51945A91-CB03-4A52-98BE-5B2D563FE265}" dt="2021-04-23T01:22:52.889" v="9223" actId="478"/>
          <ac:spMkLst>
            <pc:docMk/>
            <pc:sldMk cId="1779646733" sldId="852"/>
            <ac:spMk id="7" creationId="{E2D50112-016C-40E4-BC91-D8C0C84961BE}"/>
          </ac:spMkLst>
        </pc:spChg>
        <pc:spChg chg="add mod">
          <ac:chgData name="Tsujimoto,Mitsuhiro 辻本光宏(関東北甲信越統括支店O領域専門室)" userId="7251bc67-91ee-45c9-97e7-9c240c9b485c" providerId="ADAL" clId="{51945A91-CB03-4A52-98BE-5B2D563FE265}" dt="2021-04-23T01:31:42.260" v="9594" actId="20577"/>
          <ac:spMkLst>
            <pc:docMk/>
            <pc:sldMk cId="1779646733" sldId="852"/>
            <ac:spMk id="8" creationId="{DC43F0FC-A271-454F-BA25-99C2F13FDF93}"/>
          </ac:spMkLst>
        </pc:spChg>
        <pc:spChg chg="add mod">
          <ac:chgData name="Tsujimoto,Mitsuhiro 辻本光宏(関東北甲信越統括支店O領域専門室)" userId="7251bc67-91ee-45c9-97e7-9c240c9b485c" providerId="ADAL" clId="{51945A91-CB03-4A52-98BE-5B2D563FE265}" dt="2021-04-23T01:32:04.354" v="9617" actId="20577"/>
          <ac:spMkLst>
            <pc:docMk/>
            <pc:sldMk cId="1779646733" sldId="852"/>
            <ac:spMk id="9" creationId="{962763CA-874E-419A-9F15-58A6D63AC4D6}"/>
          </ac:spMkLst>
        </pc:spChg>
        <pc:picChg chg="add del">
          <ac:chgData name="Tsujimoto,Mitsuhiro 辻本光宏(関東北甲信越統括支店O領域専門室)" userId="7251bc67-91ee-45c9-97e7-9c240c9b485c" providerId="ADAL" clId="{51945A91-CB03-4A52-98BE-5B2D563FE265}" dt="2021-04-23T01:21:28.891" v="8968" actId="478"/>
          <ac:picMkLst>
            <pc:docMk/>
            <pc:sldMk cId="1779646733" sldId="852"/>
            <ac:picMk id="4" creationId="{DC437AB6-9E10-4169-B64C-631CE7F8E756}"/>
          </ac:picMkLst>
        </pc:picChg>
        <pc:picChg chg="add mod">
          <ac:chgData name="Tsujimoto,Mitsuhiro 辻本光宏(関東北甲信越統括支店O領域専門室)" userId="7251bc67-91ee-45c9-97e7-9c240c9b485c" providerId="ADAL" clId="{51945A91-CB03-4A52-98BE-5B2D563FE265}" dt="2021-04-23T01:31:17.892" v="9575" actId="1036"/>
          <ac:picMkLst>
            <pc:docMk/>
            <pc:sldMk cId="1779646733" sldId="852"/>
            <ac:picMk id="5" creationId="{C3738300-ABCB-43C0-907D-FAF294956183}"/>
          </ac:picMkLst>
        </pc:picChg>
      </pc:sldChg>
      <pc:sldChg chg="addSp delSp modSp add">
        <pc:chgData name="Tsujimoto,Mitsuhiro 辻本光宏(関東北甲信越統括支店O領域専門室)" userId="7251bc67-91ee-45c9-97e7-9c240c9b485c" providerId="ADAL" clId="{51945A91-CB03-4A52-98BE-5B2D563FE265}" dt="2021-04-23T01:30:21.813" v="9557" actId="1036"/>
        <pc:sldMkLst>
          <pc:docMk/>
          <pc:sldMk cId="271718290" sldId="853"/>
        </pc:sldMkLst>
        <pc:spChg chg="mod">
          <ac:chgData name="Tsujimoto,Mitsuhiro 辻本光宏(関東北甲信越統括支店O領域専門室)" userId="7251bc67-91ee-45c9-97e7-9c240c9b485c" providerId="ADAL" clId="{51945A91-CB03-4A52-98BE-5B2D563FE265}" dt="2021-04-23T01:23:41.120" v="9235"/>
          <ac:spMkLst>
            <pc:docMk/>
            <pc:sldMk cId="271718290" sldId="853"/>
            <ac:spMk id="2" creationId="{97604AAA-8C29-4C04-8C9E-025D712EF78D}"/>
          </ac:spMkLst>
        </pc:spChg>
        <pc:spChg chg="mod">
          <ac:chgData name="Tsujimoto,Mitsuhiro 辻本光宏(関東北甲信越統括支店O領域専門室)" userId="7251bc67-91ee-45c9-97e7-9c240c9b485c" providerId="ADAL" clId="{51945A91-CB03-4A52-98BE-5B2D563FE265}" dt="2021-04-23T01:24:16.887" v="9368" actId="20577"/>
          <ac:spMkLst>
            <pc:docMk/>
            <pc:sldMk cId="271718290" sldId="853"/>
            <ac:spMk id="3" creationId="{4633F855-18B5-4A22-8D2D-BCEE2D3D6A12}"/>
          </ac:spMkLst>
        </pc:spChg>
        <pc:spChg chg="add mod">
          <ac:chgData name="Tsujimoto,Mitsuhiro 辻本光宏(関東北甲信越統括支店O領域専門室)" userId="7251bc67-91ee-45c9-97e7-9c240c9b485c" providerId="ADAL" clId="{51945A91-CB03-4A52-98BE-5B2D563FE265}" dt="2021-04-23T01:30:21.813" v="9557" actId="1036"/>
          <ac:spMkLst>
            <pc:docMk/>
            <pc:sldMk cId="271718290" sldId="853"/>
            <ac:spMk id="4" creationId="{4F79DFA6-BB9F-4FBD-939B-2592B6CCE2F6}"/>
          </ac:spMkLst>
        </pc:spChg>
        <pc:spChg chg="del">
          <ac:chgData name="Tsujimoto,Mitsuhiro 辻本光宏(関東北甲信越統括支店O領域専門室)" userId="7251bc67-91ee-45c9-97e7-9c240c9b485c" providerId="ADAL" clId="{51945A91-CB03-4A52-98BE-5B2D563FE265}" dt="2021-04-23T01:30:08.758" v="9545" actId="478"/>
          <ac:spMkLst>
            <pc:docMk/>
            <pc:sldMk cId="271718290" sldId="853"/>
            <ac:spMk id="6" creationId="{219B40BE-267B-4362-96C4-A668AC994D93}"/>
          </ac:spMkLst>
        </pc:spChg>
        <pc:spChg chg="add del mod">
          <ac:chgData name="Tsujimoto,Mitsuhiro 辻本光宏(関東北甲信越統括支店O領域専門室)" userId="7251bc67-91ee-45c9-97e7-9c240c9b485c" providerId="ADAL" clId="{51945A91-CB03-4A52-98BE-5B2D563FE265}" dt="2021-04-23T01:24:20.269" v="9369" actId="478"/>
          <ac:spMkLst>
            <pc:docMk/>
            <pc:sldMk cId="271718290" sldId="853"/>
            <ac:spMk id="7" creationId="{1DF9A2ED-3097-4DEC-A9E9-1DA6A493847E}"/>
          </ac:spMkLst>
        </pc:spChg>
        <pc:spChg chg="add mod">
          <ac:chgData name="Tsujimoto,Mitsuhiro 辻本光宏(関東北甲信越統括支店O領域専門室)" userId="7251bc67-91ee-45c9-97e7-9c240c9b485c" providerId="ADAL" clId="{51945A91-CB03-4A52-98BE-5B2D563FE265}" dt="2021-04-23T01:30:21.813" v="9557" actId="1036"/>
          <ac:spMkLst>
            <pc:docMk/>
            <pc:sldMk cId="271718290" sldId="853"/>
            <ac:spMk id="10" creationId="{5B1914FC-2EAE-4BBB-8E97-01B41A4792E1}"/>
          </ac:spMkLst>
        </pc:spChg>
        <pc:picChg chg="del">
          <ac:chgData name="Tsujimoto,Mitsuhiro 辻本光宏(関東北甲信越統括支店O領域専門室)" userId="7251bc67-91ee-45c9-97e7-9c240c9b485c" providerId="ADAL" clId="{51945A91-CB03-4A52-98BE-5B2D563FE265}" dt="2021-04-23T01:25:22.913" v="9370" actId="478"/>
          <ac:picMkLst>
            <pc:docMk/>
            <pc:sldMk cId="271718290" sldId="853"/>
            <ac:picMk id="5" creationId="{C3738300-ABCB-43C0-907D-FAF294956183}"/>
          </ac:picMkLst>
        </pc:picChg>
        <pc:picChg chg="add mod">
          <ac:chgData name="Tsujimoto,Mitsuhiro 辻本光宏(関東北甲信越統括支店O領域専門室)" userId="7251bc67-91ee-45c9-97e7-9c240c9b485c" providerId="ADAL" clId="{51945A91-CB03-4A52-98BE-5B2D563FE265}" dt="2021-04-23T01:30:21.813" v="9557" actId="1036"/>
          <ac:picMkLst>
            <pc:docMk/>
            <pc:sldMk cId="271718290" sldId="853"/>
            <ac:picMk id="8" creationId="{2B107838-CF6A-4051-8464-C59887766B83}"/>
          </ac:picMkLst>
        </pc:picChg>
        <pc:picChg chg="add mod">
          <ac:chgData name="Tsujimoto,Mitsuhiro 辻本光宏(関東北甲信越統括支店O領域専門室)" userId="7251bc67-91ee-45c9-97e7-9c240c9b485c" providerId="ADAL" clId="{51945A91-CB03-4A52-98BE-5B2D563FE265}" dt="2021-04-23T01:30:21.813" v="9557" actId="1036"/>
          <ac:picMkLst>
            <pc:docMk/>
            <pc:sldMk cId="271718290" sldId="853"/>
            <ac:picMk id="9" creationId="{D024B88F-5E0A-4C26-B6BD-F30D60E0500E}"/>
          </ac:picMkLst>
        </pc:picChg>
      </pc:sldChg>
      <pc:sldChg chg="addSp delSp modSp add">
        <pc:chgData name="Tsujimoto,Mitsuhiro 辻本光宏(関東北甲信越統括支店O領域専門室)" userId="7251bc67-91ee-45c9-97e7-9c240c9b485c" providerId="ADAL" clId="{51945A91-CB03-4A52-98BE-5B2D563FE265}" dt="2021-04-23T01:41:14.366" v="9876" actId="1076"/>
        <pc:sldMkLst>
          <pc:docMk/>
          <pc:sldMk cId="259624961" sldId="854"/>
        </pc:sldMkLst>
        <pc:spChg chg="add mod">
          <ac:chgData name="Tsujimoto,Mitsuhiro 辻本光宏(関東北甲信越統括支店O領域専門室)" userId="7251bc67-91ee-45c9-97e7-9c240c9b485c" providerId="ADAL" clId="{51945A91-CB03-4A52-98BE-5B2D563FE265}" dt="2021-04-23T01:41:14.366" v="9876" actId="1076"/>
          <ac:spMkLst>
            <pc:docMk/>
            <pc:sldMk cId="259624961" sldId="854"/>
            <ac:spMk id="2" creationId="{956F412C-AFDA-4E98-81C9-25959358138C}"/>
          </ac:spMkLst>
        </pc:spChg>
        <pc:spChg chg="add mod">
          <ac:chgData name="Tsujimoto,Mitsuhiro 辻本光宏(関東北甲信越統括支店O領域専門室)" userId="7251bc67-91ee-45c9-97e7-9c240c9b485c" providerId="ADAL" clId="{51945A91-CB03-4A52-98BE-5B2D563FE265}" dt="2021-04-23T01:36:03.042" v="9714" actId="1076"/>
          <ac:spMkLst>
            <pc:docMk/>
            <pc:sldMk cId="259624961" sldId="854"/>
            <ac:spMk id="4" creationId="{14ACAD29-3920-4FB1-B16F-ADA6157EE5F2}"/>
          </ac:spMkLst>
        </pc:spChg>
        <pc:spChg chg="add mod">
          <ac:chgData name="Tsujimoto,Mitsuhiro 辻本光宏(関東北甲信越統括支店O領域専門室)" userId="7251bc67-91ee-45c9-97e7-9c240c9b485c" providerId="ADAL" clId="{51945A91-CB03-4A52-98BE-5B2D563FE265}" dt="2021-04-23T01:37:21.790" v="9872" actId="20577"/>
          <ac:spMkLst>
            <pc:docMk/>
            <pc:sldMk cId="259624961" sldId="854"/>
            <ac:spMk id="5" creationId="{D5ABFF81-73DD-4A9E-9BBD-162138AD45B4}"/>
          </ac:spMkLst>
        </pc:spChg>
        <pc:spChg chg="add del">
          <ac:chgData name="Tsujimoto,Mitsuhiro 辻本光宏(関東北甲信越統括支店O領域専門室)" userId="7251bc67-91ee-45c9-97e7-9c240c9b485c" providerId="ADAL" clId="{51945A91-CB03-4A52-98BE-5B2D563FE265}" dt="2021-04-23T01:36:30.778" v="9739" actId="478"/>
          <ac:spMkLst>
            <pc:docMk/>
            <pc:sldMk cId="259624961" sldId="854"/>
            <ac:spMk id="6" creationId="{8C4327A7-3269-415D-B99B-777E0EFB3C88}"/>
          </ac:spMkLst>
        </pc:spChg>
        <pc:picChg chg="add mod modCrop">
          <ac:chgData name="Tsujimoto,Mitsuhiro 辻本光宏(関東北甲信越統括支店O領域専門室)" userId="7251bc67-91ee-45c9-97e7-9c240c9b485c" providerId="ADAL" clId="{51945A91-CB03-4A52-98BE-5B2D563FE265}" dt="2021-04-23T01:36:05.254" v="9715" actId="1076"/>
          <ac:picMkLst>
            <pc:docMk/>
            <pc:sldMk cId="259624961" sldId="854"/>
            <ac:picMk id="3" creationId="{B4BD5522-1F1E-45C2-A642-0B5091824BA4}"/>
          </ac:picMkLst>
        </pc:picChg>
      </pc:sldChg>
      <pc:sldChg chg="addSp delSp modSp add">
        <pc:chgData name="Tsujimoto,Mitsuhiro 辻本光宏(関東北甲信越統括支店O領域専門室)" userId="7251bc67-91ee-45c9-97e7-9c240c9b485c" providerId="ADAL" clId="{51945A91-CB03-4A52-98BE-5B2D563FE265}" dt="2021-04-23T01:45:51.969" v="10290" actId="1035"/>
        <pc:sldMkLst>
          <pc:docMk/>
          <pc:sldMk cId="3047997188" sldId="855"/>
        </pc:sldMkLst>
        <pc:spChg chg="add">
          <ac:chgData name="Tsujimoto,Mitsuhiro 辻本光宏(関東北甲信越統括支店O領域専門室)" userId="7251bc67-91ee-45c9-97e7-9c240c9b485c" providerId="ADAL" clId="{51945A91-CB03-4A52-98BE-5B2D563FE265}" dt="2021-04-23T01:41:17.560" v="9877"/>
          <ac:spMkLst>
            <pc:docMk/>
            <pc:sldMk cId="3047997188" sldId="855"/>
            <ac:spMk id="2" creationId="{57787B6C-C134-487D-91E0-C762831ACFA7}"/>
          </ac:spMkLst>
        </pc:spChg>
        <pc:spChg chg="add mod">
          <ac:chgData name="Tsujimoto,Mitsuhiro 辻本光宏(関東北甲信越統括支店O領域専門室)" userId="7251bc67-91ee-45c9-97e7-9c240c9b485c" providerId="ADAL" clId="{51945A91-CB03-4A52-98BE-5B2D563FE265}" dt="2021-04-23T01:45:31.414" v="10280"/>
          <ac:spMkLst>
            <pc:docMk/>
            <pc:sldMk cId="3047997188" sldId="855"/>
            <ac:spMk id="5" creationId="{D82C5338-AFA3-4719-B324-BF9C4B32409A}"/>
          </ac:spMkLst>
        </pc:spChg>
        <pc:spChg chg="add mod">
          <ac:chgData name="Tsujimoto,Mitsuhiro 辻本光宏(関東北甲信越統括支店O領域専門室)" userId="7251bc67-91ee-45c9-97e7-9c240c9b485c" providerId="ADAL" clId="{51945A91-CB03-4A52-98BE-5B2D563FE265}" dt="2021-04-23T01:45:51.969" v="10290" actId="1035"/>
          <ac:spMkLst>
            <pc:docMk/>
            <pc:sldMk cId="3047997188" sldId="855"/>
            <ac:spMk id="6" creationId="{F0ECA539-1B61-4CEC-B115-8450AE695EE6}"/>
          </ac:spMkLst>
        </pc:spChg>
        <pc:spChg chg="add mod">
          <ac:chgData name="Tsujimoto,Mitsuhiro 辻本光宏(関東北甲信越統括支店O領域専門室)" userId="7251bc67-91ee-45c9-97e7-9c240c9b485c" providerId="ADAL" clId="{51945A91-CB03-4A52-98BE-5B2D563FE265}" dt="2021-04-23T01:45:51.969" v="10290" actId="1035"/>
          <ac:spMkLst>
            <pc:docMk/>
            <pc:sldMk cId="3047997188" sldId="855"/>
            <ac:spMk id="7" creationId="{7E61C30F-3445-4224-813C-C766ED1AA0B7}"/>
          </ac:spMkLst>
        </pc:spChg>
        <pc:spChg chg="add del">
          <ac:chgData name="Tsujimoto,Mitsuhiro 辻本光宏(関東北甲信越統括支店O領域専門室)" userId="7251bc67-91ee-45c9-97e7-9c240c9b485c" providerId="ADAL" clId="{51945A91-CB03-4A52-98BE-5B2D563FE265}" dt="2021-04-23T01:45:34.947" v="10281" actId="478"/>
          <ac:spMkLst>
            <pc:docMk/>
            <pc:sldMk cId="3047997188" sldId="855"/>
            <ac:spMk id="8" creationId="{2FE36BA9-57DB-4C84-A9A6-AC0BCDBEF60D}"/>
          </ac:spMkLst>
        </pc:spChg>
        <pc:spChg chg="add">
          <ac:chgData name="Tsujimoto,Mitsuhiro 辻本光宏(関東北甲信越統括支店O領域専門室)" userId="7251bc67-91ee-45c9-97e7-9c240c9b485c" providerId="ADAL" clId="{51945A91-CB03-4A52-98BE-5B2D563FE265}" dt="2021-04-23T01:45:40.591" v="10282"/>
          <ac:spMkLst>
            <pc:docMk/>
            <pc:sldMk cId="3047997188" sldId="855"/>
            <ac:spMk id="9" creationId="{9A856029-DE93-4109-91D5-6D921E1C8F9C}"/>
          </ac:spMkLst>
        </pc:spChg>
        <pc:picChg chg="add mod">
          <ac:chgData name="Tsujimoto,Mitsuhiro 辻本光宏(関東北甲信越統括支店O領域専門室)" userId="7251bc67-91ee-45c9-97e7-9c240c9b485c" providerId="ADAL" clId="{51945A91-CB03-4A52-98BE-5B2D563FE265}" dt="2021-04-23T01:45:51.969" v="10290" actId="1035"/>
          <ac:picMkLst>
            <pc:docMk/>
            <pc:sldMk cId="3047997188" sldId="855"/>
            <ac:picMk id="3" creationId="{F6A58093-8363-4E28-BF2D-C6CED939175D}"/>
          </ac:picMkLst>
        </pc:picChg>
        <pc:picChg chg="add mod">
          <ac:chgData name="Tsujimoto,Mitsuhiro 辻本光宏(関東北甲信越統括支店O領域専門室)" userId="7251bc67-91ee-45c9-97e7-9c240c9b485c" providerId="ADAL" clId="{51945A91-CB03-4A52-98BE-5B2D563FE265}" dt="2021-04-23T01:45:51.969" v="10290" actId="1035"/>
          <ac:picMkLst>
            <pc:docMk/>
            <pc:sldMk cId="3047997188" sldId="855"/>
            <ac:picMk id="4" creationId="{BEC48EB1-2E44-46E5-BE51-0B9991BEFBAC}"/>
          </ac:picMkLst>
        </pc:picChg>
      </pc:sldChg>
      <pc:sldChg chg="addSp delSp modSp add">
        <pc:chgData name="Tsujimoto,Mitsuhiro 辻本光宏(関東北甲信越統括支店O領域専門室)" userId="7251bc67-91ee-45c9-97e7-9c240c9b485c" providerId="ADAL" clId="{51945A91-CB03-4A52-98BE-5B2D563FE265}" dt="2021-04-23T05:05:55.072" v="12690" actId="207"/>
        <pc:sldMkLst>
          <pc:docMk/>
          <pc:sldMk cId="2812813402" sldId="856"/>
        </pc:sldMkLst>
        <pc:spChg chg="mod">
          <ac:chgData name="Tsujimoto,Mitsuhiro 辻本光宏(関東北甲信越統括支店O領域専門室)" userId="7251bc67-91ee-45c9-97e7-9c240c9b485c" providerId="ADAL" clId="{51945A91-CB03-4A52-98BE-5B2D563FE265}" dt="2021-04-23T05:05:55.072" v="12690" actId="207"/>
          <ac:spMkLst>
            <pc:docMk/>
            <pc:sldMk cId="2812813402" sldId="856"/>
            <ac:spMk id="2" creationId="{956F412C-AFDA-4E98-81C9-25959358138C}"/>
          </ac:spMkLst>
        </pc:spChg>
        <pc:spChg chg="mod">
          <ac:chgData name="Tsujimoto,Mitsuhiro 辻本光宏(関東北甲信越統括支店O領域専門室)" userId="7251bc67-91ee-45c9-97e7-9c240c9b485c" providerId="ADAL" clId="{51945A91-CB03-4A52-98BE-5B2D563FE265}" dt="2021-04-23T01:57:13.390" v="10579"/>
          <ac:spMkLst>
            <pc:docMk/>
            <pc:sldMk cId="2812813402" sldId="856"/>
            <ac:spMk id="5" creationId="{D5ABFF81-73DD-4A9E-9BBD-162138AD45B4}"/>
          </ac:spMkLst>
        </pc:spChg>
        <pc:spChg chg="add del">
          <ac:chgData name="Tsujimoto,Mitsuhiro 辻本光宏(関東北甲信越統括支店O領域専門室)" userId="7251bc67-91ee-45c9-97e7-9c240c9b485c" providerId="ADAL" clId="{51945A91-CB03-4A52-98BE-5B2D563FE265}" dt="2021-04-23T01:56:17.408" v="10457" actId="478"/>
          <ac:spMkLst>
            <pc:docMk/>
            <pc:sldMk cId="2812813402" sldId="856"/>
            <ac:spMk id="7" creationId="{2682EDC0-07D6-4155-980B-FCE83C9701B9}"/>
          </ac:spMkLst>
        </pc:spChg>
        <pc:picChg chg="del">
          <ac:chgData name="Tsujimoto,Mitsuhiro 辻本光宏(関東北甲信越統括支店O領域専門室)" userId="7251bc67-91ee-45c9-97e7-9c240c9b485c" providerId="ADAL" clId="{51945A91-CB03-4A52-98BE-5B2D563FE265}" dt="2021-04-23T01:55:21.067" v="10385" actId="478"/>
          <ac:picMkLst>
            <pc:docMk/>
            <pc:sldMk cId="2812813402" sldId="856"/>
            <ac:picMk id="3" creationId="{B4BD5522-1F1E-45C2-A642-0B5091824BA4}"/>
          </ac:picMkLst>
        </pc:picChg>
        <pc:picChg chg="add mod">
          <ac:chgData name="Tsujimoto,Mitsuhiro 辻本光宏(関東北甲信越統括支店O領域専門室)" userId="7251bc67-91ee-45c9-97e7-9c240c9b485c" providerId="ADAL" clId="{51945A91-CB03-4A52-98BE-5B2D563FE265}" dt="2021-04-23T01:55:47.639" v="10396" actId="1036"/>
          <ac:picMkLst>
            <pc:docMk/>
            <pc:sldMk cId="2812813402" sldId="856"/>
            <ac:picMk id="6" creationId="{EA25AAC2-0CDA-44F5-BF33-614349AB9354}"/>
          </ac:picMkLst>
        </pc:picChg>
      </pc:sldChg>
      <pc:sldChg chg="addSp delSp modSp add">
        <pc:chgData name="Tsujimoto,Mitsuhiro 辻本光宏(関東北甲信越統括支店O領域専門室)" userId="7251bc67-91ee-45c9-97e7-9c240c9b485c" providerId="ADAL" clId="{51945A91-CB03-4A52-98BE-5B2D563FE265}" dt="2021-04-23T02:52:43.036" v="11057" actId="478"/>
        <pc:sldMkLst>
          <pc:docMk/>
          <pc:sldMk cId="2204925454" sldId="857"/>
        </pc:sldMkLst>
        <pc:spChg chg="add mod">
          <ac:chgData name="Tsujimoto,Mitsuhiro 辻本光宏(関東北甲信越統括支店O領域専門室)" userId="7251bc67-91ee-45c9-97e7-9c240c9b485c" providerId="ADAL" clId="{51945A91-CB03-4A52-98BE-5B2D563FE265}" dt="2021-04-23T02:19:08.605" v="10639" actId="20577"/>
          <ac:spMkLst>
            <pc:docMk/>
            <pc:sldMk cId="2204925454" sldId="857"/>
            <ac:spMk id="2" creationId="{92140794-C4AA-4D37-B126-3301752259EB}"/>
          </ac:spMkLst>
        </pc:spChg>
        <pc:spChg chg="add mod">
          <ac:chgData name="Tsujimoto,Mitsuhiro 辻本光宏(関東北甲信越統括支店O領域専門室)" userId="7251bc67-91ee-45c9-97e7-9c240c9b485c" providerId="ADAL" clId="{51945A91-CB03-4A52-98BE-5B2D563FE265}" dt="2021-04-23T02:28:12.489" v="10687" actId="20577"/>
          <ac:spMkLst>
            <pc:docMk/>
            <pc:sldMk cId="2204925454" sldId="857"/>
            <ac:spMk id="5" creationId="{10FCF084-BCC7-4E7A-9FA7-8E449927DC8B}"/>
          </ac:spMkLst>
        </pc:spChg>
        <pc:spChg chg="add mod">
          <ac:chgData name="Tsujimoto,Mitsuhiro 辻本光宏(関東北甲信越統括支店O領域専門室)" userId="7251bc67-91ee-45c9-97e7-9c240c9b485c" providerId="ADAL" clId="{51945A91-CB03-4A52-98BE-5B2D563FE265}" dt="2021-04-23T02:41:51.416" v="10707" actId="20577"/>
          <ac:spMkLst>
            <pc:docMk/>
            <pc:sldMk cId="2204925454" sldId="857"/>
            <ac:spMk id="6" creationId="{E806FE7F-771A-46C4-B3E9-99E74039E939}"/>
          </ac:spMkLst>
        </pc:spChg>
        <pc:spChg chg="add mod">
          <ac:chgData name="Tsujimoto,Mitsuhiro 辻本光宏(関東北甲信越統括支店O領域専門室)" userId="7251bc67-91ee-45c9-97e7-9c240c9b485c" providerId="ADAL" clId="{51945A91-CB03-4A52-98BE-5B2D563FE265}" dt="2021-04-23T02:51:16.634" v="10988" actId="14100"/>
          <ac:spMkLst>
            <pc:docMk/>
            <pc:sldMk cId="2204925454" sldId="857"/>
            <ac:spMk id="7" creationId="{788EB9FE-FD55-4AEF-B887-EAA4AA436C90}"/>
          </ac:spMkLst>
        </pc:spChg>
        <pc:spChg chg="add del mod">
          <ac:chgData name="Tsujimoto,Mitsuhiro 辻本光宏(関東北甲信越統括支店O領域専門室)" userId="7251bc67-91ee-45c9-97e7-9c240c9b485c" providerId="ADAL" clId="{51945A91-CB03-4A52-98BE-5B2D563FE265}" dt="2021-04-23T02:51:20.031" v="10989" actId="478"/>
          <ac:spMkLst>
            <pc:docMk/>
            <pc:sldMk cId="2204925454" sldId="857"/>
            <ac:spMk id="8" creationId="{4592D1E3-F9D4-4665-B432-104CE7678FD8}"/>
          </ac:spMkLst>
        </pc:spChg>
        <pc:spChg chg="add mod">
          <ac:chgData name="Tsujimoto,Mitsuhiro 辻本光宏(関東北甲信越統括支店O領域専門室)" userId="7251bc67-91ee-45c9-97e7-9c240c9b485c" providerId="ADAL" clId="{51945A91-CB03-4A52-98BE-5B2D563FE265}" dt="2021-04-23T02:52:41.307" v="11056" actId="1076"/>
          <ac:spMkLst>
            <pc:docMk/>
            <pc:sldMk cId="2204925454" sldId="857"/>
            <ac:spMk id="10" creationId="{C36E3AB2-3884-4184-88C1-1C581B5FFC83}"/>
          </ac:spMkLst>
        </pc:spChg>
        <pc:picChg chg="add mod">
          <ac:chgData name="Tsujimoto,Mitsuhiro 辻本光宏(関東北甲信越統括支店O領域専門室)" userId="7251bc67-91ee-45c9-97e7-9c240c9b485c" providerId="ADAL" clId="{51945A91-CB03-4A52-98BE-5B2D563FE265}" dt="2021-04-23T02:26:37.755" v="10664" actId="14100"/>
          <ac:picMkLst>
            <pc:docMk/>
            <pc:sldMk cId="2204925454" sldId="857"/>
            <ac:picMk id="3" creationId="{AB05FBCB-5EB6-4F6F-B311-1C7A01775855}"/>
          </ac:picMkLst>
        </pc:picChg>
        <pc:picChg chg="add mod">
          <ac:chgData name="Tsujimoto,Mitsuhiro 辻本光宏(関東北甲信越統括支店O領域専門室)" userId="7251bc67-91ee-45c9-97e7-9c240c9b485c" providerId="ADAL" clId="{51945A91-CB03-4A52-98BE-5B2D563FE265}" dt="2021-04-23T02:26:04.690" v="10662" actId="1076"/>
          <ac:picMkLst>
            <pc:docMk/>
            <pc:sldMk cId="2204925454" sldId="857"/>
            <ac:picMk id="4" creationId="{BC5B6164-11A0-4EDF-AAB9-B82A98C28B73}"/>
          </ac:picMkLst>
        </pc:picChg>
        <pc:picChg chg="add del">
          <ac:chgData name="Tsujimoto,Mitsuhiro 辻本光宏(関東北甲信越統括支店O領域専門室)" userId="7251bc67-91ee-45c9-97e7-9c240c9b485c" providerId="ADAL" clId="{51945A91-CB03-4A52-98BE-5B2D563FE265}" dt="2021-04-23T02:52:43.036" v="11057" actId="478"/>
          <ac:picMkLst>
            <pc:docMk/>
            <pc:sldMk cId="2204925454" sldId="857"/>
            <ac:picMk id="9" creationId="{62DC94CD-C74E-46E1-8766-E95C3D0442D4}"/>
          </ac:picMkLst>
        </pc:picChg>
      </pc:sldChg>
      <pc:sldChg chg="addSp modSp add">
        <pc:chgData name="Tsujimoto,Mitsuhiro 辻本光宏(関東北甲信越統括支店O領域専門室)" userId="7251bc67-91ee-45c9-97e7-9c240c9b485c" providerId="ADAL" clId="{51945A91-CB03-4A52-98BE-5B2D563FE265}" dt="2021-04-23T04:45:07.021" v="11103"/>
        <pc:sldMkLst>
          <pc:docMk/>
          <pc:sldMk cId="3357182412" sldId="858"/>
        </pc:sldMkLst>
        <pc:spChg chg="add mod">
          <ac:chgData name="Tsujimoto,Mitsuhiro 辻本光宏(関東北甲信越統括支店O領域専門室)" userId="7251bc67-91ee-45c9-97e7-9c240c9b485c" providerId="ADAL" clId="{51945A91-CB03-4A52-98BE-5B2D563FE265}" dt="2021-04-23T04:43:39.764" v="11094"/>
          <ac:spMkLst>
            <pc:docMk/>
            <pc:sldMk cId="3357182412" sldId="858"/>
            <ac:spMk id="2" creationId="{C1AD3A09-B16A-4BE2-A9C4-0DA9F2BAA4CA}"/>
          </ac:spMkLst>
        </pc:spChg>
        <pc:spChg chg="add mod">
          <ac:chgData name="Tsujimoto,Mitsuhiro 辻本光宏(関東北甲信越統括支店O領域専門室)" userId="7251bc67-91ee-45c9-97e7-9c240c9b485c" providerId="ADAL" clId="{51945A91-CB03-4A52-98BE-5B2D563FE265}" dt="2021-04-23T04:45:07.021" v="11103"/>
          <ac:spMkLst>
            <pc:docMk/>
            <pc:sldMk cId="3357182412" sldId="858"/>
            <ac:spMk id="3" creationId="{B71138B8-92EA-4816-9088-60A0896C7585}"/>
          </ac:spMkLst>
        </pc:spChg>
        <pc:picChg chg="add mod">
          <ac:chgData name="Tsujimoto,Mitsuhiro 辻本光宏(関東北甲信越統括支店O領域専門室)" userId="7251bc67-91ee-45c9-97e7-9c240c9b485c" providerId="ADAL" clId="{51945A91-CB03-4A52-98BE-5B2D563FE265}" dt="2021-04-23T04:44:38.716" v="11102" actId="1076"/>
          <ac:picMkLst>
            <pc:docMk/>
            <pc:sldMk cId="3357182412" sldId="858"/>
            <ac:picMk id="4" creationId="{9DD80466-3085-4599-9EAC-0C44ECB721D5}"/>
          </ac:picMkLst>
        </pc:picChg>
      </pc:sldChg>
      <pc:sldChg chg="addSp delSp modSp add">
        <pc:chgData name="Tsujimoto,Mitsuhiro 辻本光宏(関東北甲信越統括支店O領域専門室)" userId="7251bc67-91ee-45c9-97e7-9c240c9b485c" providerId="ADAL" clId="{51945A91-CB03-4A52-98BE-5B2D563FE265}" dt="2021-04-23T04:56:45.101" v="11710" actId="20577"/>
        <pc:sldMkLst>
          <pc:docMk/>
          <pc:sldMk cId="585620185" sldId="859"/>
        </pc:sldMkLst>
        <pc:spChg chg="add mod">
          <ac:chgData name="Tsujimoto,Mitsuhiro 辻本光宏(関東北甲信越統括支店O領域専門室)" userId="7251bc67-91ee-45c9-97e7-9c240c9b485c" providerId="ADAL" clId="{51945A91-CB03-4A52-98BE-5B2D563FE265}" dt="2021-04-23T04:56:45.101" v="11710" actId="20577"/>
          <ac:spMkLst>
            <pc:docMk/>
            <pc:sldMk cId="585620185" sldId="859"/>
            <ac:spMk id="2" creationId="{2E3DB969-B2B8-4BA5-A697-299A33D8E545}"/>
          </ac:spMkLst>
        </pc:spChg>
        <pc:spChg chg="add mod">
          <ac:chgData name="Tsujimoto,Mitsuhiro 辻本光宏(関東北甲信越統括支店O領域専門室)" userId="7251bc67-91ee-45c9-97e7-9c240c9b485c" providerId="ADAL" clId="{51945A91-CB03-4A52-98BE-5B2D563FE265}" dt="2021-04-23T04:47:58.993" v="11449"/>
          <ac:spMkLst>
            <pc:docMk/>
            <pc:sldMk cId="585620185" sldId="859"/>
            <ac:spMk id="3" creationId="{CC7D3820-0D11-4825-AD82-EFFABF5E6DF8}"/>
          </ac:spMkLst>
        </pc:spChg>
        <pc:spChg chg="add del">
          <ac:chgData name="Tsujimoto,Mitsuhiro 辻本光宏(関東北甲信越統括支店O領域専門室)" userId="7251bc67-91ee-45c9-97e7-9c240c9b485c" providerId="ADAL" clId="{51945A91-CB03-4A52-98BE-5B2D563FE265}" dt="2021-04-23T04:48:04.106" v="11450" actId="478"/>
          <ac:spMkLst>
            <pc:docMk/>
            <pc:sldMk cId="585620185" sldId="859"/>
            <ac:spMk id="5" creationId="{2E4EEC2E-2F5A-4E5F-992A-32FAB4BB0BE1}"/>
          </ac:spMkLst>
        </pc:spChg>
        <pc:spChg chg="add mod">
          <ac:chgData name="Tsujimoto,Mitsuhiro 辻本光宏(関東北甲信越統括支店O領域専門室)" userId="7251bc67-91ee-45c9-97e7-9c240c9b485c" providerId="ADAL" clId="{51945A91-CB03-4A52-98BE-5B2D563FE265}" dt="2021-04-23T04:48:35.244" v="11465" actId="1076"/>
          <ac:spMkLst>
            <pc:docMk/>
            <pc:sldMk cId="585620185" sldId="859"/>
            <ac:spMk id="6" creationId="{33AD8B18-4868-4EB9-8668-857F7A4C37E4}"/>
          </ac:spMkLst>
        </pc:spChg>
        <pc:picChg chg="add mod">
          <ac:chgData name="Tsujimoto,Mitsuhiro 辻本光宏(関東北甲信越統括支店O領域専門室)" userId="7251bc67-91ee-45c9-97e7-9c240c9b485c" providerId="ADAL" clId="{51945A91-CB03-4A52-98BE-5B2D563FE265}" dt="2021-04-23T04:48:06.991" v="11463" actId="1036"/>
          <ac:picMkLst>
            <pc:docMk/>
            <pc:sldMk cId="585620185" sldId="859"/>
            <ac:picMk id="4" creationId="{7AC4B7E4-76E9-4886-A8C8-6FF04BCBDDE9}"/>
          </ac:picMkLst>
        </pc:picChg>
      </pc:sldChg>
      <pc:sldChg chg="addSp delSp modSp add">
        <pc:chgData name="Tsujimoto,Mitsuhiro 辻本光宏(関東北甲信越統括支店O領域専門室)" userId="7251bc67-91ee-45c9-97e7-9c240c9b485c" providerId="ADAL" clId="{51945A91-CB03-4A52-98BE-5B2D563FE265}" dt="2021-04-23T04:57:51.067" v="11755" actId="20577"/>
        <pc:sldMkLst>
          <pc:docMk/>
          <pc:sldMk cId="606222432" sldId="860"/>
        </pc:sldMkLst>
        <pc:spChg chg="add mod">
          <ac:chgData name="Tsujimoto,Mitsuhiro 辻本光宏(関東北甲信越統括支店O領域専門室)" userId="7251bc67-91ee-45c9-97e7-9c240c9b485c" providerId="ADAL" clId="{51945A91-CB03-4A52-98BE-5B2D563FE265}" dt="2021-04-23T04:56:51.024" v="11715" actId="20577"/>
          <ac:spMkLst>
            <pc:docMk/>
            <pc:sldMk cId="606222432" sldId="860"/>
            <ac:spMk id="2" creationId="{0C82AB8D-726B-4B1D-8F73-94F6CD22BA16}"/>
          </ac:spMkLst>
        </pc:spChg>
        <pc:spChg chg="add mod">
          <ac:chgData name="Tsujimoto,Mitsuhiro 辻本光宏(関東北甲信越統括支店O領域専門室)" userId="7251bc67-91ee-45c9-97e7-9c240c9b485c" providerId="ADAL" clId="{51945A91-CB03-4A52-98BE-5B2D563FE265}" dt="2021-04-23T04:57:51.067" v="11755" actId="20577"/>
          <ac:spMkLst>
            <pc:docMk/>
            <pc:sldMk cId="606222432" sldId="860"/>
            <ac:spMk id="3" creationId="{E7C6069B-9180-4EB4-A411-3225A489D812}"/>
          </ac:spMkLst>
        </pc:spChg>
        <pc:spChg chg="add del">
          <ac:chgData name="Tsujimoto,Mitsuhiro 辻本光宏(関東北甲信越統括支店O領域専門室)" userId="7251bc67-91ee-45c9-97e7-9c240c9b485c" providerId="ADAL" clId="{51945A91-CB03-4A52-98BE-5B2D563FE265}" dt="2021-04-23T04:50:05.570" v="11673" actId="478"/>
          <ac:spMkLst>
            <pc:docMk/>
            <pc:sldMk cId="606222432" sldId="860"/>
            <ac:spMk id="5" creationId="{014D4DCB-16E9-4862-80A2-0338FEC49F0E}"/>
          </ac:spMkLst>
        </pc:spChg>
        <pc:spChg chg="add mod">
          <ac:chgData name="Tsujimoto,Mitsuhiro 辻本光宏(関東北甲信越統括支店O領域専門室)" userId="7251bc67-91ee-45c9-97e7-9c240c9b485c" providerId="ADAL" clId="{51945A91-CB03-4A52-98BE-5B2D563FE265}" dt="2021-04-23T04:50:12.966" v="11675" actId="1076"/>
          <ac:spMkLst>
            <pc:docMk/>
            <pc:sldMk cId="606222432" sldId="860"/>
            <ac:spMk id="6" creationId="{DDDB3904-11AE-4C76-A3C0-4EB670B9395D}"/>
          </ac:spMkLst>
        </pc:spChg>
        <pc:picChg chg="add mod">
          <ac:chgData name="Tsujimoto,Mitsuhiro 辻本光宏(関東北甲信越統括支店O領域専門室)" userId="7251bc67-91ee-45c9-97e7-9c240c9b485c" providerId="ADAL" clId="{51945A91-CB03-4A52-98BE-5B2D563FE265}" dt="2021-04-23T04:48:58.151" v="11471" actId="1076"/>
          <ac:picMkLst>
            <pc:docMk/>
            <pc:sldMk cId="606222432" sldId="860"/>
            <ac:picMk id="4" creationId="{D7DCB84F-437D-42C6-9C07-4CC8D63837F6}"/>
          </ac:picMkLst>
        </pc:picChg>
      </pc:sldChg>
      <pc:sldChg chg="addSp modSp add">
        <pc:chgData name="Tsujimoto,Mitsuhiro 辻本光宏(関東北甲信越統括支店O領域専門室)" userId="7251bc67-91ee-45c9-97e7-9c240c9b485c" providerId="ADAL" clId="{51945A91-CB03-4A52-98BE-5B2D563FE265}" dt="2021-04-23T04:58:40.966" v="11809"/>
        <pc:sldMkLst>
          <pc:docMk/>
          <pc:sldMk cId="1473022299" sldId="861"/>
        </pc:sldMkLst>
        <pc:spChg chg="add mod">
          <ac:chgData name="Tsujimoto,Mitsuhiro 辻本光宏(関東北甲信越統括支店O領域専門室)" userId="7251bc67-91ee-45c9-97e7-9c240c9b485c" providerId="ADAL" clId="{51945A91-CB03-4A52-98BE-5B2D563FE265}" dt="2021-04-23T04:57:08.734" v="11730"/>
          <ac:spMkLst>
            <pc:docMk/>
            <pc:sldMk cId="1473022299" sldId="861"/>
            <ac:spMk id="2" creationId="{D3BBFB07-B042-4658-897E-E9F9AF78C40C}"/>
          </ac:spMkLst>
        </pc:spChg>
        <pc:spChg chg="add mod">
          <ac:chgData name="Tsujimoto,Mitsuhiro 辻本光宏(関東北甲信越統括支店O領域専門室)" userId="7251bc67-91ee-45c9-97e7-9c240c9b485c" providerId="ADAL" clId="{51945A91-CB03-4A52-98BE-5B2D563FE265}" dt="2021-04-23T04:58:40.966" v="11809"/>
          <ac:spMkLst>
            <pc:docMk/>
            <pc:sldMk cId="1473022299" sldId="861"/>
            <ac:spMk id="3" creationId="{2972801A-940E-435D-9C2A-ABEA9E61A7AC}"/>
          </ac:spMkLst>
        </pc:spChg>
        <pc:spChg chg="add">
          <ac:chgData name="Tsujimoto,Mitsuhiro 辻本光宏(関東北甲信越統括支店O領域専門室)" userId="7251bc67-91ee-45c9-97e7-9c240c9b485c" providerId="ADAL" clId="{51945A91-CB03-4A52-98BE-5B2D563FE265}" dt="2021-04-23T04:58:33.393" v="11799"/>
          <ac:spMkLst>
            <pc:docMk/>
            <pc:sldMk cId="1473022299" sldId="861"/>
            <ac:spMk id="6" creationId="{6D6F9B58-081D-403B-AA06-FFAEADBE6C72}"/>
          </ac:spMkLst>
        </pc:spChg>
        <pc:picChg chg="add mod">
          <ac:chgData name="Tsujimoto,Mitsuhiro 辻本光宏(関東北甲信越統括支店O領域専門室)" userId="7251bc67-91ee-45c9-97e7-9c240c9b485c" providerId="ADAL" clId="{51945A91-CB03-4A52-98BE-5B2D563FE265}" dt="2021-04-23T04:57:37.686" v="11736" actId="1076"/>
          <ac:picMkLst>
            <pc:docMk/>
            <pc:sldMk cId="1473022299" sldId="861"/>
            <ac:picMk id="4" creationId="{D8CC5B68-3FCC-4EB4-964A-745887A41C18}"/>
          </ac:picMkLst>
        </pc:picChg>
        <pc:picChg chg="add mod">
          <ac:chgData name="Tsujimoto,Mitsuhiro 辻本光宏(関東北甲信越統括支店O領域専門室)" userId="7251bc67-91ee-45c9-97e7-9c240c9b485c" providerId="ADAL" clId="{51945A91-CB03-4A52-98BE-5B2D563FE265}" dt="2021-04-23T04:57:37.686" v="11736" actId="1076"/>
          <ac:picMkLst>
            <pc:docMk/>
            <pc:sldMk cId="1473022299" sldId="861"/>
            <ac:picMk id="5" creationId="{EAAC1E25-AE82-4A70-8E9A-332E04AABFE6}"/>
          </ac:picMkLst>
        </pc:picChg>
      </pc:sldChg>
      <pc:sldChg chg="addSp delSp modSp add">
        <pc:chgData name="Tsujimoto,Mitsuhiro 辻本光宏(関東北甲信越統括支店O領域専門室)" userId="7251bc67-91ee-45c9-97e7-9c240c9b485c" providerId="ADAL" clId="{51945A91-CB03-4A52-98BE-5B2D563FE265}" dt="2021-04-23T05:06:02.379" v="12692" actId="20577"/>
        <pc:sldMkLst>
          <pc:docMk/>
          <pc:sldMk cId="2844626639" sldId="862"/>
        </pc:sldMkLst>
        <pc:spChg chg="mod">
          <ac:chgData name="Tsujimoto,Mitsuhiro 辻本光宏(関東北甲信越統括支店O領域専門室)" userId="7251bc67-91ee-45c9-97e7-9c240c9b485c" providerId="ADAL" clId="{51945A91-CB03-4A52-98BE-5B2D563FE265}" dt="2021-04-23T05:06:02.379" v="12692" actId="20577"/>
          <ac:spMkLst>
            <pc:docMk/>
            <pc:sldMk cId="2844626639" sldId="862"/>
            <ac:spMk id="2" creationId="{84EF22D3-4978-47AC-8C95-0E01BAE7E78B}"/>
          </ac:spMkLst>
        </pc:spChg>
        <pc:spChg chg="add del mod">
          <ac:chgData name="Tsujimoto,Mitsuhiro 辻本光宏(関東北甲信越統括支店O領域専門室)" userId="7251bc67-91ee-45c9-97e7-9c240c9b485c" providerId="ADAL" clId="{51945A91-CB03-4A52-98BE-5B2D563FE265}" dt="2021-04-23T05:02:54.263" v="12655" actId="478"/>
          <ac:spMkLst>
            <pc:docMk/>
            <pc:sldMk cId="2844626639" sldId="862"/>
            <ac:spMk id="4" creationId="{19F4DF52-9E76-4868-B544-9AB2DE1FA2A6}"/>
          </ac:spMkLst>
        </pc:spChg>
        <pc:spChg chg="mod">
          <ac:chgData name="Tsujimoto,Mitsuhiro 辻本光宏(関東北甲信越統括支店O領域専門室)" userId="7251bc67-91ee-45c9-97e7-9c240c9b485c" providerId="ADAL" clId="{51945A91-CB03-4A52-98BE-5B2D563FE265}" dt="2021-04-23T05:02:51.508" v="12654"/>
          <ac:spMkLst>
            <pc:docMk/>
            <pc:sldMk cId="2844626639" sldId="862"/>
            <ac:spMk id="5" creationId="{52708625-118C-4AF9-A524-AFAD6E7A7550}"/>
          </ac:spMkLst>
        </pc:spChg>
      </pc:sldChg>
      <pc:sldChg chg="addSp delSp modSp add">
        <pc:chgData name="Tsujimoto,Mitsuhiro 辻本光宏(関東北甲信越統括支店O領域専門室)" userId="7251bc67-91ee-45c9-97e7-9c240c9b485c" providerId="ADAL" clId="{51945A91-CB03-4A52-98BE-5B2D563FE265}" dt="2021-04-23T05:12:06.725" v="13614"/>
        <pc:sldMkLst>
          <pc:docMk/>
          <pc:sldMk cId="2644342632" sldId="863"/>
        </pc:sldMkLst>
        <pc:spChg chg="mod">
          <ac:chgData name="Tsujimoto,Mitsuhiro 辻本光宏(関東北甲信越統括支店O領域専門室)" userId="7251bc67-91ee-45c9-97e7-9c240c9b485c" providerId="ADAL" clId="{51945A91-CB03-4A52-98BE-5B2D563FE265}" dt="2021-04-23T05:06:26.183" v="12700"/>
          <ac:spMkLst>
            <pc:docMk/>
            <pc:sldMk cId="2644342632" sldId="863"/>
            <ac:spMk id="2" creationId="{84EF22D3-4978-47AC-8C95-0E01BAE7E78B}"/>
          </ac:spMkLst>
        </pc:spChg>
        <pc:spChg chg="add del mod">
          <ac:chgData name="Tsujimoto,Mitsuhiro 辻本光宏(関東北甲信越統括支店O領域専門室)" userId="7251bc67-91ee-45c9-97e7-9c240c9b485c" providerId="ADAL" clId="{51945A91-CB03-4A52-98BE-5B2D563FE265}" dt="2021-04-23T05:10:04.818" v="13462" actId="478"/>
          <ac:spMkLst>
            <pc:docMk/>
            <pc:sldMk cId="2644342632" sldId="863"/>
            <ac:spMk id="4" creationId="{5EFC9958-47F4-4CB6-B9EB-124C31AF115B}"/>
          </ac:spMkLst>
        </pc:spChg>
        <pc:spChg chg="mod">
          <ac:chgData name="Tsujimoto,Mitsuhiro 辻本光宏(関東北甲信越統括支店O領域専門室)" userId="7251bc67-91ee-45c9-97e7-9c240c9b485c" providerId="ADAL" clId="{51945A91-CB03-4A52-98BE-5B2D563FE265}" dt="2021-04-23T05:12:06.725" v="13614"/>
          <ac:spMkLst>
            <pc:docMk/>
            <pc:sldMk cId="2644342632" sldId="863"/>
            <ac:spMk id="5" creationId="{52708625-118C-4AF9-A524-AFAD6E7A7550}"/>
          </ac:spMkLst>
        </pc:spChg>
      </pc:sldChg>
      <pc:sldChg chg="modSp add ord">
        <pc:chgData name="Tsujimoto,Mitsuhiro 辻本光宏(関東北甲信越統括支店O領域専門室)" userId="7251bc67-91ee-45c9-97e7-9c240c9b485c" providerId="ADAL" clId="{51945A91-CB03-4A52-98BE-5B2D563FE265}" dt="2021-04-23T05:14:53.963" v="13618" actId="207"/>
        <pc:sldMkLst>
          <pc:docMk/>
          <pc:sldMk cId="697539685" sldId="864"/>
        </pc:sldMkLst>
        <pc:spChg chg="mod">
          <ac:chgData name="Tsujimoto,Mitsuhiro 辻本光宏(関東北甲信越統括支店O領域専門室)" userId="7251bc67-91ee-45c9-97e7-9c240c9b485c" providerId="ADAL" clId="{51945A91-CB03-4A52-98BE-5B2D563FE265}" dt="2021-04-23T05:14:53.963" v="13618" actId="207"/>
          <ac:spMkLst>
            <pc:docMk/>
            <pc:sldMk cId="697539685" sldId="864"/>
            <ac:spMk id="3" creationId="{F40FF731-017A-4AE1-9261-D60D79D216C2}"/>
          </ac:spMkLst>
        </pc:spChg>
      </pc:sldChg>
      <pc:sldChg chg="modSp add">
        <pc:chgData name="Tsujimoto,Mitsuhiro 辻本光宏(関東北甲信越統括支店O領域専門室)" userId="7251bc67-91ee-45c9-97e7-9c240c9b485c" providerId="ADAL" clId="{51945A91-CB03-4A52-98BE-5B2D563FE265}" dt="2021-04-23T05:20:43.821" v="13622" actId="207"/>
        <pc:sldMkLst>
          <pc:docMk/>
          <pc:sldMk cId="578943679" sldId="865"/>
        </pc:sldMkLst>
        <pc:spChg chg="mod">
          <ac:chgData name="Tsujimoto,Mitsuhiro 辻本光宏(関東北甲信越統括支店O領域専門室)" userId="7251bc67-91ee-45c9-97e7-9c240c9b485c" providerId="ADAL" clId="{51945A91-CB03-4A52-98BE-5B2D563FE265}" dt="2021-04-23T05:20:43.821" v="13622" actId="207"/>
          <ac:spMkLst>
            <pc:docMk/>
            <pc:sldMk cId="578943679" sldId="865"/>
            <ac:spMk id="3" creationId="{F40FF731-017A-4AE1-9261-D60D79D216C2}"/>
          </ac:spMkLst>
        </pc:spChg>
      </pc:sldChg>
      <pc:sldMasterChg chg="modSldLayout">
        <pc:chgData name="Tsujimoto,Mitsuhiro 辻本光宏(関東北甲信越統括支店O領域専門室)" userId="7251bc67-91ee-45c9-97e7-9c240c9b485c" providerId="ADAL" clId="{51945A91-CB03-4A52-98BE-5B2D563FE265}" dt="2021-04-21T11:26:09.604" v="2353" actId="207"/>
        <pc:sldMasterMkLst>
          <pc:docMk/>
          <pc:sldMasterMk cId="2653139781" sldId="2147483648"/>
        </pc:sldMasterMkLst>
        <pc:sldLayoutChg chg="delSp modSp">
          <pc:chgData name="Tsujimoto,Mitsuhiro 辻本光宏(関東北甲信越統括支店O領域専門室)" userId="7251bc67-91ee-45c9-97e7-9c240c9b485c" providerId="ADAL" clId="{51945A91-CB03-4A52-98BE-5B2D563FE265}" dt="2021-04-21T11:26:09.604" v="2353" actId="207"/>
          <pc:sldLayoutMkLst>
            <pc:docMk/>
            <pc:sldMasterMk cId="2653139781" sldId="2147483648"/>
            <pc:sldLayoutMk cId="3408255873" sldId="2147483674"/>
          </pc:sldLayoutMkLst>
          <pc:spChg chg="mod">
            <ac:chgData name="Tsujimoto,Mitsuhiro 辻本光宏(関東北甲信越統括支店O領域専門室)" userId="7251bc67-91ee-45c9-97e7-9c240c9b485c" providerId="ADAL" clId="{51945A91-CB03-4A52-98BE-5B2D563FE265}" dt="2021-04-21T11:26:09.604" v="2353" actId="207"/>
            <ac:spMkLst>
              <pc:docMk/>
              <pc:sldMasterMk cId="2653139781" sldId="2147483648"/>
              <pc:sldLayoutMk cId="3408255873" sldId="2147483674"/>
              <ac:spMk id="2" creationId="{D01EC866-3094-E04E-B88A-C6F6CDA0BF8D}"/>
            </ac:spMkLst>
          </pc:spChg>
          <pc:spChg chg="del mod">
            <ac:chgData name="Tsujimoto,Mitsuhiro 辻本光宏(関東北甲信越統括支店O領域専門室)" userId="7251bc67-91ee-45c9-97e7-9c240c9b485c" providerId="ADAL" clId="{51945A91-CB03-4A52-98BE-5B2D563FE265}" dt="2021-04-21T11:25:13.501" v="2318" actId="478"/>
            <ac:spMkLst>
              <pc:docMk/>
              <pc:sldMasterMk cId="2653139781" sldId="2147483648"/>
              <pc:sldLayoutMk cId="3408255873" sldId="2147483674"/>
              <ac:spMk id="6" creationId="{BACE5B28-DE6F-624F-A161-2D53FF2EF7ED}"/>
            </ac:spMkLst>
          </pc:spChg>
        </pc:sldLayoutChg>
      </pc:sldMasterChg>
      <pc:sldMasterChg chg="modSldLayout">
        <pc:chgData name="Tsujimoto,Mitsuhiro 辻本光宏(関東北甲信越統括支店O領域専門室)" userId="7251bc67-91ee-45c9-97e7-9c240c9b485c" providerId="ADAL" clId="{51945A91-CB03-4A52-98BE-5B2D563FE265}" dt="2021-04-21T11:28:36.145" v="2383" actId="207"/>
        <pc:sldMasterMkLst>
          <pc:docMk/>
          <pc:sldMasterMk cId="3507685230" sldId="2147483660"/>
        </pc:sldMasterMkLst>
        <pc:sldLayoutChg chg="modSp">
          <pc:chgData name="Tsujimoto,Mitsuhiro 辻本光宏(関東北甲信越統括支店O領域専門室)" userId="7251bc67-91ee-45c9-97e7-9c240c9b485c" providerId="ADAL" clId="{51945A91-CB03-4A52-98BE-5B2D563FE265}" dt="2021-04-21T11:20:25.467" v="2168" actId="14100"/>
          <pc:sldLayoutMkLst>
            <pc:docMk/>
            <pc:sldMasterMk cId="3507685230" sldId="2147483660"/>
            <pc:sldLayoutMk cId="478164877" sldId="2147483668"/>
          </pc:sldLayoutMkLst>
          <pc:picChg chg="mod">
            <ac:chgData name="Tsujimoto,Mitsuhiro 辻本光宏(関東北甲信越統括支店O領域専門室)" userId="7251bc67-91ee-45c9-97e7-9c240c9b485c" providerId="ADAL" clId="{51945A91-CB03-4A52-98BE-5B2D563FE265}" dt="2021-04-21T11:20:25.467" v="2168" actId="14100"/>
            <ac:picMkLst>
              <pc:docMk/>
              <pc:sldMasterMk cId="3507685230" sldId="2147483660"/>
              <pc:sldLayoutMk cId="478164877" sldId="2147483668"/>
              <ac:picMk id="3" creationId="{948A8249-9F9E-1547-9615-5B0D4BAFF41A}"/>
            </ac:picMkLst>
          </pc:picChg>
        </pc:sldLayoutChg>
        <pc:sldLayoutChg chg="delSp modSp">
          <pc:chgData name="Tsujimoto,Mitsuhiro 辻本光宏(関東北甲信越統括支店O領域専門室)" userId="7251bc67-91ee-45c9-97e7-9c240c9b485c" providerId="ADAL" clId="{51945A91-CB03-4A52-98BE-5B2D563FE265}" dt="2021-04-21T11:28:36.145" v="2383" actId="207"/>
          <pc:sldLayoutMkLst>
            <pc:docMk/>
            <pc:sldMasterMk cId="3507685230" sldId="2147483660"/>
            <pc:sldLayoutMk cId="3921961601" sldId="2147483669"/>
          </pc:sldLayoutMkLst>
          <pc:spChg chg="mod">
            <ac:chgData name="Tsujimoto,Mitsuhiro 辻本光宏(関東北甲信越統括支店O領域専門室)" userId="7251bc67-91ee-45c9-97e7-9c240c9b485c" providerId="ADAL" clId="{51945A91-CB03-4A52-98BE-5B2D563FE265}" dt="2021-04-21T11:28:36.145" v="2383" actId="207"/>
            <ac:spMkLst>
              <pc:docMk/>
              <pc:sldMasterMk cId="3507685230" sldId="2147483660"/>
              <pc:sldLayoutMk cId="3921961601" sldId="2147483669"/>
              <ac:spMk id="2" creationId="{D01EC866-3094-E04E-B88A-C6F6CDA0BF8D}"/>
            </ac:spMkLst>
          </pc:spChg>
          <pc:spChg chg="del">
            <ac:chgData name="Tsujimoto,Mitsuhiro 辻本光宏(関東北甲信越統括支店O領域専門室)" userId="7251bc67-91ee-45c9-97e7-9c240c9b485c" providerId="ADAL" clId="{51945A91-CB03-4A52-98BE-5B2D563FE265}" dt="2021-04-21T11:27:25.162" v="2359" actId="478"/>
            <ac:spMkLst>
              <pc:docMk/>
              <pc:sldMasterMk cId="3507685230" sldId="2147483660"/>
              <pc:sldLayoutMk cId="3921961601" sldId="2147483669"/>
              <ac:spMk id="6" creationId="{BACE5B28-DE6F-624F-A161-2D53FF2EF7ED}"/>
            </ac:spMkLst>
          </pc:spChg>
        </pc:sldLayoutChg>
      </pc:sldMasterChg>
    </pc:docChg>
  </pc:docChgLst>
  <pc:docChgLst>
    <pc:chgData name="Tsujimoto,Mitsuhiro 辻本光宏(関東北甲信越統括支店O領域専門室)" userId="7251bc67-91ee-45c9-97e7-9c240c9b485c" providerId="ADAL" clId="{D2FA0D63-E142-485F-8085-CA3863DE4895}"/>
    <pc:docChg chg="modSld sldOrd">
      <pc:chgData name="Tsujimoto,Mitsuhiro 辻本光宏(関東北甲信越統括支店O領域専門室)" userId="7251bc67-91ee-45c9-97e7-9c240c9b485c" providerId="ADAL" clId="{D2FA0D63-E142-485F-8085-CA3863DE4895}" dt="2021-03-25T01:29:58.374" v="1"/>
      <pc:docMkLst>
        <pc:docMk/>
      </pc:docMkLst>
      <pc:sldChg chg="ord">
        <pc:chgData name="Tsujimoto,Mitsuhiro 辻本光宏(関東北甲信越統括支店O領域専門室)" userId="7251bc67-91ee-45c9-97e7-9c240c9b485c" providerId="ADAL" clId="{D2FA0D63-E142-485F-8085-CA3863DE4895}" dt="2021-03-25T01:29:58.374" v="1"/>
        <pc:sldMkLst>
          <pc:docMk/>
          <pc:sldMk cId="3225905895" sldId="765"/>
        </pc:sldMkLst>
      </pc:sldChg>
    </pc:docChg>
  </pc:docChgLst>
  <pc:docChgLst>
    <pc:chgData name="Tsujimoto,Mitsuhiro 辻本光宏(関東北甲信越統括支店O領域専門室)" userId="7251bc67-91ee-45c9-97e7-9c240c9b485c" providerId="ADAL" clId="{68999E39-5F09-4CF3-B26F-BF167E85A326}"/>
    <pc:docChg chg="undo redo custSel addSld delSld modSld sldOrd delMainMaster">
      <pc:chgData name="Tsujimoto,Mitsuhiro 辻本光宏(関東北甲信越統括支店O領域専門室)" userId="7251bc67-91ee-45c9-97e7-9c240c9b485c" providerId="ADAL" clId="{68999E39-5F09-4CF3-B26F-BF167E85A326}" dt="2021-04-23T07:40:37.666" v="2392" actId="2696"/>
      <pc:docMkLst>
        <pc:docMk/>
      </pc:docMkLst>
      <pc:sldChg chg="del">
        <pc:chgData name="Tsujimoto,Mitsuhiro 辻本光宏(関東北甲信越統括支店O領域専門室)" userId="7251bc67-91ee-45c9-97e7-9c240c9b485c" providerId="ADAL" clId="{68999E39-5F09-4CF3-B26F-BF167E85A326}" dt="2021-04-23T07:40:37.412" v="2339" actId="2696"/>
        <pc:sldMkLst>
          <pc:docMk/>
          <pc:sldMk cId="0" sldId="257"/>
        </pc:sldMkLst>
      </pc:sldChg>
      <pc:sldChg chg="del">
        <pc:chgData name="Tsujimoto,Mitsuhiro 辻本光宏(関東北甲信越統括支店O領域専門室)" userId="7251bc67-91ee-45c9-97e7-9c240c9b485c" providerId="ADAL" clId="{68999E39-5F09-4CF3-B26F-BF167E85A326}" dt="2021-04-23T07:40:37.421" v="2340" actId="2696"/>
        <pc:sldMkLst>
          <pc:docMk/>
          <pc:sldMk cId="0" sldId="258"/>
        </pc:sldMkLst>
      </pc:sldChg>
      <pc:sldChg chg="del">
        <pc:chgData name="Tsujimoto,Mitsuhiro 辻本光宏(関東北甲信越統括支店O領域専門室)" userId="7251bc67-91ee-45c9-97e7-9c240c9b485c" providerId="ADAL" clId="{68999E39-5F09-4CF3-B26F-BF167E85A326}" dt="2021-04-23T05:29:22.198" v="0" actId="2696"/>
        <pc:sldMkLst>
          <pc:docMk/>
          <pc:sldMk cId="191682260" sldId="260"/>
        </pc:sldMkLst>
      </pc:sldChg>
      <pc:sldChg chg="del">
        <pc:chgData name="Tsujimoto,Mitsuhiro 辻本光宏(関東北甲信越統括支店O領域専門室)" userId="7251bc67-91ee-45c9-97e7-9c240c9b485c" providerId="ADAL" clId="{68999E39-5F09-4CF3-B26F-BF167E85A326}" dt="2021-04-23T05:29:23.269" v="1" actId="2696"/>
        <pc:sldMkLst>
          <pc:docMk/>
          <pc:sldMk cId="2202648414" sldId="261"/>
        </pc:sldMkLst>
      </pc:sldChg>
      <pc:sldChg chg="del">
        <pc:chgData name="Tsujimoto,Mitsuhiro 辻本光宏(関東北甲信越統括支店O領域専門室)" userId="7251bc67-91ee-45c9-97e7-9c240c9b485c" providerId="ADAL" clId="{68999E39-5F09-4CF3-B26F-BF167E85A326}" dt="2021-04-23T05:29:31.198" v="9" actId="2696"/>
        <pc:sldMkLst>
          <pc:docMk/>
          <pc:sldMk cId="1305757310" sldId="262"/>
        </pc:sldMkLst>
      </pc:sldChg>
      <pc:sldChg chg="del">
        <pc:chgData name="Tsujimoto,Mitsuhiro 辻本光宏(関東北甲信越統括支店O領域専門室)" userId="7251bc67-91ee-45c9-97e7-9c240c9b485c" providerId="ADAL" clId="{68999E39-5F09-4CF3-B26F-BF167E85A326}" dt="2021-04-23T07:40:37.447" v="2345" actId="2696"/>
        <pc:sldMkLst>
          <pc:docMk/>
          <pc:sldMk cId="0" sldId="263"/>
        </pc:sldMkLst>
      </pc:sldChg>
      <pc:sldChg chg="del">
        <pc:chgData name="Tsujimoto,Mitsuhiro 辻本光宏(関東北甲信越統括支店O領域専門室)" userId="7251bc67-91ee-45c9-97e7-9c240c9b485c" providerId="ADAL" clId="{68999E39-5F09-4CF3-B26F-BF167E85A326}" dt="2021-04-23T07:40:37.455" v="2346" actId="2696"/>
        <pc:sldMkLst>
          <pc:docMk/>
          <pc:sldMk cId="0" sldId="264"/>
        </pc:sldMkLst>
      </pc:sldChg>
      <pc:sldChg chg="del">
        <pc:chgData name="Tsujimoto,Mitsuhiro 辻本光宏(関東北甲信越統括支店O領域専門室)" userId="7251bc67-91ee-45c9-97e7-9c240c9b485c" providerId="ADAL" clId="{68999E39-5F09-4CF3-B26F-BF167E85A326}" dt="2021-04-23T07:40:37.460" v="2347" actId="2696"/>
        <pc:sldMkLst>
          <pc:docMk/>
          <pc:sldMk cId="0" sldId="265"/>
        </pc:sldMkLst>
      </pc:sldChg>
      <pc:sldChg chg="del">
        <pc:chgData name="Tsujimoto,Mitsuhiro 辻本光宏(関東北甲信越統括支店O領域専門室)" userId="7251bc67-91ee-45c9-97e7-9c240c9b485c" providerId="ADAL" clId="{68999E39-5F09-4CF3-B26F-BF167E85A326}" dt="2021-04-23T07:40:37.467" v="2348" actId="2696"/>
        <pc:sldMkLst>
          <pc:docMk/>
          <pc:sldMk cId="0" sldId="266"/>
        </pc:sldMkLst>
      </pc:sldChg>
      <pc:sldChg chg="del">
        <pc:chgData name="Tsujimoto,Mitsuhiro 辻本光宏(関東北甲信越統括支店O領域専門室)" userId="7251bc67-91ee-45c9-97e7-9c240c9b485c" providerId="ADAL" clId="{68999E39-5F09-4CF3-B26F-BF167E85A326}" dt="2021-04-23T07:40:37.473" v="2349" actId="2696"/>
        <pc:sldMkLst>
          <pc:docMk/>
          <pc:sldMk cId="0" sldId="267"/>
        </pc:sldMkLst>
      </pc:sldChg>
      <pc:sldChg chg="del">
        <pc:chgData name="Tsujimoto,Mitsuhiro 辻本光宏(関東北甲信越統括支店O領域専門室)" userId="7251bc67-91ee-45c9-97e7-9c240c9b485c" providerId="ADAL" clId="{68999E39-5F09-4CF3-B26F-BF167E85A326}" dt="2021-04-23T07:40:37.478" v="2350" actId="2696"/>
        <pc:sldMkLst>
          <pc:docMk/>
          <pc:sldMk cId="0" sldId="268"/>
        </pc:sldMkLst>
      </pc:sldChg>
      <pc:sldChg chg="del">
        <pc:chgData name="Tsujimoto,Mitsuhiro 辻本光宏(関東北甲信越統括支店O領域専門室)" userId="7251bc67-91ee-45c9-97e7-9c240c9b485c" providerId="ADAL" clId="{68999E39-5F09-4CF3-B26F-BF167E85A326}" dt="2021-04-23T07:40:37.488" v="2351" actId="2696"/>
        <pc:sldMkLst>
          <pc:docMk/>
          <pc:sldMk cId="0" sldId="269"/>
        </pc:sldMkLst>
      </pc:sldChg>
      <pc:sldChg chg="del">
        <pc:chgData name="Tsujimoto,Mitsuhiro 辻本光宏(関東北甲信越統括支店O領域専門室)" userId="7251bc67-91ee-45c9-97e7-9c240c9b485c" providerId="ADAL" clId="{68999E39-5F09-4CF3-B26F-BF167E85A326}" dt="2021-04-23T07:40:37.492" v="2352" actId="2696"/>
        <pc:sldMkLst>
          <pc:docMk/>
          <pc:sldMk cId="0" sldId="270"/>
        </pc:sldMkLst>
      </pc:sldChg>
      <pc:sldChg chg="del">
        <pc:chgData name="Tsujimoto,Mitsuhiro 辻本光宏(関東北甲信越統括支店O領域専門室)" userId="7251bc67-91ee-45c9-97e7-9c240c9b485c" providerId="ADAL" clId="{68999E39-5F09-4CF3-B26F-BF167E85A326}" dt="2021-04-23T07:40:37.497" v="2353" actId="2696"/>
        <pc:sldMkLst>
          <pc:docMk/>
          <pc:sldMk cId="0" sldId="271"/>
        </pc:sldMkLst>
      </pc:sldChg>
      <pc:sldChg chg="del">
        <pc:chgData name="Tsujimoto,Mitsuhiro 辻本光宏(関東北甲信越統括支店O領域専門室)" userId="7251bc67-91ee-45c9-97e7-9c240c9b485c" providerId="ADAL" clId="{68999E39-5F09-4CF3-B26F-BF167E85A326}" dt="2021-04-23T07:40:37.505" v="2354" actId="2696"/>
        <pc:sldMkLst>
          <pc:docMk/>
          <pc:sldMk cId="0" sldId="272"/>
        </pc:sldMkLst>
      </pc:sldChg>
      <pc:sldChg chg="del">
        <pc:chgData name="Tsujimoto,Mitsuhiro 辻本光宏(関東北甲信越統括支店O領域専門室)" userId="7251bc67-91ee-45c9-97e7-9c240c9b485c" providerId="ADAL" clId="{68999E39-5F09-4CF3-B26F-BF167E85A326}" dt="2021-04-23T07:40:37.510" v="2355" actId="2696"/>
        <pc:sldMkLst>
          <pc:docMk/>
          <pc:sldMk cId="0" sldId="273"/>
        </pc:sldMkLst>
      </pc:sldChg>
      <pc:sldChg chg="del">
        <pc:chgData name="Tsujimoto,Mitsuhiro 辻本光宏(関東北甲信越統括支店O領域専門室)" userId="7251bc67-91ee-45c9-97e7-9c240c9b485c" providerId="ADAL" clId="{68999E39-5F09-4CF3-B26F-BF167E85A326}" dt="2021-04-23T07:40:37.516" v="2356" actId="2696"/>
        <pc:sldMkLst>
          <pc:docMk/>
          <pc:sldMk cId="0" sldId="274"/>
        </pc:sldMkLst>
      </pc:sldChg>
      <pc:sldChg chg="del">
        <pc:chgData name="Tsujimoto,Mitsuhiro 辻本光宏(関東北甲信越統括支店O領域専門室)" userId="7251bc67-91ee-45c9-97e7-9c240c9b485c" providerId="ADAL" clId="{68999E39-5F09-4CF3-B26F-BF167E85A326}" dt="2021-04-23T07:40:37.523" v="2357" actId="2696"/>
        <pc:sldMkLst>
          <pc:docMk/>
          <pc:sldMk cId="0" sldId="275"/>
        </pc:sldMkLst>
      </pc:sldChg>
      <pc:sldChg chg="del">
        <pc:chgData name="Tsujimoto,Mitsuhiro 辻本光宏(関東北甲信越統括支店O領域専門室)" userId="7251bc67-91ee-45c9-97e7-9c240c9b485c" providerId="ADAL" clId="{68999E39-5F09-4CF3-B26F-BF167E85A326}" dt="2021-04-23T07:40:37.528" v="2358" actId="2696"/>
        <pc:sldMkLst>
          <pc:docMk/>
          <pc:sldMk cId="0" sldId="276"/>
        </pc:sldMkLst>
      </pc:sldChg>
      <pc:sldChg chg="del">
        <pc:chgData name="Tsujimoto,Mitsuhiro 辻本光宏(関東北甲信越統括支店O領域専門室)" userId="7251bc67-91ee-45c9-97e7-9c240c9b485c" providerId="ADAL" clId="{68999E39-5F09-4CF3-B26F-BF167E85A326}" dt="2021-04-23T07:40:37.642" v="2379" actId="2696"/>
        <pc:sldMkLst>
          <pc:docMk/>
          <pc:sldMk cId="0" sldId="277"/>
        </pc:sldMkLst>
      </pc:sldChg>
      <pc:sldChg chg="del">
        <pc:chgData name="Tsujimoto,Mitsuhiro 辻本光宏(関東北甲信越統括支店O領域専門室)" userId="7251bc67-91ee-45c9-97e7-9c240c9b485c" providerId="ADAL" clId="{68999E39-5F09-4CF3-B26F-BF167E85A326}" dt="2021-04-23T07:40:37.647" v="2380" actId="2696"/>
        <pc:sldMkLst>
          <pc:docMk/>
          <pc:sldMk cId="0" sldId="278"/>
        </pc:sldMkLst>
      </pc:sldChg>
      <pc:sldChg chg="del ord">
        <pc:chgData name="Tsujimoto,Mitsuhiro 辻本光宏(関東北甲信越統括支店O領域専門室)" userId="7251bc67-91ee-45c9-97e7-9c240c9b485c" providerId="ADAL" clId="{68999E39-5F09-4CF3-B26F-BF167E85A326}" dt="2021-04-23T06:02:52.149" v="993" actId="2696"/>
        <pc:sldMkLst>
          <pc:docMk/>
          <pc:sldMk cId="1863242651" sldId="425"/>
        </pc:sldMkLst>
      </pc:sldChg>
      <pc:sldChg chg="del ord">
        <pc:chgData name="Tsujimoto,Mitsuhiro 辻本光宏(関東北甲信越統括支店O領域専門室)" userId="7251bc67-91ee-45c9-97e7-9c240c9b485c" providerId="ADAL" clId="{68999E39-5F09-4CF3-B26F-BF167E85A326}" dt="2021-04-23T06:02:52.164" v="994" actId="2696"/>
        <pc:sldMkLst>
          <pc:docMk/>
          <pc:sldMk cId="1494573563" sldId="426"/>
        </pc:sldMkLst>
      </pc:sldChg>
      <pc:sldChg chg="del">
        <pc:chgData name="Tsujimoto,Mitsuhiro 辻本光宏(関東北甲信越統括支店O領域専門室)" userId="7251bc67-91ee-45c9-97e7-9c240c9b485c" providerId="ADAL" clId="{68999E39-5F09-4CF3-B26F-BF167E85A326}" dt="2021-04-23T05:29:40.055" v="15" actId="2696"/>
        <pc:sldMkLst>
          <pc:docMk/>
          <pc:sldMk cId="1517966943" sldId="482"/>
        </pc:sldMkLst>
      </pc:sldChg>
      <pc:sldChg chg="del">
        <pc:chgData name="Tsujimoto,Mitsuhiro 辻本光宏(関東北甲信越統括支店O領域専門室)" userId="7251bc67-91ee-45c9-97e7-9c240c9b485c" providerId="ADAL" clId="{68999E39-5F09-4CF3-B26F-BF167E85A326}" dt="2021-04-23T05:29:41.575" v="21" actId="2696"/>
        <pc:sldMkLst>
          <pc:docMk/>
          <pc:sldMk cId="3419947428" sldId="496"/>
        </pc:sldMkLst>
      </pc:sldChg>
      <pc:sldChg chg="del">
        <pc:chgData name="Tsujimoto,Mitsuhiro 辻本光宏(関東北甲信越統括支店O領域専門室)" userId="7251bc67-91ee-45c9-97e7-9c240c9b485c" providerId="ADAL" clId="{68999E39-5F09-4CF3-B26F-BF167E85A326}" dt="2021-04-23T05:29:41.803" v="22" actId="2696"/>
        <pc:sldMkLst>
          <pc:docMk/>
          <pc:sldMk cId="1258701999" sldId="499"/>
        </pc:sldMkLst>
      </pc:sldChg>
      <pc:sldChg chg="del ord">
        <pc:chgData name="Tsujimoto,Mitsuhiro 辻本光宏(関東北甲信越統括支店O領域専門室)" userId="7251bc67-91ee-45c9-97e7-9c240c9b485c" providerId="ADAL" clId="{68999E39-5F09-4CF3-B26F-BF167E85A326}" dt="2021-04-23T06:02:52.196" v="995" actId="2696"/>
        <pc:sldMkLst>
          <pc:docMk/>
          <pc:sldMk cId="2829303396" sldId="506"/>
        </pc:sldMkLst>
      </pc:sldChg>
      <pc:sldChg chg="del ord">
        <pc:chgData name="Tsujimoto,Mitsuhiro 辻本光宏(関東北甲信越統括支店O領域専門室)" userId="7251bc67-91ee-45c9-97e7-9c240c9b485c" providerId="ADAL" clId="{68999E39-5F09-4CF3-B26F-BF167E85A326}" dt="2021-04-23T06:02:52.218" v="996" actId="2696"/>
        <pc:sldMkLst>
          <pc:docMk/>
          <pc:sldMk cId="2364786394" sldId="508"/>
        </pc:sldMkLst>
      </pc:sldChg>
      <pc:sldChg chg="del">
        <pc:chgData name="Tsujimoto,Mitsuhiro 辻本光宏(関東北甲信越統括支店O領域専門室)" userId="7251bc67-91ee-45c9-97e7-9c240c9b485c" providerId="ADAL" clId="{68999E39-5F09-4CF3-B26F-BF167E85A326}" dt="2021-04-23T05:29:40.487" v="17" actId="2696"/>
        <pc:sldMkLst>
          <pc:docMk/>
          <pc:sldMk cId="638742736" sldId="515"/>
        </pc:sldMkLst>
      </pc:sldChg>
      <pc:sldChg chg="del">
        <pc:chgData name="Tsujimoto,Mitsuhiro 辻本光宏(関東北甲信越統括支店O領域専門室)" userId="7251bc67-91ee-45c9-97e7-9c240c9b485c" providerId="ADAL" clId="{68999E39-5F09-4CF3-B26F-BF167E85A326}" dt="2021-04-23T05:29:41.976" v="23" actId="2696"/>
        <pc:sldMkLst>
          <pc:docMk/>
          <pc:sldMk cId="534499861" sldId="517"/>
        </pc:sldMkLst>
      </pc:sldChg>
      <pc:sldChg chg="del ord">
        <pc:chgData name="Tsujimoto,Mitsuhiro 辻本光宏(関東北甲信越統括支店O領域専門室)" userId="7251bc67-91ee-45c9-97e7-9c240c9b485c" providerId="ADAL" clId="{68999E39-5F09-4CF3-B26F-BF167E85A326}" dt="2021-04-23T06:02:52.233" v="997" actId="2696"/>
        <pc:sldMkLst>
          <pc:docMk/>
          <pc:sldMk cId="1113571812" sldId="545"/>
        </pc:sldMkLst>
      </pc:sldChg>
      <pc:sldChg chg="del">
        <pc:chgData name="Tsujimoto,Mitsuhiro 辻本光宏(関東北甲信越統括支店O領域専門室)" userId="7251bc67-91ee-45c9-97e7-9c240c9b485c" providerId="ADAL" clId="{68999E39-5F09-4CF3-B26F-BF167E85A326}" dt="2021-04-23T05:29:40.903" v="19" actId="2696"/>
        <pc:sldMkLst>
          <pc:docMk/>
          <pc:sldMk cId="3515282738" sldId="547"/>
        </pc:sldMkLst>
      </pc:sldChg>
      <pc:sldChg chg="del">
        <pc:chgData name="Tsujimoto,Mitsuhiro 辻本光宏(関東北甲信越統括支店O領域専門室)" userId="7251bc67-91ee-45c9-97e7-9c240c9b485c" providerId="ADAL" clId="{68999E39-5F09-4CF3-B26F-BF167E85A326}" dt="2021-04-23T05:29:24.172" v="2" actId="2696"/>
        <pc:sldMkLst>
          <pc:docMk/>
          <pc:sldMk cId="580328257" sldId="575"/>
        </pc:sldMkLst>
      </pc:sldChg>
      <pc:sldChg chg="del">
        <pc:chgData name="Tsujimoto,Mitsuhiro 辻本光宏(関東北甲信越統括支店O領域専門室)" userId="7251bc67-91ee-45c9-97e7-9c240c9b485c" providerId="ADAL" clId="{68999E39-5F09-4CF3-B26F-BF167E85A326}" dt="2021-04-23T05:29:24.886" v="3" actId="2696"/>
        <pc:sldMkLst>
          <pc:docMk/>
          <pc:sldMk cId="1300297693" sldId="706"/>
        </pc:sldMkLst>
      </pc:sldChg>
      <pc:sldChg chg="del">
        <pc:chgData name="Tsujimoto,Mitsuhiro 辻本光宏(関東北甲信越統括支店O領域専門室)" userId="7251bc67-91ee-45c9-97e7-9c240c9b485c" providerId="ADAL" clId="{68999E39-5F09-4CF3-B26F-BF167E85A326}" dt="2021-04-23T05:29:30.196" v="8" actId="2696"/>
        <pc:sldMkLst>
          <pc:docMk/>
          <pc:sldMk cId="3932018953" sldId="720"/>
        </pc:sldMkLst>
      </pc:sldChg>
      <pc:sldChg chg="del">
        <pc:chgData name="Tsujimoto,Mitsuhiro 辻本光宏(関東北甲信越統括支店O領域専門室)" userId="7251bc67-91ee-45c9-97e7-9c240c9b485c" providerId="ADAL" clId="{68999E39-5F09-4CF3-B26F-BF167E85A326}" dt="2021-04-23T05:29:25.663" v="4" actId="2696"/>
        <pc:sldMkLst>
          <pc:docMk/>
          <pc:sldMk cId="2819914708" sldId="721"/>
        </pc:sldMkLst>
      </pc:sldChg>
      <pc:sldChg chg="del">
        <pc:chgData name="Tsujimoto,Mitsuhiro 辻本光宏(関東北甲信越統括支店O領域専門室)" userId="7251bc67-91ee-45c9-97e7-9c240c9b485c" providerId="ADAL" clId="{68999E39-5F09-4CF3-B26F-BF167E85A326}" dt="2021-04-23T05:29:27.215" v="5" actId="2696"/>
        <pc:sldMkLst>
          <pc:docMk/>
          <pc:sldMk cId="749637405" sldId="722"/>
        </pc:sldMkLst>
      </pc:sldChg>
      <pc:sldChg chg="del">
        <pc:chgData name="Tsujimoto,Mitsuhiro 辻本光宏(関東北甲信越統括支店O領域専門室)" userId="7251bc67-91ee-45c9-97e7-9c240c9b485c" providerId="ADAL" clId="{68999E39-5F09-4CF3-B26F-BF167E85A326}" dt="2021-04-23T05:29:28.710" v="6" actId="2696"/>
        <pc:sldMkLst>
          <pc:docMk/>
          <pc:sldMk cId="1018968927" sldId="723"/>
        </pc:sldMkLst>
      </pc:sldChg>
      <pc:sldChg chg="del">
        <pc:chgData name="Tsujimoto,Mitsuhiro 辻本光宏(関東北甲信越統括支店O領域専門室)" userId="7251bc67-91ee-45c9-97e7-9c240c9b485c" providerId="ADAL" clId="{68999E39-5F09-4CF3-B26F-BF167E85A326}" dt="2021-04-23T05:29:33.647" v="10" actId="2696"/>
        <pc:sldMkLst>
          <pc:docMk/>
          <pc:sldMk cId="65352219" sldId="724"/>
        </pc:sldMkLst>
      </pc:sldChg>
      <pc:sldChg chg="del">
        <pc:chgData name="Tsujimoto,Mitsuhiro 辻本光宏(関東北甲信越統括支店O領域専門室)" userId="7251bc67-91ee-45c9-97e7-9c240c9b485c" providerId="ADAL" clId="{68999E39-5F09-4CF3-B26F-BF167E85A326}" dt="2021-04-23T05:29:29.446" v="7" actId="2696"/>
        <pc:sldMkLst>
          <pc:docMk/>
          <pc:sldMk cId="3302547705" sldId="725"/>
        </pc:sldMkLst>
      </pc:sldChg>
      <pc:sldChg chg="del">
        <pc:chgData name="Tsujimoto,Mitsuhiro 辻本光宏(関東北甲信越統括支店O領域専門室)" userId="7251bc67-91ee-45c9-97e7-9c240c9b485c" providerId="ADAL" clId="{68999E39-5F09-4CF3-B26F-BF167E85A326}" dt="2021-04-23T05:29:34.363" v="11" actId="2696"/>
        <pc:sldMkLst>
          <pc:docMk/>
          <pc:sldMk cId="2095141452" sldId="726"/>
        </pc:sldMkLst>
      </pc:sldChg>
      <pc:sldChg chg="del">
        <pc:chgData name="Tsujimoto,Mitsuhiro 辻本光宏(関東北甲信越統括支店O領域専門室)" userId="7251bc67-91ee-45c9-97e7-9c240c9b485c" providerId="ADAL" clId="{68999E39-5F09-4CF3-B26F-BF167E85A326}" dt="2021-04-23T05:29:35.066" v="12" actId="2696"/>
        <pc:sldMkLst>
          <pc:docMk/>
          <pc:sldMk cId="2656621879" sldId="727"/>
        </pc:sldMkLst>
      </pc:sldChg>
      <pc:sldChg chg="del">
        <pc:chgData name="Tsujimoto,Mitsuhiro 辻本光宏(関東北甲信越統括支店O領域専門室)" userId="7251bc67-91ee-45c9-97e7-9c240c9b485c" providerId="ADAL" clId="{68999E39-5F09-4CF3-B26F-BF167E85A326}" dt="2021-04-23T05:29:36.178" v="13" actId="2696"/>
        <pc:sldMkLst>
          <pc:docMk/>
          <pc:sldMk cId="198448236" sldId="728"/>
        </pc:sldMkLst>
      </pc:sldChg>
      <pc:sldChg chg="del">
        <pc:chgData name="Tsujimoto,Mitsuhiro 辻本光宏(関東北甲信越統括支店O領域専門室)" userId="7251bc67-91ee-45c9-97e7-9c240c9b485c" providerId="ADAL" clId="{68999E39-5F09-4CF3-B26F-BF167E85A326}" dt="2021-04-23T05:29:39.754" v="14" actId="2696"/>
        <pc:sldMkLst>
          <pc:docMk/>
          <pc:sldMk cId="1950371920" sldId="730"/>
        </pc:sldMkLst>
      </pc:sldChg>
      <pc:sldChg chg="del">
        <pc:chgData name="Tsujimoto,Mitsuhiro 辻本光宏(関東北甲信越統括支店O領域専門室)" userId="7251bc67-91ee-45c9-97e7-9c240c9b485c" providerId="ADAL" clId="{68999E39-5F09-4CF3-B26F-BF167E85A326}" dt="2021-04-23T05:29:40.656" v="18" actId="2696"/>
        <pc:sldMkLst>
          <pc:docMk/>
          <pc:sldMk cId="2436949669" sldId="731"/>
        </pc:sldMkLst>
      </pc:sldChg>
      <pc:sldChg chg="del">
        <pc:chgData name="Tsujimoto,Mitsuhiro 辻本光宏(関東北甲信越統括支店O領域専門室)" userId="7251bc67-91ee-45c9-97e7-9c240c9b485c" providerId="ADAL" clId="{68999E39-5F09-4CF3-B26F-BF167E85A326}" dt="2021-04-23T05:29:40.233" v="16" actId="2696"/>
        <pc:sldMkLst>
          <pc:docMk/>
          <pc:sldMk cId="907648045" sldId="732"/>
        </pc:sldMkLst>
      </pc:sldChg>
      <pc:sldChg chg="addSp delSp modSp del">
        <pc:chgData name="Tsujimoto,Mitsuhiro 辻本光宏(関東北甲信越統括支店O領域専門室)" userId="7251bc67-91ee-45c9-97e7-9c240c9b485c" providerId="ADAL" clId="{68999E39-5F09-4CF3-B26F-BF167E85A326}" dt="2021-04-23T06:02:52.118" v="992" actId="2696"/>
        <pc:sldMkLst>
          <pc:docMk/>
          <pc:sldMk cId="764256623" sldId="733"/>
        </pc:sldMkLst>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7" creationId="{38CBFBD8-2945-4AB1-BFDC-DB64ACA6E541}"/>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10" creationId="{A480821F-BD5E-4CC8-AC6A-BE213BF16058}"/>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15" creationId="{49D7D03F-7B00-4A07-840A-7D892A018751}"/>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17" creationId="{4FA13595-4C61-487F-B1A4-8CFE946623C7}"/>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18" creationId="{35808FDC-A725-4D2A-9B8F-14510084CDD0}"/>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19" creationId="{27A5AAF5-5F6A-47BB-8759-36DAFADA45F8}"/>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20" creationId="{8C91EB55-9910-492F-9BB6-CA8C40BB08F3}"/>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21" creationId="{66B00335-AF10-42E4-B930-09EADE3725A3}"/>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22" creationId="{61525833-3454-449F-A56F-046FDCF708E7}"/>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23" creationId="{21CEE284-02E0-4DA9-AF35-E3F9C4BBBDA4}"/>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24" creationId="{665220E9-EAF0-436E-A5FD-2029A7098971}"/>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25" creationId="{82472E77-53FB-4577-A88F-D6F47DD65D3C}"/>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30" creationId="{DDCD4D12-58D5-4AF1-9F5A-6D5FB68DDA28}"/>
          </ac:spMkLst>
        </pc:spChg>
        <pc:spChg chg="add del">
          <ac:chgData name="Tsujimoto,Mitsuhiro 辻本光宏(関東北甲信越統括支店O領域専門室)" userId="7251bc67-91ee-45c9-97e7-9c240c9b485c" providerId="ADAL" clId="{68999E39-5F09-4CF3-B26F-BF167E85A326}" dt="2021-04-23T05:35:08.845" v="58"/>
          <ac:spMkLst>
            <pc:docMk/>
            <pc:sldMk cId="764256623" sldId="733"/>
            <ac:spMk id="33" creationId="{48B8F19F-E062-4AC6-A4CB-B33A3D8B9D3F}"/>
          </ac:spMkLst>
        </pc:spChg>
        <pc:picChg chg="add del mod">
          <ac:chgData name="Tsujimoto,Mitsuhiro 辻本光宏(関東北甲信越統括支店O領域専門室)" userId="7251bc67-91ee-45c9-97e7-9c240c9b485c" providerId="ADAL" clId="{68999E39-5F09-4CF3-B26F-BF167E85A326}" dt="2021-04-23T05:35:30.120" v="66" actId="478"/>
          <ac:picMkLst>
            <pc:docMk/>
            <pc:sldMk cId="764256623" sldId="733"/>
            <ac:picMk id="3" creationId="{22975119-9A67-423B-81EB-1F03E1A0FEFC}"/>
          </ac:picMkLst>
        </pc:picChg>
        <pc:picChg chg="add del">
          <ac:chgData name="Tsujimoto,Mitsuhiro 辻本光宏(関東北甲信越統括支店O領域専門室)" userId="7251bc67-91ee-45c9-97e7-9c240c9b485c" providerId="ADAL" clId="{68999E39-5F09-4CF3-B26F-BF167E85A326}" dt="2021-04-23T05:35:26.007" v="64" actId="478"/>
          <ac:picMkLst>
            <pc:docMk/>
            <pc:sldMk cId="764256623" sldId="733"/>
            <ac:picMk id="8" creationId="{3280D612-4D6D-4F66-A280-4D1253E18475}"/>
          </ac:picMkLst>
        </pc:pic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12" creationId="{DACB7163-8B46-4745-B720-5F6CEA43FFAA}"/>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14" creationId="{BD7F6195-D774-4432-938A-A210C6735A2D}"/>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16" creationId="{62EAB4D1-5DE3-422B-8A9F-33195E27D003}"/>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26" creationId="{4B065D4E-1087-46C7-8347-0B27322159D9}"/>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27" creationId="{93A67DCC-ED53-40A7-B381-E60F11FE0CE3}"/>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28" creationId="{18CDC8E8-BA26-48E3-8D60-556E1317042C}"/>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29" creationId="{7D47C032-DF5F-4F99-A3A9-561D6DA68DE3}"/>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31" creationId="{9E495D2F-21AE-4998-950A-33A9AB1D86C8}"/>
          </ac:cxnSpMkLst>
        </pc:cxnChg>
        <pc:cxnChg chg="add del">
          <ac:chgData name="Tsujimoto,Mitsuhiro 辻本光宏(関東北甲信越統括支店O領域専門室)" userId="7251bc67-91ee-45c9-97e7-9c240c9b485c" providerId="ADAL" clId="{68999E39-5F09-4CF3-B26F-BF167E85A326}" dt="2021-04-23T05:35:08.845" v="58"/>
          <ac:cxnSpMkLst>
            <pc:docMk/>
            <pc:sldMk cId="764256623" sldId="733"/>
            <ac:cxnSpMk id="32" creationId="{D929839F-F082-4FE9-866F-89043730BA6B}"/>
          </ac:cxnSpMkLst>
        </pc:cxnChg>
      </pc:sldChg>
      <pc:sldChg chg="del">
        <pc:chgData name="Tsujimoto,Mitsuhiro 辻本光宏(関東北甲信越統括支店O領域専門室)" userId="7251bc67-91ee-45c9-97e7-9c240c9b485c" providerId="ADAL" clId="{68999E39-5F09-4CF3-B26F-BF167E85A326}" dt="2021-04-23T05:29:41.188" v="20" actId="2696"/>
        <pc:sldMkLst>
          <pc:docMk/>
          <pc:sldMk cId="2933760934" sldId="734"/>
        </pc:sldMkLst>
      </pc:sldChg>
      <pc:sldChg chg="del">
        <pc:chgData name="Tsujimoto,Mitsuhiro 辻本光宏(関東北甲信越統括支店O領域専門室)" userId="7251bc67-91ee-45c9-97e7-9c240c9b485c" providerId="ADAL" clId="{68999E39-5F09-4CF3-B26F-BF167E85A326}" dt="2021-04-23T05:29:42.439" v="24" actId="2696"/>
        <pc:sldMkLst>
          <pc:docMk/>
          <pc:sldMk cId="353131866" sldId="735"/>
        </pc:sldMkLst>
      </pc:sldChg>
      <pc:sldChg chg="del">
        <pc:chgData name="Tsujimoto,Mitsuhiro 辻本光宏(関東北甲信越統括支店O領域専門室)" userId="7251bc67-91ee-45c9-97e7-9c240c9b485c" providerId="ADAL" clId="{68999E39-5F09-4CF3-B26F-BF167E85A326}" dt="2021-04-23T05:29:46.449" v="33" actId="2696"/>
        <pc:sldMkLst>
          <pc:docMk/>
          <pc:sldMk cId="340176688" sldId="737"/>
        </pc:sldMkLst>
      </pc:sldChg>
      <pc:sldChg chg="add del">
        <pc:chgData name="Tsujimoto,Mitsuhiro 辻本光宏(関東北甲信越統括支店O領域専門室)" userId="7251bc67-91ee-45c9-97e7-9c240c9b485c" providerId="ADAL" clId="{68999E39-5F09-4CF3-B26F-BF167E85A326}" dt="2021-04-23T05:30:10.970" v="51" actId="2696"/>
        <pc:sldMkLst>
          <pc:docMk/>
          <pc:sldMk cId="3927227179" sldId="739"/>
        </pc:sldMkLst>
      </pc:sldChg>
      <pc:sldChg chg="del">
        <pc:chgData name="Tsujimoto,Mitsuhiro 辻本光宏(関東北甲信越統括支店O領域専門室)" userId="7251bc67-91ee-45c9-97e7-9c240c9b485c" providerId="ADAL" clId="{68999E39-5F09-4CF3-B26F-BF167E85A326}" dt="2021-04-23T05:29:45.640" v="31" actId="2696"/>
        <pc:sldMkLst>
          <pc:docMk/>
          <pc:sldMk cId="2578003335" sldId="740"/>
        </pc:sldMkLst>
      </pc:sldChg>
      <pc:sldChg chg="del ord">
        <pc:chgData name="Tsujimoto,Mitsuhiro 辻本光宏(関東北甲信越統括支店O領域専門室)" userId="7251bc67-91ee-45c9-97e7-9c240c9b485c" providerId="ADAL" clId="{68999E39-5F09-4CF3-B26F-BF167E85A326}" dt="2021-04-23T06:02:52.233" v="998" actId="2696"/>
        <pc:sldMkLst>
          <pc:docMk/>
          <pc:sldMk cId="102786464" sldId="741"/>
        </pc:sldMkLst>
      </pc:sldChg>
      <pc:sldChg chg="del">
        <pc:chgData name="Tsujimoto,Mitsuhiro 辻本光宏(関東北甲信越統括支店O領域専門室)" userId="7251bc67-91ee-45c9-97e7-9c240c9b485c" providerId="ADAL" clId="{68999E39-5F09-4CF3-B26F-BF167E85A326}" dt="2021-04-23T05:29:43.010" v="25" actId="2696"/>
        <pc:sldMkLst>
          <pc:docMk/>
          <pc:sldMk cId="2465407958" sldId="742"/>
        </pc:sldMkLst>
      </pc:sldChg>
      <pc:sldChg chg="del">
        <pc:chgData name="Tsujimoto,Mitsuhiro 辻本光宏(関東北甲信越統括支店O領域専門室)" userId="7251bc67-91ee-45c9-97e7-9c240c9b485c" providerId="ADAL" clId="{68999E39-5F09-4CF3-B26F-BF167E85A326}" dt="2021-04-23T05:29:43.900" v="26" actId="2696"/>
        <pc:sldMkLst>
          <pc:docMk/>
          <pc:sldMk cId="2161092833" sldId="743"/>
        </pc:sldMkLst>
      </pc:sldChg>
      <pc:sldChg chg="del">
        <pc:chgData name="Tsujimoto,Mitsuhiro 辻本光宏(関東北甲信越統括支店O領域専門室)" userId="7251bc67-91ee-45c9-97e7-9c240c9b485c" providerId="ADAL" clId="{68999E39-5F09-4CF3-B26F-BF167E85A326}" dt="2021-04-23T05:29:44.773" v="29" actId="2696"/>
        <pc:sldMkLst>
          <pc:docMk/>
          <pc:sldMk cId="245556784" sldId="744"/>
        </pc:sldMkLst>
      </pc:sldChg>
      <pc:sldChg chg="del">
        <pc:chgData name="Tsujimoto,Mitsuhiro 辻本光宏(関東北甲信越統括支店O領域専門室)" userId="7251bc67-91ee-45c9-97e7-9c240c9b485c" providerId="ADAL" clId="{68999E39-5F09-4CF3-B26F-BF167E85A326}" dt="2021-04-23T05:29:44.054" v="27" actId="2696"/>
        <pc:sldMkLst>
          <pc:docMk/>
          <pc:sldMk cId="3020918798" sldId="745"/>
        </pc:sldMkLst>
      </pc:sldChg>
      <pc:sldChg chg="del">
        <pc:chgData name="Tsujimoto,Mitsuhiro 辻本光宏(関東北甲信越統括支店O領域専門室)" userId="7251bc67-91ee-45c9-97e7-9c240c9b485c" providerId="ADAL" clId="{68999E39-5F09-4CF3-B26F-BF167E85A326}" dt="2021-04-23T05:29:44.967" v="30" actId="2696"/>
        <pc:sldMkLst>
          <pc:docMk/>
          <pc:sldMk cId="865941680" sldId="746"/>
        </pc:sldMkLst>
      </pc:sldChg>
      <pc:sldChg chg="del">
        <pc:chgData name="Tsujimoto,Mitsuhiro 辻本光宏(関東北甲信越統括支店O領域専門室)" userId="7251bc67-91ee-45c9-97e7-9c240c9b485c" providerId="ADAL" clId="{68999E39-5F09-4CF3-B26F-BF167E85A326}" dt="2021-04-23T05:29:45.983" v="32" actId="2696"/>
        <pc:sldMkLst>
          <pc:docMk/>
          <pc:sldMk cId="171546614" sldId="747"/>
        </pc:sldMkLst>
      </pc:sldChg>
      <pc:sldChg chg="del">
        <pc:chgData name="Tsujimoto,Mitsuhiro 辻本光宏(関東北甲信越統括支店O領域専門室)" userId="7251bc67-91ee-45c9-97e7-9c240c9b485c" providerId="ADAL" clId="{68999E39-5F09-4CF3-B26F-BF167E85A326}" dt="2021-04-23T05:29:44.217" v="28" actId="2696"/>
        <pc:sldMkLst>
          <pc:docMk/>
          <pc:sldMk cId="3413417989" sldId="748"/>
        </pc:sldMkLst>
      </pc:sldChg>
      <pc:sldChg chg="del">
        <pc:chgData name="Tsujimoto,Mitsuhiro 辻本光宏(関東北甲信越統括支店O領域専門室)" userId="7251bc67-91ee-45c9-97e7-9c240c9b485c" providerId="ADAL" clId="{68999E39-5F09-4CF3-B26F-BF167E85A326}" dt="2021-04-23T05:29:47.050" v="34" actId="2696"/>
        <pc:sldMkLst>
          <pc:docMk/>
          <pc:sldMk cId="3197050925" sldId="749"/>
        </pc:sldMkLst>
      </pc:sldChg>
      <pc:sldChg chg="del">
        <pc:chgData name="Tsujimoto,Mitsuhiro 辻本光宏(関東北甲信越統括支店O領域専門室)" userId="7251bc67-91ee-45c9-97e7-9c240c9b485c" providerId="ADAL" clId="{68999E39-5F09-4CF3-B26F-BF167E85A326}" dt="2021-04-23T05:30:11.137" v="52" actId="2696"/>
        <pc:sldMkLst>
          <pc:docMk/>
          <pc:sldMk cId="2900227885" sldId="750"/>
        </pc:sldMkLst>
      </pc:sldChg>
      <pc:sldChg chg="del">
        <pc:chgData name="Tsujimoto,Mitsuhiro 辻本光宏(関東北甲信越統括支店O領域専門室)" userId="7251bc67-91ee-45c9-97e7-9c240c9b485c" providerId="ADAL" clId="{68999E39-5F09-4CF3-B26F-BF167E85A326}" dt="2021-04-23T05:30:11.776" v="53" actId="2696"/>
        <pc:sldMkLst>
          <pc:docMk/>
          <pc:sldMk cId="618097399" sldId="751"/>
        </pc:sldMkLst>
      </pc:sldChg>
      <pc:sldChg chg="del ord">
        <pc:chgData name="Tsujimoto,Mitsuhiro 辻本光宏(関東北甲信越統括支店O領域専門室)" userId="7251bc67-91ee-45c9-97e7-9c240c9b485c" providerId="ADAL" clId="{68999E39-5F09-4CF3-B26F-BF167E85A326}" dt="2021-04-23T06:34:08.165" v="2275" actId="2696"/>
        <pc:sldMkLst>
          <pc:docMk/>
          <pc:sldMk cId="973602215" sldId="752"/>
        </pc:sldMkLst>
      </pc:sldChg>
      <pc:sldChg chg="modSp add del ord">
        <pc:chgData name="Tsujimoto,Mitsuhiro 辻本光宏(関東北甲信越統括支店O領域専門室)" userId="7251bc67-91ee-45c9-97e7-9c240c9b485c" providerId="ADAL" clId="{68999E39-5F09-4CF3-B26F-BF167E85A326}" dt="2021-04-23T06:34:50.625" v="2296" actId="2696"/>
        <pc:sldMkLst>
          <pc:docMk/>
          <pc:sldMk cId="1284347402" sldId="753"/>
        </pc:sldMkLst>
        <pc:picChg chg="mod modCrop">
          <ac:chgData name="Tsujimoto,Mitsuhiro 辻本光宏(関東北甲信越統括支店O領域専門室)" userId="7251bc67-91ee-45c9-97e7-9c240c9b485c" providerId="ADAL" clId="{68999E39-5F09-4CF3-B26F-BF167E85A326}" dt="2021-04-23T06:25:04.016" v="1715" actId="732"/>
          <ac:picMkLst>
            <pc:docMk/>
            <pc:sldMk cId="1284347402" sldId="753"/>
            <ac:picMk id="6" creationId="{5E5BE1F9-1EA9-4CAA-BD37-5435102DC8C5}"/>
          </ac:picMkLst>
        </pc:picChg>
        <pc:picChg chg="mod modCrop">
          <ac:chgData name="Tsujimoto,Mitsuhiro 辻本光宏(関東北甲信越統括支店O領域専門室)" userId="7251bc67-91ee-45c9-97e7-9c240c9b485c" providerId="ADAL" clId="{68999E39-5F09-4CF3-B26F-BF167E85A326}" dt="2021-04-23T06:24:52.970" v="1712" actId="732"/>
          <ac:picMkLst>
            <pc:docMk/>
            <pc:sldMk cId="1284347402" sldId="753"/>
            <ac:picMk id="7" creationId="{5BD593E8-D459-4574-A61C-3E3DC3FAF19B}"/>
          </ac:picMkLst>
        </pc:picChg>
        <pc:picChg chg="mod modCrop">
          <ac:chgData name="Tsujimoto,Mitsuhiro 辻本光宏(関東北甲信越統括支店O領域専門室)" userId="7251bc67-91ee-45c9-97e7-9c240c9b485c" providerId="ADAL" clId="{68999E39-5F09-4CF3-B26F-BF167E85A326}" dt="2021-04-23T06:25:04.536" v="1716" actId="732"/>
          <ac:picMkLst>
            <pc:docMk/>
            <pc:sldMk cId="1284347402" sldId="753"/>
            <ac:picMk id="8" creationId="{D96BF282-BBA9-4FBE-BC7D-5DECA6183E7A}"/>
          </ac:picMkLst>
        </pc:picChg>
      </pc:sldChg>
      <pc:sldChg chg="del ord">
        <pc:chgData name="Tsujimoto,Mitsuhiro 辻本光宏(関東北甲信越統括支店O領域専門室)" userId="7251bc67-91ee-45c9-97e7-9c240c9b485c" providerId="ADAL" clId="{68999E39-5F09-4CF3-B26F-BF167E85A326}" dt="2021-04-23T06:34:06.232" v="2273" actId="2696"/>
        <pc:sldMkLst>
          <pc:docMk/>
          <pc:sldMk cId="356113396" sldId="754"/>
        </pc:sldMkLst>
      </pc:sldChg>
      <pc:sldChg chg="del ord">
        <pc:chgData name="Tsujimoto,Mitsuhiro 辻本光宏(関東北甲信越統括支店O領域専門室)" userId="7251bc67-91ee-45c9-97e7-9c240c9b485c" providerId="ADAL" clId="{68999E39-5F09-4CF3-B26F-BF167E85A326}" dt="2021-04-23T06:34:06.369" v="2274" actId="2696"/>
        <pc:sldMkLst>
          <pc:docMk/>
          <pc:sldMk cId="198655893" sldId="755"/>
        </pc:sldMkLst>
      </pc:sldChg>
      <pc:sldChg chg="del">
        <pc:chgData name="Tsujimoto,Mitsuhiro 辻本光宏(関東北甲信越統括支店O領域専門室)" userId="7251bc67-91ee-45c9-97e7-9c240c9b485c" providerId="ADAL" clId="{68999E39-5F09-4CF3-B26F-BF167E85A326}" dt="2021-04-23T05:29:52.254" v="35" actId="2696"/>
        <pc:sldMkLst>
          <pc:docMk/>
          <pc:sldMk cId="872188564" sldId="766"/>
        </pc:sldMkLst>
      </pc:sldChg>
      <pc:sldChg chg="del">
        <pc:chgData name="Tsujimoto,Mitsuhiro 辻本光宏(関東北甲信越統括支店O領域専門室)" userId="7251bc67-91ee-45c9-97e7-9c240c9b485c" providerId="ADAL" clId="{68999E39-5F09-4CF3-B26F-BF167E85A326}" dt="2021-04-23T05:29:52.677" v="36" actId="2696"/>
        <pc:sldMkLst>
          <pc:docMk/>
          <pc:sldMk cId="1046730939" sldId="768"/>
        </pc:sldMkLst>
      </pc:sldChg>
      <pc:sldChg chg="del">
        <pc:chgData name="Tsujimoto,Mitsuhiro 辻本光宏(関東北甲信越統括支店O領域専門室)" userId="7251bc67-91ee-45c9-97e7-9c240c9b485c" providerId="ADAL" clId="{68999E39-5F09-4CF3-B26F-BF167E85A326}" dt="2021-04-23T05:29:53.341" v="37" actId="2696"/>
        <pc:sldMkLst>
          <pc:docMk/>
          <pc:sldMk cId="542936682" sldId="769"/>
        </pc:sldMkLst>
      </pc:sldChg>
      <pc:sldChg chg="del">
        <pc:chgData name="Tsujimoto,Mitsuhiro 辻本光宏(関東北甲信越統括支店O領域専門室)" userId="7251bc67-91ee-45c9-97e7-9c240c9b485c" providerId="ADAL" clId="{68999E39-5F09-4CF3-B26F-BF167E85A326}" dt="2021-04-23T05:29:59.807" v="41" actId="2696"/>
        <pc:sldMkLst>
          <pc:docMk/>
          <pc:sldMk cId="3144679568" sldId="770"/>
        </pc:sldMkLst>
      </pc:sldChg>
      <pc:sldChg chg="del">
        <pc:chgData name="Tsujimoto,Mitsuhiro 辻本光宏(関東北甲信越統括支店O領域専門室)" userId="7251bc67-91ee-45c9-97e7-9c240c9b485c" providerId="ADAL" clId="{68999E39-5F09-4CF3-B26F-BF167E85A326}" dt="2021-04-23T05:30:00.564" v="44" actId="2696"/>
        <pc:sldMkLst>
          <pc:docMk/>
          <pc:sldMk cId="2724684597" sldId="771"/>
        </pc:sldMkLst>
      </pc:sldChg>
      <pc:sldChg chg="del">
        <pc:chgData name="Tsujimoto,Mitsuhiro 辻本光宏(関東北甲信越統括支店O領域専門室)" userId="7251bc67-91ee-45c9-97e7-9c240c9b485c" providerId="ADAL" clId="{68999E39-5F09-4CF3-B26F-BF167E85A326}" dt="2021-04-23T05:30:00.948" v="45" actId="2696"/>
        <pc:sldMkLst>
          <pc:docMk/>
          <pc:sldMk cId="3523293569" sldId="772"/>
        </pc:sldMkLst>
      </pc:sldChg>
      <pc:sldChg chg="del">
        <pc:chgData name="Tsujimoto,Mitsuhiro 辻本光宏(関東北甲信越統括支店O領域専門室)" userId="7251bc67-91ee-45c9-97e7-9c240c9b485c" providerId="ADAL" clId="{68999E39-5F09-4CF3-B26F-BF167E85A326}" dt="2021-04-23T05:30:02.267" v="47" actId="2696"/>
        <pc:sldMkLst>
          <pc:docMk/>
          <pc:sldMk cId="2984594396" sldId="773"/>
        </pc:sldMkLst>
      </pc:sldChg>
      <pc:sldChg chg="del">
        <pc:chgData name="Tsujimoto,Mitsuhiro 辻本光宏(関東北甲信越統括支店O領域専門室)" userId="7251bc67-91ee-45c9-97e7-9c240c9b485c" providerId="ADAL" clId="{68999E39-5F09-4CF3-B26F-BF167E85A326}" dt="2021-04-23T05:30:00.109" v="42" actId="2696"/>
        <pc:sldMkLst>
          <pc:docMk/>
          <pc:sldMk cId="736248774" sldId="774"/>
        </pc:sldMkLst>
      </pc:sldChg>
      <pc:sldChg chg="del">
        <pc:chgData name="Tsujimoto,Mitsuhiro 辻本光宏(関東北甲信越統括支店O領域専門室)" userId="7251bc67-91ee-45c9-97e7-9c240c9b485c" providerId="ADAL" clId="{68999E39-5F09-4CF3-B26F-BF167E85A326}" dt="2021-04-23T05:30:00.346" v="43" actId="2696"/>
        <pc:sldMkLst>
          <pc:docMk/>
          <pc:sldMk cId="3521530438" sldId="775"/>
        </pc:sldMkLst>
      </pc:sldChg>
      <pc:sldChg chg="del">
        <pc:chgData name="Tsujimoto,Mitsuhiro 辻本光宏(関東北甲信越統括支店O領域専門室)" userId="7251bc67-91ee-45c9-97e7-9c240c9b485c" providerId="ADAL" clId="{68999E39-5F09-4CF3-B26F-BF167E85A326}" dt="2021-04-23T05:30:02.970" v="48" actId="2696"/>
        <pc:sldMkLst>
          <pc:docMk/>
          <pc:sldMk cId="3153821987" sldId="776"/>
        </pc:sldMkLst>
      </pc:sldChg>
      <pc:sldChg chg="del">
        <pc:chgData name="Tsujimoto,Mitsuhiro 辻本光宏(関東北甲信越統括支店O領域専門室)" userId="7251bc67-91ee-45c9-97e7-9c240c9b485c" providerId="ADAL" clId="{68999E39-5F09-4CF3-B26F-BF167E85A326}" dt="2021-04-23T05:29:55.295" v="38" actId="2696"/>
        <pc:sldMkLst>
          <pc:docMk/>
          <pc:sldMk cId="518700404" sldId="784"/>
        </pc:sldMkLst>
      </pc:sldChg>
      <pc:sldChg chg="del">
        <pc:chgData name="Tsujimoto,Mitsuhiro 辻本光宏(関東北甲信越統括支店O領域専門室)" userId="7251bc67-91ee-45c9-97e7-9c240c9b485c" providerId="ADAL" clId="{68999E39-5F09-4CF3-B26F-BF167E85A326}" dt="2021-04-23T05:29:56.362" v="39" actId="2696"/>
        <pc:sldMkLst>
          <pc:docMk/>
          <pc:sldMk cId="350877147" sldId="785"/>
        </pc:sldMkLst>
      </pc:sldChg>
      <pc:sldChg chg="del">
        <pc:chgData name="Tsujimoto,Mitsuhiro 辻本光宏(関東北甲信越統括支店O領域専門室)" userId="7251bc67-91ee-45c9-97e7-9c240c9b485c" providerId="ADAL" clId="{68999E39-5F09-4CF3-B26F-BF167E85A326}" dt="2021-04-23T05:29:57.398" v="40" actId="2696"/>
        <pc:sldMkLst>
          <pc:docMk/>
          <pc:sldMk cId="3715807874" sldId="786"/>
        </pc:sldMkLst>
      </pc:sldChg>
      <pc:sldChg chg="del">
        <pc:chgData name="Tsujimoto,Mitsuhiro 辻本光宏(関東北甲信越統括支店O領域専門室)" userId="7251bc67-91ee-45c9-97e7-9c240c9b485c" providerId="ADAL" clId="{68999E39-5F09-4CF3-B26F-BF167E85A326}" dt="2021-04-23T05:30:01.685" v="46" actId="2696"/>
        <pc:sldMkLst>
          <pc:docMk/>
          <pc:sldMk cId="1885713338" sldId="787"/>
        </pc:sldMkLst>
      </pc:sldChg>
      <pc:sldChg chg="del">
        <pc:chgData name="Tsujimoto,Mitsuhiro 辻本光宏(関東北甲信越統括支店O領域専門室)" userId="7251bc67-91ee-45c9-97e7-9c240c9b485c" providerId="ADAL" clId="{68999E39-5F09-4CF3-B26F-BF167E85A326}" dt="2021-04-23T07:40:37.425" v="2341" actId="2696"/>
        <pc:sldMkLst>
          <pc:docMk/>
          <pc:sldMk cId="2564999324" sldId="814"/>
        </pc:sldMkLst>
      </pc:sldChg>
      <pc:sldChg chg="del">
        <pc:chgData name="Tsujimoto,Mitsuhiro 辻本光宏(関東北甲信越統括支店O領域専門室)" userId="7251bc67-91ee-45c9-97e7-9c240c9b485c" providerId="ADAL" clId="{68999E39-5F09-4CF3-B26F-BF167E85A326}" dt="2021-04-23T07:40:37.431" v="2342" actId="2696"/>
        <pc:sldMkLst>
          <pc:docMk/>
          <pc:sldMk cId="3604182268" sldId="815"/>
        </pc:sldMkLst>
      </pc:sldChg>
      <pc:sldChg chg="del">
        <pc:chgData name="Tsujimoto,Mitsuhiro 辻本光宏(関東北甲信越統括支店O領域専門室)" userId="7251bc67-91ee-45c9-97e7-9c240c9b485c" providerId="ADAL" clId="{68999E39-5F09-4CF3-B26F-BF167E85A326}" dt="2021-04-23T07:40:37.436" v="2343" actId="2696"/>
        <pc:sldMkLst>
          <pc:docMk/>
          <pc:sldMk cId="657269597" sldId="816"/>
        </pc:sldMkLst>
      </pc:sldChg>
      <pc:sldChg chg="del">
        <pc:chgData name="Tsujimoto,Mitsuhiro 辻本光宏(関東北甲信越統括支店O領域専門室)" userId="7251bc67-91ee-45c9-97e7-9c240c9b485c" providerId="ADAL" clId="{68999E39-5F09-4CF3-B26F-BF167E85A326}" dt="2021-04-23T07:40:37.441" v="2344" actId="2696"/>
        <pc:sldMkLst>
          <pc:docMk/>
          <pc:sldMk cId="1172932861" sldId="817"/>
        </pc:sldMkLst>
      </pc:sldChg>
      <pc:sldChg chg="del">
        <pc:chgData name="Tsujimoto,Mitsuhiro 辻本光宏(関東北甲信越統括支店O領域専門室)" userId="7251bc67-91ee-45c9-97e7-9c240c9b485c" providerId="ADAL" clId="{68999E39-5F09-4CF3-B26F-BF167E85A326}" dt="2021-04-23T07:40:37.535" v="2359" actId="2696"/>
        <pc:sldMkLst>
          <pc:docMk/>
          <pc:sldMk cId="4128798923" sldId="818"/>
        </pc:sldMkLst>
      </pc:sldChg>
      <pc:sldChg chg="del">
        <pc:chgData name="Tsujimoto,Mitsuhiro 辻本光宏(関東北甲信越統括支店O領域専門室)" userId="7251bc67-91ee-45c9-97e7-9c240c9b485c" providerId="ADAL" clId="{68999E39-5F09-4CF3-B26F-BF167E85A326}" dt="2021-04-23T07:40:37.541" v="2360" actId="2696"/>
        <pc:sldMkLst>
          <pc:docMk/>
          <pc:sldMk cId="2101180717" sldId="819"/>
        </pc:sldMkLst>
      </pc:sldChg>
      <pc:sldChg chg="del">
        <pc:chgData name="Tsujimoto,Mitsuhiro 辻本光宏(関東北甲信越統括支店O領域専門室)" userId="7251bc67-91ee-45c9-97e7-9c240c9b485c" providerId="ADAL" clId="{68999E39-5F09-4CF3-B26F-BF167E85A326}" dt="2021-04-23T07:40:37.546" v="2361" actId="2696"/>
        <pc:sldMkLst>
          <pc:docMk/>
          <pc:sldMk cId="1866573599" sldId="820"/>
        </pc:sldMkLst>
      </pc:sldChg>
      <pc:sldChg chg="del">
        <pc:chgData name="Tsujimoto,Mitsuhiro 辻本光宏(関東北甲信越統括支店O領域専門室)" userId="7251bc67-91ee-45c9-97e7-9c240c9b485c" providerId="ADAL" clId="{68999E39-5F09-4CF3-B26F-BF167E85A326}" dt="2021-04-23T07:40:37.552" v="2362" actId="2696"/>
        <pc:sldMkLst>
          <pc:docMk/>
          <pc:sldMk cId="3684780289" sldId="821"/>
        </pc:sldMkLst>
      </pc:sldChg>
      <pc:sldChg chg="del">
        <pc:chgData name="Tsujimoto,Mitsuhiro 辻本光宏(関東北甲信越統括支店O領域専門室)" userId="7251bc67-91ee-45c9-97e7-9c240c9b485c" providerId="ADAL" clId="{68999E39-5F09-4CF3-B26F-BF167E85A326}" dt="2021-04-23T07:40:37.557" v="2363" actId="2696"/>
        <pc:sldMkLst>
          <pc:docMk/>
          <pc:sldMk cId="2034992123" sldId="822"/>
        </pc:sldMkLst>
      </pc:sldChg>
      <pc:sldChg chg="del">
        <pc:chgData name="Tsujimoto,Mitsuhiro 辻本光宏(関東北甲信越統括支店O領域専門室)" userId="7251bc67-91ee-45c9-97e7-9c240c9b485c" providerId="ADAL" clId="{68999E39-5F09-4CF3-B26F-BF167E85A326}" dt="2021-04-23T07:40:37.562" v="2364" actId="2696"/>
        <pc:sldMkLst>
          <pc:docMk/>
          <pc:sldMk cId="4271470290" sldId="823"/>
        </pc:sldMkLst>
      </pc:sldChg>
      <pc:sldChg chg="del">
        <pc:chgData name="Tsujimoto,Mitsuhiro 辻本光宏(関東北甲信越統括支店O領域専門室)" userId="7251bc67-91ee-45c9-97e7-9c240c9b485c" providerId="ADAL" clId="{68999E39-5F09-4CF3-B26F-BF167E85A326}" dt="2021-04-23T07:40:37.569" v="2365" actId="2696"/>
        <pc:sldMkLst>
          <pc:docMk/>
          <pc:sldMk cId="181187519" sldId="824"/>
        </pc:sldMkLst>
      </pc:sldChg>
      <pc:sldChg chg="del">
        <pc:chgData name="Tsujimoto,Mitsuhiro 辻本光宏(関東北甲信越統括支店O領域専門室)" userId="7251bc67-91ee-45c9-97e7-9c240c9b485c" providerId="ADAL" clId="{68999E39-5F09-4CF3-B26F-BF167E85A326}" dt="2021-04-23T07:40:37.574" v="2366" actId="2696"/>
        <pc:sldMkLst>
          <pc:docMk/>
          <pc:sldMk cId="2588628830" sldId="825"/>
        </pc:sldMkLst>
      </pc:sldChg>
      <pc:sldChg chg="del">
        <pc:chgData name="Tsujimoto,Mitsuhiro 辻本光宏(関東北甲信越統括支店O領域専門室)" userId="7251bc67-91ee-45c9-97e7-9c240c9b485c" providerId="ADAL" clId="{68999E39-5F09-4CF3-B26F-BF167E85A326}" dt="2021-04-23T07:40:37.579" v="2367" actId="2696"/>
        <pc:sldMkLst>
          <pc:docMk/>
          <pc:sldMk cId="1624020984" sldId="826"/>
        </pc:sldMkLst>
      </pc:sldChg>
      <pc:sldChg chg="del">
        <pc:chgData name="Tsujimoto,Mitsuhiro 辻本光宏(関東北甲信越統括支店O領域専門室)" userId="7251bc67-91ee-45c9-97e7-9c240c9b485c" providerId="ADAL" clId="{68999E39-5F09-4CF3-B26F-BF167E85A326}" dt="2021-04-23T07:40:37.586" v="2368" actId="2696"/>
        <pc:sldMkLst>
          <pc:docMk/>
          <pc:sldMk cId="1808461951" sldId="827"/>
        </pc:sldMkLst>
      </pc:sldChg>
      <pc:sldChg chg="del">
        <pc:chgData name="Tsujimoto,Mitsuhiro 辻本光宏(関東北甲信越統括支店O領域専門室)" userId="7251bc67-91ee-45c9-97e7-9c240c9b485c" providerId="ADAL" clId="{68999E39-5F09-4CF3-B26F-BF167E85A326}" dt="2021-04-23T07:40:37.592" v="2369" actId="2696"/>
        <pc:sldMkLst>
          <pc:docMk/>
          <pc:sldMk cId="2709625172" sldId="828"/>
        </pc:sldMkLst>
      </pc:sldChg>
      <pc:sldChg chg="del">
        <pc:chgData name="Tsujimoto,Mitsuhiro 辻本光宏(関東北甲信越統括支店O領域専門室)" userId="7251bc67-91ee-45c9-97e7-9c240c9b485c" providerId="ADAL" clId="{68999E39-5F09-4CF3-B26F-BF167E85A326}" dt="2021-04-23T07:40:37.597" v="2370" actId="2696"/>
        <pc:sldMkLst>
          <pc:docMk/>
          <pc:sldMk cId="2083894819" sldId="829"/>
        </pc:sldMkLst>
      </pc:sldChg>
      <pc:sldChg chg="del">
        <pc:chgData name="Tsujimoto,Mitsuhiro 辻本光宏(関東北甲信越統括支店O領域専門室)" userId="7251bc67-91ee-45c9-97e7-9c240c9b485c" providerId="ADAL" clId="{68999E39-5F09-4CF3-B26F-BF167E85A326}" dt="2021-04-23T07:40:37.602" v="2371" actId="2696"/>
        <pc:sldMkLst>
          <pc:docMk/>
          <pc:sldMk cId="1516807206" sldId="830"/>
        </pc:sldMkLst>
      </pc:sldChg>
      <pc:sldChg chg="del">
        <pc:chgData name="Tsujimoto,Mitsuhiro 辻本光宏(関東北甲信越統括支店O領域専門室)" userId="7251bc67-91ee-45c9-97e7-9c240c9b485c" providerId="ADAL" clId="{68999E39-5F09-4CF3-B26F-BF167E85A326}" dt="2021-04-23T07:40:37.608" v="2372" actId="2696"/>
        <pc:sldMkLst>
          <pc:docMk/>
          <pc:sldMk cId="3571752565" sldId="831"/>
        </pc:sldMkLst>
      </pc:sldChg>
      <pc:sldChg chg="del">
        <pc:chgData name="Tsujimoto,Mitsuhiro 辻本光宏(関東北甲信越統括支店O領域専門室)" userId="7251bc67-91ee-45c9-97e7-9c240c9b485c" providerId="ADAL" clId="{68999E39-5F09-4CF3-B26F-BF167E85A326}" dt="2021-04-23T07:40:37.612" v="2373" actId="2696"/>
        <pc:sldMkLst>
          <pc:docMk/>
          <pc:sldMk cId="2912000340" sldId="832"/>
        </pc:sldMkLst>
      </pc:sldChg>
      <pc:sldChg chg="del">
        <pc:chgData name="Tsujimoto,Mitsuhiro 辻本光宏(関東北甲信越統括支店O領域専門室)" userId="7251bc67-91ee-45c9-97e7-9c240c9b485c" providerId="ADAL" clId="{68999E39-5F09-4CF3-B26F-BF167E85A326}" dt="2021-04-23T07:40:37.618" v="2374" actId="2696"/>
        <pc:sldMkLst>
          <pc:docMk/>
          <pc:sldMk cId="2528286872" sldId="833"/>
        </pc:sldMkLst>
      </pc:sldChg>
      <pc:sldChg chg="del">
        <pc:chgData name="Tsujimoto,Mitsuhiro 辻本光宏(関東北甲信越統括支店O領域専門室)" userId="7251bc67-91ee-45c9-97e7-9c240c9b485c" providerId="ADAL" clId="{68999E39-5F09-4CF3-B26F-BF167E85A326}" dt="2021-04-23T07:40:37.623" v="2375" actId="2696"/>
        <pc:sldMkLst>
          <pc:docMk/>
          <pc:sldMk cId="0" sldId="834"/>
        </pc:sldMkLst>
      </pc:sldChg>
      <pc:sldChg chg="del">
        <pc:chgData name="Tsujimoto,Mitsuhiro 辻本光宏(関東北甲信越統括支店O領域専門室)" userId="7251bc67-91ee-45c9-97e7-9c240c9b485c" providerId="ADAL" clId="{68999E39-5F09-4CF3-B26F-BF167E85A326}" dt="2021-04-23T07:40:37.627" v="2376" actId="2696"/>
        <pc:sldMkLst>
          <pc:docMk/>
          <pc:sldMk cId="0" sldId="835"/>
        </pc:sldMkLst>
      </pc:sldChg>
      <pc:sldChg chg="del">
        <pc:chgData name="Tsujimoto,Mitsuhiro 辻本光宏(関東北甲信越統括支店O領域専門室)" userId="7251bc67-91ee-45c9-97e7-9c240c9b485c" providerId="ADAL" clId="{68999E39-5F09-4CF3-B26F-BF167E85A326}" dt="2021-04-23T07:40:37.631" v="2377" actId="2696"/>
        <pc:sldMkLst>
          <pc:docMk/>
          <pc:sldMk cId="0" sldId="836"/>
        </pc:sldMkLst>
      </pc:sldChg>
      <pc:sldChg chg="del">
        <pc:chgData name="Tsujimoto,Mitsuhiro 辻本光宏(関東北甲信越統括支店O領域専門室)" userId="7251bc67-91ee-45c9-97e7-9c240c9b485c" providerId="ADAL" clId="{68999E39-5F09-4CF3-B26F-BF167E85A326}" dt="2021-04-23T07:40:37.637" v="2378" actId="2696"/>
        <pc:sldMkLst>
          <pc:docMk/>
          <pc:sldMk cId="0" sldId="837"/>
        </pc:sldMkLst>
      </pc:sldChg>
      <pc:sldChg chg="modSp">
        <pc:chgData name="Tsujimoto,Mitsuhiro 辻本光宏(関東北甲信越統括支店O領域専門室)" userId="7251bc67-91ee-45c9-97e7-9c240c9b485c" providerId="ADAL" clId="{68999E39-5F09-4CF3-B26F-BF167E85A326}" dt="2021-04-23T05:54:39.880" v="610"/>
        <pc:sldMkLst>
          <pc:docMk/>
          <pc:sldMk cId="1438196563" sldId="846"/>
        </pc:sldMkLst>
        <pc:spChg chg="mod">
          <ac:chgData name="Tsujimoto,Mitsuhiro 辻本光宏(関東北甲信越統括支店O領域専門室)" userId="7251bc67-91ee-45c9-97e7-9c240c9b485c" providerId="ADAL" clId="{68999E39-5F09-4CF3-B26F-BF167E85A326}" dt="2021-04-23T05:54:39.880" v="610"/>
          <ac:spMkLst>
            <pc:docMk/>
            <pc:sldMk cId="1438196563" sldId="846"/>
            <ac:spMk id="5" creationId="{52708625-118C-4AF9-A524-AFAD6E7A7550}"/>
          </ac:spMkLst>
        </pc:spChg>
      </pc:sldChg>
      <pc:sldChg chg="modSp">
        <pc:chgData name="Tsujimoto,Mitsuhiro 辻本光宏(関東北甲信越統括支店O領域専門室)" userId="7251bc67-91ee-45c9-97e7-9c240c9b485c" providerId="ADAL" clId="{68999E39-5F09-4CF3-B26F-BF167E85A326}" dt="2021-04-23T06:35:46.095" v="2337" actId="2711"/>
        <pc:sldMkLst>
          <pc:docMk/>
          <pc:sldMk cId="2750986973" sldId="850"/>
        </pc:sldMkLst>
        <pc:spChg chg="mod">
          <ac:chgData name="Tsujimoto,Mitsuhiro 辻本光宏(関東北甲信越統括支店O領域専門室)" userId="7251bc67-91ee-45c9-97e7-9c240c9b485c" providerId="ADAL" clId="{68999E39-5F09-4CF3-B26F-BF167E85A326}" dt="2021-04-23T06:35:00.935" v="2334" actId="1038"/>
          <ac:spMkLst>
            <pc:docMk/>
            <pc:sldMk cId="2750986973" sldId="850"/>
            <ac:spMk id="7" creationId="{57BD455B-195A-4309-AD4E-6BC6976160AA}"/>
          </ac:spMkLst>
        </pc:spChg>
        <pc:spChg chg="mod">
          <ac:chgData name="Tsujimoto,Mitsuhiro 辻本光宏(関東北甲信越統括支店O領域専門室)" userId="7251bc67-91ee-45c9-97e7-9c240c9b485c" providerId="ADAL" clId="{68999E39-5F09-4CF3-B26F-BF167E85A326}" dt="2021-04-23T06:35:00.935" v="2334" actId="1038"/>
          <ac:spMkLst>
            <pc:docMk/>
            <pc:sldMk cId="2750986973" sldId="850"/>
            <ac:spMk id="8" creationId="{1E911D6B-C921-4194-89ED-9733FB4A11FA}"/>
          </ac:spMkLst>
        </pc:spChg>
        <pc:spChg chg="mod">
          <ac:chgData name="Tsujimoto,Mitsuhiro 辻本光宏(関東北甲信越統括支店O領域専門室)" userId="7251bc67-91ee-45c9-97e7-9c240c9b485c" providerId="ADAL" clId="{68999E39-5F09-4CF3-B26F-BF167E85A326}" dt="2021-04-23T06:35:00.935" v="2334" actId="1038"/>
          <ac:spMkLst>
            <pc:docMk/>
            <pc:sldMk cId="2750986973" sldId="850"/>
            <ac:spMk id="9" creationId="{A7FFCC32-B8E9-4E35-A92F-6B38F883B0A8}"/>
          </ac:spMkLst>
        </pc:spChg>
        <pc:spChg chg="mod">
          <ac:chgData name="Tsujimoto,Mitsuhiro 辻本光宏(関東北甲信越統括支店O領域専門室)" userId="7251bc67-91ee-45c9-97e7-9c240c9b485c" providerId="ADAL" clId="{68999E39-5F09-4CF3-B26F-BF167E85A326}" dt="2021-04-23T06:35:46.095" v="2337" actId="2711"/>
          <ac:spMkLst>
            <pc:docMk/>
            <pc:sldMk cId="2750986973" sldId="850"/>
            <ac:spMk id="14" creationId="{D2D9FE1F-7640-4E57-B47D-D39338E3DE3E}"/>
          </ac:spMkLst>
        </pc:spChg>
        <pc:spChg chg="mod">
          <ac:chgData name="Tsujimoto,Mitsuhiro 辻本光宏(関東北甲信越統括支店O領域専門室)" userId="7251bc67-91ee-45c9-97e7-9c240c9b485c" providerId="ADAL" clId="{68999E39-5F09-4CF3-B26F-BF167E85A326}" dt="2021-04-23T06:35:46.095" v="2337" actId="2711"/>
          <ac:spMkLst>
            <pc:docMk/>
            <pc:sldMk cId="2750986973" sldId="850"/>
            <ac:spMk id="15" creationId="{09214FCE-F87C-4C4C-B8FD-0D764CD152B1}"/>
          </ac:spMkLst>
        </pc:spChg>
        <pc:spChg chg="mod">
          <ac:chgData name="Tsujimoto,Mitsuhiro 辻本光宏(関東北甲信越統括支店O領域専門室)" userId="7251bc67-91ee-45c9-97e7-9c240c9b485c" providerId="ADAL" clId="{68999E39-5F09-4CF3-B26F-BF167E85A326}" dt="2021-04-23T06:35:46.095" v="2337" actId="2711"/>
          <ac:spMkLst>
            <pc:docMk/>
            <pc:sldMk cId="2750986973" sldId="850"/>
            <ac:spMk id="16" creationId="{CB8BD04B-5844-411A-8516-9CD9C79DE91B}"/>
          </ac:spMkLst>
        </pc:spChg>
        <pc:picChg chg="mod">
          <ac:chgData name="Tsujimoto,Mitsuhiro 辻本光宏(関東北甲信越統括支店O領域専門室)" userId="7251bc67-91ee-45c9-97e7-9c240c9b485c" providerId="ADAL" clId="{68999E39-5F09-4CF3-B26F-BF167E85A326}" dt="2021-04-23T06:35:00.935" v="2334" actId="1038"/>
          <ac:picMkLst>
            <pc:docMk/>
            <pc:sldMk cId="2750986973" sldId="850"/>
            <ac:picMk id="2050" creationId="{EE37813D-C78B-458D-AD0A-E7289C7716F0}"/>
          </ac:picMkLst>
        </pc:picChg>
        <pc:picChg chg="mod">
          <ac:chgData name="Tsujimoto,Mitsuhiro 辻本光宏(関東北甲信越統括支店O領域専門室)" userId="7251bc67-91ee-45c9-97e7-9c240c9b485c" providerId="ADAL" clId="{68999E39-5F09-4CF3-B26F-BF167E85A326}" dt="2021-04-23T06:35:00.935" v="2334" actId="1038"/>
          <ac:picMkLst>
            <pc:docMk/>
            <pc:sldMk cId="2750986973" sldId="850"/>
            <ac:picMk id="2052" creationId="{C07B4C9A-27F3-4544-A0DA-ABAC2C13FB22}"/>
          </ac:picMkLst>
        </pc:picChg>
        <pc:picChg chg="mod">
          <ac:chgData name="Tsujimoto,Mitsuhiro 辻本光宏(関東北甲信越統括支店O領域専門室)" userId="7251bc67-91ee-45c9-97e7-9c240c9b485c" providerId="ADAL" clId="{68999E39-5F09-4CF3-B26F-BF167E85A326}" dt="2021-04-23T06:35:00.935" v="2334" actId="1038"/>
          <ac:picMkLst>
            <pc:docMk/>
            <pc:sldMk cId="2750986973" sldId="850"/>
            <ac:picMk id="2056" creationId="{C9518F7E-D0E0-4C0D-9549-E0EF4F6D4A19}"/>
          </ac:picMkLst>
        </pc:picChg>
      </pc:sldChg>
      <pc:sldChg chg="addSp delSp modSp add">
        <pc:chgData name="Tsujimoto,Mitsuhiro 辻本光宏(関東北甲信越統括支店O領域専門室)" userId="7251bc67-91ee-45c9-97e7-9c240c9b485c" providerId="ADAL" clId="{68999E39-5F09-4CF3-B26F-BF167E85A326}" dt="2021-04-23T05:37:37.245" v="155" actId="1076"/>
        <pc:sldMkLst>
          <pc:docMk/>
          <pc:sldMk cId="3008612814" sldId="866"/>
        </pc:sldMkLst>
        <pc:spChg chg="mod">
          <ac:chgData name="Tsujimoto,Mitsuhiro 辻本光宏(関東北甲信越統括支店O領域専門室)" userId="7251bc67-91ee-45c9-97e7-9c240c9b485c" providerId="ADAL" clId="{68999E39-5F09-4CF3-B26F-BF167E85A326}" dt="2021-04-23T05:34:32.983" v="56" actId="20577"/>
          <ac:spMkLst>
            <pc:docMk/>
            <pc:sldMk cId="3008612814" sldId="866"/>
            <ac:spMk id="2" creationId="{E9C84B9A-0A5E-4501-A736-97E7536FAD85}"/>
          </ac:spMkLst>
        </pc:spChg>
        <pc:spChg chg="del">
          <ac:chgData name="Tsujimoto,Mitsuhiro 辻本光宏(関東北甲信越統括支店O領域専門室)" userId="7251bc67-91ee-45c9-97e7-9c240c9b485c" providerId="ADAL" clId="{68999E39-5F09-4CF3-B26F-BF167E85A326}" dt="2021-04-23T05:37:34.611" v="153" actId="478"/>
          <ac:spMkLst>
            <pc:docMk/>
            <pc:sldMk cId="3008612814" sldId="866"/>
            <ac:spMk id="6" creationId="{DB762508-B2DE-4DF4-BA8E-E427FABE18CF}"/>
          </ac:spMkLst>
        </pc:spChg>
        <pc:spChg chg="del">
          <ac:chgData name="Tsujimoto,Mitsuhiro 辻本光宏(関東北甲信越統括支店O領域専門室)" userId="7251bc67-91ee-45c9-97e7-9c240c9b485c" providerId="ADAL" clId="{68999E39-5F09-4CF3-B26F-BF167E85A326}" dt="2021-04-23T05:36:26.072" v="73" actId="478"/>
          <ac:spMkLst>
            <pc:docMk/>
            <pc:sldMk cId="3008612814" sldId="866"/>
            <ac:spMk id="9" creationId="{961A8DDC-52FD-43C8-8EB1-F361125483B3}"/>
          </ac:spMkLst>
        </pc:spChg>
        <pc:spChg chg="add mod">
          <ac:chgData name="Tsujimoto,Mitsuhiro 辻本光宏(関東北甲信越統括支店O領域専門室)" userId="7251bc67-91ee-45c9-97e7-9c240c9b485c" providerId="ADAL" clId="{68999E39-5F09-4CF3-B26F-BF167E85A326}" dt="2021-04-23T05:37:26.651" v="151"/>
          <ac:spMkLst>
            <pc:docMk/>
            <pc:sldMk cId="3008612814" sldId="866"/>
            <ac:spMk id="37" creationId="{326FB8DD-205A-4C46-8D05-1694D2165239}"/>
          </ac:spMkLst>
        </pc:spChg>
        <pc:spChg chg="add del">
          <ac:chgData name="Tsujimoto,Mitsuhiro 辻本光宏(関東北甲信越統括支店O領域専門室)" userId="7251bc67-91ee-45c9-97e7-9c240c9b485c" providerId="ADAL" clId="{68999E39-5F09-4CF3-B26F-BF167E85A326}" dt="2021-04-23T05:37:29.519" v="152" actId="478"/>
          <ac:spMkLst>
            <pc:docMk/>
            <pc:sldMk cId="3008612814" sldId="866"/>
            <ac:spMk id="38" creationId="{F326FEC7-3773-4D5B-87FF-D3A6CE4515A5}"/>
          </ac:spMkLst>
        </pc:spChg>
        <pc:spChg chg="add mod">
          <ac:chgData name="Tsujimoto,Mitsuhiro 辻本光宏(関東北甲信越統括支店O領域専門室)" userId="7251bc67-91ee-45c9-97e7-9c240c9b485c" providerId="ADAL" clId="{68999E39-5F09-4CF3-B26F-BF167E85A326}" dt="2021-04-23T05:37:37.245" v="155" actId="1076"/>
          <ac:spMkLst>
            <pc:docMk/>
            <pc:sldMk cId="3008612814" sldId="866"/>
            <ac:spMk id="39" creationId="{54A4A93D-AE66-4F12-9B6C-BE7EA10CBB9A}"/>
          </ac:spMkLst>
        </pc:spChg>
        <pc:grpChg chg="del">
          <ac:chgData name="Tsujimoto,Mitsuhiro 辻本光宏(関東北甲信越統括支店O領域専門室)" userId="7251bc67-91ee-45c9-97e7-9c240c9b485c" providerId="ADAL" clId="{68999E39-5F09-4CF3-B26F-BF167E85A326}" dt="2021-04-23T05:35:36.433" v="69" actId="478"/>
          <ac:grpSpMkLst>
            <pc:docMk/>
            <pc:sldMk cId="3008612814" sldId="866"/>
            <ac:grpSpMk id="7" creationId="{7FE6651F-1136-4D61-B65B-2E615A516C40}"/>
          </ac:grpSpMkLst>
        </pc:grpChg>
        <pc:picChg chg="add mod">
          <ac:chgData name="Tsujimoto,Mitsuhiro 辻本光宏(関東北甲信越統括支店O領域専門室)" userId="7251bc67-91ee-45c9-97e7-9c240c9b485c" providerId="ADAL" clId="{68999E39-5F09-4CF3-B26F-BF167E85A326}" dt="2021-04-23T05:35:45.350" v="72" actId="1076"/>
          <ac:picMkLst>
            <pc:docMk/>
            <pc:sldMk cId="3008612814" sldId="866"/>
            <ac:picMk id="36" creationId="{EAF86B06-8CBF-4D8C-94F0-2ABC361FE445}"/>
          </ac:picMkLst>
        </pc:pic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12" creationId="{1900D124-F7FC-4DEB-A656-4AC80E94DD36}"/>
          </ac:cxnSpMkLst>
        </pc:cxn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14" creationId="{74C0921E-0212-4570-A077-CCAD25325550}"/>
          </ac:cxnSpMkLst>
        </pc:cxn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23" creationId="{2BBA75EE-84A3-45C9-96BB-AFA383C35D64}"/>
          </ac:cxnSpMkLst>
        </pc:cxn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27" creationId="{8EE7037D-996F-46B3-892C-29C4035031F0}"/>
          </ac:cxnSpMkLst>
        </pc:cxn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28" creationId="{7C579B56-4CA6-414B-BC91-F4BA197ABEC5}"/>
          </ac:cxnSpMkLst>
        </pc:cxn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31" creationId="{C85F07B8-2FF6-46EA-B056-EEB543CF1FF7}"/>
          </ac:cxnSpMkLst>
        </pc:cxn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32" creationId="{E364300B-84FE-4918-945B-FBDC02B76579}"/>
          </ac:cxnSpMkLst>
        </pc:cxnChg>
        <pc:cxnChg chg="mod">
          <ac:chgData name="Tsujimoto,Mitsuhiro 辻本光宏(関東北甲信越統括支店O領域専門室)" userId="7251bc67-91ee-45c9-97e7-9c240c9b485c" providerId="ADAL" clId="{68999E39-5F09-4CF3-B26F-BF167E85A326}" dt="2021-04-23T05:35:36.433" v="69" actId="478"/>
          <ac:cxnSpMkLst>
            <pc:docMk/>
            <pc:sldMk cId="3008612814" sldId="866"/>
            <ac:cxnSpMk id="35" creationId="{928323BE-50F2-43A4-96B9-A7E7CD2F0DE7}"/>
          </ac:cxnSpMkLst>
        </pc:cxnChg>
      </pc:sldChg>
      <pc:sldChg chg="addSp delSp modSp add">
        <pc:chgData name="Tsujimoto,Mitsuhiro 辻本光宏(関東北甲信越統括支店O領域専門室)" userId="7251bc67-91ee-45c9-97e7-9c240c9b485c" providerId="ADAL" clId="{68999E39-5F09-4CF3-B26F-BF167E85A326}" dt="2021-04-23T05:45:22.840" v="377" actId="1035"/>
        <pc:sldMkLst>
          <pc:docMk/>
          <pc:sldMk cId="3836524626" sldId="867"/>
        </pc:sldMkLst>
        <pc:spChg chg="mod">
          <ac:chgData name="Tsujimoto,Mitsuhiro 辻本光宏(関東北甲信越統括支店O領域専門室)" userId="7251bc67-91ee-45c9-97e7-9c240c9b485c" providerId="ADAL" clId="{68999E39-5F09-4CF3-B26F-BF167E85A326}" dt="2021-04-23T05:42:34.089" v="215"/>
          <ac:spMkLst>
            <pc:docMk/>
            <pc:sldMk cId="3836524626" sldId="867"/>
            <ac:spMk id="2" creationId="{B67DD072-EE98-408E-A750-34564FBD2D7D}"/>
          </ac:spMkLst>
        </pc:spChg>
        <pc:spChg chg="del">
          <ac:chgData name="Tsujimoto,Mitsuhiro 辻本光宏(関東北甲信越統括支店O領域専門室)" userId="7251bc67-91ee-45c9-97e7-9c240c9b485c" providerId="ADAL" clId="{68999E39-5F09-4CF3-B26F-BF167E85A326}" dt="2021-04-23T05:44:09.678" v="254" actId="478"/>
          <ac:spMkLst>
            <pc:docMk/>
            <pc:sldMk cId="3836524626" sldId="867"/>
            <ac:spMk id="3" creationId="{B866AC4F-D945-467C-8512-F40A13B04C48}"/>
          </ac:spMkLst>
        </pc:spChg>
        <pc:spChg chg="mod">
          <ac:chgData name="Tsujimoto,Mitsuhiro 辻本光宏(関東北甲信越統括支店O領域専門室)" userId="7251bc67-91ee-45c9-97e7-9c240c9b485c" providerId="ADAL" clId="{68999E39-5F09-4CF3-B26F-BF167E85A326}" dt="2021-04-23T05:45:17.019" v="368" actId="1037"/>
          <ac:spMkLst>
            <pc:docMk/>
            <pc:sldMk cId="3836524626" sldId="867"/>
            <ac:spMk id="14" creationId="{BB326143-66C6-4594-A01D-3E4C08BB27EF}"/>
          </ac:spMkLst>
        </pc:spChg>
        <pc:spChg chg="add mod">
          <ac:chgData name="Tsujimoto,Mitsuhiro 辻本光宏(関東北甲信越統括支店O領域専門室)" userId="7251bc67-91ee-45c9-97e7-9c240c9b485c" providerId="ADAL" clId="{68999E39-5F09-4CF3-B26F-BF167E85A326}" dt="2021-04-23T05:41:04.145" v="183" actId="164"/>
          <ac:spMkLst>
            <pc:docMk/>
            <pc:sldMk cId="3836524626" sldId="867"/>
            <ac:spMk id="15" creationId="{6E0DA926-945C-460E-8617-A48029A9C796}"/>
          </ac:spMkLst>
        </pc:spChg>
        <pc:spChg chg="add mod">
          <ac:chgData name="Tsujimoto,Mitsuhiro 辻本光宏(関東北甲信越統括支店O領域専門室)" userId="7251bc67-91ee-45c9-97e7-9c240c9b485c" providerId="ADAL" clId="{68999E39-5F09-4CF3-B26F-BF167E85A326}" dt="2021-04-23T05:41:04.145" v="183" actId="164"/>
          <ac:spMkLst>
            <pc:docMk/>
            <pc:sldMk cId="3836524626" sldId="867"/>
            <ac:spMk id="16" creationId="{053079F1-1BF4-4FFA-9A83-C7EB4C03D997}"/>
          </ac:spMkLst>
        </pc:spChg>
        <pc:spChg chg="add mod">
          <ac:chgData name="Tsujimoto,Mitsuhiro 辻本光宏(関東北甲信越統括支店O領域専門室)" userId="7251bc67-91ee-45c9-97e7-9c240c9b485c" providerId="ADAL" clId="{68999E39-5F09-4CF3-B26F-BF167E85A326}" dt="2021-04-23T05:41:04.145" v="183" actId="164"/>
          <ac:spMkLst>
            <pc:docMk/>
            <pc:sldMk cId="3836524626" sldId="867"/>
            <ac:spMk id="21" creationId="{CED8A1CD-A255-4525-8B82-5990F98E301D}"/>
          </ac:spMkLst>
        </pc:spChg>
        <pc:spChg chg="add mod">
          <ac:chgData name="Tsujimoto,Mitsuhiro 辻本光宏(関東北甲信越統括支店O領域専門室)" userId="7251bc67-91ee-45c9-97e7-9c240c9b485c" providerId="ADAL" clId="{68999E39-5F09-4CF3-B26F-BF167E85A326}" dt="2021-04-23T05:41:04.145" v="183" actId="164"/>
          <ac:spMkLst>
            <pc:docMk/>
            <pc:sldMk cId="3836524626" sldId="867"/>
            <ac:spMk id="22" creationId="{C1BF78DB-88A7-47A2-9ABC-EA556975EAA5}"/>
          </ac:spMkLst>
        </pc:spChg>
        <pc:spChg chg="add del">
          <ac:chgData name="Tsujimoto,Mitsuhiro 辻本光宏(関東北甲信越統括支店O領域専門室)" userId="7251bc67-91ee-45c9-97e7-9c240c9b485c" providerId="ADAL" clId="{68999E39-5F09-4CF3-B26F-BF167E85A326}" dt="2021-04-23T05:42:08.986" v="202"/>
          <ac:spMkLst>
            <pc:docMk/>
            <pc:sldMk cId="3836524626" sldId="867"/>
            <ac:spMk id="34" creationId="{9B2C948A-66A4-41A1-9E28-9BAC1EF9CB8B}"/>
          </ac:spMkLst>
        </pc:spChg>
        <pc:spChg chg="add del">
          <ac:chgData name="Tsujimoto,Mitsuhiro 辻本光宏(関東北甲信越統括支店O領域専門室)" userId="7251bc67-91ee-45c9-97e7-9c240c9b485c" providerId="ADAL" clId="{68999E39-5F09-4CF3-B26F-BF167E85A326}" dt="2021-04-23T05:42:08.986" v="202"/>
          <ac:spMkLst>
            <pc:docMk/>
            <pc:sldMk cId="3836524626" sldId="867"/>
            <ac:spMk id="35" creationId="{468F8E1B-B4E2-4C31-AECD-5C74407C64ED}"/>
          </ac:spMkLst>
        </pc:spChg>
        <pc:spChg chg="add del">
          <ac:chgData name="Tsujimoto,Mitsuhiro 辻本光宏(関東北甲信越統括支店O領域専門室)" userId="7251bc67-91ee-45c9-97e7-9c240c9b485c" providerId="ADAL" clId="{68999E39-5F09-4CF3-B26F-BF167E85A326}" dt="2021-04-23T05:42:08.986" v="202"/>
          <ac:spMkLst>
            <pc:docMk/>
            <pc:sldMk cId="3836524626" sldId="867"/>
            <ac:spMk id="36" creationId="{8C036766-AD2B-41FF-8141-C1E7FA93B966}"/>
          </ac:spMkLst>
        </pc:spChg>
        <pc:spChg chg="add del">
          <ac:chgData name="Tsujimoto,Mitsuhiro 辻本光宏(関東北甲信越統括支店O領域専門室)" userId="7251bc67-91ee-45c9-97e7-9c240c9b485c" providerId="ADAL" clId="{68999E39-5F09-4CF3-B26F-BF167E85A326}" dt="2021-04-23T05:42:08.986" v="202"/>
          <ac:spMkLst>
            <pc:docMk/>
            <pc:sldMk cId="3836524626" sldId="867"/>
            <ac:spMk id="39" creationId="{6C4ABC94-AC94-4F05-9635-125DB4F54C66}"/>
          </ac:spMkLst>
        </pc:spChg>
        <pc:spChg chg="add">
          <ac:chgData name="Tsujimoto,Mitsuhiro 辻本光宏(関東北甲信越統括支店O領域専門室)" userId="7251bc67-91ee-45c9-97e7-9c240c9b485c" providerId="ADAL" clId="{68999E39-5F09-4CF3-B26F-BF167E85A326}" dt="2021-04-23T05:44:10.643" v="255"/>
          <ac:spMkLst>
            <pc:docMk/>
            <pc:sldMk cId="3836524626" sldId="867"/>
            <ac:spMk id="41" creationId="{7B187E99-F118-4D35-8074-0A962F6BAD38}"/>
          </ac:spMkLst>
        </pc:spChg>
        <pc:spChg chg="add del mod">
          <ac:chgData name="Tsujimoto,Mitsuhiro 辻本光宏(関東北甲信越統括支店O領域専門室)" userId="7251bc67-91ee-45c9-97e7-9c240c9b485c" providerId="ADAL" clId="{68999E39-5F09-4CF3-B26F-BF167E85A326}" dt="2021-04-23T05:45:20.234" v="369" actId="478"/>
          <ac:spMkLst>
            <pc:docMk/>
            <pc:sldMk cId="3836524626" sldId="867"/>
            <ac:spMk id="42" creationId="{A5304B45-C606-47E3-8048-5F77ACF9DF98}"/>
          </ac:spMkLst>
        </pc:spChg>
        <pc:grpChg chg="add del mod">
          <ac:chgData name="Tsujimoto,Mitsuhiro 辻本光宏(関東北甲信越統括支店O領域専門室)" userId="7251bc67-91ee-45c9-97e7-9c240c9b485c" providerId="ADAL" clId="{68999E39-5F09-4CF3-B26F-BF167E85A326}" dt="2021-04-23T05:41:14.959" v="192" actId="478"/>
          <ac:grpSpMkLst>
            <pc:docMk/>
            <pc:sldMk cId="3836524626" sldId="867"/>
            <ac:grpSpMk id="4" creationId="{20F22F85-E27E-4216-A291-36DB2631A9CC}"/>
          </ac:grpSpMkLst>
        </pc:grpChg>
        <pc:grpChg chg="del">
          <ac:chgData name="Tsujimoto,Mitsuhiro 辻本光宏(関東北甲信越統括支店O領域専門室)" userId="7251bc67-91ee-45c9-97e7-9c240c9b485c" providerId="ADAL" clId="{68999E39-5F09-4CF3-B26F-BF167E85A326}" dt="2021-04-23T05:41:20.666" v="195" actId="478"/>
          <ac:grpSpMkLst>
            <pc:docMk/>
            <pc:sldMk cId="3836524626" sldId="867"/>
            <ac:grpSpMk id="19" creationId="{B9F597EB-C79B-454F-995B-FE51EF6C9355}"/>
          </ac:grpSpMkLst>
        </pc:grpChg>
        <pc:grpChg chg="add del mod">
          <ac:chgData name="Tsujimoto,Mitsuhiro 辻本光宏(関東北甲信越統括支店O領域専門室)" userId="7251bc67-91ee-45c9-97e7-9c240c9b485c" providerId="ADAL" clId="{68999E39-5F09-4CF3-B26F-BF167E85A326}" dt="2021-04-23T05:41:12.993" v="189"/>
          <ac:grpSpMkLst>
            <pc:docMk/>
            <pc:sldMk cId="3836524626" sldId="867"/>
            <ac:grpSpMk id="23" creationId="{4FD7D44D-1A53-45D5-A5FC-B6453F46A200}"/>
          </ac:grpSpMkLst>
        </pc:grpChg>
        <pc:picChg chg="add mod">
          <ac:chgData name="Tsujimoto,Mitsuhiro 辻本光宏(関東北甲信越統括支店O領域専門室)" userId="7251bc67-91ee-45c9-97e7-9c240c9b485c" providerId="ADAL" clId="{68999E39-5F09-4CF3-B26F-BF167E85A326}" dt="2021-04-23T05:45:22.840" v="377" actId="1035"/>
          <ac:picMkLst>
            <pc:docMk/>
            <pc:sldMk cId="3836524626" sldId="867"/>
            <ac:picMk id="5" creationId="{5FCA543A-8106-4F4D-A48D-99C96E090CEB}"/>
          </ac:picMkLst>
        </pc:picChg>
        <pc:picChg chg="add del mod">
          <ac:chgData name="Tsujimoto,Mitsuhiro 辻本光宏(関東北甲信越統括支店O領域専門室)" userId="7251bc67-91ee-45c9-97e7-9c240c9b485c" providerId="ADAL" clId="{68999E39-5F09-4CF3-B26F-BF167E85A326}" dt="2021-04-23T05:42:36.555" v="216" actId="478"/>
          <ac:picMkLst>
            <pc:docMk/>
            <pc:sldMk cId="3836524626" sldId="867"/>
            <ac:picMk id="6" creationId="{5947BE46-9FF6-4DD7-AD7B-1D4A13506D8B}"/>
          </ac:picMkLst>
        </pc:picChg>
        <pc:picChg chg="add mod">
          <ac:chgData name="Tsujimoto,Mitsuhiro 辻本光宏(関東北甲信越統括支店O領域専門室)" userId="7251bc67-91ee-45c9-97e7-9c240c9b485c" providerId="ADAL" clId="{68999E39-5F09-4CF3-B26F-BF167E85A326}" dt="2021-04-23T05:41:04.145" v="183" actId="164"/>
          <ac:picMkLst>
            <pc:docMk/>
            <pc:sldMk cId="3836524626" sldId="867"/>
            <ac:picMk id="13" creationId="{8F211E3B-19AF-4501-BA72-8482EFB87E65}"/>
          </ac:picMkLst>
        </pc:picChg>
        <pc:picChg chg="del">
          <ac:chgData name="Tsujimoto,Mitsuhiro 辻本光宏(関東北甲信越統括支店O領域専門室)" userId="7251bc67-91ee-45c9-97e7-9c240c9b485c" providerId="ADAL" clId="{68999E39-5F09-4CF3-B26F-BF167E85A326}" dt="2021-04-23T05:41:17.072" v="193" actId="478"/>
          <ac:picMkLst>
            <pc:docMk/>
            <pc:sldMk cId="3836524626" sldId="867"/>
            <ac:picMk id="28" creationId="{8DAD9F69-8D4F-41B9-B6BF-42E776E1BE90}"/>
          </ac:picMkLst>
        </pc:picChg>
        <pc:picChg chg="add del">
          <ac:chgData name="Tsujimoto,Mitsuhiro 辻本光宏(関東北甲信越統括支店O領域専門室)" userId="7251bc67-91ee-45c9-97e7-9c240c9b485c" providerId="ADAL" clId="{68999E39-5F09-4CF3-B26F-BF167E85A326}" dt="2021-04-23T05:42:08.986" v="202"/>
          <ac:picMkLst>
            <pc:docMk/>
            <pc:sldMk cId="3836524626" sldId="867"/>
            <ac:picMk id="33" creationId="{EB21EBDA-452D-47F4-A0F7-1E24693FA729}"/>
          </ac:picMkLst>
        </pc:picChg>
        <pc:cxnChg chg="add mod">
          <ac:chgData name="Tsujimoto,Mitsuhiro 辻本光宏(関東北甲信越統括支店O領域専門室)" userId="7251bc67-91ee-45c9-97e7-9c240c9b485c" providerId="ADAL" clId="{68999E39-5F09-4CF3-B26F-BF167E85A326}" dt="2021-04-23T05:41:04.145" v="183" actId="164"/>
          <ac:cxnSpMkLst>
            <pc:docMk/>
            <pc:sldMk cId="3836524626" sldId="867"/>
            <ac:cxnSpMk id="17" creationId="{76EF2755-C0CC-4AD9-9E4F-1708C169E9A8}"/>
          </ac:cxnSpMkLst>
        </pc:cxnChg>
        <pc:cxnChg chg="add mod">
          <ac:chgData name="Tsujimoto,Mitsuhiro 辻本光宏(関東北甲信越統括支店O領域専門室)" userId="7251bc67-91ee-45c9-97e7-9c240c9b485c" providerId="ADAL" clId="{68999E39-5F09-4CF3-B26F-BF167E85A326}" dt="2021-04-23T05:41:04.145" v="183" actId="164"/>
          <ac:cxnSpMkLst>
            <pc:docMk/>
            <pc:sldMk cId="3836524626" sldId="867"/>
            <ac:cxnSpMk id="18" creationId="{34694636-F2EC-4235-99D1-9CB0FB545F7C}"/>
          </ac:cxnSpMkLst>
        </pc:cxnChg>
        <pc:cxnChg chg="add mod">
          <ac:chgData name="Tsujimoto,Mitsuhiro 辻本光宏(関東北甲信越統括支店O領域専門室)" userId="7251bc67-91ee-45c9-97e7-9c240c9b485c" providerId="ADAL" clId="{68999E39-5F09-4CF3-B26F-BF167E85A326}" dt="2021-04-23T05:41:04.145" v="183" actId="164"/>
          <ac:cxnSpMkLst>
            <pc:docMk/>
            <pc:sldMk cId="3836524626" sldId="867"/>
            <ac:cxnSpMk id="20" creationId="{07FB827D-FFE6-4108-956F-35629892CF76}"/>
          </ac:cxnSpMkLst>
        </pc:cxnChg>
        <pc:cxnChg chg="add del">
          <ac:chgData name="Tsujimoto,Mitsuhiro 辻本光宏(関東北甲信越統括支店O領域専門室)" userId="7251bc67-91ee-45c9-97e7-9c240c9b485c" providerId="ADAL" clId="{68999E39-5F09-4CF3-B26F-BF167E85A326}" dt="2021-04-23T05:42:08.986" v="202"/>
          <ac:cxnSpMkLst>
            <pc:docMk/>
            <pc:sldMk cId="3836524626" sldId="867"/>
            <ac:cxnSpMk id="37" creationId="{E7304587-9411-4CEE-9D01-E44FC9A1FF26}"/>
          </ac:cxnSpMkLst>
        </pc:cxnChg>
        <pc:cxnChg chg="add del">
          <ac:chgData name="Tsujimoto,Mitsuhiro 辻本光宏(関東北甲信越統括支店O領域専門室)" userId="7251bc67-91ee-45c9-97e7-9c240c9b485c" providerId="ADAL" clId="{68999E39-5F09-4CF3-B26F-BF167E85A326}" dt="2021-04-23T05:42:08.986" v="202"/>
          <ac:cxnSpMkLst>
            <pc:docMk/>
            <pc:sldMk cId="3836524626" sldId="867"/>
            <ac:cxnSpMk id="38" creationId="{E3AA662D-455F-4F5A-BAF4-16C25C48026B}"/>
          </ac:cxnSpMkLst>
        </pc:cxnChg>
        <pc:cxnChg chg="add del">
          <ac:chgData name="Tsujimoto,Mitsuhiro 辻本光宏(関東北甲信越統括支店O領域専門室)" userId="7251bc67-91ee-45c9-97e7-9c240c9b485c" providerId="ADAL" clId="{68999E39-5F09-4CF3-B26F-BF167E85A326}" dt="2021-04-23T05:42:08.986" v="202"/>
          <ac:cxnSpMkLst>
            <pc:docMk/>
            <pc:sldMk cId="3836524626" sldId="867"/>
            <ac:cxnSpMk id="40" creationId="{E462D7A5-DC68-491D-9972-03E84B215E16}"/>
          </ac:cxnSpMkLst>
        </pc:cxnChg>
      </pc:sldChg>
      <pc:sldChg chg="addSp delSp modSp add ord">
        <pc:chgData name="Tsujimoto,Mitsuhiro 辻本光宏(関東北甲信越統括支店O領域専門室)" userId="7251bc67-91ee-45c9-97e7-9c240c9b485c" providerId="ADAL" clId="{68999E39-5F09-4CF3-B26F-BF167E85A326}" dt="2021-04-23T05:45:59.601" v="411" actId="1076"/>
        <pc:sldMkLst>
          <pc:docMk/>
          <pc:sldMk cId="3597620934" sldId="868"/>
        </pc:sldMkLst>
        <pc:spChg chg="del">
          <ac:chgData name="Tsujimoto,Mitsuhiro 辻本光宏(関東北甲信越統括支店O領域専門室)" userId="7251bc67-91ee-45c9-97e7-9c240c9b485c" providerId="ADAL" clId="{68999E39-5F09-4CF3-B26F-BF167E85A326}" dt="2021-04-23T05:44:06.651" v="252" actId="478"/>
          <ac:spMkLst>
            <pc:docMk/>
            <pc:sldMk cId="3597620934" sldId="868"/>
            <ac:spMk id="3" creationId="{B866AC4F-D945-467C-8512-F40A13B04C48}"/>
          </ac:spMkLst>
        </pc:spChg>
        <pc:spChg chg="add">
          <ac:chgData name="Tsujimoto,Mitsuhiro 辻本光宏(関東北甲信越統括支店O領域専門室)" userId="7251bc67-91ee-45c9-97e7-9c240c9b485c" providerId="ADAL" clId="{68999E39-5F09-4CF3-B26F-BF167E85A326}" dt="2021-04-23T05:44:06.882" v="253"/>
          <ac:spMkLst>
            <pc:docMk/>
            <pc:sldMk cId="3597620934" sldId="868"/>
            <ac:spMk id="7" creationId="{1485B2BE-6964-4C97-8B6A-721EEF229327}"/>
          </ac:spMkLst>
        </pc:spChg>
        <pc:spChg chg="add mod">
          <ac:chgData name="Tsujimoto,Mitsuhiro 辻本光宏(関東北甲信越統括支店O領域専門室)" userId="7251bc67-91ee-45c9-97e7-9c240c9b485c" providerId="ADAL" clId="{68999E39-5F09-4CF3-B26F-BF167E85A326}" dt="2021-04-23T05:45:59.601" v="411" actId="1076"/>
          <ac:spMkLst>
            <pc:docMk/>
            <pc:sldMk cId="3597620934" sldId="868"/>
            <ac:spMk id="8" creationId="{B3FC51E9-F524-4F6C-B68B-4AF52BCD7CCC}"/>
          </ac:spMkLst>
        </pc:spChg>
        <pc:spChg chg="mod">
          <ac:chgData name="Tsujimoto,Mitsuhiro 辻本光宏(関東北甲信越統括支店O領域専門室)" userId="7251bc67-91ee-45c9-97e7-9c240c9b485c" providerId="ADAL" clId="{68999E39-5F09-4CF3-B26F-BF167E85A326}" dt="2021-04-23T05:43:56.190" v="251" actId="20577"/>
          <ac:spMkLst>
            <pc:docMk/>
            <pc:sldMk cId="3597620934" sldId="868"/>
            <ac:spMk id="14" creationId="{BB326143-66C6-4594-A01D-3E4C08BB27EF}"/>
          </ac:spMkLst>
        </pc:spChg>
        <pc:picChg chg="del">
          <ac:chgData name="Tsujimoto,Mitsuhiro 辻本光宏(関東北甲信越統括支店O領域専門室)" userId="7251bc67-91ee-45c9-97e7-9c240c9b485c" providerId="ADAL" clId="{68999E39-5F09-4CF3-B26F-BF167E85A326}" dt="2021-04-23T05:42:18.857" v="206" actId="478"/>
          <ac:picMkLst>
            <pc:docMk/>
            <pc:sldMk cId="3597620934" sldId="868"/>
            <ac:picMk id="5" creationId="{5FCA543A-8106-4F4D-A48D-99C96E090CEB}"/>
          </ac:picMkLst>
        </pc:picChg>
        <pc:picChg chg="mod">
          <ac:chgData name="Tsujimoto,Mitsuhiro 辻本光宏(関東北甲信越統括支店O領域専門室)" userId="7251bc67-91ee-45c9-97e7-9c240c9b485c" providerId="ADAL" clId="{68999E39-5F09-4CF3-B26F-BF167E85A326}" dt="2021-04-23T05:45:28.056" v="389" actId="1035"/>
          <ac:picMkLst>
            <pc:docMk/>
            <pc:sldMk cId="3597620934" sldId="868"/>
            <ac:picMk id="6" creationId="{5947BE46-9FF6-4DD7-AD7B-1D4A13506D8B}"/>
          </ac:picMkLst>
        </pc:picChg>
      </pc:sldChg>
      <pc:sldChg chg="addSp delSp modSp add">
        <pc:chgData name="Tsujimoto,Mitsuhiro 辻本光宏(関東北甲信越統括支店O領域専門室)" userId="7251bc67-91ee-45c9-97e7-9c240c9b485c" providerId="ADAL" clId="{68999E39-5F09-4CF3-B26F-BF167E85A326}" dt="2021-04-23T05:50:51.947" v="527" actId="478"/>
        <pc:sldMkLst>
          <pc:docMk/>
          <pc:sldMk cId="2018580732" sldId="869"/>
        </pc:sldMkLst>
        <pc:spChg chg="add mod">
          <ac:chgData name="Tsujimoto,Mitsuhiro 辻本光宏(関東北甲信越統括支店O領域専門室)" userId="7251bc67-91ee-45c9-97e7-9c240c9b485c" providerId="ADAL" clId="{68999E39-5F09-4CF3-B26F-BF167E85A326}" dt="2021-04-23T05:49:42.732" v="429" actId="20577"/>
          <ac:spMkLst>
            <pc:docMk/>
            <pc:sldMk cId="2018580732" sldId="869"/>
            <ac:spMk id="2" creationId="{73A6E657-3F68-4930-8DAB-D1D5C21A981B}"/>
          </ac:spMkLst>
        </pc:spChg>
        <pc:spChg chg="add mod">
          <ac:chgData name="Tsujimoto,Mitsuhiro 辻本光宏(関東北甲信越統括支店O領域専門室)" userId="7251bc67-91ee-45c9-97e7-9c240c9b485c" providerId="ADAL" clId="{68999E39-5F09-4CF3-B26F-BF167E85A326}" dt="2021-04-23T05:50:48.617" v="526"/>
          <ac:spMkLst>
            <pc:docMk/>
            <pc:sldMk cId="2018580732" sldId="869"/>
            <ac:spMk id="3" creationId="{89BD0A32-9705-4E39-A204-9AF3909575A2}"/>
          </ac:spMkLst>
        </pc:spChg>
        <pc:spChg chg="add mod">
          <ac:chgData name="Tsujimoto,Mitsuhiro 辻本光宏(関東北甲信越統括支店O領域専門室)" userId="7251bc67-91ee-45c9-97e7-9c240c9b485c" providerId="ADAL" clId="{68999E39-5F09-4CF3-B26F-BF167E85A326}" dt="2021-04-23T05:50:09.880" v="434" actId="1076"/>
          <ac:spMkLst>
            <pc:docMk/>
            <pc:sldMk cId="2018580732" sldId="869"/>
            <ac:spMk id="76" creationId="{B6B03370-21D3-43E0-B70C-2285D8CD8186}"/>
          </ac:spMkLst>
        </pc:spChg>
        <pc:spChg chg="add mod">
          <ac:chgData name="Tsujimoto,Mitsuhiro 辻本光宏(関東北甲信越統括支店O領域専門室)" userId="7251bc67-91ee-45c9-97e7-9c240c9b485c" providerId="ADAL" clId="{68999E39-5F09-4CF3-B26F-BF167E85A326}" dt="2021-04-23T05:50:15.794" v="435" actId="1076"/>
          <ac:spMkLst>
            <pc:docMk/>
            <pc:sldMk cId="2018580732" sldId="869"/>
            <ac:spMk id="77" creationId="{145DC52E-AD39-4C2A-947A-1F21F4AEF944}"/>
          </ac:spMkLst>
        </pc:spChg>
        <pc:spChg chg="add del">
          <ac:chgData name="Tsujimoto,Mitsuhiro 辻本光宏(関東北甲信越統括支店O領域専門室)" userId="7251bc67-91ee-45c9-97e7-9c240c9b485c" providerId="ADAL" clId="{68999E39-5F09-4CF3-B26F-BF167E85A326}" dt="2021-04-23T05:50:51.947" v="527" actId="478"/>
          <ac:spMkLst>
            <pc:docMk/>
            <pc:sldMk cId="2018580732" sldId="869"/>
            <ac:spMk id="78" creationId="{B7AAAF1B-C455-42FF-9975-5AEB2A97E8D5}"/>
          </ac:spMkLst>
        </pc:spChg>
        <pc:grpChg chg="add mod">
          <ac:chgData name="Tsujimoto,Mitsuhiro 辻本光宏(関東北甲信越統括支店O領域専門室)" userId="7251bc67-91ee-45c9-97e7-9c240c9b485c" providerId="ADAL" clId="{68999E39-5F09-4CF3-B26F-BF167E85A326}" dt="2021-04-23T05:50:09.880" v="434" actId="1076"/>
          <ac:grpSpMkLst>
            <pc:docMk/>
            <pc:sldMk cId="2018580732" sldId="869"/>
            <ac:grpSpMk id="6" creationId="{23CB493D-38DE-49DF-A48F-D3B931014480}"/>
          </ac:grpSpMkLst>
        </pc:grpChg>
        <pc:graphicFrameChg chg="add del">
          <ac:chgData name="Tsujimoto,Mitsuhiro 辻本光宏(関東北甲信越統括支店O領域専門室)" userId="7251bc67-91ee-45c9-97e7-9c240c9b485c" providerId="ADAL" clId="{68999E39-5F09-4CF3-B26F-BF167E85A326}" dt="2021-04-23T05:49:57.039" v="432"/>
          <ac:graphicFrameMkLst>
            <pc:docMk/>
            <pc:sldMk cId="2018580732" sldId="869"/>
            <ac:graphicFrameMk id="4" creationId="{EEE6E342-CF70-4A0F-B485-E5CB703B830B}"/>
          </ac:graphicFrameMkLst>
        </pc:graphicFrameChg>
        <pc:graphicFrameChg chg="add mod">
          <ac:chgData name="Tsujimoto,Mitsuhiro 辻本光宏(関東北甲信越統括支店O領域専門室)" userId="7251bc67-91ee-45c9-97e7-9c240c9b485c" providerId="ADAL" clId="{68999E39-5F09-4CF3-B26F-BF167E85A326}" dt="2021-04-23T05:50:09.880" v="434" actId="1076"/>
          <ac:graphicFrameMkLst>
            <pc:docMk/>
            <pc:sldMk cId="2018580732" sldId="869"/>
            <ac:graphicFrameMk id="5" creationId="{ED32ED50-427B-47FB-A4AC-B5A63C48287D}"/>
          </ac:graphicFrameMkLst>
        </pc:graphicFrameChg>
      </pc:sldChg>
      <pc:sldChg chg="addSp delSp modSp add">
        <pc:chgData name="Tsujimoto,Mitsuhiro 辻本光宏(関東北甲信越統括支店O領域専門室)" userId="7251bc67-91ee-45c9-97e7-9c240c9b485c" providerId="ADAL" clId="{68999E39-5F09-4CF3-B26F-BF167E85A326}" dt="2021-04-23T05:52:05.074" v="567"/>
        <pc:sldMkLst>
          <pc:docMk/>
          <pc:sldMk cId="3791192522" sldId="870"/>
        </pc:sldMkLst>
        <pc:spChg chg="mod">
          <ac:chgData name="Tsujimoto,Mitsuhiro 辻本光宏(関東北甲信越統括支店O領域専門室)" userId="7251bc67-91ee-45c9-97e7-9c240c9b485c" providerId="ADAL" clId="{68999E39-5F09-4CF3-B26F-BF167E85A326}" dt="2021-04-23T05:51:22.089" v="535" actId="20577"/>
          <ac:spMkLst>
            <pc:docMk/>
            <pc:sldMk cId="3791192522" sldId="870"/>
            <ac:spMk id="2" creationId="{73A6E657-3F68-4930-8DAB-D1D5C21A981B}"/>
          </ac:spMkLst>
        </pc:spChg>
        <pc:spChg chg="mod">
          <ac:chgData name="Tsujimoto,Mitsuhiro 辻本光宏(関東北甲信越統括支店O領域専門室)" userId="7251bc67-91ee-45c9-97e7-9c240c9b485c" providerId="ADAL" clId="{68999E39-5F09-4CF3-B26F-BF167E85A326}" dt="2021-04-23T05:52:05.074" v="567"/>
          <ac:spMkLst>
            <pc:docMk/>
            <pc:sldMk cId="3791192522" sldId="870"/>
            <ac:spMk id="3" creationId="{89BD0A32-9705-4E39-A204-9AF3909575A2}"/>
          </ac:spMkLst>
        </pc:spChg>
        <pc:spChg chg="del">
          <ac:chgData name="Tsujimoto,Mitsuhiro 辻本光宏(関東北甲信越統括支店O領域専門室)" userId="7251bc67-91ee-45c9-97e7-9c240c9b485c" providerId="ADAL" clId="{68999E39-5F09-4CF3-B26F-BF167E85A326}" dt="2021-04-23T05:51:28.131" v="536" actId="478"/>
          <ac:spMkLst>
            <pc:docMk/>
            <pc:sldMk cId="3791192522" sldId="870"/>
            <ac:spMk id="76" creationId="{B6B03370-21D3-43E0-B70C-2285D8CD8186}"/>
          </ac:spMkLst>
        </pc:spChg>
        <pc:spChg chg="add mod">
          <ac:chgData name="Tsujimoto,Mitsuhiro 辻本光宏(関東北甲信越統括支店O領域専門室)" userId="7251bc67-91ee-45c9-97e7-9c240c9b485c" providerId="ADAL" clId="{68999E39-5F09-4CF3-B26F-BF167E85A326}" dt="2021-04-23T05:51:48.507" v="540" actId="1035"/>
          <ac:spMkLst>
            <pc:docMk/>
            <pc:sldMk cId="3791192522" sldId="870"/>
            <ac:spMk id="149" creationId="{AA31F457-A3BF-4F01-A950-DD8A96EB24C3}"/>
          </ac:spMkLst>
        </pc:spChg>
        <pc:grpChg chg="del">
          <ac:chgData name="Tsujimoto,Mitsuhiro 辻本光宏(関東北甲信越統括支店O領域専門室)" userId="7251bc67-91ee-45c9-97e7-9c240c9b485c" providerId="ADAL" clId="{68999E39-5F09-4CF3-B26F-BF167E85A326}" dt="2021-04-23T05:51:28.131" v="536" actId="478"/>
          <ac:grpSpMkLst>
            <pc:docMk/>
            <pc:sldMk cId="3791192522" sldId="870"/>
            <ac:grpSpMk id="6" creationId="{23CB493D-38DE-49DF-A48F-D3B931014480}"/>
          </ac:grpSpMkLst>
        </pc:grpChg>
        <pc:grpChg chg="add mod">
          <ac:chgData name="Tsujimoto,Mitsuhiro 辻本光宏(関東北甲信越統括支店O領域専門室)" userId="7251bc67-91ee-45c9-97e7-9c240c9b485c" providerId="ADAL" clId="{68999E39-5F09-4CF3-B26F-BF167E85A326}" dt="2021-04-23T05:51:48.507" v="540" actId="1035"/>
          <ac:grpSpMkLst>
            <pc:docMk/>
            <pc:sldMk cId="3791192522" sldId="870"/>
            <ac:grpSpMk id="79" creationId="{EF820866-4D3B-429E-B1A3-B9945FBC0274}"/>
          </ac:grpSpMkLst>
        </pc:grpChg>
        <pc:graphicFrameChg chg="del">
          <ac:chgData name="Tsujimoto,Mitsuhiro 辻本光宏(関東北甲信越統括支店O領域専門室)" userId="7251bc67-91ee-45c9-97e7-9c240c9b485c" providerId="ADAL" clId="{68999E39-5F09-4CF3-B26F-BF167E85A326}" dt="2021-04-23T05:51:28.131" v="536" actId="478"/>
          <ac:graphicFrameMkLst>
            <pc:docMk/>
            <pc:sldMk cId="3791192522" sldId="870"/>
            <ac:graphicFrameMk id="5" creationId="{ED32ED50-427B-47FB-A4AC-B5A63C48287D}"/>
          </ac:graphicFrameMkLst>
        </pc:graphicFrameChg>
        <pc:graphicFrameChg chg="add mod">
          <ac:chgData name="Tsujimoto,Mitsuhiro 辻本光宏(関東北甲信越統括支店O領域専門室)" userId="7251bc67-91ee-45c9-97e7-9c240c9b485c" providerId="ADAL" clId="{68999E39-5F09-4CF3-B26F-BF167E85A326}" dt="2021-04-23T05:51:48.507" v="540" actId="1035"/>
          <ac:graphicFrameMkLst>
            <pc:docMk/>
            <pc:sldMk cId="3791192522" sldId="870"/>
            <ac:graphicFrameMk id="78" creationId="{8FECEEE7-CAC5-40D2-B550-7CAB18A00CF8}"/>
          </ac:graphicFrameMkLst>
        </pc:graphicFrameChg>
      </pc:sldChg>
      <pc:sldChg chg="addSp delSp modSp add">
        <pc:chgData name="Tsujimoto,Mitsuhiro 辻本光宏(関東北甲信越統括支店O領域専門室)" userId="7251bc67-91ee-45c9-97e7-9c240c9b485c" providerId="ADAL" clId="{68999E39-5F09-4CF3-B26F-BF167E85A326}" dt="2021-04-23T05:58:24.543" v="990" actId="207"/>
        <pc:sldMkLst>
          <pc:docMk/>
          <pc:sldMk cId="4286481177" sldId="871"/>
        </pc:sldMkLst>
        <pc:spChg chg="mod">
          <ac:chgData name="Tsujimoto,Mitsuhiro 辻本光宏(関東北甲信越統括支店O領域専門室)" userId="7251bc67-91ee-45c9-97e7-9c240c9b485c" providerId="ADAL" clId="{68999E39-5F09-4CF3-B26F-BF167E85A326}" dt="2021-04-23T05:56:27.979" v="616"/>
          <ac:spMkLst>
            <pc:docMk/>
            <pc:sldMk cId="4286481177" sldId="871"/>
            <ac:spMk id="2" creationId="{84EF22D3-4978-47AC-8C95-0E01BAE7E78B}"/>
          </ac:spMkLst>
        </pc:spChg>
        <pc:spChg chg="add del mod">
          <ac:chgData name="Tsujimoto,Mitsuhiro 辻本光宏(関東北甲信越統括支店O領域専門室)" userId="7251bc67-91ee-45c9-97e7-9c240c9b485c" providerId="ADAL" clId="{68999E39-5F09-4CF3-B26F-BF167E85A326}" dt="2021-04-23T05:58:16.760" v="989" actId="478"/>
          <ac:spMkLst>
            <pc:docMk/>
            <pc:sldMk cId="4286481177" sldId="871"/>
            <ac:spMk id="4" creationId="{BA67C519-10E5-43E3-92A8-3A8047C1C5D9}"/>
          </ac:spMkLst>
        </pc:spChg>
        <pc:spChg chg="mod">
          <ac:chgData name="Tsujimoto,Mitsuhiro 辻本光宏(関東北甲信越統括支店O領域専門室)" userId="7251bc67-91ee-45c9-97e7-9c240c9b485c" providerId="ADAL" clId="{68999E39-5F09-4CF3-B26F-BF167E85A326}" dt="2021-04-23T05:58:24.543" v="990" actId="207"/>
          <ac:spMkLst>
            <pc:docMk/>
            <pc:sldMk cId="4286481177" sldId="871"/>
            <ac:spMk id="5" creationId="{52708625-118C-4AF9-A524-AFAD6E7A7550}"/>
          </ac:spMkLst>
        </pc:spChg>
      </pc:sldChg>
      <pc:sldChg chg="addSp delSp modSp add">
        <pc:chgData name="Tsujimoto,Mitsuhiro 辻本光宏(関東北甲信越統括支店O領域専門室)" userId="7251bc67-91ee-45c9-97e7-9c240c9b485c" providerId="ADAL" clId="{68999E39-5F09-4CF3-B26F-BF167E85A326}" dt="2021-04-23T07:39:46.502" v="2338" actId="1076"/>
        <pc:sldMkLst>
          <pc:docMk/>
          <pc:sldMk cId="2179113742" sldId="872"/>
        </pc:sldMkLst>
        <pc:spChg chg="add mod">
          <ac:chgData name="Tsujimoto,Mitsuhiro 辻本光宏(関東北甲信越統括支店O領域専門室)" userId="7251bc67-91ee-45c9-97e7-9c240c9b485c" providerId="ADAL" clId="{68999E39-5F09-4CF3-B26F-BF167E85A326}" dt="2021-04-23T06:15:06.839" v="1076" actId="20577"/>
          <ac:spMkLst>
            <pc:docMk/>
            <pc:sldMk cId="2179113742" sldId="872"/>
            <ac:spMk id="2" creationId="{55283425-6940-4DCA-B37F-C9F2D58E3D2E}"/>
          </ac:spMkLst>
        </pc:spChg>
        <pc:spChg chg="add del mod">
          <ac:chgData name="Tsujimoto,Mitsuhiro 辻本光宏(関東北甲信越統括支店O領域専門室)" userId="7251bc67-91ee-45c9-97e7-9c240c9b485c" providerId="ADAL" clId="{68999E39-5F09-4CF3-B26F-BF167E85A326}" dt="2021-04-23T06:17:06.810" v="1080" actId="478"/>
          <ac:spMkLst>
            <pc:docMk/>
            <pc:sldMk cId="2179113742" sldId="872"/>
            <ac:spMk id="7" creationId="{797B6465-FD0C-4788-85AE-43DED78B5D03}"/>
          </ac:spMkLst>
        </pc:spChg>
        <pc:spChg chg="add del mod">
          <ac:chgData name="Tsujimoto,Mitsuhiro 辻本光宏(関東北甲信越統括支店O領域専門室)" userId="7251bc67-91ee-45c9-97e7-9c240c9b485c" providerId="ADAL" clId="{68999E39-5F09-4CF3-B26F-BF167E85A326}" dt="2021-04-23T06:17:06.810" v="1080" actId="478"/>
          <ac:spMkLst>
            <pc:docMk/>
            <pc:sldMk cId="2179113742" sldId="872"/>
            <ac:spMk id="8" creationId="{0E7CC1B0-0887-4489-B1F1-A6D77AF78261}"/>
          </ac:spMkLst>
        </pc:spChg>
        <pc:spChg chg="add del mod">
          <ac:chgData name="Tsujimoto,Mitsuhiro 辻本光宏(関東北甲信越統括支店O領域専門室)" userId="7251bc67-91ee-45c9-97e7-9c240c9b485c" providerId="ADAL" clId="{68999E39-5F09-4CF3-B26F-BF167E85A326}" dt="2021-04-23T06:17:06.810" v="1080" actId="478"/>
          <ac:spMkLst>
            <pc:docMk/>
            <pc:sldMk cId="2179113742" sldId="872"/>
            <ac:spMk id="9" creationId="{3EA2A7E3-88DD-46E9-A364-80491062BDAC}"/>
          </ac:spMkLst>
        </pc:spChg>
        <pc:spChg chg="add mod">
          <ac:chgData name="Tsujimoto,Mitsuhiro 辻本光宏(関東北甲信越統括支店O領域専門室)" userId="7251bc67-91ee-45c9-97e7-9c240c9b485c" providerId="ADAL" clId="{68999E39-5F09-4CF3-B26F-BF167E85A326}" dt="2021-04-23T06:20:20.538" v="1613"/>
          <ac:spMkLst>
            <pc:docMk/>
            <pc:sldMk cId="2179113742" sldId="872"/>
            <ac:spMk id="10" creationId="{F374088C-9D62-4B6C-BA82-E36B17E4675D}"/>
          </ac:spMkLst>
        </pc:spChg>
        <pc:spChg chg="add del mod">
          <ac:chgData name="Tsujimoto,Mitsuhiro 辻本光宏(関東北甲信越統括支店O領域専門室)" userId="7251bc67-91ee-45c9-97e7-9c240c9b485c" providerId="ADAL" clId="{68999E39-5F09-4CF3-B26F-BF167E85A326}" dt="2021-04-23T06:19:53.432" v="1466" actId="478"/>
          <ac:spMkLst>
            <pc:docMk/>
            <pc:sldMk cId="2179113742" sldId="872"/>
            <ac:spMk id="11" creationId="{165E7815-6F20-4A54-9CFE-9AA3F71392F3}"/>
          </ac:spMkLst>
        </pc:spChg>
        <pc:spChg chg="add del mod">
          <ac:chgData name="Tsujimoto,Mitsuhiro 辻本光宏(関東北甲信越統括支店O領域専門室)" userId="7251bc67-91ee-45c9-97e7-9c240c9b485c" providerId="ADAL" clId="{68999E39-5F09-4CF3-B26F-BF167E85A326}" dt="2021-04-23T06:20:23.233" v="1614" actId="478"/>
          <ac:spMkLst>
            <pc:docMk/>
            <pc:sldMk cId="2179113742" sldId="872"/>
            <ac:spMk id="12" creationId="{0DF5C861-2179-4DFA-BBDE-B1C4C4FE2372}"/>
          </ac:spMkLst>
        </pc:spChg>
        <pc:spChg chg="add mod">
          <ac:chgData name="Tsujimoto,Mitsuhiro 辻本光宏(関東北甲信越統括支店O領域専門室)" userId="7251bc67-91ee-45c9-97e7-9c240c9b485c" providerId="ADAL" clId="{68999E39-5F09-4CF3-B26F-BF167E85A326}" dt="2021-04-23T06:21:07.752" v="1626" actId="1076"/>
          <ac:spMkLst>
            <pc:docMk/>
            <pc:sldMk cId="2179113742" sldId="872"/>
            <ac:spMk id="13" creationId="{113ABC44-4DEF-480C-8170-7876D2FDFBF5}"/>
          </ac:spMkLst>
        </pc:spChg>
        <pc:spChg chg="add mod">
          <ac:chgData name="Tsujimoto,Mitsuhiro 辻本光宏(関東北甲信越統括支店O領域専門室)" userId="7251bc67-91ee-45c9-97e7-9c240c9b485c" providerId="ADAL" clId="{68999E39-5F09-4CF3-B26F-BF167E85A326}" dt="2021-04-23T06:22:11.666" v="1647" actId="14100"/>
          <ac:spMkLst>
            <pc:docMk/>
            <pc:sldMk cId="2179113742" sldId="872"/>
            <ac:spMk id="17" creationId="{3D2671F3-1F55-48EB-B23A-33DAF11F2543}"/>
          </ac:spMkLst>
        </pc:spChg>
        <pc:spChg chg="add mod">
          <ac:chgData name="Tsujimoto,Mitsuhiro 辻本光宏(関東北甲信越統括支店O領域専門室)" userId="7251bc67-91ee-45c9-97e7-9c240c9b485c" providerId="ADAL" clId="{68999E39-5F09-4CF3-B26F-BF167E85A326}" dt="2021-04-23T06:22:26.784" v="1656" actId="1036"/>
          <ac:spMkLst>
            <pc:docMk/>
            <pc:sldMk cId="2179113742" sldId="872"/>
            <ac:spMk id="18" creationId="{24E6D100-085A-4015-AC2E-F67C422F69CD}"/>
          </ac:spMkLst>
        </pc:spChg>
        <pc:spChg chg="add mod">
          <ac:chgData name="Tsujimoto,Mitsuhiro 辻本光宏(関東北甲信越統括支店O領域専門室)" userId="7251bc67-91ee-45c9-97e7-9c240c9b485c" providerId="ADAL" clId="{68999E39-5F09-4CF3-B26F-BF167E85A326}" dt="2021-04-23T06:22:46.032" v="1662" actId="14100"/>
          <ac:spMkLst>
            <pc:docMk/>
            <pc:sldMk cId="2179113742" sldId="872"/>
            <ac:spMk id="19" creationId="{9B0496F2-4667-4226-A84E-D9535FF4C529}"/>
          </ac:spMkLst>
        </pc:spChg>
        <pc:picChg chg="add mod">
          <ac:chgData name="Tsujimoto,Mitsuhiro 辻本光宏(関東北甲信越統括支店O領域専門室)" userId="7251bc67-91ee-45c9-97e7-9c240c9b485c" providerId="ADAL" clId="{68999E39-5F09-4CF3-B26F-BF167E85A326}" dt="2021-04-23T07:39:46.502" v="2338" actId="1076"/>
          <ac:picMkLst>
            <pc:docMk/>
            <pc:sldMk cId="2179113742" sldId="872"/>
            <ac:picMk id="3" creationId="{179D2A33-F000-42E4-8A56-B59FB0000C2A}"/>
          </ac:picMkLst>
        </pc:picChg>
        <pc:picChg chg="add mod">
          <ac:chgData name="Tsujimoto,Mitsuhiro 辻本光宏(関東北甲信越統括支店O領域専門室)" userId="7251bc67-91ee-45c9-97e7-9c240c9b485c" providerId="ADAL" clId="{68999E39-5F09-4CF3-B26F-BF167E85A326}" dt="2021-04-23T06:22:16.278" v="1649" actId="1076"/>
          <ac:picMkLst>
            <pc:docMk/>
            <pc:sldMk cId="2179113742" sldId="872"/>
            <ac:picMk id="4" creationId="{49849105-BA61-4CB8-B3C8-E6BB931EF80F}"/>
          </ac:picMkLst>
        </pc:picChg>
        <pc:cxnChg chg="add del mod">
          <ac:chgData name="Tsujimoto,Mitsuhiro 辻本光宏(関東北甲信越統括支店O領域専門室)" userId="7251bc67-91ee-45c9-97e7-9c240c9b485c" providerId="ADAL" clId="{68999E39-5F09-4CF3-B26F-BF167E85A326}" dt="2021-04-23T06:21:35.330" v="1641" actId="478"/>
          <ac:cxnSpMkLst>
            <pc:docMk/>
            <pc:sldMk cId="2179113742" sldId="872"/>
            <ac:cxnSpMk id="5" creationId="{86DC84ED-CCE7-4DE3-B103-6FA8EF92DC83}"/>
          </ac:cxnSpMkLst>
        </pc:cxnChg>
        <pc:cxnChg chg="add mod">
          <ac:chgData name="Tsujimoto,Mitsuhiro 辻本光宏(関東北甲信越統括支店O領域専門室)" userId="7251bc67-91ee-45c9-97e7-9c240c9b485c" providerId="ADAL" clId="{68999E39-5F09-4CF3-B26F-BF167E85A326}" dt="2021-04-23T06:21:22.965" v="1631" actId="1035"/>
          <ac:cxnSpMkLst>
            <pc:docMk/>
            <pc:sldMk cId="2179113742" sldId="872"/>
            <ac:cxnSpMk id="6" creationId="{060E5A80-1068-44EE-81AB-A01E92BC7A7C}"/>
          </ac:cxnSpMkLst>
        </pc:cxnChg>
        <pc:cxnChg chg="add mod">
          <ac:chgData name="Tsujimoto,Mitsuhiro 辻本光宏(関東北甲信越統括支店O領域専門室)" userId="7251bc67-91ee-45c9-97e7-9c240c9b485c" providerId="ADAL" clId="{68999E39-5F09-4CF3-B26F-BF167E85A326}" dt="2021-04-23T06:21:33.683" v="1640" actId="14100"/>
          <ac:cxnSpMkLst>
            <pc:docMk/>
            <pc:sldMk cId="2179113742" sldId="872"/>
            <ac:cxnSpMk id="15" creationId="{FB756C28-30C4-45F8-AF1C-727761F401CF}"/>
          </ac:cxnSpMkLst>
        </pc:cxnChg>
      </pc:sldChg>
      <pc:sldChg chg="addSp delSp modSp add">
        <pc:chgData name="Tsujimoto,Mitsuhiro 辻本光宏(関東北甲信越統括支店O領域専門室)" userId="7251bc67-91ee-45c9-97e7-9c240c9b485c" providerId="ADAL" clId="{68999E39-5F09-4CF3-B26F-BF167E85A326}" dt="2021-04-23T06:32:05.514" v="2271" actId="1076"/>
        <pc:sldMkLst>
          <pc:docMk/>
          <pc:sldMk cId="1286954728" sldId="873"/>
        </pc:sldMkLst>
        <pc:spChg chg="add mod">
          <ac:chgData name="Tsujimoto,Mitsuhiro 辻本光宏(関東北甲信越統括支店O領域専門室)" userId="7251bc67-91ee-45c9-97e7-9c240c9b485c" providerId="ADAL" clId="{68999E39-5F09-4CF3-B26F-BF167E85A326}" dt="2021-04-23T06:25:59.181" v="1767" actId="20577"/>
          <ac:spMkLst>
            <pc:docMk/>
            <pc:sldMk cId="1286954728" sldId="873"/>
            <ac:spMk id="2" creationId="{DCAD9A7E-F7E6-4FC6-A03F-56C326164644}"/>
          </ac:spMkLst>
        </pc:spChg>
        <pc:spChg chg="add mod">
          <ac:chgData name="Tsujimoto,Mitsuhiro 辻本光宏(関東北甲信越統括支店O領域専門室)" userId="7251bc67-91ee-45c9-97e7-9c240c9b485c" providerId="ADAL" clId="{68999E39-5F09-4CF3-B26F-BF167E85A326}" dt="2021-04-23T06:28:00.468" v="2147" actId="6549"/>
          <ac:spMkLst>
            <pc:docMk/>
            <pc:sldMk cId="1286954728" sldId="873"/>
            <ac:spMk id="3" creationId="{DFB0FD30-1212-459B-97CD-F2A59596FD0C}"/>
          </ac:spMkLst>
        </pc:spChg>
        <pc:spChg chg="add del">
          <ac:chgData name="Tsujimoto,Mitsuhiro 辻本光宏(関東北甲信越統括支店O領域専門室)" userId="7251bc67-91ee-45c9-97e7-9c240c9b485c" providerId="ADAL" clId="{68999E39-5F09-4CF3-B26F-BF167E85A326}" dt="2021-04-23T06:27:40.139" v="2040" actId="478"/>
          <ac:spMkLst>
            <pc:docMk/>
            <pc:sldMk cId="1286954728" sldId="873"/>
            <ac:spMk id="4" creationId="{FCC6CB55-CA01-4469-B4D2-784F59B12E2D}"/>
          </ac:spMkLst>
        </pc:spChg>
        <pc:spChg chg="add del">
          <ac:chgData name="Tsujimoto,Mitsuhiro 辻本光宏(関東北甲信越統括支店O領域専門室)" userId="7251bc67-91ee-45c9-97e7-9c240c9b485c" providerId="ADAL" clId="{68999E39-5F09-4CF3-B26F-BF167E85A326}" dt="2021-04-23T06:28:05.323" v="2148" actId="478"/>
          <ac:spMkLst>
            <pc:docMk/>
            <pc:sldMk cId="1286954728" sldId="873"/>
            <ac:spMk id="5" creationId="{ECE42EDC-7AC3-441F-8BF3-3A67F72A709F}"/>
          </ac:spMkLst>
        </pc:spChg>
        <pc:spChg chg="add mod">
          <ac:chgData name="Tsujimoto,Mitsuhiro 辻本光宏(関東北甲信越統括支店O領域専門室)" userId="7251bc67-91ee-45c9-97e7-9c240c9b485c" providerId="ADAL" clId="{68999E39-5F09-4CF3-B26F-BF167E85A326}" dt="2021-04-23T06:31:25.619" v="2256" actId="1076"/>
          <ac:spMkLst>
            <pc:docMk/>
            <pc:sldMk cId="1286954728" sldId="873"/>
            <ac:spMk id="13" creationId="{B7242912-B295-483D-A37F-7FA6CEDE2336}"/>
          </ac:spMkLst>
        </pc:spChg>
        <pc:spChg chg="add mod">
          <ac:chgData name="Tsujimoto,Mitsuhiro 辻本光宏(関東北甲信越統括支店O領域専門室)" userId="7251bc67-91ee-45c9-97e7-9c240c9b485c" providerId="ADAL" clId="{68999E39-5F09-4CF3-B26F-BF167E85A326}" dt="2021-04-23T06:31:42.808" v="2265" actId="20577"/>
          <ac:spMkLst>
            <pc:docMk/>
            <pc:sldMk cId="1286954728" sldId="873"/>
            <ac:spMk id="14" creationId="{3C95BFF0-5D89-4EC1-B0EE-49EAF53AC2FB}"/>
          </ac:spMkLst>
        </pc:spChg>
        <pc:spChg chg="add del">
          <ac:chgData name="Tsujimoto,Mitsuhiro 辻本光宏(関東北甲信越統括支店O領域専門室)" userId="7251bc67-91ee-45c9-97e7-9c240c9b485c" providerId="ADAL" clId="{68999E39-5F09-4CF3-B26F-BF167E85A326}" dt="2021-04-23T06:31:59.754" v="2268"/>
          <ac:spMkLst>
            <pc:docMk/>
            <pc:sldMk cId="1286954728" sldId="873"/>
            <ac:spMk id="15" creationId="{F5FAA31F-B8E9-4DED-A56E-DF01231E5C79}"/>
          </ac:spMkLst>
        </pc:spChg>
        <pc:spChg chg="add mod">
          <ac:chgData name="Tsujimoto,Mitsuhiro 辻本光宏(関東北甲信越統括支店O領域専門室)" userId="7251bc67-91ee-45c9-97e7-9c240c9b485c" providerId="ADAL" clId="{68999E39-5F09-4CF3-B26F-BF167E85A326}" dt="2021-04-23T06:32:05.514" v="2271" actId="1076"/>
          <ac:spMkLst>
            <pc:docMk/>
            <pc:sldMk cId="1286954728" sldId="873"/>
            <ac:spMk id="16" creationId="{12CA189F-0797-4BE5-8D23-B2CA2FF7E9C3}"/>
          </ac:spMkLst>
        </pc:spChg>
        <pc:picChg chg="add mod">
          <ac:chgData name="Tsujimoto,Mitsuhiro 辻本光宏(関東北甲信越統括支店O領域専門室)" userId="7251bc67-91ee-45c9-97e7-9c240c9b485c" providerId="ADAL" clId="{68999E39-5F09-4CF3-B26F-BF167E85A326}" dt="2021-04-23T06:31:29.175" v="2259" actId="1076"/>
          <ac:picMkLst>
            <pc:docMk/>
            <pc:sldMk cId="1286954728" sldId="873"/>
            <ac:picMk id="6" creationId="{7B2FF073-1DA5-4E07-B6DE-72E198655E6D}"/>
          </ac:picMkLst>
        </pc:picChg>
        <pc:picChg chg="add mod">
          <ac:chgData name="Tsujimoto,Mitsuhiro 辻本光宏(関東北甲信越統括支店O領域専門室)" userId="7251bc67-91ee-45c9-97e7-9c240c9b485c" providerId="ADAL" clId="{68999E39-5F09-4CF3-B26F-BF167E85A326}" dt="2021-04-23T06:30:33.873" v="2248" actId="1036"/>
          <ac:picMkLst>
            <pc:docMk/>
            <pc:sldMk cId="1286954728" sldId="873"/>
            <ac:picMk id="7" creationId="{3E4104AD-DF82-479C-9AAD-0F2E64D04191}"/>
          </ac:picMkLst>
        </pc:picChg>
        <pc:picChg chg="add mod">
          <ac:chgData name="Tsujimoto,Mitsuhiro 辻本光宏(関東北甲信越統括支店O領域専門室)" userId="7251bc67-91ee-45c9-97e7-9c240c9b485c" providerId="ADAL" clId="{68999E39-5F09-4CF3-B26F-BF167E85A326}" dt="2021-04-23T06:30:33.873" v="2248" actId="1036"/>
          <ac:picMkLst>
            <pc:docMk/>
            <pc:sldMk cId="1286954728" sldId="873"/>
            <ac:picMk id="8" creationId="{4EDCC856-F1F0-4612-A03E-9847B2D73882}"/>
          </ac:picMkLst>
        </pc:picChg>
        <pc:picChg chg="add mod">
          <ac:chgData name="Tsujimoto,Mitsuhiro 辻本光宏(関東北甲信越統括支店O領域専門室)" userId="7251bc67-91ee-45c9-97e7-9c240c9b485c" providerId="ADAL" clId="{68999E39-5F09-4CF3-B26F-BF167E85A326}" dt="2021-04-23T06:30:33.873" v="2248" actId="1036"/>
          <ac:picMkLst>
            <pc:docMk/>
            <pc:sldMk cId="1286954728" sldId="873"/>
            <ac:picMk id="9" creationId="{203E424E-1863-4100-A9C4-1389F1DD04EE}"/>
          </ac:picMkLst>
        </pc:picChg>
        <pc:picChg chg="add mod modCrop">
          <ac:chgData name="Tsujimoto,Mitsuhiro 辻本光宏(関東北甲信越統括支店O領域専門室)" userId="7251bc67-91ee-45c9-97e7-9c240c9b485c" providerId="ADAL" clId="{68999E39-5F09-4CF3-B26F-BF167E85A326}" dt="2021-04-23T06:30:33.873" v="2248" actId="1036"/>
          <ac:picMkLst>
            <pc:docMk/>
            <pc:sldMk cId="1286954728" sldId="873"/>
            <ac:picMk id="10" creationId="{56E4B317-B61C-4259-B757-4AF7F7B28DCE}"/>
          </ac:picMkLst>
        </pc:picChg>
        <pc:picChg chg="add mod">
          <ac:chgData name="Tsujimoto,Mitsuhiro 辻本光宏(関東北甲信越統括支店O領域専門室)" userId="7251bc67-91ee-45c9-97e7-9c240c9b485c" providerId="ADAL" clId="{68999E39-5F09-4CF3-B26F-BF167E85A326}" dt="2021-04-23T06:30:33.873" v="2248" actId="1036"/>
          <ac:picMkLst>
            <pc:docMk/>
            <pc:sldMk cId="1286954728" sldId="873"/>
            <ac:picMk id="11" creationId="{22B965DC-7123-4035-BBA6-A5D55C1EC3CC}"/>
          </ac:picMkLst>
        </pc:picChg>
        <pc:picChg chg="add mod">
          <ac:chgData name="Tsujimoto,Mitsuhiro 辻本光宏(関東北甲信越統括支店O領域専門室)" userId="7251bc67-91ee-45c9-97e7-9c240c9b485c" providerId="ADAL" clId="{68999E39-5F09-4CF3-B26F-BF167E85A326}" dt="2021-04-23T06:31:52.045" v="2266" actId="208"/>
          <ac:picMkLst>
            <pc:docMk/>
            <pc:sldMk cId="1286954728" sldId="873"/>
            <ac:picMk id="12" creationId="{5A6AB464-3BC6-4B05-BEE3-22A57996ADF5}"/>
          </ac:picMkLst>
        </pc:picChg>
      </pc:sldChg>
      <pc:sldMasterChg chg="del delSldLayout">
        <pc:chgData name="Tsujimoto,Mitsuhiro 辻本光宏(関東北甲信越統括支店O領域専門室)" userId="7251bc67-91ee-45c9-97e7-9c240c9b485c" providerId="ADAL" clId="{68999E39-5F09-4CF3-B26F-BF167E85A326}" dt="2021-04-23T07:40:37.666" v="2392" actId="2696"/>
        <pc:sldMasterMkLst>
          <pc:docMk/>
          <pc:sldMasterMk cId="840570227" sldId="2147483675"/>
        </pc:sldMasterMkLst>
        <pc:sldLayoutChg chg="del">
          <pc:chgData name="Tsujimoto,Mitsuhiro 辻本光宏(関東北甲信越統括支店O領域専門室)" userId="7251bc67-91ee-45c9-97e7-9c240c9b485c" providerId="ADAL" clId="{68999E39-5F09-4CF3-B26F-BF167E85A326}" dt="2021-04-23T07:40:37.653" v="2381" actId="2696"/>
          <pc:sldLayoutMkLst>
            <pc:docMk/>
            <pc:sldMasterMk cId="840570227" sldId="2147483675"/>
            <pc:sldLayoutMk cId="508598554" sldId="2147483676"/>
          </pc:sldLayoutMkLst>
        </pc:sldLayoutChg>
        <pc:sldLayoutChg chg="del">
          <pc:chgData name="Tsujimoto,Mitsuhiro 辻本光宏(関東北甲信越統括支店O領域専門室)" userId="7251bc67-91ee-45c9-97e7-9c240c9b485c" providerId="ADAL" clId="{68999E39-5F09-4CF3-B26F-BF167E85A326}" dt="2021-04-23T07:40:37.654" v="2382" actId="2696"/>
          <pc:sldLayoutMkLst>
            <pc:docMk/>
            <pc:sldMasterMk cId="840570227" sldId="2147483675"/>
            <pc:sldLayoutMk cId="2390005338" sldId="2147483677"/>
          </pc:sldLayoutMkLst>
        </pc:sldLayoutChg>
        <pc:sldLayoutChg chg="del">
          <pc:chgData name="Tsujimoto,Mitsuhiro 辻本光宏(関東北甲信越統括支店O領域専門室)" userId="7251bc67-91ee-45c9-97e7-9c240c9b485c" providerId="ADAL" clId="{68999E39-5F09-4CF3-B26F-BF167E85A326}" dt="2021-04-23T07:40:37.655" v="2383" actId="2696"/>
          <pc:sldLayoutMkLst>
            <pc:docMk/>
            <pc:sldMasterMk cId="840570227" sldId="2147483675"/>
            <pc:sldLayoutMk cId="2207446214" sldId="2147483678"/>
          </pc:sldLayoutMkLst>
        </pc:sldLayoutChg>
        <pc:sldLayoutChg chg="del">
          <pc:chgData name="Tsujimoto,Mitsuhiro 辻本光宏(関東北甲信越統括支店O領域専門室)" userId="7251bc67-91ee-45c9-97e7-9c240c9b485c" providerId="ADAL" clId="{68999E39-5F09-4CF3-B26F-BF167E85A326}" dt="2021-04-23T07:40:37.656" v="2384" actId="2696"/>
          <pc:sldLayoutMkLst>
            <pc:docMk/>
            <pc:sldMasterMk cId="840570227" sldId="2147483675"/>
            <pc:sldLayoutMk cId="3026301912" sldId="2147483679"/>
          </pc:sldLayoutMkLst>
        </pc:sldLayoutChg>
        <pc:sldLayoutChg chg="del">
          <pc:chgData name="Tsujimoto,Mitsuhiro 辻本光宏(関東北甲信越統括支店O領域専門室)" userId="7251bc67-91ee-45c9-97e7-9c240c9b485c" providerId="ADAL" clId="{68999E39-5F09-4CF3-B26F-BF167E85A326}" dt="2021-04-23T07:40:37.658" v="2385" actId="2696"/>
          <pc:sldLayoutMkLst>
            <pc:docMk/>
            <pc:sldMasterMk cId="840570227" sldId="2147483675"/>
            <pc:sldLayoutMk cId="1685589534" sldId="2147483680"/>
          </pc:sldLayoutMkLst>
        </pc:sldLayoutChg>
        <pc:sldLayoutChg chg="del">
          <pc:chgData name="Tsujimoto,Mitsuhiro 辻本光宏(関東北甲信越統括支店O領域専門室)" userId="7251bc67-91ee-45c9-97e7-9c240c9b485c" providerId="ADAL" clId="{68999E39-5F09-4CF3-B26F-BF167E85A326}" dt="2021-04-23T07:40:37.659" v="2386" actId="2696"/>
          <pc:sldLayoutMkLst>
            <pc:docMk/>
            <pc:sldMasterMk cId="840570227" sldId="2147483675"/>
            <pc:sldLayoutMk cId="2611559884" sldId="2147483681"/>
          </pc:sldLayoutMkLst>
        </pc:sldLayoutChg>
        <pc:sldLayoutChg chg="del">
          <pc:chgData name="Tsujimoto,Mitsuhiro 辻本光宏(関東北甲信越統括支店O領域専門室)" userId="7251bc67-91ee-45c9-97e7-9c240c9b485c" providerId="ADAL" clId="{68999E39-5F09-4CF3-B26F-BF167E85A326}" dt="2021-04-23T07:40:37.659" v="2387" actId="2696"/>
          <pc:sldLayoutMkLst>
            <pc:docMk/>
            <pc:sldMasterMk cId="840570227" sldId="2147483675"/>
            <pc:sldLayoutMk cId="3012993469" sldId="2147483682"/>
          </pc:sldLayoutMkLst>
        </pc:sldLayoutChg>
        <pc:sldLayoutChg chg="del">
          <pc:chgData name="Tsujimoto,Mitsuhiro 辻本光宏(関東北甲信越統括支店O領域専門室)" userId="7251bc67-91ee-45c9-97e7-9c240c9b485c" providerId="ADAL" clId="{68999E39-5F09-4CF3-B26F-BF167E85A326}" dt="2021-04-23T07:40:37.660" v="2388" actId="2696"/>
          <pc:sldLayoutMkLst>
            <pc:docMk/>
            <pc:sldMasterMk cId="840570227" sldId="2147483675"/>
            <pc:sldLayoutMk cId="1992686844" sldId="2147483683"/>
          </pc:sldLayoutMkLst>
        </pc:sldLayoutChg>
        <pc:sldLayoutChg chg="del">
          <pc:chgData name="Tsujimoto,Mitsuhiro 辻本光宏(関東北甲信越統括支店O領域専門室)" userId="7251bc67-91ee-45c9-97e7-9c240c9b485c" providerId="ADAL" clId="{68999E39-5F09-4CF3-B26F-BF167E85A326}" dt="2021-04-23T07:40:37.661" v="2389" actId="2696"/>
          <pc:sldLayoutMkLst>
            <pc:docMk/>
            <pc:sldMasterMk cId="840570227" sldId="2147483675"/>
            <pc:sldLayoutMk cId="2810008539" sldId="2147483684"/>
          </pc:sldLayoutMkLst>
        </pc:sldLayoutChg>
        <pc:sldLayoutChg chg="del">
          <pc:chgData name="Tsujimoto,Mitsuhiro 辻本光宏(関東北甲信越統括支店O領域専門室)" userId="7251bc67-91ee-45c9-97e7-9c240c9b485c" providerId="ADAL" clId="{68999E39-5F09-4CF3-B26F-BF167E85A326}" dt="2021-04-23T07:40:37.662" v="2390" actId="2696"/>
          <pc:sldLayoutMkLst>
            <pc:docMk/>
            <pc:sldMasterMk cId="840570227" sldId="2147483675"/>
            <pc:sldLayoutMk cId="388296" sldId="2147483685"/>
          </pc:sldLayoutMkLst>
        </pc:sldLayoutChg>
        <pc:sldLayoutChg chg="del">
          <pc:chgData name="Tsujimoto,Mitsuhiro 辻本光宏(関東北甲信越統括支店O領域専門室)" userId="7251bc67-91ee-45c9-97e7-9c240c9b485c" providerId="ADAL" clId="{68999E39-5F09-4CF3-B26F-BF167E85A326}" dt="2021-04-23T07:40:37.663" v="2391" actId="2696"/>
          <pc:sldLayoutMkLst>
            <pc:docMk/>
            <pc:sldMasterMk cId="840570227" sldId="2147483675"/>
            <pc:sldLayoutMk cId="3116000232" sldId="2147483686"/>
          </pc:sldLayoutMkLst>
        </pc:sldLayoutChg>
      </pc:sldMasterChg>
    </pc:docChg>
  </pc:docChgLst>
  <pc:docChgLst>
    <pc:chgData name="Tsujimoto,Mitsuhiro 辻本光宏(関東北甲信越統括支店O領域専門室)" userId="7251bc67-91ee-45c9-97e7-9c240c9b485c" providerId="ADAL" clId="{84BEBAD3-CDC6-4E60-BDDD-D9A6E533E4C1}"/>
    <pc:docChg chg="undo redo custSel addSld delSld modSld sldOrd modMainMaster">
      <pc:chgData name="Tsujimoto,Mitsuhiro 辻本光宏(関東北甲信越統括支店O領域専門室)" userId="7251bc67-91ee-45c9-97e7-9c240c9b485c" providerId="ADAL" clId="{84BEBAD3-CDC6-4E60-BDDD-D9A6E533E4C1}" dt="2021-04-26T06:09:54.606" v="11431" actId="478"/>
      <pc:docMkLst>
        <pc:docMk/>
      </pc:docMkLst>
      <pc:sldChg chg="del">
        <pc:chgData name="Tsujimoto,Mitsuhiro 辻本光宏(関東北甲信越統括支店O領域専門室)" userId="7251bc67-91ee-45c9-97e7-9c240c9b485c" providerId="ADAL" clId="{84BEBAD3-CDC6-4E60-BDDD-D9A6E533E4C1}" dt="2021-04-26T05:19:01.996" v="7462" actId="2696"/>
        <pc:sldMkLst>
          <pc:docMk/>
          <pc:sldMk cId="2356854897" sldId="392"/>
        </pc:sldMkLst>
      </pc:sldChg>
      <pc:sldChg chg="add del">
        <pc:chgData name="Tsujimoto,Mitsuhiro 辻本光宏(関東北甲信越統括支店O領域専門室)" userId="7251bc67-91ee-45c9-97e7-9c240c9b485c" providerId="ADAL" clId="{84BEBAD3-CDC6-4E60-BDDD-D9A6E533E4C1}" dt="2021-04-26T05:13:05.052" v="7172" actId="2696"/>
        <pc:sldMkLst>
          <pc:docMk/>
          <pc:sldMk cId="804880459" sldId="492"/>
        </pc:sldMkLst>
      </pc:sldChg>
      <pc:sldChg chg="del">
        <pc:chgData name="Tsujimoto,Mitsuhiro 辻本光宏(関東北甲信越統括支店O領域専門室)" userId="7251bc67-91ee-45c9-97e7-9c240c9b485c" providerId="ADAL" clId="{84BEBAD3-CDC6-4E60-BDDD-D9A6E533E4C1}" dt="2021-04-26T02:06:03.865" v="1367" actId="2696"/>
        <pc:sldMkLst>
          <pc:docMk/>
          <pc:sldMk cId="1712006855" sldId="729"/>
        </pc:sldMkLst>
      </pc:sldChg>
      <pc:sldChg chg="del">
        <pc:chgData name="Tsujimoto,Mitsuhiro 辻本光宏(関東北甲信越統括支店O領域専門室)" userId="7251bc67-91ee-45c9-97e7-9c240c9b485c" providerId="ADAL" clId="{84BEBAD3-CDC6-4E60-BDDD-D9A6E533E4C1}" dt="2021-04-26T03:05:31.873" v="3044" actId="2696"/>
        <pc:sldMkLst>
          <pc:docMk/>
          <pc:sldMk cId="1493870158" sldId="756"/>
        </pc:sldMkLst>
      </pc:sldChg>
      <pc:sldChg chg="del">
        <pc:chgData name="Tsujimoto,Mitsuhiro 辻本光宏(関東北甲信越統括支店O領域専門室)" userId="7251bc67-91ee-45c9-97e7-9c240c9b485c" providerId="ADAL" clId="{84BEBAD3-CDC6-4E60-BDDD-D9A6E533E4C1}" dt="2021-04-26T03:14:29.902" v="3663" actId="2696"/>
        <pc:sldMkLst>
          <pc:docMk/>
          <pc:sldMk cId="3904871625" sldId="757"/>
        </pc:sldMkLst>
      </pc:sldChg>
      <pc:sldChg chg="del">
        <pc:chgData name="Tsujimoto,Mitsuhiro 辻本光宏(関東北甲信越統括支店O領域専門室)" userId="7251bc67-91ee-45c9-97e7-9c240c9b485c" providerId="ADAL" clId="{84BEBAD3-CDC6-4E60-BDDD-D9A6E533E4C1}" dt="2021-04-26T03:14:30.454" v="3664" actId="2696"/>
        <pc:sldMkLst>
          <pc:docMk/>
          <pc:sldMk cId="1090776625" sldId="758"/>
        </pc:sldMkLst>
      </pc:sldChg>
      <pc:sldChg chg="del">
        <pc:chgData name="Tsujimoto,Mitsuhiro 辻本光宏(関東北甲信越統括支店O領域専門室)" userId="7251bc67-91ee-45c9-97e7-9c240c9b485c" providerId="ADAL" clId="{84BEBAD3-CDC6-4E60-BDDD-D9A6E533E4C1}" dt="2021-04-26T03:21:58.966" v="4052" actId="2696"/>
        <pc:sldMkLst>
          <pc:docMk/>
          <pc:sldMk cId="2176366065" sldId="759"/>
        </pc:sldMkLst>
      </pc:sldChg>
      <pc:sldChg chg="del">
        <pc:chgData name="Tsujimoto,Mitsuhiro 辻本光宏(関東北甲信越統括支店O領域専門室)" userId="7251bc67-91ee-45c9-97e7-9c240c9b485c" providerId="ADAL" clId="{84BEBAD3-CDC6-4E60-BDDD-D9A6E533E4C1}" dt="2021-04-23T08:06:36.193" v="53" actId="2696"/>
        <pc:sldMkLst>
          <pc:docMk/>
          <pc:sldMk cId="3497726325" sldId="760"/>
        </pc:sldMkLst>
      </pc:sldChg>
      <pc:sldChg chg="del">
        <pc:chgData name="Tsujimoto,Mitsuhiro 辻本光宏(関東北甲信越統括支店O領域専門室)" userId="7251bc67-91ee-45c9-97e7-9c240c9b485c" providerId="ADAL" clId="{84BEBAD3-CDC6-4E60-BDDD-D9A6E533E4C1}" dt="2021-04-23T08:06:56.348" v="57" actId="2696"/>
        <pc:sldMkLst>
          <pc:docMk/>
          <pc:sldMk cId="3758392976" sldId="761"/>
        </pc:sldMkLst>
      </pc:sldChg>
      <pc:sldChg chg="del">
        <pc:chgData name="Tsujimoto,Mitsuhiro 辻本光宏(関東北甲信越統括支店O領域専門室)" userId="7251bc67-91ee-45c9-97e7-9c240c9b485c" providerId="ADAL" clId="{84BEBAD3-CDC6-4E60-BDDD-D9A6E533E4C1}" dt="2021-04-26T03:38:19.020" v="4504" actId="2696"/>
        <pc:sldMkLst>
          <pc:docMk/>
          <pc:sldMk cId="2401733796" sldId="762"/>
        </pc:sldMkLst>
      </pc:sldChg>
      <pc:sldChg chg="del">
        <pc:chgData name="Tsujimoto,Mitsuhiro 辻本光宏(関東北甲信越統括支店O領域専門室)" userId="7251bc67-91ee-45c9-97e7-9c240c9b485c" providerId="ADAL" clId="{84BEBAD3-CDC6-4E60-BDDD-D9A6E533E4C1}" dt="2021-04-26T04:35:48.338" v="5485" actId="2696"/>
        <pc:sldMkLst>
          <pc:docMk/>
          <pc:sldMk cId="624941586" sldId="763"/>
        </pc:sldMkLst>
      </pc:sldChg>
      <pc:sldChg chg="del">
        <pc:chgData name="Tsujimoto,Mitsuhiro 辻本光宏(関東北甲信越統括支店O領域専門室)" userId="7251bc67-91ee-45c9-97e7-9c240c9b485c" providerId="ADAL" clId="{84BEBAD3-CDC6-4E60-BDDD-D9A6E533E4C1}" dt="2021-04-26T05:01:27.793" v="7086" actId="2696"/>
        <pc:sldMkLst>
          <pc:docMk/>
          <pc:sldMk cId="494433995" sldId="764"/>
        </pc:sldMkLst>
      </pc:sldChg>
      <pc:sldChg chg="del">
        <pc:chgData name="Tsujimoto,Mitsuhiro 辻本光宏(関東北甲信越統括支店O領域専門室)" userId="7251bc67-91ee-45c9-97e7-9c240c9b485c" providerId="ADAL" clId="{84BEBAD3-CDC6-4E60-BDDD-D9A6E533E4C1}" dt="2021-04-26T05:01:40.113" v="7088" actId="2696"/>
        <pc:sldMkLst>
          <pc:docMk/>
          <pc:sldMk cId="3225905895" sldId="765"/>
        </pc:sldMkLst>
      </pc:sldChg>
      <pc:sldChg chg="modSp del">
        <pc:chgData name="Tsujimoto,Mitsuhiro 辻本光宏(関東北甲信越統括支店O領域専門室)" userId="7251bc67-91ee-45c9-97e7-9c240c9b485c" providerId="ADAL" clId="{84BEBAD3-CDC6-4E60-BDDD-D9A6E533E4C1}" dt="2021-04-26T06:05:16.594" v="11354" actId="2696"/>
        <pc:sldMkLst>
          <pc:docMk/>
          <pc:sldMk cId="3195568981" sldId="767"/>
        </pc:sldMkLst>
        <pc:picChg chg="mod">
          <ac:chgData name="Tsujimoto,Mitsuhiro 辻本光宏(関東北甲信越統括支店O領域専門室)" userId="7251bc67-91ee-45c9-97e7-9c240c9b485c" providerId="ADAL" clId="{84BEBAD3-CDC6-4E60-BDDD-D9A6E533E4C1}" dt="2021-04-26T06:04:51.992" v="11313" actId="1076"/>
          <ac:picMkLst>
            <pc:docMk/>
            <pc:sldMk cId="3195568981" sldId="767"/>
            <ac:picMk id="3" creationId="{9B1E7813-D720-4042-BF9B-F3D102FEEFC6}"/>
          </ac:picMkLst>
        </pc:picChg>
      </pc:sldChg>
      <pc:sldChg chg="modSp del">
        <pc:chgData name="Tsujimoto,Mitsuhiro 辻本光宏(関東北甲信越統括支店O領域専門室)" userId="7251bc67-91ee-45c9-97e7-9c240c9b485c" providerId="ADAL" clId="{84BEBAD3-CDC6-4E60-BDDD-D9A6E533E4C1}" dt="2021-04-26T05:36:55.256" v="8400" actId="2696"/>
        <pc:sldMkLst>
          <pc:docMk/>
          <pc:sldMk cId="4288596072" sldId="777"/>
        </pc:sldMkLst>
        <pc:picChg chg="mod">
          <ac:chgData name="Tsujimoto,Mitsuhiro 辻本光宏(関東北甲信越統括支店O領域専門室)" userId="7251bc67-91ee-45c9-97e7-9c240c9b485c" providerId="ADAL" clId="{84BEBAD3-CDC6-4E60-BDDD-D9A6E533E4C1}" dt="2021-04-26T05:33:47.209" v="7981" actId="1076"/>
          <ac:picMkLst>
            <pc:docMk/>
            <pc:sldMk cId="4288596072" sldId="777"/>
            <ac:picMk id="12" creationId="{7FE6372B-8066-45D8-A227-1FC527136DAD}"/>
          </ac:picMkLst>
        </pc:picChg>
      </pc:sldChg>
      <pc:sldChg chg="del">
        <pc:chgData name="Tsujimoto,Mitsuhiro 辻本光宏(関東北甲信越統括支店O領域専門室)" userId="7251bc67-91ee-45c9-97e7-9c240c9b485c" providerId="ADAL" clId="{84BEBAD3-CDC6-4E60-BDDD-D9A6E533E4C1}" dt="2021-04-26T05:56:21.806" v="9598" actId="2696"/>
        <pc:sldMkLst>
          <pc:docMk/>
          <pc:sldMk cId="348750081" sldId="779"/>
        </pc:sldMkLst>
      </pc:sldChg>
      <pc:sldChg chg="modSp del">
        <pc:chgData name="Tsujimoto,Mitsuhiro 辻本光宏(関東北甲信越統括支店O領域専門室)" userId="7251bc67-91ee-45c9-97e7-9c240c9b485c" providerId="ADAL" clId="{84BEBAD3-CDC6-4E60-BDDD-D9A6E533E4C1}" dt="2021-04-26T05:41:31.610" v="8876" actId="2696"/>
        <pc:sldMkLst>
          <pc:docMk/>
          <pc:sldMk cId="1484038544" sldId="780"/>
        </pc:sldMkLst>
        <pc:spChg chg="mod">
          <ac:chgData name="Tsujimoto,Mitsuhiro 辻本光宏(関東北甲信越統括支店O領域専門室)" userId="7251bc67-91ee-45c9-97e7-9c240c9b485c" providerId="ADAL" clId="{84BEBAD3-CDC6-4E60-BDDD-D9A6E533E4C1}" dt="2021-04-26T05:39:08.996" v="8450" actId="1076"/>
          <ac:spMkLst>
            <pc:docMk/>
            <pc:sldMk cId="1484038544" sldId="780"/>
            <ac:spMk id="3" creationId="{A95941D6-0BC8-4D9D-8329-D71BB203CEEA}"/>
          </ac:spMkLst>
        </pc:spChg>
      </pc:sldChg>
      <pc:sldChg chg="del">
        <pc:chgData name="Tsujimoto,Mitsuhiro 辻本光宏(関東北甲信越統括支店O領域専門室)" userId="7251bc67-91ee-45c9-97e7-9c240c9b485c" providerId="ADAL" clId="{84BEBAD3-CDC6-4E60-BDDD-D9A6E533E4C1}" dt="2021-04-26T05:59:36.603" v="10381" actId="2696"/>
        <pc:sldMkLst>
          <pc:docMk/>
          <pc:sldMk cId="1610970600" sldId="781"/>
        </pc:sldMkLst>
      </pc:sldChg>
      <pc:sldChg chg="del">
        <pc:chgData name="Tsujimoto,Mitsuhiro 辻本光宏(関東北甲信越統括支店O領域専門室)" userId="7251bc67-91ee-45c9-97e7-9c240c9b485c" providerId="ADAL" clId="{84BEBAD3-CDC6-4E60-BDDD-D9A6E533E4C1}" dt="2021-04-26T06:04:30.922" v="11307" actId="2696"/>
        <pc:sldMkLst>
          <pc:docMk/>
          <pc:sldMk cId="1877917049" sldId="782"/>
        </pc:sldMkLst>
      </pc:sldChg>
      <pc:sldChg chg="del">
        <pc:chgData name="Tsujimoto,Mitsuhiro 辻本光宏(関東北甲信越統括支店O領域専門室)" userId="7251bc67-91ee-45c9-97e7-9c240c9b485c" providerId="ADAL" clId="{84BEBAD3-CDC6-4E60-BDDD-D9A6E533E4C1}" dt="2021-04-26T05:32:13.977" v="7952" actId="2696"/>
        <pc:sldMkLst>
          <pc:docMk/>
          <pc:sldMk cId="1010342451" sldId="783"/>
        </pc:sldMkLst>
      </pc:sldChg>
      <pc:sldChg chg="modSp">
        <pc:chgData name="Tsujimoto,Mitsuhiro 辻本光宏(関東北甲信越統括支店O領域専門室)" userId="7251bc67-91ee-45c9-97e7-9c240c9b485c" providerId="ADAL" clId="{84BEBAD3-CDC6-4E60-BDDD-D9A6E533E4C1}" dt="2021-04-26T02:36:27.005" v="1551" actId="1076"/>
        <pc:sldMkLst>
          <pc:docMk/>
          <pc:sldMk cId="1851872886" sldId="801"/>
        </pc:sldMkLst>
        <pc:spChg chg="mod">
          <ac:chgData name="Tsujimoto,Mitsuhiro 辻本光宏(関東北甲信越統括支店O領域専門室)" userId="7251bc67-91ee-45c9-97e7-9c240c9b485c" providerId="ADAL" clId="{84BEBAD3-CDC6-4E60-BDDD-D9A6E533E4C1}" dt="2021-04-26T02:36:27.005" v="1551" actId="1076"/>
          <ac:spMkLst>
            <pc:docMk/>
            <pc:sldMk cId="1851872886" sldId="801"/>
            <ac:spMk id="10" creationId="{228AD992-2426-4E95-954D-6E80FEC72589}"/>
          </ac:spMkLst>
        </pc:spChg>
        <pc:spChg chg="mod">
          <ac:chgData name="Tsujimoto,Mitsuhiro 辻本光宏(関東北甲信越統括支店O領域専門室)" userId="7251bc67-91ee-45c9-97e7-9c240c9b485c" providerId="ADAL" clId="{84BEBAD3-CDC6-4E60-BDDD-D9A6E533E4C1}" dt="2021-04-26T02:36:27.005" v="1551" actId="1076"/>
          <ac:spMkLst>
            <pc:docMk/>
            <pc:sldMk cId="1851872886" sldId="801"/>
            <ac:spMk id="11" creationId="{D3462EFE-8008-4FB7-B7C1-B528D0094240}"/>
          </ac:spMkLst>
        </pc:spChg>
      </pc:sldChg>
      <pc:sldChg chg="modSp">
        <pc:chgData name="Tsujimoto,Mitsuhiro 辻本光宏(関東北甲信越統括支店O領域専門室)" userId="7251bc67-91ee-45c9-97e7-9c240c9b485c" providerId="ADAL" clId="{84BEBAD3-CDC6-4E60-BDDD-D9A6E533E4C1}" dt="2021-04-26T02:36:31.608" v="1552" actId="404"/>
        <pc:sldMkLst>
          <pc:docMk/>
          <pc:sldMk cId="3540568972" sldId="802"/>
        </pc:sldMkLst>
        <pc:spChg chg="mod">
          <ac:chgData name="Tsujimoto,Mitsuhiro 辻本光宏(関東北甲信越統括支店O領域専門室)" userId="7251bc67-91ee-45c9-97e7-9c240c9b485c" providerId="ADAL" clId="{84BEBAD3-CDC6-4E60-BDDD-D9A6E533E4C1}" dt="2021-04-26T02:36:31.608" v="1552" actId="404"/>
          <ac:spMkLst>
            <pc:docMk/>
            <pc:sldMk cId="3540568972" sldId="802"/>
            <ac:spMk id="3" creationId="{E7E35B6C-025B-485E-A129-2A18D9A26CBB}"/>
          </ac:spMkLst>
        </pc:spChg>
        <pc:spChg chg="mod">
          <ac:chgData name="Tsujimoto,Mitsuhiro 辻本光宏(関東北甲信越統括支店O領域専門室)" userId="7251bc67-91ee-45c9-97e7-9c240c9b485c" providerId="ADAL" clId="{84BEBAD3-CDC6-4E60-BDDD-D9A6E533E4C1}" dt="2021-04-26T02:36:31.608" v="1552" actId="404"/>
          <ac:spMkLst>
            <pc:docMk/>
            <pc:sldMk cId="3540568972" sldId="802"/>
            <ac:spMk id="4" creationId="{C7E90043-AB0C-4BD5-BB95-DFEA4B2C7165}"/>
          </ac:spMkLst>
        </pc:spChg>
      </pc:sldChg>
      <pc:sldChg chg="addSp delSp modSp">
        <pc:chgData name="Tsujimoto,Mitsuhiro 辻本光宏(関東北甲信越統括支店O領域専門室)" userId="7251bc67-91ee-45c9-97e7-9c240c9b485c" providerId="ADAL" clId="{84BEBAD3-CDC6-4E60-BDDD-D9A6E533E4C1}" dt="2021-04-26T01:36:43.382" v="377" actId="1076"/>
        <pc:sldMkLst>
          <pc:docMk/>
          <pc:sldMk cId="2644131426" sldId="803"/>
        </pc:sldMkLst>
        <pc:spChg chg="del">
          <ac:chgData name="Tsujimoto,Mitsuhiro 辻本光宏(関東北甲信越統括支店O領域専門室)" userId="7251bc67-91ee-45c9-97e7-9c240c9b485c" providerId="ADAL" clId="{84BEBAD3-CDC6-4E60-BDDD-D9A6E533E4C1}" dt="2021-04-26T01:36:29.459" v="375" actId="478"/>
          <ac:spMkLst>
            <pc:docMk/>
            <pc:sldMk cId="2644131426" sldId="803"/>
            <ac:spMk id="9" creationId="{497BD80D-7235-4741-8DB3-670E136E8DC2}"/>
          </ac:spMkLst>
        </pc:spChg>
        <pc:spChg chg="add del mod">
          <ac:chgData name="Tsujimoto,Mitsuhiro 辻本光宏(関東北甲信越統括支店O領域専門室)" userId="7251bc67-91ee-45c9-97e7-9c240c9b485c" providerId="ADAL" clId="{84BEBAD3-CDC6-4E60-BDDD-D9A6E533E4C1}" dt="2021-04-26T01:35:50.808" v="182" actId="478"/>
          <ac:spMkLst>
            <pc:docMk/>
            <pc:sldMk cId="2644131426" sldId="803"/>
            <ac:spMk id="17" creationId="{A9E6F7A9-058B-4392-B110-F0D5393CB9B6}"/>
          </ac:spMkLst>
        </pc:spChg>
        <pc:spChg chg="add mod">
          <ac:chgData name="Tsujimoto,Mitsuhiro 辻本光宏(関東北甲信越統括支店O領域専門室)" userId="7251bc67-91ee-45c9-97e7-9c240c9b485c" providerId="ADAL" clId="{84BEBAD3-CDC6-4E60-BDDD-D9A6E533E4C1}" dt="2021-04-26T01:36:43.382" v="377" actId="1076"/>
          <ac:spMkLst>
            <pc:docMk/>
            <pc:sldMk cId="2644131426" sldId="803"/>
            <ac:spMk id="18" creationId="{4354A025-024C-453C-9F99-4CE066494D38}"/>
          </ac:spMkLst>
        </pc:spChg>
      </pc:sldChg>
      <pc:sldChg chg="addSp modSp">
        <pc:chgData name="Tsujimoto,Mitsuhiro 辻本光宏(関東北甲信越統括支店O領域専門室)" userId="7251bc67-91ee-45c9-97e7-9c240c9b485c" providerId="ADAL" clId="{84BEBAD3-CDC6-4E60-BDDD-D9A6E533E4C1}" dt="2021-04-26T01:41:08.372" v="800" actId="1036"/>
        <pc:sldMkLst>
          <pc:docMk/>
          <pc:sldMk cId="754859798" sldId="804"/>
        </pc:sldMkLst>
        <pc:spChg chg="add mod">
          <ac:chgData name="Tsujimoto,Mitsuhiro 辻本光宏(関東北甲信越統括支店O領域専門室)" userId="7251bc67-91ee-45c9-97e7-9c240c9b485c" providerId="ADAL" clId="{84BEBAD3-CDC6-4E60-BDDD-D9A6E533E4C1}" dt="2021-04-26T01:40:31.053" v="779" actId="1076"/>
          <ac:spMkLst>
            <pc:docMk/>
            <pc:sldMk cId="754859798" sldId="804"/>
            <ac:spMk id="6" creationId="{530A0818-CDDD-43CA-935A-BE813AB80297}"/>
          </ac:spMkLst>
        </pc:spChg>
        <pc:spChg chg="add mod">
          <ac:chgData name="Tsujimoto,Mitsuhiro 辻本光宏(関東北甲信越統括支店O領域専門室)" userId="7251bc67-91ee-45c9-97e7-9c240c9b485c" providerId="ADAL" clId="{84BEBAD3-CDC6-4E60-BDDD-D9A6E533E4C1}" dt="2021-04-26T01:41:02.395" v="792" actId="1076"/>
          <ac:spMkLst>
            <pc:docMk/>
            <pc:sldMk cId="754859798" sldId="804"/>
            <ac:spMk id="7" creationId="{5BAF0A73-71F3-4F14-989A-47A8EB2404C1}"/>
          </ac:spMkLst>
        </pc:spChg>
        <pc:picChg chg="mod">
          <ac:chgData name="Tsujimoto,Mitsuhiro 辻本光宏(関東北甲信越統括支店O領域専門室)" userId="7251bc67-91ee-45c9-97e7-9c240c9b485c" providerId="ADAL" clId="{84BEBAD3-CDC6-4E60-BDDD-D9A6E533E4C1}" dt="2021-04-26T01:41:08.372" v="800" actId="1036"/>
          <ac:picMkLst>
            <pc:docMk/>
            <pc:sldMk cId="754859798" sldId="804"/>
            <ac:picMk id="3" creationId="{07A40473-F19E-4E99-98DE-5BF798D520B9}"/>
          </ac:picMkLst>
        </pc:picChg>
        <pc:picChg chg="mod">
          <ac:chgData name="Tsujimoto,Mitsuhiro 辻本光宏(関東北甲信越統括支店O領域専門室)" userId="7251bc67-91ee-45c9-97e7-9c240c9b485c" providerId="ADAL" clId="{84BEBAD3-CDC6-4E60-BDDD-D9A6E533E4C1}" dt="2021-04-26T01:41:08.372" v="800" actId="1036"/>
          <ac:picMkLst>
            <pc:docMk/>
            <pc:sldMk cId="754859798" sldId="804"/>
            <ac:picMk id="4" creationId="{F1ADD3B7-4D2A-4F17-8DAD-3D79F112E949}"/>
          </ac:picMkLst>
        </pc:picChg>
      </pc:sldChg>
      <pc:sldChg chg="addSp delSp modSp">
        <pc:chgData name="Tsujimoto,Mitsuhiro 辻本光宏(関東北甲信越統括支店O領域専門室)" userId="7251bc67-91ee-45c9-97e7-9c240c9b485c" providerId="ADAL" clId="{84BEBAD3-CDC6-4E60-BDDD-D9A6E533E4C1}" dt="2021-04-26T06:09:54.606" v="11431" actId="478"/>
        <pc:sldMkLst>
          <pc:docMk/>
          <pc:sldMk cId="4145765581" sldId="807"/>
        </pc:sldMkLst>
        <pc:spChg chg="add del">
          <ac:chgData name="Tsujimoto,Mitsuhiro 辻本光宏(関東北甲信越統括支店O領域専門室)" userId="7251bc67-91ee-45c9-97e7-9c240c9b485c" providerId="ADAL" clId="{84BEBAD3-CDC6-4E60-BDDD-D9A6E533E4C1}" dt="2021-04-26T06:09:54.606" v="11431" actId="478"/>
          <ac:spMkLst>
            <pc:docMk/>
            <pc:sldMk cId="4145765581" sldId="807"/>
            <ac:spMk id="27" creationId="{631A9CCF-544E-4515-B0C2-9BF3EE8F1232}"/>
          </ac:spMkLst>
        </pc:spChg>
        <pc:spChg chg="mod">
          <ac:chgData name="Tsujimoto,Mitsuhiro 辻本光宏(関東北甲信越統括支店O領域専門室)" userId="7251bc67-91ee-45c9-97e7-9c240c9b485c" providerId="ADAL" clId="{84BEBAD3-CDC6-4E60-BDDD-D9A6E533E4C1}" dt="2021-04-23T09:44:33.162" v="65" actId="1035"/>
          <ac:spMkLst>
            <pc:docMk/>
            <pc:sldMk cId="4145765581" sldId="807"/>
            <ac:spMk id="41" creationId="{F97E967E-8A32-42C3-9DA2-9599FAEE3329}"/>
          </ac:spMkLst>
        </pc:spChg>
      </pc:sldChg>
      <pc:sldChg chg="modSp">
        <pc:chgData name="Tsujimoto,Mitsuhiro 辻本光宏(関東北甲信越統括支店O領域専門室)" userId="7251bc67-91ee-45c9-97e7-9c240c9b485c" providerId="ADAL" clId="{84BEBAD3-CDC6-4E60-BDDD-D9A6E533E4C1}" dt="2021-04-26T01:37:08.887" v="383" actId="1035"/>
        <pc:sldMkLst>
          <pc:docMk/>
          <pc:sldMk cId="3607764144" sldId="810"/>
        </pc:sldMkLst>
        <pc:spChg chg="mod">
          <ac:chgData name="Tsujimoto,Mitsuhiro 辻本光宏(関東北甲信越統括支店O領域専門室)" userId="7251bc67-91ee-45c9-97e7-9c240c9b485c" providerId="ADAL" clId="{84BEBAD3-CDC6-4E60-BDDD-D9A6E533E4C1}" dt="2021-04-26T01:37:08.887" v="383" actId="1035"/>
          <ac:spMkLst>
            <pc:docMk/>
            <pc:sldMk cId="3607764144" sldId="810"/>
            <ac:spMk id="9" creationId="{961A8DDC-52FD-43C8-8EB1-F361125483B3}"/>
          </ac:spMkLst>
        </pc:spChg>
      </pc:sldChg>
      <pc:sldChg chg="modSp">
        <pc:chgData name="Tsujimoto,Mitsuhiro 辻本光宏(関東北甲信越統括支店O領域専門室)" userId="7251bc67-91ee-45c9-97e7-9c240c9b485c" providerId="ADAL" clId="{84BEBAD3-CDC6-4E60-BDDD-D9A6E533E4C1}" dt="2021-04-26T02:36:42.476" v="1554" actId="1076"/>
        <pc:sldMkLst>
          <pc:docMk/>
          <pc:sldMk cId="1506810546" sldId="811"/>
        </pc:sldMkLst>
        <pc:spChg chg="mod">
          <ac:chgData name="Tsujimoto,Mitsuhiro 辻本光宏(関東北甲信越統括支店O領域専門室)" userId="7251bc67-91ee-45c9-97e7-9c240c9b485c" providerId="ADAL" clId="{84BEBAD3-CDC6-4E60-BDDD-D9A6E533E4C1}" dt="2021-04-26T02:36:42.476" v="1554" actId="1076"/>
          <ac:spMkLst>
            <pc:docMk/>
            <pc:sldMk cId="1506810546" sldId="811"/>
            <ac:spMk id="6" creationId="{0B68DE6B-E955-419F-8245-97EFCF5E794C}"/>
          </ac:spMkLst>
        </pc:spChg>
        <pc:spChg chg="mod">
          <ac:chgData name="Tsujimoto,Mitsuhiro 辻本光宏(関東北甲信越統括支店O領域専門室)" userId="7251bc67-91ee-45c9-97e7-9c240c9b485c" providerId="ADAL" clId="{84BEBAD3-CDC6-4E60-BDDD-D9A6E533E4C1}" dt="2021-04-26T02:36:42.476" v="1554" actId="1076"/>
          <ac:spMkLst>
            <pc:docMk/>
            <pc:sldMk cId="1506810546" sldId="811"/>
            <ac:spMk id="7" creationId="{B09C1FE5-DDAB-4F19-9343-BC72A755A813}"/>
          </ac:spMkLst>
        </pc:spChg>
        <pc:spChg chg="mod">
          <ac:chgData name="Tsujimoto,Mitsuhiro 辻本光宏(関東北甲信越統括支店O領域専門室)" userId="7251bc67-91ee-45c9-97e7-9c240c9b485c" providerId="ADAL" clId="{84BEBAD3-CDC6-4E60-BDDD-D9A6E533E4C1}" dt="2021-04-26T01:37:14.092" v="384" actId="403"/>
          <ac:spMkLst>
            <pc:docMk/>
            <pc:sldMk cId="1506810546" sldId="811"/>
            <ac:spMk id="9" creationId="{762CF155-EB4E-4C98-B600-6186088405D3}"/>
          </ac:spMkLst>
        </pc:spChg>
        <pc:picChg chg="mod">
          <ac:chgData name="Tsujimoto,Mitsuhiro 辻本光宏(関東北甲信越統括支店O領域専門室)" userId="7251bc67-91ee-45c9-97e7-9c240c9b485c" providerId="ADAL" clId="{84BEBAD3-CDC6-4E60-BDDD-D9A6E533E4C1}" dt="2021-04-26T01:45:48.599" v="882" actId="1036"/>
          <ac:picMkLst>
            <pc:docMk/>
            <pc:sldMk cId="1506810546" sldId="811"/>
            <ac:picMk id="4" creationId="{C22D6773-B427-4C61-BD07-8572F22B376A}"/>
          </ac:picMkLst>
        </pc:picChg>
        <pc:picChg chg="mod">
          <ac:chgData name="Tsujimoto,Mitsuhiro 辻本光宏(関東北甲信越統括支店O領域専門室)" userId="7251bc67-91ee-45c9-97e7-9c240c9b485c" providerId="ADAL" clId="{84BEBAD3-CDC6-4E60-BDDD-D9A6E533E4C1}" dt="2021-04-26T01:45:53.492" v="893" actId="1037"/>
          <ac:picMkLst>
            <pc:docMk/>
            <pc:sldMk cId="1506810546" sldId="811"/>
            <ac:picMk id="5" creationId="{D42D850E-8750-4FAD-847E-E7966D672532}"/>
          </ac:picMkLst>
        </pc:picChg>
      </pc:sldChg>
      <pc:sldChg chg="modSp">
        <pc:chgData name="Tsujimoto,Mitsuhiro 辻本光宏(関東北甲信越統括支店O領域専門室)" userId="7251bc67-91ee-45c9-97e7-9c240c9b485c" providerId="ADAL" clId="{84BEBAD3-CDC6-4E60-BDDD-D9A6E533E4C1}" dt="2021-04-26T02:37:03.241" v="1563" actId="1035"/>
        <pc:sldMkLst>
          <pc:docMk/>
          <pc:sldMk cId="1562766757" sldId="812"/>
        </pc:sldMkLst>
        <pc:spChg chg="mod">
          <ac:chgData name="Tsujimoto,Mitsuhiro 辻本光宏(関東北甲信越統括支店O領域専門室)" userId="7251bc67-91ee-45c9-97e7-9c240c9b485c" providerId="ADAL" clId="{84BEBAD3-CDC6-4E60-BDDD-D9A6E533E4C1}" dt="2021-04-26T02:36:55.146" v="1555" actId="255"/>
          <ac:spMkLst>
            <pc:docMk/>
            <pc:sldMk cId="1562766757" sldId="812"/>
            <ac:spMk id="6" creationId="{C8BD4B9B-AD02-4CA3-929B-D783269DFE6C}"/>
          </ac:spMkLst>
        </pc:spChg>
        <pc:spChg chg="mod">
          <ac:chgData name="Tsujimoto,Mitsuhiro 辻本光宏(関東北甲信越統括支店O領域専門室)" userId="7251bc67-91ee-45c9-97e7-9c240c9b485c" providerId="ADAL" clId="{84BEBAD3-CDC6-4E60-BDDD-D9A6E533E4C1}" dt="2021-04-26T02:36:55.146" v="1555" actId="255"/>
          <ac:spMkLst>
            <pc:docMk/>
            <pc:sldMk cId="1562766757" sldId="812"/>
            <ac:spMk id="7" creationId="{2C9CC779-C35F-4D60-94BB-94616DE64975}"/>
          </ac:spMkLst>
        </pc:spChg>
        <pc:spChg chg="mod">
          <ac:chgData name="Tsujimoto,Mitsuhiro 辻本光宏(関東北甲信越統括支店O領域専門室)" userId="7251bc67-91ee-45c9-97e7-9c240c9b485c" providerId="ADAL" clId="{84BEBAD3-CDC6-4E60-BDDD-D9A6E533E4C1}" dt="2021-04-26T02:36:55.146" v="1555" actId="255"/>
          <ac:spMkLst>
            <pc:docMk/>
            <pc:sldMk cId="1562766757" sldId="812"/>
            <ac:spMk id="8" creationId="{A5FB70D3-651D-42DA-9293-39C12F552FB4}"/>
          </ac:spMkLst>
        </pc:spChg>
        <pc:spChg chg="mod">
          <ac:chgData name="Tsujimoto,Mitsuhiro 辻本光宏(関東北甲信越統括支店O領域専門室)" userId="7251bc67-91ee-45c9-97e7-9c240c9b485c" providerId="ADAL" clId="{84BEBAD3-CDC6-4E60-BDDD-D9A6E533E4C1}" dt="2021-04-26T01:37:21.302" v="385" actId="403"/>
          <ac:spMkLst>
            <pc:docMk/>
            <pc:sldMk cId="1562766757" sldId="812"/>
            <ac:spMk id="9" creationId="{542BFC70-CD2B-4D3B-B7BE-3404BC9A63B4}"/>
          </ac:spMkLst>
        </pc:spChg>
        <pc:picChg chg="mod">
          <ac:chgData name="Tsujimoto,Mitsuhiro 辻本光宏(関東北甲信越統括支店O領域専門室)" userId="7251bc67-91ee-45c9-97e7-9c240c9b485c" providerId="ADAL" clId="{84BEBAD3-CDC6-4E60-BDDD-D9A6E533E4C1}" dt="2021-04-26T02:37:03.241" v="1563" actId="1035"/>
          <ac:picMkLst>
            <pc:docMk/>
            <pc:sldMk cId="1562766757" sldId="812"/>
            <ac:picMk id="3" creationId="{7B5033F6-2C5A-4D4D-AA4A-D022ADD1CD35}"/>
          </ac:picMkLst>
        </pc:picChg>
        <pc:picChg chg="mod">
          <ac:chgData name="Tsujimoto,Mitsuhiro 辻本光宏(関東北甲信越統括支店O領域専門室)" userId="7251bc67-91ee-45c9-97e7-9c240c9b485c" providerId="ADAL" clId="{84BEBAD3-CDC6-4E60-BDDD-D9A6E533E4C1}" dt="2021-04-26T02:37:03.241" v="1563" actId="1035"/>
          <ac:picMkLst>
            <pc:docMk/>
            <pc:sldMk cId="1562766757" sldId="812"/>
            <ac:picMk id="4" creationId="{F3A3D9B8-19F8-4245-A0DB-291A4FA9A168}"/>
          </ac:picMkLst>
        </pc:picChg>
        <pc:picChg chg="mod">
          <ac:chgData name="Tsujimoto,Mitsuhiro 辻本光宏(関東北甲信越統括支店O領域専門室)" userId="7251bc67-91ee-45c9-97e7-9c240c9b485c" providerId="ADAL" clId="{84BEBAD3-CDC6-4E60-BDDD-D9A6E533E4C1}" dt="2021-04-26T02:37:03.241" v="1563" actId="1035"/>
          <ac:picMkLst>
            <pc:docMk/>
            <pc:sldMk cId="1562766757" sldId="812"/>
            <ac:picMk id="5" creationId="{E7F816C4-BD42-4215-B655-930706830600}"/>
          </ac:picMkLst>
        </pc:picChg>
      </pc:sldChg>
      <pc:sldChg chg="modSp">
        <pc:chgData name="Tsujimoto,Mitsuhiro 辻本光宏(関東北甲信越統括支店O領域専門室)" userId="7251bc67-91ee-45c9-97e7-9c240c9b485c" providerId="ADAL" clId="{84BEBAD3-CDC6-4E60-BDDD-D9A6E533E4C1}" dt="2021-04-26T02:37:10.342" v="1564" actId="255"/>
        <pc:sldMkLst>
          <pc:docMk/>
          <pc:sldMk cId="1300342973" sldId="813"/>
        </pc:sldMkLst>
        <pc:spChg chg="mod">
          <ac:chgData name="Tsujimoto,Mitsuhiro 辻本光宏(関東北甲信越統括支店O領域専門室)" userId="7251bc67-91ee-45c9-97e7-9c240c9b485c" providerId="ADAL" clId="{84BEBAD3-CDC6-4E60-BDDD-D9A6E533E4C1}" dt="2021-04-26T02:37:10.342" v="1564" actId="255"/>
          <ac:spMkLst>
            <pc:docMk/>
            <pc:sldMk cId="1300342973" sldId="813"/>
            <ac:spMk id="6" creationId="{C8BD4B9B-AD02-4CA3-929B-D783269DFE6C}"/>
          </ac:spMkLst>
        </pc:spChg>
        <pc:spChg chg="mod">
          <ac:chgData name="Tsujimoto,Mitsuhiro 辻本光宏(関東北甲信越統括支店O領域専門室)" userId="7251bc67-91ee-45c9-97e7-9c240c9b485c" providerId="ADAL" clId="{84BEBAD3-CDC6-4E60-BDDD-D9A6E533E4C1}" dt="2021-04-26T02:37:10.342" v="1564" actId="255"/>
          <ac:spMkLst>
            <pc:docMk/>
            <pc:sldMk cId="1300342973" sldId="813"/>
            <ac:spMk id="7" creationId="{2C9CC779-C35F-4D60-94BB-94616DE64975}"/>
          </ac:spMkLst>
        </pc:spChg>
        <pc:spChg chg="mod">
          <ac:chgData name="Tsujimoto,Mitsuhiro 辻本光宏(関東北甲信越統括支店O領域専門室)" userId="7251bc67-91ee-45c9-97e7-9c240c9b485c" providerId="ADAL" clId="{84BEBAD3-CDC6-4E60-BDDD-D9A6E533E4C1}" dt="2021-04-26T02:37:10.342" v="1564" actId="255"/>
          <ac:spMkLst>
            <pc:docMk/>
            <pc:sldMk cId="1300342973" sldId="813"/>
            <ac:spMk id="8" creationId="{A5FB70D3-651D-42DA-9293-39C12F552FB4}"/>
          </ac:spMkLst>
        </pc:spChg>
        <pc:spChg chg="mod">
          <ac:chgData name="Tsujimoto,Mitsuhiro 辻本光宏(関東北甲信越統括支店O領域専門室)" userId="7251bc67-91ee-45c9-97e7-9c240c9b485c" providerId="ADAL" clId="{84BEBAD3-CDC6-4E60-BDDD-D9A6E533E4C1}" dt="2021-04-26T01:37:25.977" v="386" actId="403"/>
          <ac:spMkLst>
            <pc:docMk/>
            <pc:sldMk cId="1300342973" sldId="813"/>
            <ac:spMk id="9" creationId="{542BFC70-CD2B-4D3B-B7BE-3404BC9A63B4}"/>
          </ac:spMkLst>
        </pc:spChg>
      </pc:sldChg>
      <pc:sldChg chg="modSp">
        <pc:chgData name="Tsujimoto,Mitsuhiro 辻本光宏(関東北甲信越統括支店O領域専門室)" userId="7251bc67-91ee-45c9-97e7-9c240c9b485c" providerId="ADAL" clId="{84BEBAD3-CDC6-4E60-BDDD-D9A6E533E4C1}" dt="2021-04-26T02:08:39.135" v="1432" actId="207"/>
        <pc:sldMkLst>
          <pc:docMk/>
          <pc:sldMk cId="2024961420" sldId="838"/>
        </pc:sldMkLst>
        <pc:spChg chg="mod">
          <ac:chgData name="Tsujimoto,Mitsuhiro 辻本光宏(関東北甲信越統括支店O領域専門室)" userId="7251bc67-91ee-45c9-97e7-9c240c9b485c" providerId="ADAL" clId="{84BEBAD3-CDC6-4E60-BDDD-D9A6E533E4C1}" dt="2021-04-26T02:08:39.135" v="1432" actId="207"/>
          <ac:spMkLst>
            <pc:docMk/>
            <pc:sldMk cId="2024961420" sldId="838"/>
            <ac:spMk id="2" creationId="{E9C84B9A-0A5E-4501-A736-97E7536FAD85}"/>
          </ac:spMkLst>
        </pc:spChg>
        <pc:spChg chg="mod">
          <ac:chgData name="Tsujimoto,Mitsuhiro 辻本光宏(関東北甲信越統括支店O領域専門室)" userId="7251bc67-91ee-45c9-97e7-9c240c9b485c" providerId="ADAL" clId="{84BEBAD3-CDC6-4E60-BDDD-D9A6E533E4C1}" dt="2021-04-26T01:37:43.413" v="391" actId="1076"/>
          <ac:spMkLst>
            <pc:docMk/>
            <pc:sldMk cId="2024961420" sldId="838"/>
            <ac:spMk id="9" creationId="{961A8DDC-52FD-43C8-8EB1-F361125483B3}"/>
          </ac:spMkLst>
        </pc:spChg>
      </pc:sldChg>
      <pc:sldChg chg="modSp">
        <pc:chgData name="Tsujimoto,Mitsuhiro 辻本光宏(関東北甲信越統括支店O領域専門室)" userId="7251bc67-91ee-45c9-97e7-9c240c9b485c" providerId="ADAL" clId="{84BEBAD3-CDC6-4E60-BDDD-D9A6E533E4C1}" dt="2021-04-26T01:37:47.424" v="392" actId="403"/>
        <pc:sldMkLst>
          <pc:docMk/>
          <pc:sldMk cId="3330569479" sldId="839"/>
        </pc:sldMkLst>
        <pc:spChg chg="mod">
          <ac:chgData name="Tsujimoto,Mitsuhiro 辻本光宏(関東北甲信越統括支店O領域専門室)" userId="7251bc67-91ee-45c9-97e7-9c240c9b485c" providerId="ADAL" clId="{84BEBAD3-CDC6-4E60-BDDD-D9A6E533E4C1}" dt="2021-04-26T01:37:47.424" v="392" actId="403"/>
          <ac:spMkLst>
            <pc:docMk/>
            <pc:sldMk cId="3330569479" sldId="839"/>
            <ac:spMk id="14" creationId="{BB326143-66C6-4594-A01D-3E4C08BB27EF}"/>
          </ac:spMkLst>
        </pc:spChg>
      </pc:sldChg>
      <pc:sldChg chg="modSp">
        <pc:chgData name="Tsujimoto,Mitsuhiro 辻本光宏(関東北甲信越統括支店O領域専門室)" userId="7251bc67-91ee-45c9-97e7-9c240c9b485c" providerId="ADAL" clId="{84BEBAD3-CDC6-4E60-BDDD-D9A6E533E4C1}" dt="2021-04-26T02:07:36.021" v="1400" actId="1036"/>
        <pc:sldMkLst>
          <pc:docMk/>
          <pc:sldMk cId="2443364138" sldId="841"/>
        </pc:sldMkLst>
        <pc:spChg chg="mod">
          <ac:chgData name="Tsujimoto,Mitsuhiro 辻本光宏(関東北甲信越統括支店O領域専門室)" userId="7251bc67-91ee-45c9-97e7-9c240c9b485c" providerId="ADAL" clId="{84BEBAD3-CDC6-4E60-BDDD-D9A6E533E4C1}" dt="2021-04-26T02:07:26.990" v="1393" actId="403"/>
          <ac:spMkLst>
            <pc:docMk/>
            <pc:sldMk cId="2443364138" sldId="841"/>
            <ac:spMk id="14" creationId="{BB326143-66C6-4594-A01D-3E4C08BB27EF}"/>
          </ac:spMkLst>
        </pc:spChg>
        <pc:picChg chg="mod">
          <ac:chgData name="Tsujimoto,Mitsuhiro 辻本光宏(関東北甲信越統括支店O領域専門室)" userId="7251bc67-91ee-45c9-97e7-9c240c9b485c" providerId="ADAL" clId="{84BEBAD3-CDC6-4E60-BDDD-D9A6E533E4C1}" dt="2021-04-26T02:07:36.021" v="1400" actId="1036"/>
          <ac:picMkLst>
            <pc:docMk/>
            <pc:sldMk cId="2443364138" sldId="841"/>
            <ac:picMk id="4" creationId="{E6077187-0171-4DC2-A9F8-BCD055D46BFC}"/>
          </ac:picMkLst>
        </pc:picChg>
      </pc:sldChg>
      <pc:sldChg chg="addSp delSp modSp">
        <pc:chgData name="Tsujimoto,Mitsuhiro 辻本光宏(関東北甲信越統括支店O領域専門室)" userId="7251bc67-91ee-45c9-97e7-9c240c9b485c" providerId="ADAL" clId="{84BEBAD3-CDC6-4E60-BDDD-D9A6E533E4C1}" dt="2021-04-26T06:09:50.196" v="11430" actId="478"/>
        <pc:sldMkLst>
          <pc:docMk/>
          <pc:sldMk cId="4242311681" sldId="842"/>
        </pc:sldMkLst>
        <pc:spChg chg="mod">
          <ac:chgData name="Tsujimoto,Mitsuhiro 辻本光宏(関東北甲信越統括支店O領域専門室)" userId="7251bc67-91ee-45c9-97e7-9c240c9b485c" providerId="ADAL" clId="{84BEBAD3-CDC6-4E60-BDDD-D9A6E533E4C1}" dt="2021-04-26T02:07:24.039" v="1392" actId="403"/>
          <ac:spMkLst>
            <pc:docMk/>
            <pc:sldMk cId="4242311681" sldId="842"/>
            <ac:spMk id="6" creationId="{67FEB859-2DF5-49B6-9E37-CD4C8F09B447}"/>
          </ac:spMkLst>
        </pc:spChg>
        <pc:spChg chg="add del">
          <ac:chgData name="Tsujimoto,Mitsuhiro 辻本光宏(関東北甲信越統括支店O領域専門室)" userId="7251bc67-91ee-45c9-97e7-9c240c9b485c" providerId="ADAL" clId="{84BEBAD3-CDC6-4E60-BDDD-D9A6E533E4C1}" dt="2021-04-26T06:09:50.196" v="11430" actId="478"/>
          <ac:spMkLst>
            <pc:docMk/>
            <pc:sldMk cId="4242311681" sldId="842"/>
            <ac:spMk id="7" creationId="{36825BC1-0EC5-4781-9C42-DF73A0207F25}"/>
          </ac:spMkLst>
        </pc:spChg>
      </pc:sldChg>
      <pc:sldChg chg="modSp">
        <pc:chgData name="Tsujimoto,Mitsuhiro 辻本光宏(関東北甲信越統括支店O領域専門室)" userId="7251bc67-91ee-45c9-97e7-9c240c9b485c" providerId="ADAL" clId="{84BEBAD3-CDC6-4E60-BDDD-D9A6E533E4C1}" dt="2021-04-26T02:37:27.350" v="1566" actId="1076"/>
        <pc:sldMkLst>
          <pc:docMk/>
          <pc:sldMk cId="3559440001" sldId="843"/>
        </pc:sldMkLst>
        <pc:spChg chg="mod">
          <ac:chgData name="Tsujimoto,Mitsuhiro 辻本光宏(関東北甲信越統括支店O領域専門室)" userId="7251bc67-91ee-45c9-97e7-9c240c9b485c" providerId="ADAL" clId="{84BEBAD3-CDC6-4E60-BDDD-D9A6E533E4C1}" dt="2021-04-26T02:37:27.350" v="1566" actId="1076"/>
          <ac:spMkLst>
            <pc:docMk/>
            <pc:sldMk cId="3559440001" sldId="843"/>
            <ac:spMk id="5" creationId="{EFDAC30D-A299-45D2-9D7A-85E18096C40D}"/>
          </ac:spMkLst>
        </pc:spChg>
        <pc:spChg chg="mod">
          <ac:chgData name="Tsujimoto,Mitsuhiro 辻本光宏(関東北甲信越統括支店O領域専門室)" userId="7251bc67-91ee-45c9-97e7-9c240c9b485c" providerId="ADAL" clId="{84BEBAD3-CDC6-4E60-BDDD-D9A6E533E4C1}" dt="2021-04-26T02:37:27.350" v="1566" actId="1076"/>
          <ac:spMkLst>
            <pc:docMk/>
            <pc:sldMk cId="3559440001" sldId="843"/>
            <ac:spMk id="6" creationId="{07B75FF7-9BFB-44F2-9869-87C68594B77C}"/>
          </ac:spMkLst>
        </pc:spChg>
        <pc:spChg chg="mod">
          <ac:chgData name="Tsujimoto,Mitsuhiro 辻本光宏(関東北甲信越統括支店O領域専門室)" userId="7251bc67-91ee-45c9-97e7-9c240c9b485c" providerId="ADAL" clId="{84BEBAD3-CDC6-4E60-BDDD-D9A6E533E4C1}" dt="2021-04-26T02:07:44.383" v="1402" actId="14100"/>
          <ac:spMkLst>
            <pc:docMk/>
            <pc:sldMk cId="3559440001" sldId="843"/>
            <ac:spMk id="7" creationId="{E28748BF-DDEE-4142-9DF4-0C207954F653}"/>
          </ac:spMkLst>
        </pc:spChg>
        <pc:picChg chg="mod">
          <ac:chgData name="Tsujimoto,Mitsuhiro 辻本光宏(関東北甲信越統括支店O領域専門室)" userId="7251bc67-91ee-45c9-97e7-9c240c9b485c" providerId="ADAL" clId="{84BEBAD3-CDC6-4E60-BDDD-D9A6E533E4C1}" dt="2021-04-26T02:08:04.160" v="1421" actId="1035"/>
          <ac:picMkLst>
            <pc:docMk/>
            <pc:sldMk cId="3559440001" sldId="843"/>
            <ac:picMk id="10" creationId="{F1401302-0E62-43CC-961A-DC224AC9D5E6}"/>
          </ac:picMkLst>
        </pc:picChg>
        <pc:picChg chg="mod">
          <ac:chgData name="Tsujimoto,Mitsuhiro 辻本光宏(関東北甲信越統括支店O領域専門室)" userId="7251bc67-91ee-45c9-97e7-9c240c9b485c" providerId="ADAL" clId="{84BEBAD3-CDC6-4E60-BDDD-D9A6E533E4C1}" dt="2021-04-26T02:08:04.160" v="1421" actId="1035"/>
          <ac:picMkLst>
            <pc:docMk/>
            <pc:sldMk cId="3559440001" sldId="843"/>
            <ac:picMk id="11" creationId="{717B7E4B-7B44-47F8-A30F-F27C454EC2C1}"/>
          </ac:picMkLst>
        </pc:picChg>
        <pc:picChg chg="mod">
          <ac:chgData name="Tsujimoto,Mitsuhiro 辻本光宏(関東北甲信越統括支店O領域専門室)" userId="7251bc67-91ee-45c9-97e7-9c240c9b485c" providerId="ADAL" clId="{84BEBAD3-CDC6-4E60-BDDD-D9A6E533E4C1}" dt="2021-04-26T02:07:59.583" v="1408" actId="1076"/>
          <ac:picMkLst>
            <pc:docMk/>
            <pc:sldMk cId="3559440001" sldId="843"/>
            <ac:picMk id="13" creationId="{F1120E6F-B11E-4A6B-B812-B1D0756C6A62}"/>
          </ac:picMkLst>
        </pc:picChg>
      </pc:sldChg>
      <pc:sldChg chg="modSp">
        <pc:chgData name="Tsujimoto,Mitsuhiro 辻本光宏(関東北甲信越統括支店O領域専門室)" userId="7251bc67-91ee-45c9-97e7-9c240c9b485c" providerId="ADAL" clId="{84BEBAD3-CDC6-4E60-BDDD-D9A6E533E4C1}" dt="2021-04-26T02:08:23.105" v="1431" actId="1076"/>
        <pc:sldMkLst>
          <pc:docMk/>
          <pc:sldMk cId="4154227508" sldId="845"/>
        </pc:sldMkLst>
        <pc:spChg chg="mod">
          <ac:chgData name="Tsujimoto,Mitsuhiro 辻本光宏(関東北甲信越統括支店O領域専門室)" userId="7251bc67-91ee-45c9-97e7-9c240c9b485c" providerId="ADAL" clId="{84BEBAD3-CDC6-4E60-BDDD-D9A6E533E4C1}" dt="2021-04-26T02:08:23.105" v="1431" actId="1076"/>
          <ac:spMkLst>
            <pc:docMk/>
            <pc:sldMk cId="4154227508" sldId="845"/>
            <ac:spMk id="3" creationId="{95280CD7-1251-486F-A0D6-E05809CC9D7E}"/>
          </ac:spMkLst>
        </pc:spChg>
      </pc:sldChg>
      <pc:sldChg chg="modSp">
        <pc:chgData name="Tsujimoto,Mitsuhiro 辻本光宏(関東北甲信越統括支店O領域専門室)" userId="7251bc67-91ee-45c9-97e7-9c240c9b485c" providerId="ADAL" clId="{84BEBAD3-CDC6-4E60-BDDD-D9A6E533E4C1}" dt="2021-04-26T02:41:37.284" v="1758" actId="20577"/>
        <pc:sldMkLst>
          <pc:docMk/>
          <pc:sldMk cId="1438196563" sldId="846"/>
        </pc:sldMkLst>
        <pc:spChg chg="mod">
          <ac:chgData name="Tsujimoto,Mitsuhiro 辻本光宏(関東北甲信越統括支店O領域専門室)" userId="7251bc67-91ee-45c9-97e7-9c240c9b485c" providerId="ADAL" clId="{84BEBAD3-CDC6-4E60-BDDD-D9A6E533E4C1}" dt="2021-04-26T02:41:37.284" v="1758" actId="20577"/>
          <ac:spMkLst>
            <pc:docMk/>
            <pc:sldMk cId="1438196563" sldId="846"/>
            <ac:spMk id="5" creationId="{52708625-118C-4AF9-A524-AFAD6E7A7550}"/>
          </ac:spMkLst>
        </pc:spChg>
      </pc:sldChg>
      <pc:sldChg chg="modSp">
        <pc:chgData name="Tsujimoto,Mitsuhiro 辻本光宏(関東北甲信越統括支店O領域専門室)" userId="7251bc67-91ee-45c9-97e7-9c240c9b485c" providerId="ADAL" clId="{84BEBAD3-CDC6-4E60-BDDD-D9A6E533E4C1}" dt="2021-04-26T02:36:13.616" v="1549" actId="404"/>
        <pc:sldMkLst>
          <pc:docMk/>
          <pc:sldMk cId="106793652" sldId="847"/>
        </pc:sldMkLst>
        <pc:spChg chg="mod">
          <ac:chgData name="Tsujimoto,Mitsuhiro 辻本光宏(関東北甲信越統括支店O領域専門室)" userId="7251bc67-91ee-45c9-97e7-9c240c9b485c" providerId="ADAL" clId="{84BEBAD3-CDC6-4E60-BDDD-D9A6E533E4C1}" dt="2021-04-26T02:36:10.621" v="1548" actId="404"/>
          <ac:spMkLst>
            <pc:docMk/>
            <pc:sldMk cId="106793652" sldId="847"/>
            <ac:spMk id="5" creationId="{EFDAC30D-A299-45D2-9D7A-85E18096C40D}"/>
          </ac:spMkLst>
        </pc:spChg>
        <pc:spChg chg="mod">
          <ac:chgData name="Tsujimoto,Mitsuhiro 辻本光宏(関東北甲信越統括支店O領域専門室)" userId="7251bc67-91ee-45c9-97e7-9c240c9b485c" providerId="ADAL" clId="{84BEBAD3-CDC6-4E60-BDDD-D9A6E533E4C1}" dt="2021-04-26T02:36:13.616" v="1549" actId="404"/>
          <ac:spMkLst>
            <pc:docMk/>
            <pc:sldMk cId="106793652" sldId="847"/>
            <ac:spMk id="6" creationId="{07B75FF7-9BFB-44F2-9869-87C68594B77C}"/>
          </ac:spMkLst>
        </pc:spChg>
        <pc:spChg chg="mod">
          <ac:chgData name="Tsujimoto,Mitsuhiro 辻本光宏(関東北甲信越統括支店O領域専門室)" userId="7251bc67-91ee-45c9-97e7-9c240c9b485c" providerId="ADAL" clId="{84BEBAD3-CDC6-4E60-BDDD-D9A6E533E4C1}" dt="2021-04-26T02:09:03.606" v="1436" actId="1076"/>
          <ac:spMkLst>
            <pc:docMk/>
            <pc:sldMk cId="106793652" sldId="847"/>
            <ac:spMk id="7" creationId="{E28748BF-DDEE-4142-9DF4-0C207954F653}"/>
          </ac:spMkLst>
        </pc:spChg>
      </pc:sldChg>
      <pc:sldChg chg="addSp delSp modSp">
        <pc:chgData name="Tsujimoto,Mitsuhiro 辻本光宏(関東北甲信越統括支店O領域専門室)" userId="7251bc67-91ee-45c9-97e7-9c240c9b485c" providerId="ADAL" clId="{84BEBAD3-CDC6-4E60-BDDD-D9A6E533E4C1}" dt="2021-04-26T06:09:37.867" v="11428" actId="478"/>
        <pc:sldMkLst>
          <pc:docMk/>
          <pc:sldMk cId="2750986973" sldId="850"/>
        </pc:sldMkLst>
        <pc:spChg chg="mod">
          <ac:chgData name="Tsujimoto,Mitsuhiro 辻本光宏(関東北甲信越統括支店O領域専門室)" userId="7251bc67-91ee-45c9-97e7-9c240c9b485c" providerId="ADAL" clId="{84BEBAD3-CDC6-4E60-BDDD-D9A6E533E4C1}" dt="2021-04-26T05:01:23.448" v="7085" actId="404"/>
          <ac:spMkLst>
            <pc:docMk/>
            <pc:sldMk cId="2750986973" sldId="850"/>
            <ac:spMk id="2" creationId="{CC1162C8-AFF0-41DD-9FB3-4037F1043041}"/>
          </ac:spMkLst>
        </pc:spChg>
        <pc:spChg chg="add del">
          <ac:chgData name="Tsujimoto,Mitsuhiro 辻本光宏(関東北甲信越統括支店O領域専門室)" userId="7251bc67-91ee-45c9-97e7-9c240c9b485c" providerId="ADAL" clId="{84BEBAD3-CDC6-4E60-BDDD-D9A6E533E4C1}" dt="2021-04-26T05:01:06.097" v="7082" actId="478"/>
          <ac:spMkLst>
            <pc:docMk/>
            <pc:sldMk cId="2750986973" sldId="850"/>
            <ac:spMk id="6" creationId="{57EE3C2F-98F1-41F0-A186-6B37493844AA}"/>
          </ac:spMkLst>
        </pc:spChg>
        <pc:spChg chg="mod">
          <ac:chgData name="Tsujimoto,Mitsuhiro 辻本光宏(関東北甲信越統括支店O領域専門室)" userId="7251bc67-91ee-45c9-97e7-9c240c9b485c" providerId="ADAL" clId="{84BEBAD3-CDC6-4E60-BDDD-D9A6E533E4C1}" dt="2021-04-26T04:43:12.348" v="5855" actId="164"/>
          <ac:spMkLst>
            <pc:docMk/>
            <pc:sldMk cId="2750986973" sldId="850"/>
            <ac:spMk id="7" creationId="{57BD455B-195A-4309-AD4E-6BC6976160AA}"/>
          </ac:spMkLst>
        </pc:spChg>
        <pc:spChg chg="mod">
          <ac:chgData name="Tsujimoto,Mitsuhiro 辻本光宏(関東北甲信越統括支店O領域専門室)" userId="7251bc67-91ee-45c9-97e7-9c240c9b485c" providerId="ADAL" clId="{84BEBAD3-CDC6-4E60-BDDD-D9A6E533E4C1}" dt="2021-04-26T04:43:16.328" v="5856" actId="164"/>
          <ac:spMkLst>
            <pc:docMk/>
            <pc:sldMk cId="2750986973" sldId="850"/>
            <ac:spMk id="8" creationId="{1E911D6B-C921-4194-89ED-9733FB4A11FA}"/>
          </ac:spMkLst>
        </pc:spChg>
        <pc:spChg chg="mod">
          <ac:chgData name="Tsujimoto,Mitsuhiro 辻本光宏(関東北甲信越統括支店O領域専門室)" userId="7251bc67-91ee-45c9-97e7-9c240c9b485c" providerId="ADAL" clId="{84BEBAD3-CDC6-4E60-BDDD-D9A6E533E4C1}" dt="2021-04-26T04:43:19.703" v="5857" actId="164"/>
          <ac:spMkLst>
            <pc:docMk/>
            <pc:sldMk cId="2750986973" sldId="850"/>
            <ac:spMk id="9" creationId="{A7FFCC32-B8E9-4E35-A92F-6B38F883B0A8}"/>
          </ac:spMkLst>
        </pc:spChg>
        <pc:spChg chg="add mod">
          <ac:chgData name="Tsujimoto,Mitsuhiro 辻本光宏(関東北甲信越統括支店O領域専門室)" userId="7251bc67-91ee-45c9-97e7-9c240c9b485c" providerId="ADAL" clId="{84BEBAD3-CDC6-4E60-BDDD-D9A6E533E4C1}" dt="2021-04-26T04:58:47.711" v="6849"/>
          <ac:spMkLst>
            <pc:docMk/>
            <pc:sldMk cId="2750986973" sldId="850"/>
            <ac:spMk id="12" creationId="{8931BEBD-7143-4D5F-8AB9-75BDBD87E6D9}"/>
          </ac:spMkLst>
        </pc:spChg>
        <pc:spChg chg="add mod">
          <ac:chgData name="Tsujimoto,Mitsuhiro 辻本光宏(関東北甲信越統括支店O領域専門室)" userId="7251bc67-91ee-45c9-97e7-9c240c9b485c" providerId="ADAL" clId="{84BEBAD3-CDC6-4E60-BDDD-D9A6E533E4C1}" dt="2021-04-26T04:57:00.152" v="6642" actId="20577"/>
          <ac:spMkLst>
            <pc:docMk/>
            <pc:sldMk cId="2750986973" sldId="850"/>
            <ac:spMk id="13" creationId="{42146C5F-DF4D-4613-B33D-C308F7314F23}"/>
          </ac:spMkLst>
        </pc:spChg>
        <pc:spChg chg="mod">
          <ac:chgData name="Tsujimoto,Mitsuhiro 辻本光宏(関東北甲信越統括支店O領域専門室)" userId="7251bc67-91ee-45c9-97e7-9c240c9b485c" providerId="ADAL" clId="{84BEBAD3-CDC6-4E60-BDDD-D9A6E533E4C1}" dt="2021-04-26T04:55:24.974" v="6551" actId="1076"/>
          <ac:spMkLst>
            <pc:docMk/>
            <pc:sldMk cId="2750986973" sldId="850"/>
            <ac:spMk id="14" creationId="{D2D9FE1F-7640-4E57-B47D-D39338E3DE3E}"/>
          </ac:spMkLst>
        </pc:spChg>
        <pc:spChg chg="mod">
          <ac:chgData name="Tsujimoto,Mitsuhiro 辻本光宏(関東北甲信越統括支店O領域専門室)" userId="7251bc67-91ee-45c9-97e7-9c240c9b485c" providerId="ADAL" clId="{84BEBAD3-CDC6-4E60-BDDD-D9A6E533E4C1}" dt="2021-04-26T04:55:24.974" v="6551" actId="1076"/>
          <ac:spMkLst>
            <pc:docMk/>
            <pc:sldMk cId="2750986973" sldId="850"/>
            <ac:spMk id="15" creationId="{09214FCE-F87C-4C4C-B8FD-0D764CD152B1}"/>
          </ac:spMkLst>
        </pc:spChg>
        <pc:spChg chg="mod">
          <ac:chgData name="Tsujimoto,Mitsuhiro 辻本光宏(関東北甲信越統括支店O領域専門室)" userId="7251bc67-91ee-45c9-97e7-9c240c9b485c" providerId="ADAL" clId="{84BEBAD3-CDC6-4E60-BDDD-D9A6E533E4C1}" dt="2021-04-26T04:55:24.974" v="6551" actId="1076"/>
          <ac:spMkLst>
            <pc:docMk/>
            <pc:sldMk cId="2750986973" sldId="850"/>
            <ac:spMk id="16" creationId="{CB8BD04B-5844-411A-8516-9CD9C79DE91B}"/>
          </ac:spMkLst>
        </pc:spChg>
        <pc:spChg chg="add mod">
          <ac:chgData name="Tsujimoto,Mitsuhiro 辻本光宏(関東北甲信越統括支店O領域専門室)" userId="7251bc67-91ee-45c9-97e7-9c240c9b485c" providerId="ADAL" clId="{84BEBAD3-CDC6-4E60-BDDD-D9A6E533E4C1}" dt="2021-04-26T04:56:01.320" v="6578" actId="1038"/>
          <ac:spMkLst>
            <pc:docMk/>
            <pc:sldMk cId="2750986973" sldId="850"/>
            <ac:spMk id="17" creationId="{487F4F98-CC2E-44B4-A244-B82303392BD0}"/>
          </ac:spMkLst>
        </pc:spChg>
        <pc:spChg chg="add mod">
          <ac:chgData name="Tsujimoto,Mitsuhiro 辻本光宏(関東北甲信越統括支店O領域専門室)" userId="7251bc67-91ee-45c9-97e7-9c240c9b485c" providerId="ADAL" clId="{84BEBAD3-CDC6-4E60-BDDD-D9A6E533E4C1}" dt="2021-04-26T04:55:07.801" v="6550" actId="1076"/>
          <ac:spMkLst>
            <pc:docMk/>
            <pc:sldMk cId="2750986973" sldId="850"/>
            <ac:spMk id="18" creationId="{107D4B05-63CD-4160-8D30-3097944A19DF}"/>
          </ac:spMkLst>
        </pc:spChg>
        <pc:spChg chg="add del">
          <ac:chgData name="Tsujimoto,Mitsuhiro 辻本光宏(関東北甲信越統括支店O領域専門室)" userId="7251bc67-91ee-45c9-97e7-9c240c9b485c" providerId="ADAL" clId="{84BEBAD3-CDC6-4E60-BDDD-D9A6E533E4C1}" dt="2021-04-26T06:09:37.867" v="11428" actId="478"/>
          <ac:spMkLst>
            <pc:docMk/>
            <pc:sldMk cId="2750986973" sldId="850"/>
            <ac:spMk id="20" creationId="{05C867D6-02BE-4775-9087-CD1B0F2A81D3}"/>
          </ac:spMkLst>
        </pc:spChg>
        <pc:grpChg chg="add mod">
          <ac:chgData name="Tsujimoto,Mitsuhiro 辻本光宏(関東北甲信越統括支店O領域専門室)" userId="7251bc67-91ee-45c9-97e7-9c240c9b485c" providerId="ADAL" clId="{84BEBAD3-CDC6-4E60-BDDD-D9A6E533E4C1}" dt="2021-04-26T04:55:24.974" v="6551" actId="1076"/>
          <ac:grpSpMkLst>
            <pc:docMk/>
            <pc:sldMk cId="2750986973" sldId="850"/>
            <ac:grpSpMk id="3" creationId="{3E3B08D4-9C0D-4D43-895E-62A3F8C745AC}"/>
          </ac:grpSpMkLst>
        </pc:grpChg>
        <pc:grpChg chg="add mod">
          <ac:chgData name="Tsujimoto,Mitsuhiro 辻本光宏(関東北甲信越統括支店O領域専門室)" userId="7251bc67-91ee-45c9-97e7-9c240c9b485c" providerId="ADAL" clId="{84BEBAD3-CDC6-4E60-BDDD-D9A6E533E4C1}" dt="2021-04-26T04:55:24.974" v="6551" actId="1076"/>
          <ac:grpSpMkLst>
            <pc:docMk/>
            <pc:sldMk cId="2750986973" sldId="850"/>
            <ac:grpSpMk id="4" creationId="{ADB34CE8-972E-4B66-86C7-1306CFB6306C}"/>
          </ac:grpSpMkLst>
        </pc:grpChg>
        <pc:grpChg chg="add mod">
          <ac:chgData name="Tsujimoto,Mitsuhiro 辻本光宏(関東北甲信越統括支店O領域専門室)" userId="7251bc67-91ee-45c9-97e7-9c240c9b485c" providerId="ADAL" clId="{84BEBAD3-CDC6-4E60-BDDD-D9A6E533E4C1}" dt="2021-04-26T04:55:24.974" v="6551" actId="1076"/>
          <ac:grpSpMkLst>
            <pc:docMk/>
            <pc:sldMk cId="2750986973" sldId="850"/>
            <ac:grpSpMk id="5" creationId="{8E6E26DC-9E26-4893-9E9B-FF17C3D3B3E0}"/>
          </ac:grpSpMkLst>
        </pc:grpChg>
        <pc:picChg chg="mod">
          <ac:chgData name="Tsujimoto,Mitsuhiro 辻本光宏(関東北甲信越統括支店O領域専門室)" userId="7251bc67-91ee-45c9-97e7-9c240c9b485c" providerId="ADAL" clId="{84BEBAD3-CDC6-4E60-BDDD-D9A6E533E4C1}" dt="2021-04-26T04:43:16.328" v="5856" actId="164"/>
          <ac:picMkLst>
            <pc:docMk/>
            <pc:sldMk cId="2750986973" sldId="850"/>
            <ac:picMk id="2050" creationId="{EE37813D-C78B-458D-AD0A-E7289C7716F0}"/>
          </ac:picMkLst>
        </pc:picChg>
        <pc:picChg chg="mod">
          <ac:chgData name="Tsujimoto,Mitsuhiro 辻本光宏(関東北甲信越統括支店O領域専門室)" userId="7251bc67-91ee-45c9-97e7-9c240c9b485c" providerId="ADAL" clId="{84BEBAD3-CDC6-4E60-BDDD-D9A6E533E4C1}" dt="2021-04-26T04:43:19.703" v="5857" actId="164"/>
          <ac:picMkLst>
            <pc:docMk/>
            <pc:sldMk cId="2750986973" sldId="850"/>
            <ac:picMk id="2052" creationId="{C07B4C9A-27F3-4544-A0DA-ABAC2C13FB22}"/>
          </ac:picMkLst>
        </pc:picChg>
        <pc:picChg chg="mod">
          <ac:chgData name="Tsujimoto,Mitsuhiro 辻本光宏(関東北甲信越統括支店O領域専門室)" userId="7251bc67-91ee-45c9-97e7-9c240c9b485c" providerId="ADAL" clId="{84BEBAD3-CDC6-4E60-BDDD-D9A6E533E4C1}" dt="2021-04-26T04:43:12.348" v="5855" actId="164"/>
          <ac:picMkLst>
            <pc:docMk/>
            <pc:sldMk cId="2750986973" sldId="850"/>
            <ac:picMk id="2056" creationId="{C9518F7E-D0E0-4C0D-9549-E0EF4F6D4A19}"/>
          </ac:picMkLst>
        </pc:picChg>
      </pc:sldChg>
      <pc:sldChg chg="modSp">
        <pc:chgData name="Tsujimoto,Mitsuhiro 辻本光宏(関東北甲信越統括支店O領域専門室)" userId="7251bc67-91ee-45c9-97e7-9c240c9b485c" providerId="ADAL" clId="{84BEBAD3-CDC6-4E60-BDDD-D9A6E533E4C1}" dt="2021-04-26T02:10:03.837" v="1453" actId="403"/>
        <pc:sldMkLst>
          <pc:docMk/>
          <pc:sldMk cId="3543397277" sldId="851"/>
        </pc:sldMkLst>
        <pc:spChg chg="mod">
          <ac:chgData name="Tsujimoto,Mitsuhiro 辻本光宏(関東北甲信越統括支店O領域専門室)" userId="7251bc67-91ee-45c9-97e7-9c240c9b485c" providerId="ADAL" clId="{84BEBAD3-CDC6-4E60-BDDD-D9A6E533E4C1}" dt="2021-04-26T02:10:03.837" v="1453" actId="403"/>
          <ac:spMkLst>
            <pc:docMk/>
            <pc:sldMk cId="3543397277" sldId="851"/>
            <ac:spMk id="9" creationId="{961A8DDC-52FD-43C8-8EB1-F361125483B3}"/>
          </ac:spMkLst>
        </pc:spChg>
      </pc:sldChg>
      <pc:sldChg chg="addSp modSp">
        <pc:chgData name="Tsujimoto,Mitsuhiro 辻本光宏(関東北甲信越統括支店O領域専門室)" userId="7251bc67-91ee-45c9-97e7-9c240c9b485c" providerId="ADAL" clId="{84BEBAD3-CDC6-4E60-BDDD-D9A6E533E4C1}" dt="2021-04-26T02:42:06.282" v="1760" actId="20577"/>
        <pc:sldMkLst>
          <pc:docMk/>
          <pc:sldMk cId="1779646733" sldId="852"/>
        </pc:sldMkLst>
        <pc:spChg chg="mod">
          <ac:chgData name="Tsujimoto,Mitsuhiro 辻本光宏(関東北甲信越統括支店O領域専門室)" userId="7251bc67-91ee-45c9-97e7-9c240c9b485c" providerId="ADAL" clId="{84BEBAD3-CDC6-4E60-BDDD-D9A6E533E4C1}" dt="2021-04-26T02:42:06.282" v="1760" actId="20577"/>
          <ac:spMkLst>
            <pc:docMk/>
            <pc:sldMk cId="1779646733" sldId="852"/>
            <ac:spMk id="3" creationId="{4633F855-18B5-4A22-8D2D-BCEE2D3D6A12}"/>
          </ac:spMkLst>
        </pc:spChg>
        <pc:spChg chg="mod">
          <ac:chgData name="Tsujimoto,Mitsuhiro 辻本光宏(関東北甲信越統括支店O領域専門室)" userId="7251bc67-91ee-45c9-97e7-9c240c9b485c" providerId="ADAL" clId="{84BEBAD3-CDC6-4E60-BDDD-D9A6E533E4C1}" dt="2021-04-26T02:10:14.159" v="1459" actId="1036"/>
          <ac:spMkLst>
            <pc:docMk/>
            <pc:sldMk cId="1779646733" sldId="852"/>
            <ac:spMk id="6" creationId="{219B40BE-267B-4362-96C4-A668AC994D93}"/>
          </ac:spMkLst>
        </pc:spChg>
        <pc:spChg chg="mod">
          <ac:chgData name="Tsujimoto,Mitsuhiro 辻本光宏(関東北甲信越統括支店O領域専門室)" userId="7251bc67-91ee-45c9-97e7-9c240c9b485c" providerId="ADAL" clId="{84BEBAD3-CDC6-4E60-BDDD-D9A6E533E4C1}" dt="2021-04-26T02:10:14.159" v="1459" actId="1036"/>
          <ac:spMkLst>
            <pc:docMk/>
            <pc:sldMk cId="1779646733" sldId="852"/>
            <ac:spMk id="8" creationId="{DC43F0FC-A271-454F-BA25-99C2F13FDF93}"/>
          </ac:spMkLst>
        </pc:spChg>
        <pc:spChg chg="mod">
          <ac:chgData name="Tsujimoto,Mitsuhiro 辻本光宏(関東北甲信越統括支店O領域専門室)" userId="7251bc67-91ee-45c9-97e7-9c240c9b485c" providerId="ADAL" clId="{84BEBAD3-CDC6-4E60-BDDD-D9A6E533E4C1}" dt="2021-04-26T02:10:14.159" v="1459" actId="1036"/>
          <ac:spMkLst>
            <pc:docMk/>
            <pc:sldMk cId="1779646733" sldId="852"/>
            <ac:spMk id="9" creationId="{962763CA-874E-419A-9F15-58A6D63AC4D6}"/>
          </ac:spMkLst>
        </pc:spChg>
        <pc:spChg chg="add">
          <ac:chgData name="Tsujimoto,Mitsuhiro 辻本光宏(関東北甲信越統括支店O領域専門室)" userId="7251bc67-91ee-45c9-97e7-9c240c9b485c" providerId="ADAL" clId="{84BEBAD3-CDC6-4E60-BDDD-D9A6E533E4C1}" dt="2021-04-26T02:10:19.155" v="1460"/>
          <ac:spMkLst>
            <pc:docMk/>
            <pc:sldMk cId="1779646733" sldId="852"/>
            <ac:spMk id="10" creationId="{43736234-79BB-46C1-B553-F9EC303A690D}"/>
          </ac:spMkLst>
        </pc:spChg>
        <pc:picChg chg="mod">
          <ac:chgData name="Tsujimoto,Mitsuhiro 辻本光宏(関東北甲信越統括支店O領域専門室)" userId="7251bc67-91ee-45c9-97e7-9c240c9b485c" providerId="ADAL" clId="{84BEBAD3-CDC6-4E60-BDDD-D9A6E533E4C1}" dt="2021-04-26T02:10:14.159" v="1459" actId="1036"/>
          <ac:picMkLst>
            <pc:docMk/>
            <pc:sldMk cId="1779646733" sldId="852"/>
            <ac:picMk id="5" creationId="{C3738300-ABCB-43C0-907D-FAF294956183}"/>
          </ac:picMkLst>
        </pc:picChg>
      </pc:sldChg>
      <pc:sldChg chg="addSp modSp">
        <pc:chgData name="Tsujimoto,Mitsuhiro 辻本光宏(関東北甲信越統括支店O領域専門室)" userId="7251bc67-91ee-45c9-97e7-9c240c9b485c" providerId="ADAL" clId="{84BEBAD3-CDC6-4E60-BDDD-D9A6E533E4C1}" dt="2021-04-26T02:10:23.071" v="1462" actId="403"/>
        <pc:sldMkLst>
          <pc:docMk/>
          <pc:sldMk cId="271718290" sldId="853"/>
        </pc:sldMkLst>
        <pc:spChg chg="mod">
          <ac:chgData name="Tsujimoto,Mitsuhiro 辻本光宏(関東北甲信越統括支店O領域専門室)" userId="7251bc67-91ee-45c9-97e7-9c240c9b485c" providerId="ADAL" clId="{84BEBAD3-CDC6-4E60-BDDD-D9A6E533E4C1}" dt="2021-04-26T02:10:23.071" v="1462" actId="403"/>
          <ac:spMkLst>
            <pc:docMk/>
            <pc:sldMk cId="271718290" sldId="853"/>
            <ac:spMk id="3" creationId="{4633F855-18B5-4A22-8D2D-BCEE2D3D6A12}"/>
          </ac:spMkLst>
        </pc:spChg>
        <pc:spChg chg="add">
          <ac:chgData name="Tsujimoto,Mitsuhiro 辻本光宏(関東北甲信越統括支店O領域専門室)" userId="7251bc67-91ee-45c9-97e7-9c240c9b485c" providerId="ADAL" clId="{84BEBAD3-CDC6-4E60-BDDD-D9A6E533E4C1}" dt="2021-04-26T02:10:20.336" v="1461"/>
          <ac:spMkLst>
            <pc:docMk/>
            <pc:sldMk cId="271718290" sldId="853"/>
            <ac:spMk id="11" creationId="{091E5EE8-2A52-45B9-8FC9-CD16ADA2E2AB}"/>
          </ac:spMkLst>
        </pc:spChg>
      </pc:sldChg>
      <pc:sldChg chg="modSp">
        <pc:chgData name="Tsujimoto,Mitsuhiro 辻本光宏(関東北甲信越統括支店O領域専門室)" userId="7251bc67-91ee-45c9-97e7-9c240c9b485c" providerId="ADAL" clId="{84BEBAD3-CDC6-4E60-BDDD-D9A6E533E4C1}" dt="2021-04-26T02:10:27.552" v="1463" actId="403"/>
        <pc:sldMkLst>
          <pc:docMk/>
          <pc:sldMk cId="259624961" sldId="854"/>
        </pc:sldMkLst>
        <pc:spChg chg="mod">
          <ac:chgData name="Tsujimoto,Mitsuhiro 辻本光宏(関東北甲信越統括支店O領域専門室)" userId="7251bc67-91ee-45c9-97e7-9c240c9b485c" providerId="ADAL" clId="{84BEBAD3-CDC6-4E60-BDDD-D9A6E533E4C1}" dt="2021-04-26T02:10:27.552" v="1463" actId="403"/>
          <ac:spMkLst>
            <pc:docMk/>
            <pc:sldMk cId="259624961" sldId="854"/>
            <ac:spMk id="5" creationId="{D5ABFF81-73DD-4A9E-9BBD-162138AD45B4}"/>
          </ac:spMkLst>
        </pc:spChg>
      </pc:sldChg>
      <pc:sldChg chg="modSp">
        <pc:chgData name="Tsujimoto,Mitsuhiro 辻本光宏(関東北甲信越統括支店O領域専門室)" userId="7251bc67-91ee-45c9-97e7-9c240c9b485c" providerId="ADAL" clId="{84BEBAD3-CDC6-4E60-BDDD-D9A6E533E4C1}" dt="2021-04-26T02:43:19.661" v="1844" actId="1076"/>
        <pc:sldMkLst>
          <pc:docMk/>
          <pc:sldMk cId="3047997188" sldId="855"/>
        </pc:sldMkLst>
        <pc:spChg chg="mod">
          <ac:chgData name="Tsujimoto,Mitsuhiro 辻本光宏(関東北甲信越統括支店O領域専門室)" userId="7251bc67-91ee-45c9-97e7-9c240c9b485c" providerId="ADAL" clId="{84BEBAD3-CDC6-4E60-BDDD-D9A6E533E4C1}" dt="2021-04-26T02:43:19.661" v="1844" actId="1076"/>
          <ac:spMkLst>
            <pc:docMk/>
            <pc:sldMk cId="3047997188" sldId="855"/>
            <ac:spMk id="5" creationId="{D82C5338-AFA3-4719-B324-BF9C4B32409A}"/>
          </ac:spMkLst>
        </pc:spChg>
        <pc:spChg chg="mod">
          <ac:chgData name="Tsujimoto,Mitsuhiro 辻本光宏(関東北甲信越統括支店O領域専門室)" userId="7251bc67-91ee-45c9-97e7-9c240c9b485c" providerId="ADAL" clId="{84BEBAD3-CDC6-4E60-BDDD-D9A6E533E4C1}" dt="2021-04-26T02:10:40.132" v="1472" actId="1036"/>
          <ac:spMkLst>
            <pc:docMk/>
            <pc:sldMk cId="3047997188" sldId="855"/>
            <ac:spMk id="6" creationId="{F0ECA539-1B61-4CEC-B115-8450AE695EE6}"/>
          </ac:spMkLst>
        </pc:spChg>
        <pc:spChg chg="mod">
          <ac:chgData name="Tsujimoto,Mitsuhiro 辻本光宏(関東北甲信越統括支店O領域専門室)" userId="7251bc67-91ee-45c9-97e7-9c240c9b485c" providerId="ADAL" clId="{84BEBAD3-CDC6-4E60-BDDD-D9A6E533E4C1}" dt="2021-04-26T02:10:40.132" v="1472" actId="1036"/>
          <ac:spMkLst>
            <pc:docMk/>
            <pc:sldMk cId="3047997188" sldId="855"/>
            <ac:spMk id="7" creationId="{7E61C30F-3445-4224-813C-C766ED1AA0B7}"/>
          </ac:spMkLst>
        </pc:spChg>
        <pc:spChg chg="mod">
          <ac:chgData name="Tsujimoto,Mitsuhiro 辻本光宏(関東北甲信越統括支店O領域専門室)" userId="7251bc67-91ee-45c9-97e7-9c240c9b485c" providerId="ADAL" clId="{84BEBAD3-CDC6-4E60-BDDD-D9A6E533E4C1}" dt="2021-04-26T02:10:45.714" v="1474" actId="1076"/>
          <ac:spMkLst>
            <pc:docMk/>
            <pc:sldMk cId="3047997188" sldId="855"/>
            <ac:spMk id="9" creationId="{9A856029-DE93-4109-91D5-6D921E1C8F9C}"/>
          </ac:spMkLst>
        </pc:spChg>
        <pc:picChg chg="mod">
          <ac:chgData name="Tsujimoto,Mitsuhiro 辻本光宏(関東北甲信越統括支店O領域専門室)" userId="7251bc67-91ee-45c9-97e7-9c240c9b485c" providerId="ADAL" clId="{84BEBAD3-CDC6-4E60-BDDD-D9A6E533E4C1}" dt="2021-04-26T02:10:40.132" v="1472" actId="1036"/>
          <ac:picMkLst>
            <pc:docMk/>
            <pc:sldMk cId="3047997188" sldId="855"/>
            <ac:picMk id="3" creationId="{F6A58093-8363-4E28-BF2D-C6CED939175D}"/>
          </ac:picMkLst>
        </pc:picChg>
        <pc:picChg chg="mod">
          <ac:chgData name="Tsujimoto,Mitsuhiro 辻本光宏(関東北甲信越統括支店O領域専門室)" userId="7251bc67-91ee-45c9-97e7-9c240c9b485c" providerId="ADAL" clId="{84BEBAD3-CDC6-4E60-BDDD-D9A6E533E4C1}" dt="2021-04-26T02:10:40.132" v="1472" actId="1036"/>
          <ac:picMkLst>
            <pc:docMk/>
            <pc:sldMk cId="3047997188" sldId="855"/>
            <ac:picMk id="4" creationId="{BEC48EB1-2E44-46E5-BE51-0B9991BEFBAC}"/>
          </ac:picMkLst>
        </pc:picChg>
      </pc:sldChg>
      <pc:sldChg chg="modSp">
        <pc:chgData name="Tsujimoto,Mitsuhiro 辻本光宏(関東北甲信越統括支店O領域専門室)" userId="7251bc67-91ee-45c9-97e7-9c240c9b485c" providerId="ADAL" clId="{84BEBAD3-CDC6-4E60-BDDD-D9A6E533E4C1}" dt="2021-04-26T02:11:14.740" v="1480" actId="1076"/>
        <pc:sldMkLst>
          <pc:docMk/>
          <pc:sldMk cId="2812813402" sldId="856"/>
        </pc:sldMkLst>
        <pc:spChg chg="mod">
          <ac:chgData name="Tsujimoto,Mitsuhiro 辻本光宏(関東北甲信越統括支店O領域専門室)" userId="7251bc67-91ee-45c9-97e7-9c240c9b485c" providerId="ADAL" clId="{84BEBAD3-CDC6-4E60-BDDD-D9A6E533E4C1}" dt="2021-04-26T02:11:14.740" v="1480" actId="1076"/>
          <ac:spMkLst>
            <pc:docMk/>
            <pc:sldMk cId="2812813402" sldId="856"/>
            <ac:spMk id="4" creationId="{14ACAD29-3920-4FB1-B16F-ADA6157EE5F2}"/>
          </ac:spMkLst>
        </pc:spChg>
        <pc:spChg chg="mod">
          <ac:chgData name="Tsujimoto,Mitsuhiro 辻本光宏(関東北甲信越統括支店O領域専門室)" userId="7251bc67-91ee-45c9-97e7-9c240c9b485c" providerId="ADAL" clId="{84BEBAD3-CDC6-4E60-BDDD-D9A6E533E4C1}" dt="2021-04-26T02:10:50.907" v="1475" actId="403"/>
          <ac:spMkLst>
            <pc:docMk/>
            <pc:sldMk cId="2812813402" sldId="856"/>
            <ac:spMk id="5" creationId="{D5ABFF81-73DD-4A9E-9BBD-162138AD45B4}"/>
          </ac:spMkLst>
        </pc:spChg>
      </pc:sldChg>
      <pc:sldChg chg="addSp modSp">
        <pc:chgData name="Tsujimoto,Mitsuhiro 辻本光宏(関東北甲信越統括支店O領域専門室)" userId="7251bc67-91ee-45c9-97e7-9c240c9b485c" providerId="ADAL" clId="{84BEBAD3-CDC6-4E60-BDDD-D9A6E533E4C1}" dt="2021-04-26T02:11:17.168" v="1481"/>
        <pc:sldMkLst>
          <pc:docMk/>
          <pc:sldMk cId="2204925454" sldId="857"/>
        </pc:sldMkLst>
        <pc:spChg chg="mod">
          <ac:chgData name="Tsujimoto,Mitsuhiro 辻本光宏(関東北甲信越統括支店O領域専門室)" userId="7251bc67-91ee-45c9-97e7-9c240c9b485c" providerId="ADAL" clId="{84BEBAD3-CDC6-4E60-BDDD-D9A6E533E4C1}" dt="2021-04-26T02:11:04.545" v="1478" actId="1076"/>
          <ac:spMkLst>
            <pc:docMk/>
            <pc:sldMk cId="2204925454" sldId="857"/>
            <ac:spMk id="7" creationId="{788EB9FE-FD55-4AEF-B887-EAA4AA436C90}"/>
          </ac:spMkLst>
        </pc:spChg>
        <pc:spChg chg="add">
          <ac:chgData name="Tsujimoto,Mitsuhiro 辻本光宏(関東北甲信越統括支店O領域専門室)" userId="7251bc67-91ee-45c9-97e7-9c240c9b485c" providerId="ADAL" clId="{84BEBAD3-CDC6-4E60-BDDD-D9A6E533E4C1}" dt="2021-04-26T02:11:17.168" v="1481"/>
          <ac:spMkLst>
            <pc:docMk/>
            <pc:sldMk cId="2204925454" sldId="857"/>
            <ac:spMk id="9" creationId="{35CE45AB-97FC-4B55-AE8E-E63AF0BBD259}"/>
          </ac:spMkLst>
        </pc:spChg>
      </pc:sldChg>
      <pc:sldChg chg="addSp modSp">
        <pc:chgData name="Tsujimoto,Mitsuhiro 辻本光宏(関東北甲信越統括支店O領域専門室)" userId="7251bc67-91ee-45c9-97e7-9c240c9b485c" providerId="ADAL" clId="{84BEBAD3-CDC6-4E60-BDDD-D9A6E533E4C1}" dt="2021-04-26T02:11:25.218" v="1483" actId="403"/>
        <pc:sldMkLst>
          <pc:docMk/>
          <pc:sldMk cId="3357182412" sldId="858"/>
        </pc:sldMkLst>
        <pc:spChg chg="mod">
          <ac:chgData name="Tsujimoto,Mitsuhiro 辻本光宏(関東北甲信越統括支店O領域専門室)" userId="7251bc67-91ee-45c9-97e7-9c240c9b485c" providerId="ADAL" clId="{84BEBAD3-CDC6-4E60-BDDD-D9A6E533E4C1}" dt="2021-04-26T02:11:25.218" v="1483" actId="403"/>
          <ac:spMkLst>
            <pc:docMk/>
            <pc:sldMk cId="3357182412" sldId="858"/>
            <ac:spMk id="3" creationId="{B71138B8-92EA-4816-9088-60A0896C7585}"/>
          </ac:spMkLst>
        </pc:spChg>
        <pc:spChg chg="add">
          <ac:chgData name="Tsujimoto,Mitsuhiro 辻本光宏(関東北甲信越統括支店O領域専門室)" userId="7251bc67-91ee-45c9-97e7-9c240c9b485c" providerId="ADAL" clId="{84BEBAD3-CDC6-4E60-BDDD-D9A6E533E4C1}" dt="2021-04-26T02:11:18.557" v="1482"/>
          <ac:spMkLst>
            <pc:docMk/>
            <pc:sldMk cId="3357182412" sldId="858"/>
            <ac:spMk id="5" creationId="{F030EE54-03DA-4B47-8F1F-8C12B278D79C}"/>
          </ac:spMkLst>
        </pc:spChg>
      </pc:sldChg>
      <pc:sldChg chg="modSp">
        <pc:chgData name="Tsujimoto,Mitsuhiro 辻本光宏(関東北甲信越統括支店O領域専門室)" userId="7251bc67-91ee-45c9-97e7-9c240c9b485c" providerId="ADAL" clId="{84BEBAD3-CDC6-4E60-BDDD-D9A6E533E4C1}" dt="2021-04-26T02:11:31.625" v="1485" actId="1076"/>
        <pc:sldMkLst>
          <pc:docMk/>
          <pc:sldMk cId="585620185" sldId="859"/>
        </pc:sldMkLst>
        <pc:spChg chg="mod">
          <ac:chgData name="Tsujimoto,Mitsuhiro 辻本光宏(関東北甲信越統括支店O領域専門室)" userId="7251bc67-91ee-45c9-97e7-9c240c9b485c" providerId="ADAL" clId="{84BEBAD3-CDC6-4E60-BDDD-D9A6E533E4C1}" dt="2021-04-23T08:05:08.971" v="19"/>
          <ac:spMkLst>
            <pc:docMk/>
            <pc:sldMk cId="585620185" sldId="859"/>
            <ac:spMk id="2" creationId="{2E3DB969-B2B8-4BA5-A697-299A33D8E545}"/>
          </ac:spMkLst>
        </pc:spChg>
        <pc:spChg chg="mod">
          <ac:chgData name="Tsujimoto,Mitsuhiro 辻本光宏(関東北甲信越統括支店O領域専門室)" userId="7251bc67-91ee-45c9-97e7-9c240c9b485c" providerId="ADAL" clId="{84BEBAD3-CDC6-4E60-BDDD-D9A6E533E4C1}" dt="2021-04-26T02:11:31.625" v="1485" actId="1076"/>
          <ac:spMkLst>
            <pc:docMk/>
            <pc:sldMk cId="585620185" sldId="859"/>
            <ac:spMk id="3" creationId="{CC7D3820-0D11-4825-AD82-EFFABF5E6DF8}"/>
          </ac:spMkLst>
        </pc:spChg>
      </pc:sldChg>
      <pc:sldChg chg="addSp delSp modSp">
        <pc:chgData name="Tsujimoto,Mitsuhiro 辻本光宏(関東北甲信越統括支店O領域専門室)" userId="7251bc67-91ee-45c9-97e7-9c240c9b485c" providerId="ADAL" clId="{84BEBAD3-CDC6-4E60-BDDD-D9A6E533E4C1}" dt="2021-04-26T02:11:35.735" v="1486" actId="403"/>
        <pc:sldMkLst>
          <pc:docMk/>
          <pc:sldMk cId="606222432" sldId="860"/>
        </pc:sldMkLst>
        <pc:spChg chg="del">
          <ac:chgData name="Tsujimoto,Mitsuhiro 辻本光宏(関東北甲信越統括支店O領域専門室)" userId="7251bc67-91ee-45c9-97e7-9c240c9b485c" providerId="ADAL" clId="{84BEBAD3-CDC6-4E60-BDDD-D9A6E533E4C1}" dt="2021-04-23T08:05:14.981" v="20" actId="478"/>
          <ac:spMkLst>
            <pc:docMk/>
            <pc:sldMk cId="606222432" sldId="860"/>
            <ac:spMk id="2" creationId="{0C82AB8D-726B-4B1D-8F73-94F6CD22BA16}"/>
          </ac:spMkLst>
        </pc:spChg>
        <pc:spChg chg="mod">
          <ac:chgData name="Tsujimoto,Mitsuhiro 辻本光宏(関東北甲信越統括支店O領域専門室)" userId="7251bc67-91ee-45c9-97e7-9c240c9b485c" providerId="ADAL" clId="{84BEBAD3-CDC6-4E60-BDDD-D9A6E533E4C1}" dt="2021-04-26T02:11:35.735" v="1486" actId="403"/>
          <ac:spMkLst>
            <pc:docMk/>
            <pc:sldMk cId="606222432" sldId="860"/>
            <ac:spMk id="3" creationId="{E7C6069B-9180-4EB4-A411-3225A489D812}"/>
          </ac:spMkLst>
        </pc:spChg>
        <pc:spChg chg="add">
          <ac:chgData name="Tsujimoto,Mitsuhiro 辻本光宏(関東北甲信越統括支店O領域専門室)" userId="7251bc67-91ee-45c9-97e7-9c240c9b485c" providerId="ADAL" clId="{84BEBAD3-CDC6-4E60-BDDD-D9A6E533E4C1}" dt="2021-04-23T08:05:15.530" v="21"/>
          <ac:spMkLst>
            <pc:docMk/>
            <pc:sldMk cId="606222432" sldId="860"/>
            <ac:spMk id="7" creationId="{9BE912DE-FF09-46CC-BC42-9C752E9E88FB}"/>
          </ac:spMkLst>
        </pc:spChg>
      </pc:sldChg>
      <pc:sldChg chg="modSp">
        <pc:chgData name="Tsujimoto,Mitsuhiro 辻本光宏(関東北甲信越統括支店O領域専門室)" userId="7251bc67-91ee-45c9-97e7-9c240c9b485c" providerId="ADAL" clId="{84BEBAD3-CDC6-4E60-BDDD-D9A6E533E4C1}" dt="2021-04-26T02:11:45.567" v="1490" actId="1076"/>
        <pc:sldMkLst>
          <pc:docMk/>
          <pc:sldMk cId="1473022299" sldId="861"/>
        </pc:sldMkLst>
        <pc:spChg chg="mod">
          <ac:chgData name="Tsujimoto,Mitsuhiro 辻本光宏(関東北甲信越統括支店O領域専門室)" userId="7251bc67-91ee-45c9-97e7-9c240c9b485c" providerId="ADAL" clId="{84BEBAD3-CDC6-4E60-BDDD-D9A6E533E4C1}" dt="2021-04-23T08:05:30.452" v="51"/>
          <ac:spMkLst>
            <pc:docMk/>
            <pc:sldMk cId="1473022299" sldId="861"/>
            <ac:spMk id="2" creationId="{D3BBFB07-B042-4658-897E-E9F9AF78C40C}"/>
          </ac:spMkLst>
        </pc:spChg>
        <pc:spChg chg="mod">
          <ac:chgData name="Tsujimoto,Mitsuhiro 辻本光宏(関東北甲信越統括支店O領域専門室)" userId="7251bc67-91ee-45c9-97e7-9c240c9b485c" providerId="ADAL" clId="{84BEBAD3-CDC6-4E60-BDDD-D9A6E533E4C1}" dt="2021-04-26T02:11:45.567" v="1490" actId="1076"/>
          <ac:spMkLst>
            <pc:docMk/>
            <pc:sldMk cId="1473022299" sldId="861"/>
            <ac:spMk id="3" creationId="{2972801A-940E-435D-9C2A-ABEA9E61A7AC}"/>
          </ac:spMkLst>
        </pc:spChg>
      </pc:sldChg>
      <pc:sldChg chg="modSp">
        <pc:chgData name="Tsujimoto,Mitsuhiro 辻本光宏(関東北甲信越統括支店O領域専門室)" userId="7251bc67-91ee-45c9-97e7-9c240c9b485c" providerId="ADAL" clId="{84BEBAD3-CDC6-4E60-BDDD-D9A6E533E4C1}" dt="2021-04-23T09:53:46.711" v="78"/>
        <pc:sldMkLst>
          <pc:docMk/>
          <pc:sldMk cId="2844626639" sldId="862"/>
        </pc:sldMkLst>
        <pc:spChg chg="mod">
          <ac:chgData name="Tsujimoto,Mitsuhiro 辻本光宏(関東北甲信越統括支店O領域専門室)" userId="7251bc67-91ee-45c9-97e7-9c240c9b485c" providerId="ADAL" clId="{84BEBAD3-CDC6-4E60-BDDD-D9A6E533E4C1}" dt="2021-04-23T09:53:46.711" v="78"/>
          <ac:spMkLst>
            <pc:docMk/>
            <pc:sldMk cId="2844626639" sldId="862"/>
            <ac:spMk id="5" creationId="{52708625-118C-4AF9-A524-AFAD6E7A7550}"/>
          </ac:spMkLst>
        </pc:spChg>
      </pc:sldChg>
      <pc:sldChg chg="addSp delSp modSp">
        <pc:chgData name="Tsujimoto,Mitsuhiro 辻本光宏(関東北甲信越統括支店O領域専門室)" userId="7251bc67-91ee-45c9-97e7-9c240c9b485c" providerId="ADAL" clId="{84BEBAD3-CDC6-4E60-BDDD-D9A6E533E4C1}" dt="2021-04-26T05:00:31.326" v="7013" actId="478"/>
        <pc:sldMkLst>
          <pc:docMk/>
          <pc:sldMk cId="2644342632" sldId="863"/>
        </pc:sldMkLst>
        <pc:spChg chg="mod">
          <ac:chgData name="Tsujimoto,Mitsuhiro 辻本光宏(関東北甲信越統括支店O領域専門室)" userId="7251bc67-91ee-45c9-97e7-9c240c9b485c" providerId="ADAL" clId="{84BEBAD3-CDC6-4E60-BDDD-D9A6E533E4C1}" dt="2021-04-26T05:00:22.643" v="7012" actId="404"/>
          <ac:spMkLst>
            <pc:docMk/>
            <pc:sldMk cId="2644342632" sldId="863"/>
            <ac:spMk id="2" creationId="{84EF22D3-4978-47AC-8C95-0E01BAE7E78B}"/>
          </ac:spMkLst>
        </pc:spChg>
        <pc:spChg chg="add del mod">
          <ac:chgData name="Tsujimoto,Mitsuhiro 辻本光宏(関東北甲信越統括支店O領域専門室)" userId="7251bc67-91ee-45c9-97e7-9c240c9b485c" providerId="ADAL" clId="{84BEBAD3-CDC6-4E60-BDDD-D9A6E533E4C1}" dt="2021-04-26T05:00:31.326" v="7013" actId="478"/>
          <ac:spMkLst>
            <pc:docMk/>
            <pc:sldMk cId="2644342632" sldId="863"/>
            <ac:spMk id="3" creationId="{3664C045-B9AB-4211-B9E0-C75BC034F359}"/>
          </ac:spMkLst>
        </pc:spChg>
      </pc:sldChg>
      <pc:sldChg chg="modSp">
        <pc:chgData name="Tsujimoto,Mitsuhiro 辻本光宏(関東北甲信越統括支店O領域専門室)" userId="7251bc67-91ee-45c9-97e7-9c240c9b485c" providerId="ADAL" clId="{84BEBAD3-CDC6-4E60-BDDD-D9A6E533E4C1}" dt="2021-04-26T02:09:26.360" v="1443" actId="403"/>
        <pc:sldMkLst>
          <pc:docMk/>
          <pc:sldMk cId="3008612814" sldId="866"/>
        </pc:sldMkLst>
        <pc:spChg chg="mod">
          <ac:chgData name="Tsujimoto,Mitsuhiro 辻本光宏(関東北甲信越統括支店O領域専門室)" userId="7251bc67-91ee-45c9-97e7-9c240c9b485c" providerId="ADAL" clId="{84BEBAD3-CDC6-4E60-BDDD-D9A6E533E4C1}" dt="2021-04-26T02:09:26.360" v="1443" actId="403"/>
          <ac:spMkLst>
            <pc:docMk/>
            <pc:sldMk cId="3008612814" sldId="866"/>
            <ac:spMk id="37" creationId="{326FB8DD-205A-4C46-8D05-1694D2165239}"/>
          </ac:spMkLst>
        </pc:spChg>
      </pc:sldChg>
      <pc:sldChg chg="modSp">
        <pc:chgData name="Tsujimoto,Mitsuhiro 辻本光宏(関東北甲信越統括支店O領域専門室)" userId="7251bc67-91ee-45c9-97e7-9c240c9b485c" providerId="ADAL" clId="{84BEBAD3-CDC6-4E60-BDDD-D9A6E533E4C1}" dt="2021-04-26T02:09:48.607" v="1450" actId="14100"/>
        <pc:sldMkLst>
          <pc:docMk/>
          <pc:sldMk cId="3836524626" sldId="867"/>
        </pc:sldMkLst>
        <pc:spChg chg="mod">
          <ac:chgData name="Tsujimoto,Mitsuhiro 辻本光宏(関東北甲信越統括支店O領域専門室)" userId="7251bc67-91ee-45c9-97e7-9c240c9b485c" providerId="ADAL" clId="{84BEBAD3-CDC6-4E60-BDDD-D9A6E533E4C1}" dt="2021-04-26T02:09:48.607" v="1450" actId="14100"/>
          <ac:spMkLst>
            <pc:docMk/>
            <pc:sldMk cId="3836524626" sldId="867"/>
            <ac:spMk id="14" creationId="{BB326143-66C6-4594-A01D-3E4C08BB27EF}"/>
          </ac:spMkLst>
        </pc:spChg>
      </pc:sldChg>
      <pc:sldChg chg="modSp">
        <pc:chgData name="Tsujimoto,Mitsuhiro 辻本光宏(関東北甲信越統括支店O領域専門室)" userId="7251bc67-91ee-45c9-97e7-9c240c9b485c" providerId="ADAL" clId="{84BEBAD3-CDC6-4E60-BDDD-D9A6E533E4C1}" dt="2021-04-26T02:09:30.084" v="1444" actId="403"/>
        <pc:sldMkLst>
          <pc:docMk/>
          <pc:sldMk cId="3597620934" sldId="868"/>
        </pc:sldMkLst>
        <pc:spChg chg="mod">
          <ac:chgData name="Tsujimoto,Mitsuhiro 辻本光宏(関東北甲信越統括支店O領域専門室)" userId="7251bc67-91ee-45c9-97e7-9c240c9b485c" providerId="ADAL" clId="{84BEBAD3-CDC6-4E60-BDDD-D9A6E533E4C1}" dt="2021-04-26T02:09:30.084" v="1444" actId="403"/>
          <ac:spMkLst>
            <pc:docMk/>
            <pc:sldMk cId="3597620934" sldId="868"/>
            <ac:spMk id="14" creationId="{BB326143-66C6-4594-A01D-3E4C08BB27EF}"/>
          </ac:spMkLst>
        </pc:spChg>
      </pc:sldChg>
      <pc:sldChg chg="modSp">
        <pc:chgData name="Tsujimoto,Mitsuhiro 辻本光宏(関東北甲信越統括支店O領域専門室)" userId="7251bc67-91ee-45c9-97e7-9c240c9b485c" providerId="ADAL" clId="{84BEBAD3-CDC6-4E60-BDDD-D9A6E533E4C1}" dt="2021-04-26T02:09:36.636" v="1446" actId="1076"/>
        <pc:sldMkLst>
          <pc:docMk/>
          <pc:sldMk cId="2018580732" sldId="869"/>
        </pc:sldMkLst>
        <pc:spChg chg="mod">
          <ac:chgData name="Tsujimoto,Mitsuhiro 辻本光宏(関東北甲信越統括支店O領域専門室)" userId="7251bc67-91ee-45c9-97e7-9c240c9b485c" providerId="ADAL" clId="{84BEBAD3-CDC6-4E60-BDDD-D9A6E533E4C1}" dt="2021-04-26T02:09:36.636" v="1446" actId="1076"/>
          <ac:spMkLst>
            <pc:docMk/>
            <pc:sldMk cId="2018580732" sldId="869"/>
            <ac:spMk id="3" creationId="{89BD0A32-9705-4E39-A204-9AF3909575A2}"/>
          </ac:spMkLst>
        </pc:spChg>
      </pc:sldChg>
      <pc:sldChg chg="modSp">
        <pc:chgData name="Tsujimoto,Mitsuhiro 辻本光宏(関東北甲信越統括支店O領域専門室)" userId="7251bc67-91ee-45c9-97e7-9c240c9b485c" providerId="ADAL" clId="{84BEBAD3-CDC6-4E60-BDDD-D9A6E533E4C1}" dt="2021-04-26T02:09:57.359" v="1452" actId="1076"/>
        <pc:sldMkLst>
          <pc:docMk/>
          <pc:sldMk cId="3791192522" sldId="870"/>
        </pc:sldMkLst>
        <pc:spChg chg="mod">
          <ac:chgData name="Tsujimoto,Mitsuhiro 辻本光宏(関東北甲信越統括支店O領域専門室)" userId="7251bc67-91ee-45c9-97e7-9c240c9b485c" providerId="ADAL" clId="{84BEBAD3-CDC6-4E60-BDDD-D9A6E533E4C1}" dt="2021-04-26T02:09:57.359" v="1452" actId="1076"/>
          <ac:spMkLst>
            <pc:docMk/>
            <pc:sldMk cId="3791192522" sldId="870"/>
            <ac:spMk id="3" creationId="{89BD0A32-9705-4E39-A204-9AF3909575A2}"/>
          </ac:spMkLst>
        </pc:spChg>
      </pc:sldChg>
      <pc:sldChg chg="modSp">
        <pc:chgData name="Tsujimoto,Mitsuhiro 辻本光宏(関東北甲信越統括支店O領域専門室)" userId="7251bc67-91ee-45c9-97e7-9c240c9b485c" providerId="ADAL" clId="{84BEBAD3-CDC6-4E60-BDDD-D9A6E533E4C1}" dt="2021-04-26T02:12:54.923" v="1547" actId="1035"/>
        <pc:sldMkLst>
          <pc:docMk/>
          <pc:sldMk cId="1286954728" sldId="873"/>
        </pc:sldMkLst>
        <pc:spChg chg="mod">
          <ac:chgData name="Tsujimoto,Mitsuhiro 辻本光宏(関東北甲信越統括支店O領域専門室)" userId="7251bc67-91ee-45c9-97e7-9c240c9b485c" providerId="ADAL" clId="{84BEBAD3-CDC6-4E60-BDDD-D9A6E533E4C1}" dt="2021-04-26T02:12:54.923" v="1547" actId="1035"/>
          <ac:spMkLst>
            <pc:docMk/>
            <pc:sldMk cId="1286954728" sldId="873"/>
            <ac:spMk id="3" creationId="{DFB0FD30-1212-459B-97CD-F2A59596FD0C}"/>
          </ac:spMkLst>
        </pc:spChg>
      </pc:sldChg>
      <pc:sldChg chg="modSp add">
        <pc:chgData name="Tsujimoto,Mitsuhiro 辻本光宏(関東北甲信越統括支店O領域専門室)" userId="7251bc67-91ee-45c9-97e7-9c240c9b485c" providerId="ADAL" clId="{84BEBAD3-CDC6-4E60-BDDD-D9A6E533E4C1}" dt="2021-04-23T08:06:42.451" v="55" actId="113"/>
        <pc:sldMkLst>
          <pc:docMk/>
          <pc:sldMk cId="1324505784" sldId="874"/>
        </pc:sldMkLst>
        <pc:spChg chg="mod">
          <ac:chgData name="Tsujimoto,Mitsuhiro 辻本光宏(関東北甲信越統括支店O領域専門室)" userId="7251bc67-91ee-45c9-97e7-9c240c9b485c" providerId="ADAL" clId="{84BEBAD3-CDC6-4E60-BDDD-D9A6E533E4C1}" dt="2021-04-23T08:06:42.451" v="55" actId="113"/>
          <ac:spMkLst>
            <pc:docMk/>
            <pc:sldMk cId="1324505784" sldId="874"/>
            <ac:spMk id="15" creationId="{09214FCE-F87C-4C4C-B8FD-0D764CD152B1}"/>
          </ac:spMkLst>
        </pc:spChg>
      </pc:sldChg>
      <pc:sldChg chg="modSp add">
        <pc:chgData name="Tsujimoto,Mitsuhiro 辻本光宏(関東北甲信越統括支店O領域専門室)" userId="7251bc67-91ee-45c9-97e7-9c240c9b485c" providerId="ADAL" clId="{84BEBAD3-CDC6-4E60-BDDD-D9A6E533E4C1}" dt="2021-04-23T08:07:01.679" v="60" actId="113"/>
        <pc:sldMkLst>
          <pc:docMk/>
          <pc:sldMk cId="3080870429" sldId="875"/>
        </pc:sldMkLst>
        <pc:spChg chg="mod">
          <ac:chgData name="Tsujimoto,Mitsuhiro 辻本光宏(関東北甲信越統括支店O領域専門室)" userId="7251bc67-91ee-45c9-97e7-9c240c9b485c" providerId="ADAL" clId="{84BEBAD3-CDC6-4E60-BDDD-D9A6E533E4C1}" dt="2021-04-23T08:07:01.679" v="60" actId="113"/>
          <ac:spMkLst>
            <pc:docMk/>
            <pc:sldMk cId="3080870429" sldId="875"/>
            <ac:spMk id="16" creationId="{CB8BD04B-5844-411A-8516-9CD9C79DE91B}"/>
          </ac:spMkLst>
        </pc:spChg>
      </pc:sldChg>
      <pc:sldChg chg="addSp delSp modSp add">
        <pc:chgData name="Tsujimoto,Mitsuhiro 辻本光宏(関東北甲信越統括支店O領域専門室)" userId="7251bc67-91ee-45c9-97e7-9c240c9b485c" providerId="ADAL" clId="{84BEBAD3-CDC6-4E60-BDDD-D9A6E533E4C1}" dt="2021-04-26T02:06:42.642" v="1391"/>
        <pc:sldMkLst>
          <pc:docMk/>
          <pc:sldMk cId="2792958577" sldId="876"/>
        </pc:sldMkLst>
        <pc:spChg chg="add mod">
          <ac:chgData name="Tsujimoto,Mitsuhiro 辻本光宏(関東北甲信越統括支店O領域専門室)" userId="7251bc67-91ee-45c9-97e7-9c240c9b485c" providerId="ADAL" clId="{84BEBAD3-CDC6-4E60-BDDD-D9A6E533E4C1}" dt="2021-04-26T01:49:26.607" v="982"/>
          <ac:spMkLst>
            <pc:docMk/>
            <pc:sldMk cId="2792958577" sldId="876"/>
            <ac:spMk id="2" creationId="{A87B48B6-6C85-48E3-804B-9308D79226C5}"/>
          </ac:spMkLst>
        </pc:spChg>
        <pc:spChg chg="add del mod">
          <ac:chgData name="Tsujimoto,Mitsuhiro 辻本光宏(関東北甲信越統括支店O領域専門室)" userId="7251bc67-91ee-45c9-97e7-9c240c9b485c" providerId="ADAL" clId="{84BEBAD3-CDC6-4E60-BDDD-D9A6E533E4C1}" dt="2021-04-26T02:04:53.561" v="1203" actId="478"/>
          <ac:spMkLst>
            <pc:docMk/>
            <pc:sldMk cId="2792958577" sldId="876"/>
            <ac:spMk id="9" creationId="{399E1433-D881-422B-B5E9-C2A936F1BBFC}"/>
          </ac:spMkLst>
        </pc:spChg>
        <pc:spChg chg="add mod">
          <ac:chgData name="Tsujimoto,Mitsuhiro 辻本光宏(関東北甲信越統括支店O領域専門室)" userId="7251bc67-91ee-45c9-97e7-9c240c9b485c" providerId="ADAL" clId="{84BEBAD3-CDC6-4E60-BDDD-D9A6E533E4C1}" dt="2021-04-26T02:06:42.642" v="1391"/>
          <ac:spMkLst>
            <pc:docMk/>
            <pc:sldMk cId="2792958577" sldId="876"/>
            <ac:spMk id="16" creationId="{38445AB1-2E12-4DC5-9DDA-57E509A17121}"/>
          </ac:spMkLst>
        </pc:spChg>
        <pc:spChg chg="add mod">
          <ac:chgData name="Tsujimoto,Mitsuhiro 辻本光宏(関東北甲信越統括支店O領域専門室)" userId="7251bc67-91ee-45c9-97e7-9c240c9b485c" providerId="ADAL" clId="{84BEBAD3-CDC6-4E60-BDDD-D9A6E533E4C1}" dt="2021-04-26T02:05:59.004" v="1366" actId="1076"/>
          <ac:spMkLst>
            <pc:docMk/>
            <pc:sldMk cId="2792958577" sldId="876"/>
            <ac:spMk id="17" creationId="{6BF8955A-E231-473D-A7BF-982A1993B627}"/>
          </ac:spMkLst>
        </pc:spChg>
        <pc:picChg chg="add del mod modCrop">
          <ac:chgData name="Tsujimoto,Mitsuhiro 辻本光宏(関東北甲信越統括支店O領域専門室)" userId="7251bc67-91ee-45c9-97e7-9c240c9b485c" providerId="ADAL" clId="{84BEBAD3-CDC6-4E60-BDDD-D9A6E533E4C1}" dt="2021-04-26T02:02:06.860" v="986" actId="478"/>
          <ac:picMkLst>
            <pc:docMk/>
            <pc:sldMk cId="2792958577" sldId="876"/>
            <ac:picMk id="3" creationId="{94E3450A-CCB4-473A-B7B1-F3E62B6974FA}"/>
          </ac:picMkLst>
        </pc:picChg>
        <pc:picChg chg="add mod">
          <ac:chgData name="Tsujimoto,Mitsuhiro 辻本光宏(関東北甲信越統括支店O領域専門室)" userId="7251bc67-91ee-45c9-97e7-9c240c9b485c" providerId="ADAL" clId="{84BEBAD3-CDC6-4E60-BDDD-D9A6E533E4C1}" dt="2021-04-26T02:04:58.283" v="1214" actId="1036"/>
          <ac:picMkLst>
            <pc:docMk/>
            <pc:sldMk cId="2792958577" sldId="876"/>
            <ac:picMk id="4" creationId="{321832F7-50DC-4605-8AA7-62DB640AF3DF}"/>
          </ac:picMkLst>
        </pc:picChg>
        <pc:cxnChg chg="add mod">
          <ac:chgData name="Tsujimoto,Mitsuhiro 辻本光宏(関東北甲信越統括支店O領域専門室)" userId="7251bc67-91ee-45c9-97e7-9c240c9b485c" providerId="ADAL" clId="{84BEBAD3-CDC6-4E60-BDDD-D9A6E533E4C1}" dt="2021-04-26T02:04:58.283" v="1214" actId="1036"/>
          <ac:cxnSpMkLst>
            <pc:docMk/>
            <pc:sldMk cId="2792958577" sldId="876"/>
            <ac:cxnSpMk id="6" creationId="{F92B4802-90C1-4A46-8812-71E11B5C9C5D}"/>
          </ac:cxnSpMkLst>
        </pc:cxnChg>
        <pc:cxnChg chg="add mod">
          <ac:chgData name="Tsujimoto,Mitsuhiro 辻本光宏(関東北甲信越統括支店O領域専門室)" userId="7251bc67-91ee-45c9-97e7-9c240c9b485c" providerId="ADAL" clId="{84BEBAD3-CDC6-4E60-BDDD-D9A6E533E4C1}" dt="2021-04-26T02:04:58.283" v="1214" actId="1036"/>
          <ac:cxnSpMkLst>
            <pc:docMk/>
            <pc:sldMk cId="2792958577" sldId="876"/>
            <ac:cxnSpMk id="7" creationId="{1434D183-C5A5-4F31-B2D4-BC6D8F123502}"/>
          </ac:cxnSpMkLst>
        </pc:cxnChg>
        <pc:cxnChg chg="add mod">
          <ac:chgData name="Tsujimoto,Mitsuhiro 辻本光宏(関東北甲信越統括支店O領域専門室)" userId="7251bc67-91ee-45c9-97e7-9c240c9b485c" providerId="ADAL" clId="{84BEBAD3-CDC6-4E60-BDDD-D9A6E533E4C1}" dt="2021-04-26T02:04:58.283" v="1214" actId="1036"/>
          <ac:cxnSpMkLst>
            <pc:docMk/>
            <pc:sldMk cId="2792958577" sldId="876"/>
            <ac:cxnSpMk id="8" creationId="{C53875F8-1928-46BA-BB0C-05669915B192}"/>
          </ac:cxnSpMkLst>
        </pc:cxnChg>
        <pc:cxnChg chg="add mod">
          <ac:chgData name="Tsujimoto,Mitsuhiro 辻本光宏(関東北甲信越統括支店O領域専門室)" userId="7251bc67-91ee-45c9-97e7-9c240c9b485c" providerId="ADAL" clId="{84BEBAD3-CDC6-4E60-BDDD-D9A6E533E4C1}" dt="2021-04-26T02:04:58.283" v="1214" actId="1036"/>
          <ac:cxnSpMkLst>
            <pc:docMk/>
            <pc:sldMk cId="2792958577" sldId="876"/>
            <ac:cxnSpMk id="11" creationId="{EF8695D0-3247-45EE-9495-37503AD664A6}"/>
          </ac:cxnSpMkLst>
        </pc:cxnChg>
        <pc:cxnChg chg="add del">
          <ac:chgData name="Tsujimoto,Mitsuhiro 辻本光宏(関東北甲信越統括支店O領域専門室)" userId="7251bc67-91ee-45c9-97e7-9c240c9b485c" providerId="ADAL" clId="{84BEBAD3-CDC6-4E60-BDDD-D9A6E533E4C1}" dt="2021-04-26T02:04:02.993" v="1011"/>
          <ac:cxnSpMkLst>
            <pc:docMk/>
            <pc:sldMk cId="2792958577" sldId="876"/>
            <ac:cxnSpMk id="13" creationId="{0F2703E3-9FF3-42BF-823E-745A3929A595}"/>
          </ac:cxnSpMkLst>
        </pc:cxnChg>
        <pc:cxnChg chg="add mod">
          <ac:chgData name="Tsujimoto,Mitsuhiro 辻本光宏(関東北甲信越統括支店O領域専門室)" userId="7251bc67-91ee-45c9-97e7-9c240c9b485c" providerId="ADAL" clId="{84BEBAD3-CDC6-4E60-BDDD-D9A6E533E4C1}" dt="2021-04-26T02:04:58.283" v="1214" actId="1036"/>
          <ac:cxnSpMkLst>
            <pc:docMk/>
            <pc:sldMk cId="2792958577" sldId="876"/>
            <ac:cxnSpMk id="14" creationId="{81C22F14-F422-49E6-B450-B4565E6FA204}"/>
          </ac:cxnSpMkLst>
        </pc:cxnChg>
        <pc:cxnChg chg="add mod">
          <ac:chgData name="Tsujimoto,Mitsuhiro 辻本光宏(関東北甲信越統括支店O領域専門室)" userId="7251bc67-91ee-45c9-97e7-9c240c9b485c" providerId="ADAL" clId="{84BEBAD3-CDC6-4E60-BDDD-D9A6E533E4C1}" dt="2021-04-26T02:04:58.283" v="1214" actId="1036"/>
          <ac:cxnSpMkLst>
            <pc:docMk/>
            <pc:sldMk cId="2792958577" sldId="876"/>
            <ac:cxnSpMk id="15" creationId="{5DAB4F12-78FD-4AA4-ADB4-71B4C8489E32}"/>
          </ac:cxnSpMkLst>
        </pc:cxnChg>
      </pc:sldChg>
      <pc:sldChg chg="addSp delSp modSp add ord">
        <pc:chgData name="Tsujimoto,Mitsuhiro 辻本光宏(関東北甲信越統括支店O領域専門室)" userId="7251bc67-91ee-45c9-97e7-9c240c9b485c" providerId="ADAL" clId="{84BEBAD3-CDC6-4E60-BDDD-D9A6E533E4C1}" dt="2021-04-26T06:09:42.367" v="11429" actId="478"/>
        <pc:sldMkLst>
          <pc:docMk/>
          <pc:sldMk cId="2666405214" sldId="877"/>
        </pc:sldMkLst>
        <pc:spChg chg="add">
          <ac:chgData name="Tsujimoto,Mitsuhiro 辻本光宏(関東北甲信越統括支店O領域専門室)" userId="7251bc67-91ee-45c9-97e7-9c240c9b485c" providerId="ADAL" clId="{84BEBAD3-CDC6-4E60-BDDD-D9A6E533E4C1}" dt="2021-04-26T02:50:49.232" v="1847"/>
          <ac:spMkLst>
            <pc:docMk/>
            <pc:sldMk cId="2666405214" sldId="877"/>
            <ac:spMk id="2" creationId="{868142BA-0BF3-43FC-8F83-77F50339242E}"/>
          </ac:spMkLst>
        </pc:spChg>
        <pc:spChg chg="add mod">
          <ac:chgData name="Tsujimoto,Mitsuhiro 辻本光宏(関東北甲信越統括支店O領域専門室)" userId="7251bc67-91ee-45c9-97e7-9c240c9b485c" providerId="ADAL" clId="{84BEBAD3-CDC6-4E60-BDDD-D9A6E533E4C1}" dt="2021-04-26T02:58:43.836" v="2214" actId="1036"/>
          <ac:spMkLst>
            <pc:docMk/>
            <pc:sldMk cId="2666405214" sldId="877"/>
            <ac:spMk id="6" creationId="{4B70311E-3145-4FA7-B7CA-89C9316487CA}"/>
          </ac:spMkLst>
        </pc:spChg>
        <pc:spChg chg="add mod">
          <ac:chgData name="Tsujimoto,Mitsuhiro 辻本光宏(関東北甲信越統括支店O領域専門室)" userId="7251bc67-91ee-45c9-97e7-9c240c9b485c" providerId="ADAL" clId="{84BEBAD3-CDC6-4E60-BDDD-D9A6E533E4C1}" dt="2021-04-26T02:58:43.836" v="2214" actId="1036"/>
          <ac:spMkLst>
            <pc:docMk/>
            <pc:sldMk cId="2666405214" sldId="877"/>
            <ac:spMk id="7" creationId="{007ADFE7-CEFA-4F8D-94F8-BE825BE87D86}"/>
          </ac:spMkLst>
        </pc:spChg>
        <pc:spChg chg="add mod">
          <ac:chgData name="Tsujimoto,Mitsuhiro 辻本光宏(関東北甲信越統括支店O領域専門室)" userId="7251bc67-91ee-45c9-97e7-9c240c9b485c" providerId="ADAL" clId="{84BEBAD3-CDC6-4E60-BDDD-D9A6E533E4C1}" dt="2021-04-26T02:58:43.836" v="2214" actId="1036"/>
          <ac:spMkLst>
            <pc:docMk/>
            <pc:sldMk cId="2666405214" sldId="877"/>
            <ac:spMk id="8" creationId="{12BD33F1-9B2B-4CB4-9F2F-5114D54AB2ED}"/>
          </ac:spMkLst>
        </pc:spChg>
        <pc:spChg chg="add mod">
          <ac:chgData name="Tsujimoto,Mitsuhiro 辻本光宏(関東北甲信越統括支店O領域専門室)" userId="7251bc67-91ee-45c9-97e7-9c240c9b485c" providerId="ADAL" clId="{84BEBAD3-CDC6-4E60-BDDD-D9A6E533E4C1}" dt="2021-04-26T02:58:43.836" v="2214" actId="1036"/>
          <ac:spMkLst>
            <pc:docMk/>
            <pc:sldMk cId="2666405214" sldId="877"/>
            <ac:spMk id="11" creationId="{56BF3090-D48C-45BD-BF0C-8E1AC7E95230}"/>
          </ac:spMkLst>
        </pc:spChg>
        <pc:spChg chg="add mod">
          <ac:chgData name="Tsujimoto,Mitsuhiro 辻本光宏(関東北甲信越統括支店O領域専門室)" userId="7251bc67-91ee-45c9-97e7-9c240c9b485c" providerId="ADAL" clId="{84BEBAD3-CDC6-4E60-BDDD-D9A6E533E4C1}" dt="2021-04-26T02:58:43.836" v="2214" actId="1036"/>
          <ac:spMkLst>
            <pc:docMk/>
            <pc:sldMk cId="2666405214" sldId="877"/>
            <ac:spMk id="12" creationId="{29978B25-D04D-44E4-B490-80B352DBE670}"/>
          </ac:spMkLst>
        </pc:spChg>
        <pc:spChg chg="add mod">
          <ac:chgData name="Tsujimoto,Mitsuhiro 辻本光宏(関東北甲信越統括支店O領域専門室)" userId="7251bc67-91ee-45c9-97e7-9c240c9b485c" providerId="ADAL" clId="{84BEBAD3-CDC6-4E60-BDDD-D9A6E533E4C1}" dt="2021-04-26T02:56:46.558" v="1958" actId="1035"/>
          <ac:spMkLst>
            <pc:docMk/>
            <pc:sldMk cId="2666405214" sldId="877"/>
            <ac:spMk id="13" creationId="{F1BA79D6-B5CE-46AD-839A-E8578AD660D0}"/>
          </ac:spMkLst>
        </pc:spChg>
        <pc:spChg chg="add mod">
          <ac:chgData name="Tsujimoto,Mitsuhiro 辻本光宏(関東北甲信越統括支店O領域専門室)" userId="7251bc67-91ee-45c9-97e7-9c240c9b485c" providerId="ADAL" clId="{84BEBAD3-CDC6-4E60-BDDD-D9A6E533E4C1}" dt="2021-04-26T02:58:52.412" v="2225" actId="1036"/>
          <ac:spMkLst>
            <pc:docMk/>
            <pc:sldMk cId="2666405214" sldId="877"/>
            <ac:spMk id="15" creationId="{E4C7F22E-A9F3-495C-801A-6CC77DF1A9E1}"/>
          </ac:spMkLst>
        </pc:spChg>
        <pc:spChg chg="add mod">
          <ac:chgData name="Tsujimoto,Mitsuhiro 辻本光宏(関東北甲信越統括支店O領域専門室)" userId="7251bc67-91ee-45c9-97e7-9c240c9b485c" providerId="ADAL" clId="{84BEBAD3-CDC6-4E60-BDDD-D9A6E533E4C1}" dt="2021-04-26T04:45:54.101" v="5893" actId="1036"/>
          <ac:spMkLst>
            <pc:docMk/>
            <pc:sldMk cId="2666405214" sldId="877"/>
            <ac:spMk id="16" creationId="{D5E90F7A-15B1-4FCC-9959-32DB29D608C4}"/>
          </ac:spMkLst>
        </pc:spChg>
        <pc:spChg chg="add del mod">
          <ac:chgData name="Tsujimoto,Mitsuhiro 辻本光宏(関東北甲信越統括支店O領域専門室)" userId="7251bc67-91ee-45c9-97e7-9c240c9b485c" providerId="ADAL" clId="{84BEBAD3-CDC6-4E60-BDDD-D9A6E533E4C1}" dt="2021-04-26T06:09:42.367" v="11429" actId="478"/>
          <ac:spMkLst>
            <pc:docMk/>
            <pc:sldMk cId="2666405214" sldId="877"/>
            <ac:spMk id="17" creationId="{4C2CE727-73FC-4794-980E-3ECC4E6AAFBD}"/>
          </ac:spMkLst>
        </pc:spChg>
        <pc:picChg chg="add mod">
          <ac:chgData name="Tsujimoto,Mitsuhiro 辻本光宏(関東北甲信越統括支店O領域専門室)" userId="7251bc67-91ee-45c9-97e7-9c240c9b485c" providerId="ADAL" clId="{84BEBAD3-CDC6-4E60-BDDD-D9A6E533E4C1}" dt="2021-04-26T02:58:43.836" v="2214" actId="1036"/>
          <ac:picMkLst>
            <pc:docMk/>
            <pc:sldMk cId="2666405214" sldId="877"/>
            <ac:picMk id="3" creationId="{CF008BAC-8AE3-4FCD-8F03-D7128DA6383B}"/>
          </ac:picMkLst>
        </pc:picChg>
        <pc:picChg chg="add mod">
          <ac:chgData name="Tsujimoto,Mitsuhiro 辻本光宏(関東北甲信越統括支店O領域専門室)" userId="7251bc67-91ee-45c9-97e7-9c240c9b485c" providerId="ADAL" clId="{84BEBAD3-CDC6-4E60-BDDD-D9A6E533E4C1}" dt="2021-04-26T02:58:43.836" v="2214" actId="1036"/>
          <ac:picMkLst>
            <pc:docMk/>
            <pc:sldMk cId="2666405214" sldId="877"/>
            <ac:picMk id="4" creationId="{35AF7AB5-3BBB-4F39-9235-846BB1D40059}"/>
          </ac:picMkLst>
        </pc:picChg>
        <pc:picChg chg="add mod">
          <ac:chgData name="Tsujimoto,Mitsuhiro 辻本光宏(関東北甲信越統括支店O領域専門室)" userId="7251bc67-91ee-45c9-97e7-9c240c9b485c" providerId="ADAL" clId="{84BEBAD3-CDC6-4E60-BDDD-D9A6E533E4C1}" dt="2021-04-26T02:58:43.836" v="2214" actId="1036"/>
          <ac:picMkLst>
            <pc:docMk/>
            <pc:sldMk cId="2666405214" sldId="877"/>
            <ac:picMk id="5" creationId="{2BA6F3D9-042A-476F-ACD5-106D85DA6DF1}"/>
          </ac:picMkLst>
        </pc:picChg>
        <pc:picChg chg="add mod modCrop">
          <ac:chgData name="Tsujimoto,Mitsuhiro 辻本光宏(関東北甲信越統括支店O領域専門室)" userId="7251bc67-91ee-45c9-97e7-9c240c9b485c" providerId="ADAL" clId="{84BEBAD3-CDC6-4E60-BDDD-D9A6E533E4C1}" dt="2021-04-26T02:58:37" v="2206" actId="732"/>
          <ac:picMkLst>
            <pc:docMk/>
            <pc:sldMk cId="2666405214" sldId="877"/>
            <ac:picMk id="9" creationId="{01C766F8-A444-4A5F-A2E4-540D6E04219E}"/>
          </ac:picMkLst>
        </pc:picChg>
        <pc:picChg chg="add mod">
          <ac:chgData name="Tsujimoto,Mitsuhiro 辻本光宏(関東北甲信越統括支店O領域専門室)" userId="7251bc67-91ee-45c9-97e7-9c240c9b485c" providerId="ADAL" clId="{84BEBAD3-CDC6-4E60-BDDD-D9A6E533E4C1}" dt="2021-04-26T02:58:43.836" v="2214" actId="1036"/>
          <ac:picMkLst>
            <pc:docMk/>
            <pc:sldMk cId="2666405214" sldId="877"/>
            <ac:picMk id="10" creationId="{1EE7F01C-1AD4-4250-8C46-10B7C9B9C875}"/>
          </ac:picMkLst>
        </pc:picChg>
        <pc:picChg chg="add mod">
          <ac:chgData name="Tsujimoto,Mitsuhiro 辻本光宏(関東北甲信越統括支店O領域専門室)" userId="7251bc67-91ee-45c9-97e7-9c240c9b485c" providerId="ADAL" clId="{84BEBAD3-CDC6-4E60-BDDD-D9A6E533E4C1}" dt="2021-04-26T02:58:52.412" v="2225" actId="1036"/>
          <ac:picMkLst>
            <pc:docMk/>
            <pc:sldMk cId="2666405214" sldId="877"/>
            <ac:picMk id="14" creationId="{ACA2FB89-6304-4594-A01A-4AB557E830AD}"/>
          </ac:picMkLst>
        </pc:picChg>
      </pc:sldChg>
      <pc:sldChg chg="addSp delSp modSp add">
        <pc:chgData name="Tsujimoto,Mitsuhiro 辻本光宏(関東北甲信越統括支店O領域専門室)" userId="7251bc67-91ee-45c9-97e7-9c240c9b485c" providerId="ADAL" clId="{84BEBAD3-CDC6-4E60-BDDD-D9A6E533E4C1}" dt="2021-04-26T03:05:26.433" v="3043" actId="1035"/>
        <pc:sldMkLst>
          <pc:docMk/>
          <pc:sldMk cId="16578642" sldId="878"/>
        </pc:sldMkLst>
        <pc:spChg chg="add mod">
          <ac:chgData name="Tsujimoto,Mitsuhiro 辻本光宏(関東北甲信越統括支店O領域専門室)" userId="7251bc67-91ee-45c9-97e7-9c240c9b485c" providerId="ADAL" clId="{84BEBAD3-CDC6-4E60-BDDD-D9A6E533E4C1}" dt="2021-04-26T03:00:00.101" v="2251" actId="20577"/>
          <ac:spMkLst>
            <pc:docMk/>
            <pc:sldMk cId="16578642" sldId="878"/>
            <ac:spMk id="2" creationId="{5281A7ED-12C9-4EEC-80A5-428995E4FD3D}"/>
          </ac:spMkLst>
        </pc:spChg>
        <pc:spChg chg="add mod">
          <ac:chgData name="Tsujimoto,Mitsuhiro 辻本光宏(関東北甲信越統括支店O領域専門室)" userId="7251bc67-91ee-45c9-97e7-9c240c9b485c" providerId="ADAL" clId="{84BEBAD3-CDC6-4E60-BDDD-D9A6E533E4C1}" dt="2021-04-26T03:00:44.650" v="2259" actId="1076"/>
          <ac:spMkLst>
            <pc:docMk/>
            <pc:sldMk cId="16578642" sldId="878"/>
            <ac:spMk id="5" creationId="{071B430E-588D-4CB2-B084-46C593EC12B5}"/>
          </ac:spMkLst>
        </pc:spChg>
        <pc:spChg chg="add mod">
          <ac:chgData name="Tsujimoto,Mitsuhiro 辻本光宏(関東北甲信越統括支店O領域専門室)" userId="7251bc67-91ee-45c9-97e7-9c240c9b485c" providerId="ADAL" clId="{84BEBAD3-CDC6-4E60-BDDD-D9A6E533E4C1}" dt="2021-04-26T03:05:26.433" v="3043" actId="1035"/>
          <ac:spMkLst>
            <pc:docMk/>
            <pc:sldMk cId="16578642" sldId="878"/>
            <ac:spMk id="6" creationId="{1C768680-62F8-4527-B382-CFCE333AA29F}"/>
          </ac:spMkLst>
        </pc:spChg>
        <pc:spChg chg="add del mod">
          <ac:chgData name="Tsujimoto,Mitsuhiro 辻本光宏(関東北甲信越統括支店O領域専門室)" userId="7251bc67-91ee-45c9-97e7-9c240c9b485c" providerId="ADAL" clId="{84BEBAD3-CDC6-4E60-BDDD-D9A6E533E4C1}" dt="2021-04-26T03:02:31.737" v="2566" actId="478"/>
          <ac:spMkLst>
            <pc:docMk/>
            <pc:sldMk cId="16578642" sldId="878"/>
            <ac:spMk id="7" creationId="{56043AF9-EF8B-449E-9FCB-2F5C91576C9A}"/>
          </ac:spMkLst>
        </pc:spChg>
        <pc:spChg chg="add del mod">
          <ac:chgData name="Tsujimoto,Mitsuhiro 辻本光宏(関東北甲信越統括支店O領域専門室)" userId="7251bc67-91ee-45c9-97e7-9c240c9b485c" providerId="ADAL" clId="{84BEBAD3-CDC6-4E60-BDDD-D9A6E533E4C1}" dt="2021-04-26T03:04:58.721" v="3011" actId="478"/>
          <ac:spMkLst>
            <pc:docMk/>
            <pc:sldMk cId="16578642" sldId="878"/>
            <ac:spMk id="8" creationId="{5A5CE402-8730-4817-BC63-419096F03175}"/>
          </ac:spMkLst>
        </pc:spChg>
        <pc:spChg chg="add del mod">
          <ac:chgData name="Tsujimoto,Mitsuhiro 辻本光宏(関東北甲信越統括支店O領域専門室)" userId="7251bc67-91ee-45c9-97e7-9c240c9b485c" providerId="ADAL" clId="{84BEBAD3-CDC6-4E60-BDDD-D9A6E533E4C1}" dt="2021-04-26T03:04:58.721" v="3011" actId="478"/>
          <ac:spMkLst>
            <pc:docMk/>
            <pc:sldMk cId="16578642" sldId="878"/>
            <ac:spMk id="9" creationId="{DA129B34-7B94-4499-AB37-3F65035A5C3D}"/>
          </ac:spMkLst>
        </pc:spChg>
        <pc:picChg chg="add mod">
          <ac:chgData name="Tsujimoto,Mitsuhiro 辻本光宏(関東北甲信越統括支店O領域専門室)" userId="7251bc67-91ee-45c9-97e7-9c240c9b485c" providerId="ADAL" clId="{84BEBAD3-CDC6-4E60-BDDD-D9A6E533E4C1}" dt="2021-04-26T03:05:11.275" v="3032" actId="1036"/>
          <ac:picMkLst>
            <pc:docMk/>
            <pc:sldMk cId="16578642" sldId="878"/>
            <ac:picMk id="3" creationId="{8EF47528-E9D0-44C0-A391-16975915BBD5}"/>
          </ac:picMkLst>
        </pc:picChg>
        <pc:picChg chg="add mod">
          <ac:chgData name="Tsujimoto,Mitsuhiro 辻本光宏(関東北甲信越統括支店O領域専門室)" userId="7251bc67-91ee-45c9-97e7-9c240c9b485c" providerId="ADAL" clId="{84BEBAD3-CDC6-4E60-BDDD-D9A6E533E4C1}" dt="2021-04-26T03:05:11.275" v="3032" actId="1036"/>
          <ac:picMkLst>
            <pc:docMk/>
            <pc:sldMk cId="16578642" sldId="878"/>
            <ac:picMk id="4" creationId="{97F12E7C-2BA6-4959-8496-87E4D174C1F7}"/>
          </ac:picMkLst>
        </pc:picChg>
      </pc:sldChg>
      <pc:sldChg chg="addSp delSp modSp add">
        <pc:chgData name="Tsujimoto,Mitsuhiro 辻本光宏(関東北甲信越統括支店O領域専門室)" userId="7251bc67-91ee-45c9-97e7-9c240c9b485c" providerId="ADAL" clId="{84BEBAD3-CDC6-4E60-BDDD-D9A6E533E4C1}" dt="2021-04-26T03:14:26.546" v="3662" actId="1076"/>
        <pc:sldMkLst>
          <pc:docMk/>
          <pc:sldMk cId="63742668" sldId="879"/>
        </pc:sldMkLst>
        <pc:spChg chg="add">
          <ac:chgData name="Tsujimoto,Mitsuhiro 辻本光宏(関東北甲信越統括支店O領域専門室)" userId="7251bc67-91ee-45c9-97e7-9c240c9b485c" providerId="ADAL" clId="{84BEBAD3-CDC6-4E60-BDDD-D9A6E533E4C1}" dt="2021-04-26T03:05:54.243" v="3046"/>
          <ac:spMkLst>
            <pc:docMk/>
            <pc:sldMk cId="63742668" sldId="879"/>
            <ac:spMk id="2" creationId="{9D2AA808-0211-4F8D-BBD0-9CC646C9EC20}"/>
          </ac:spMkLst>
        </pc:spChg>
        <pc:spChg chg="add mod">
          <ac:chgData name="Tsujimoto,Mitsuhiro 辻本光宏(関東北甲信越統括支店O領域専門室)" userId="7251bc67-91ee-45c9-97e7-9c240c9b485c" providerId="ADAL" clId="{84BEBAD3-CDC6-4E60-BDDD-D9A6E533E4C1}" dt="2021-04-26T03:14:16.508" v="3653" actId="1035"/>
          <ac:spMkLst>
            <pc:docMk/>
            <pc:sldMk cId="63742668" sldId="879"/>
            <ac:spMk id="8" creationId="{CE993756-CD5F-4A4A-8FEF-89736D05EA19}"/>
          </ac:spMkLst>
        </pc:spChg>
        <pc:spChg chg="add mod">
          <ac:chgData name="Tsujimoto,Mitsuhiro 辻本光宏(関東北甲信越統括支店O領域専門室)" userId="7251bc67-91ee-45c9-97e7-9c240c9b485c" providerId="ADAL" clId="{84BEBAD3-CDC6-4E60-BDDD-D9A6E533E4C1}" dt="2021-04-26T03:14:16.508" v="3653" actId="1035"/>
          <ac:spMkLst>
            <pc:docMk/>
            <pc:sldMk cId="63742668" sldId="879"/>
            <ac:spMk id="9" creationId="{63A6563A-2F09-4C46-ABF2-62D0B7E68F02}"/>
          </ac:spMkLst>
        </pc:spChg>
        <pc:spChg chg="add del mod">
          <ac:chgData name="Tsujimoto,Mitsuhiro 辻本光宏(関東北甲信越統括支店O領域専門室)" userId="7251bc67-91ee-45c9-97e7-9c240c9b485c" providerId="ADAL" clId="{84BEBAD3-CDC6-4E60-BDDD-D9A6E533E4C1}" dt="2021-04-26T03:11:38.054" v="3146" actId="478"/>
          <ac:spMkLst>
            <pc:docMk/>
            <pc:sldMk cId="63742668" sldId="879"/>
            <ac:spMk id="10" creationId="{A54D959E-5BFC-4C04-9D60-A6E1BDF416EE}"/>
          </ac:spMkLst>
        </pc:spChg>
        <pc:spChg chg="add del mod">
          <ac:chgData name="Tsujimoto,Mitsuhiro 辻本光宏(関東北甲信越統括支店O領域専門室)" userId="7251bc67-91ee-45c9-97e7-9c240c9b485c" providerId="ADAL" clId="{84BEBAD3-CDC6-4E60-BDDD-D9A6E533E4C1}" dt="2021-04-26T03:11:38.054" v="3146" actId="478"/>
          <ac:spMkLst>
            <pc:docMk/>
            <pc:sldMk cId="63742668" sldId="879"/>
            <ac:spMk id="11" creationId="{D9051A18-5305-403B-B870-000C1A736FB1}"/>
          </ac:spMkLst>
        </pc:spChg>
        <pc:spChg chg="add mod">
          <ac:chgData name="Tsujimoto,Mitsuhiro 辻本光宏(関東北甲信越統括支店O領域専門室)" userId="7251bc67-91ee-45c9-97e7-9c240c9b485c" providerId="ADAL" clId="{84BEBAD3-CDC6-4E60-BDDD-D9A6E533E4C1}" dt="2021-04-26T03:11:45.177" v="3148" actId="1076"/>
          <ac:spMkLst>
            <pc:docMk/>
            <pc:sldMk cId="63742668" sldId="879"/>
            <ac:spMk id="12" creationId="{AF36EE23-92A9-4A90-BA94-7236384F1D86}"/>
          </ac:spMkLst>
        </pc:spChg>
        <pc:spChg chg="add mod">
          <ac:chgData name="Tsujimoto,Mitsuhiro 辻本光宏(関東北甲信越統括支店O領域専門室)" userId="7251bc67-91ee-45c9-97e7-9c240c9b485c" providerId="ADAL" clId="{84BEBAD3-CDC6-4E60-BDDD-D9A6E533E4C1}" dt="2021-04-26T03:14:19.490" v="3660"/>
          <ac:spMkLst>
            <pc:docMk/>
            <pc:sldMk cId="63742668" sldId="879"/>
            <ac:spMk id="13" creationId="{3BEAC96D-30B2-419E-A563-4DBACDFCB515}"/>
          </ac:spMkLst>
        </pc:spChg>
        <pc:spChg chg="add del mod">
          <ac:chgData name="Tsujimoto,Mitsuhiro 辻本光宏(関東北甲信越統括支店O領域専門室)" userId="7251bc67-91ee-45c9-97e7-9c240c9b485c" providerId="ADAL" clId="{84BEBAD3-CDC6-4E60-BDDD-D9A6E533E4C1}" dt="2021-04-26T03:13:28.589" v="3493" actId="478"/>
          <ac:spMkLst>
            <pc:docMk/>
            <pc:sldMk cId="63742668" sldId="879"/>
            <ac:spMk id="14" creationId="{995CBE94-9B9F-4557-85E8-E71B2832B4FE}"/>
          </ac:spMkLst>
        </pc:spChg>
        <pc:spChg chg="add del">
          <ac:chgData name="Tsujimoto,Mitsuhiro 辻本光宏(関東北甲信越統括支店O領域専門室)" userId="7251bc67-91ee-45c9-97e7-9c240c9b485c" providerId="ADAL" clId="{84BEBAD3-CDC6-4E60-BDDD-D9A6E533E4C1}" dt="2021-04-26T03:14:10.826" v="3638" actId="478"/>
          <ac:spMkLst>
            <pc:docMk/>
            <pc:sldMk cId="63742668" sldId="879"/>
            <ac:spMk id="15" creationId="{1AC2B0A4-38B4-47A4-B272-09B41C25405C}"/>
          </ac:spMkLst>
        </pc:spChg>
        <pc:picChg chg="add mod">
          <ac:chgData name="Tsujimoto,Mitsuhiro 辻本光宏(関東北甲信越統括支店O領域専門室)" userId="7251bc67-91ee-45c9-97e7-9c240c9b485c" providerId="ADAL" clId="{84BEBAD3-CDC6-4E60-BDDD-D9A6E533E4C1}" dt="2021-04-26T03:14:26.546" v="3662" actId="1076"/>
          <ac:picMkLst>
            <pc:docMk/>
            <pc:sldMk cId="63742668" sldId="879"/>
            <ac:picMk id="3" creationId="{D5D6D656-EDF1-459D-8B56-8CC062A64916}"/>
          </ac:picMkLst>
        </pc:picChg>
        <pc:picChg chg="add del mod">
          <ac:chgData name="Tsujimoto,Mitsuhiro 辻本光宏(関東北甲信越統括支店O領域専門室)" userId="7251bc67-91ee-45c9-97e7-9c240c9b485c" providerId="ADAL" clId="{84BEBAD3-CDC6-4E60-BDDD-D9A6E533E4C1}" dt="2021-04-26T03:07:47.882" v="3062" actId="478"/>
          <ac:picMkLst>
            <pc:docMk/>
            <pc:sldMk cId="63742668" sldId="879"/>
            <ac:picMk id="4" creationId="{ED15C45D-87DE-4173-BF62-F3DA043BBD45}"/>
          </ac:picMkLst>
        </pc:picChg>
        <pc:picChg chg="add del mod">
          <ac:chgData name="Tsujimoto,Mitsuhiro 辻本光宏(関東北甲信越統括支店O領域専門室)" userId="7251bc67-91ee-45c9-97e7-9c240c9b485c" providerId="ADAL" clId="{84BEBAD3-CDC6-4E60-BDDD-D9A6E533E4C1}" dt="2021-04-26T03:07:48.471" v="3063" actId="478"/>
          <ac:picMkLst>
            <pc:docMk/>
            <pc:sldMk cId="63742668" sldId="879"/>
            <ac:picMk id="5" creationId="{8C022469-C78C-492C-963F-BE43CBE11733}"/>
          </ac:picMkLst>
        </pc:picChg>
        <pc:picChg chg="add mod">
          <ac:chgData name="Tsujimoto,Mitsuhiro 辻本光宏(関東北甲信越統括支店O領域専門室)" userId="7251bc67-91ee-45c9-97e7-9c240c9b485c" providerId="ADAL" clId="{84BEBAD3-CDC6-4E60-BDDD-D9A6E533E4C1}" dt="2021-04-26T03:14:16.508" v="3653" actId="1035"/>
          <ac:picMkLst>
            <pc:docMk/>
            <pc:sldMk cId="63742668" sldId="879"/>
            <ac:picMk id="6" creationId="{49CDDDE9-FD72-456E-96B7-D7B5B22CB15A}"/>
          </ac:picMkLst>
        </pc:picChg>
        <pc:picChg chg="add mod">
          <ac:chgData name="Tsujimoto,Mitsuhiro 辻本光宏(関東北甲信越統括支店O領域専門室)" userId="7251bc67-91ee-45c9-97e7-9c240c9b485c" providerId="ADAL" clId="{84BEBAD3-CDC6-4E60-BDDD-D9A6E533E4C1}" dt="2021-04-26T03:14:16.508" v="3653" actId="1035"/>
          <ac:picMkLst>
            <pc:docMk/>
            <pc:sldMk cId="63742668" sldId="879"/>
            <ac:picMk id="7" creationId="{7AA957AB-4718-41EB-A946-31B3D5DF2E07}"/>
          </ac:picMkLst>
        </pc:picChg>
      </pc:sldChg>
      <pc:sldChg chg="addSp delSp modSp add">
        <pc:chgData name="Tsujimoto,Mitsuhiro 辻本光宏(関東北甲信越統括支店O領域専門室)" userId="7251bc67-91ee-45c9-97e7-9c240c9b485c" providerId="ADAL" clId="{84BEBAD3-CDC6-4E60-BDDD-D9A6E533E4C1}" dt="2021-04-26T03:21:44.567" v="4051" actId="14100"/>
        <pc:sldMkLst>
          <pc:docMk/>
          <pc:sldMk cId="372804387" sldId="880"/>
        </pc:sldMkLst>
        <pc:spChg chg="add mod">
          <ac:chgData name="Tsujimoto,Mitsuhiro 辻本光宏(関東北甲信越統括支店O領域専門室)" userId="7251bc67-91ee-45c9-97e7-9c240c9b485c" providerId="ADAL" clId="{84BEBAD3-CDC6-4E60-BDDD-D9A6E533E4C1}" dt="2021-04-26T03:17:32.634" v="3702"/>
          <ac:spMkLst>
            <pc:docMk/>
            <pc:sldMk cId="372804387" sldId="880"/>
            <ac:spMk id="2" creationId="{4EC21BBD-AF9C-4B57-9680-AFAEDE463594}"/>
          </ac:spMkLst>
        </pc:spChg>
        <pc:spChg chg="add del mod">
          <ac:chgData name="Tsujimoto,Mitsuhiro 辻本光宏(関東北甲信越統括支店O領域専門室)" userId="7251bc67-91ee-45c9-97e7-9c240c9b485c" providerId="ADAL" clId="{84BEBAD3-CDC6-4E60-BDDD-D9A6E533E4C1}" dt="2021-04-26T03:17:44.107" v="3705" actId="478"/>
          <ac:spMkLst>
            <pc:docMk/>
            <pc:sldMk cId="372804387" sldId="880"/>
            <ac:spMk id="5" creationId="{5CF8C7B2-5E0A-4CD2-9518-8F985DAA8B35}"/>
          </ac:spMkLst>
        </pc:spChg>
        <pc:spChg chg="add mod">
          <ac:chgData name="Tsujimoto,Mitsuhiro 辻本光宏(関東北甲信越統括支店O領域専門室)" userId="7251bc67-91ee-45c9-97e7-9c240c9b485c" providerId="ADAL" clId="{84BEBAD3-CDC6-4E60-BDDD-D9A6E533E4C1}" dt="2021-04-26T03:20:48.977" v="4022" actId="1076"/>
          <ac:spMkLst>
            <pc:docMk/>
            <pc:sldMk cId="372804387" sldId="880"/>
            <ac:spMk id="6" creationId="{345A12AB-46CE-4E1E-8765-3B7A5A0A6E70}"/>
          </ac:spMkLst>
        </pc:spChg>
        <pc:spChg chg="add del mod">
          <ac:chgData name="Tsujimoto,Mitsuhiro 辻本光宏(関東北甲信越統括支店O領域専門室)" userId="7251bc67-91ee-45c9-97e7-9c240c9b485c" providerId="ADAL" clId="{84BEBAD3-CDC6-4E60-BDDD-D9A6E533E4C1}" dt="2021-04-26T03:20:40.756" v="4008" actId="478"/>
          <ac:spMkLst>
            <pc:docMk/>
            <pc:sldMk cId="372804387" sldId="880"/>
            <ac:spMk id="7" creationId="{DA844100-62D4-4CF8-9D89-9DBAF5FDF996}"/>
          </ac:spMkLst>
        </pc:spChg>
        <pc:spChg chg="add mod">
          <ac:chgData name="Tsujimoto,Mitsuhiro 辻本光宏(関東北甲信越統括支店O領域専門室)" userId="7251bc67-91ee-45c9-97e7-9c240c9b485c" providerId="ADAL" clId="{84BEBAD3-CDC6-4E60-BDDD-D9A6E533E4C1}" dt="2021-04-26T03:21:01.439" v="4041"/>
          <ac:spMkLst>
            <pc:docMk/>
            <pc:sldMk cId="372804387" sldId="880"/>
            <ac:spMk id="8" creationId="{15005FA1-069C-471E-9AA2-E5D82B8D6305}"/>
          </ac:spMkLst>
        </pc:spChg>
        <pc:spChg chg="add mod">
          <ac:chgData name="Tsujimoto,Mitsuhiro 辻本光宏(関東北甲信越統括支店O領域専門室)" userId="7251bc67-91ee-45c9-97e7-9c240c9b485c" providerId="ADAL" clId="{84BEBAD3-CDC6-4E60-BDDD-D9A6E533E4C1}" dt="2021-04-26T03:21:44.567" v="4051" actId="14100"/>
          <ac:spMkLst>
            <pc:docMk/>
            <pc:sldMk cId="372804387" sldId="880"/>
            <ac:spMk id="9" creationId="{35AE21A7-6C90-4129-AA18-B7E103CE40CA}"/>
          </ac:spMkLst>
        </pc:spChg>
        <pc:picChg chg="add mod">
          <ac:chgData name="Tsujimoto,Mitsuhiro 辻本光宏(関東北甲信越統括支店O領域専門室)" userId="7251bc67-91ee-45c9-97e7-9c240c9b485c" providerId="ADAL" clId="{84BEBAD3-CDC6-4E60-BDDD-D9A6E533E4C1}" dt="2021-04-26T03:20:45.929" v="4021" actId="1036"/>
          <ac:picMkLst>
            <pc:docMk/>
            <pc:sldMk cId="372804387" sldId="880"/>
            <ac:picMk id="3" creationId="{CC100EC1-F16E-4BD8-9C82-BD621871F613}"/>
          </ac:picMkLst>
        </pc:picChg>
        <pc:picChg chg="add mod">
          <ac:chgData name="Tsujimoto,Mitsuhiro 辻本光宏(関東北甲信越統括支店O領域専門室)" userId="7251bc67-91ee-45c9-97e7-9c240c9b485c" providerId="ADAL" clId="{84BEBAD3-CDC6-4E60-BDDD-D9A6E533E4C1}" dt="2021-04-26T03:20:45.929" v="4021" actId="1036"/>
          <ac:picMkLst>
            <pc:docMk/>
            <pc:sldMk cId="372804387" sldId="880"/>
            <ac:picMk id="4" creationId="{E4FEA34B-5087-4040-BA41-DB91E9E80491}"/>
          </ac:picMkLst>
        </pc:picChg>
      </pc:sldChg>
      <pc:sldChg chg="addSp delSp modSp add">
        <pc:chgData name="Tsujimoto,Mitsuhiro 辻本光宏(関東北甲信越統括支店O領域専門室)" userId="7251bc67-91ee-45c9-97e7-9c240c9b485c" providerId="ADAL" clId="{84BEBAD3-CDC6-4E60-BDDD-D9A6E533E4C1}" dt="2021-04-26T05:16:30.173" v="7432" actId="403"/>
        <pc:sldMkLst>
          <pc:docMk/>
          <pc:sldMk cId="1353205464" sldId="881"/>
        </pc:sldMkLst>
        <pc:spChg chg="add mod">
          <ac:chgData name="Tsujimoto,Mitsuhiro 辻本光宏(関東北甲信越統括支店O領域専門室)" userId="7251bc67-91ee-45c9-97e7-9c240c9b485c" providerId="ADAL" clId="{84BEBAD3-CDC6-4E60-BDDD-D9A6E533E4C1}" dt="2021-04-26T03:28:32.105" v="4138"/>
          <ac:spMkLst>
            <pc:docMk/>
            <pc:sldMk cId="1353205464" sldId="881"/>
            <ac:spMk id="2" creationId="{CD906F45-9BB0-4BEE-B5FA-4763C9002AD9}"/>
          </ac:spMkLst>
        </pc:spChg>
        <pc:spChg chg="add del mod">
          <ac:chgData name="Tsujimoto,Mitsuhiro 辻本光宏(関東北甲信越統括支店O領域専門室)" userId="7251bc67-91ee-45c9-97e7-9c240c9b485c" providerId="ADAL" clId="{84BEBAD3-CDC6-4E60-BDDD-D9A6E533E4C1}" dt="2021-04-26T03:36:28.137" v="4480" actId="478"/>
          <ac:spMkLst>
            <pc:docMk/>
            <pc:sldMk cId="1353205464" sldId="881"/>
            <ac:spMk id="7" creationId="{9CC497BB-1C0F-44A8-83A9-4EC79845972E}"/>
          </ac:spMkLst>
        </pc:spChg>
        <pc:spChg chg="add del">
          <ac:chgData name="Tsujimoto,Mitsuhiro 辻本光宏(関東北甲信越統括支店O領域専門室)" userId="7251bc67-91ee-45c9-97e7-9c240c9b485c" providerId="ADAL" clId="{84BEBAD3-CDC6-4E60-BDDD-D9A6E533E4C1}" dt="2021-04-26T03:36:28.137" v="4480" actId="478"/>
          <ac:spMkLst>
            <pc:docMk/>
            <pc:sldMk cId="1353205464" sldId="881"/>
            <ac:spMk id="8" creationId="{494B254F-EBB4-4EFE-94B0-3B197C23A92E}"/>
          </ac:spMkLst>
        </pc:spChg>
        <pc:spChg chg="add mod">
          <ac:chgData name="Tsujimoto,Mitsuhiro 辻本光宏(関東北甲信越統括支店O領域専門室)" userId="7251bc67-91ee-45c9-97e7-9c240c9b485c" providerId="ADAL" clId="{84BEBAD3-CDC6-4E60-BDDD-D9A6E533E4C1}" dt="2021-04-26T05:16:30.173" v="7432" actId="403"/>
          <ac:spMkLst>
            <pc:docMk/>
            <pc:sldMk cId="1353205464" sldId="881"/>
            <ac:spMk id="9" creationId="{6CDA9107-921B-46B6-AED9-A56235B205D5}"/>
          </ac:spMkLst>
        </pc:spChg>
        <pc:spChg chg="add mod">
          <ac:chgData name="Tsujimoto,Mitsuhiro 辻本光宏(関東北甲信越統括支店O領域専門室)" userId="7251bc67-91ee-45c9-97e7-9c240c9b485c" providerId="ADAL" clId="{84BEBAD3-CDC6-4E60-BDDD-D9A6E533E4C1}" dt="2021-04-26T03:38:32.706" v="4505" actId="1076"/>
          <ac:spMkLst>
            <pc:docMk/>
            <pc:sldMk cId="1353205464" sldId="881"/>
            <ac:spMk id="10" creationId="{84DCE660-BDD0-4EFB-9D13-E61014914CAD}"/>
          </ac:spMkLst>
        </pc:spChg>
        <pc:spChg chg="add mod">
          <ac:chgData name="Tsujimoto,Mitsuhiro 辻本光宏(関東北甲信越統括支店O領域専門室)" userId="7251bc67-91ee-45c9-97e7-9c240c9b485c" providerId="ADAL" clId="{84BEBAD3-CDC6-4E60-BDDD-D9A6E533E4C1}" dt="2021-04-26T03:38:43.268" v="4517" actId="1035"/>
          <ac:spMkLst>
            <pc:docMk/>
            <pc:sldMk cId="1353205464" sldId="881"/>
            <ac:spMk id="15" creationId="{FCEAFD85-6DB2-4ED6-9C03-0176A720B7AD}"/>
          </ac:spMkLst>
        </pc:spChg>
        <pc:spChg chg="add mod">
          <ac:chgData name="Tsujimoto,Mitsuhiro 辻本光宏(関東北甲信越統括支店O領域専門室)" userId="7251bc67-91ee-45c9-97e7-9c240c9b485c" providerId="ADAL" clId="{84BEBAD3-CDC6-4E60-BDDD-D9A6E533E4C1}" dt="2021-04-26T03:38:43.268" v="4517" actId="1035"/>
          <ac:spMkLst>
            <pc:docMk/>
            <pc:sldMk cId="1353205464" sldId="881"/>
            <ac:spMk id="16" creationId="{FC027C7A-EE1A-4C01-B2F1-4377E88FA998}"/>
          </ac:spMkLst>
        </pc:spChg>
        <pc:spChg chg="add mod">
          <ac:chgData name="Tsujimoto,Mitsuhiro 辻本光宏(関東北甲信越統括支店O領域専門室)" userId="7251bc67-91ee-45c9-97e7-9c240c9b485c" providerId="ADAL" clId="{84BEBAD3-CDC6-4E60-BDDD-D9A6E533E4C1}" dt="2021-04-26T03:39:02.619" v="4530" actId="1076"/>
          <ac:spMkLst>
            <pc:docMk/>
            <pc:sldMk cId="1353205464" sldId="881"/>
            <ac:spMk id="17" creationId="{FDB4E8CA-F826-4839-AB34-B3E818B9B613}"/>
          </ac:spMkLst>
        </pc:spChg>
        <pc:spChg chg="add mod">
          <ac:chgData name="Tsujimoto,Mitsuhiro 辻本光宏(関東北甲信越統括支店O領域専門室)" userId="7251bc67-91ee-45c9-97e7-9c240c9b485c" providerId="ADAL" clId="{84BEBAD3-CDC6-4E60-BDDD-D9A6E533E4C1}" dt="2021-04-26T03:39:10.434" v="4537"/>
          <ac:spMkLst>
            <pc:docMk/>
            <pc:sldMk cId="1353205464" sldId="881"/>
            <ac:spMk id="18" creationId="{3702ACDD-6192-4F62-A1C6-DF021BE1CE82}"/>
          </ac:spMkLst>
        </pc:spChg>
        <pc:picChg chg="add mod">
          <ac:chgData name="Tsujimoto,Mitsuhiro 辻本光宏(関東北甲信越統括支店O領域専門室)" userId="7251bc67-91ee-45c9-97e7-9c240c9b485c" providerId="ADAL" clId="{84BEBAD3-CDC6-4E60-BDDD-D9A6E533E4C1}" dt="2021-04-26T03:39:24.983" v="4540" actId="1076"/>
          <ac:picMkLst>
            <pc:docMk/>
            <pc:sldMk cId="1353205464" sldId="881"/>
            <ac:picMk id="3" creationId="{29E4ECDB-358B-4300-AADA-CF1FC52EFF6B}"/>
          </ac:picMkLst>
        </pc:picChg>
        <pc:picChg chg="add mod">
          <ac:chgData name="Tsujimoto,Mitsuhiro 辻本光宏(関東北甲信越統括支店O領域専門室)" userId="7251bc67-91ee-45c9-97e7-9c240c9b485c" providerId="ADAL" clId="{84BEBAD3-CDC6-4E60-BDDD-D9A6E533E4C1}" dt="2021-04-26T03:38:43.268" v="4517" actId="1035"/>
          <ac:picMkLst>
            <pc:docMk/>
            <pc:sldMk cId="1353205464" sldId="881"/>
            <ac:picMk id="4" creationId="{9F919603-7A2F-4AAE-98BE-A4A1E30F8936}"/>
          </ac:picMkLst>
        </pc:picChg>
        <pc:picChg chg="add mod">
          <ac:chgData name="Tsujimoto,Mitsuhiro 辻本光宏(関東北甲信越統括支店O領域専門室)" userId="7251bc67-91ee-45c9-97e7-9c240c9b485c" providerId="ADAL" clId="{84BEBAD3-CDC6-4E60-BDDD-D9A6E533E4C1}" dt="2021-04-26T03:38:43.268" v="4517" actId="1035"/>
          <ac:picMkLst>
            <pc:docMk/>
            <pc:sldMk cId="1353205464" sldId="881"/>
            <ac:picMk id="5" creationId="{1C3C938E-0CDC-45FA-A2FE-0A831AEEB1A0}"/>
          </ac:picMkLst>
        </pc:picChg>
        <pc:picChg chg="add mod modCrop">
          <ac:chgData name="Tsujimoto,Mitsuhiro 辻本光宏(関東北甲信越統括支店O領域専門室)" userId="7251bc67-91ee-45c9-97e7-9c240c9b485c" providerId="ADAL" clId="{84BEBAD3-CDC6-4E60-BDDD-D9A6E533E4C1}" dt="2021-04-26T03:38:43.268" v="4517" actId="1035"/>
          <ac:picMkLst>
            <pc:docMk/>
            <pc:sldMk cId="1353205464" sldId="881"/>
            <ac:picMk id="6" creationId="{8C8E9EE3-227E-4F31-B546-BD1AD5C100FC}"/>
          </ac:picMkLst>
        </pc:picChg>
        <pc:cxnChg chg="add mod">
          <ac:chgData name="Tsujimoto,Mitsuhiro 辻本光宏(関東北甲信越統括支店O領域専門室)" userId="7251bc67-91ee-45c9-97e7-9c240c9b485c" providerId="ADAL" clId="{84BEBAD3-CDC6-4E60-BDDD-D9A6E533E4C1}" dt="2021-04-26T03:38:43.268" v="4517" actId="1035"/>
          <ac:cxnSpMkLst>
            <pc:docMk/>
            <pc:sldMk cId="1353205464" sldId="881"/>
            <ac:cxnSpMk id="11" creationId="{6BC0153A-A8C5-45CE-9D8A-DBCC2EF2E174}"/>
          </ac:cxnSpMkLst>
        </pc:cxnChg>
        <pc:cxnChg chg="add del mod">
          <ac:chgData name="Tsujimoto,Mitsuhiro 辻本光宏(関東北甲信越統括支店O領域専門室)" userId="7251bc67-91ee-45c9-97e7-9c240c9b485c" providerId="ADAL" clId="{84BEBAD3-CDC6-4E60-BDDD-D9A6E533E4C1}" dt="2021-04-26T03:37:14.486" v="4491" actId="478"/>
          <ac:cxnSpMkLst>
            <pc:docMk/>
            <pc:sldMk cId="1353205464" sldId="881"/>
            <ac:cxnSpMk id="12" creationId="{7B9534DA-A68C-4DAE-8B81-6D1C990E6200}"/>
          </ac:cxnSpMkLst>
        </pc:cxnChg>
        <pc:cxnChg chg="add mod">
          <ac:chgData name="Tsujimoto,Mitsuhiro 辻本光宏(関東北甲信越統括支店O領域専門室)" userId="7251bc67-91ee-45c9-97e7-9c240c9b485c" providerId="ADAL" clId="{84BEBAD3-CDC6-4E60-BDDD-D9A6E533E4C1}" dt="2021-04-26T03:38:43.268" v="4517" actId="1035"/>
          <ac:cxnSpMkLst>
            <pc:docMk/>
            <pc:sldMk cId="1353205464" sldId="881"/>
            <ac:cxnSpMk id="14" creationId="{3A944E85-F3E4-4F32-8071-7927337CA3BD}"/>
          </ac:cxnSpMkLst>
        </pc:cxnChg>
      </pc:sldChg>
      <pc:sldChg chg="addSp delSp modSp add">
        <pc:chgData name="Tsujimoto,Mitsuhiro 辻本光宏(関東北甲信越統括支店O領域専門室)" userId="7251bc67-91ee-45c9-97e7-9c240c9b485c" providerId="ADAL" clId="{84BEBAD3-CDC6-4E60-BDDD-D9A6E533E4C1}" dt="2021-04-26T04:35:39.820" v="5484" actId="14100"/>
        <pc:sldMkLst>
          <pc:docMk/>
          <pc:sldMk cId="2965080348" sldId="882"/>
        </pc:sldMkLst>
        <pc:spChg chg="add mod">
          <ac:chgData name="Tsujimoto,Mitsuhiro 辻本光宏(関東北甲信越統括支店O領域専門室)" userId="7251bc67-91ee-45c9-97e7-9c240c9b485c" providerId="ADAL" clId="{84BEBAD3-CDC6-4E60-BDDD-D9A6E533E4C1}" dt="2021-04-26T04:28:09.122" v="4623"/>
          <ac:spMkLst>
            <pc:docMk/>
            <pc:sldMk cId="2965080348" sldId="882"/>
            <ac:spMk id="2" creationId="{5424E571-E4EA-4D0C-81D1-57A747F51AB6}"/>
          </ac:spMkLst>
        </pc:spChg>
        <pc:spChg chg="add mod">
          <ac:chgData name="Tsujimoto,Mitsuhiro 辻本光宏(関東北甲信越統括支店O領域専門室)" userId="7251bc67-91ee-45c9-97e7-9c240c9b485c" providerId="ADAL" clId="{84BEBAD3-CDC6-4E60-BDDD-D9A6E533E4C1}" dt="2021-04-26T04:34:51.443" v="5468" actId="1076"/>
          <ac:spMkLst>
            <pc:docMk/>
            <pc:sldMk cId="2965080348" sldId="882"/>
            <ac:spMk id="5" creationId="{09D1EC28-1448-4056-815B-34599B9F40B1}"/>
          </ac:spMkLst>
        </pc:spChg>
        <pc:spChg chg="add del mod">
          <ac:chgData name="Tsujimoto,Mitsuhiro 辻本光宏(関東北甲信越統括支店O領域専門室)" userId="7251bc67-91ee-45c9-97e7-9c240c9b485c" providerId="ADAL" clId="{84BEBAD3-CDC6-4E60-BDDD-D9A6E533E4C1}" dt="2021-04-26T04:33:28.667" v="5447" actId="478"/>
          <ac:spMkLst>
            <pc:docMk/>
            <pc:sldMk cId="2965080348" sldId="882"/>
            <ac:spMk id="6" creationId="{E45C0383-497F-49FD-86A6-AECF3B5423EF}"/>
          </ac:spMkLst>
        </pc:spChg>
        <pc:spChg chg="add del mod">
          <ac:chgData name="Tsujimoto,Mitsuhiro 辻本光宏(関東北甲信越統括支店O領域専門室)" userId="7251bc67-91ee-45c9-97e7-9c240c9b485c" providerId="ADAL" clId="{84BEBAD3-CDC6-4E60-BDDD-D9A6E533E4C1}" dt="2021-04-26T04:33:28.667" v="5447" actId="478"/>
          <ac:spMkLst>
            <pc:docMk/>
            <pc:sldMk cId="2965080348" sldId="882"/>
            <ac:spMk id="7" creationId="{CF13DCB6-912B-44C4-9018-D82054F98550}"/>
          </ac:spMkLst>
        </pc:spChg>
        <pc:spChg chg="add mod">
          <ac:chgData name="Tsujimoto,Mitsuhiro 辻本光宏(関東北甲信越統括支店O領域専門室)" userId="7251bc67-91ee-45c9-97e7-9c240c9b485c" providerId="ADAL" clId="{84BEBAD3-CDC6-4E60-BDDD-D9A6E533E4C1}" dt="2021-04-26T04:35:05.730" v="5476" actId="14100"/>
          <ac:spMkLst>
            <pc:docMk/>
            <pc:sldMk cId="2965080348" sldId="882"/>
            <ac:spMk id="8" creationId="{092CACEB-0BD8-4AF9-9993-16263D5E52BF}"/>
          </ac:spMkLst>
        </pc:spChg>
        <pc:spChg chg="add mod">
          <ac:chgData name="Tsujimoto,Mitsuhiro 辻本光宏(関東北甲信越統括支店O領域専門室)" userId="7251bc67-91ee-45c9-97e7-9c240c9b485c" providerId="ADAL" clId="{84BEBAD3-CDC6-4E60-BDDD-D9A6E533E4C1}" dt="2021-04-26T04:35:22.035" v="5479" actId="14100"/>
          <ac:spMkLst>
            <pc:docMk/>
            <pc:sldMk cId="2965080348" sldId="882"/>
            <ac:spMk id="9" creationId="{4D9799C2-1960-4026-8E2B-50B34CE1BBF6}"/>
          </ac:spMkLst>
        </pc:spChg>
        <pc:picChg chg="add mod">
          <ac:chgData name="Tsujimoto,Mitsuhiro 辻本光宏(関東北甲信越統括支店O領域専門室)" userId="7251bc67-91ee-45c9-97e7-9c240c9b485c" providerId="ADAL" clId="{84BEBAD3-CDC6-4E60-BDDD-D9A6E533E4C1}" dt="2021-04-26T04:35:01.173" v="5474" actId="1076"/>
          <ac:picMkLst>
            <pc:docMk/>
            <pc:sldMk cId="2965080348" sldId="882"/>
            <ac:picMk id="3" creationId="{B720620A-9998-4397-801E-9D7C7F2064D0}"/>
          </ac:picMkLst>
        </pc:picChg>
        <pc:picChg chg="add mod">
          <ac:chgData name="Tsujimoto,Mitsuhiro 辻本光宏(関東北甲信越統括支店O領域専門室)" userId="7251bc67-91ee-45c9-97e7-9c240c9b485c" providerId="ADAL" clId="{84BEBAD3-CDC6-4E60-BDDD-D9A6E533E4C1}" dt="2021-04-26T04:35:25.235" v="5481" actId="1035"/>
          <ac:picMkLst>
            <pc:docMk/>
            <pc:sldMk cId="2965080348" sldId="882"/>
            <ac:picMk id="4" creationId="{A32BBD96-18A5-4826-B8C2-1FDB6550E2E2}"/>
          </ac:picMkLst>
        </pc:picChg>
        <pc:cxnChg chg="add mod">
          <ac:chgData name="Tsujimoto,Mitsuhiro 辻本光宏(関東北甲信越統括支店O領域専門室)" userId="7251bc67-91ee-45c9-97e7-9c240c9b485c" providerId="ADAL" clId="{84BEBAD3-CDC6-4E60-BDDD-D9A6E533E4C1}" dt="2021-04-26T04:35:39.820" v="5484" actId="14100"/>
          <ac:cxnSpMkLst>
            <pc:docMk/>
            <pc:sldMk cId="2965080348" sldId="882"/>
            <ac:cxnSpMk id="10" creationId="{9A65CF83-EF51-4A44-9279-3DB9AA08A46F}"/>
          </ac:cxnSpMkLst>
        </pc:cxnChg>
      </pc:sldChg>
      <pc:sldChg chg="modSp add">
        <pc:chgData name="Tsujimoto,Mitsuhiro 辻本光宏(関東北甲信越統括支店O領域専門室)" userId="7251bc67-91ee-45c9-97e7-9c240c9b485c" providerId="ADAL" clId="{84BEBAD3-CDC6-4E60-BDDD-D9A6E533E4C1}" dt="2021-04-26T05:01:54.420" v="7090" actId="207"/>
        <pc:sldMkLst>
          <pc:docMk/>
          <pc:sldMk cId="1163957808" sldId="883"/>
        </pc:sldMkLst>
        <pc:spChg chg="mod">
          <ac:chgData name="Tsujimoto,Mitsuhiro 辻本光宏(関東北甲信越統括支店O領域専門室)" userId="7251bc67-91ee-45c9-97e7-9c240c9b485c" providerId="ADAL" clId="{84BEBAD3-CDC6-4E60-BDDD-D9A6E533E4C1}" dt="2021-04-26T05:01:54.420" v="7090" actId="207"/>
          <ac:spMkLst>
            <pc:docMk/>
            <pc:sldMk cId="1163957808" sldId="883"/>
            <ac:spMk id="3" creationId="{F40FF731-017A-4AE1-9261-D60D79D216C2}"/>
          </ac:spMkLst>
        </pc:spChg>
      </pc:sldChg>
      <pc:sldChg chg="addSp delSp modSp add">
        <pc:chgData name="Tsujimoto,Mitsuhiro 辻本光宏(関東北甲信越統括支店O領域専門室)" userId="7251bc67-91ee-45c9-97e7-9c240c9b485c" providerId="ADAL" clId="{84BEBAD3-CDC6-4E60-BDDD-D9A6E533E4C1}" dt="2021-04-26T05:31:49.173" v="7940" actId="1076"/>
        <pc:sldMkLst>
          <pc:docMk/>
          <pc:sldMk cId="2097519585" sldId="884"/>
        </pc:sldMkLst>
        <pc:spChg chg="add mod">
          <ac:chgData name="Tsujimoto,Mitsuhiro 辻本光宏(関東北甲信越統括支店O領域専門室)" userId="7251bc67-91ee-45c9-97e7-9c240c9b485c" providerId="ADAL" clId="{84BEBAD3-CDC6-4E60-BDDD-D9A6E533E4C1}" dt="2021-04-26T05:13:02.527" v="7171"/>
          <ac:spMkLst>
            <pc:docMk/>
            <pc:sldMk cId="2097519585" sldId="884"/>
            <ac:spMk id="2" creationId="{E155C6A8-4AE8-403C-9F74-99006944AEE6}"/>
          </ac:spMkLst>
        </pc:spChg>
        <pc:spChg chg="add del">
          <ac:chgData name="Tsujimoto,Mitsuhiro 辻本光宏(関東北甲信越統括支店O領域専門室)" userId="7251bc67-91ee-45c9-97e7-9c240c9b485c" providerId="ADAL" clId="{84BEBAD3-CDC6-4E60-BDDD-D9A6E533E4C1}" dt="2021-04-26T05:13:15.538" v="7174"/>
          <ac:spMkLst>
            <pc:docMk/>
            <pc:sldMk cId="2097519585" sldId="884"/>
            <ac:spMk id="4" creationId="{4A2F50D6-26D8-4694-B870-9E7A1FA72E24}"/>
          </ac:spMkLst>
        </pc:spChg>
        <pc:spChg chg="add del">
          <ac:chgData name="Tsujimoto,Mitsuhiro 辻本光宏(関東北甲信越統括支店O領域専門室)" userId="7251bc67-91ee-45c9-97e7-9c240c9b485c" providerId="ADAL" clId="{84BEBAD3-CDC6-4E60-BDDD-D9A6E533E4C1}" dt="2021-04-26T05:13:15.538" v="7174"/>
          <ac:spMkLst>
            <pc:docMk/>
            <pc:sldMk cId="2097519585" sldId="884"/>
            <ac:spMk id="5" creationId="{949E2DD2-1FF4-4C4F-B0BF-AACE32C3A2B6}"/>
          </ac:spMkLst>
        </pc:spChg>
        <pc:spChg chg="add del">
          <ac:chgData name="Tsujimoto,Mitsuhiro 辻本光宏(関東北甲信越統括支店O領域専門室)" userId="7251bc67-91ee-45c9-97e7-9c240c9b485c" providerId="ADAL" clId="{84BEBAD3-CDC6-4E60-BDDD-D9A6E533E4C1}" dt="2021-04-26T05:13:15.538" v="7174"/>
          <ac:spMkLst>
            <pc:docMk/>
            <pc:sldMk cId="2097519585" sldId="884"/>
            <ac:spMk id="6" creationId="{69FDEB97-37A3-435B-A544-E875FFB8752D}"/>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34" creationId="{1EC64067-1B62-4C2B-8DE5-DAFD2321A115}"/>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2" creationId="{AEC607C1-FC37-459A-AFE2-867CCEDE2C95}"/>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3" creationId="{81C119FA-2D55-4B81-9FF3-773953B1391D}"/>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4" creationId="{AB6932F4-DF2C-4852-BC4F-BDECBE6D32CA}"/>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5" creationId="{62CA34B2-CAA6-43C8-AB96-64A5C4B805A1}"/>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6" creationId="{5211293B-1030-4DAF-8E2E-B66A8412B250}"/>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7" creationId="{37B25421-0F44-43B0-9AFB-209178C5B197}"/>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8" creationId="{7E274B3C-5CAE-4FB5-B74E-922D7A7B19E6}"/>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49" creationId="{B34F98D4-9F95-4767-AC17-856ECB5AE5E6}"/>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0" creationId="{0244F703-0850-4195-81E8-F3E1FFBA964F}"/>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1" creationId="{5E5DE5B1-72FC-4497-A928-A6C0152E936D}"/>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2" creationId="{DDA71BCB-6EFC-463B-BFF8-1F7721336B1C}"/>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3" creationId="{50AD6EBE-FC74-4611-BE31-0C30D809EA39}"/>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4" creationId="{84ACDB5C-7397-44E6-B17B-F852F647630A}"/>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5" creationId="{BB321524-E5EC-4E8C-83F4-6F2129315E10}"/>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6" creationId="{96DF3D46-0830-47C1-932E-C25C1CD19924}"/>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7" creationId="{87A12E0A-33D0-441C-961E-469E8A056C51}"/>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8" creationId="{7A4DB8D1-08F8-4BE6-916D-9AC1A6C5C505}"/>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59" creationId="{2B3C370D-DD32-4129-AA30-5619A20D3057}"/>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61" creationId="{060866B9-48B4-4F48-9EE8-D23D1CFF5D26}"/>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63" creationId="{C842993A-6B95-4587-B64F-57DE6D5DE7A2}"/>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65" creationId="{8C2A85EF-0717-485C-8BA7-AAB3153BF499}"/>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67" creationId="{C0A7B2DD-3C7C-4D31-9769-56C6F398147D}"/>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69" creationId="{D322F4E5-A31C-49EC-B70E-F567CD306B23}"/>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71" creationId="{E386916F-F17F-4309-98CD-B4B02D6F38EA}"/>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73" creationId="{5BF57A90-816A-4D22-B0AE-6A91A0DB6EBC}"/>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75" creationId="{C5700536-1456-4777-839A-1FC157928702}"/>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77" creationId="{2D9B02AB-E0F3-4A5E-8B4D-F9B8FA9EF9B0}"/>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79" creationId="{C9B5F245-6C8C-4203-A6CC-049DFB9909CD}"/>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81" creationId="{7A000C3C-4257-4B7A-B984-8D178043470A}"/>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82" creationId="{845F169A-9530-46CC-8926-AA1FBD56F097}"/>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83" creationId="{B0D1A006-5D87-44DF-829B-A2E6D4392FDA}"/>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84" creationId="{24215359-6FE3-4F67-AA9C-B236DB20249B}"/>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85" creationId="{90069030-E244-4FCF-B23A-2AE1DD2B7CB9}"/>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86" creationId="{95D40992-1BB8-41EA-A378-721985A43369}"/>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87" creationId="{B7797A9E-755F-4B4E-8993-073BCC0220DE}"/>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99" creationId="{5208A41E-A3AF-4E4A-AECF-318A20281E9C}"/>
          </ac:spMkLst>
        </pc:spChg>
        <pc:spChg chg="add mod">
          <ac:chgData name="Tsujimoto,Mitsuhiro 辻本光宏(関東北甲信越統括支店O領域専門室)" userId="7251bc67-91ee-45c9-97e7-9c240c9b485c" providerId="ADAL" clId="{84BEBAD3-CDC6-4E60-BDDD-D9A6E533E4C1}" dt="2021-04-26T05:13:46.682" v="7179" actId="1076"/>
          <ac:spMkLst>
            <pc:docMk/>
            <pc:sldMk cId="2097519585" sldId="884"/>
            <ac:spMk id="100" creationId="{49A790B5-6121-4E04-81D4-FFB8D97A47DF}"/>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101" creationId="{BEB888DD-0FE9-4DC5-B418-AF0AB09926D2}"/>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102" creationId="{C4990B4D-7D55-42C8-84A4-840329A0C310}"/>
          </ac:spMkLst>
        </pc:spChg>
        <pc:spChg chg="add del">
          <ac:chgData name="Tsujimoto,Mitsuhiro 辻本光宏(関東北甲信越統括支店O領域専門室)" userId="7251bc67-91ee-45c9-97e7-9c240c9b485c" providerId="ADAL" clId="{84BEBAD3-CDC6-4E60-BDDD-D9A6E533E4C1}" dt="2021-04-26T05:14:20.017" v="7186" actId="478"/>
          <ac:spMkLst>
            <pc:docMk/>
            <pc:sldMk cId="2097519585" sldId="884"/>
            <ac:spMk id="103" creationId="{C41DB29D-E356-48C8-8B05-973CAD3D9E8D}"/>
          </ac:spMkLst>
        </pc:spChg>
        <pc:spChg chg="add mod">
          <ac:chgData name="Tsujimoto,Mitsuhiro 辻本光宏(関東北甲信越統括支店O領域専門室)" userId="7251bc67-91ee-45c9-97e7-9c240c9b485c" providerId="ADAL" clId="{84BEBAD3-CDC6-4E60-BDDD-D9A6E533E4C1}" dt="2021-04-26T05:13:39.983" v="7178" actId="255"/>
          <ac:spMkLst>
            <pc:docMk/>
            <pc:sldMk cId="2097519585" sldId="884"/>
            <ac:spMk id="104" creationId="{41F2D7AD-22F4-442B-907D-A9FC1F7B579F}"/>
          </ac:spMkLst>
        </pc:spChg>
        <pc:spChg chg="add del">
          <ac:chgData name="Tsujimoto,Mitsuhiro 辻本光宏(関東北甲信越統括支店O領域専門室)" userId="7251bc67-91ee-45c9-97e7-9c240c9b485c" providerId="ADAL" clId="{84BEBAD3-CDC6-4E60-BDDD-D9A6E533E4C1}" dt="2021-04-26T05:13:51.240" v="7181" actId="478"/>
          <ac:spMkLst>
            <pc:docMk/>
            <pc:sldMk cId="2097519585" sldId="884"/>
            <ac:spMk id="105" creationId="{588DA95E-D9CE-4B03-AC75-9538918C2313}"/>
          </ac:spMkLst>
        </pc:spChg>
        <pc:spChg chg="add del">
          <ac:chgData name="Tsujimoto,Mitsuhiro 辻本光宏(関東北甲信越統括支店O領域専門室)" userId="7251bc67-91ee-45c9-97e7-9c240c9b485c" providerId="ADAL" clId="{84BEBAD3-CDC6-4E60-BDDD-D9A6E533E4C1}" dt="2021-04-26T05:13:50.460" v="7180" actId="478"/>
          <ac:spMkLst>
            <pc:docMk/>
            <pc:sldMk cId="2097519585" sldId="884"/>
            <ac:spMk id="106" creationId="{C0AB1A1D-C300-4A2A-9AE1-F802752C63BA}"/>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34" creationId="{8F79D65F-F7C3-44EF-8881-2B589E87000E}"/>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2" creationId="{0DEEAFBB-A455-4BD6-8F45-18BDFF4C7D7B}"/>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3" creationId="{9DB6CC57-946F-4688-B184-060FF4C17586}"/>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4" creationId="{48081638-784A-4352-90B4-FBD8C6EF7FD9}"/>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5" creationId="{4244FB83-35FA-472C-B204-3F3829C0A139}"/>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6" creationId="{E7680E02-AA22-45C8-A53A-B4D8ED0C56DA}"/>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7" creationId="{C0D28D7C-12BB-4D3E-A00D-CA9ACA48C33B}"/>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8" creationId="{F138CE8B-EA19-4C4F-BA6B-327C1BB4F3C1}"/>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49" creationId="{20D70F2E-F748-428F-8F5C-210A74D344E1}"/>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0" creationId="{E7BC3A4F-717C-4C66-96C6-E5E09EDB026F}"/>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1" creationId="{411569C6-01E8-421C-8C6F-BF746E2306A0}"/>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2" creationId="{BF8DA2AB-E0BC-4E0E-909A-C53E392013C4}"/>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3" creationId="{1E29FC5D-AAEF-4FC5-983D-B6CF03034F57}"/>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4" creationId="{F29C7249-0290-4654-8A78-6E9EF14E70C0}"/>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5" creationId="{9C575ED1-1BD5-4E0E-B774-A81E8F7F3745}"/>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6" creationId="{97A126D4-3A4D-4BF4-BBCF-B5930A334B47}"/>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7" creationId="{434B3C19-F8A5-47A7-98CE-04BF90902ABD}"/>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8" creationId="{98A15401-997D-4EA3-9952-11AC8DA7957E}"/>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59" creationId="{E00B0FA9-6D7A-4820-A4BC-B6CF065AB888}"/>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61" creationId="{107A6F16-B3E1-4E92-BB3E-E0BAF9C7E593}"/>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63" creationId="{D955C18A-7F84-4CD6-93AF-B888187C4891}"/>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65" creationId="{26D3CE9D-2F6B-46C9-BA2C-B849F8B72432}"/>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67" creationId="{00B16013-6473-4427-81D8-6B81CF5E7700}"/>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69" creationId="{6FB2731A-F750-4D7A-873E-0918E79B7DF3}"/>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71" creationId="{556208C0-E648-4151-9201-473158D18A5B}"/>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73" creationId="{6C58E77D-8DD8-446C-B77A-7B1D87222923}"/>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75" creationId="{CE426AB8-0C29-408D-99E3-5D5C2FCB1FC0}"/>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77" creationId="{CF0BD974-CF8E-45D2-95C7-5158B8E184E5}"/>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79" creationId="{6D27A9A3-C137-4D05-A278-ADE693577780}"/>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81" creationId="{18410C96-87B5-47FB-942E-6A5DDE69D86B}"/>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82" creationId="{FD82E6D3-1C8A-427D-9205-0E5166B8405D}"/>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83" creationId="{E6AAE245-030D-46FF-877D-B24DA2C5A3FA}"/>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84" creationId="{85437EF4-8506-4D2C-A943-287DB96C563E}"/>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85" creationId="{06D8E01C-60C3-4EA7-A570-D69E707E1CF6}"/>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86" creationId="{BB419EC3-2EE7-4F3D-A408-676DE20CBC32}"/>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87" creationId="{09DC4B08-E38D-4EAC-8318-184A135EA4B8}"/>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199" creationId="{DD1F949A-7578-4E85-A9FC-EBB3661F8B5B}"/>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200" creationId="{1EC130DC-A4A0-4246-83AC-B44EC2103FF1}"/>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201" creationId="{2B5F3616-0AD9-46C3-B2A2-45393A10DE96}"/>
          </ac:spMkLst>
        </pc:spChg>
        <pc:spChg chg="add del">
          <ac:chgData name="Tsujimoto,Mitsuhiro 辻本光宏(関東北甲信越統括支店O領域専門室)" userId="7251bc67-91ee-45c9-97e7-9c240c9b485c" providerId="ADAL" clId="{84BEBAD3-CDC6-4E60-BDDD-D9A6E533E4C1}" dt="2021-04-26T05:14:13.355" v="7183"/>
          <ac:spMkLst>
            <pc:docMk/>
            <pc:sldMk cId="2097519585" sldId="884"/>
            <ac:spMk id="202" creationId="{1EDAB3E4-DF0D-462D-9241-7636064D53B5}"/>
          </ac:spMkLst>
        </pc:spChg>
        <pc:spChg chg="add del mod">
          <ac:chgData name="Tsujimoto,Mitsuhiro 辻本光宏(関東北甲信越統括支店O領域専門室)" userId="7251bc67-91ee-45c9-97e7-9c240c9b485c" providerId="ADAL" clId="{84BEBAD3-CDC6-4E60-BDDD-D9A6E533E4C1}" dt="2021-04-26T05:16:36.046" v="7436" actId="478"/>
          <ac:spMkLst>
            <pc:docMk/>
            <pc:sldMk cId="2097519585" sldId="884"/>
            <ac:spMk id="204" creationId="{A0DC7C7C-E2CA-4777-8CE4-177F635CF661}"/>
          </ac:spMkLst>
        </pc:spChg>
        <pc:spChg chg="add mod">
          <ac:chgData name="Tsujimoto,Mitsuhiro 辻本光宏(関東北甲信越統括支店O領域専門室)" userId="7251bc67-91ee-45c9-97e7-9c240c9b485c" providerId="ADAL" clId="{84BEBAD3-CDC6-4E60-BDDD-D9A6E533E4C1}" dt="2021-04-26T05:31:49.173" v="7940" actId="1076"/>
          <ac:spMkLst>
            <pc:docMk/>
            <pc:sldMk cId="2097519585" sldId="884"/>
            <ac:spMk id="205" creationId="{FC952C9E-C76C-4DC5-9CDC-11D2F4F66836}"/>
          </ac:spMkLst>
        </pc:spChg>
        <pc:spChg chg="add mod">
          <ac:chgData name="Tsujimoto,Mitsuhiro 辻本光宏(関東北甲信越統括支店O領域専門室)" userId="7251bc67-91ee-45c9-97e7-9c240c9b485c" providerId="ADAL" clId="{84BEBAD3-CDC6-4E60-BDDD-D9A6E533E4C1}" dt="2021-04-26T05:17:54.065" v="7457" actId="14100"/>
          <ac:spMkLst>
            <pc:docMk/>
            <pc:sldMk cId="2097519585" sldId="884"/>
            <ac:spMk id="208" creationId="{BBDBA7AB-3918-4F6A-8F45-DB7038010CC5}"/>
          </ac:spMkLst>
        </pc:spChg>
        <pc:spChg chg="add mod">
          <ac:chgData name="Tsujimoto,Mitsuhiro 辻本光宏(関東北甲信越統括支店O領域専門室)" userId="7251bc67-91ee-45c9-97e7-9c240c9b485c" providerId="ADAL" clId="{84BEBAD3-CDC6-4E60-BDDD-D9A6E533E4C1}" dt="2021-04-26T05:18:12.136" v="7461" actId="1036"/>
          <ac:spMkLst>
            <pc:docMk/>
            <pc:sldMk cId="2097519585" sldId="884"/>
            <ac:spMk id="209" creationId="{760F2179-C30B-406B-9460-AD266EE5CF87}"/>
          </ac:spMkLst>
        </pc:spChg>
        <pc:grpChg chg="add del">
          <ac:chgData name="Tsujimoto,Mitsuhiro 辻本光宏(関東北甲信越統括支店O領域専門室)" userId="7251bc67-91ee-45c9-97e7-9c240c9b485c" providerId="ADAL" clId="{84BEBAD3-CDC6-4E60-BDDD-D9A6E533E4C1}" dt="2021-04-26T05:14:20.017" v="7186" actId="478"/>
          <ac:grpSpMkLst>
            <pc:docMk/>
            <pc:sldMk cId="2097519585" sldId="884"/>
            <ac:grpSpMk id="8" creationId="{F7F4C714-AE4F-42EB-8499-B0337B2D6B09}"/>
          </ac:grpSpMkLst>
        </pc:grpChg>
        <pc:grpChg chg="add del">
          <ac:chgData name="Tsujimoto,Mitsuhiro 辻本光宏(関東北甲信越統括支店O領域専門室)" userId="7251bc67-91ee-45c9-97e7-9c240c9b485c" providerId="ADAL" clId="{84BEBAD3-CDC6-4E60-BDDD-D9A6E533E4C1}" dt="2021-04-26T05:14:20.017" v="7186" actId="478"/>
          <ac:grpSpMkLst>
            <pc:docMk/>
            <pc:sldMk cId="2097519585" sldId="884"/>
            <ac:grpSpMk id="19" creationId="{04838D7F-8F4E-4293-9025-39F0EE27C907}"/>
          </ac:grpSpMkLst>
        </pc:grpChg>
        <pc:grpChg chg="add del">
          <ac:chgData name="Tsujimoto,Mitsuhiro 辻本光宏(関東北甲信越統括支店O領域専門室)" userId="7251bc67-91ee-45c9-97e7-9c240c9b485c" providerId="ADAL" clId="{84BEBAD3-CDC6-4E60-BDDD-D9A6E533E4C1}" dt="2021-04-26T05:14:20.017" v="7186" actId="478"/>
          <ac:grpSpMkLst>
            <pc:docMk/>
            <pc:sldMk cId="2097519585" sldId="884"/>
            <ac:grpSpMk id="35" creationId="{C49F76B0-AEDC-4954-B80F-94587611F025}"/>
          </ac:grpSpMkLst>
        </pc:grpChg>
        <pc:grpChg chg="add del">
          <ac:chgData name="Tsujimoto,Mitsuhiro 辻本光宏(関東北甲信越統括支店O領域専門室)" userId="7251bc67-91ee-45c9-97e7-9c240c9b485c" providerId="ADAL" clId="{84BEBAD3-CDC6-4E60-BDDD-D9A6E533E4C1}" dt="2021-04-26T05:14:20.017" v="7186" actId="478"/>
          <ac:grpSpMkLst>
            <pc:docMk/>
            <pc:sldMk cId="2097519585" sldId="884"/>
            <ac:grpSpMk id="88" creationId="{03DC351A-465A-4EE0-A411-ED6B4CC8D8C5}"/>
          </ac:grpSpMkLst>
        </pc:grpChg>
        <pc:grpChg chg="add del mod">
          <ac:chgData name="Tsujimoto,Mitsuhiro 辻本光宏(関東北甲信越統括支店O領域専門室)" userId="7251bc67-91ee-45c9-97e7-9c240c9b485c" providerId="ADAL" clId="{84BEBAD3-CDC6-4E60-BDDD-D9A6E533E4C1}" dt="2021-04-26T05:14:13.355" v="7183"/>
          <ac:grpSpMkLst>
            <pc:docMk/>
            <pc:sldMk cId="2097519585" sldId="884"/>
            <ac:grpSpMk id="108" creationId="{2D12E5CB-E25B-4ACC-88DD-D07EF07C93B3}"/>
          </ac:grpSpMkLst>
        </pc:grpChg>
        <pc:grpChg chg="add del mod">
          <ac:chgData name="Tsujimoto,Mitsuhiro 辻本光宏(関東北甲信越統括支店O領域専門室)" userId="7251bc67-91ee-45c9-97e7-9c240c9b485c" providerId="ADAL" clId="{84BEBAD3-CDC6-4E60-BDDD-D9A6E533E4C1}" dt="2021-04-26T05:14:13.355" v="7183"/>
          <ac:grpSpMkLst>
            <pc:docMk/>
            <pc:sldMk cId="2097519585" sldId="884"/>
            <ac:grpSpMk id="119" creationId="{71B78F44-9C6C-4777-87C9-7373A03E4C16}"/>
          </ac:grpSpMkLst>
        </pc:grpChg>
        <pc:grpChg chg="add del mod">
          <ac:chgData name="Tsujimoto,Mitsuhiro 辻本光宏(関東北甲信越統括支店O領域専門室)" userId="7251bc67-91ee-45c9-97e7-9c240c9b485c" providerId="ADAL" clId="{84BEBAD3-CDC6-4E60-BDDD-D9A6E533E4C1}" dt="2021-04-26T05:14:13.355" v="7183"/>
          <ac:grpSpMkLst>
            <pc:docMk/>
            <pc:sldMk cId="2097519585" sldId="884"/>
            <ac:grpSpMk id="135" creationId="{5D6E6FB7-0699-4E50-AC18-C01E1C434F9A}"/>
          </ac:grpSpMkLst>
        </pc:grpChg>
        <pc:grpChg chg="mod">
          <ac:chgData name="Tsujimoto,Mitsuhiro 辻本光宏(関東北甲信越統括支店O領域専門室)" userId="7251bc67-91ee-45c9-97e7-9c240c9b485c" providerId="ADAL" clId="{84BEBAD3-CDC6-4E60-BDDD-D9A6E533E4C1}" dt="2021-04-26T05:14:10.550" v="7182"/>
          <ac:grpSpMkLst>
            <pc:docMk/>
            <pc:sldMk cId="2097519585" sldId="884"/>
            <ac:grpSpMk id="136" creationId="{29016BE2-B98A-431F-BADA-8E9480426296}"/>
          </ac:grpSpMkLst>
        </pc:grpChg>
        <pc:grpChg chg="mod">
          <ac:chgData name="Tsujimoto,Mitsuhiro 辻本光宏(関東北甲信越統括支店O領域専門室)" userId="7251bc67-91ee-45c9-97e7-9c240c9b485c" providerId="ADAL" clId="{84BEBAD3-CDC6-4E60-BDDD-D9A6E533E4C1}" dt="2021-04-26T05:14:10.550" v="7182"/>
          <ac:grpSpMkLst>
            <pc:docMk/>
            <pc:sldMk cId="2097519585" sldId="884"/>
            <ac:grpSpMk id="137" creationId="{1B9E41E9-8279-42FE-AA0F-61ED4F4C2C9A}"/>
          </ac:grpSpMkLst>
        </pc:grpChg>
        <pc:grpChg chg="add del mod">
          <ac:chgData name="Tsujimoto,Mitsuhiro 辻本光宏(関東北甲信越統括支店O領域専門室)" userId="7251bc67-91ee-45c9-97e7-9c240c9b485c" providerId="ADAL" clId="{84BEBAD3-CDC6-4E60-BDDD-D9A6E533E4C1}" dt="2021-04-26T05:14:13.355" v="7183"/>
          <ac:grpSpMkLst>
            <pc:docMk/>
            <pc:sldMk cId="2097519585" sldId="884"/>
            <ac:grpSpMk id="188" creationId="{513D21B4-0313-4844-B1F1-E39E78B6794B}"/>
          </ac:grpSpMkLst>
        </pc:grpChg>
        <pc:graphicFrameChg chg="add del">
          <ac:chgData name="Tsujimoto,Mitsuhiro 辻本光宏(関東北甲信越統括支店O領域専門室)" userId="7251bc67-91ee-45c9-97e7-9c240c9b485c" providerId="ADAL" clId="{84BEBAD3-CDC6-4E60-BDDD-D9A6E533E4C1}" dt="2021-04-26T05:13:15.538" v="7174"/>
          <ac:graphicFrameMkLst>
            <pc:docMk/>
            <pc:sldMk cId="2097519585" sldId="884"/>
            <ac:graphicFrameMk id="3" creationId="{AA4A15F9-48CB-4CF1-89D8-3ADAA6340AA8}"/>
          </ac:graphicFrameMkLst>
        </pc:graphicFrameChg>
        <pc:graphicFrameChg chg="add del">
          <ac:chgData name="Tsujimoto,Mitsuhiro 辻本光宏(関東北甲信越統括支店O領域専門室)" userId="7251bc67-91ee-45c9-97e7-9c240c9b485c" providerId="ADAL" clId="{84BEBAD3-CDC6-4E60-BDDD-D9A6E533E4C1}" dt="2021-04-26T05:14:20.017" v="7186" actId="478"/>
          <ac:graphicFrameMkLst>
            <pc:docMk/>
            <pc:sldMk cId="2097519585" sldId="884"/>
            <ac:graphicFrameMk id="7" creationId="{678E06A7-0E45-4B35-B3F2-875C5BF99752}"/>
          </ac:graphicFrameMkLst>
        </pc:graphicFrameChg>
        <pc:graphicFrameChg chg="add del">
          <ac:chgData name="Tsujimoto,Mitsuhiro 辻本光宏(関東北甲信越統括支店O領域専門室)" userId="7251bc67-91ee-45c9-97e7-9c240c9b485c" providerId="ADAL" clId="{84BEBAD3-CDC6-4E60-BDDD-D9A6E533E4C1}" dt="2021-04-26T05:14:13.355" v="7183"/>
          <ac:graphicFrameMkLst>
            <pc:docMk/>
            <pc:sldMk cId="2097519585" sldId="884"/>
            <ac:graphicFrameMk id="107" creationId="{D00C8681-EECC-4F95-A3C0-A907F49A84D8}"/>
          </ac:graphicFrameMkLst>
        </pc:graphicFrameChg>
        <pc:picChg chg="add mod">
          <ac:chgData name="Tsujimoto,Mitsuhiro 辻本光宏(関東北甲信越統括支店O領域専門室)" userId="7251bc67-91ee-45c9-97e7-9c240c9b485c" providerId="ADAL" clId="{84BEBAD3-CDC6-4E60-BDDD-D9A6E533E4C1}" dt="2021-04-26T05:17:33.924" v="7452" actId="1076"/>
          <ac:picMkLst>
            <pc:docMk/>
            <pc:sldMk cId="2097519585" sldId="884"/>
            <ac:picMk id="203" creationId="{8E581764-1711-4500-B289-ABB7906F8D90}"/>
          </ac:picMkLst>
        </pc:pic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60" creationId="{CF8864C5-86A0-4619-B7DF-934873516F89}"/>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62" creationId="{E8F94E28-CD6D-4272-9A26-AA2B57E03528}"/>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64" creationId="{8E3E3FA8-4B18-4D24-888C-FCAB3A42F987}"/>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66" creationId="{5FA11467-BC00-469B-93BD-A9B0AF65FA67}"/>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68" creationId="{A2BCECEE-A5BF-47FF-BF34-593F9201FBED}"/>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70" creationId="{DBFA5C34-9EBC-4D54-A9B4-F4D34483FC6E}"/>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72" creationId="{7AE3408A-9D92-4879-B42A-E0875AB72E68}"/>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74" creationId="{9C321F0F-A812-4306-94DA-68E77F1FCE66}"/>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76" creationId="{422C75FE-6193-4203-AA4A-9C87135D548B}"/>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78" creationId="{D2A85935-EC2E-48F8-9CBF-8ECE19ECAF6E}"/>
          </ac:cxnSpMkLst>
        </pc:cxnChg>
        <pc:cxnChg chg="add del">
          <ac:chgData name="Tsujimoto,Mitsuhiro 辻本光宏(関東北甲信越統括支店O領域専門室)" userId="7251bc67-91ee-45c9-97e7-9c240c9b485c" providerId="ADAL" clId="{84BEBAD3-CDC6-4E60-BDDD-D9A6E533E4C1}" dt="2021-04-26T05:14:20.017" v="7186" actId="478"/>
          <ac:cxnSpMkLst>
            <pc:docMk/>
            <pc:sldMk cId="2097519585" sldId="884"/>
            <ac:cxnSpMk id="80" creationId="{0BD3C68A-2489-4497-80C4-331ECAD9DBE7}"/>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60" creationId="{276867D5-9039-45B9-8E58-2B584D060879}"/>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62" creationId="{3871CC3C-8A1B-4BFD-8991-04F01C3E6292}"/>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64" creationId="{C44E7BE1-0A14-4F77-8D57-E17765E4A8BA}"/>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66" creationId="{9BD10285-D0B1-4097-B9F1-73E978441295}"/>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68" creationId="{DD9D3488-7970-47CA-90C1-19FC78A3BA03}"/>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70" creationId="{187B7878-25EF-4363-80BE-42C647C2E615}"/>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72" creationId="{71BBB1C0-4374-4722-B075-599E77EB4D93}"/>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74" creationId="{EDBF12EE-43E4-40F1-BA8E-C223ED69ED6E}"/>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76" creationId="{B19AF0A0-E190-41D2-9936-B53E6ED8B6CB}"/>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78" creationId="{0FDDAAC3-C6CD-4C8E-BF3A-BB8F40A29522}"/>
          </ac:cxnSpMkLst>
        </pc:cxnChg>
        <pc:cxnChg chg="add del">
          <ac:chgData name="Tsujimoto,Mitsuhiro 辻本光宏(関東北甲信越統括支店O領域専門室)" userId="7251bc67-91ee-45c9-97e7-9c240c9b485c" providerId="ADAL" clId="{84BEBAD3-CDC6-4E60-BDDD-D9A6E533E4C1}" dt="2021-04-26T05:14:13.355" v="7183"/>
          <ac:cxnSpMkLst>
            <pc:docMk/>
            <pc:sldMk cId="2097519585" sldId="884"/>
            <ac:cxnSpMk id="180" creationId="{E3046CA5-D37E-46B7-A188-73DC00FD4ADC}"/>
          </ac:cxnSpMkLst>
        </pc:cxnChg>
        <pc:cxnChg chg="add del mod">
          <ac:chgData name="Tsujimoto,Mitsuhiro 辻本光宏(関東北甲信越統括支店O領域専門室)" userId="7251bc67-91ee-45c9-97e7-9c240c9b485c" providerId="ADAL" clId="{84BEBAD3-CDC6-4E60-BDDD-D9A6E533E4C1}" dt="2021-04-26T05:17:23.035" v="7449"/>
          <ac:cxnSpMkLst>
            <pc:docMk/>
            <pc:sldMk cId="2097519585" sldId="884"/>
            <ac:cxnSpMk id="206" creationId="{9B5FEC29-62B8-4CEA-89BA-929127359237}"/>
          </ac:cxnSpMkLst>
        </pc:cxnChg>
      </pc:sldChg>
      <pc:sldChg chg="addSp delSp modSp add">
        <pc:chgData name="Tsujimoto,Mitsuhiro 辻本光宏(関東北甲信越統括支店O領域専門室)" userId="7251bc67-91ee-45c9-97e7-9c240c9b485c" providerId="ADAL" clId="{84BEBAD3-CDC6-4E60-BDDD-D9A6E533E4C1}" dt="2021-04-26T05:32:09.947" v="7951" actId="1076"/>
        <pc:sldMkLst>
          <pc:docMk/>
          <pc:sldMk cId="1965412759" sldId="885"/>
        </pc:sldMkLst>
        <pc:spChg chg="add mod">
          <ac:chgData name="Tsujimoto,Mitsuhiro 辻本光宏(関東北甲信越統括支店O領域専門室)" userId="7251bc67-91ee-45c9-97e7-9c240c9b485c" providerId="ADAL" clId="{84BEBAD3-CDC6-4E60-BDDD-D9A6E533E4C1}" dt="2021-04-26T05:27:46.681" v="7526"/>
          <ac:spMkLst>
            <pc:docMk/>
            <pc:sldMk cId="1965412759" sldId="885"/>
            <ac:spMk id="2" creationId="{3773F2C1-B800-40E7-9FDA-1888D0F7F7A7}"/>
          </ac:spMkLst>
        </pc:spChg>
        <pc:spChg chg="add del mod">
          <ac:chgData name="Tsujimoto,Mitsuhiro 辻本光宏(関東北甲信越統括支店O領域専門室)" userId="7251bc67-91ee-45c9-97e7-9c240c9b485c" providerId="ADAL" clId="{84BEBAD3-CDC6-4E60-BDDD-D9A6E533E4C1}" dt="2021-04-26T05:30:53.046" v="7923" actId="478"/>
          <ac:spMkLst>
            <pc:docMk/>
            <pc:sldMk cId="1965412759" sldId="885"/>
            <ac:spMk id="8" creationId="{4CC5FAE4-74EB-4D1A-AFA5-5B2CA481295B}"/>
          </ac:spMkLst>
        </pc:spChg>
        <pc:spChg chg="add del">
          <ac:chgData name="Tsujimoto,Mitsuhiro 辻本光宏(関東北甲信越統括支店O領域専門室)" userId="7251bc67-91ee-45c9-97e7-9c240c9b485c" providerId="ADAL" clId="{84BEBAD3-CDC6-4E60-BDDD-D9A6E533E4C1}" dt="2021-04-26T05:30:53.046" v="7923" actId="478"/>
          <ac:spMkLst>
            <pc:docMk/>
            <pc:sldMk cId="1965412759" sldId="885"/>
            <ac:spMk id="9" creationId="{75E903BA-B8FC-4A2B-8812-289BED7570C4}"/>
          </ac:spMkLst>
        </pc:spChg>
        <pc:spChg chg="add del">
          <ac:chgData name="Tsujimoto,Mitsuhiro 辻本光宏(関東北甲信越統括支店O領域専門室)" userId="7251bc67-91ee-45c9-97e7-9c240c9b485c" providerId="ADAL" clId="{84BEBAD3-CDC6-4E60-BDDD-D9A6E533E4C1}" dt="2021-04-26T05:30:53.046" v="7923" actId="478"/>
          <ac:spMkLst>
            <pc:docMk/>
            <pc:sldMk cId="1965412759" sldId="885"/>
            <ac:spMk id="10" creationId="{2C0CBABA-3FC0-4D32-9C88-FA65E5BBA1FF}"/>
          </ac:spMkLst>
        </pc:spChg>
        <pc:spChg chg="add del">
          <ac:chgData name="Tsujimoto,Mitsuhiro 辻本光宏(関東北甲信越統括支店O領域専門室)" userId="7251bc67-91ee-45c9-97e7-9c240c9b485c" providerId="ADAL" clId="{84BEBAD3-CDC6-4E60-BDDD-D9A6E533E4C1}" dt="2021-04-26T05:30:53.046" v="7923" actId="478"/>
          <ac:spMkLst>
            <pc:docMk/>
            <pc:sldMk cId="1965412759" sldId="885"/>
            <ac:spMk id="11" creationId="{78BAB7AC-2EC3-4B63-8884-D6439D4B5E6F}"/>
          </ac:spMkLst>
        </pc:spChg>
        <pc:spChg chg="add del mod">
          <ac:chgData name="Tsujimoto,Mitsuhiro 辻本光宏(関東北甲信越統括支店O領域専門室)" userId="7251bc67-91ee-45c9-97e7-9c240c9b485c" providerId="ADAL" clId="{84BEBAD3-CDC6-4E60-BDDD-D9A6E533E4C1}" dt="2021-04-26T05:30:42.013" v="7918" actId="478"/>
          <ac:spMkLst>
            <pc:docMk/>
            <pc:sldMk cId="1965412759" sldId="885"/>
            <ac:spMk id="12" creationId="{FEE1380E-B464-45C0-8038-8A576601CDD1}"/>
          </ac:spMkLst>
        </pc:spChg>
        <pc:spChg chg="add mod">
          <ac:chgData name="Tsujimoto,Mitsuhiro 辻本光宏(関東北甲信越統括支店O領域専門室)" userId="7251bc67-91ee-45c9-97e7-9c240c9b485c" providerId="ADAL" clId="{84BEBAD3-CDC6-4E60-BDDD-D9A6E533E4C1}" dt="2021-04-26T05:28:47.867" v="7539" actId="1076"/>
          <ac:spMkLst>
            <pc:docMk/>
            <pc:sldMk cId="1965412759" sldId="885"/>
            <ac:spMk id="13" creationId="{461F5857-5955-4486-BDB2-12846C0B0FD8}"/>
          </ac:spMkLst>
        </pc:spChg>
        <pc:spChg chg="add del mod">
          <ac:chgData name="Tsujimoto,Mitsuhiro 辻本光宏(関東北甲信越統括支店O領域専門室)" userId="7251bc67-91ee-45c9-97e7-9c240c9b485c" providerId="ADAL" clId="{84BEBAD3-CDC6-4E60-BDDD-D9A6E533E4C1}" dt="2021-04-26T05:30:30.365" v="7916" actId="478"/>
          <ac:spMkLst>
            <pc:docMk/>
            <pc:sldMk cId="1965412759" sldId="885"/>
            <ac:spMk id="14" creationId="{B73C2660-4D5A-4B6D-BA2B-6BE145520479}"/>
          </ac:spMkLst>
        </pc:spChg>
        <pc:spChg chg="add mod">
          <ac:chgData name="Tsujimoto,Mitsuhiro 辻本光宏(関東北甲信越統括支店O領域専門室)" userId="7251bc67-91ee-45c9-97e7-9c240c9b485c" providerId="ADAL" clId="{84BEBAD3-CDC6-4E60-BDDD-D9A6E533E4C1}" dt="2021-04-26T05:31:59.679" v="7943" actId="1076"/>
          <ac:spMkLst>
            <pc:docMk/>
            <pc:sldMk cId="1965412759" sldId="885"/>
            <ac:spMk id="15" creationId="{C9D2D212-75A8-49D9-94D1-C20C58B37E25}"/>
          </ac:spMkLst>
        </pc:spChg>
        <pc:spChg chg="add mod">
          <ac:chgData name="Tsujimoto,Mitsuhiro 辻本光宏(関東北甲信越統括支店O領域専門室)" userId="7251bc67-91ee-45c9-97e7-9c240c9b485c" providerId="ADAL" clId="{84BEBAD3-CDC6-4E60-BDDD-D9A6E533E4C1}" dt="2021-04-26T05:32:06.492" v="7950" actId="1036"/>
          <ac:spMkLst>
            <pc:docMk/>
            <pc:sldMk cId="1965412759" sldId="885"/>
            <ac:spMk id="16" creationId="{DD7CC4F8-8794-4CEF-A008-230BFCD7AEBA}"/>
          </ac:spMkLst>
        </pc:spChg>
        <pc:spChg chg="add mod">
          <ac:chgData name="Tsujimoto,Mitsuhiro 辻本光宏(関東北甲信越統括支店O領域専門室)" userId="7251bc67-91ee-45c9-97e7-9c240c9b485c" providerId="ADAL" clId="{84BEBAD3-CDC6-4E60-BDDD-D9A6E533E4C1}" dt="2021-04-26T05:32:06.492" v="7950" actId="1036"/>
          <ac:spMkLst>
            <pc:docMk/>
            <pc:sldMk cId="1965412759" sldId="885"/>
            <ac:spMk id="17" creationId="{C100A762-352A-4C4A-8735-066F38479B91}"/>
          </ac:spMkLst>
        </pc:spChg>
        <pc:spChg chg="add mod">
          <ac:chgData name="Tsujimoto,Mitsuhiro 辻本光宏(関東北甲信越統括支店O領域専門室)" userId="7251bc67-91ee-45c9-97e7-9c240c9b485c" providerId="ADAL" clId="{84BEBAD3-CDC6-4E60-BDDD-D9A6E533E4C1}" dt="2021-04-26T05:32:06.492" v="7950" actId="1036"/>
          <ac:spMkLst>
            <pc:docMk/>
            <pc:sldMk cId="1965412759" sldId="885"/>
            <ac:spMk id="18" creationId="{F171C258-9FDC-4B5B-9CD2-8F377149B051}"/>
          </ac:spMkLst>
        </pc:spChg>
        <pc:spChg chg="add mod">
          <ac:chgData name="Tsujimoto,Mitsuhiro 辻本光宏(関東北甲信越統括支店O領域専門室)" userId="7251bc67-91ee-45c9-97e7-9c240c9b485c" providerId="ADAL" clId="{84BEBAD3-CDC6-4E60-BDDD-D9A6E533E4C1}" dt="2021-04-26T05:32:06.492" v="7950" actId="1036"/>
          <ac:spMkLst>
            <pc:docMk/>
            <pc:sldMk cId="1965412759" sldId="885"/>
            <ac:spMk id="19" creationId="{35F67658-5A00-4E72-9BC7-269FCF506DBE}"/>
          </ac:spMkLst>
        </pc:spChg>
        <pc:picChg chg="add mod">
          <ac:chgData name="Tsujimoto,Mitsuhiro 辻本光宏(関東北甲信越統括支店O領域専門室)" userId="7251bc67-91ee-45c9-97e7-9c240c9b485c" providerId="ADAL" clId="{84BEBAD3-CDC6-4E60-BDDD-D9A6E533E4C1}" dt="2021-04-26T05:32:09.947" v="7951" actId="1076"/>
          <ac:picMkLst>
            <pc:docMk/>
            <pc:sldMk cId="1965412759" sldId="885"/>
            <ac:picMk id="3" creationId="{7EC97F66-002A-4277-A1EC-EC7F7FFE3DDE}"/>
          </ac:picMkLst>
        </pc:picChg>
        <pc:picChg chg="add mod">
          <ac:chgData name="Tsujimoto,Mitsuhiro 辻本光宏(関東北甲信越統括支店O領域専門室)" userId="7251bc67-91ee-45c9-97e7-9c240c9b485c" providerId="ADAL" clId="{84BEBAD3-CDC6-4E60-BDDD-D9A6E533E4C1}" dt="2021-04-26T05:32:06.492" v="7950" actId="1036"/>
          <ac:picMkLst>
            <pc:docMk/>
            <pc:sldMk cId="1965412759" sldId="885"/>
            <ac:picMk id="4" creationId="{09AFD125-5E47-4075-890F-E86417A06169}"/>
          </ac:picMkLst>
        </pc:picChg>
        <pc:picChg chg="add mod">
          <ac:chgData name="Tsujimoto,Mitsuhiro 辻本光宏(関東北甲信越統括支店O領域専門室)" userId="7251bc67-91ee-45c9-97e7-9c240c9b485c" providerId="ADAL" clId="{84BEBAD3-CDC6-4E60-BDDD-D9A6E533E4C1}" dt="2021-04-26T05:32:06.492" v="7950" actId="1036"/>
          <ac:picMkLst>
            <pc:docMk/>
            <pc:sldMk cId="1965412759" sldId="885"/>
            <ac:picMk id="5" creationId="{0245CD21-D743-4A5B-B1C7-7ADF4F0BFC70}"/>
          </ac:picMkLst>
        </pc:picChg>
        <pc:picChg chg="add mod">
          <ac:chgData name="Tsujimoto,Mitsuhiro 辻本光宏(関東北甲信越統括支店O領域専門室)" userId="7251bc67-91ee-45c9-97e7-9c240c9b485c" providerId="ADAL" clId="{84BEBAD3-CDC6-4E60-BDDD-D9A6E533E4C1}" dt="2021-04-26T05:32:06.492" v="7950" actId="1036"/>
          <ac:picMkLst>
            <pc:docMk/>
            <pc:sldMk cId="1965412759" sldId="885"/>
            <ac:picMk id="6" creationId="{DD02265C-0F68-47CA-8B5D-301E759949F3}"/>
          </ac:picMkLst>
        </pc:picChg>
        <pc:picChg chg="add mod">
          <ac:chgData name="Tsujimoto,Mitsuhiro 辻本光宏(関東北甲信越統括支店O領域専門室)" userId="7251bc67-91ee-45c9-97e7-9c240c9b485c" providerId="ADAL" clId="{84BEBAD3-CDC6-4E60-BDDD-D9A6E533E4C1}" dt="2021-04-26T05:32:06.492" v="7950" actId="1036"/>
          <ac:picMkLst>
            <pc:docMk/>
            <pc:sldMk cId="1965412759" sldId="885"/>
            <ac:picMk id="7" creationId="{342B850A-5DDD-4C8A-959F-7D83126A55F9}"/>
          </ac:picMkLst>
        </pc:picChg>
      </pc:sldChg>
      <pc:sldChg chg="addSp delSp modSp add">
        <pc:chgData name="Tsujimoto,Mitsuhiro 辻本光宏(関東北甲信越統括支店O領域専門室)" userId="7251bc67-91ee-45c9-97e7-9c240c9b485c" providerId="ADAL" clId="{84BEBAD3-CDC6-4E60-BDDD-D9A6E533E4C1}" dt="2021-04-26T05:36:47.627" v="8399" actId="1076"/>
        <pc:sldMkLst>
          <pc:docMk/>
          <pc:sldMk cId="3063411067" sldId="886"/>
        </pc:sldMkLst>
        <pc:spChg chg="add mod">
          <ac:chgData name="Tsujimoto,Mitsuhiro 辻本光宏(関東北甲信越統括支店O領域専門室)" userId="7251bc67-91ee-45c9-97e7-9c240c9b485c" providerId="ADAL" clId="{84BEBAD3-CDC6-4E60-BDDD-D9A6E533E4C1}" dt="2021-04-26T05:33:20.730" v="7976" actId="6549"/>
          <ac:spMkLst>
            <pc:docMk/>
            <pc:sldMk cId="3063411067" sldId="886"/>
            <ac:spMk id="2" creationId="{83C7D220-F1B5-47FB-AD15-260FBD42ACB3}"/>
          </ac:spMkLst>
        </pc:spChg>
        <pc:spChg chg="add mod">
          <ac:chgData name="Tsujimoto,Mitsuhiro 辻本光宏(関東北甲信越統括支店O領域専門室)" userId="7251bc67-91ee-45c9-97e7-9c240c9b485c" providerId="ADAL" clId="{84BEBAD3-CDC6-4E60-BDDD-D9A6E533E4C1}" dt="2021-04-26T05:33:40.739" v="7979" actId="1076"/>
          <ac:spMkLst>
            <pc:docMk/>
            <pc:sldMk cId="3063411067" sldId="886"/>
            <ac:spMk id="3" creationId="{48769493-5B03-4ECB-ACC2-A4B7BD92C5B3}"/>
          </ac:spMkLst>
        </pc:spChg>
        <pc:spChg chg="add del mod">
          <ac:chgData name="Tsujimoto,Mitsuhiro 辻本光宏(関東北甲信越統括支店O領域専門室)" userId="7251bc67-91ee-45c9-97e7-9c240c9b485c" providerId="ADAL" clId="{84BEBAD3-CDC6-4E60-BDDD-D9A6E533E4C1}" dt="2021-04-26T05:36:35.341" v="8397" actId="478"/>
          <ac:spMkLst>
            <pc:docMk/>
            <pc:sldMk cId="3063411067" sldId="886"/>
            <ac:spMk id="7" creationId="{CEAFA806-B49D-4F6E-9E1F-FCCB1B83C8DF}"/>
          </ac:spMkLst>
        </pc:spChg>
        <pc:spChg chg="add del">
          <ac:chgData name="Tsujimoto,Mitsuhiro 辻本光宏(関東北甲信越統括支店O領域専門室)" userId="7251bc67-91ee-45c9-97e7-9c240c9b485c" providerId="ADAL" clId="{84BEBAD3-CDC6-4E60-BDDD-D9A6E533E4C1}" dt="2021-04-26T05:36:35.341" v="8397" actId="478"/>
          <ac:spMkLst>
            <pc:docMk/>
            <pc:sldMk cId="3063411067" sldId="886"/>
            <ac:spMk id="8" creationId="{43E82AD1-3D13-48B7-945D-C00F0F99FCA0}"/>
          </ac:spMkLst>
        </pc:spChg>
        <pc:spChg chg="add mod">
          <ac:chgData name="Tsujimoto,Mitsuhiro 辻本光宏(関東北甲信越統括支店O領域専門室)" userId="7251bc67-91ee-45c9-97e7-9c240c9b485c" providerId="ADAL" clId="{84BEBAD3-CDC6-4E60-BDDD-D9A6E533E4C1}" dt="2021-04-26T05:36:40.010" v="8398" actId="1076"/>
          <ac:spMkLst>
            <pc:docMk/>
            <pc:sldMk cId="3063411067" sldId="886"/>
            <ac:spMk id="9" creationId="{11A64F54-9397-44A2-B89C-C9EE78515EE1}"/>
          </ac:spMkLst>
        </pc:spChg>
        <pc:picChg chg="add mod">
          <ac:chgData name="Tsujimoto,Mitsuhiro 辻本光宏(関東北甲信越統括支店O領域専門室)" userId="7251bc67-91ee-45c9-97e7-9c240c9b485c" providerId="ADAL" clId="{84BEBAD3-CDC6-4E60-BDDD-D9A6E533E4C1}" dt="2021-04-26T05:36:47.627" v="8399" actId="1076"/>
          <ac:picMkLst>
            <pc:docMk/>
            <pc:sldMk cId="3063411067" sldId="886"/>
            <ac:picMk id="4" creationId="{E67C2A83-D28E-4651-A425-794F84AF8800}"/>
          </ac:picMkLst>
        </pc:picChg>
        <pc:picChg chg="add mod">
          <ac:chgData name="Tsujimoto,Mitsuhiro 辻本光宏(関東北甲信越統括支店O領域専門室)" userId="7251bc67-91ee-45c9-97e7-9c240c9b485c" providerId="ADAL" clId="{84BEBAD3-CDC6-4E60-BDDD-D9A6E533E4C1}" dt="2021-04-26T05:36:47.627" v="8399" actId="1076"/>
          <ac:picMkLst>
            <pc:docMk/>
            <pc:sldMk cId="3063411067" sldId="886"/>
            <ac:picMk id="5" creationId="{546E691F-F8E4-426B-91AF-27FA109117C9}"/>
          </ac:picMkLst>
        </pc:picChg>
        <pc:picChg chg="add mod">
          <ac:chgData name="Tsujimoto,Mitsuhiro 辻本光宏(関東北甲信越統括支店O領域専門室)" userId="7251bc67-91ee-45c9-97e7-9c240c9b485c" providerId="ADAL" clId="{84BEBAD3-CDC6-4E60-BDDD-D9A6E533E4C1}" dt="2021-04-26T05:36:47.627" v="8399" actId="1076"/>
          <ac:picMkLst>
            <pc:docMk/>
            <pc:sldMk cId="3063411067" sldId="886"/>
            <ac:picMk id="6" creationId="{369C5CB8-FA82-4434-A6EF-09E84038A045}"/>
          </ac:picMkLst>
        </pc:picChg>
      </pc:sldChg>
      <pc:sldChg chg="addSp delSp modSp add">
        <pc:chgData name="Tsujimoto,Mitsuhiro 辻本光宏(関東北甲信越統括支店O領域専門室)" userId="7251bc67-91ee-45c9-97e7-9c240c9b485c" providerId="ADAL" clId="{84BEBAD3-CDC6-4E60-BDDD-D9A6E533E4C1}" dt="2021-04-26T05:41:27.867" v="8875" actId="1076"/>
        <pc:sldMkLst>
          <pc:docMk/>
          <pc:sldMk cId="3343705746" sldId="887"/>
        </pc:sldMkLst>
        <pc:spChg chg="add mod">
          <ac:chgData name="Tsujimoto,Mitsuhiro 辻本光宏(関東北甲信越統括支店O領域専門室)" userId="7251bc67-91ee-45c9-97e7-9c240c9b485c" providerId="ADAL" clId="{84BEBAD3-CDC6-4E60-BDDD-D9A6E533E4C1}" dt="2021-04-26T05:37:09.108" v="8405" actId="20577"/>
          <ac:spMkLst>
            <pc:docMk/>
            <pc:sldMk cId="3343705746" sldId="887"/>
            <ac:spMk id="2" creationId="{68E3DE1D-A540-4723-8ED3-2A838C764DB8}"/>
          </ac:spMkLst>
        </pc:spChg>
        <pc:spChg chg="add mod">
          <ac:chgData name="Tsujimoto,Mitsuhiro 辻本光宏(関東北甲信越統括支店O領域専門室)" userId="7251bc67-91ee-45c9-97e7-9c240c9b485c" providerId="ADAL" clId="{84BEBAD3-CDC6-4E60-BDDD-D9A6E533E4C1}" dt="2021-04-26T05:38:40.318" v="8442" actId="1076"/>
          <ac:spMkLst>
            <pc:docMk/>
            <pc:sldMk cId="3343705746" sldId="887"/>
            <ac:spMk id="5" creationId="{46AA763D-BF70-4B7C-94AF-29F5D0F96484}"/>
          </ac:spMkLst>
        </pc:spChg>
        <pc:spChg chg="add mod">
          <ac:chgData name="Tsujimoto,Mitsuhiro 辻本光宏(関東北甲信越統括支店O領域専門室)" userId="7251bc67-91ee-45c9-97e7-9c240c9b485c" providerId="ADAL" clId="{84BEBAD3-CDC6-4E60-BDDD-D9A6E533E4C1}" dt="2021-04-26T05:38:40.318" v="8442" actId="1076"/>
          <ac:spMkLst>
            <pc:docMk/>
            <pc:sldMk cId="3343705746" sldId="887"/>
            <ac:spMk id="6" creationId="{4EE3F3F9-BED4-4480-A9E1-E72E9D3683B8}"/>
          </ac:spMkLst>
        </pc:spChg>
        <pc:spChg chg="add mod">
          <ac:chgData name="Tsujimoto,Mitsuhiro 辻本光宏(関東北甲信越統括支店O領域専門室)" userId="7251bc67-91ee-45c9-97e7-9c240c9b485c" providerId="ADAL" clId="{84BEBAD3-CDC6-4E60-BDDD-D9A6E533E4C1}" dt="2021-04-26T05:41:27.867" v="8875" actId="1076"/>
          <ac:spMkLst>
            <pc:docMk/>
            <pc:sldMk cId="3343705746" sldId="887"/>
            <ac:spMk id="7" creationId="{206A62C0-8173-4D2A-A06F-20926C92126A}"/>
          </ac:spMkLst>
        </pc:spChg>
        <pc:spChg chg="add del mod">
          <ac:chgData name="Tsujimoto,Mitsuhiro 辻本光宏(関東北甲信越統括支店O領域専門室)" userId="7251bc67-91ee-45c9-97e7-9c240c9b485c" providerId="ADAL" clId="{84BEBAD3-CDC6-4E60-BDDD-D9A6E533E4C1}" dt="2021-04-26T05:40:49.422" v="8857" actId="478"/>
          <ac:spMkLst>
            <pc:docMk/>
            <pc:sldMk cId="3343705746" sldId="887"/>
            <ac:spMk id="8" creationId="{97F02C20-5B15-4E2C-AABC-BA93C9CE7D61}"/>
          </ac:spMkLst>
        </pc:spChg>
        <pc:spChg chg="add del mod">
          <ac:chgData name="Tsujimoto,Mitsuhiro 辻本光宏(関東北甲信越統括支店O領域専門室)" userId="7251bc67-91ee-45c9-97e7-9c240c9b485c" providerId="ADAL" clId="{84BEBAD3-CDC6-4E60-BDDD-D9A6E533E4C1}" dt="2021-04-26T05:40:49.422" v="8857" actId="478"/>
          <ac:spMkLst>
            <pc:docMk/>
            <pc:sldMk cId="3343705746" sldId="887"/>
            <ac:spMk id="9" creationId="{AD40DA7E-2A2A-415F-BBDE-160F218B7A1C}"/>
          </ac:spMkLst>
        </pc:spChg>
        <pc:picChg chg="add mod">
          <ac:chgData name="Tsujimoto,Mitsuhiro 辻本光宏(関東北甲信越統括支店O領域専門室)" userId="7251bc67-91ee-45c9-97e7-9c240c9b485c" providerId="ADAL" clId="{84BEBAD3-CDC6-4E60-BDDD-D9A6E533E4C1}" dt="2021-04-26T05:40:52.312" v="8867" actId="1036"/>
          <ac:picMkLst>
            <pc:docMk/>
            <pc:sldMk cId="3343705746" sldId="887"/>
            <ac:picMk id="3" creationId="{B4B06EE6-6DF6-40F5-9A7E-27D388C74EA6}"/>
          </ac:picMkLst>
        </pc:picChg>
        <pc:picChg chg="add mod">
          <ac:chgData name="Tsujimoto,Mitsuhiro 辻本光宏(関東北甲信越統括支店O領域専門室)" userId="7251bc67-91ee-45c9-97e7-9c240c9b485c" providerId="ADAL" clId="{84BEBAD3-CDC6-4E60-BDDD-D9A6E533E4C1}" dt="2021-04-26T05:40:52.312" v="8867" actId="1036"/>
          <ac:picMkLst>
            <pc:docMk/>
            <pc:sldMk cId="3343705746" sldId="887"/>
            <ac:picMk id="4" creationId="{87A1FE19-9214-421A-9CEC-AD124D2BD84B}"/>
          </ac:picMkLst>
        </pc:picChg>
      </pc:sldChg>
      <pc:sldChg chg="addSp delSp modSp add">
        <pc:chgData name="Tsujimoto,Mitsuhiro 辻本光宏(関東北甲信越統括支店O領域専門室)" userId="7251bc67-91ee-45c9-97e7-9c240c9b485c" providerId="ADAL" clId="{84BEBAD3-CDC6-4E60-BDDD-D9A6E533E4C1}" dt="2021-04-26T05:55:28.449" v="9597" actId="20577"/>
        <pc:sldMkLst>
          <pc:docMk/>
          <pc:sldMk cId="97662140" sldId="888"/>
        </pc:sldMkLst>
        <pc:spChg chg="add mod">
          <ac:chgData name="Tsujimoto,Mitsuhiro 辻本光宏(関東北甲信越統括支店O領域専門室)" userId="7251bc67-91ee-45c9-97e7-9c240c9b485c" providerId="ADAL" clId="{84BEBAD3-CDC6-4E60-BDDD-D9A6E533E4C1}" dt="2021-04-26T05:43:21.267" v="8930"/>
          <ac:spMkLst>
            <pc:docMk/>
            <pc:sldMk cId="97662140" sldId="888"/>
            <ac:spMk id="3" creationId="{977FBDD2-BAAE-466F-ABC6-AC3B92F91982}"/>
          </ac:spMkLst>
        </pc:spChg>
        <pc:spChg chg="add mod">
          <ac:chgData name="Tsujimoto,Mitsuhiro 辻本光宏(関東北甲信越統括支店O領域専門室)" userId="7251bc67-91ee-45c9-97e7-9c240c9b485c" providerId="ADAL" clId="{84BEBAD3-CDC6-4E60-BDDD-D9A6E533E4C1}" dt="2021-04-26T05:55:28.449" v="9597" actId="20577"/>
          <ac:spMkLst>
            <pc:docMk/>
            <pc:sldMk cId="97662140" sldId="888"/>
            <ac:spMk id="6" creationId="{17582D1D-049A-48A4-8EB1-5BFB8FC57FBD}"/>
          </ac:spMkLst>
        </pc:spChg>
        <pc:spChg chg="add del mod">
          <ac:chgData name="Tsujimoto,Mitsuhiro 辻本光宏(関東北甲信越統括支店O領域専門室)" userId="7251bc67-91ee-45c9-97e7-9c240c9b485c" providerId="ADAL" clId="{84BEBAD3-CDC6-4E60-BDDD-D9A6E533E4C1}" dt="2021-04-26T05:54:55.068" v="9569" actId="478"/>
          <ac:spMkLst>
            <pc:docMk/>
            <pc:sldMk cId="97662140" sldId="888"/>
            <ac:spMk id="7" creationId="{29BC095F-6527-4975-BF72-2E3409A4D831}"/>
          </ac:spMkLst>
        </pc:spChg>
        <pc:spChg chg="add mod">
          <ac:chgData name="Tsujimoto,Mitsuhiro 辻本光宏(関東北甲信越統括支店O領域専門室)" userId="7251bc67-91ee-45c9-97e7-9c240c9b485c" providerId="ADAL" clId="{84BEBAD3-CDC6-4E60-BDDD-D9A6E533E4C1}" dt="2021-04-26T05:55:03.804" v="9592" actId="1036"/>
          <ac:spMkLst>
            <pc:docMk/>
            <pc:sldMk cId="97662140" sldId="888"/>
            <ac:spMk id="8" creationId="{F19CB42E-AF1B-4DAB-B932-410B491E3037}"/>
          </ac:spMkLst>
        </pc:spChg>
        <pc:spChg chg="add mod">
          <ac:chgData name="Tsujimoto,Mitsuhiro 辻本光宏(関東北甲信越統括支店O領域専門室)" userId="7251bc67-91ee-45c9-97e7-9c240c9b485c" providerId="ADAL" clId="{84BEBAD3-CDC6-4E60-BDDD-D9A6E533E4C1}" dt="2021-04-26T05:55:03.804" v="9592" actId="1036"/>
          <ac:spMkLst>
            <pc:docMk/>
            <pc:sldMk cId="97662140" sldId="888"/>
            <ac:spMk id="9" creationId="{0C119F36-064F-4A27-9683-133AD26F11C3}"/>
          </ac:spMkLst>
        </pc:spChg>
        <pc:spChg chg="add mod">
          <ac:chgData name="Tsujimoto,Mitsuhiro 辻本光宏(関東北甲信越統括支店O領域専門室)" userId="7251bc67-91ee-45c9-97e7-9c240c9b485c" providerId="ADAL" clId="{84BEBAD3-CDC6-4E60-BDDD-D9A6E533E4C1}" dt="2021-04-26T05:55:13.058" v="9595" actId="1076"/>
          <ac:spMkLst>
            <pc:docMk/>
            <pc:sldMk cId="97662140" sldId="888"/>
            <ac:spMk id="10" creationId="{CD30F1C5-DD49-4A17-9C3D-CC0AD2F15737}"/>
          </ac:spMkLst>
        </pc:spChg>
        <pc:picChg chg="add mod ord">
          <ac:chgData name="Tsujimoto,Mitsuhiro 辻本光宏(関東北甲信越統括支店O領域専門室)" userId="7251bc67-91ee-45c9-97e7-9c240c9b485c" providerId="ADAL" clId="{84BEBAD3-CDC6-4E60-BDDD-D9A6E533E4C1}" dt="2021-04-26T05:55:03.804" v="9592" actId="1036"/>
          <ac:picMkLst>
            <pc:docMk/>
            <pc:sldMk cId="97662140" sldId="888"/>
            <ac:picMk id="2" creationId="{90AC36FA-AB6A-4A80-B66B-A455FAE225B2}"/>
          </ac:picMkLst>
        </pc:picChg>
        <pc:picChg chg="add mod">
          <ac:chgData name="Tsujimoto,Mitsuhiro 辻本光宏(関東北甲信越統括支店O領域専門室)" userId="7251bc67-91ee-45c9-97e7-9c240c9b485c" providerId="ADAL" clId="{84BEBAD3-CDC6-4E60-BDDD-D9A6E533E4C1}" dt="2021-04-26T05:55:03.804" v="9592" actId="1036"/>
          <ac:picMkLst>
            <pc:docMk/>
            <pc:sldMk cId="97662140" sldId="888"/>
            <ac:picMk id="4" creationId="{DB781A18-CA73-40FE-BEAA-6D65A48A2B8C}"/>
          </ac:picMkLst>
        </pc:picChg>
        <pc:picChg chg="add mod">
          <ac:chgData name="Tsujimoto,Mitsuhiro 辻本光宏(関東北甲信越統括支店O領域専門室)" userId="7251bc67-91ee-45c9-97e7-9c240c9b485c" providerId="ADAL" clId="{84BEBAD3-CDC6-4E60-BDDD-D9A6E533E4C1}" dt="2021-04-26T05:55:03.804" v="9592" actId="1036"/>
          <ac:picMkLst>
            <pc:docMk/>
            <pc:sldMk cId="97662140" sldId="888"/>
            <ac:picMk id="5" creationId="{F99135B4-4ECF-445E-B546-459461C0BDDE}"/>
          </ac:picMkLst>
        </pc:picChg>
      </pc:sldChg>
      <pc:sldChg chg="addSp delSp modSp add">
        <pc:chgData name="Tsujimoto,Mitsuhiro 辻本光宏(関東北甲信越統括支店O領域専門室)" userId="7251bc67-91ee-45c9-97e7-9c240c9b485c" providerId="ADAL" clId="{84BEBAD3-CDC6-4E60-BDDD-D9A6E533E4C1}" dt="2021-04-26T06:09:33.891" v="11427" actId="478"/>
        <pc:sldMkLst>
          <pc:docMk/>
          <pc:sldMk cId="2120590716" sldId="889"/>
        </pc:sldMkLst>
        <pc:spChg chg="mod">
          <ac:chgData name="Tsujimoto,Mitsuhiro 辻本光宏(関東北甲信越統括支店O領域専門室)" userId="7251bc67-91ee-45c9-97e7-9c240c9b485c" providerId="ADAL" clId="{84BEBAD3-CDC6-4E60-BDDD-D9A6E533E4C1}" dt="2021-04-26T05:57:03.281" v="9678"/>
          <ac:spMkLst>
            <pc:docMk/>
            <pc:sldMk cId="2120590716" sldId="889"/>
            <ac:spMk id="2" creationId="{CC1162C8-AFF0-41DD-9FB3-4037F1043041}"/>
          </ac:spMkLst>
        </pc:spChg>
        <pc:spChg chg="add del">
          <ac:chgData name="Tsujimoto,Mitsuhiro 辻本光宏(関東北甲信越統括支店O領域専門室)" userId="7251bc67-91ee-45c9-97e7-9c240c9b485c" providerId="ADAL" clId="{84BEBAD3-CDC6-4E60-BDDD-D9A6E533E4C1}" dt="2021-04-26T05:57:06.096" v="9679" actId="478"/>
          <ac:spMkLst>
            <pc:docMk/>
            <pc:sldMk cId="2120590716" sldId="889"/>
            <ac:spMk id="6" creationId="{1746A942-FF3E-4EBA-8824-72511480DC19}"/>
          </ac:spMkLst>
        </pc:spChg>
        <pc:spChg chg="del">
          <ac:chgData name="Tsujimoto,Mitsuhiro 辻本光宏(関東北甲信越統括支店O領域専門室)" userId="7251bc67-91ee-45c9-97e7-9c240c9b485c" providerId="ADAL" clId="{84BEBAD3-CDC6-4E60-BDDD-D9A6E533E4C1}" dt="2021-04-26T05:57:09.253" v="9680" actId="478"/>
          <ac:spMkLst>
            <pc:docMk/>
            <pc:sldMk cId="2120590716" sldId="889"/>
            <ac:spMk id="12" creationId="{8931BEBD-7143-4D5F-8AB9-75BDBD87E6D9}"/>
          </ac:spMkLst>
        </pc:spChg>
        <pc:spChg chg="del">
          <ac:chgData name="Tsujimoto,Mitsuhiro 辻本光宏(関東北甲信越統括支店O領域専門室)" userId="7251bc67-91ee-45c9-97e7-9c240c9b485c" providerId="ADAL" clId="{84BEBAD3-CDC6-4E60-BDDD-D9A6E533E4C1}" dt="2021-04-26T05:57:09.253" v="9680" actId="478"/>
          <ac:spMkLst>
            <pc:docMk/>
            <pc:sldMk cId="2120590716" sldId="889"/>
            <ac:spMk id="13" creationId="{42146C5F-DF4D-4613-B33D-C308F7314F23}"/>
          </ac:spMkLst>
        </pc:spChg>
        <pc:spChg chg="del">
          <ac:chgData name="Tsujimoto,Mitsuhiro 辻本光宏(関東北甲信越統括支店O領域専門室)" userId="7251bc67-91ee-45c9-97e7-9c240c9b485c" providerId="ADAL" clId="{84BEBAD3-CDC6-4E60-BDDD-D9A6E533E4C1}" dt="2021-04-26T05:57:09.253" v="9680" actId="478"/>
          <ac:spMkLst>
            <pc:docMk/>
            <pc:sldMk cId="2120590716" sldId="889"/>
            <ac:spMk id="14" creationId="{D2D9FE1F-7640-4E57-B47D-D39338E3DE3E}"/>
          </ac:spMkLst>
        </pc:spChg>
        <pc:spChg chg="del">
          <ac:chgData name="Tsujimoto,Mitsuhiro 辻本光宏(関東北甲信越統括支店O領域専門室)" userId="7251bc67-91ee-45c9-97e7-9c240c9b485c" providerId="ADAL" clId="{84BEBAD3-CDC6-4E60-BDDD-D9A6E533E4C1}" dt="2021-04-26T05:57:09.253" v="9680" actId="478"/>
          <ac:spMkLst>
            <pc:docMk/>
            <pc:sldMk cId="2120590716" sldId="889"/>
            <ac:spMk id="15" creationId="{09214FCE-F87C-4C4C-B8FD-0D764CD152B1}"/>
          </ac:spMkLst>
        </pc:spChg>
        <pc:spChg chg="del">
          <ac:chgData name="Tsujimoto,Mitsuhiro 辻本光宏(関東北甲信越統括支店O領域専門室)" userId="7251bc67-91ee-45c9-97e7-9c240c9b485c" providerId="ADAL" clId="{84BEBAD3-CDC6-4E60-BDDD-D9A6E533E4C1}" dt="2021-04-26T05:57:09.253" v="9680" actId="478"/>
          <ac:spMkLst>
            <pc:docMk/>
            <pc:sldMk cId="2120590716" sldId="889"/>
            <ac:spMk id="16" creationId="{CB8BD04B-5844-411A-8516-9CD9C79DE91B}"/>
          </ac:spMkLst>
        </pc:spChg>
        <pc:spChg chg="del">
          <ac:chgData name="Tsujimoto,Mitsuhiro 辻本光宏(関東北甲信越統括支店O領域専門室)" userId="7251bc67-91ee-45c9-97e7-9c240c9b485c" providerId="ADAL" clId="{84BEBAD3-CDC6-4E60-BDDD-D9A6E533E4C1}" dt="2021-04-26T05:57:09.253" v="9680" actId="478"/>
          <ac:spMkLst>
            <pc:docMk/>
            <pc:sldMk cId="2120590716" sldId="889"/>
            <ac:spMk id="17" creationId="{487F4F98-CC2E-44B4-A244-B82303392BD0}"/>
          </ac:spMkLst>
        </pc:spChg>
        <pc:spChg chg="del">
          <ac:chgData name="Tsujimoto,Mitsuhiro 辻本光宏(関東北甲信越統括支店O領域専門室)" userId="7251bc67-91ee-45c9-97e7-9c240c9b485c" providerId="ADAL" clId="{84BEBAD3-CDC6-4E60-BDDD-D9A6E533E4C1}" dt="2021-04-26T05:57:09.253" v="9680" actId="478"/>
          <ac:spMkLst>
            <pc:docMk/>
            <pc:sldMk cId="2120590716" sldId="889"/>
            <ac:spMk id="18" creationId="{107D4B05-63CD-4160-8D30-3097944A19DF}"/>
          </ac:spMkLst>
        </pc:spChg>
        <pc:spChg chg="del">
          <ac:chgData name="Tsujimoto,Mitsuhiro 辻本光宏(関東北甲信越統括支店O領域専門室)" userId="7251bc67-91ee-45c9-97e7-9c240c9b485c" providerId="ADAL" clId="{84BEBAD3-CDC6-4E60-BDDD-D9A6E533E4C1}" dt="2021-04-26T06:09:33.891" v="11427" actId="478"/>
          <ac:spMkLst>
            <pc:docMk/>
            <pc:sldMk cId="2120590716" sldId="889"/>
            <ac:spMk id="20" creationId="{05C867D6-02BE-4775-9087-CD1B0F2A81D3}"/>
          </ac:spMkLst>
        </pc:spChg>
        <pc:spChg chg="add mod">
          <ac:chgData name="Tsujimoto,Mitsuhiro 辻本光宏(関東北甲信越統括支店O領域専門室)" userId="7251bc67-91ee-45c9-97e7-9c240c9b485c" providerId="ADAL" clId="{84BEBAD3-CDC6-4E60-BDDD-D9A6E533E4C1}" dt="2021-04-26T06:04:20.718" v="11306" actId="1076"/>
          <ac:spMkLst>
            <pc:docMk/>
            <pc:sldMk cId="2120590716" sldId="889"/>
            <ac:spMk id="21" creationId="{BD571CC1-B969-485C-9BDE-926F2C4A68A5}"/>
          </ac:spMkLst>
        </pc:spChg>
        <pc:spChg chg="add del mod">
          <ac:chgData name="Tsujimoto,Mitsuhiro 辻本光宏(関東北甲信越統括支店O領域専門室)" userId="7251bc67-91ee-45c9-97e7-9c240c9b485c" providerId="ADAL" clId="{84BEBAD3-CDC6-4E60-BDDD-D9A6E533E4C1}" dt="2021-04-26T05:59:33.810" v="10380" actId="478"/>
          <ac:spMkLst>
            <pc:docMk/>
            <pc:sldMk cId="2120590716" sldId="889"/>
            <ac:spMk id="22" creationId="{0094F7CE-08CE-4140-8EBC-D2EA4FCA95E9}"/>
          </ac:spMkLst>
        </pc:spChg>
        <pc:grpChg chg="del">
          <ac:chgData name="Tsujimoto,Mitsuhiro 辻本光宏(関東北甲信越統括支店O領域専門室)" userId="7251bc67-91ee-45c9-97e7-9c240c9b485c" providerId="ADAL" clId="{84BEBAD3-CDC6-4E60-BDDD-D9A6E533E4C1}" dt="2021-04-26T05:57:09.253" v="9680" actId="478"/>
          <ac:grpSpMkLst>
            <pc:docMk/>
            <pc:sldMk cId="2120590716" sldId="889"/>
            <ac:grpSpMk id="3" creationId="{3E3B08D4-9C0D-4D43-895E-62A3F8C745AC}"/>
          </ac:grpSpMkLst>
        </pc:grpChg>
        <pc:grpChg chg="del">
          <ac:chgData name="Tsujimoto,Mitsuhiro 辻本光宏(関東北甲信越統括支店O領域専門室)" userId="7251bc67-91ee-45c9-97e7-9c240c9b485c" providerId="ADAL" clId="{84BEBAD3-CDC6-4E60-BDDD-D9A6E533E4C1}" dt="2021-04-26T05:57:09.253" v="9680" actId="478"/>
          <ac:grpSpMkLst>
            <pc:docMk/>
            <pc:sldMk cId="2120590716" sldId="889"/>
            <ac:grpSpMk id="4" creationId="{ADB34CE8-972E-4B66-86C7-1306CFB6306C}"/>
          </ac:grpSpMkLst>
        </pc:grpChg>
        <pc:grpChg chg="del">
          <ac:chgData name="Tsujimoto,Mitsuhiro 辻本光宏(関東北甲信越統括支店O領域専門室)" userId="7251bc67-91ee-45c9-97e7-9c240c9b485c" providerId="ADAL" clId="{84BEBAD3-CDC6-4E60-BDDD-D9A6E533E4C1}" dt="2021-04-26T05:57:09.253" v="9680" actId="478"/>
          <ac:grpSpMkLst>
            <pc:docMk/>
            <pc:sldMk cId="2120590716" sldId="889"/>
            <ac:grpSpMk id="5" creationId="{8E6E26DC-9E26-4893-9E9B-FF17C3D3B3E0}"/>
          </ac:grpSpMkLst>
        </pc:grpChg>
      </pc:sldChg>
      <pc:sldChg chg="addSp delSp modSp add">
        <pc:chgData name="Tsujimoto,Mitsuhiro 辻本光宏(関東北甲信越統括支店O領域専門室)" userId="7251bc67-91ee-45c9-97e7-9c240c9b485c" providerId="ADAL" clId="{84BEBAD3-CDC6-4E60-BDDD-D9A6E533E4C1}" dt="2021-04-26T06:04:14.619" v="11305" actId="1076"/>
        <pc:sldMkLst>
          <pc:docMk/>
          <pc:sldMk cId="2266380815" sldId="890"/>
        </pc:sldMkLst>
        <pc:spChg chg="add mod">
          <ac:chgData name="Tsujimoto,Mitsuhiro 辻本光宏(関東北甲信越統括支店O領域専門室)" userId="7251bc67-91ee-45c9-97e7-9c240c9b485c" providerId="ADAL" clId="{84BEBAD3-CDC6-4E60-BDDD-D9A6E533E4C1}" dt="2021-04-26T05:59:50.626" v="10400" actId="20577"/>
          <ac:spMkLst>
            <pc:docMk/>
            <pc:sldMk cId="2266380815" sldId="890"/>
            <ac:spMk id="2" creationId="{60BEA09C-0DE3-4DC7-9D77-B42395091580}"/>
          </ac:spMkLst>
        </pc:spChg>
        <pc:spChg chg="add del mod">
          <ac:chgData name="Tsujimoto,Mitsuhiro 辻本光宏(関東北甲信越統括支店O領域専門室)" userId="7251bc67-91ee-45c9-97e7-9c240c9b485c" providerId="ADAL" clId="{84BEBAD3-CDC6-4E60-BDDD-D9A6E533E4C1}" dt="2021-04-26T06:03:15.978" v="11175" actId="478"/>
          <ac:spMkLst>
            <pc:docMk/>
            <pc:sldMk cId="2266380815" sldId="890"/>
            <ac:spMk id="3" creationId="{C9E43D0D-2F41-431F-AEA9-5C94EB1D4049}"/>
          </ac:spMkLst>
        </pc:spChg>
        <pc:spChg chg="add mod">
          <ac:chgData name="Tsujimoto,Mitsuhiro 辻本光宏(関東北甲信越統括支店O領域専門室)" userId="7251bc67-91ee-45c9-97e7-9c240c9b485c" providerId="ADAL" clId="{84BEBAD3-CDC6-4E60-BDDD-D9A6E533E4C1}" dt="2021-04-26T06:04:14.619" v="11305" actId="1076"/>
          <ac:spMkLst>
            <pc:docMk/>
            <pc:sldMk cId="2266380815" sldId="890"/>
            <ac:spMk id="4" creationId="{849BC93E-D4F0-4701-B218-2052DA533057}"/>
          </ac:spMkLst>
        </pc:spChg>
      </pc:sldChg>
      <pc:sldChg chg="addSp delSp modSp add">
        <pc:chgData name="Tsujimoto,Mitsuhiro 辻本光宏(関東北甲信越統括支店O領域専門室)" userId="7251bc67-91ee-45c9-97e7-9c240c9b485c" providerId="ADAL" clId="{84BEBAD3-CDC6-4E60-BDDD-D9A6E533E4C1}" dt="2021-04-26T06:05:37.933" v="11426" actId="2711"/>
        <pc:sldMkLst>
          <pc:docMk/>
          <pc:sldMk cId="3744196632" sldId="891"/>
        </pc:sldMkLst>
        <pc:spChg chg="add mod">
          <ac:chgData name="Tsujimoto,Mitsuhiro 辻本光宏(関東北甲信越統括支店O領域専門室)" userId="7251bc67-91ee-45c9-97e7-9c240c9b485c" providerId="ADAL" clId="{84BEBAD3-CDC6-4E60-BDDD-D9A6E533E4C1}" dt="2021-04-26T06:05:13.899" v="11353"/>
          <ac:spMkLst>
            <pc:docMk/>
            <pc:sldMk cId="3744196632" sldId="891"/>
            <ac:spMk id="4" creationId="{81F9C243-E9C1-4EB5-AF08-1AFB954C6043}"/>
          </ac:spMkLst>
        </pc:spChg>
        <pc:spChg chg="add mod">
          <ac:chgData name="Tsujimoto,Mitsuhiro 辻本光宏(関東北甲信越統括支店O領域専門室)" userId="7251bc67-91ee-45c9-97e7-9c240c9b485c" providerId="ADAL" clId="{84BEBAD3-CDC6-4E60-BDDD-D9A6E533E4C1}" dt="2021-04-26T06:05:37.933" v="11426" actId="2711"/>
          <ac:spMkLst>
            <pc:docMk/>
            <pc:sldMk cId="3744196632" sldId="891"/>
            <ac:spMk id="5" creationId="{C11EDB40-27FC-42AE-BE38-4A98870D160D}"/>
          </ac:spMkLst>
        </pc:spChg>
        <pc:picChg chg="add mod">
          <ac:chgData name="Tsujimoto,Mitsuhiro 辻本光宏(関東北甲信越統括支店O領域専門室)" userId="7251bc67-91ee-45c9-97e7-9c240c9b485c" providerId="ADAL" clId="{84BEBAD3-CDC6-4E60-BDDD-D9A6E533E4C1}" dt="2021-04-26T06:04:47.312" v="11311" actId="1076"/>
          <ac:picMkLst>
            <pc:docMk/>
            <pc:sldMk cId="3744196632" sldId="891"/>
            <ac:picMk id="2" creationId="{CD36EC25-FD3D-462A-BBB4-F435468734B3}"/>
          </ac:picMkLst>
        </pc:picChg>
        <pc:picChg chg="add del">
          <ac:chgData name="Tsujimoto,Mitsuhiro 辻本光宏(関東北甲信越統括支店O領域専門室)" userId="7251bc67-91ee-45c9-97e7-9c240c9b485c" providerId="ADAL" clId="{84BEBAD3-CDC6-4E60-BDDD-D9A6E533E4C1}" dt="2021-04-26T06:04:57.043" v="11315" actId="478"/>
          <ac:picMkLst>
            <pc:docMk/>
            <pc:sldMk cId="3744196632" sldId="891"/>
            <ac:picMk id="3" creationId="{0A05ED80-4A12-4A23-A34F-D96D01F8EA23}"/>
          </ac:picMkLst>
        </pc:picChg>
      </pc:sldChg>
      <pc:sldMasterChg chg="modSldLayout">
        <pc:chgData name="Tsujimoto,Mitsuhiro 辻本光宏(関東北甲信越統括支店O領域専門室)" userId="7251bc67-91ee-45c9-97e7-9c240c9b485c" providerId="ADAL" clId="{84BEBAD3-CDC6-4E60-BDDD-D9A6E533E4C1}" dt="2021-04-26T03:26:51.093" v="4059" actId="2085"/>
        <pc:sldMasterMkLst>
          <pc:docMk/>
          <pc:sldMasterMk cId="2653139781" sldId="2147483648"/>
        </pc:sldMasterMkLst>
        <pc:sldLayoutChg chg="modSp">
          <pc:chgData name="Tsujimoto,Mitsuhiro 辻本光宏(関東北甲信越統括支店O領域専門室)" userId="7251bc67-91ee-45c9-97e7-9c240c9b485c" providerId="ADAL" clId="{84BEBAD3-CDC6-4E60-BDDD-D9A6E533E4C1}" dt="2021-04-26T03:26:51.093" v="4059" actId="2085"/>
          <pc:sldLayoutMkLst>
            <pc:docMk/>
            <pc:sldMasterMk cId="2653139781" sldId="2147483648"/>
            <pc:sldLayoutMk cId="3408255873" sldId="2147483674"/>
          </pc:sldLayoutMkLst>
          <pc:spChg chg="mod">
            <ac:chgData name="Tsujimoto,Mitsuhiro 辻本光宏(関東北甲信越統括支店O領域専門室)" userId="7251bc67-91ee-45c9-97e7-9c240c9b485c" providerId="ADAL" clId="{84BEBAD3-CDC6-4E60-BDDD-D9A6E533E4C1}" dt="2021-04-26T03:26:51.093" v="4059" actId="2085"/>
            <ac:spMkLst>
              <pc:docMk/>
              <pc:sldMasterMk cId="2653139781" sldId="2147483648"/>
              <pc:sldLayoutMk cId="3408255873" sldId="2147483674"/>
              <ac:spMk id="2" creationId="{D01EC866-3094-E04E-B88A-C6F6CDA0BF8D}"/>
            </ac:spMkLst>
          </pc:spChg>
        </pc:sldLayoutChg>
      </pc:sldMasterChg>
      <pc:sldMasterChg chg="modSldLayout">
        <pc:chgData name="Tsujimoto,Mitsuhiro 辻本光宏(関東北甲信越統括支店O領域専門室)" userId="7251bc67-91ee-45c9-97e7-9c240c9b485c" providerId="ADAL" clId="{84BEBAD3-CDC6-4E60-BDDD-D9A6E533E4C1}" dt="2021-04-26T01:48:53.141" v="894" actId="2085"/>
        <pc:sldMasterMkLst>
          <pc:docMk/>
          <pc:sldMasterMk cId="3507685230" sldId="2147483660"/>
        </pc:sldMasterMkLst>
        <pc:sldLayoutChg chg="modSp">
          <pc:chgData name="Tsujimoto,Mitsuhiro 辻本光宏(関東北甲信越統括支店O領域専門室)" userId="7251bc67-91ee-45c9-97e7-9c240c9b485c" providerId="ADAL" clId="{84BEBAD3-CDC6-4E60-BDDD-D9A6E533E4C1}" dt="2021-04-26T01:48:53.141" v="894" actId="2085"/>
          <pc:sldLayoutMkLst>
            <pc:docMk/>
            <pc:sldMasterMk cId="3507685230" sldId="2147483660"/>
            <pc:sldLayoutMk cId="3921961601" sldId="2147483669"/>
          </pc:sldLayoutMkLst>
          <pc:spChg chg="mod">
            <ac:chgData name="Tsujimoto,Mitsuhiro 辻本光宏(関東北甲信越統括支店O領域専門室)" userId="7251bc67-91ee-45c9-97e7-9c240c9b485c" providerId="ADAL" clId="{84BEBAD3-CDC6-4E60-BDDD-D9A6E533E4C1}" dt="2021-04-26T01:48:53.141" v="894" actId="2085"/>
            <ac:spMkLst>
              <pc:docMk/>
              <pc:sldMasterMk cId="3507685230" sldId="2147483660"/>
              <pc:sldLayoutMk cId="3921961601" sldId="2147483669"/>
              <ac:spMk id="2" creationId="{D01EC866-3094-E04E-B88A-C6F6CDA0BF8D}"/>
            </ac:spMkLst>
          </pc:spChg>
        </pc:sldLayoutChg>
      </pc:sldMaster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18831" cy="495029"/>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5373" y="0"/>
            <a:ext cx="2918831" cy="495029"/>
          </a:xfrm>
          <a:prstGeom prst="rect">
            <a:avLst/>
          </a:prstGeom>
        </p:spPr>
        <p:txBody>
          <a:bodyPr vert="horz" lIns="91440" tIns="45720" rIns="91440" bIns="45720" rtlCol="0"/>
          <a:lstStyle>
            <a:lvl1pPr algn="r">
              <a:defRPr sz="1200"/>
            </a:lvl1pPr>
          </a:lstStyle>
          <a:p>
            <a:fld id="{F06C27B4-929C-43D1-9FE1-2B3B10AB124E}" type="datetimeFigureOut">
              <a:rPr kumimoji="1" lang="ja-JP" altLang="en-US" smtClean="0"/>
              <a:t>2024/4/26</a:t>
            </a:fld>
            <a:endParaRPr kumimoji="1" lang="ja-JP" altLang="en-US"/>
          </a:p>
        </p:txBody>
      </p:sp>
      <p:sp>
        <p:nvSpPr>
          <p:cNvPr id="4" name="スライド イメージ プレースホルダー 3"/>
          <p:cNvSpPr>
            <a:spLocks noGrp="1" noRot="1" noChangeAspect="1"/>
          </p:cNvSpPr>
          <p:nvPr>
            <p:ph type="sldImg" idx="2"/>
          </p:nvPr>
        </p:nvSpPr>
        <p:spPr>
          <a:xfrm>
            <a:off x="409575" y="1233488"/>
            <a:ext cx="5916613" cy="33289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3577" y="4748163"/>
            <a:ext cx="5388610" cy="3884861"/>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371286"/>
            <a:ext cx="2918831" cy="495028"/>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5373" y="9371286"/>
            <a:ext cx="2918831" cy="495028"/>
          </a:xfrm>
          <a:prstGeom prst="rect">
            <a:avLst/>
          </a:prstGeom>
        </p:spPr>
        <p:txBody>
          <a:bodyPr vert="horz" lIns="91440" tIns="45720" rIns="91440" bIns="45720" rtlCol="0" anchor="b"/>
          <a:lstStyle>
            <a:lvl1pPr algn="r">
              <a:defRPr sz="1200"/>
            </a:lvl1pPr>
          </a:lstStyle>
          <a:p>
            <a:fld id="{321E955D-F522-4F5B-AA0A-8A0973EE625D}" type="slidenum">
              <a:rPr kumimoji="1" lang="ja-JP" altLang="en-US" smtClean="0"/>
              <a:t>‹#›</a:t>
            </a:fld>
            <a:endParaRPr kumimoji="1" lang="ja-JP" altLang="en-US"/>
          </a:p>
        </p:txBody>
      </p:sp>
    </p:spTree>
    <p:extLst>
      <p:ext uri="{BB962C8B-B14F-4D97-AF65-F5344CB8AC3E}">
        <p14:creationId xmlns:p14="http://schemas.microsoft.com/office/powerpoint/2010/main" val="88108195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EB9CD56-0211-4A81-8D7F-4A6D6DEEDF4C}"/>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110250CE-4ECB-4109-AF0C-A6A89E31C56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E9B454B0-A8B1-4B03-AAAE-2F6631DC2AAA}"/>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5" name="フッター プレースホルダー 4">
            <a:extLst>
              <a:ext uri="{FF2B5EF4-FFF2-40B4-BE49-F238E27FC236}">
                <a16:creationId xmlns:a16="http://schemas.microsoft.com/office/drawing/2014/main" id="{DF16AD16-897D-4D2F-BE53-CF916126B7E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910B922-A245-4610-B723-B4844CDB6056}"/>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1127390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B93B404-EF58-4C26-A92C-A1F1DB72C881}"/>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6B2CBCC8-CA4C-4F59-8653-BD9F1A0358D4}"/>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2DB8B88-A6A3-4D2A-80F9-8EB3763CAF76}"/>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5" name="フッター プレースホルダー 4">
            <a:extLst>
              <a:ext uri="{FF2B5EF4-FFF2-40B4-BE49-F238E27FC236}">
                <a16:creationId xmlns:a16="http://schemas.microsoft.com/office/drawing/2014/main" id="{AB3B85D1-5B6B-417F-9CD8-CF837BEE328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9BDCFC7-115F-4EFB-8331-2881C323F2BE}"/>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22856900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D67BEB27-CFB3-430F-81FA-C8EA9EB3C8B4}"/>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843E1F08-0AE1-4EF6-A91A-22AEA525FBEC}"/>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86BDA07-2173-4F62-A6DA-AB6B42777583}"/>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5" name="フッター プレースホルダー 4">
            <a:extLst>
              <a:ext uri="{FF2B5EF4-FFF2-40B4-BE49-F238E27FC236}">
                <a16:creationId xmlns:a16="http://schemas.microsoft.com/office/drawing/2014/main" id="{604D9147-E501-4159-BF0A-475C1A1C6C6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3337C4C-49B7-42D4-9C79-36647EDD84CE}"/>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15197831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39F2EFC-301A-45C6-BB18-F8D4D8CDA6BD}"/>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2E6EF2E-4AD8-406A-8678-7246AA058B22}"/>
              </a:ext>
            </a:extLst>
          </p:cNvPr>
          <p:cNvSpPr>
            <a:spLocks noGrp="1"/>
          </p:cNvSpPr>
          <p:nvPr>
            <p:ph idx="1"/>
          </p:nvPr>
        </p:nvSpPr>
        <p:spPr/>
        <p:txBody>
          <a:bodyPr/>
          <a:lstStyle/>
          <a:p>
            <a:pPr lvl="0"/>
            <a:r>
              <a:rPr kumimoji="1" lang="ja-JP" altLang="en-US" dirty="0"/>
              <a:t>マスター テキストの書式設定</a:t>
            </a:r>
          </a:p>
          <a:p>
            <a:pPr lvl="1"/>
            <a:r>
              <a:rPr kumimoji="1" lang="ja-JP" altLang="en-US" dirty="0"/>
              <a:t>第 </a:t>
            </a:r>
            <a:r>
              <a:rPr kumimoji="1" lang="en-US" altLang="ja-JP" dirty="0"/>
              <a:t>2 </a:t>
            </a:r>
            <a:r>
              <a:rPr kumimoji="1" lang="ja-JP" altLang="en-US" dirty="0"/>
              <a:t>レベル</a:t>
            </a:r>
          </a:p>
          <a:p>
            <a:pPr lvl="2"/>
            <a:r>
              <a:rPr kumimoji="1" lang="ja-JP" altLang="en-US" dirty="0"/>
              <a:t>第 </a:t>
            </a:r>
            <a:r>
              <a:rPr kumimoji="1" lang="en-US" altLang="ja-JP" dirty="0"/>
              <a:t>3 </a:t>
            </a:r>
            <a:r>
              <a:rPr kumimoji="1" lang="ja-JP" altLang="en-US" dirty="0"/>
              <a:t>レベル</a:t>
            </a:r>
          </a:p>
          <a:p>
            <a:pPr lvl="3"/>
            <a:r>
              <a:rPr kumimoji="1" lang="ja-JP" altLang="en-US" dirty="0"/>
              <a:t>第 </a:t>
            </a:r>
            <a:r>
              <a:rPr kumimoji="1" lang="en-US" altLang="ja-JP" dirty="0"/>
              <a:t>4 </a:t>
            </a:r>
            <a:r>
              <a:rPr kumimoji="1" lang="ja-JP" altLang="en-US" dirty="0"/>
              <a:t>レベル</a:t>
            </a:r>
          </a:p>
          <a:p>
            <a:pPr lvl="4"/>
            <a:r>
              <a:rPr kumimoji="1" lang="ja-JP" altLang="en-US" dirty="0"/>
              <a:t>第 </a:t>
            </a:r>
            <a:r>
              <a:rPr kumimoji="1" lang="en-US" altLang="ja-JP" dirty="0"/>
              <a:t>5 </a:t>
            </a:r>
            <a:r>
              <a:rPr kumimoji="1" lang="ja-JP" altLang="en-US" dirty="0"/>
              <a:t>レベル</a:t>
            </a:r>
          </a:p>
        </p:txBody>
      </p:sp>
      <p:sp>
        <p:nvSpPr>
          <p:cNvPr id="4" name="日付プレースホルダー 3">
            <a:extLst>
              <a:ext uri="{FF2B5EF4-FFF2-40B4-BE49-F238E27FC236}">
                <a16:creationId xmlns:a16="http://schemas.microsoft.com/office/drawing/2014/main" id="{CAE1D092-4D4C-4B02-BAD9-3FFCB2A05857}"/>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5" name="フッター プレースホルダー 4">
            <a:extLst>
              <a:ext uri="{FF2B5EF4-FFF2-40B4-BE49-F238E27FC236}">
                <a16:creationId xmlns:a16="http://schemas.microsoft.com/office/drawing/2014/main" id="{D3A9A795-22D1-471B-9D52-C1562678B8C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51A28DB-1E53-45C3-919B-FC53938B198D}"/>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23368522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F877A63-58AF-4C8C-B629-20967C6F9969}"/>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D2676FF-CE14-472B-AE90-F6FD192B76B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602BBCB4-E9FD-4869-9603-C71C158AC8E4}"/>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5" name="フッター プレースホルダー 4">
            <a:extLst>
              <a:ext uri="{FF2B5EF4-FFF2-40B4-BE49-F238E27FC236}">
                <a16:creationId xmlns:a16="http://schemas.microsoft.com/office/drawing/2014/main" id="{3E7C5F0E-C94F-4D86-99B8-666C94427FA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D0D90DA-9E57-4CA0-8967-FB50DD2228D7}"/>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6330228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B72F943-38F3-467D-A172-ADD6C115381F}"/>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2694CB6-5124-40EC-AFFD-6BF0D4C2F023}"/>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B9BB28D2-1CAB-4641-B56F-3CFBDE7F6DF9}"/>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A0AAFB5C-9824-41C3-BD06-E8B96DCE0A6F}"/>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6" name="フッター プレースホルダー 5">
            <a:extLst>
              <a:ext uri="{FF2B5EF4-FFF2-40B4-BE49-F238E27FC236}">
                <a16:creationId xmlns:a16="http://schemas.microsoft.com/office/drawing/2014/main" id="{15C192A7-52F7-4BE1-BDF4-5CC63AB02CF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6B1EDA19-E80B-476D-BC4A-6D3DDCFF264D}"/>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27020829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778CB6E-6195-462B-879D-A1B7ECD58FD7}"/>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7C0D90F2-DD1C-45E9-8770-D8EDF589BE4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2BDED49F-9DE5-4FD5-AE9D-33D83F56CC5A}"/>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2BE64801-E493-4003-A288-B287A4BAAF0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3A944054-D22B-4676-804F-DC03D26F699B}"/>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7FF96836-EF4D-4EE0-A7C4-DEF3219AA01B}"/>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8" name="フッター プレースホルダー 7">
            <a:extLst>
              <a:ext uri="{FF2B5EF4-FFF2-40B4-BE49-F238E27FC236}">
                <a16:creationId xmlns:a16="http://schemas.microsoft.com/office/drawing/2014/main" id="{F0EED372-5977-4F76-B22B-CF5B93EB7083}"/>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A23E149E-39CE-4B6B-B2CD-CA6BCB500ACE}"/>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6068912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F9886BB-C266-451E-80DE-934807085648}"/>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06E1FA40-6618-492F-9869-E5753D2A3975}"/>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4" name="フッター プレースホルダー 3">
            <a:extLst>
              <a:ext uri="{FF2B5EF4-FFF2-40B4-BE49-F238E27FC236}">
                <a16:creationId xmlns:a16="http://schemas.microsoft.com/office/drawing/2014/main" id="{D970EC94-9154-4B52-9B57-C0884F9063E1}"/>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10B4EBF4-FECB-4731-BB9D-55D273A425AD}"/>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15207969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2C73637A-627D-46C6-A65D-5B2D7A18A940}"/>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3" name="フッター プレースホルダー 2">
            <a:extLst>
              <a:ext uri="{FF2B5EF4-FFF2-40B4-BE49-F238E27FC236}">
                <a16:creationId xmlns:a16="http://schemas.microsoft.com/office/drawing/2014/main" id="{5F2A7899-42F3-4AF7-94D1-CBA6C5BE0D1F}"/>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3F46E592-AE19-42E2-9B3A-BBDD73385897}"/>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41729736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4D1B82B-EB0A-4E1C-95AC-12FCC03C59F3}"/>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34CEDD30-44C5-45A1-9BA9-231CE7635B0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1C538EBA-A654-454E-A8E1-6C9BB801FCE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142FB2DD-04EA-4B81-A5FB-77F81CDB113B}"/>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6" name="フッター プレースホルダー 5">
            <a:extLst>
              <a:ext uri="{FF2B5EF4-FFF2-40B4-BE49-F238E27FC236}">
                <a16:creationId xmlns:a16="http://schemas.microsoft.com/office/drawing/2014/main" id="{4A1A80C9-959B-4C43-8B55-163F849B25C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B503E5A-A4B4-4D05-A979-FFA7FE21638B}"/>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28351839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BEEE970-18C8-482E-B54A-7DDD96A05E5F}"/>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08E21283-6665-44E2-A734-BDA67F72AD0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3D3E9542-7CDE-445B-93C0-F21BCB43B0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F798C15C-42CC-453E-BECE-1E700FB394F1}"/>
              </a:ext>
            </a:extLst>
          </p:cNvPr>
          <p:cNvSpPr>
            <a:spLocks noGrp="1"/>
          </p:cNvSpPr>
          <p:nvPr>
            <p:ph type="dt" sz="half" idx="10"/>
          </p:nvPr>
        </p:nvSpPr>
        <p:spPr/>
        <p:txBody>
          <a:bodyPr/>
          <a:lstStyle/>
          <a:p>
            <a:fld id="{AB41BE8F-0B34-4485-B762-9E27C461DDC9}" type="datetimeFigureOut">
              <a:rPr kumimoji="1" lang="ja-JP" altLang="en-US" smtClean="0"/>
              <a:t>2024/4/26</a:t>
            </a:fld>
            <a:endParaRPr kumimoji="1" lang="ja-JP" altLang="en-US"/>
          </a:p>
        </p:txBody>
      </p:sp>
      <p:sp>
        <p:nvSpPr>
          <p:cNvPr id="6" name="フッター プレースホルダー 5">
            <a:extLst>
              <a:ext uri="{FF2B5EF4-FFF2-40B4-BE49-F238E27FC236}">
                <a16:creationId xmlns:a16="http://schemas.microsoft.com/office/drawing/2014/main" id="{F12ACDC5-9731-427F-8989-C58C6CBA34C5}"/>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47CCBB78-3E0A-416E-99E7-47806DDAAA3E}"/>
              </a:ext>
            </a:extLst>
          </p:cNvPr>
          <p:cNvSpPr>
            <a:spLocks noGrp="1"/>
          </p:cNvSpPr>
          <p:nvPr>
            <p:ph type="sldNum" sz="quarter" idx="12"/>
          </p:nvPr>
        </p:nvSpPr>
        <p:spPr/>
        <p:txBody>
          <a:body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34595620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E6E6DD80-7F43-4F6B-AEAB-7959AC8FB7B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73DCD391-B656-472D-98A1-EACA8A23FC0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FDCFE9B-4792-4F73-B51F-4C7B0C88B1C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B41BE8F-0B34-4485-B762-9E27C461DDC9}" type="datetimeFigureOut">
              <a:rPr kumimoji="1" lang="ja-JP" altLang="en-US" smtClean="0"/>
              <a:t>2024/4/26</a:t>
            </a:fld>
            <a:endParaRPr kumimoji="1" lang="ja-JP" altLang="en-US"/>
          </a:p>
        </p:txBody>
      </p:sp>
      <p:sp>
        <p:nvSpPr>
          <p:cNvPr id="5" name="フッター プレースホルダー 4">
            <a:extLst>
              <a:ext uri="{FF2B5EF4-FFF2-40B4-BE49-F238E27FC236}">
                <a16:creationId xmlns:a16="http://schemas.microsoft.com/office/drawing/2014/main" id="{4215758B-3399-4899-AA90-83EE7B06659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A73C9A66-47A5-421D-82F2-DF5C707B6FC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D14423-77CF-4B1B-BFC3-CC44D3CD3D39}" type="slidenum">
              <a:rPr kumimoji="1" lang="ja-JP" altLang="en-US" smtClean="0"/>
              <a:t>‹#›</a:t>
            </a:fld>
            <a:endParaRPr kumimoji="1" lang="ja-JP" altLang="en-US"/>
          </a:p>
        </p:txBody>
      </p:sp>
    </p:spTree>
    <p:extLst>
      <p:ext uri="{BB962C8B-B14F-4D97-AF65-F5344CB8AC3E}">
        <p14:creationId xmlns:p14="http://schemas.microsoft.com/office/powerpoint/2010/main" val="26531397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BFAC059-BE98-BF71-871C-9CCA7FF32DA5}"/>
            </a:ext>
          </a:extLst>
        </p:cNvPr>
        <p:cNvGrpSpPr/>
        <p:nvPr/>
      </p:nvGrpSpPr>
      <p:grpSpPr>
        <a:xfrm>
          <a:off x="0" y="0"/>
          <a:ext cx="0" cy="0"/>
          <a:chOff x="0" y="0"/>
          <a:chExt cx="0" cy="0"/>
        </a:xfrm>
      </p:grpSpPr>
      <p:sp>
        <p:nvSpPr>
          <p:cNvPr id="7" name="正方形/長方形 6">
            <a:extLst>
              <a:ext uri="{FF2B5EF4-FFF2-40B4-BE49-F238E27FC236}">
                <a16:creationId xmlns:a16="http://schemas.microsoft.com/office/drawing/2014/main" id="{BF0A3B5A-CB66-5761-3568-AB322500E527}"/>
              </a:ext>
            </a:extLst>
          </p:cNvPr>
          <p:cNvSpPr/>
          <p:nvPr/>
        </p:nvSpPr>
        <p:spPr>
          <a:xfrm>
            <a:off x="790379" y="4769487"/>
            <a:ext cx="4902861" cy="276999"/>
          </a:xfrm>
          <a:prstGeom prst="rect">
            <a:avLst/>
          </a:prstGeom>
        </p:spPr>
        <p:txBody>
          <a:bodyPr wrap="square">
            <a:spAutoFit/>
          </a:bodyPr>
          <a:lstStyle/>
          <a:p>
            <a:r>
              <a:rPr lang="ja-JP" altLang="en-US" sz="1200" dirty="0">
                <a:latin typeface="+mn-ea"/>
                <a:cs typeface="Arial" panose="020B060402020202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0            6           12          18          24         30 </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 </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  36          42          48           </a:t>
            </a:r>
            <a:r>
              <a:rPr lang="ja-JP" altLang="en-US" sz="1200" dirty="0">
                <a:latin typeface="Calibri" panose="020F0502020204030204" pitchFamily="34" charset="0"/>
                <a:cs typeface="Calibri" panose="020F0502020204030204" pitchFamily="34" charset="0"/>
              </a:rPr>
              <a:t>    </a:t>
            </a:r>
          </a:p>
        </p:txBody>
      </p:sp>
      <p:sp>
        <p:nvSpPr>
          <p:cNvPr id="8" name="テキスト ボックス 7">
            <a:extLst>
              <a:ext uri="{FF2B5EF4-FFF2-40B4-BE49-F238E27FC236}">
                <a16:creationId xmlns:a16="http://schemas.microsoft.com/office/drawing/2014/main" id="{B12A1D59-E9DD-4B42-6210-9304E882EA35}"/>
              </a:ext>
            </a:extLst>
          </p:cNvPr>
          <p:cNvSpPr txBox="1"/>
          <p:nvPr/>
        </p:nvSpPr>
        <p:spPr>
          <a:xfrm>
            <a:off x="2569488" y="4993306"/>
            <a:ext cx="1927412" cy="276999"/>
          </a:xfrm>
          <a:prstGeom prst="rect">
            <a:avLst/>
          </a:prstGeom>
          <a:noFill/>
        </p:spPr>
        <p:txBody>
          <a:bodyPr wrap="square" rtlCol="0">
            <a:spAutoFit/>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Time (months)</a:t>
            </a:r>
            <a:endParaRPr kumimoji="1" lang="ja-JP" altLang="en-US" sz="1200" dirty="0">
              <a:latin typeface="Calibri" panose="020F0502020204030204" pitchFamily="34" charset="0"/>
              <a:ea typeface="Meiryo UI" panose="020B0604030504040204" pitchFamily="50" charset="-128"/>
              <a:cs typeface="Calibri" panose="020F0502020204030204" pitchFamily="34" charset="0"/>
            </a:endParaRPr>
          </a:p>
        </p:txBody>
      </p:sp>
      <p:sp>
        <p:nvSpPr>
          <p:cNvPr id="10" name="正方形/長方形 9">
            <a:extLst>
              <a:ext uri="{FF2B5EF4-FFF2-40B4-BE49-F238E27FC236}">
                <a16:creationId xmlns:a16="http://schemas.microsoft.com/office/drawing/2014/main" id="{07049DF1-145A-0FA5-E109-1FAF53204399}"/>
              </a:ext>
            </a:extLst>
          </p:cNvPr>
          <p:cNvSpPr/>
          <p:nvPr/>
        </p:nvSpPr>
        <p:spPr>
          <a:xfrm rot="16200000">
            <a:off x="5818401" y="2952426"/>
            <a:ext cx="1192314" cy="276999"/>
          </a:xfrm>
          <a:prstGeom prst="rect">
            <a:avLst/>
          </a:prstGeom>
        </p:spPr>
        <p:txBody>
          <a:bodyPr wrap="none">
            <a:spAutoFit/>
          </a:bodyPr>
          <a:lstStyle/>
          <a:p>
            <a:r>
              <a:rPr lang="en-US" altLang="ja-JP" sz="1200" dirty="0">
                <a:latin typeface="Calibri" panose="020F0502020204030204" pitchFamily="34" charset="0"/>
                <a:ea typeface="Calibri" panose="020F0502020204030204" pitchFamily="34" charset="0"/>
                <a:cs typeface="Calibri" panose="020F0502020204030204" pitchFamily="34" charset="0"/>
              </a:rPr>
              <a:t>Survival</a:t>
            </a:r>
            <a:r>
              <a:rPr lang="ja-JP" altLang="en-US" sz="1200" dirty="0">
                <a:latin typeface="Calibri" panose="020F0502020204030204" pitchFamily="34" charset="0"/>
                <a:ea typeface="Meiryo UI" panose="020B0604030504040204" pitchFamily="50" charset="-128"/>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rate (%)</a:t>
            </a:r>
            <a:endParaRPr lang="ja-JP" altLang="en-US" sz="1200" dirty="0">
              <a:latin typeface="Calibri" panose="020F0502020204030204" pitchFamily="34" charset="0"/>
              <a:ea typeface="Meiryo UI" panose="020B0604030504040204" pitchFamily="50" charset="-128"/>
              <a:cs typeface="Calibri" panose="020F0502020204030204" pitchFamily="34" charset="0"/>
            </a:endParaRPr>
          </a:p>
        </p:txBody>
      </p:sp>
      <p:sp>
        <p:nvSpPr>
          <p:cNvPr id="13" name="正方形/長方形 12">
            <a:extLst>
              <a:ext uri="{FF2B5EF4-FFF2-40B4-BE49-F238E27FC236}">
                <a16:creationId xmlns:a16="http://schemas.microsoft.com/office/drawing/2014/main" id="{FA45F2B0-FE62-19B1-FE05-1D4DDFE1B289}"/>
              </a:ext>
            </a:extLst>
          </p:cNvPr>
          <p:cNvSpPr/>
          <p:nvPr/>
        </p:nvSpPr>
        <p:spPr>
          <a:xfrm>
            <a:off x="516519" y="1695685"/>
            <a:ext cx="547720" cy="276999"/>
          </a:xfrm>
          <a:prstGeom prst="rect">
            <a:avLst/>
          </a:prstGeom>
        </p:spPr>
        <p:txBody>
          <a:bodyPr wrap="square">
            <a:spAutoFit/>
          </a:bodyPr>
          <a:lstStyle/>
          <a:p>
            <a:r>
              <a:rPr lang="en-US" altLang="ja-JP" sz="1200" dirty="0">
                <a:latin typeface="Calibri" panose="020F0502020204030204" pitchFamily="34" charset="0"/>
                <a:ea typeface="Calibri" panose="020F0502020204030204" pitchFamily="34" charset="0"/>
                <a:cs typeface="Calibri" panose="020F0502020204030204" pitchFamily="34" charset="0"/>
              </a:rPr>
              <a:t>100</a:t>
            </a:r>
            <a:endParaRPr lang="ja-JP" altLang="en-US" sz="1200" dirty="0">
              <a:latin typeface="Calibri" panose="020F0502020204030204" pitchFamily="34" charset="0"/>
              <a:ea typeface="Meiryo UI" panose="020B0604030504040204" pitchFamily="50" charset="-128"/>
              <a:cs typeface="Calibri" panose="020F0502020204030204" pitchFamily="34" charset="0"/>
            </a:endParaRPr>
          </a:p>
        </p:txBody>
      </p:sp>
      <p:sp>
        <p:nvSpPr>
          <p:cNvPr id="15" name="テキスト ボックス 14">
            <a:extLst>
              <a:ext uri="{FF2B5EF4-FFF2-40B4-BE49-F238E27FC236}">
                <a16:creationId xmlns:a16="http://schemas.microsoft.com/office/drawing/2014/main" id="{6BDB106F-E91D-5648-DD3D-ABDB6FE6C7DB}"/>
              </a:ext>
            </a:extLst>
          </p:cNvPr>
          <p:cNvSpPr txBox="1"/>
          <p:nvPr/>
        </p:nvSpPr>
        <p:spPr>
          <a:xfrm>
            <a:off x="577118" y="2173842"/>
            <a:ext cx="372538" cy="2771173"/>
          </a:xfrm>
          <a:prstGeom prst="rect">
            <a:avLst/>
          </a:prstGeom>
          <a:noFill/>
        </p:spPr>
        <p:txBody>
          <a:bodyPr vert="eaVert" wrap="square" rtlCol="0">
            <a:spAutoFit/>
          </a:bodyPr>
          <a:lstStyle/>
          <a:p>
            <a:r>
              <a:rPr kumimoji="1" lang="en-US" altLang="ja-JP" sz="1200" dirty="0">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80           60          40        </a:t>
            </a:r>
            <a:r>
              <a:rPr lang="ja-JP" altLang="en-US" sz="1200" dirty="0">
                <a:latin typeface="Calibri" panose="020F0502020204030204" pitchFamily="34" charset="0"/>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  20        </a:t>
            </a:r>
            <a:r>
              <a:rPr lang="ja-JP" altLang="en-US" sz="1200" dirty="0">
                <a:latin typeface="Calibri" panose="020F0502020204030204" pitchFamily="34" charset="0"/>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 </a:t>
            </a:r>
            <a:r>
              <a:rPr lang="ja-JP" altLang="en-US" sz="1200" dirty="0">
                <a:latin typeface="Calibri" panose="020F0502020204030204" pitchFamily="34" charset="0"/>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0</a:t>
            </a:r>
            <a:endParaRPr kumimoji="1" lang="ja-JP" altLang="en-US" sz="1200" dirty="0">
              <a:latin typeface="Calibri" panose="020F0502020204030204" pitchFamily="34" charset="0"/>
              <a:cs typeface="Calibri" panose="020F0502020204030204" pitchFamily="34" charset="0"/>
            </a:endParaRPr>
          </a:p>
        </p:txBody>
      </p:sp>
      <p:sp>
        <p:nvSpPr>
          <p:cNvPr id="6" name="正方形/長方形 5">
            <a:extLst>
              <a:ext uri="{FF2B5EF4-FFF2-40B4-BE49-F238E27FC236}">
                <a16:creationId xmlns:a16="http://schemas.microsoft.com/office/drawing/2014/main" id="{890EE7F2-7DC4-0486-2D0F-2A2D39BA30AC}"/>
              </a:ext>
            </a:extLst>
          </p:cNvPr>
          <p:cNvSpPr/>
          <p:nvPr/>
        </p:nvSpPr>
        <p:spPr>
          <a:xfrm>
            <a:off x="282697" y="5276517"/>
            <a:ext cx="5066173" cy="830997"/>
          </a:xfrm>
          <a:prstGeom prst="rect">
            <a:avLst/>
          </a:prstGeom>
        </p:spPr>
        <p:txBody>
          <a:bodyPr wrap="square">
            <a:spAutoFit/>
          </a:bodyPr>
          <a:lstStyle/>
          <a:p>
            <a:r>
              <a:rPr lang="en-US" altLang="ja-JP" sz="1200" dirty="0">
                <a:latin typeface="Calibri" panose="020F0502020204030204" pitchFamily="34" charset="0"/>
                <a:ea typeface="Calibri" panose="020F0502020204030204" pitchFamily="34" charset="0"/>
                <a:cs typeface="Calibri" panose="020F0502020204030204" pitchFamily="34" charset="0"/>
              </a:rPr>
              <a:t>Number at risk</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With Grade1-2 </a:t>
            </a:r>
            <a:r>
              <a:rPr lang="en-US" altLang="ja-JP" sz="1200" dirty="0" err="1">
                <a:latin typeface="Calibri" panose="020F0502020204030204" pitchFamily="34" charset="0"/>
                <a:ea typeface="Calibri" panose="020F0502020204030204" pitchFamily="34" charset="0"/>
                <a:cs typeface="Calibri" panose="020F0502020204030204" pitchFamily="34" charset="0"/>
              </a:rPr>
              <a:t>irAEs</a:t>
            </a:r>
            <a:r>
              <a:rPr lang="en-US" altLang="ja-JP" sz="1200" dirty="0">
                <a:latin typeface="Calibri" panose="020F0502020204030204" pitchFamily="34" charset="0"/>
                <a:ea typeface="Calibri" panose="020F0502020204030204" pitchFamily="34" charset="0"/>
                <a:cs typeface="Calibri" panose="020F0502020204030204" pitchFamily="34" charset="0"/>
              </a:rPr>
              <a:t>)</a:t>
            </a:r>
          </a:p>
          <a:p>
            <a:r>
              <a:rPr lang="en-US" altLang="ja-JP" sz="1200" dirty="0">
                <a:latin typeface="Calibri" panose="020F0502020204030204" pitchFamily="34" charset="0"/>
                <a:ea typeface="Calibri" panose="020F0502020204030204" pitchFamily="34" charset="0"/>
                <a:cs typeface="Calibri" panose="020F0502020204030204" pitchFamily="34" charset="0"/>
              </a:rPr>
              <a:t>            </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78          57      </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  43          30          18         11           7            2            0     </a:t>
            </a:r>
          </a:p>
          <a:p>
            <a:r>
              <a:rPr lang="en-US" altLang="ja-JP" sz="1200" dirty="0">
                <a:latin typeface="Calibri" panose="020F0502020204030204" pitchFamily="34" charset="0"/>
                <a:ea typeface="Calibri" panose="020F0502020204030204" pitchFamily="34" charset="0"/>
                <a:cs typeface="Calibri" panose="020F0502020204030204" pitchFamily="34" charset="0"/>
              </a:rPr>
              <a:t>Number at risk (Without </a:t>
            </a:r>
            <a:r>
              <a:rPr lang="en-US" altLang="ja-JP" sz="1200" dirty="0" err="1">
                <a:latin typeface="Calibri" panose="020F0502020204030204" pitchFamily="34" charset="0"/>
                <a:ea typeface="Calibri" panose="020F0502020204030204" pitchFamily="34" charset="0"/>
                <a:cs typeface="Calibri" panose="020F0502020204030204" pitchFamily="34" charset="0"/>
              </a:rPr>
              <a:t>irAE</a:t>
            </a:r>
            <a:r>
              <a:rPr lang="en-US" altLang="ja-JP" sz="1200" dirty="0">
                <a:latin typeface="Calibri" panose="020F0502020204030204" pitchFamily="34" charset="0"/>
                <a:ea typeface="Calibri" panose="020F0502020204030204" pitchFamily="34" charset="0"/>
                <a:cs typeface="Calibri" panose="020F0502020204030204" pitchFamily="34" charset="0"/>
              </a:rPr>
              <a:t>)        </a:t>
            </a:r>
          </a:p>
          <a:p>
            <a:r>
              <a:rPr lang="en-US" altLang="ja-JP" sz="1200" dirty="0">
                <a:latin typeface="Calibri" panose="020F0502020204030204" pitchFamily="34" charset="0"/>
                <a:ea typeface="Calibri" panose="020F0502020204030204" pitchFamily="34" charset="0"/>
                <a:cs typeface="Calibri" panose="020F0502020204030204" pitchFamily="34" charset="0"/>
              </a:rPr>
              <a:t>                    93          55         43          32          24         13           6            5            0    </a:t>
            </a:r>
            <a:endParaRPr lang="ja-JP" altLang="en-US" sz="1200" dirty="0">
              <a:latin typeface="Calibri" panose="020F0502020204030204" pitchFamily="34" charset="0"/>
              <a:cs typeface="Calibri" panose="020F0502020204030204" pitchFamily="34" charset="0"/>
            </a:endParaRPr>
          </a:p>
        </p:txBody>
      </p:sp>
      <p:sp>
        <p:nvSpPr>
          <p:cNvPr id="5" name="正方形/長方形 4">
            <a:extLst>
              <a:ext uri="{FF2B5EF4-FFF2-40B4-BE49-F238E27FC236}">
                <a16:creationId xmlns:a16="http://schemas.microsoft.com/office/drawing/2014/main" id="{346FE314-CA89-B62D-FDB1-128B673BF35E}"/>
              </a:ext>
            </a:extLst>
          </p:cNvPr>
          <p:cNvSpPr/>
          <p:nvPr/>
        </p:nvSpPr>
        <p:spPr>
          <a:xfrm rot="16200000">
            <a:off x="-161060" y="2992581"/>
            <a:ext cx="1192314" cy="276999"/>
          </a:xfrm>
          <a:prstGeom prst="rect">
            <a:avLst/>
          </a:prstGeom>
        </p:spPr>
        <p:txBody>
          <a:bodyPr wrap="none">
            <a:spAutoFit/>
          </a:bodyPr>
          <a:lstStyle/>
          <a:p>
            <a:r>
              <a:rPr lang="en-US" altLang="ja-JP" sz="1200" dirty="0">
                <a:latin typeface="Calibri" panose="020F0502020204030204" pitchFamily="34" charset="0"/>
                <a:ea typeface="Calibri" panose="020F0502020204030204" pitchFamily="34" charset="0"/>
                <a:cs typeface="Calibri" panose="020F0502020204030204" pitchFamily="34" charset="0"/>
              </a:rPr>
              <a:t>Survival</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rate (%)</a:t>
            </a:r>
            <a:endParaRPr lang="ja-JP" altLang="en-US" sz="1200" dirty="0">
              <a:latin typeface="Calibri" panose="020F0502020204030204" pitchFamily="34" charset="0"/>
              <a:cs typeface="Calibri" panose="020F0502020204030204" pitchFamily="34" charset="0"/>
            </a:endParaRPr>
          </a:p>
        </p:txBody>
      </p:sp>
      <p:sp>
        <p:nvSpPr>
          <p:cNvPr id="9" name="正方形/長方形 8">
            <a:extLst>
              <a:ext uri="{FF2B5EF4-FFF2-40B4-BE49-F238E27FC236}">
                <a16:creationId xmlns:a16="http://schemas.microsoft.com/office/drawing/2014/main" id="{61653D98-4EE3-177E-C39E-A41861C9FC73}"/>
              </a:ext>
            </a:extLst>
          </p:cNvPr>
          <p:cNvSpPr/>
          <p:nvPr/>
        </p:nvSpPr>
        <p:spPr>
          <a:xfrm>
            <a:off x="6538232" y="1716701"/>
            <a:ext cx="583329" cy="276999"/>
          </a:xfrm>
          <a:prstGeom prst="rect">
            <a:avLst/>
          </a:prstGeom>
        </p:spPr>
        <p:txBody>
          <a:bodyPr wrap="square">
            <a:spAutoFit/>
          </a:bodyPr>
          <a:lstStyle/>
          <a:p>
            <a:r>
              <a:rPr lang="en-US" altLang="ja-JP" sz="1200" dirty="0">
                <a:latin typeface="Calibri" panose="020F0502020204030204" pitchFamily="34" charset="0"/>
                <a:ea typeface="Calibri" panose="020F0502020204030204" pitchFamily="34" charset="0"/>
                <a:cs typeface="Calibri" panose="020F0502020204030204" pitchFamily="34" charset="0"/>
              </a:rPr>
              <a:t>100</a:t>
            </a:r>
            <a:endParaRPr lang="ja-JP" altLang="en-US" sz="1200" dirty="0">
              <a:latin typeface="Calibri" panose="020F0502020204030204" pitchFamily="34" charset="0"/>
              <a:ea typeface="Meiryo UI" panose="020B0604030504040204" pitchFamily="50" charset="-128"/>
              <a:cs typeface="Calibri" panose="020F0502020204030204" pitchFamily="34" charset="0"/>
            </a:endParaRPr>
          </a:p>
        </p:txBody>
      </p:sp>
      <p:sp>
        <p:nvSpPr>
          <p:cNvPr id="12" name="テキスト ボックス 11">
            <a:extLst>
              <a:ext uri="{FF2B5EF4-FFF2-40B4-BE49-F238E27FC236}">
                <a16:creationId xmlns:a16="http://schemas.microsoft.com/office/drawing/2014/main" id="{86C50BAB-FBD9-4876-A55A-91A34D83F43B}"/>
              </a:ext>
            </a:extLst>
          </p:cNvPr>
          <p:cNvSpPr txBox="1"/>
          <p:nvPr/>
        </p:nvSpPr>
        <p:spPr>
          <a:xfrm>
            <a:off x="6607202" y="2173842"/>
            <a:ext cx="372538" cy="2771173"/>
          </a:xfrm>
          <a:prstGeom prst="rect">
            <a:avLst/>
          </a:prstGeom>
          <a:noFill/>
        </p:spPr>
        <p:txBody>
          <a:bodyPr vert="eaVert" wrap="square" rtlCol="0">
            <a:spAutoFit/>
          </a:bodyPr>
          <a:lstStyle/>
          <a:p>
            <a:r>
              <a:rPr kumimoji="1" lang="en-US" altLang="ja-JP" sz="1200" dirty="0">
                <a:latin typeface="+mj-ea"/>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80           60          40           20        </a:t>
            </a:r>
            <a:r>
              <a:rPr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 </a:t>
            </a:r>
            <a:r>
              <a:rPr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0</a:t>
            </a:r>
            <a:endParaRPr kumimoji="1" lang="ja-JP" altLang="en-US" sz="1200" dirty="0">
              <a:latin typeface="Calibri" panose="020F0502020204030204" pitchFamily="34" charset="0"/>
              <a:ea typeface="+mj-ea"/>
              <a:cs typeface="Calibri" panose="020F0502020204030204" pitchFamily="34" charset="0"/>
            </a:endParaRPr>
          </a:p>
        </p:txBody>
      </p:sp>
      <p:sp>
        <p:nvSpPr>
          <p:cNvPr id="16" name="テキスト ボックス 15">
            <a:extLst>
              <a:ext uri="{FF2B5EF4-FFF2-40B4-BE49-F238E27FC236}">
                <a16:creationId xmlns:a16="http://schemas.microsoft.com/office/drawing/2014/main" id="{9DD03166-B73C-17C5-24CA-F59097212E5B}"/>
              </a:ext>
            </a:extLst>
          </p:cNvPr>
          <p:cNvSpPr txBox="1"/>
          <p:nvPr/>
        </p:nvSpPr>
        <p:spPr>
          <a:xfrm>
            <a:off x="8496881" y="4993306"/>
            <a:ext cx="1927412" cy="276999"/>
          </a:xfrm>
          <a:prstGeom prst="rect">
            <a:avLst/>
          </a:prstGeom>
          <a:noFill/>
        </p:spPr>
        <p:txBody>
          <a:bodyPr wrap="square" rtlCol="0">
            <a:spAutoFit/>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Time (months)</a:t>
            </a:r>
            <a:endParaRPr kumimoji="1" lang="ja-JP" altLang="en-US" sz="1200" dirty="0">
              <a:latin typeface="Calibri" panose="020F0502020204030204" pitchFamily="34" charset="0"/>
              <a:ea typeface="+mj-ea"/>
              <a:cs typeface="Calibri" panose="020F0502020204030204" pitchFamily="34" charset="0"/>
            </a:endParaRPr>
          </a:p>
        </p:txBody>
      </p:sp>
      <p:sp>
        <p:nvSpPr>
          <p:cNvPr id="19" name="正方形/長方形 18">
            <a:extLst>
              <a:ext uri="{FF2B5EF4-FFF2-40B4-BE49-F238E27FC236}">
                <a16:creationId xmlns:a16="http://schemas.microsoft.com/office/drawing/2014/main" id="{E9E37A8A-5D6E-60E9-B661-53C1452B6B18}"/>
              </a:ext>
            </a:extLst>
          </p:cNvPr>
          <p:cNvSpPr/>
          <p:nvPr/>
        </p:nvSpPr>
        <p:spPr>
          <a:xfrm>
            <a:off x="6889580" y="4746774"/>
            <a:ext cx="4836186" cy="276999"/>
          </a:xfrm>
          <a:prstGeom prst="rect">
            <a:avLst/>
          </a:prstGeom>
        </p:spPr>
        <p:txBody>
          <a:bodyPr wrap="square">
            <a:spAutoFit/>
          </a:bodyPr>
          <a:lstStyle/>
          <a:p>
            <a:r>
              <a:rPr lang="ja-JP" altLang="en-US" sz="1200" dirty="0">
                <a:latin typeface="Calibri" panose="020F0502020204030204" pitchFamily="34" charset="0"/>
                <a:ea typeface="+mj-ea"/>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0           6          12         18         24         30         36         42         48           </a:t>
            </a:r>
            <a:r>
              <a:rPr lang="ja-JP" altLang="en-US" sz="1200" dirty="0">
                <a:latin typeface="Calibri" panose="020F0502020204030204" pitchFamily="34" charset="0"/>
                <a:ea typeface="+mj-ea"/>
                <a:cs typeface="Calibri" panose="020F0502020204030204" pitchFamily="34" charset="0"/>
              </a:rPr>
              <a:t>    </a:t>
            </a:r>
          </a:p>
        </p:txBody>
      </p:sp>
      <p:sp>
        <p:nvSpPr>
          <p:cNvPr id="22" name="テキスト ボックス 21">
            <a:extLst>
              <a:ext uri="{FF2B5EF4-FFF2-40B4-BE49-F238E27FC236}">
                <a16:creationId xmlns:a16="http://schemas.microsoft.com/office/drawing/2014/main" id="{5B31F2B1-CD52-7168-468A-919948497D17}"/>
              </a:ext>
            </a:extLst>
          </p:cNvPr>
          <p:cNvSpPr txBox="1"/>
          <p:nvPr/>
        </p:nvSpPr>
        <p:spPr>
          <a:xfrm>
            <a:off x="466234" y="928555"/>
            <a:ext cx="4439141" cy="338554"/>
          </a:xfrm>
          <a:prstGeom prst="rect">
            <a:avLst/>
          </a:prstGeom>
          <a:noFill/>
        </p:spPr>
        <p:txBody>
          <a:bodyPr wrap="square" rtlCol="0">
            <a:spAutoFit/>
          </a:bodyPr>
          <a:lstStyle/>
          <a:p>
            <a:r>
              <a:rPr kumimoji="1" lang="en-US" altLang="ja-JP" sz="1600" dirty="0">
                <a:latin typeface="Meiryo UI" panose="020B0604030504040204" pitchFamily="50" charset="-128"/>
                <a:ea typeface="Meiryo UI" panose="020B0604030504040204" pitchFamily="50" charset="-128"/>
                <a:cs typeface="Calibri" panose="020F0502020204030204" pitchFamily="34" charset="0"/>
              </a:rPr>
              <a:t>(a)</a:t>
            </a:r>
            <a:r>
              <a:rPr kumimoji="1" lang="en-US" altLang="ja-JP" sz="1600" b="1" dirty="0">
                <a:solidFill>
                  <a:schemeClr val="accent1"/>
                </a:solidFill>
                <a:latin typeface="Meiryo UI" panose="020B0604030504040204" pitchFamily="50" charset="-128"/>
                <a:ea typeface="Meiryo UI" panose="020B0604030504040204" pitchFamily="50" charset="-128"/>
                <a:cs typeface="Calibri" panose="020F0502020204030204" pitchFamily="34" charset="0"/>
              </a:rPr>
              <a:t> </a:t>
            </a:r>
            <a:endParaRPr kumimoji="1" lang="ja-JP" altLang="en-US" sz="1600" b="1" dirty="0">
              <a:solidFill>
                <a:schemeClr val="accent1"/>
              </a:solidFill>
              <a:latin typeface="Meiryo UI" panose="020B0604030504040204" pitchFamily="50" charset="-128"/>
              <a:ea typeface="Meiryo UI" panose="020B0604030504040204" pitchFamily="50" charset="-128"/>
              <a:cs typeface="Calibri" panose="020F0502020204030204" pitchFamily="34" charset="0"/>
            </a:endParaRPr>
          </a:p>
        </p:txBody>
      </p:sp>
      <p:sp>
        <p:nvSpPr>
          <p:cNvPr id="23" name="テキスト ボックス 22">
            <a:extLst>
              <a:ext uri="{FF2B5EF4-FFF2-40B4-BE49-F238E27FC236}">
                <a16:creationId xmlns:a16="http://schemas.microsoft.com/office/drawing/2014/main" id="{AAD9DE14-4FD2-E5BD-D9EC-1766F14F53DA}"/>
              </a:ext>
            </a:extLst>
          </p:cNvPr>
          <p:cNvSpPr txBox="1"/>
          <p:nvPr/>
        </p:nvSpPr>
        <p:spPr>
          <a:xfrm>
            <a:off x="6141716" y="920772"/>
            <a:ext cx="5863598" cy="338554"/>
          </a:xfrm>
          <a:prstGeom prst="rect">
            <a:avLst/>
          </a:prstGeom>
          <a:noFill/>
        </p:spPr>
        <p:txBody>
          <a:bodyPr wrap="square" rtlCol="0">
            <a:spAutoFit/>
          </a:bodyPr>
          <a:lstStyle/>
          <a:p>
            <a:r>
              <a:rPr kumimoji="1" lang="en-US" altLang="ja-JP" sz="1600" dirty="0">
                <a:latin typeface="Meiryo UI" panose="020B0604030504040204" pitchFamily="50" charset="-128"/>
                <a:ea typeface="Meiryo UI" panose="020B0604030504040204" pitchFamily="50" charset="-128"/>
                <a:cs typeface="Calibri" panose="020F0502020204030204" pitchFamily="34" charset="0"/>
              </a:rPr>
              <a:t>(b) </a:t>
            </a:r>
            <a:endParaRPr kumimoji="1" lang="ja-JP" altLang="en-US" sz="1600" b="1" dirty="0">
              <a:solidFill>
                <a:schemeClr val="accent1"/>
              </a:solidFill>
              <a:latin typeface="Meiryo UI" panose="020B0604030504040204" pitchFamily="50" charset="-128"/>
              <a:ea typeface="Meiryo UI" panose="020B0604030504040204" pitchFamily="50" charset="-128"/>
              <a:cs typeface="Calibri" panose="020F0502020204030204" pitchFamily="34" charset="0"/>
            </a:endParaRPr>
          </a:p>
        </p:txBody>
      </p:sp>
      <p:pic>
        <p:nvPicPr>
          <p:cNvPr id="3" name="図 2">
            <a:extLst>
              <a:ext uri="{FF2B5EF4-FFF2-40B4-BE49-F238E27FC236}">
                <a16:creationId xmlns:a16="http://schemas.microsoft.com/office/drawing/2014/main" id="{8AC0D570-5315-1C94-48FC-EAAD3569D74C}"/>
              </a:ext>
            </a:extLst>
          </p:cNvPr>
          <p:cNvPicPr>
            <a:picLocks noChangeAspect="1"/>
          </p:cNvPicPr>
          <p:nvPr/>
        </p:nvPicPr>
        <p:blipFill rotWithShape="1">
          <a:blip r:embed="rId2" cstate="email">
            <a:extLst>
              <a:ext uri="{28A0092B-C50C-407E-A947-70E740481C1C}">
                <a14:useLocalDpi xmlns:a14="http://schemas.microsoft.com/office/drawing/2010/main"/>
              </a:ext>
            </a:extLst>
          </a:blip>
          <a:srcRect/>
          <a:stretch/>
        </p:blipFill>
        <p:spPr>
          <a:xfrm>
            <a:off x="876235" y="1632401"/>
            <a:ext cx="4377416" cy="3182506"/>
          </a:xfrm>
          <a:prstGeom prst="rect">
            <a:avLst/>
          </a:prstGeom>
        </p:spPr>
      </p:pic>
      <p:sp>
        <p:nvSpPr>
          <p:cNvPr id="17" name="正方形/長方形 16">
            <a:extLst>
              <a:ext uri="{FF2B5EF4-FFF2-40B4-BE49-F238E27FC236}">
                <a16:creationId xmlns:a16="http://schemas.microsoft.com/office/drawing/2014/main" id="{91545AF9-B7BA-20AD-E4A3-97E7E05A301A}"/>
              </a:ext>
            </a:extLst>
          </p:cNvPr>
          <p:cNvSpPr/>
          <p:nvPr/>
        </p:nvSpPr>
        <p:spPr>
          <a:xfrm>
            <a:off x="6659593" y="5276517"/>
            <a:ext cx="5066173" cy="830997"/>
          </a:xfrm>
          <a:prstGeom prst="rect">
            <a:avLst/>
          </a:prstGeom>
        </p:spPr>
        <p:txBody>
          <a:bodyPr wrap="square">
            <a:spAutoFit/>
          </a:bodyPr>
          <a:lstStyle/>
          <a:p>
            <a:r>
              <a:rPr lang="en-US" altLang="ja-JP" sz="1200" dirty="0">
                <a:latin typeface="Calibri" panose="020F0502020204030204" pitchFamily="34" charset="0"/>
                <a:ea typeface="Calibri" panose="020F0502020204030204" pitchFamily="34" charset="0"/>
                <a:cs typeface="Calibri" panose="020F0502020204030204" pitchFamily="34" charset="0"/>
              </a:rPr>
              <a:t>Number at risk</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With </a:t>
            </a:r>
            <a:r>
              <a:rPr lang="en-US" altLang="ja-JP" sz="1200" u="sng" dirty="0">
                <a:latin typeface="Calibri" panose="020F0502020204030204" pitchFamily="34" charset="0"/>
                <a:ea typeface="Calibri" panose="020F0502020204030204" pitchFamily="34" charset="0"/>
                <a:cs typeface="Calibri" panose="020F0502020204030204" pitchFamily="34" charset="0"/>
              </a:rPr>
              <a:t>&gt;</a:t>
            </a:r>
            <a:r>
              <a:rPr lang="en-US" altLang="ja-JP" sz="1200" dirty="0">
                <a:latin typeface="Calibri" panose="020F0502020204030204" pitchFamily="34" charset="0"/>
                <a:ea typeface="Calibri" panose="020F0502020204030204" pitchFamily="34" charset="0"/>
                <a:cs typeface="Calibri" panose="020F0502020204030204" pitchFamily="34" charset="0"/>
              </a:rPr>
              <a:t> Grade 3 </a:t>
            </a:r>
            <a:r>
              <a:rPr lang="en-US" altLang="ja-JP" sz="1200" dirty="0" err="1">
                <a:latin typeface="Calibri" panose="020F0502020204030204" pitchFamily="34" charset="0"/>
                <a:ea typeface="Calibri" panose="020F0502020204030204" pitchFamily="34" charset="0"/>
                <a:cs typeface="Calibri" panose="020F0502020204030204" pitchFamily="34" charset="0"/>
              </a:rPr>
              <a:t>irAEs</a:t>
            </a:r>
            <a:r>
              <a:rPr lang="en-US" altLang="ja-JP" sz="1200" dirty="0">
                <a:latin typeface="Calibri" panose="020F0502020204030204" pitchFamily="34" charset="0"/>
                <a:ea typeface="Calibri" panose="020F0502020204030204" pitchFamily="34" charset="0"/>
                <a:cs typeface="Calibri" panose="020F0502020204030204" pitchFamily="34" charset="0"/>
              </a:rPr>
              <a:t>)</a:t>
            </a:r>
          </a:p>
          <a:p>
            <a:r>
              <a:rPr lang="en-US" altLang="ja-JP" sz="1200" dirty="0">
                <a:latin typeface="Calibri" panose="020F0502020204030204" pitchFamily="34" charset="0"/>
                <a:ea typeface="Calibri" panose="020F0502020204030204" pitchFamily="34" charset="0"/>
                <a:cs typeface="Calibri" panose="020F0502020204030204" pitchFamily="34" charset="0"/>
              </a:rPr>
              <a:t>         </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28         23       </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 13         10           8           4           2    </a:t>
            </a:r>
            <a:r>
              <a:rPr lang="ja-JP" altLang="en-US" sz="1200" dirty="0">
                <a:latin typeface="Calibri" panose="020F0502020204030204" pitchFamily="34" charset="0"/>
                <a:cs typeface="Calibri" panose="020F0502020204030204" pitchFamily="34" charset="0"/>
              </a:rPr>
              <a:t> </a:t>
            </a:r>
            <a:r>
              <a:rPr lang="en-US" altLang="ja-JP" sz="1200" dirty="0">
                <a:latin typeface="Calibri" panose="020F0502020204030204" pitchFamily="34" charset="0"/>
                <a:ea typeface="Calibri" panose="020F0502020204030204" pitchFamily="34" charset="0"/>
                <a:cs typeface="Calibri" panose="020F0502020204030204" pitchFamily="34" charset="0"/>
              </a:rPr>
              <a:t>      0           0     </a:t>
            </a:r>
          </a:p>
          <a:p>
            <a:r>
              <a:rPr lang="en-US" altLang="ja-JP" sz="1200" dirty="0">
                <a:latin typeface="Calibri" panose="020F0502020204030204" pitchFamily="34" charset="0"/>
                <a:ea typeface="Calibri" panose="020F0502020204030204" pitchFamily="34" charset="0"/>
                <a:cs typeface="Calibri" panose="020F0502020204030204" pitchFamily="34" charset="0"/>
              </a:rPr>
              <a:t>Number at risk (Without </a:t>
            </a:r>
            <a:r>
              <a:rPr lang="en-US" altLang="ja-JP" sz="1200" dirty="0" err="1">
                <a:latin typeface="Calibri" panose="020F0502020204030204" pitchFamily="34" charset="0"/>
                <a:ea typeface="Calibri" panose="020F0502020204030204" pitchFamily="34" charset="0"/>
                <a:cs typeface="Calibri" panose="020F0502020204030204" pitchFamily="34" charset="0"/>
              </a:rPr>
              <a:t>irAE</a:t>
            </a:r>
            <a:r>
              <a:rPr lang="en-US" altLang="ja-JP" sz="1200" dirty="0">
                <a:latin typeface="Calibri" panose="020F0502020204030204" pitchFamily="34" charset="0"/>
                <a:ea typeface="Calibri" panose="020F0502020204030204" pitchFamily="34" charset="0"/>
                <a:cs typeface="Calibri" panose="020F0502020204030204" pitchFamily="34" charset="0"/>
              </a:rPr>
              <a:t>)        </a:t>
            </a:r>
          </a:p>
          <a:p>
            <a:r>
              <a:rPr lang="en-US" altLang="ja-JP" sz="1200">
                <a:latin typeface="Calibri" panose="020F0502020204030204" pitchFamily="34" charset="0"/>
                <a:ea typeface="Calibri" panose="020F0502020204030204" pitchFamily="34" charset="0"/>
                <a:cs typeface="Calibri" panose="020F0502020204030204" pitchFamily="34" charset="0"/>
              </a:rPr>
              <a:t>          93         55         43          32         24         13         6            5           </a:t>
            </a:r>
            <a:r>
              <a:rPr lang="en-US" altLang="ja-JP" sz="1200" dirty="0">
                <a:latin typeface="Calibri" panose="020F0502020204030204" pitchFamily="34" charset="0"/>
                <a:ea typeface="Calibri" panose="020F0502020204030204" pitchFamily="34" charset="0"/>
                <a:cs typeface="Calibri" panose="020F0502020204030204" pitchFamily="34" charset="0"/>
              </a:rPr>
              <a:t>0    </a:t>
            </a:r>
            <a:endParaRPr lang="ja-JP" altLang="en-US" sz="1200" dirty="0">
              <a:latin typeface="Calibri" panose="020F0502020204030204" pitchFamily="34" charset="0"/>
              <a:cs typeface="Calibri" panose="020F0502020204030204" pitchFamily="34" charset="0"/>
            </a:endParaRPr>
          </a:p>
        </p:txBody>
      </p:sp>
      <p:pic>
        <p:nvPicPr>
          <p:cNvPr id="18" name="図 17">
            <a:extLst>
              <a:ext uri="{FF2B5EF4-FFF2-40B4-BE49-F238E27FC236}">
                <a16:creationId xmlns:a16="http://schemas.microsoft.com/office/drawing/2014/main" id="{EF74B423-ED36-4E23-7909-B4113C85A10F}"/>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r="-743"/>
          <a:stretch/>
        </p:blipFill>
        <p:spPr>
          <a:xfrm>
            <a:off x="6889580" y="1701467"/>
            <a:ext cx="4367871" cy="3068019"/>
          </a:xfrm>
          <a:prstGeom prst="rect">
            <a:avLst/>
          </a:prstGeom>
        </p:spPr>
      </p:pic>
      <p:graphicFrame>
        <p:nvGraphicFramePr>
          <p:cNvPr id="2" name="表 1">
            <a:extLst>
              <a:ext uri="{FF2B5EF4-FFF2-40B4-BE49-F238E27FC236}">
                <a16:creationId xmlns:a16="http://schemas.microsoft.com/office/drawing/2014/main" id="{6AA66A58-E062-4B9E-7CC7-A54EEEC605E3}"/>
              </a:ext>
            </a:extLst>
          </p:cNvPr>
          <p:cNvGraphicFramePr>
            <a:graphicFrameLocks noGrp="1"/>
          </p:cNvGraphicFramePr>
          <p:nvPr>
            <p:extLst>
              <p:ext uri="{D42A27DB-BD31-4B8C-83A1-F6EECF244321}">
                <p14:modId xmlns:p14="http://schemas.microsoft.com/office/powerpoint/2010/main" val="2104960133"/>
              </p:ext>
            </p:extLst>
          </p:nvPr>
        </p:nvGraphicFramePr>
        <p:xfrm>
          <a:off x="1547446" y="954959"/>
          <a:ext cx="3667649" cy="822960"/>
        </p:xfrm>
        <a:graphic>
          <a:graphicData uri="http://schemas.openxmlformats.org/drawingml/2006/table">
            <a:tbl>
              <a:tblPr firstRow="1" bandRow="1">
                <a:tableStyleId>{5C22544A-7EE6-4342-B048-85BDC9FD1C3A}</a:tableStyleId>
              </a:tblPr>
              <a:tblGrid>
                <a:gridCol w="1085222">
                  <a:extLst>
                    <a:ext uri="{9D8B030D-6E8A-4147-A177-3AD203B41FA5}">
                      <a16:colId xmlns:a16="http://schemas.microsoft.com/office/drawing/2014/main" val="608464401"/>
                    </a:ext>
                  </a:extLst>
                </a:gridCol>
                <a:gridCol w="1055077">
                  <a:extLst>
                    <a:ext uri="{9D8B030D-6E8A-4147-A177-3AD203B41FA5}">
                      <a16:colId xmlns:a16="http://schemas.microsoft.com/office/drawing/2014/main" val="2971327886"/>
                    </a:ext>
                  </a:extLst>
                </a:gridCol>
                <a:gridCol w="1527350">
                  <a:extLst>
                    <a:ext uri="{9D8B030D-6E8A-4147-A177-3AD203B41FA5}">
                      <a16:colId xmlns:a16="http://schemas.microsoft.com/office/drawing/2014/main" val="1387933777"/>
                    </a:ext>
                  </a:extLst>
                </a:gridCol>
              </a:tblGrid>
              <a:tr h="196312">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Category</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Without </a:t>
                      </a:r>
                      <a:r>
                        <a:rPr kumimoji="1" lang="en-US" altLang="ja-JP" sz="1200" dirty="0" err="1">
                          <a:latin typeface="Calibri" panose="020F0502020204030204" pitchFamily="34" charset="0"/>
                          <a:ea typeface="Calibri" panose="020F0502020204030204" pitchFamily="34" charset="0"/>
                          <a:cs typeface="Calibri" panose="020F0502020204030204" pitchFamily="34" charset="0"/>
                        </a:rPr>
                        <a:t>irAE</a:t>
                      </a:r>
                      <a:r>
                        <a:rPr kumimoji="1" lang="en-US" altLang="ja-JP" sz="1200" dirty="0">
                          <a:latin typeface="Calibri" panose="020F0502020204030204" pitchFamily="34" charset="0"/>
                          <a:ea typeface="Calibri" panose="020F0502020204030204" pitchFamily="34" charset="0"/>
                          <a:cs typeface="Calibri" panose="020F0502020204030204" pitchFamily="34" charset="0"/>
                        </a:rPr>
                        <a:t> </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With Grade1-2 </a:t>
                      </a:r>
                      <a:r>
                        <a:rPr kumimoji="1" lang="en-US" altLang="ja-JP" sz="1200" dirty="0" err="1">
                          <a:latin typeface="Calibri" panose="020F0502020204030204" pitchFamily="34" charset="0"/>
                          <a:ea typeface="Calibri" panose="020F0502020204030204" pitchFamily="34" charset="0"/>
                          <a:cs typeface="Calibri" panose="020F0502020204030204" pitchFamily="34" charset="0"/>
                        </a:rPr>
                        <a:t>irAEs</a:t>
                      </a:r>
                      <a:endParaRPr kumimoji="1" lang="ja-JP" altLang="en-US" sz="1200" dirty="0">
                        <a:latin typeface="Calibri" panose="020F0502020204030204" pitchFamily="34" charset="0"/>
                        <a:ea typeface="+mj-ea"/>
                        <a:cs typeface="Calibri" panose="020F0502020204030204" pitchFamily="34" charset="0"/>
                      </a:endParaRPr>
                    </a:p>
                  </a:txBody>
                  <a:tcPr/>
                </a:tc>
                <a:extLst>
                  <a:ext uri="{0D108BD9-81ED-4DB2-BD59-A6C34878D82A}">
                    <a16:rowId xmlns:a16="http://schemas.microsoft.com/office/drawing/2014/main" val="1634356550"/>
                  </a:ext>
                </a:extLst>
              </a:tr>
              <a:tr h="196312">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1</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year</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OS</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rate</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66.7</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76.8 %</a:t>
                      </a:r>
                      <a:endParaRPr kumimoji="1" lang="ja-JP" altLang="en-US" sz="1200" dirty="0">
                        <a:latin typeface="Calibri" panose="020F0502020204030204" pitchFamily="34" charset="0"/>
                        <a:ea typeface="+mj-ea"/>
                        <a:cs typeface="Calibri" panose="020F0502020204030204" pitchFamily="34" charset="0"/>
                      </a:endParaRPr>
                    </a:p>
                  </a:txBody>
                  <a:tcPr/>
                </a:tc>
                <a:extLst>
                  <a:ext uri="{0D108BD9-81ED-4DB2-BD59-A6C34878D82A}">
                    <a16:rowId xmlns:a16="http://schemas.microsoft.com/office/drawing/2014/main" val="1196083941"/>
                  </a:ext>
                </a:extLst>
              </a:tr>
              <a:tr h="196312">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2 year OS rate</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48.3 %</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55.1 %</a:t>
                      </a:r>
                      <a:endParaRPr kumimoji="1" lang="ja-JP" altLang="en-US" sz="1200" dirty="0">
                        <a:latin typeface="Calibri" panose="020F0502020204030204" pitchFamily="34" charset="0"/>
                        <a:ea typeface="+mj-ea"/>
                        <a:cs typeface="Calibri" panose="020F0502020204030204" pitchFamily="34" charset="0"/>
                      </a:endParaRPr>
                    </a:p>
                  </a:txBody>
                  <a:tcPr/>
                </a:tc>
                <a:extLst>
                  <a:ext uri="{0D108BD9-81ED-4DB2-BD59-A6C34878D82A}">
                    <a16:rowId xmlns:a16="http://schemas.microsoft.com/office/drawing/2014/main" val="2708273431"/>
                  </a:ext>
                </a:extLst>
              </a:tr>
            </a:tbl>
          </a:graphicData>
        </a:graphic>
      </p:graphicFrame>
      <p:graphicFrame>
        <p:nvGraphicFramePr>
          <p:cNvPr id="21" name="表 20">
            <a:extLst>
              <a:ext uri="{FF2B5EF4-FFF2-40B4-BE49-F238E27FC236}">
                <a16:creationId xmlns:a16="http://schemas.microsoft.com/office/drawing/2014/main" id="{93EC916E-879C-1DA7-8816-D4ECFC3C58CD}"/>
              </a:ext>
            </a:extLst>
          </p:cNvPr>
          <p:cNvGraphicFramePr>
            <a:graphicFrameLocks noGrp="1"/>
          </p:cNvGraphicFramePr>
          <p:nvPr>
            <p:extLst>
              <p:ext uri="{D42A27DB-BD31-4B8C-83A1-F6EECF244321}">
                <p14:modId xmlns:p14="http://schemas.microsoft.com/office/powerpoint/2010/main" val="3935307932"/>
              </p:ext>
            </p:extLst>
          </p:nvPr>
        </p:nvGraphicFramePr>
        <p:xfrm>
          <a:off x="7761313" y="954959"/>
          <a:ext cx="3730295" cy="822960"/>
        </p:xfrm>
        <a:graphic>
          <a:graphicData uri="http://schemas.openxmlformats.org/drawingml/2006/table">
            <a:tbl>
              <a:tblPr firstRow="1" bandRow="1">
                <a:tableStyleId>{5C22544A-7EE6-4342-B048-85BDC9FD1C3A}</a:tableStyleId>
              </a:tblPr>
              <a:tblGrid>
                <a:gridCol w="1111908">
                  <a:extLst>
                    <a:ext uri="{9D8B030D-6E8A-4147-A177-3AD203B41FA5}">
                      <a16:colId xmlns:a16="http://schemas.microsoft.com/office/drawing/2014/main" val="608464401"/>
                    </a:ext>
                  </a:extLst>
                </a:gridCol>
                <a:gridCol w="1075173">
                  <a:extLst>
                    <a:ext uri="{9D8B030D-6E8A-4147-A177-3AD203B41FA5}">
                      <a16:colId xmlns:a16="http://schemas.microsoft.com/office/drawing/2014/main" val="2971327886"/>
                    </a:ext>
                  </a:extLst>
                </a:gridCol>
                <a:gridCol w="1543214">
                  <a:extLst>
                    <a:ext uri="{9D8B030D-6E8A-4147-A177-3AD203B41FA5}">
                      <a16:colId xmlns:a16="http://schemas.microsoft.com/office/drawing/2014/main" val="1387933777"/>
                    </a:ext>
                  </a:extLst>
                </a:gridCol>
              </a:tblGrid>
              <a:tr h="196312">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Category</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Without </a:t>
                      </a:r>
                      <a:r>
                        <a:rPr kumimoji="1" lang="en-US" altLang="ja-JP" sz="1200" dirty="0" err="1">
                          <a:latin typeface="Calibri" panose="020F0502020204030204" pitchFamily="34" charset="0"/>
                          <a:ea typeface="Calibri" panose="020F0502020204030204" pitchFamily="34" charset="0"/>
                          <a:cs typeface="Calibri" panose="020F0502020204030204" pitchFamily="34" charset="0"/>
                        </a:rPr>
                        <a:t>irAE</a:t>
                      </a:r>
                      <a:r>
                        <a:rPr kumimoji="1" lang="en-US" altLang="ja-JP" sz="1200" dirty="0">
                          <a:latin typeface="Calibri" panose="020F0502020204030204" pitchFamily="34" charset="0"/>
                          <a:ea typeface="Calibri" panose="020F0502020204030204" pitchFamily="34" charset="0"/>
                          <a:cs typeface="Calibri" panose="020F0502020204030204" pitchFamily="34" charset="0"/>
                        </a:rPr>
                        <a:t> </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With </a:t>
                      </a:r>
                      <a:r>
                        <a:rPr kumimoji="1" lang="en-US" altLang="ja-JP" sz="1200" u="sng" dirty="0">
                          <a:latin typeface="Calibri" panose="020F0502020204030204" pitchFamily="34" charset="0"/>
                          <a:ea typeface="Calibri" panose="020F0502020204030204" pitchFamily="34" charset="0"/>
                          <a:cs typeface="Calibri" panose="020F0502020204030204" pitchFamily="34" charset="0"/>
                        </a:rPr>
                        <a:t>&gt;</a:t>
                      </a:r>
                      <a:r>
                        <a:rPr kumimoji="1" lang="en-US" altLang="ja-JP" sz="1200" dirty="0">
                          <a:latin typeface="Calibri" panose="020F0502020204030204" pitchFamily="34" charset="0"/>
                          <a:ea typeface="Calibri" panose="020F0502020204030204" pitchFamily="34" charset="0"/>
                          <a:cs typeface="Calibri" panose="020F0502020204030204" pitchFamily="34" charset="0"/>
                        </a:rPr>
                        <a:t> Grade3 </a:t>
                      </a:r>
                      <a:r>
                        <a:rPr kumimoji="1" lang="en-US" altLang="ja-JP" sz="1200" dirty="0" err="1">
                          <a:latin typeface="Calibri" panose="020F0502020204030204" pitchFamily="34" charset="0"/>
                          <a:ea typeface="Calibri" panose="020F0502020204030204" pitchFamily="34" charset="0"/>
                          <a:cs typeface="Calibri" panose="020F0502020204030204" pitchFamily="34" charset="0"/>
                        </a:rPr>
                        <a:t>irAEs</a:t>
                      </a:r>
                      <a:endParaRPr kumimoji="1" lang="ja-JP" altLang="en-US" sz="1200" dirty="0">
                        <a:latin typeface="Calibri" panose="020F0502020204030204" pitchFamily="34" charset="0"/>
                        <a:ea typeface="+mj-ea"/>
                        <a:cs typeface="Calibri" panose="020F0502020204030204" pitchFamily="34" charset="0"/>
                      </a:endParaRPr>
                    </a:p>
                  </a:txBody>
                  <a:tcPr/>
                </a:tc>
                <a:extLst>
                  <a:ext uri="{0D108BD9-81ED-4DB2-BD59-A6C34878D82A}">
                    <a16:rowId xmlns:a16="http://schemas.microsoft.com/office/drawing/2014/main" val="1634356550"/>
                  </a:ext>
                </a:extLst>
              </a:tr>
              <a:tr h="196312">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1</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year</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OS</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rate</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66.7</a:t>
                      </a:r>
                      <a:r>
                        <a:rPr kumimoji="1" lang="ja-JP" altLang="en-US" sz="1200" dirty="0">
                          <a:latin typeface="Calibri" panose="020F0502020204030204" pitchFamily="34" charset="0"/>
                          <a:ea typeface="+mj-ea"/>
                          <a:cs typeface="Calibri" panose="020F0502020204030204" pitchFamily="34" charset="0"/>
                        </a:rPr>
                        <a:t> </a:t>
                      </a:r>
                      <a:r>
                        <a:rPr kumimoji="1" lang="en-US" altLang="ja-JP" sz="1200" dirty="0">
                          <a:latin typeface="Calibri" panose="020F0502020204030204" pitchFamily="34" charset="0"/>
                          <a:ea typeface="Calibri" panose="020F0502020204030204" pitchFamily="34" charset="0"/>
                          <a:cs typeface="Calibri" panose="020F0502020204030204" pitchFamily="34" charset="0"/>
                        </a:rPr>
                        <a:t>%</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77.4 %</a:t>
                      </a:r>
                      <a:endParaRPr kumimoji="1" lang="ja-JP" altLang="en-US" sz="1200" dirty="0">
                        <a:latin typeface="Calibri" panose="020F0502020204030204" pitchFamily="34" charset="0"/>
                        <a:ea typeface="+mj-ea"/>
                        <a:cs typeface="Calibri" panose="020F0502020204030204" pitchFamily="34" charset="0"/>
                      </a:endParaRPr>
                    </a:p>
                  </a:txBody>
                  <a:tcPr/>
                </a:tc>
                <a:extLst>
                  <a:ext uri="{0D108BD9-81ED-4DB2-BD59-A6C34878D82A}">
                    <a16:rowId xmlns:a16="http://schemas.microsoft.com/office/drawing/2014/main" val="1196083941"/>
                  </a:ext>
                </a:extLst>
              </a:tr>
              <a:tr h="196312">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2 year OS rate</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48.3 %</a:t>
                      </a:r>
                      <a:endParaRPr kumimoji="1" lang="ja-JP" altLang="en-US" sz="1200" dirty="0">
                        <a:latin typeface="Calibri" panose="020F0502020204030204" pitchFamily="34" charset="0"/>
                        <a:ea typeface="+mj-ea"/>
                        <a:cs typeface="Calibri" panose="020F0502020204030204" pitchFamily="34" charset="0"/>
                      </a:endParaRPr>
                    </a:p>
                  </a:txBody>
                  <a:tcPr/>
                </a:tc>
                <a:tc>
                  <a:txBody>
                    <a:bodyPr/>
                    <a:lstStyle/>
                    <a:p>
                      <a:r>
                        <a:rPr kumimoji="1" lang="en-US" altLang="ja-JP" sz="1200" dirty="0">
                          <a:latin typeface="Calibri" panose="020F0502020204030204" pitchFamily="34" charset="0"/>
                          <a:ea typeface="Calibri" panose="020F0502020204030204" pitchFamily="34" charset="0"/>
                          <a:cs typeface="Calibri" panose="020F0502020204030204" pitchFamily="34" charset="0"/>
                        </a:rPr>
                        <a:t>53.9 %</a:t>
                      </a:r>
                      <a:endParaRPr kumimoji="1" lang="ja-JP" altLang="en-US" sz="1200" dirty="0">
                        <a:latin typeface="Calibri" panose="020F0502020204030204" pitchFamily="34" charset="0"/>
                        <a:ea typeface="+mj-ea"/>
                        <a:cs typeface="Calibri" panose="020F0502020204030204" pitchFamily="34" charset="0"/>
                      </a:endParaRPr>
                    </a:p>
                  </a:txBody>
                  <a:tcPr/>
                </a:tc>
                <a:extLst>
                  <a:ext uri="{0D108BD9-81ED-4DB2-BD59-A6C34878D82A}">
                    <a16:rowId xmlns:a16="http://schemas.microsoft.com/office/drawing/2014/main" val="2708273431"/>
                  </a:ext>
                </a:extLst>
              </a:tr>
            </a:tbl>
          </a:graphicData>
        </a:graphic>
      </p:graphicFrame>
    </p:spTree>
    <p:extLst>
      <p:ext uri="{BB962C8B-B14F-4D97-AF65-F5344CB8AC3E}">
        <p14:creationId xmlns:p14="http://schemas.microsoft.com/office/powerpoint/2010/main" val="345225753"/>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ユーザー定義 3">
      <a:majorFont>
        <a:latin typeface="Meiryo UI"/>
        <a:ea typeface="Meiryo UI"/>
        <a:cs typeface=""/>
      </a:majorFont>
      <a:minorFont>
        <a:latin typeface="Meiryo UI"/>
        <a:ea typeface="Meiryo UI"/>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722</TotalTime>
  <Words>171</Words>
  <Application>Microsoft Office PowerPoint</Application>
  <PresentationFormat>ワイド画面</PresentationFormat>
  <Paragraphs>38</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Meiryo UI</vt:lpstr>
      <vt:lpstr>游ゴシック</vt:lpstr>
      <vt:lpstr>Arial</vt:lpstr>
      <vt:lpstr>Calibri</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細胞傷害性抗がん剤と免疫チェックポイント阻害剤併用療法の最適な治療戦略</dc:title>
  <dc:creator>曽根原　圭</dc:creator>
  <cp:lastModifiedBy>圭 曽根原</cp:lastModifiedBy>
  <cp:revision>730</cp:revision>
  <cp:lastPrinted>2021-02-09T09:58:43Z</cp:lastPrinted>
  <dcterms:created xsi:type="dcterms:W3CDTF">2021-01-18T03:33:30Z</dcterms:created>
  <dcterms:modified xsi:type="dcterms:W3CDTF">2024-04-26T13:24:58Z</dcterms:modified>
</cp:coreProperties>
</file>